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0" r:id="rId2"/>
    <p:sldId id="342" r:id="rId3"/>
    <p:sldId id="340" r:id="rId4"/>
    <p:sldId id="352" r:id="rId5"/>
    <p:sldId id="34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32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2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CDBCDD-F4B2-3441-B090-E24BB66E5078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1F4DB7-2016-1F45-A38D-62D58005E0F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8863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2DA66-819B-4A9F-B646-87A5B89CB355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85684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3/31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1EFF8245-8FFE-E44A-8B01-DCD3F078347C}"/>
              </a:ext>
            </a:extLst>
          </p:cNvPr>
          <p:cNvSpPr txBox="1"/>
          <p:nvPr/>
        </p:nvSpPr>
        <p:spPr>
          <a:xfrm>
            <a:off x="8638778" y="289287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0E614C6-E022-FB4A-8DD4-B3FA7B2A37F8}"/>
              </a:ext>
            </a:extLst>
          </p:cNvPr>
          <p:cNvSpPr txBox="1"/>
          <p:nvPr/>
        </p:nvSpPr>
        <p:spPr>
          <a:xfrm>
            <a:off x="1134630" y="290239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文本框 59">
            <a:extLst>
              <a:ext uri="{FF2B5EF4-FFF2-40B4-BE49-F238E27FC236}">
                <a16:creationId xmlns:a16="http://schemas.microsoft.com/office/drawing/2014/main" id="{347A09B4-D61D-DD41-8236-4D6EE438B21C}"/>
              </a:ext>
            </a:extLst>
          </p:cNvPr>
          <p:cNvSpPr txBox="1"/>
          <p:nvPr/>
        </p:nvSpPr>
        <p:spPr>
          <a:xfrm>
            <a:off x="57151" y="76101"/>
            <a:ext cx="3014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0E9E7BB-00B4-5B83-3679-FA27F14011E5}"/>
              </a:ext>
            </a:extLst>
          </p:cNvPr>
          <p:cNvGrpSpPr/>
          <p:nvPr/>
        </p:nvGrpSpPr>
        <p:grpSpPr>
          <a:xfrm>
            <a:off x="1086799" y="3172268"/>
            <a:ext cx="10627274" cy="3647709"/>
            <a:chOff x="538566" y="1686291"/>
            <a:chExt cx="11302167" cy="38354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B89BFBE-D801-84EF-7D38-7C8FDEC9FEB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071809" y="1885440"/>
              <a:ext cx="3068507" cy="3068507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B9242C0A-DC0E-E70B-9EAD-9177864148D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86922" y="1686291"/>
              <a:ext cx="2885269" cy="328034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4699A1C-B123-11A9-051B-331C5068D21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38566" y="1822114"/>
              <a:ext cx="2885269" cy="3091359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2AC5218-181F-53A3-3585-D4F0128684B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526033" y="1686291"/>
              <a:ext cx="3314700" cy="3835400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1556621D-41F6-A854-2582-BACE906A504B}"/>
              </a:ext>
            </a:extLst>
          </p:cNvPr>
          <p:cNvSpPr txBox="1"/>
          <p:nvPr/>
        </p:nvSpPr>
        <p:spPr>
          <a:xfrm>
            <a:off x="3827030" y="9823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0B73883-5F61-4C80-96E6-ECB34F12013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36082" y="318266"/>
            <a:ext cx="1877216" cy="264955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9076768-92DC-C534-F8C1-BD45FFAFCF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45151" y="183735"/>
            <a:ext cx="1877216" cy="2794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04498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文本框 65">
            <a:extLst>
              <a:ext uri="{FF2B5EF4-FFF2-40B4-BE49-F238E27FC236}">
                <a16:creationId xmlns:a16="http://schemas.microsoft.com/office/drawing/2014/main" id="{ECD34D9B-11B9-F54C-A32E-F577B90FF0A5}"/>
              </a:ext>
            </a:extLst>
          </p:cNvPr>
          <p:cNvSpPr txBox="1"/>
          <p:nvPr/>
        </p:nvSpPr>
        <p:spPr>
          <a:xfrm>
            <a:off x="4947251" y="1311372"/>
            <a:ext cx="379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59">
            <a:extLst>
              <a:ext uri="{FF2B5EF4-FFF2-40B4-BE49-F238E27FC236}">
                <a16:creationId xmlns:a16="http://schemas.microsoft.com/office/drawing/2014/main" id="{284D72EF-2251-AF4F-A759-975B97F58583}"/>
              </a:ext>
            </a:extLst>
          </p:cNvPr>
          <p:cNvSpPr txBox="1"/>
          <p:nvPr/>
        </p:nvSpPr>
        <p:spPr>
          <a:xfrm>
            <a:off x="57151" y="76101"/>
            <a:ext cx="3014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65">
            <a:extLst>
              <a:ext uri="{FF2B5EF4-FFF2-40B4-BE49-F238E27FC236}">
                <a16:creationId xmlns:a16="http://schemas.microsoft.com/office/drawing/2014/main" id="{8B4785AA-EC04-E348-BF0D-9D695521B8C4}"/>
              </a:ext>
            </a:extLst>
          </p:cNvPr>
          <p:cNvSpPr txBox="1"/>
          <p:nvPr/>
        </p:nvSpPr>
        <p:spPr>
          <a:xfrm>
            <a:off x="2412967" y="1323095"/>
            <a:ext cx="3799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ED488EB-03F3-A8B0-46F6-F118D16DDD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9688" y="1554520"/>
            <a:ext cx="2527300" cy="37973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D1A665F-4F04-AB05-5DCD-6FCC3C8CA9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88674" y="1553087"/>
            <a:ext cx="2565400" cy="35179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DDAF98E-52B1-E150-AC8D-1AA1C56E42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3920" y="1546380"/>
            <a:ext cx="3028002" cy="40680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20751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F76068F6-9340-4E5E-8EF5-AE37388F1E87}"/>
              </a:ext>
            </a:extLst>
          </p:cNvPr>
          <p:cNvGrpSpPr/>
          <p:nvPr/>
        </p:nvGrpSpPr>
        <p:grpSpPr>
          <a:xfrm>
            <a:off x="1238004" y="67570"/>
            <a:ext cx="9580505" cy="6799734"/>
            <a:chOff x="746167" y="-613723"/>
            <a:chExt cx="9580505" cy="6799734"/>
          </a:xfrm>
        </p:grpSpPr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1D5FD4F8-091A-49FF-BCD2-30942CB156AC}"/>
                </a:ext>
              </a:extLst>
            </p:cNvPr>
            <p:cNvSpPr/>
            <p:nvPr/>
          </p:nvSpPr>
          <p:spPr>
            <a:xfrm>
              <a:off x="993075" y="0"/>
              <a:ext cx="9199121" cy="61860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2E865FA7-00E3-430D-9E72-698B119C4F3D}"/>
                </a:ext>
              </a:extLst>
            </p:cNvPr>
            <p:cNvGrpSpPr/>
            <p:nvPr/>
          </p:nvGrpSpPr>
          <p:grpSpPr>
            <a:xfrm>
              <a:off x="2820095" y="2179505"/>
              <a:ext cx="4256169" cy="2621153"/>
              <a:chOff x="7050449" y="2253181"/>
              <a:chExt cx="3569222" cy="2111122"/>
            </a:xfrm>
          </p:grpSpPr>
          <p:sp>
            <p:nvSpPr>
              <p:cNvPr id="13" name="流程图: 直接访问存储器 12">
                <a:extLst>
                  <a:ext uri="{FF2B5EF4-FFF2-40B4-BE49-F238E27FC236}">
                    <a16:creationId xmlns:a16="http://schemas.microsoft.com/office/drawing/2014/main" id="{2995664A-5AEC-4F41-B404-3EA20F49D096}"/>
                  </a:ext>
                </a:extLst>
              </p:cNvPr>
              <p:cNvSpPr/>
              <p:nvPr/>
            </p:nvSpPr>
            <p:spPr>
              <a:xfrm>
                <a:off x="9510091" y="2904391"/>
                <a:ext cx="134449" cy="132118"/>
              </a:xfrm>
              <a:prstGeom prst="flowChartMagneticDrum">
                <a:avLst/>
              </a:prstGeom>
              <a:solidFill>
                <a:srgbClr val="00B0F0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B660B9F1-2A0B-40F5-B63F-6E87E5258E22}"/>
                  </a:ext>
                </a:extLst>
              </p:cNvPr>
              <p:cNvGrpSpPr/>
              <p:nvPr/>
            </p:nvGrpSpPr>
            <p:grpSpPr>
              <a:xfrm>
                <a:off x="7050449" y="2253181"/>
                <a:ext cx="3569222" cy="2111122"/>
                <a:chOff x="4795764" y="3466927"/>
                <a:chExt cx="3569222" cy="2111122"/>
              </a:xfrm>
            </p:grpSpPr>
            <p:grpSp>
              <p:nvGrpSpPr>
                <p:cNvPr id="8" name="组合 7">
                  <a:extLst>
                    <a:ext uri="{FF2B5EF4-FFF2-40B4-BE49-F238E27FC236}">
                      <a16:creationId xmlns:a16="http://schemas.microsoft.com/office/drawing/2014/main" id="{13598C75-19BB-4409-94A3-3F04C043C1C3}"/>
                    </a:ext>
                  </a:extLst>
                </p:cNvPr>
                <p:cNvGrpSpPr/>
                <p:nvPr/>
              </p:nvGrpSpPr>
              <p:grpSpPr>
                <a:xfrm>
                  <a:off x="4795764" y="3533237"/>
                  <a:ext cx="1688963" cy="2044812"/>
                  <a:chOff x="1418953" y="416067"/>
                  <a:chExt cx="6934227" cy="9112094"/>
                </a:xfrm>
              </p:grpSpPr>
              <p:grpSp>
                <p:nvGrpSpPr>
                  <p:cNvPr id="6" name="组合 5">
                    <a:extLst>
                      <a:ext uri="{FF2B5EF4-FFF2-40B4-BE49-F238E27FC236}">
                        <a16:creationId xmlns:a16="http://schemas.microsoft.com/office/drawing/2014/main" id="{FA9218B6-461C-44FF-A678-64A4264E9B2B}"/>
                      </a:ext>
                    </a:extLst>
                  </p:cNvPr>
                  <p:cNvGrpSpPr/>
                  <p:nvPr/>
                </p:nvGrpSpPr>
                <p:grpSpPr>
                  <a:xfrm>
                    <a:off x="1418953" y="416067"/>
                    <a:ext cx="6934227" cy="9112094"/>
                    <a:chOff x="6718831" y="644442"/>
                    <a:chExt cx="4360870" cy="7470993"/>
                  </a:xfrm>
                </p:grpSpPr>
                <p:sp>
                  <p:nvSpPr>
                    <p:cNvPr id="4" name="任意多边形: 形状 3">
                      <a:extLst>
                        <a:ext uri="{FF2B5EF4-FFF2-40B4-BE49-F238E27FC236}">
                          <a16:creationId xmlns:a16="http://schemas.microsoft.com/office/drawing/2014/main" id="{9AE91241-A741-4F2B-AEDF-ADFAB1A828B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6718831" y="644442"/>
                      <a:ext cx="4360870" cy="7470993"/>
                    </a:xfrm>
                    <a:custGeom>
                      <a:avLst/>
                      <a:gdLst>
                        <a:gd name="connsiteX0" fmla="*/ 1433667 w 1936758"/>
                        <a:gd name="connsiteY0" fmla="*/ 750882 h 2648976"/>
                        <a:gd name="connsiteX1" fmla="*/ 1291427 w 1936758"/>
                        <a:gd name="connsiteY1" fmla="*/ 192082 h 2648976"/>
                        <a:gd name="connsiteX2" fmla="*/ 925667 w 1936758"/>
                        <a:gd name="connsiteY2" fmla="*/ 9202 h 2648976"/>
                        <a:gd name="connsiteX3" fmla="*/ 580227 w 1936758"/>
                        <a:gd name="connsiteY3" fmla="*/ 435922 h 2648976"/>
                        <a:gd name="connsiteX4" fmla="*/ 397347 w 1936758"/>
                        <a:gd name="connsiteY4" fmla="*/ 954082 h 2648976"/>
                        <a:gd name="connsiteX5" fmla="*/ 316067 w 1936758"/>
                        <a:gd name="connsiteY5" fmla="*/ 1330002 h 2648976"/>
                        <a:gd name="connsiteX6" fmla="*/ 610707 w 1936758"/>
                        <a:gd name="connsiteY6" fmla="*/ 1330002 h 2648976"/>
                        <a:gd name="connsiteX7" fmla="*/ 803747 w 1936758"/>
                        <a:gd name="connsiteY7" fmla="*/ 1299522 h 2648976"/>
                        <a:gd name="connsiteX8" fmla="*/ 1057747 w 1936758"/>
                        <a:gd name="connsiteY8" fmla="*/ 1238562 h 2648976"/>
                        <a:gd name="connsiteX9" fmla="*/ 1210147 w 1936758"/>
                        <a:gd name="connsiteY9" fmla="*/ 1136962 h 2648976"/>
                        <a:gd name="connsiteX10" fmla="*/ 1301587 w 1936758"/>
                        <a:gd name="connsiteY10" fmla="*/ 1004882 h 2648976"/>
                        <a:gd name="connsiteX11" fmla="*/ 1362547 w 1936758"/>
                        <a:gd name="connsiteY11" fmla="*/ 913442 h 2648976"/>
                        <a:gd name="connsiteX12" fmla="*/ 1240627 w 1936758"/>
                        <a:gd name="connsiteY12" fmla="*/ 1157282 h 2648976"/>
                        <a:gd name="connsiteX13" fmla="*/ 1088227 w 1936758"/>
                        <a:gd name="connsiteY13" fmla="*/ 1258882 h 2648976"/>
                        <a:gd name="connsiteX14" fmla="*/ 813907 w 1936758"/>
                        <a:gd name="connsiteY14" fmla="*/ 1340162 h 2648976"/>
                        <a:gd name="connsiteX15" fmla="*/ 265267 w 1936758"/>
                        <a:gd name="connsiteY15" fmla="*/ 1401122 h 2648976"/>
                        <a:gd name="connsiteX16" fmla="*/ 102707 w 1936758"/>
                        <a:gd name="connsiteY16" fmla="*/ 1919282 h 2648976"/>
                        <a:gd name="connsiteX17" fmla="*/ 51907 w 1936758"/>
                        <a:gd name="connsiteY17" fmla="*/ 2315522 h 2648976"/>
                        <a:gd name="connsiteX18" fmla="*/ 1107 w 1936758"/>
                        <a:gd name="connsiteY18" fmla="*/ 2467922 h 2648976"/>
                        <a:gd name="connsiteX19" fmla="*/ 102707 w 1936758"/>
                        <a:gd name="connsiteY19" fmla="*/ 2640642 h 2648976"/>
                        <a:gd name="connsiteX20" fmla="*/ 295747 w 1936758"/>
                        <a:gd name="connsiteY20" fmla="*/ 2610162 h 2648976"/>
                        <a:gd name="connsiteX21" fmla="*/ 549747 w 1936758"/>
                        <a:gd name="connsiteY21" fmla="*/ 2508562 h 2648976"/>
                        <a:gd name="connsiteX22" fmla="*/ 732627 w 1936758"/>
                        <a:gd name="connsiteY22" fmla="*/ 2528882 h 2648976"/>
                        <a:gd name="connsiteX23" fmla="*/ 1352387 w 1936758"/>
                        <a:gd name="connsiteY23" fmla="*/ 2254562 h 2648976"/>
                        <a:gd name="connsiteX24" fmla="*/ 1433667 w 1936758"/>
                        <a:gd name="connsiteY24" fmla="*/ 1959922 h 2648976"/>
                        <a:gd name="connsiteX25" fmla="*/ 1443827 w 1936758"/>
                        <a:gd name="connsiteY25" fmla="*/ 1573842 h 2648976"/>
                        <a:gd name="connsiteX26" fmla="*/ 1443827 w 1936758"/>
                        <a:gd name="connsiteY26" fmla="*/ 1238562 h 2648976"/>
                        <a:gd name="connsiteX27" fmla="*/ 1433667 w 1936758"/>
                        <a:gd name="connsiteY27" fmla="*/ 1086162 h 2648976"/>
                        <a:gd name="connsiteX28" fmla="*/ 1697827 w 1936758"/>
                        <a:gd name="connsiteY28" fmla="*/ 1025202 h 2648976"/>
                        <a:gd name="connsiteX29" fmla="*/ 1718147 w 1936758"/>
                        <a:gd name="connsiteY29" fmla="*/ 913442 h 2648976"/>
                        <a:gd name="connsiteX30" fmla="*/ 1545427 w 1936758"/>
                        <a:gd name="connsiteY30" fmla="*/ 923602 h 2648976"/>
                        <a:gd name="connsiteX31" fmla="*/ 1433667 w 1936758"/>
                        <a:gd name="connsiteY31" fmla="*/ 954082 h 2648976"/>
                        <a:gd name="connsiteX32" fmla="*/ 1433667 w 1936758"/>
                        <a:gd name="connsiteY32" fmla="*/ 893122 h 2648976"/>
                        <a:gd name="connsiteX33" fmla="*/ 1433667 w 1936758"/>
                        <a:gd name="connsiteY33" fmla="*/ 913442 h 2648976"/>
                        <a:gd name="connsiteX34" fmla="*/ 1555587 w 1936758"/>
                        <a:gd name="connsiteY34" fmla="*/ 882962 h 2648976"/>
                        <a:gd name="connsiteX35" fmla="*/ 1647027 w 1936758"/>
                        <a:gd name="connsiteY35" fmla="*/ 842322 h 2648976"/>
                        <a:gd name="connsiteX36" fmla="*/ 1748627 w 1936758"/>
                        <a:gd name="connsiteY36" fmla="*/ 740722 h 2648976"/>
                        <a:gd name="connsiteX37" fmla="*/ 1901027 w 1936758"/>
                        <a:gd name="connsiteY37" fmla="*/ 496882 h 2648976"/>
                        <a:gd name="connsiteX38" fmla="*/ 1931507 w 1936758"/>
                        <a:gd name="connsiteY38" fmla="*/ 425762 h 2648976"/>
                        <a:gd name="connsiteX39" fmla="*/ 1819747 w 1936758"/>
                        <a:gd name="connsiteY39" fmla="*/ 385122 h 2648976"/>
                        <a:gd name="connsiteX40" fmla="*/ 1697827 w 1936758"/>
                        <a:gd name="connsiteY40" fmla="*/ 608642 h 2648976"/>
                        <a:gd name="connsiteX41" fmla="*/ 1606387 w 1936758"/>
                        <a:gd name="connsiteY41" fmla="*/ 720402 h 2648976"/>
                        <a:gd name="connsiteX42" fmla="*/ 1433667 w 1936758"/>
                        <a:gd name="connsiteY42" fmla="*/ 750882 h 2648976"/>
                        <a:gd name="connsiteX0" fmla="*/ 1433667 w 1936758"/>
                        <a:gd name="connsiteY0" fmla="*/ 750882 h 2648976"/>
                        <a:gd name="connsiteX1" fmla="*/ 1291427 w 1936758"/>
                        <a:gd name="connsiteY1" fmla="*/ 192082 h 2648976"/>
                        <a:gd name="connsiteX2" fmla="*/ 925667 w 1936758"/>
                        <a:gd name="connsiteY2" fmla="*/ 9202 h 2648976"/>
                        <a:gd name="connsiteX3" fmla="*/ 580227 w 1936758"/>
                        <a:gd name="connsiteY3" fmla="*/ 435922 h 2648976"/>
                        <a:gd name="connsiteX4" fmla="*/ 397347 w 1936758"/>
                        <a:gd name="connsiteY4" fmla="*/ 954082 h 2648976"/>
                        <a:gd name="connsiteX5" fmla="*/ 316067 w 1936758"/>
                        <a:gd name="connsiteY5" fmla="*/ 1330002 h 2648976"/>
                        <a:gd name="connsiteX6" fmla="*/ 610707 w 1936758"/>
                        <a:gd name="connsiteY6" fmla="*/ 1330002 h 2648976"/>
                        <a:gd name="connsiteX7" fmla="*/ 803747 w 1936758"/>
                        <a:gd name="connsiteY7" fmla="*/ 1299522 h 2648976"/>
                        <a:gd name="connsiteX8" fmla="*/ 1057747 w 1936758"/>
                        <a:gd name="connsiteY8" fmla="*/ 1238562 h 2648976"/>
                        <a:gd name="connsiteX9" fmla="*/ 1210147 w 1936758"/>
                        <a:gd name="connsiteY9" fmla="*/ 1136962 h 2648976"/>
                        <a:gd name="connsiteX10" fmla="*/ 1301587 w 1936758"/>
                        <a:gd name="connsiteY10" fmla="*/ 1004882 h 2648976"/>
                        <a:gd name="connsiteX11" fmla="*/ 1362547 w 1936758"/>
                        <a:gd name="connsiteY11" fmla="*/ 913442 h 2648976"/>
                        <a:gd name="connsiteX12" fmla="*/ 1240627 w 1936758"/>
                        <a:gd name="connsiteY12" fmla="*/ 1157282 h 2648976"/>
                        <a:gd name="connsiteX13" fmla="*/ 1088227 w 1936758"/>
                        <a:gd name="connsiteY13" fmla="*/ 1258882 h 2648976"/>
                        <a:gd name="connsiteX14" fmla="*/ 813907 w 1936758"/>
                        <a:gd name="connsiteY14" fmla="*/ 1340162 h 2648976"/>
                        <a:gd name="connsiteX15" fmla="*/ 265267 w 1936758"/>
                        <a:gd name="connsiteY15" fmla="*/ 1401122 h 2648976"/>
                        <a:gd name="connsiteX16" fmla="*/ 102707 w 1936758"/>
                        <a:gd name="connsiteY16" fmla="*/ 1919282 h 2648976"/>
                        <a:gd name="connsiteX17" fmla="*/ 51907 w 1936758"/>
                        <a:gd name="connsiteY17" fmla="*/ 2315522 h 2648976"/>
                        <a:gd name="connsiteX18" fmla="*/ 1107 w 1936758"/>
                        <a:gd name="connsiteY18" fmla="*/ 2467922 h 2648976"/>
                        <a:gd name="connsiteX19" fmla="*/ 102707 w 1936758"/>
                        <a:gd name="connsiteY19" fmla="*/ 2640642 h 2648976"/>
                        <a:gd name="connsiteX20" fmla="*/ 295747 w 1936758"/>
                        <a:gd name="connsiteY20" fmla="*/ 2610162 h 2648976"/>
                        <a:gd name="connsiteX21" fmla="*/ 549747 w 1936758"/>
                        <a:gd name="connsiteY21" fmla="*/ 2508562 h 2648976"/>
                        <a:gd name="connsiteX22" fmla="*/ 751394 w 1936758"/>
                        <a:gd name="connsiteY22" fmla="*/ 2448464 h 2648976"/>
                        <a:gd name="connsiteX23" fmla="*/ 1352387 w 1936758"/>
                        <a:gd name="connsiteY23" fmla="*/ 2254562 h 2648976"/>
                        <a:gd name="connsiteX24" fmla="*/ 1433667 w 1936758"/>
                        <a:gd name="connsiteY24" fmla="*/ 1959922 h 2648976"/>
                        <a:gd name="connsiteX25" fmla="*/ 1443827 w 1936758"/>
                        <a:gd name="connsiteY25" fmla="*/ 1573842 h 2648976"/>
                        <a:gd name="connsiteX26" fmla="*/ 1443827 w 1936758"/>
                        <a:gd name="connsiteY26" fmla="*/ 1238562 h 2648976"/>
                        <a:gd name="connsiteX27" fmla="*/ 1433667 w 1936758"/>
                        <a:gd name="connsiteY27" fmla="*/ 1086162 h 2648976"/>
                        <a:gd name="connsiteX28" fmla="*/ 1697827 w 1936758"/>
                        <a:gd name="connsiteY28" fmla="*/ 1025202 h 2648976"/>
                        <a:gd name="connsiteX29" fmla="*/ 1718147 w 1936758"/>
                        <a:gd name="connsiteY29" fmla="*/ 913442 h 2648976"/>
                        <a:gd name="connsiteX30" fmla="*/ 1545427 w 1936758"/>
                        <a:gd name="connsiteY30" fmla="*/ 923602 h 2648976"/>
                        <a:gd name="connsiteX31" fmla="*/ 1433667 w 1936758"/>
                        <a:gd name="connsiteY31" fmla="*/ 954082 h 2648976"/>
                        <a:gd name="connsiteX32" fmla="*/ 1433667 w 1936758"/>
                        <a:gd name="connsiteY32" fmla="*/ 893122 h 2648976"/>
                        <a:gd name="connsiteX33" fmla="*/ 1433667 w 1936758"/>
                        <a:gd name="connsiteY33" fmla="*/ 913442 h 2648976"/>
                        <a:gd name="connsiteX34" fmla="*/ 1555587 w 1936758"/>
                        <a:gd name="connsiteY34" fmla="*/ 882962 h 2648976"/>
                        <a:gd name="connsiteX35" fmla="*/ 1647027 w 1936758"/>
                        <a:gd name="connsiteY35" fmla="*/ 842322 h 2648976"/>
                        <a:gd name="connsiteX36" fmla="*/ 1748627 w 1936758"/>
                        <a:gd name="connsiteY36" fmla="*/ 740722 h 2648976"/>
                        <a:gd name="connsiteX37" fmla="*/ 1901027 w 1936758"/>
                        <a:gd name="connsiteY37" fmla="*/ 496882 h 2648976"/>
                        <a:gd name="connsiteX38" fmla="*/ 1931507 w 1936758"/>
                        <a:gd name="connsiteY38" fmla="*/ 425762 h 2648976"/>
                        <a:gd name="connsiteX39" fmla="*/ 1819747 w 1936758"/>
                        <a:gd name="connsiteY39" fmla="*/ 385122 h 2648976"/>
                        <a:gd name="connsiteX40" fmla="*/ 1697827 w 1936758"/>
                        <a:gd name="connsiteY40" fmla="*/ 608642 h 2648976"/>
                        <a:gd name="connsiteX41" fmla="*/ 1606387 w 1936758"/>
                        <a:gd name="connsiteY41" fmla="*/ 720402 h 2648976"/>
                        <a:gd name="connsiteX42" fmla="*/ 1433667 w 1936758"/>
                        <a:gd name="connsiteY42" fmla="*/ 750882 h 2648976"/>
                        <a:gd name="connsiteX0" fmla="*/ 1404783 w 1907874"/>
                        <a:gd name="connsiteY0" fmla="*/ 750882 h 2648976"/>
                        <a:gd name="connsiteX1" fmla="*/ 1262543 w 1907874"/>
                        <a:gd name="connsiteY1" fmla="*/ 192082 h 2648976"/>
                        <a:gd name="connsiteX2" fmla="*/ 896783 w 1907874"/>
                        <a:gd name="connsiteY2" fmla="*/ 9202 h 2648976"/>
                        <a:gd name="connsiteX3" fmla="*/ 551343 w 1907874"/>
                        <a:gd name="connsiteY3" fmla="*/ 435922 h 2648976"/>
                        <a:gd name="connsiteX4" fmla="*/ 368463 w 1907874"/>
                        <a:gd name="connsiteY4" fmla="*/ 954082 h 2648976"/>
                        <a:gd name="connsiteX5" fmla="*/ 287183 w 1907874"/>
                        <a:gd name="connsiteY5" fmla="*/ 1330002 h 2648976"/>
                        <a:gd name="connsiteX6" fmla="*/ 581823 w 1907874"/>
                        <a:gd name="connsiteY6" fmla="*/ 1330002 h 2648976"/>
                        <a:gd name="connsiteX7" fmla="*/ 774863 w 1907874"/>
                        <a:gd name="connsiteY7" fmla="*/ 1299522 h 2648976"/>
                        <a:gd name="connsiteX8" fmla="*/ 1028863 w 1907874"/>
                        <a:gd name="connsiteY8" fmla="*/ 1238562 h 2648976"/>
                        <a:gd name="connsiteX9" fmla="*/ 1181263 w 1907874"/>
                        <a:gd name="connsiteY9" fmla="*/ 1136962 h 2648976"/>
                        <a:gd name="connsiteX10" fmla="*/ 1272703 w 1907874"/>
                        <a:gd name="connsiteY10" fmla="*/ 1004882 h 2648976"/>
                        <a:gd name="connsiteX11" fmla="*/ 1333663 w 1907874"/>
                        <a:gd name="connsiteY11" fmla="*/ 913442 h 2648976"/>
                        <a:gd name="connsiteX12" fmla="*/ 1211743 w 1907874"/>
                        <a:gd name="connsiteY12" fmla="*/ 1157282 h 2648976"/>
                        <a:gd name="connsiteX13" fmla="*/ 1059343 w 1907874"/>
                        <a:gd name="connsiteY13" fmla="*/ 1258882 h 2648976"/>
                        <a:gd name="connsiteX14" fmla="*/ 785023 w 1907874"/>
                        <a:gd name="connsiteY14" fmla="*/ 1340162 h 2648976"/>
                        <a:gd name="connsiteX15" fmla="*/ 236383 w 1907874"/>
                        <a:gd name="connsiteY15" fmla="*/ 1401122 h 2648976"/>
                        <a:gd name="connsiteX16" fmla="*/ 73823 w 1907874"/>
                        <a:gd name="connsiteY16" fmla="*/ 1919282 h 2648976"/>
                        <a:gd name="connsiteX17" fmla="*/ 23023 w 1907874"/>
                        <a:gd name="connsiteY17" fmla="*/ 2315522 h 2648976"/>
                        <a:gd name="connsiteX18" fmla="*/ 2250 w 1907874"/>
                        <a:gd name="connsiteY18" fmla="*/ 2467922 h 2648976"/>
                        <a:gd name="connsiteX19" fmla="*/ 73823 w 1907874"/>
                        <a:gd name="connsiteY19" fmla="*/ 2640642 h 2648976"/>
                        <a:gd name="connsiteX20" fmla="*/ 266863 w 1907874"/>
                        <a:gd name="connsiteY20" fmla="*/ 2610162 h 2648976"/>
                        <a:gd name="connsiteX21" fmla="*/ 520863 w 1907874"/>
                        <a:gd name="connsiteY21" fmla="*/ 2508562 h 2648976"/>
                        <a:gd name="connsiteX22" fmla="*/ 722510 w 1907874"/>
                        <a:gd name="connsiteY22" fmla="*/ 2448464 h 2648976"/>
                        <a:gd name="connsiteX23" fmla="*/ 1323503 w 1907874"/>
                        <a:gd name="connsiteY23" fmla="*/ 2254562 h 2648976"/>
                        <a:gd name="connsiteX24" fmla="*/ 1404783 w 1907874"/>
                        <a:gd name="connsiteY24" fmla="*/ 1959922 h 2648976"/>
                        <a:gd name="connsiteX25" fmla="*/ 1414943 w 1907874"/>
                        <a:gd name="connsiteY25" fmla="*/ 1573842 h 2648976"/>
                        <a:gd name="connsiteX26" fmla="*/ 1414943 w 1907874"/>
                        <a:gd name="connsiteY26" fmla="*/ 1238562 h 2648976"/>
                        <a:gd name="connsiteX27" fmla="*/ 1404783 w 1907874"/>
                        <a:gd name="connsiteY27" fmla="*/ 1086162 h 2648976"/>
                        <a:gd name="connsiteX28" fmla="*/ 1668943 w 1907874"/>
                        <a:gd name="connsiteY28" fmla="*/ 1025202 h 2648976"/>
                        <a:gd name="connsiteX29" fmla="*/ 1689263 w 1907874"/>
                        <a:gd name="connsiteY29" fmla="*/ 913442 h 2648976"/>
                        <a:gd name="connsiteX30" fmla="*/ 1516543 w 1907874"/>
                        <a:gd name="connsiteY30" fmla="*/ 923602 h 2648976"/>
                        <a:gd name="connsiteX31" fmla="*/ 1404783 w 1907874"/>
                        <a:gd name="connsiteY31" fmla="*/ 954082 h 2648976"/>
                        <a:gd name="connsiteX32" fmla="*/ 1404783 w 1907874"/>
                        <a:gd name="connsiteY32" fmla="*/ 893122 h 2648976"/>
                        <a:gd name="connsiteX33" fmla="*/ 1404783 w 1907874"/>
                        <a:gd name="connsiteY33" fmla="*/ 913442 h 2648976"/>
                        <a:gd name="connsiteX34" fmla="*/ 1526703 w 1907874"/>
                        <a:gd name="connsiteY34" fmla="*/ 882962 h 2648976"/>
                        <a:gd name="connsiteX35" fmla="*/ 1618143 w 1907874"/>
                        <a:gd name="connsiteY35" fmla="*/ 842322 h 2648976"/>
                        <a:gd name="connsiteX36" fmla="*/ 1719743 w 1907874"/>
                        <a:gd name="connsiteY36" fmla="*/ 740722 h 2648976"/>
                        <a:gd name="connsiteX37" fmla="*/ 1872143 w 1907874"/>
                        <a:gd name="connsiteY37" fmla="*/ 496882 h 2648976"/>
                        <a:gd name="connsiteX38" fmla="*/ 1902623 w 1907874"/>
                        <a:gd name="connsiteY38" fmla="*/ 425762 h 2648976"/>
                        <a:gd name="connsiteX39" fmla="*/ 1790863 w 1907874"/>
                        <a:gd name="connsiteY39" fmla="*/ 385122 h 2648976"/>
                        <a:gd name="connsiteX40" fmla="*/ 1668943 w 1907874"/>
                        <a:gd name="connsiteY40" fmla="*/ 608642 h 2648976"/>
                        <a:gd name="connsiteX41" fmla="*/ 1577503 w 1907874"/>
                        <a:gd name="connsiteY41" fmla="*/ 720402 h 2648976"/>
                        <a:gd name="connsiteX42" fmla="*/ 1404783 w 1907874"/>
                        <a:gd name="connsiteY42" fmla="*/ 750882 h 2648976"/>
                        <a:gd name="connsiteX0" fmla="*/ 1405316 w 1908407"/>
                        <a:gd name="connsiteY0" fmla="*/ 750882 h 2648976"/>
                        <a:gd name="connsiteX1" fmla="*/ 1263076 w 1908407"/>
                        <a:gd name="connsiteY1" fmla="*/ 192082 h 2648976"/>
                        <a:gd name="connsiteX2" fmla="*/ 897316 w 1908407"/>
                        <a:gd name="connsiteY2" fmla="*/ 9202 h 2648976"/>
                        <a:gd name="connsiteX3" fmla="*/ 551876 w 1908407"/>
                        <a:gd name="connsiteY3" fmla="*/ 435922 h 2648976"/>
                        <a:gd name="connsiteX4" fmla="*/ 368996 w 1908407"/>
                        <a:gd name="connsiteY4" fmla="*/ 954082 h 2648976"/>
                        <a:gd name="connsiteX5" fmla="*/ 287716 w 1908407"/>
                        <a:gd name="connsiteY5" fmla="*/ 1330002 h 2648976"/>
                        <a:gd name="connsiteX6" fmla="*/ 582356 w 1908407"/>
                        <a:gd name="connsiteY6" fmla="*/ 1330002 h 2648976"/>
                        <a:gd name="connsiteX7" fmla="*/ 775396 w 1908407"/>
                        <a:gd name="connsiteY7" fmla="*/ 1299522 h 2648976"/>
                        <a:gd name="connsiteX8" fmla="*/ 1029396 w 1908407"/>
                        <a:gd name="connsiteY8" fmla="*/ 1238562 h 2648976"/>
                        <a:gd name="connsiteX9" fmla="*/ 1181796 w 1908407"/>
                        <a:gd name="connsiteY9" fmla="*/ 1136962 h 2648976"/>
                        <a:gd name="connsiteX10" fmla="*/ 1273236 w 1908407"/>
                        <a:gd name="connsiteY10" fmla="*/ 1004882 h 2648976"/>
                        <a:gd name="connsiteX11" fmla="*/ 1334196 w 1908407"/>
                        <a:gd name="connsiteY11" fmla="*/ 913442 h 2648976"/>
                        <a:gd name="connsiteX12" fmla="*/ 1212276 w 1908407"/>
                        <a:gd name="connsiteY12" fmla="*/ 1157282 h 2648976"/>
                        <a:gd name="connsiteX13" fmla="*/ 1059876 w 1908407"/>
                        <a:gd name="connsiteY13" fmla="*/ 1258882 h 2648976"/>
                        <a:gd name="connsiteX14" fmla="*/ 785556 w 1908407"/>
                        <a:gd name="connsiteY14" fmla="*/ 1340162 h 2648976"/>
                        <a:gd name="connsiteX15" fmla="*/ 236916 w 1908407"/>
                        <a:gd name="connsiteY15" fmla="*/ 1401122 h 2648976"/>
                        <a:gd name="connsiteX16" fmla="*/ 74356 w 1908407"/>
                        <a:gd name="connsiteY16" fmla="*/ 1919282 h 2648976"/>
                        <a:gd name="connsiteX17" fmla="*/ 23556 w 1908407"/>
                        <a:gd name="connsiteY17" fmla="*/ 2315522 h 2648976"/>
                        <a:gd name="connsiteX18" fmla="*/ 2783 w 1908407"/>
                        <a:gd name="connsiteY18" fmla="*/ 2467922 h 2648976"/>
                        <a:gd name="connsiteX19" fmla="*/ 74356 w 1908407"/>
                        <a:gd name="connsiteY19" fmla="*/ 2640642 h 2648976"/>
                        <a:gd name="connsiteX20" fmla="*/ 267396 w 1908407"/>
                        <a:gd name="connsiteY20" fmla="*/ 2610162 h 2648976"/>
                        <a:gd name="connsiteX21" fmla="*/ 521396 w 1908407"/>
                        <a:gd name="connsiteY21" fmla="*/ 2508562 h 2648976"/>
                        <a:gd name="connsiteX22" fmla="*/ 723043 w 1908407"/>
                        <a:gd name="connsiteY22" fmla="*/ 2448464 h 2648976"/>
                        <a:gd name="connsiteX23" fmla="*/ 1324036 w 1908407"/>
                        <a:gd name="connsiteY23" fmla="*/ 2254562 h 2648976"/>
                        <a:gd name="connsiteX24" fmla="*/ 1405316 w 1908407"/>
                        <a:gd name="connsiteY24" fmla="*/ 1959922 h 2648976"/>
                        <a:gd name="connsiteX25" fmla="*/ 1415476 w 1908407"/>
                        <a:gd name="connsiteY25" fmla="*/ 1573842 h 2648976"/>
                        <a:gd name="connsiteX26" fmla="*/ 1415476 w 1908407"/>
                        <a:gd name="connsiteY26" fmla="*/ 1238562 h 2648976"/>
                        <a:gd name="connsiteX27" fmla="*/ 1405316 w 1908407"/>
                        <a:gd name="connsiteY27" fmla="*/ 1086162 h 2648976"/>
                        <a:gd name="connsiteX28" fmla="*/ 1669476 w 1908407"/>
                        <a:gd name="connsiteY28" fmla="*/ 1025202 h 2648976"/>
                        <a:gd name="connsiteX29" fmla="*/ 1689796 w 1908407"/>
                        <a:gd name="connsiteY29" fmla="*/ 913442 h 2648976"/>
                        <a:gd name="connsiteX30" fmla="*/ 1517076 w 1908407"/>
                        <a:gd name="connsiteY30" fmla="*/ 923602 h 2648976"/>
                        <a:gd name="connsiteX31" fmla="*/ 1405316 w 1908407"/>
                        <a:gd name="connsiteY31" fmla="*/ 954082 h 2648976"/>
                        <a:gd name="connsiteX32" fmla="*/ 1405316 w 1908407"/>
                        <a:gd name="connsiteY32" fmla="*/ 893122 h 2648976"/>
                        <a:gd name="connsiteX33" fmla="*/ 1405316 w 1908407"/>
                        <a:gd name="connsiteY33" fmla="*/ 913442 h 2648976"/>
                        <a:gd name="connsiteX34" fmla="*/ 1527236 w 1908407"/>
                        <a:gd name="connsiteY34" fmla="*/ 882962 h 2648976"/>
                        <a:gd name="connsiteX35" fmla="*/ 1618676 w 1908407"/>
                        <a:gd name="connsiteY35" fmla="*/ 842322 h 2648976"/>
                        <a:gd name="connsiteX36" fmla="*/ 1720276 w 1908407"/>
                        <a:gd name="connsiteY36" fmla="*/ 740722 h 2648976"/>
                        <a:gd name="connsiteX37" fmla="*/ 1872676 w 1908407"/>
                        <a:gd name="connsiteY37" fmla="*/ 496882 h 2648976"/>
                        <a:gd name="connsiteX38" fmla="*/ 1903156 w 1908407"/>
                        <a:gd name="connsiteY38" fmla="*/ 425762 h 2648976"/>
                        <a:gd name="connsiteX39" fmla="*/ 1791396 w 1908407"/>
                        <a:gd name="connsiteY39" fmla="*/ 385122 h 2648976"/>
                        <a:gd name="connsiteX40" fmla="*/ 1669476 w 1908407"/>
                        <a:gd name="connsiteY40" fmla="*/ 608642 h 2648976"/>
                        <a:gd name="connsiteX41" fmla="*/ 1578036 w 1908407"/>
                        <a:gd name="connsiteY41" fmla="*/ 720402 h 2648976"/>
                        <a:gd name="connsiteX42" fmla="*/ 1405316 w 1908407"/>
                        <a:gd name="connsiteY42" fmla="*/ 750882 h 2648976"/>
                        <a:gd name="connsiteX0" fmla="*/ 1402712 w 1905803"/>
                        <a:gd name="connsiteY0" fmla="*/ 750882 h 2648976"/>
                        <a:gd name="connsiteX1" fmla="*/ 1260472 w 1905803"/>
                        <a:gd name="connsiteY1" fmla="*/ 192082 h 2648976"/>
                        <a:gd name="connsiteX2" fmla="*/ 894712 w 1905803"/>
                        <a:gd name="connsiteY2" fmla="*/ 9202 h 2648976"/>
                        <a:gd name="connsiteX3" fmla="*/ 549272 w 1905803"/>
                        <a:gd name="connsiteY3" fmla="*/ 435922 h 2648976"/>
                        <a:gd name="connsiteX4" fmla="*/ 366392 w 1905803"/>
                        <a:gd name="connsiteY4" fmla="*/ 954082 h 2648976"/>
                        <a:gd name="connsiteX5" fmla="*/ 285112 w 1905803"/>
                        <a:gd name="connsiteY5" fmla="*/ 1330002 h 2648976"/>
                        <a:gd name="connsiteX6" fmla="*/ 579752 w 1905803"/>
                        <a:gd name="connsiteY6" fmla="*/ 1330002 h 2648976"/>
                        <a:gd name="connsiteX7" fmla="*/ 772792 w 1905803"/>
                        <a:gd name="connsiteY7" fmla="*/ 1299522 h 2648976"/>
                        <a:gd name="connsiteX8" fmla="*/ 1026792 w 1905803"/>
                        <a:gd name="connsiteY8" fmla="*/ 1238562 h 2648976"/>
                        <a:gd name="connsiteX9" fmla="*/ 1179192 w 1905803"/>
                        <a:gd name="connsiteY9" fmla="*/ 1136962 h 2648976"/>
                        <a:gd name="connsiteX10" fmla="*/ 1270632 w 1905803"/>
                        <a:gd name="connsiteY10" fmla="*/ 1004882 h 2648976"/>
                        <a:gd name="connsiteX11" fmla="*/ 1331592 w 1905803"/>
                        <a:gd name="connsiteY11" fmla="*/ 913442 h 2648976"/>
                        <a:gd name="connsiteX12" fmla="*/ 1209672 w 1905803"/>
                        <a:gd name="connsiteY12" fmla="*/ 1157282 h 2648976"/>
                        <a:gd name="connsiteX13" fmla="*/ 1057272 w 1905803"/>
                        <a:gd name="connsiteY13" fmla="*/ 1258882 h 2648976"/>
                        <a:gd name="connsiteX14" fmla="*/ 782952 w 1905803"/>
                        <a:gd name="connsiteY14" fmla="*/ 1340162 h 2648976"/>
                        <a:gd name="connsiteX15" fmla="*/ 234312 w 1905803"/>
                        <a:gd name="connsiteY15" fmla="*/ 1401122 h 2648976"/>
                        <a:gd name="connsiteX16" fmla="*/ 71752 w 1905803"/>
                        <a:gd name="connsiteY16" fmla="*/ 1919282 h 2648976"/>
                        <a:gd name="connsiteX17" fmla="*/ 20952 w 1905803"/>
                        <a:gd name="connsiteY17" fmla="*/ 2315522 h 2648976"/>
                        <a:gd name="connsiteX18" fmla="*/ 179 w 1905803"/>
                        <a:gd name="connsiteY18" fmla="*/ 2467922 h 2648976"/>
                        <a:gd name="connsiteX19" fmla="*/ 71752 w 1905803"/>
                        <a:gd name="connsiteY19" fmla="*/ 2640642 h 2648976"/>
                        <a:gd name="connsiteX20" fmla="*/ 264792 w 1905803"/>
                        <a:gd name="connsiteY20" fmla="*/ 2610162 h 2648976"/>
                        <a:gd name="connsiteX21" fmla="*/ 518792 w 1905803"/>
                        <a:gd name="connsiteY21" fmla="*/ 2508562 h 2648976"/>
                        <a:gd name="connsiteX22" fmla="*/ 720439 w 1905803"/>
                        <a:gd name="connsiteY22" fmla="*/ 2448464 h 2648976"/>
                        <a:gd name="connsiteX23" fmla="*/ 1321432 w 1905803"/>
                        <a:gd name="connsiteY23" fmla="*/ 2254562 h 2648976"/>
                        <a:gd name="connsiteX24" fmla="*/ 1402712 w 1905803"/>
                        <a:gd name="connsiteY24" fmla="*/ 1959922 h 2648976"/>
                        <a:gd name="connsiteX25" fmla="*/ 1412872 w 1905803"/>
                        <a:gd name="connsiteY25" fmla="*/ 1573842 h 2648976"/>
                        <a:gd name="connsiteX26" fmla="*/ 1412872 w 1905803"/>
                        <a:gd name="connsiteY26" fmla="*/ 1238562 h 2648976"/>
                        <a:gd name="connsiteX27" fmla="*/ 1402712 w 1905803"/>
                        <a:gd name="connsiteY27" fmla="*/ 1086162 h 2648976"/>
                        <a:gd name="connsiteX28" fmla="*/ 1666872 w 1905803"/>
                        <a:gd name="connsiteY28" fmla="*/ 1025202 h 2648976"/>
                        <a:gd name="connsiteX29" fmla="*/ 1687192 w 1905803"/>
                        <a:gd name="connsiteY29" fmla="*/ 913442 h 2648976"/>
                        <a:gd name="connsiteX30" fmla="*/ 1514472 w 1905803"/>
                        <a:gd name="connsiteY30" fmla="*/ 923602 h 2648976"/>
                        <a:gd name="connsiteX31" fmla="*/ 1402712 w 1905803"/>
                        <a:gd name="connsiteY31" fmla="*/ 954082 h 2648976"/>
                        <a:gd name="connsiteX32" fmla="*/ 1402712 w 1905803"/>
                        <a:gd name="connsiteY32" fmla="*/ 893122 h 2648976"/>
                        <a:gd name="connsiteX33" fmla="*/ 1402712 w 1905803"/>
                        <a:gd name="connsiteY33" fmla="*/ 913442 h 2648976"/>
                        <a:gd name="connsiteX34" fmla="*/ 1524632 w 1905803"/>
                        <a:gd name="connsiteY34" fmla="*/ 882962 h 2648976"/>
                        <a:gd name="connsiteX35" fmla="*/ 1616072 w 1905803"/>
                        <a:gd name="connsiteY35" fmla="*/ 842322 h 2648976"/>
                        <a:gd name="connsiteX36" fmla="*/ 1717672 w 1905803"/>
                        <a:gd name="connsiteY36" fmla="*/ 740722 h 2648976"/>
                        <a:gd name="connsiteX37" fmla="*/ 1870072 w 1905803"/>
                        <a:gd name="connsiteY37" fmla="*/ 496882 h 2648976"/>
                        <a:gd name="connsiteX38" fmla="*/ 1900552 w 1905803"/>
                        <a:gd name="connsiteY38" fmla="*/ 425762 h 2648976"/>
                        <a:gd name="connsiteX39" fmla="*/ 1788792 w 1905803"/>
                        <a:gd name="connsiteY39" fmla="*/ 385122 h 2648976"/>
                        <a:gd name="connsiteX40" fmla="*/ 1666872 w 1905803"/>
                        <a:gd name="connsiteY40" fmla="*/ 608642 h 2648976"/>
                        <a:gd name="connsiteX41" fmla="*/ 1575432 w 1905803"/>
                        <a:gd name="connsiteY41" fmla="*/ 720402 h 2648976"/>
                        <a:gd name="connsiteX42" fmla="*/ 1402712 w 1905803"/>
                        <a:gd name="connsiteY42" fmla="*/ 750882 h 2648976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3000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1537 w 1917668"/>
                        <a:gd name="connsiteY12" fmla="*/ 1157282 h 2660273"/>
                        <a:gd name="connsiteX13" fmla="*/ 1069137 w 1917668"/>
                        <a:gd name="connsiteY13" fmla="*/ 1258882 h 2660273"/>
                        <a:gd name="connsiteX14" fmla="*/ 794817 w 1917668"/>
                        <a:gd name="connsiteY14" fmla="*/ 1340162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3000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1537 w 1917668"/>
                        <a:gd name="connsiteY12" fmla="*/ 1157282 h 2660273"/>
                        <a:gd name="connsiteX13" fmla="*/ 1069137 w 1917668"/>
                        <a:gd name="connsiteY13" fmla="*/ 1258882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3000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1537 w 1917668"/>
                        <a:gd name="connsiteY12" fmla="*/ 1157282 h 2660273"/>
                        <a:gd name="connsiteX13" fmla="*/ 1069137 w 1917668"/>
                        <a:gd name="connsiteY13" fmla="*/ 1258882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3000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1537 w 1917668"/>
                        <a:gd name="connsiteY12" fmla="*/ 115728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3000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1537 w 1917668"/>
                        <a:gd name="connsiteY12" fmla="*/ 115728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3000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4693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4693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91617 w 1917668"/>
                        <a:gd name="connsiteY6" fmla="*/ 1346932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80357 w 1917668"/>
                        <a:gd name="connsiteY6" fmla="*/ 1325769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80357 w 1917668"/>
                        <a:gd name="connsiteY6" fmla="*/ 1325769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76603 w 1917668"/>
                        <a:gd name="connsiteY6" fmla="*/ 1308839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577 w 1917668"/>
                        <a:gd name="connsiteY0" fmla="*/ 750882 h 2660273"/>
                        <a:gd name="connsiteX1" fmla="*/ 1272337 w 1917668"/>
                        <a:gd name="connsiteY1" fmla="*/ 192082 h 2660273"/>
                        <a:gd name="connsiteX2" fmla="*/ 906577 w 1917668"/>
                        <a:gd name="connsiteY2" fmla="*/ 9202 h 2660273"/>
                        <a:gd name="connsiteX3" fmla="*/ 561137 w 1917668"/>
                        <a:gd name="connsiteY3" fmla="*/ 435922 h 2660273"/>
                        <a:gd name="connsiteX4" fmla="*/ 378257 w 1917668"/>
                        <a:gd name="connsiteY4" fmla="*/ 954082 h 2660273"/>
                        <a:gd name="connsiteX5" fmla="*/ 296977 w 1917668"/>
                        <a:gd name="connsiteY5" fmla="*/ 1330002 h 2660273"/>
                        <a:gd name="connsiteX6" fmla="*/ 576603 w 1917668"/>
                        <a:gd name="connsiteY6" fmla="*/ 1308839 h 2660273"/>
                        <a:gd name="connsiteX7" fmla="*/ 784657 w 1917668"/>
                        <a:gd name="connsiteY7" fmla="*/ 1299522 h 2660273"/>
                        <a:gd name="connsiteX8" fmla="*/ 1038657 w 1917668"/>
                        <a:gd name="connsiteY8" fmla="*/ 1238562 h 2660273"/>
                        <a:gd name="connsiteX9" fmla="*/ 1191057 w 1917668"/>
                        <a:gd name="connsiteY9" fmla="*/ 1136962 h 2660273"/>
                        <a:gd name="connsiteX10" fmla="*/ 1282497 w 1917668"/>
                        <a:gd name="connsiteY10" fmla="*/ 1004882 h 2660273"/>
                        <a:gd name="connsiteX11" fmla="*/ 1343457 w 1917668"/>
                        <a:gd name="connsiteY11" fmla="*/ 913442 h 2660273"/>
                        <a:gd name="connsiteX12" fmla="*/ 1225290 w 1917668"/>
                        <a:gd name="connsiteY12" fmla="*/ 1123422 h 2660273"/>
                        <a:gd name="connsiteX13" fmla="*/ 1069137 w 1917668"/>
                        <a:gd name="connsiteY13" fmla="*/ 1250417 h 2660273"/>
                        <a:gd name="connsiteX14" fmla="*/ 809831 w 1917668"/>
                        <a:gd name="connsiteY14" fmla="*/ 1314767 h 2660273"/>
                        <a:gd name="connsiteX15" fmla="*/ 246177 w 1917668"/>
                        <a:gd name="connsiteY15" fmla="*/ 1401122 h 2660273"/>
                        <a:gd name="connsiteX16" fmla="*/ 83617 w 1917668"/>
                        <a:gd name="connsiteY16" fmla="*/ 1919282 h 2660273"/>
                        <a:gd name="connsiteX17" fmla="*/ 32817 w 1917668"/>
                        <a:gd name="connsiteY17" fmla="*/ 2315522 h 2660273"/>
                        <a:gd name="connsiteX18" fmla="*/ 12044 w 1917668"/>
                        <a:gd name="connsiteY18" fmla="*/ 2467922 h 2660273"/>
                        <a:gd name="connsiteX19" fmla="*/ 23563 w 1917668"/>
                        <a:gd name="connsiteY19" fmla="*/ 2653340 h 2660273"/>
                        <a:gd name="connsiteX20" fmla="*/ 276657 w 1917668"/>
                        <a:gd name="connsiteY20" fmla="*/ 2610162 h 2660273"/>
                        <a:gd name="connsiteX21" fmla="*/ 530657 w 1917668"/>
                        <a:gd name="connsiteY21" fmla="*/ 2508562 h 2660273"/>
                        <a:gd name="connsiteX22" fmla="*/ 732304 w 1917668"/>
                        <a:gd name="connsiteY22" fmla="*/ 2448464 h 2660273"/>
                        <a:gd name="connsiteX23" fmla="*/ 1333297 w 1917668"/>
                        <a:gd name="connsiteY23" fmla="*/ 2254562 h 2660273"/>
                        <a:gd name="connsiteX24" fmla="*/ 1414577 w 1917668"/>
                        <a:gd name="connsiteY24" fmla="*/ 1959922 h 2660273"/>
                        <a:gd name="connsiteX25" fmla="*/ 1424737 w 1917668"/>
                        <a:gd name="connsiteY25" fmla="*/ 1573842 h 2660273"/>
                        <a:gd name="connsiteX26" fmla="*/ 1424737 w 1917668"/>
                        <a:gd name="connsiteY26" fmla="*/ 1238562 h 2660273"/>
                        <a:gd name="connsiteX27" fmla="*/ 1414577 w 1917668"/>
                        <a:gd name="connsiteY27" fmla="*/ 1086162 h 2660273"/>
                        <a:gd name="connsiteX28" fmla="*/ 1678737 w 1917668"/>
                        <a:gd name="connsiteY28" fmla="*/ 1025202 h 2660273"/>
                        <a:gd name="connsiteX29" fmla="*/ 1699057 w 1917668"/>
                        <a:gd name="connsiteY29" fmla="*/ 913442 h 2660273"/>
                        <a:gd name="connsiteX30" fmla="*/ 1526337 w 1917668"/>
                        <a:gd name="connsiteY30" fmla="*/ 923602 h 2660273"/>
                        <a:gd name="connsiteX31" fmla="*/ 1414577 w 1917668"/>
                        <a:gd name="connsiteY31" fmla="*/ 954082 h 2660273"/>
                        <a:gd name="connsiteX32" fmla="*/ 1414577 w 1917668"/>
                        <a:gd name="connsiteY32" fmla="*/ 893122 h 2660273"/>
                        <a:gd name="connsiteX33" fmla="*/ 1414577 w 1917668"/>
                        <a:gd name="connsiteY33" fmla="*/ 913442 h 2660273"/>
                        <a:gd name="connsiteX34" fmla="*/ 1536497 w 1917668"/>
                        <a:gd name="connsiteY34" fmla="*/ 882962 h 2660273"/>
                        <a:gd name="connsiteX35" fmla="*/ 1627937 w 1917668"/>
                        <a:gd name="connsiteY35" fmla="*/ 842322 h 2660273"/>
                        <a:gd name="connsiteX36" fmla="*/ 1729537 w 1917668"/>
                        <a:gd name="connsiteY36" fmla="*/ 740722 h 2660273"/>
                        <a:gd name="connsiteX37" fmla="*/ 1881937 w 1917668"/>
                        <a:gd name="connsiteY37" fmla="*/ 496882 h 2660273"/>
                        <a:gd name="connsiteX38" fmla="*/ 1912417 w 1917668"/>
                        <a:gd name="connsiteY38" fmla="*/ 425762 h 2660273"/>
                        <a:gd name="connsiteX39" fmla="*/ 1800657 w 1917668"/>
                        <a:gd name="connsiteY39" fmla="*/ 385122 h 2660273"/>
                        <a:gd name="connsiteX40" fmla="*/ 1678737 w 1917668"/>
                        <a:gd name="connsiteY40" fmla="*/ 608642 h 2660273"/>
                        <a:gd name="connsiteX41" fmla="*/ 1587297 w 1917668"/>
                        <a:gd name="connsiteY41" fmla="*/ 720402 h 2660273"/>
                        <a:gd name="connsiteX42" fmla="*/ 1414577 w 1917668"/>
                        <a:gd name="connsiteY42" fmla="*/ 750882 h 2660273"/>
                        <a:gd name="connsiteX0" fmla="*/ 1414025 w 1917116"/>
                        <a:gd name="connsiteY0" fmla="*/ 750882 h 2660273"/>
                        <a:gd name="connsiteX1" fmla="*/ 1271785 w 1917116"/>
                        <a:gd name="connsiteY1" fmla="*/ 192082 h 2660273"/>
                        <a:gd name="connsiteX2" fmla="*/ 906025 w 1917116"/>
                        <a:gd name="connsiteY2" fmla="*/ 9202 h 2660273"/>
                        <a:gd name="connsiteX3" fmla="*/ 560585 w 1917116"/>
                        <a:gd name="connsiteY3" fmla="*/ 435922 h 2660273"/>
                        <a:gd name="connsiteX4" fmla="*/ 377705 w 1917116"/>
                        <a:gd name="connsiteY4" fmla="*/ 954082 h 2660273"/>
                        <a:gd name="connsiteX5" fmla="*/ 296425 w 1917116"/>
                        <a:gd name="connsiteY5" fmla="*/ 1330002 h 2660273"/>
                        <a:gd name="connsiteX6" fmla="*/ 576051 w 1917116"/>
                        <a:gd name="connsiteY6" fmla="*/ 1308839 h 2660273"/>
                        <a:gd name="connsiteX7" fmla="*/ 784105 w 1917116"/>
                        <a:gd name="connsiteY7" fmla="*/ 1299522 h 2660273"/>
                        <a:gd name="connsiteX8" fmla="*/ 1038105 w 1917116"/>
                        <a:gd name="connsiteY8" fmla="*/ 1238562 h 2660273"/>
                        <a:gd name="connsiteX9" fmla="*/ 1190505 w 1917116"/>
                        <a:gd name="connsiteY9" fmla="*/ 1136962 h 2660273"/>
                        <a:gd name="connsiteX10" fmla="*/ 1281945 w 1917116"/>
                        <a:gd name="connsiteY10" fmla="*/ 1004882 h 2660273"/>
                        <a:gd name="connsiteX11" fmla="*/ 1342905 w 1917116"/>
                        <a:gd name="connsiteY11" fmla="*/ 913442 h 2660273"/>
                        <a:gd name="connsiteX12" fmla="*/ 1224738 w 1917116"/>
                        <a:gd name="connsiteY12" fmla="*/ 1123422 h 2660273"/>
                        <a:gd name="connsiteX13" fmla="*/ 1068585 w 1917116"/>
                        <a:gd name="connsiteY13" fmla="*/ 1250417 h 2660273"/>
                        <a:gd name="connsiteX14" fmla="*/ 809279 w 1917116"/>
                        <a:gd name="connsiteY14" fmla="*/ 1314767 h 2660273"/>
                        <a:gd name="connsiteX15" fmla="*/ 245625 w 1917116"/>
                        <a:gd name="connsiteY15" fmla="*/ 1401122 h 2660273"/>
                        <a:gd name="connsiteX16" fmla="*/ 83065 w 1917116"/>
                        <a:gd name="connsiteY16" fmla="*/ 1919282 h 2660273"/>
                        <a:gd name="connsiteX17" fmla="*/ 21005 w 1917116"/>
                        <a:gd name="connsiteY17" fmla="*/ 2323987 h 2660273"/>
                        <a:gd name="connsiteX18" fmla="*/ 11492 w 1917116"/>
                        <a:gd name="connsiteY18" fmla="*/ 2467922 h 2660273"/>
                        <a:gd name="connsiteX19" fmla="*/ 23011 w 1917116"/>
                        <a:gd name="connsiteY19" fmla="*/ 2653340 h 2660273"/>
                        <a:gd name="connsiteX20" fmla="*/ 276105 w 1917116"/>
                        <a:gd name="connsiteY20" fmla="*/ 2610162 h 2660273"/>
                        <a:gd name="connsiteX21" fmla="*/ 530105 w 1917116"/>
                        <a:gd name="connsiteY21" fmla="*/ 2508562 h 2660273"/>
                        <a:gd name="connsiteX22" fmla="*/ 731752 w 1917116"/>
                        <a:gd name="connsiteY22" fmla="*/ 2448464 h 2660273"/>
                        <a:gd name="connsiteX23" fmla="*/ 1332745 w 1917116"/>
                        <a:gd name="connsiteY23" fmla="*/ 2254562 h 2660273"/>
                        <a:gd name="connsiteX24" fmla="*/ 1414025 w 1917116"/>
                        <a:gd name="connsiteY24" fmla="*/ 1959922 h 2660273"/>
                        <a:gd name="connsiteX25" fmla="*/ 1424185 w 1917116"/>
                        <a:gd name="connsiteY25" fmla="*/ 1573842 h 2660273"/>
                        <a:gd name="connsiteX26" fmla="*/ 1424185 w 1917116"/>
                        <a:gd name="connsiteY26" fmla="*/ 1238562 h 2660273"/>
                        <a:gd name="connsiteX27" fmla="*/ 1414025 w 1917116"/>
                        <a:gd name="connsiteY27" fmla="*/ 1086162 h 2660273"/>
                        <a:gd name="connsiteX28" fmla="*/ 1678185 w 1917116"/>
                        <a:gd name="connsiteY28" fmla="*/ 1025202 h 2660273"/>
                        <a:gd name="connsiteX29" fmla="*/ 1698505 w 1917116"/>
                        <a:gd name="connsiteY29" fmla="*/ 913442 h 2660273"/>
                        <a:gd name="connsiteX30" fmla="*/ 1525785 w 1917116"/>
                        <a:gd name="connsiteY30" fmla="*/ 923602 h 2660273"/>
                        <a:gd name="connsiteX31" fmla="*/ 1414025 w 1917116"/>
                        <a:gd name="connsiteY31" fmla="*/ 954082 h 2660273"/>
                        <a:gd name="connsiteX32" fmla="*/ 1414025 w 1917116"/>
                        <a:gd name="connsiteY32" fmla="*/ 893122 h 2660273"/>
                        <a:gd name="connsiteX33" fmla="*/ 1414025 w 1917116"/>
                        <a:gd name="connsiteY33" fmla="*/ 913442 h 2660273"/>
                        <a:gd name="connsiteX34" fmla="*/ 1535945 w 1917116"/>
                        <a:gd name="connsiteY34" fmla="*/ 882962 h 2660273"/>
                        <a:gd name="connsiteX35" fmla="*/ 1627385 w 1917116"/>
                        <a:gd name="connsiteY35" fmla="*/ 842322 h 2660273"/>
                        <a:gd name="connsiteX36" fmla="*/ 1728985 w 1917116"/>
                        <a:gd name="connsiteY36" fmla="*/ 740722 h 2660273"/>
                        <a:gd name="connsiteX37" fmla="*/ 1881385 w 1917116"/>
                        <a:gd name="connsiteY37" fmla="*/ 496882 h 2660273"/>
                        <a:gd name="connsiteX38" fmla="*/ 1911865 w 1917116"/>
                        <a:gd name="connsiteY38" fmla="*/ 425762 h 2660273"/>
                        <a:gd name="connsiteX39" fmla="*/ 1800105 w 1917116"/>
                        <a:gd name="connsiteY39" fmla="*/ 385122 h 2660273"/>
                        <a:gd name="connsiteX40" fmla="*/ 1678185 w 1917116"/>
                        <a:gd name="connsiteY40" fmla="*/ 608642 h 2660273"/>
                        <a:gd name="connsiteX41" fmla="*/ 1586745 w 1917116"/>
                        <a:gd name="connsiteY41" fmla="*/ 720402 h 2660273"/>
                        <a:gd name="connsiteX42" fmla="*/ 1414025 w 1917116"/>
                        <a:gd name="connsiteY42" fmla="*/ 750882 h 2660273"/>
                        <a:gd name="connsiteX0" fmla="*/ 1421711 w 1924802"/>
                        <a:gd name="connsiteY0" fmla="*/ 750882 h 2660273"/>
                        <a:gd name="connsiteX1" fmla="*/ 1279471 w 1924802"/>
                        <a:gd name="connsiteY1" fmla="*/ 192082 h 2660273"/>
                        <a:gd name="connsiteX2" fmla="*/ 913711 w 1924802"/>
                        <a:gd name="connsiteY2" fmla="*/ 9202 h 2660273"/>
                        <a:gd name="connsiteX3" fmla="*/ 568271 w 1924802"/>
                        <a:gd name="connsiteY3" fmla="*/ 435922 h 2660273"/>
                        <a:gd name="connsiteX4" fmla="*/ 385391 w 1924802"/>
                        <a:gd name="connsiteY4" fmla="*/ 954082 h 2660273"/>
                        <a:gd name="connsiteX5" fmla="*/ 304111 w 1924802"/>
                        <a:gd name="connsiteY5" fmla="*/ 1330002 h 2660273"/>
                        <a:gd name="connsiteX6" fmla="*/ 583737 w 1924802"/>
                        <a:gd name="connsiteY6" fmla="*/ 1308839 h 2660273"/>
                        <a:gd name="connsiteX7" fmla="*/ 791791 w 1924802"/>
                        <a:gd name="connsiteY7" fmla="*/ 1299522 h 2660273"/>
                        <a:gd name="connsiteX8" fmla="*/ 1045791 w 1924802"/>
                        <a:gd name="connsiteY8" fmla="*/ 1238562 h 2660273"/>
                        <a:gd name="connsiteX9" fmla="*/ 1198191 w 1924802"/>
                        <a:gd name="connsiteY9" fmla="*/ 1136962 h 2660273"/>
                        <a:gd name="connsiteX10" fmla="*/ 1289631 w 1924802"/>
                        <a:gd name="connsiteY10" fmla="*/ 1004882 h 2660273"/>
                        <a:gd name="connsiteX11" fmla="*/ 1350591 w 1924802"/>
                        <a:gd name="connsiteY11" fmla="*/ 913442 h 2660273"/>
                        <a:gd name="connsiteX12" fmla="*/ 1232424 w 1924802"/>
                        <a:gd name="connsiteY12" fmla="*/ 1123422 h 2660273"/>
                        <a:gd name="connsiteX13" fmla="*/ 1076271 w 1924802"/>
                        <a:gd name="connsiteY13" fmla="*/ 1250417 h 2660273"/>
                        <a:gd name="connsiteX14" fmla="*/ 816965 w 1924802"/>
                        <a:gd name="connsiteY14" fmla="*/ 1314767 h 2660273"/>
                        <a:gd name="connsiteX15" fmla="*/ 253311 w 1924802"/>
                        <a:gd name="connsiteY15" fmla="*/ 1401122 h 2660273"/>
                        <a:gd name="connsiteX16" fmla="*/ 90751 w 1924802"/>
                        <a:gd name="connsiteY16" fmla="*/ 1919282 h 2660273"/>
                        <a:gd name="connsiteX17" fmla="*/ 28691 w 1924802"/>
                        <a:gd name="connsiteY17" fmla="*/ 2323987 h 2660273"/>
                        <a:gd name="connsiteX18" fmla="*/ 4164 w 1924802"/>
                        <a:gd name="connsiteY18" fmla="*/ 2467922 h 2660273"/>
                        <a:gd name="connsiteX19" fmla="*/ 30697 w 1924802"/>
                        <a:gd name="connsiteY19" fmla="*/ 2653340 h 2660273"/>
                        <a:gd name="connsiteX20" fmla="*/ 283791 w 1924802"/>
                        <a:gd name="connsiteY20" fmla="*/ 2610162 h 2660273"/>
                        <a:gd name="connsiteX21" fmla="*/ 537791 w 1924802"/>
                        <a:gd name="connsiteY21" fmla="*/ 2508562 h 2660273"/>
                        <a:gd name="connsiteX22" fmla="*/ 739438 w 1924802"/>
                        <a:gd name="connsiteY22" fmla="*/ 2448464 h 2660273"/>
                        <a:gd name="connsiteX23" fmla="*/ 1340431 w 1924802"/>
                        <a:gd name="connsiteY23" fmla="*/ 2254562 h 2660273"/>
                        <a:gd name="connsiteX24" fmla="*/ 1421711 w 1924802"/>
                        <a:gd name="connsiteY24" fmla="*/ 1959922 h 2660273"/>
                        <a:gd name="connsiteX25" fmla="*/ 1431871 w 1924802"/>
                        <a:gd name="connsiteY25" fmla="*/ 1573842 h 2660273"/>
                        <a:gd name="connsiteX26" fmla="*/ 1431871 w 1924802"/>
                        <a:gd name="connsiteY26" fmla="*/ 1238562 h 2660273"/>
                        <a:gd name="connsiteX27" fmla="*/ 1421711 w 1924802"/>
                        <a:gd name="connsiteY27" fmla="*/ 1086162 h 2660273"/>
                        <a:gd name="connsiteX28" fmla="*/ 1685871 w 1924802"/>
                        <a:gd name="connsiteY28" fmla="*/ 1025202 h 2660273"/>
                        <a:gd name="connsiteX29" fmla="*/ 1706191 w 1924802"/>
                        <a:gd name="connsiteY29" fmla="*/ 913442 h 2660273"/>
                        <a:gd name="connsiteX30" fmla="*/ 1533471 w 1924802"/>
                        <a:gd name="connsiteY30" fmla="*/ 923602 h 2660273"/>
                        <a:gd name="connsiteX31" fmla="*/ 1421711 w 1924802"/>
                        <a:gd name="connsiteY31" fmla="*/ 954082 h 2660273"/>
                        <a:gd name="connsiteX32" fmla="*/ 1421711 w 1924802"/>
                        <a:gd name="connsiteY32" fmla="*/ 893122 h 2660273"/>
                        <a:gd name="connsiteX33" fmla="*/ 1421711 w 1924802"/>
                        <a:gd name="connsiteY33" fmla="*/ 913442 h 2660273"/>
                        <a:gd name="connsiteX34" fmla="*/ 1543631 w 1924802"/>
                        <a:gd name="connsiteY34" fmla="*/ 882962 h 2660273"/>
                        <a:gd name="connsiteX35" fmla="*/ 1635071 w 1924802"/>
                        <a:gd name="connsiteY35" fmla="*/ 842322 h 2660273"/>
                        <a:gd name="connsiteX36" fmla="*/ 1736671 w 1924802"/>
                        <a:gd name="connsiteY36" fmla="*/ 740722 h 2660273"/>
                        <a:gd name="connsiteX37" fmla="*/ 1889071 w 1924802"/>
                        <a:gd name="connsiteY37" fmla="*/ 496882 h 2660273"/>
                        <a:gd name="connsiteX38" fmla="*/ 1919551 w 1924802"/>
                        <a:gd name="connsiteY38" fmla="*/ 425762 h 2660273"/>
                        <a:gd name="connsiteX39" fmla="*/ 1807791 w 1924802"/>
                        <a:gd name="connsiteY39" fmla="*/ 385122 h 2660273"/>
                        <a:gd name="connsiteX40" fmla="*/ 1685871 w 1924802"/>
                        <a:gd name="connsiteY40" fmla="*/ 608642 h 2660273"/>
                        <a:gd name="connsiteX41" fmla="*/ 1594431 w 1924802"/>
                        <a:gd name="connsiteY41" fmla="*/ 720402 h 2660273"/>
                        <a:gd name="connsiteX42" fmla="*/ 1421711 w 1924802"/>
                        <a:gd name="connsiteY42" fmla="*/ 750882 h 2660273"/>
                        <a:gd name="connsiteX0" fmla="*/ 1415699 w 1918790"/>
                        <a:gd name="connsiteY0" fmla="*/ 750882 h 2660273"/>
                        <a:gd name="connsiteX1" fmla="*/ 1273459 w 1918790"/>
                        <a:gd name="connsiteY1" fmla="*/ 192082 h 2660273"/>
                        <a:gd name="connsiteX2" fmla="*/ 907699 w 1918790"/>
                        <a:gd name="connsiteY2" fmla="*/ 9202 h 2660273"/>
                        <a:gd name="connsiteX3" fmla="*/ 562259 w 1918790"/>
                        <a:gd name="connsiteY3" fmla="*/ 435922 h 2660273"/>
                        <a:gd name="connsiteX4" fmla="*/ 379379 w 1918790"/>
                        <a:gd name="connsiteY4" fmla="*/ 954082 h 2660273"/>
                        <a:gd name="connsiteX5" fmla="*/ 298099 w 1918790"/>
                        <a:gd name="connsiteY5" fmla="*/ 1330002 h 2660273"/>
                        <a:gd name="connsiteX6" fmla="*/ 577725 w 1918790"/>
                        <a:gd name="connsiteY6" fmla="*/ 1308839 h 2660273"/>
                        <a:gd name="connsiteX7" fmla="*/ 785779 w 1918790"/>
                        <a:gd name="connsiteY7" fmla="*/ 1299522 h 2660273"/>
                        <a:gd name="connsiteX8" fmla="*/ 1039779 w 1918790"/>
                        <a:gd name="connsiteY8" fmla="*/ 1238562 h 2660273"/>
                        <a:gd name="connsiteX9" fmla="*/ 1192179 w 1918790"/>
                        <a:gd name="connsiteY9" fmla="*/ 1136962 h 2660273"/>
                        <a:gd name="connsiteX10" fmla="*/ 1283619 w 1918790"/>
                        <a:gd name="connsiteY10" fmla="*/ 1004882 h 2660273"/>
                        <a:gd name="connsiteX11" fmla="*/ 1344579 w 1918790"/>
                        <a:gd name="connsiteY11" fmla="*/ 913442 h 2660273"/>
                        <a:gd name="connsiteX12" fmla="*/ 1226412 w 1918790"/>
                        <a:gd name="connsiteY12" fmla="*/ 1123422 h 2660273"/>
                        <a:gd name="connsiteX13" fmla="*/ 1070259 w 1918790"/>
                        <a:gd name="connsiteY13" fmla="*/ 1250417 h 2660273"/>
                        <a:gd name="connsiteX14" fmla="*/ 810953 w 1918790"/>
                        <a:gd name="connsiteY14" fmla="*/ 1314767 h 2660273"/>
                        <a:gd name="connsiteX15" fmla="*/ 247299 w 1918790"/>
                        <a:gd name="connsiteY15" fmla="*/ 1401122 h 2660273"/>
                        <a:gd name="connsiteX16" fmla="*/ 84739 w 1918790"/>
                        <a:gd name="connsiteY16" fmla="*/ 1919282 h 2660273"/>
                        <a:gd name="connsiteX17" fmla="*/ 22679 w 1918790"/>
                        <a:gd name="connsiteY17" fmla="*/ 2323987 h 2660273"/>
                        <a:gd name="connsiteX18" fmla="*/ 9412 w 1918790"/>
                        <a:gd name="connsiteY18" fmla="*/ 2467922 h 2660273"/>
                        <a:gd name="connsiteX19" fmla="*/ 24685 w 1918790"/>
                        <a:gd name="connsiteY19" fmla="*/ 2653340 h 2660273"/>
                        <a:gd name="connsiteX20" fmla="*/ 277779 w 1918790"/>
                        <a:gd name="connsiteY20" fmla="*/ 2610162 h 2660273"/>
                        <a:gd name="connsiteX21" fmla="*/ 531779 w 1918790"/>
                        <a:gd name="connsiteY21" fmla="*/ 2508562 h 2660273"/>
                        <a:gd name="connsiteX22" fmla="*/ 733426 w 1918790"/>
                        <a:gd name="connsiteY22" fmla="*/ 2448464 h 2660273"/>
                        <a:gd name="connsiteX23" fmla="*/ 1334419 w 1918790"/>
                        <a:gd name="connsiteY23" fmla="*/ 2254562 h 2660273"/>
                        <a:gd name="connsiteX24" fmla="*/ 1415699 w 1918790"/>
                        <a:gd name="connsiteY24" fmla="*/ 1959922 h 2660273"/>
                        <a:gd name="connsiteX25" fmla="*/ 1425859 w 1918790"/>
                        <a:gd name="connsiteY25" fmla="*/ 1573842 h 2660273"/>
                        <a:gd name="connsiteX26" fmla="*/ 1425859 w 1918790"/>
                        <a:gd name="connsiteY26" fmla="*/ 1238562 h 2660273"/>
                        <a:gd name="connsiteX27" fmla="*/ 1415699 w 1918790"/>
                        <a:gd name="connsiteY27" fmla="*/ 1086162 h 2660273"/>
                        <a:gd name="connsiteX28" fmla="*/ 1679859 w 1918790"/>
                        <a:gd name="connsiteY28" fmla="*/ 1025202 h 2660273"/>
                        <a:gd name="connsiteX29" fmla="*/ 1700179 w 1918790"/>
                        <a:gd name="connsiteY29" fmla="*/ 913442 h 2660273"/>
                        <a:gd name="connsiteX30" fmla="*/ 1527459 w 1918790"/>
                        <a:gd name="connsiteY30" fmla="*/ 923602 h 2660273"/>
                        <a:gd name="connsiteX31" fmla="*/ 1415699 w 1918790"/>
                        <a:gd name="connsiteY31" fmla="*/ 954082 h 2660273"/>
                        <a:gd name="connsiteX32" fmla="*/ 1415699 w 1918790"/>
                        <a:gd name="connsiteY32" fmla="*/ 893122 h 2660273"/>
                        <a:gd name="connsiteX33" fmla="*/ 1415699 w 1918790"/>
                        <a:gd name="connsiteY33" fmla="*/ 913442 h 2660273"/>
                        <a:gd name="connsiteX34" fmla="*/ 1537619 w 1918790"/>
                        <a:gd name="connsiteY34" fmla="*/ 882962 h 2660273"/>
                        <a:gd name="connsiteX35" fmla="*/ 1629059 w 1918790"/>
                        <a:gd name="connsiteY35" fmla="*/ 842322 h 2660273"/>
                        <a:gd name="connsiteX36" fmla="*/ 1730659 w 1918790"/>
                        <a:gd name="connsiteY36" fmla="*/ 740722 h 2660273"/>
                        <a:gd name="connsiteX37" fmla="*/ 1883059 w 1918790"/>
                        <a:gd name="connsiteY37" fmla="*/ 496882 h 2660273"/>
                        <a:gd name="connsiteX38" fmla="*/ 1913539 w 1918790"/>
                        <a:gd name="connsiteY38" fmla="*/ 425762 h 2660273"/>
                        <a:gd name="connsiteX39" fmla="*/ 1801779 w 1918790"/>
                        <a:gd name="connsiteY39" fmla="*/ 385122 h 2660273"/>
                        <a:gd name="connsiteX40" fmla="*/ 1679859 w 1918790"/>
                        <a:gd name="connsiteY40" fmla="*/ 608642 h 2660273"/>
                        <a:gd name="connsiteX41" fmla="*/ 1588419 w 1918790"/>
                        <a:gd name="connsiteY41" fmla="*/ 720402 h 2660273"/>
                        <a:gd name="connsiteX42" fmla="*/ 1415699 w 1918790"/>
                        <a:gd name="connsiteY42" fmla="*/ 750882 h 2660273"/>
                        <a:gd name="connsiteX0" fmla="*/ 1415699 w 1918790"/>
                        <a:gd name="connsiteY0" fmla="*/ 750882 h 2660273"/>
                        <a:gd name="connsiteX1" fmla="*/ 1273459 w 1918790"/>
                        <a:gd name="connsiteY1" fmla="*/ 192082 h 2660273"/>
                        <a:gd name="connsiteX2" fmla="*/ 907699 w 1918790"/>
                        <a:gd name="connsiteY2" fmla="*/ 9202 h 2660273"/>
                        <a:gd name="connsiteX3" fmla="*/ 562259 w 1918790"/>
                        <a:gd name="connsiteY3" fmla="*/ 435922 h 2660273"/>
                        <a:gd name="connsiteX4" fmla="*/ 379379 w 1918790"/>
                        <a:gd name="connsiteY4" fmla="*/ 954082 h 2660273"/>
                        <a:gd name="connsiteX5" fmla="*/ 298099 w 1918790"/>
                        <a:gd name="connsiteY5" fmla="*/ 1330002 h 2660273"/>
                        <a:gd name="connsiteX6" fmla="*/ 577725 w 1918790"/>
                        <a:gd name="connsiteY6" fmla="*/ 1308839 h 2660273"/>
                        <a:gd name="connsiteX7" fmla="*/ 785779 w 1918790"/>
                        <a:gd name="connsiteY7" fmla="*/ 1299522 h 2660273"/>
                        <a:gd name="connsiteX8" fmla="*/ 1039779 w 1918790"/>
                        <a:gd name="connsiteY8" fmla="*/ 1238562 h 2660273"/>
                        <a:gd name="connsiteX9" fmla="*/ 1192179 w 1918790"/>
                        <a:gd name="connsiteY9" fmla="*/ 1136962 h 2660273"/>
                        <a:gd name="connsiteX10" fmla="*/ 1283619 w 1918790"/>
                        <a:gd name="connsiteY10" fmla="*/ 1004882 h 2660273"/>
                        <a:gd name="connsiteX11" fmla="*/ 1344579 w 1918790"/>
                        <a:gd name="connsiteY11" fmla="*/ 913442 h 2660273"/>
                        <a:gd name="connsiteX12" fmla="*/ 1226412 w 1918790"/>
                        <a:gd name="connsiteY12" fmla="*/ 1123422 h 2660273"/>
                        <a:gd name="connsiteX13" fmla="*/ 1070259 w 1918790"/>
                        <a:gd name="connsiteY13" fmla="*/ 1250417 h 2660273"/>
                        <a:gd name="connsiteX14" fmla="*/ 810953 w 1918790"/>
                        <a:gd name="connsiteY14" fmla="*/ 1314767 h 2660273"/>
                        <a:gd name="connsiteX15" fmla="*/ 247299 w 1918790"/>
                        <a:gd name="connsiteY15" fmla="*/ 1401122 h 2660273"/>
                        <a:gd name="connsiteX16" fmla="*/ 84739 w 1918790"/>
                        <a:gd name="connsiteY16" fmla="*/ 1919282 h 2660273"/>
                        <a:gd name="connsiteX17" fmla="*/ 22679 w 1918790"/>
                        <a:gd name="connsiteY17" fmla="*/ 2323987 h 2660273"/>
                        <a:gd name="connsiteX18" fmla="*/ 9412 w 1918790"/>
                        <a:gd name="connsiteY18" fmla="*/ 2467922 h 2660273"/>
                        <a:gd name="connsiteX19" fmla="*/ 24685 w 1918790"/>
                        <a:gd name="connsiteY19" fmla="*/ 2653340 h 2660273"/>
                        <a:gd name="connsiteX20" fmla="*/ 277779 w 1918790"/>
                        <a:gd name="connsiteY20" fmla="*/ 2610162 h 2660273"/>
                        <a:gd name="connsiteX21" fmla="*/ 531779 w 1918790"/>
                        <a:gd name="connsiteY21" fmla="*/ 2508562 h 2660273"/>
                        <a:gd name="connsiteX22" fmla="*/ 733426 w 1918790"/>
                        <a:gd name="connsiteY22" fmla="*/ 2448464 h 2660273"/>
                        <a:gd name="connsiteX23" fmla="*/ 1334419 w 1918790"/>
                        <a:gd name="connsiteY23" fmla="*/ 2254562 h 2660273"/>
                        <a:gd name="connsiteX24" fmla="*/ 1415699 w 1918790"/>
                        <a:gd name="connsiteY24" fmla="*/ 1959922 h 2660273"/>
                        <a:gd name="connsiteX25" fmla="*/ 1425859 w 1918790"/>
                        <a:gd name="connsiteY25" fmla="*/ 1573842 h 2660273"/>
                        <a:gd name="connsiteX26" fmla="*/ 1425859 w 1918790"/>
                        <a:gd name="connsiteY26" fmla="*/ 1238562 h 2660273"/>
                        <a:gd name="connsiteX27" fmla="*/ 1415699 w 1918790"/>
                        <a:gd name="connsiteY27" fmla="*/ 1086162 h 2660273"/>
                        <a:gd name="connsiteX28" fmla="*/ 1679859 w 1918790"/>
                        <a:gd name="connsiteY28" fmla="*/ 1025202 h 2660273"/>
                        <a:gd name="connsiteX29" fmla="*/ 1700179 w 1918790"/>
                        <a:gd name="connsiteY29" fmla="*/ 913442 h 2660273"/>
                        <a:gd name="connsiteX30" fmla="*/ 1527459 w 1918790"/>
                        <a:gd name="connsiteY30" fmla="*/ 923602 h 2660273"/>
                        <a:gd name="connsiteX31" fmla="*/ 1415699 w 1918790"/>
                        <a:gd name="connsiteY31" fmla="*/ 954082 h 2660273"/>
                        <a:gd name="connsiteX32" fmla="*/ 1415699 w 1918790"/>
                        <a:gd name="connsiteY32" fmla="*/ 893122 h 2660273"/>
                        <a:gd name="connsiteX33" fmla="*/ 1415699 w 1918790"/>
                        <a:gd name="connsiteY33" fmla="*/ 913442 h 2660273"/>
                        <a:gd name="connsiteX34" fmla="*/ 1537619 w 1918790"/>
                        <a:gd name="connsiteY34" fmla="*/ 882962 h 2660273"/>
                        <a:gd name="connsiteX35" fmla="*/ 1629059 w 1918790"/>
                        <a:gd name="connsiteY35" fmla="*/ 842322 h 2660273"/>
                        <a:gd name="connsiteX36" fmla="*/ 1730659 w 1918790"/>
                        <a:gd name="connsiteY36" fmla="*/ 740722 h 2660273"/>
                        <a:gd name="connsiteX37" fmla="*/ 1883059 w 1918790"/>
                        <a:gd name="connsiteY37" fmla="*/ 496882 h 2660273"/>
                        <a:gd name="connsiteX38" fmla="*/ 1913539 w 1918790"/>
                        <a:gd name="connsiteY38" fmla="*/ 425762 h 2660273"/>
                        <a:gd name="connsiteX39" fmla="*/ 1801779 w 1918790"/>
                        <a:gd name="connsiteY39" fmla="*/ 385122 h 2660273"/>
                        <a:gd name="connsiteX40" fmla="*/ 1679859 w 1918790"/>
                        <a:gd name="connsiteY40" fmla="*/ 608642 h 2660273"/>
                        <a:gd name="connsiteX41" fmla="*/ 1592173 w 1918790"/>
                        <a:gd name="connsiteY41" fmla="*/ 724634 h 2660273"/>
                        <a:gd name="connsiteX42" fmla="*/ 1415699 w 1918790"/>
                        <a:gd name="connsiteY42" fmla="*/ 750882 h 2660273"/>
                        <a:gd name="connsiteX0" fmla="*/ 1415699 w 1918790"/>
                        <a:gd name="connsiteY0" fmla="*/ 750882 h 2660273"/>
                        <a:gd name="connsiteX1" fmla="*/ 1273459 w 1918790"/>
                        <a:gd name="connsiteY1" fmla="*/ 192082 h 2660273"/>
                        <a:gd name="connsiteX2" fmla="*/ 907699 w 1918790"/>
                        <a:gd name="connsiteY2" fmla="*/ 9202 h 2660273"/>
                        <a:gd name="connsiteX3" fmla="*/ 562259 w 1918790"/>
                        <a:gd name="connsiteY3" fmla="*/ 435922 h 2660273"/>
                        <a:gd name="connsiteX4" fmla="*/ 379379 w 1918790"/>
                        <a:gd name="connsiteY4" fmla="*/ 954082 h 2660273"/>
                        <a:gd name="connsiteX5" fmla="*/ 298099 w 1918790"/>
                        <a:gd name="connsiteY5" fmla="*/ 1330002 h 2660273"/>
                        <a:gd name="connsiteX6" fmla="*/ 577725 w 1918790"/>
                        <a:gd name="connsiteY6" fmla="*/ 1308839 h 2660273"/>
                        <a:gd name="connsiteX7" fmla="*/ 785779 w 1918790"/>
                        <a:gd name="connsiteY7" fmla="*/ 1299522 h 2660273"/>
                        <a:gd name="connsiteX8" fmla="*/ 1039779 w 1918790"/>
                        <a:gd name="connsiteY8" fmla="*/ 1238562 h 2660273"/>
                        <a:gd name="connsiteX9" fmla="*/ 1192179 w 1918790"/>
                        <a:gd name="connsiteY9" fmla="*/ 1136962 h 2660273"/>
                        <a:gd name="connsiteX10" fmla="*/ 1283619 w 1918790"/>
                        <a:gd name="connsiteY10" fmla="*/ 1004882 h 2660273"/>
                        <a:gd name="connsiteX11" fmla="*/ 1344579 w 1918790"/>
                        <a:gd name="connsiteY11" fmla="*/ 913442 h 2660273"/>
                        <a:gd name="connsiteX12" fmla="*/ 1226412 w 1918790"/>
                        <a:gd name="connsiteY12" fmla="*/ 1123422 h 2660273"/>
                        <a:gd name="connsiteX13" fmla="*/ 1070259 w 1918790"/>
                        <a:gd name="connsiteY13" fmla="*/ 1250417 h 2660273"/>
                        <a:gd name="connsiteX14" fmla="*/ 810953 w 1918790"/>
                        <a:gd name="connsiteY14" fmla="*/ 1314767 h 2660273"/>
                        <a:gd name="connsiteX15" fmla="*/ 247299 w 1918790"/>
                        <a:gd name="connsiteY15" fmla="*/ 1401122 h 2660273"/>
                        <a:gd name="connsiteX16" fmla="*/ 84739 w 1918790"/>
                        <a:gd name="connsiteY16" fmla="*/ 1919282 h 2660273"/>
                        <a:gd name="connsiteX17" fmla="*/ 22679 w 1918790"/>
                        <a:gd name="connsiteY17" fmla="*/ 2323987 h 2660273"/>
                        <a:gd name="connsiteX18" fmla="*/ 9412 w 1918790"/>
                        <a:gd name="connsiteY18" fmla="*/ 2467922 h 2660273"/>
                        <a:gd name="connsiteX19" fmla="*/ 24685 w 1918790"/>
                        <a:gd name="connsiteY19" fmla="*/ 2653340 h 2660273"/>
                        <a:gd name="connsiteX20" fmla="*/ 277779 w 1918790"/>
                        <a:gd name="connsiteY20" fmla="*/ 2610162 h 2660273"/>
                        <a:gd name="connsiteX21" fmla="*/ 531779 w 1918790"/>
                        <a:gd name="connsiteY21" fmla="*/ 2508562 h 2660273"/>
                        <a:gd name="connsiteX22" fmla="*/ 733426 w 1918790"/>
                        <a:gd name="connsiteY22" fmla="*/ 2448464 h 2660273"/>
                        <a:gd name="connsiteX23" fmla="*/ 1334419 w 1918790"/>
                        <a:gd name="connsiteY23" fmla="*/ 2254562 h 2660273"/>
                        <a:gd name="connsiteX24" fmla="*/ 1415699 w 1918790"/>
                        <a:gd name="connsiteY24" fmla="*/ 1959922 h 2660273"/>
                        <a:gd name="connsiteX25" fmla="*/ 1425859 w 1918790"/>
                        <a:gd name="connsiteY25" fmla="*/ 1573842 h 2660273"/>
                        <a:gd name="connsiteX26" fmla="*/ 1425859 w 1918790"/>
                        <a:gd name="connsiteY26" fmla="*/ 1238562 h 2660273"/>
                        <a:gd name="connsiteX27" fmla="*/ 1415699 w 1918790"/>
                        <a:gd name="connsiteY27" fmla="*/ 1086162 h 2660273"/>
                        <a:gd name="connsiteX28" fmla="*/ 1679859 w 1918790"/>
                        <a:gd name="connsiteY28" fmla="*/ 1025202 h 2660273"/>
                        <a:gd name="connsiteX29" fmla="*/ 1700179 w 1918790"/>
                        <a:gd name="connsiteY29" fmla="*/ 913442 h 2660273"/>
                        <a:gd name="connsiteX30" fmla="*/ 1527459 w 1918790"/>
                        <a:gd name="connsiteY30" fmla="*/ 923602 h 2660273"/>
                        <a:gd name="connsiteX31" fmla="*/ 1415699 w 1918790"/>
                        <a:gd name="connsiteY31" fmla="*/ 954082 h 2660273"/>
                        <a:gd name="connsiteX32" fmla="*/ 1415699 w 1918790"/>
                        <a:gd name="connsiteY32" fmla="*/ 893122 h 2660273"/>
                        <a:gd name="connsiteX33" fmla="*/ 1415699 w 1918790"/>
                        <a:gd name="connsiteY33" fmla="*/ 913442 h 2660273"/>
                        <a:gd name="connsiteX34" fmla="*/ 1537619 w 1918790"/>
                        <a:gd name="connsiteY34" fmla="*/ 882962 h 2660273"/>
                        <a:gd name="connsiteX35" fmla="*/ 1629059 w 1918790"/>
                        <a:gd name="connsiteY35" fmla="*/ 842322 h 2660273"/>
                        <a:gd name="connsiteX36" fmla="*/ 1730659 w 1918790"/>
                        <a:gd name="connsiteY36" fmla="*/ 740722 h 2660273"/>
                        <a:gd name="connsiteX37" fmla="*/ 1883059 w 1918790"/>
                        <a:gd name="connsiteY37" fmla="*/ 496882 h 2660273"/>
                        <a:gd name="connsiteX38" fmla="*/ 1913539 w 1918790"/>
                        <a:gd name="connsiteY38" fmla="*/ 425762 h 2660273"/>
                        <a:gd name="connsiteX39" fmla="*/ 1801779 w 1918790"/>
                        <a:gd name="connsiteY39" fmla="*/ 385122 h 2660273"/>
                        <a:gd name="connsiteX40" fmla="*/ 1679859 w 1918790"/>
                        <a:gd name="connsiteY40" fmla="*/ 608642 h 2660273"/>
                        <a:gd name="connsiteX41" fmla="*/ 1592173 w 1918790"/>
                        <a:gd name="connsiteY41" fmla="*/ 724634 h 2660273"/>
                        <a:gd name="connsiteX42" fmla="*/ 1415699 w 1918790"/>
                        <a:gd name="connsiteY42" fmla="*/ 750882 h 2660273"/>
                        <a:gd name="connsiteX0" fmla="*/ 1415699 w 1918790"/>
                        <a:gd name="connsiteY0" fmla="*/ 750882 h 2660273"/>
                        <a:gd name="connsiteX1" fmla="*/ 1273459 w 1918790"/>
                        <a:gd name="connsiteY1" fmla="*/ 192082 h 2660273"/>
                        <a:gd name="connsiteX2" fmla="*/ 907699 w 1918790"/>
                        <a:gd name="connsiteY2" fmla="*/ 9202 h 2660273"/>
                        <a:gd name="connsiteX3" fmla="*/ 562259 w 1918790"/>
                        <a:gd name="connsiteY3" fmla="*/ 435922 h 2660273"/>
                        <a:gd name="connsiteX4" fmla="*/ 379379 w 1918790"/>
                        <a:gd name="connsiteY4" fmla="*/ 954082 h 2660273"/>
                        <a:gd name="connsiteX5" fmla="*/ 298099 w 1918790"/>
                        <a:gd name="connsiteY5" fmla="*/ 1330002 h 2660273"/>
                        <a:gd name="connsiteX6" fmla="*/ 577725 w 1918790"/>
                        <a:gd name="connsiteY6" fmla="*/ 1308839 h 2660273"/>
                        <a:gd name="connsiteX7" fmla="*/ 785779 w 1918790"/>
                        <a:gd name="connsiteY7" fmla="*/ 1299522 h 2660273"/>
                        <a:gd name="connsiteX8" fmla="*/ 1039779 w 1918790"/>
                        <a:gd name="connsiteY8" fmla="*/ 1238562 h 2660273"/>
                        <a:gd name="connsiteX9" fmla="*/ 1192179 w 1918790"/>
                        <a:gd name="connsiteY9" fmla="*/ 1136962 h 2660273"/>
                        <a:gd name="connsiteX10" fmla="*/ 1283619 w 1918790"/>
                        <a:gd name="connsiteY10" fmla="*/ 1004882 h 2660273"/>
                        <a:gd name="connsiteX11" fmla="*/ 1344579 w 1918790"/>
                        <a:gd name="connsiteY11" fmla="*/ 913442 h 2660273"/>
                        <a:gd name="connsiteX12" fmla="*/ 1226412 w 1918790"/>
                        <a:gd name="connsiteY12" fmla="*/ 1123422 h 2660273"/>
                        <a:gd name="connsiteX13" fmla="*/ 1070259 w 1918790"/>
                        <a:gd name="connsiteY13" fmla="*/ 1250417 h 2660273"/>
                        <a:gd name="connsiteX14" fmla="*/ 810953 w 1918790"/>
                        <a:gd name="connsiteY14" fmla="*/ 1314767 h 2660273"/>
                        <a:gd name="connsiteX15" fmla="*/ 247299 w 1918790"/>
                        <a:gd name="connsiteY15" fmla="*/ 1401122 h 2660273"/>
                        <a:gd name="connsiteX16" fmla="*/ 84739 w 1918790"/>
                        <a:gd name="connsiteY16" fmla="*/ 1919282 h 2660273"/>
                        <a:gd name="connsiteX17" fmla="*/ 22679 w 1918790"/>
                        <a:gd name="connsiteY17" fmla="*/ 2323987 h 2660273"/>
                        <a:gd name="connsiteX18" fmla="*/ 9412 w 1918790"/>
                        <a:gd name="connsiteY18" fmla="*/ 2467922 h 2660273"/>
                        <a:gd name="connsiteX19" fmla="*/ 24685 w 1918790"/>
                        <a:gd name="connsiteY19" fmla="*/ 2653340 h 2660273"/>
                        <a:gd name="connsiteX20" fmla="*/ 277779 w 1918790"/>
                        <a:gd name="connsiteY20" fmla="*/ 2610162 h 2660273"/>
                        <a:gd name="connsiteX21" fmla="*/ 531779 w 1918790"/>
                        <a:gd name="connsiteY21" fmla="*/ 2508562 h 2660273"/>
                        <a:gd name="connsiteX22" fmla="*/ 733426 w 1918790"/>
                        <a:gd name="connsiteY22" fmla="*/ 2448464 h 2660273"/>
                        <a:gd name="connsiteX23" fmla="*/ 1334419 w 1918790"/>
                        <a:gd name="connsiteY23" fmla="*/ 2254562 h 2660273"/>
                        <a:gd name="connsiteX24" fmla="*/ 1415699 w 1918790"/>
                        <a:gd name="connsiteY24" fmla="*/ 1959922 h 2660273"/>
                        <a:gd name="connsiteX25" fmla="*/ 1425859 w 1918790"/>
                        <a:gd name="connsiteY25" fmla="*/ 1573842 h 2660273"/>
                        <a:gd name="connsiteX26" fmla="*/ 1407092 w 1918790"/>
                        <a:gd name="connsiteY26" fmla="*/ 1238562 h 2660273"/>
                        <a:gd name="connsiteX27" fmla="*/ 1415699 w 1918790"/>
                        <a:gd name="connsiteY27" fmla="*/ 1086162 h 2660273"/>
                        <a:gd name="connsiteX28" fmla="*/ 1679859 w 1918790"/>
                        <a:gd name="connsiteY28" fmla="*/ 1025202 h 2660273"/>
                        <a:gd name="connsiteX29" fmla="*/ 1700179 w 1918790"/>
                        <a:gd name="connsiteY29" fmla="*/ 913442 h 2660273"/>
                        <a:gd name="connsiteX30" fmla="*/ 1527459 w 1918790"/>
                        <a:gd name="connsiteY30" fmla="*/ 923602 h 2660273"/>
                        <a:gd name="connsiteX31" fmla="*/ 1415699 w 1918790"/>
                        <a:gd name="connsiteY31" fmla="*/ 954082 h 2660273"/>
                        <a:gd name="connsiteX32" fmla="*/ 1415699 w 1918790"/>
                        <a:gd name="connsiteY32" fmla="*/ 893122 h 2660273"/>
                        <a:gd name="connsiteX33" fmla="*/ 1415699 w 1918790"/>
                        <a:gd name="connsiteY33" fmla="*/ 913442 h 2660273"/>
                        <a:gd name="connsiteX34" fmla="*/ 1537619 w 1918790"/>
                        <a:gd name="connsiteY34" fmla="*/ 882962 h 2660273"/>
                        <a:gd name="connsiteX35" fmla="*/ 1629059 w 1918790"/>
                        <a:gd name="connsiteY35" fmla="*/ 842322 h 2660273"/>
                        <a:gd name="connsiteX36" fmla="*/ 1730659 w 1918790"/>
                        <a:gd name="connsiteY36" fmla="*/ 740722 h 2660273"/>
                        <a:gd name="connsiteX37" fmla="*/ 1883059 w 1918790"/>
                        <a:gd name="connsiteY37" fmla="*/ 496882 h 2660273"/>
                        <a:gd name="connsiteX38" fmla="*/ 1913539 w 1918790"/>
                        <a:gd name="connsiteY38" fmla="*/ 425762 h 2660273"/>
                        <a:gd name="connsiteX39" fmla="*/ 1801779 w 1918790"/>
                        <a:gd name="connsiteY39" fmla="*/ 385122 h 2660273"/>
                        <a:gd name="connsiteX40" fmla="*/ 1679859 w 1918790"/>
                        <a:gd name="connsiteY40" fmla="*/ 608642 h 2660273"/>
                        <a:gd name="connsiteX41" fmla="*/ 1592173 w 1918790"/>
                        <a:gd name="connsiteY41" fmla="*/ 724634 h 2660273"/>
                        <a:gd name="connsiteX42" fmla="*/ 1415699 w 1918790"/>
                        <a:gd name="connsiteY42" fmla="*/ 750882 h 2660273"/>
                        <a:gd name="connsiteX0" fmla="*/ 1415699 w 1918790"/>
                        <a:gd name="connsiteY0" fmla="*/ 750882 h 2659757"/>
                        <a:gd name="connsiteX1" fmla="*/ 1273459 w 1918790"/>
                        <a:gd name="connsiteY1" fmla="*/ 192082 h 2659757"/>
                        <a:gd name="connsiteX2" fmla="*/ 907699 w 1918790"/>
                        <a:gd name="connsiteY2" fmla="*/ 9202 h 2659757"/>
                        <a:gd name="connsiteX3" fmla="*/ 562259 w 1918790"/>
                        <a:gd name="connsiteY3" fmla="*/ 435922 h 2659757"/>
                        <a:gd name="connsiteX4" fmla="*/ 379379 w 1918790"/>
                        <a:gd name="connsiteY4" fmla="*/ 954082 h 2659757"/>
                        <a:gd name="connsiteX5" fmla="*/ 298099 w 1918790"/>
                        <a:gd name="connsiteY5" fmla="*/ 1330002 h 2659757"/>
                        <a:gd name="connsiteX6" fmla="*/ 577725 w 1918790"/>
                        <a:gd name="connsiteY6" fmla="*/ 1308839 h 2659757"/>
                        <a:gd name="connsiteX7" fmla="*/ 785779 w 1918790"/>
                        <a:gd name="connsiteY7" fmla="*/ 1299522 h 2659757"/>
                        <a:gd name="connsiteX8" fmla="*/ 1039779 w 1918790"/>
                        <a:gd name="connsiteY8" fmla="*/ 1238562 h 2659757"/>
                        <a:gd name="connsiteX9" fmla="*/ 1192179 w 1918790"/>
                        <a:gd name="connsiteY9" fmla="*/ 1136962 h 2659757"/>
                        <a:gd name="connsiteX10" fmla="*/ 1283619 w 1918790"/>
                        <a:gd name="connsiteY10" fmla="*/ 1004882 h 2659757"/>
                        <a:gd name="connsiteX11" fmla="*/ 1344579 w 1918790"/>
                        <a:gd name="connsiteY11" fmla="*/ 913442 h 2659757"/>
                        <a:gd name="connsiteX12" fmla="*/ 1226412 w 1918790"/>
                        <a:gd name="connsiteY12" fmla="*/ 1123422 h 2659757"/>
                        <a:gd name="connsiteX13" fmla="*/ 1070259 w 1918790"/>
                        <a:gd name="connsiteY13" fmla="*/ 1250417 h 2659757"/>
                        <a:gd name="connsiteX14" fmla="*/ 810953 w 1918790"/>
                        <a:gd name="connsiteY14" fmla="*/ 1314767 h 2659757"/>
                        <a:gd name="connsiteX15" fmla="*/ 247299 w 1918790"/>
                        <a:gd name="connsiteY15" fmla="*/ 1401122 h 2659757"/>
                        <a:gd name="connsiteX16" fmla="*/ 84739 w 1918790"/>
                        <a:gd name="connsiteY16" fmla="*/ 1919282 h 2659757"/>
                        <a:gd name="connsiteX17" fmla="*/ 22679 w 1918790"/>
                        <a:gd name="connsiteY17" fmla="*/ 2323987 h 2659757"/>
                        <a:gd name="connsiteX18" fmla="*/ 9412 w 1918790"/>
                        <a:gd name="connsiteY18" fmla="*/ 2467922 h 2659757"/>
                        <a:gd name="connsiteX19" fmla="*/ 24685 w 1918790"/>
                        <a:gd name="connsiteY19" fmla="*/ 2653340 h 2659757"/>
                        <a:gd name="connsiteX20" fmla="*/ 277779 w 1918790"/>
                        <a:gd name="connsiteY20" fmla="*/ 2610162 h 2659757"/>
                        <a:gd name="connsiteX21" fmla="*/ 568212 w 1918790"/>
                        <a:gd name="connsiteY21" fmla="*/ 2541473 h 2659757"/>
                        <a:gd name="connsiteX22" fmla="*/ 733426 w 1918790"/>
                        <a:gd name="connsiteY22" fmla="*/ 2448464 h 2659757"/>
                        <a:gd name="connsiteX23" fmla="*/ 1334419 w 1918790"/>
                        <a:gd name="connsiteY23" fmla="*/ 2254562 h 2659757"/>
                        <a:gd name="connsiteX24" fmla="*/ 1415699 w 1918790"/>
                        <a:gd name="connsiteY24" fmla="*/ 1959922 h 2659757"/>
                        <a:gd name="connsiteX25" fmla="*/ 1425859 w 1918790"/>
                        <a:gd name="connsiteY25" fmla="*/ 1573842 h 2659757"/>
                        <a:gd name="connsiteX26" fmla="*/ 1407092 w 1918790"/>
                        <a:gd name="connsiteY26" fmla="*/ 1238562 h 2659757"/>
                        <a:gd name="connsiteX27" fmla="*/ 1415699 w 1918790"/>
                        <a:gd name="connsiteY27" fmla="*/ 1086162 h 2659757"/>
                        <a:gd name="connsiteX28" fmla="*/ 1679859 w 1918790"/>
                        <a:gd name="connsiteY28" fmla="*/ 1025202 h 2659757"/>
                        <a:gd name="connsiteX29" fmla="*/ 1700179 w 1918790"/>
                        <a:gd name="connsiteY29" fmla="*/ 913442 h 2659757"/>
                        <a:gd name="connsiteX30" fmla="*/ 1527459 w 1918790"/>
                        <a:gd name="connsiteY30" fmla="*/ 923602 h 2659757"/>
                        <a:gd name="connsiteX31" fmla="*/ 1415699 w 1918790"/>
                        <a:gd name="connsiteY31" fmla="*/ 954082 h 2659757"/>
                        <a:gd name="connsiteX32" fmla="*/ 1415699 w 1918790"/>
                        <a:gd name="connsiteY32" fmla="*/ 893122 h 2659757"/>
                        <a:gd name="connsiteX33" fmla="*/ 1415699 w 1918790"/>
                        <a:gd name="connsiteY33" fmla="*/ 913442 h 2659757"/>
                        <a:gd name="connsiteX34" fmla="*/ 1537619 w 1918790"/>
                        <a:gd name="connsiteY34" fmla="*/ 882962 h 2659757"/>
                        <a:gd name="connsiteX35" fmla="*/ 1629059 w 1918790"/>
                        <a:gd name="connsiteY35" fmla="*/ 842322 h 2659757"/>
                        <a:gd name="connsiteX36" fmla="*/ 1730659 w 1918790"/>
                        <a:gd name="connsiteY36" fmla="*/ 740722 h 2659757"/>
                        <a:gd name="connsiteX37" fmla="*/ 1883059 w 1918790"/>
                        <a:gd name="connsiteY37" fmla="*/ 496882 h 2659757"/>
                        <a:gd name="connsiteX38" fmla="*/ 1913539 w 1918790"/>
                        <a:gd name="connsiteY38" fmla="*/ 425762 h 2659757"/>
                        <a:gd name="connsiteX39" fmla="*/ 1801779 w 1918790"/>
                        <a:gd name="connsiteY39" fmla="*/ 385122 h 2659757"/>
                        <a:gd name="connsiteX40" fmla="*/ 1679859 w 1918790"/>
                        <a:gd name="connsiteY40" fmla="*/ 608642 h 2659757"/>
                        <a:gd name="connsiteX41" fmla="*/ 1592173 w 1918790"/>
                        <a:gd name="connsiteY41" fmla="*/ 724634 h 2659757"/>
                        <a:gd name="connsiteX42" fmla="*/ 1415699 w 1918790"/>
                        <a:gd name="connsiteY42" fmla="*/ 750882 h 2659757"/>
                        <a:gd name="connsiteX0" fmla="*/ 1415699 w 1918790"/>
                        <a:gd name="connsiteY0" fmla="*/ 750882 h 2659757"/>
                        <a:gd name="connsiteX1" fmla="*/ 1273459 w 1918790"/>
                        <a:gd name="connsiteY1" fmla="*/ 192082 h 2659757"/>
                        <a:gd name="connsiteX2" fmla="*/ 907699 w 1918790"/>
                        <a:gd name="connsiteY2" fmla="*/ 9202 h 2659757"/>
                        <a:gd name="connsiteX3" fmla="*/ 562259 w 1918790"/>
                        <a:gd name="connsiteY3" fmla="*/ 435922 h 2659757"/>
                        <a:gd name="connsiteX4" fmla="*/ 379379 w 1918790"/>
                        <a:gd name="connsiteY4" fmla="*/ 954082 h 2659757"/>
                        <a:gd name="connsiteX5" fmla="*/ 298099 w 1918790"/>
                        <a:gd name="connsiteY5" fmla="*/ 1330002 h 2659757"/>
                        <a:gd name="connsiteX6" fmla="*/ 577725 w 1918790"/>
                        <a:gd name="connsiteY6" fmla="*/ 1308839 h 2659757"/>
                        <a:gd name="connsiteX7" fmla="*/ 785779 w 1918790"/>
                        <a:gd name="connsiteY7" fmla="*/ 1299522 h 2659757"/>
                        <a:gd name="connsiteX8" fmla="*/ 1039779 w 1918790"/>
                        <a:gd name="connsiteY8" fmla="*/ 1238562 h 2659757"/>
                        <a:gd name="connsiteX9" fmla="*/ 1192179 w 1918790"/>
                        <a:gd name="connsiteY9" fmla="*/ 1136962 h 2659757"/>
                        <a:gd name="connsiteX10" fmla="*/ 1283619 w 1918790"/>
                        <a:gd name="connsiteY10" fmla="*/ 1004882 h 2659757"/>
                        <a:gd name="connsiteX11" fmla="*/ 1344579 w 1918790"/>
                        <a:gd name="connsiteY11" fmla="*/ 913442 h 2659757"/>
                        <a:gd name="connsiteX12" fmla="*/ 1226412 w 1918790"/>
                        <a:gd name="connsiteY12" fmla="*/ 1123422 h 2659757"/>
                        <a:gd name="connsiteX13" fmla="*/ 1070259 w 1918790"/>
                        <a:gd name="connsiteY13" fmla="*/ 1250417 h 2659757"/>
                        <a:gd name="connsiteX14" fmla="*/ 810953 w 1918790"/>
                        <a:gd name="connsiteY14" fmla="*/ 1314767 h 2659757"/>
                        <a:gd name="connsiteX15" fmla="*/ 247299 w 1918790"/>
                        <a:gd name="connsiteY15" fmla="*/ 1401122 h 2659757"/>
                        <a:gd name="connsiteX16" fmla="*/ 84739 w 1918790"/>
                        <a:gd name="connsiteY16" fmla="*/ 1919282 h 2659757"/>
                        <a:gd name="connsiteX17" fmla="*/ 22679 w 1918790"/>
                        <a:gd name="connsiteY17" fmla="*/ 2323987 h 2659757"/>
                        <a:gd name="connsiteX18" fmla="*/ 9412 w 1918790"/>
                        <a:gd name="connsiteY18" fmla="*/ 2467922 h 2659757"/>
                        <a:gd name="connsiteX19" fmla="*/ 24685 w 1918790"/>
                        <a:gd name="connsiteY19" fmla="*/ 2653340 h 2659757"/>
                        <a:gd name="connsiteX20" fmla="*/ 277779 w 1918790"/>
                        <a:gd name="connsiteY20" fmla="*/ 2610162 h 2659757"/>
                        <a:gd name="connsiteX21" fmla="*/ 568212 w 1918790"/>
                        <a:gd name="connsiteY21" fmla="*/ 2541473 h 2659757"/>
                        <a:gd name="connsiteX22" fmla="*/ 806291 w 1918790"/>
                        <a:gd name="connsiteY22" fmla="*/ 2508800 h 2659757"/>
                        <a:gd name="connsiteX23" fmla="*/ 1334419 w 1918790"/>
                        <a:gd name="connsiteY23" fmla="*/ 2254562 h 2659757"/>
                        <a:gd name="connsiteX24" fmla="*/ 1415699 w 1918790"/>
                        <a:gd name="connsiteY24" fmla="*/ 1959922 h 2659757"/>
                        <a:gd name="connsiteX25" fmla="*/ 1425859 w 1918790"/>
                        <a:gd name="connsiteY25" fmla="*/ 1573842 h 2659757"/>
                        <a:gd name="connsiteX26" fmla="*/ 1407092 w 1918790"/>
                        <a:gd name="connsiteY26" fmla="*/ 1238562 h 2659757"/>
                        <a:gd name="connsiteX27" fmla="*/ 1415699 w 1918790"/>
                        <a:gd name="connsiteY27" fmla="*/ 1086162 h 2659757"/>
                        <a:gd name="connsiteX28" fmla="*/ 1679859 w 1918790"/>
                        <a:gd name="connsiteY28" fmla="*/ 1025202 h 2659757"/>
                        <a:gd name="connsiteX29" fmla="*/ 1700179 w 1918790"/>
                        <a:gd name="connsiteY29" fmla="*/ 913442 h 2659757"/>
                        <a:gd name="connsiteX30" fmla="*/ 1527459 w 1918790"/>
                        <a:gd name="connsiteY30" fmla="*/ 923602 h 2659757"/>
                        <a:gd name="connsiteX31" fmla="*/ 1415699 w 1918790"/>
                        <a:gd name="connsiteY31" fmla="*/ 954082 h 2659757"/>
                        <a:gd name="connsiteX32" fmla="*/ 1415699 w 1918790"/>
                        <a:gd name="connsiteY32" fmla="*/ 893122 h 2659757"/>
                        <a:gd name="connsiteX33" fmla="*/ 1415699 w 1918790"/>
                        <a:gd name="connsiteY33" fmla="*/ 913442 h 2659757"/>
                        <a:gd name="connsiteX34" fmla="*/ 1537619 w 1918790"/>
                        <a:gd name="connsiteY34" fmla="*/ 882962 h 2659757"/>
                        <a:gd name="connsiteX35" fmla="*/ 1629059 w 1918790"/>
                        <a:gd name="connsiteY35" fmla="*/ 842322 h 2659757"/>
                        <a:gd name="connsiteX36" fmla="*/ 1730659 w 1918790"/>
                        <a:gd name="connsiteY36" fmla="*/ 740722 h 2659757"/>
                        <a:gd name="connsiteX37" fmla="*/ 1883059 w 1918790"/>
                        <a:gd name="connsiteY37" fmla="*/ 496882 h 2659757"/>
                        <a:gd name="connsiteX38" fmla="*/ 1913539 w 1918790"/>
                        <a:gd name="connsiteY38" fmla="*/ 425762 h 2659757"/>
                        <a:gd name="connsiteX39" fmla="*/ 1801779 w 1918790"/>
                        <a:gd name="connsiteY39" fmla="*/ 385122 h 2659757"/>
                        <a:gd name="connsiteX40" fmla="*/ 1679859 w 1918790"/>
                        <a:gd name="connsiteY40" fmla="*/ 608642 h 2659757"/>
                        <a:gd name="connsiteX41" fmla="*/ 1592173 w 1918790"/>
                        <a:gd name="connsiteY41" fmla="*/ 724634 h 2659757"/>
                        <a:gd name="connsiteX42" fmla="*/ 1415699 w 1918790"/>
                        <a:gd name="connsiteY42" fmla="*/ 750882 h 2659757"/>
                        <a:gd name="connsiteX0" fmla="*/ 1415699 w 1918790"/>
                        <a:gd name="connsiteY0" fmla="*/ 750882 h 2659305"/>
                        <a:gd name="connsiteX1" fmla="*/ 1273459 w 1918790"/>
                        <a:gd name="connsiteY1" fmla="*/ 192082 h 2659305"/>
                        <a:gd name="connsiteX2" fmla="*/ 907699 w 1918790"/>
                        <a:gd name="connsiteY2" fmla="*/ 9202 h 2659305"/>
                        <a:gd name="connsiteX3" fmla="*/ 562259 w 1918790"/>
                        <a:gd name="connsiteY3" fmla="*/ 435922 h 2659305"/>
                        <a:gd name="connsiteX4" fmla="*/ 379379 w 1918790"/>
                        <a:gd name="connsiteY4" fmla="*/ 954082 h 2659305"/>
                        <a:gd name="connsiteX5" fmla="*/ 298099 w 1918790"/>
                        <a:gd name="connsiteY5" fmla="*/ 1330002 h 2659305"/>
                        <a:gd name="connsiteX6" fmla="*/ 577725 w 1918790"/>
                        <a:gd name="connsiteY6" fmla="*/ 1308839 h 2659305"/>
                        <a:gd name="connsiteX7" fmla="*/ 785779 w 1918790"/>
                        <a:gd name="connsiteY7" fmla="*/ 1299522 h 2659305"/>
                        <a:gd name="connsiteX8" fmla="*/ 1039779 w 1918790"/>
                        <a:gd name="connsiteY8" fmla="*/ 1238562 h 2659305"/>
                        <a:gd name="connsiteX9" fmla="*/ 1192179 w 1918790"/>
                        <a:gd name="connsiteY9" fmla="*/ 1136962 h 2659305"/>
                        <a:gd name="connsiteX10" fmla="*/ 1283619 w 1918790"/>
                        <a:gd name="connsiteY10" fmla="*/ 1004882 h 2659305"/>
                        <a:gd name="connsiteX11" fmla="*/ 1344579 w 1918790"/>
                        <a:gd name="connsiteY11" fmla="*/ 913442 h 2659305"/>
                        <a:gd name="connsiteX12" fmla="*/ 1226412 w 1918790"/>
                        <a:gd name="connsiteY12" fmla="*/ 1123422 h 2659305"/>
                        <a:gd name="connsiteX13" fmla="*/ 1070259 w 1918790"/>
                        <a:gd name="connsiteY13" fmla="*/ 1250417 h 2659305"/>
                        <a:gd name="connsiteX14" fmla="*/ 810953 w 1918790"/>
                        <a:gd name="connsiteY14" fmla="*/ 1314767 h 2659305"/>
                        <a:gd name="connsiteX15" fmla="*/ 247299 w 1918790"/>
                        <a:gd name="connsiteY15" fmla="*/ 1401122 h 2659305"/>
                        <a:gd name="connsiteX16" fmla="*/ 84739 w 1918790"/>
                        <a:gd name="connsiteY16" fmla="*/ 1919282 h 2659305"/>
                        <a:gd name="connsiteX17" fmla="*/ 22679 w 1918790"/>
                        <a:gd name="connsiteY17" fmla="*/ 2323987 h 2659305"/>
                        <a:gd name="connsiteX18" fmla="*/ 9412 w 1918790"/>
                        <a:gd name="connsiteY18" fmla="*/ 2467922 h 2659305"/>
                        <a:gd name="connsiteX19" fmla="*/ 24685 w 1918790"/>
                        <a:gd name="connsiteY19" fmla="*/ 2653340 h 2659305"/>
                        <a:gd name="connsiteX20" fmla="*/ 277779 w 1918790"/>
                        <a:gd name="connsiteY20" fmla="*/ 2610162 h 2659305"/>
                        <a:gd name="connsiteX21" fmla="*/ 568212 w 1918790"/>
                        <a:gd name="connsiteY21" fmla="*/ 2574384 h 2659305"/>
                        <a:gd name="connsiteX22" fmla="*/ 806291 w 1918790"/>
                        <a:gd name="connsiteY22" fmla="*/ 2508800 h 2659305"/>
                        <a:gd name="connsiteX23" fmla="*/ 1334419 w 1918790"/>
                        <a:gd name="connsiteY23" fmla="*/ 2254562 h 2659305"/>
                        <a:gd name="connsiteX24" fmla="*/ 1415699 w 1918790"/>
                        <a:gd name="connsiteY24" fmla="*/ 1959922 h 2659305"/>
                        <a:gd name="connsiteX25" fmla="*/ 1425859 w 1918790"/>
                        <a:gd name="connsiteY25" fmla="*/ 1573842 h 2659305"/>
                        <a:gd name="connsiteX26" fmla="*/ 1407092 w 1918790"/>
                        <a:gd name="connsiteY26" fmla="*/ 1238562 h 2659305"/>
                        <a:gd name="connsiteX27" fmla="*/ 1415699 w 1918790"/>
                        <a:gd name="connsiteY27" fmla="*/ 1086162 h 2659305"/>
                        <a:gd name="connsiteX28" fmla="*/ 1679859 w 1918790"/>
                        <a:gd name="connsiteY28" fmla="*/ 1025202 h 2659305"/>
                        <a:gd name="connsiteX29" fmla="*/ 1700179 w 1918790"/>
                        <a:gd name="connsiteY29" fmla="*/ 913442 h 2659305"/>
                        <a:gd name="connsiteX30" fmla="*/ 1527459 w 1918790"/>
                        <a:gd name="connsiteY30" fmla="*/ 923602 h 2659305"/>
                        <a:gd name="connsiteX31" fmla="*/ 1415699 w 1918790"/>
                        <a:gd name="connsiteY31" fmla="*/ 954082 h 2659305"/>
                        <a:gd name="connsiteX32" fmla="*/ 1415699 w 1918790"/>
                        <a:gd name="connsiteY32" fmla="*/ 893122 h 2659305"/>
                        <a:gd name="connsiteX33" fmla="*/ 1415699 w 1918790"/>
                        <a:gd name="connsiteY33" fmla="*/ 913442 h 2659305"/>
                        <a:gd name="connsiteX34" fmla="*/ 1537619 w 1918790"/>
                        <a:gd name="connsiteY34" fmla="*/ 882962 h 2659305"/>
                        <a:gd name="connsiteX35" fmla="*/ 1629059 w 1918790"/>
                        <a:gd name="connsiteY35" fmla="*/ 842322 h 2659305"/>
                        <a:gd name="connsiteX36" fmla="*/ 1730659 w 1918790"/>
                        <a:gd name="connsiteY36" fmla="*/ 740722 h 2659305"/>
                        <a:gd name="connsiteX37" fmla="*/ 1883059 w 1918790"/>
                        <a:gd name="connsiteY37" fmla="*/ 496882 h 2659305"/>
                        <a:gd name="connsiteX38" fmla="*/ 1913539 w 1918790"/>
                        <a:gd name="connsiteY38" fmla="*/ 425762 h 2659305"/>
                        <a:gd name="connsiteX39" fmla="*/ 1801779 w 1918790"/>
                        <a:gd name="connsiteY39" fmla="*/ 385122 h 2659305"/>
                        <a:gd name="connsiteX40" fmla="*/ 1679859 w 1918790"/>
                        <a:gd name="connsiteY40" fmla="*/ 608642 h 2659305"/>
                        <a:gd name="connsiteX41" fmla="*/ 1592173 w 1918790"/>
                        <a:gd name="connsiteY41" fmla="*/ 724634 h 2659305"/>
                        <a:gd name="connsiteX42" fmla="*/ 1415699 w 1918790"/>
                        <a:gd name="connsiteY42" fmla="*/ 750882 h 2659305"/>
                        <a:gd name="connsiteX0" fmla="*/ 1415699 w 1918790"/>
                        <a:gd name="connsiteY0" fmla="*/ 750882 h 2666577"/>
                        <a:gd name="connsiteX1" fmla="*/ 1273459 w 1918790"/>
                        <a:gd name="connsiteY1" fmla="*/ 192082 h 2666577"/>
                        <a:gd name="connsiteX2" fmla="*/ 907699 w 1918790"/>
                        <a:gd name="connsiteY2" fmla="*/ 9202 h 2666577"/>
                        <a:gd name="connsiteX3" fmla="*/ 562259 w 1918790"/>
                        <a:gd name="connsiteY3" fmla="*/ 435922 h 2666577"/>
                        <a:gd name="connsiteX4" fmla="*/ 379379 w 1918790"/>
                        <a:gd name="connsiteY4" fmla="*/ 954082 h 2666577"/>
                        <a:gd name="connsiteX5" fmla="*/ 298099 w 1918790"/>
                        <a:gd name="connsiteY5" fmla="*/ 1330002 h 2666577"/>
                        <a:gd name="connsiteX6" fmla="*/ 577725 w 1918790"/>
                        <a:gd name="connsiteY6" fmla="*/ 1308839 h 2666577"/>
                        <a:gd name="connsiteX7" fmla="*/ 785779 w 1918790"/>
                        <a:gd name="connsiteY7" fmla="*/ 1299522 h 2666577"/>
                        <a:gd name="connsiteX8" fmla="*/ 1039779 w 1918790"/>
                        <a:gd name="connsiteY8" fmla="*/ 1238562 h 2666577"/>
                        <a:gd name="connsiteX9" fmla="*/ 1192179 w 1918790"/>
                        <a:gd name="connsiteY9" fmla="*/ 1136962 h 2666577"/>
                        <a:gd name="connsiteX10" fmla="*/ 1283619 w 1918790"/>
                        <a:gd name="connsiteY10" fmla="*/ 1004882 h 2666577"/>
                        <a:gd name="connsiteX11" fmla="*/ 1344579 w 1918790"/>
                        <a:gd name="connsiteY11" fmla="*/ 913442 h 2666577"/>
                        <a:gd name="connsiteX12" fmla="*/ 1226412 w 1918790"/>
                        <a:gd name="connsiteY12" fmla="*/ 1123422 h 2666577"/>
                        <a:gd name="connsiteX13" fmla="*/ 1070259 w 1918790"/>
                        <a:gd name="connsiteY13" fmla="*/ 1250417 h 2666577"/>
                        <a:gd name="connsiteX14" fmla="*/ 810953 w 1918790"/>
                        <a:gd name="connsiteY14" fmla="*/ 1314767 h 2666577"/>
                        <a:gd name="connsiteX15" fmla="*/ 247299 w 1918790"/>
                        <a:gd name="connsiteY15" fmla="*/ 1401122 h 2666577"/>
                        <a:gd name="connsiteX16" fmla="*/ 84739 w 1918790"/>
                        <a:gd name="connsiteY16" fmla="*/ 1919282 h 2666577"/>
                        <a:gd name="connsiteX17" fmla="*/ 22679 w 1918790"/>
                        <a:gd name="connsiteY17" fmla="*/ 2323987 h 2666577"/>
                        <a:gd name="connsiteX18" fmla="*/ 9412 w 1918790"/>
                        <a:gd name="connsiteY18" fmla="*/ 2467922 h 2666577"/>
                        <a:gd name="connsiteX19" fmla="*/ 24685 w 1918790"/>
                        <a:gd name="connsiteY19" fmla="*/ 2653340 h 2666577"/>
                        <a:gd name="connsiteX20" fmla="*/ 277779 w 1918790"/>
                        <a:gd name="connsiteY20" fmla="*/ 2643073 h 2666577"/>
                        <a:gd name="connsiteX21" fmla="*/ 568212 w 1918790"/>
                        <a:gd name="connsiteY21" fmla="*/ 2574384 h 2666577"/>
                        <a:gd name="connsiteX22" fmla="*/ 806291 w 1918790"/>
                        <a:gd name="connsiteY22" fmla="*/ 2508800 h 2666577"/>
                        <a:gd name="connsiteX23" fmla="*/ 1334419 w 1918790"/>
                        <a:gd name="connsiteY23" fmla="*/ 2254562 h 2666577"/>
                        <a:gd name="connsiteX24" fmla="*/ 1415699 w 1918790"/>
                        <a:gd name="connsiteY24" fmla="*/ 1959922 h 2666577"/>
                        <a:gd name="connsiteX25" fmla="*/ 1425859 w 1918790"/>
                        <a:gd name="connsiteY25" fmla="*/ 1573842 h 2666577"/>
                        <a:gd name="connsiteX26" fmla="*/ 1407092 w 1918790"/>
                        <a:gd name="connsiteY26" fmla="*/ 1238562 h 2666577"/>
                        <a:gd name="connsiteX27" fmla="*/ 1415699 w 1918790"/>
                        <a:gd name="connsiteY27" fmla="*/ 1086162 h 2666577"/>
                        <a:gd name="connsiteX28" fmla="*/ 1679859 w 1918790"/>
                        <a:gd name="connsiteY28" fmla="*/ 1025202 h 2666577"/>
                        <a:gd name="connsiteX29" fmla="*/ 1700179 w 1918790"/>
                        <a:gd name="connsiteY29" fmla="*/ 913442 h 2666577"/>
                        <a:gd name="connsiteX30" fmla="*/ 1527459 w 1918790"/>
                        <a:gd name="connsiteY30" fmla="*/ 923602 h 2666577"/>
                        <a:gd name="connsiteX31" fmla="*/ 1415699 w 1918790"/>
                        <a:gd name="connsiteY31" fmla="*/ 954082 h 2666577"/>
                        <a:gd name="connsiteX32" fmla="*/ 1415699 w 1918790"/>
                        <a:gd name="connsiteY32" fmla="*/ 893122 h 2666577"/>
                        <a:gd name="connsiteX33" fmla="*/ 1415699 w 1918790"/>
                        <a:gd name="connsiteY33" fmla="*/ 913442 h 2666577"/>
                        <a:gd name="connsiteX34" fmla="*/ 1537619 w 1918790"/>
                        <a:gd name="connsiteY34" fmla="*/ 882962 h 2666577"/>
                        <a:gd name="connsiteX35" fmla="*/ 1629059 w 1918790"/>
                        <a:gd name="connsiteY35" fmla="*/ 842322 h 2666577"/>
                        <a:gd name="connsiteX36" fmla="*/ 1730659 w 1918790"/>
                        <a:gd name="connsiteY36" fmla="*/ 740722 h 2666577"/>
                        <a:gd name="connsiteX37" fmla="*/ 1883059 w 1918790"/>
                        <a:gd name="connsiteY37" fmla="*/ 496882 h 2666577"/>
                        <a:gd name="connsiteX38" fmla="*/ 1913539 w 1918790"/>
                        <a:gd name="connsiteY38" fmla="*/ 425762 h 2666577"/>
                        <a:gd name="connsiteX39" fmla="*/ 1801779 w 1918790"/>
                        <a:gd name="connsiteY39" fmla="*/ 385122 h 2666577"/>
                        <a:gd name="connsiteX40" fmla="*/ 1679859 w 1918790"/>
                        <a:gd name="connsiteY40" fmla="*/ 608642 h 2666577"/>
                        <a:gd name="connsiteX41" fmla="*/ 1592173 w 1918790"/>
                        <a:gd name="connsiteY41" fmla="*/ 724634 h 2666577"/>
                        <a:gd name="connsiteX42" fmla="*/ 1415699 w 1918790"/>
                        <a:gd name="connsiteY42" fmla="*/ 750882 h 2666577"/>
                        <a:gd name="connsiteX0" fmla="*/ 1415699 w 1918790"/>
                        <a:gd name="connsiteY0" fmla="*/ 750882 h 2666577"/>
                        <a:gd name="connsiteX1" fmla="*/ 1273459 w 1918790"/>
                        <a:gd name="connsiteY1" fmla="*/ 192082 h 2666577"/>
                        <a:gd name="connsiteX2" fmla="*/ 907699 w 1918790"/>
                        <a:gd name="connsiteY2" fmla="*/ 9202 h 2666577"/>
                        <a:gd name="connsiteX3" fmla="*/ 562259 w 1918790"/>
                        <a:gd name="connsiteY3" fmla="*/ 435922 h 2666577"/>
                        <a:gd name="connsiteX4" fmla="*/ 379379 w 1918790"/>
                        <a:gd name="connsiteY4" fmla="*/ 954082 h 2666577"/>
                        <a:gd name="connsiteX5" fmla="*/ 298099 w 1918790"/>
                        <a:gd name="connsiteY5" fmla="*/ 1330002 h 2666577"/>
                        <a:gd name="connsiteX6" fmla="*/ 577725 w 1918790"/>
                        <a:gd name="connsiteY6" fmla="*/ 1308839 h 2666577"/>
                        <a:gd name="connsiteX7" fmla="*/ 785779 w 1918790"/>
                        <a:gd name="connsiteY7" fmla="*/ 1299522 h 2666577"/>
                        <a:gd name="connsiteX8" fmla="*/ 1039779 w 1918790"/>
                        <a:gd name="connsiteY8" fmla="*/ 1238562 h 2666577"/>
                        <a:gd name="connsiteX9" fmla="*/ 1192179 w 1918790"/>
                        <a:gd name="connsiteY9" fmla="*/ 1136962 h 2666577"/>
                        <a:gd name="connsiteX10" fmla="*/ 1283619 w 1918790"/>
                        <a:gd name="connsiteY10" fmla="*/ 1004882 h 2666577"/>
                        <a:gd name="connsiteX11" fmla="*/ 1344579 w 1918790"/>
                        <a:gd name="connsiteY11" fmla="*/ 913442 h 2666577"/>
                        <a:gd name="connsiteX12" fmla="*/ 1226412 w 1918790"/>
                        <a:gd name="connsiteY12" fmla="*/ 1123422 h 2666577"/>
                        <a:gd name="connsiteX13" fmla="*/ 1070259 w 1918790"/>
                        <a:gd name="connsiteY13" fmla="*/ 1250417 h 2666577"/>
                        <a:gd name="connsiteX14" fmla="*/ 810953 w 1918790"/>
                        <a:gd name="connsiteY14" fmla="*/ 1314767 h 2666577"/>
                        <a:gd name="connsiteX15" fmla="*/ 247299 w 1918790"/>
                        <a:gd name="connsiteY15" fmla="*/ 1401122 h 2666577"/>
                        <a:gd name="connsiteX16" fmla="*/ 84739 w 1918790"/>
                        <a:gd name="connsiteY16" fmla="*/ 1919282 h 2666577"/>
                        <a:gd name="connsiteX17" fmla="*/ 22679 w 1918790"/>
                        <a:gd name="connsiteY17" fmla="*/ 2323987 h 2666577"/>
                        <a:gd name="connsiteX18" fmla="*/ 9412 w 1918790"/>
                        <a:gd name="connsiteY18" fmla="*/ 2467922 h 2666577"/>
                        <a:gd name="connsiteX19" fmla="*/ 24685 w 1918790"/>
                        <a:gd name="connsiteY19" fmla="*/ 2653340 h 2666577"/>
                        <a:gd name="connsiteX20" fmla="*/ 277779 w 1918790"/>
                        <a:gd name="connsiteY20" fmla="*/ 2643073 h 2666577"/>
                        <a:gd name="connsiteX21" fmla="*/ 568212 w 1918790"/>
                        <a:gd name="connsiteY21" fmla="*/ 2574384 h 2666577"/>
                        <a:gd name="connsiteX22" fmla="*/ 806291 w 1918790"/>
                        <a:gd name="connsiteY22" fmla="*/ 2508800 h 2666577"/>
                        <a:gd name="connsiteX23" fmla="*/ 1334419 w 1918790"/>
                        <a:gd name="connsiteY23" fmla="*/ 2254562 h 2666577"/>
                        <a:gd name="connsiteX24" fmla="*/ 1415699 w 1918790"/>
                        <a:gd name="connsiteY24" fmla="*/ 1959922 h 2666577"/>
                        <a:gd name="connsiteX25" fmla="*/ 1425859 w 1918790"/>
                        <a:gd name="connsiteY25" fmla="*/ 1573842 h 2666577"/>
                        <a:gd name="connsiteX26" fmla="*/ 1407092 w 1918790"/>
                        <a:gd name="connsiteY26" fmla="*/ 1238562 h 2666577"/>
                        <a:gd name="connsiteX27" fmla="*/ 1415699 w 1918790"/>
                        <a:gd name="connsiteY27" fmla="*/ 1086162 h 2666577"/>
                        <a:gd name="connsiteX28" fmla="*/ 1679859 w 1918790"/>
                        <a:gd name="connsiteY28" fmla="*/ 1025202 h 2666577"/>
                        <a:gd name="connsiteX29" fmla="*/ 1700179 w 1918790"/>
                        <a:gd name="connsiteY29" fmla="*/ 913442 h 2666577"/>
                        <a:gd name="connsiteX30" fmla="*/ 1527459 w 1918790"/>
                        <a:gd name="connsiteY30" fmla="*/ 923602 h 2666577"/>
                        <a:gd name="connsiteX31" fmla="*/ 1415699 w 1918790"/>
                        <a:gd name="connsiteY31" fmla="*/ 954082 h 2666577"/>
                        <a:gd name="connsiteX32" fmla="*/ 1415699 w 1918790"/>
                        <a:gd name="connsiteY32" fmla="*/ 893122 h 2666577"/>
                        <a:gd name="connsiteX33" fmla="*/ 1415699 w 1918790"/>
                        <a:gd name="connsiteY33" fmla="*/ 913442 h 2666577"/>
                        <a:gd name="connsiteX34" fmla="*/ 1537619 w 1918790"/>
                        <a:gd name="connsiteY34" fmla="*/ 882962 h 2666577"/>
                        <a:gd name="connsiteX35" fmla="*/ 1629059 w 1918790"/>
                        <a:gd name="connsiteY35" fmla="*/ 842322 h 2666577"/>
                        <a:gd name="connsiteX36" fmla="*/ 1730659 w 1918790"/>
                        <a:gd name="connsiteY36" fmla="*/ 740722 h 2666577"/>
                        <a:gd name="connsiteX37" fmla="*/ 1883059 w 1918790"/>
                        <a:gd name="connsiteY37" fmla="*/ 496882 h 2666577"/>
                        <a:gd name="connsiteX38" fmla="*/ 1913539 w 1918790"/>
                        <a:gd name="connsiteY38" fmla="*/ 425762 h 2666577"/>
                        <a:gd name="connsiteX39" fmla="*/ 1801779 w 1918790"/>
                        <a:gd name="connsiteY39" fmla="*/ 385122 h 2666577"/>
                        <a:gd name="connsiteX40" fmla="*/ 1679859 w 1918790"/>
                        <a:gd name="connsiteY40" fmla="*/ 608642 h 2666577"/>
                        <a:gd name="connsiteX41" fmla="*/ 1592173 w 1918790"/>
                        <a:gd name="connsiteY41" fmla="*/ 724634 h 2666577"/>
                        <a:gd name="connsiteX42" fmla="*/ 1415699 w 1918790"/>
                        <a:gd name="connsiteY42" fmla="*/ 750882 h 2666577"/>
                        <a:gd name="connsiteX0" fmla="*/ 1415699 w 1918790"/>
                        <a:gd name="connsiteY0" fmla="*/ 750882 h 2676457"/>
                        <a:gd name="connsiteX1" fmla="*/ 1273459 w 1918790"/>
                        <a:gd name="connsiteY1" fmla="*/ 192082 h 2676457"/>
                        <a:gd name="connsiteX2" fmla="*/ 907699 w 1918790"/>
                        <a:gd name="connsiteY2" fmla="*/ 9202 h 2676457"/>
                        <a:gd name="connsiteX3" fmla="*/ 562259 w 1918790"/>
                        <a:gd name="connsiteY3" fmla="*/ 435922 h 2676457"/>
                        <a:gd name="connsiteX4" fmla="*/ 379379 w 1918790"/>
                        <a:gd name="connsiteY4" fmla="*/ 954082 h 2676457"/>
                        <a:gd name="connsiteX5" fmla="*/ 298099 w 1918790"/>
                        <a:gd name="connsiteY5" fmla="*/ 1330002 h 2676457"/>
                        <a:gd name="connsiteX6" fmla="*/ 577725 w 1918790"/>
                        <a:gd name="connsiteY6" fmla="*/ 1308839 h 2676457"/>
                        <a:gd name="connsiteX7" fmla="*/ 785779 w 1918790"/>
                        <a:gd name="connsiteY7" fmla="*/ 1299522 h 2676457"/>
                        <a:gd name="connsiteX8" fmla="*/ 1039779 w 1918790"/>
                        <a:gd name="connsiteY8" fmla="*/ 1238562 h 2676457"/>
                        <a:gd name="connsiteX9" fmla="*/ 1192179 w 1918790"/>
                        <a:gd name="connsiteY9" fmla="*/ 1136962 h 2676457"/>
                        <a:gd name="connsiteX10" fmla="*/ 1283619 w 1918790"/>
                        <a:gd name="connsiteY10" fmla="*/ 1004882 h 2676457"/>
                        <a:gd name="connsiteX11" fmla="*/ 1344579 w 1918790"/>
                        <a:gd name="connsiteY11" fmla="*/ 913442 h 2676457"/>
                        <a:gd name="connsiteX12" fmla="*/ 1226412 w 1918790"/>
                        <a:gd name="connsiteY12" fmla="*/ 1123422 h 2676457"/>
                        <a:gd name="connsiteX13" fmla="*/ 1070259 w 1918790"/>
                        <a:gd name="connsiteY13" fmla="*/ 1250417 h 2676457"/>
                        <a:gd name="connsiteX14" fmla="*/ 810953 w 1918790"/>
                        <a:gd name="connsiteY14" fmla="*/ 1314767 h 2676457"/>
                        <a:gd name="connsiteX15" fmla="*/ 247299 w 1918790"/>
                        <a:gd name="connsiteY15" fmla="*/ 1401122 h 2676457"/>
                        <a:gd name="connsiteX16" fmla="*/ 84739 w 1918790"/>
                        <a:gd name="connsiteY16" fmla="*/ 1919282 h 2676457"/>
                        <a:gd name="connsiteX17" fmla="*/ 22679 w 1918790"/>
                        <a:gd name="connsiteY17" fmla="*/ 2323987 h 2676457"/>
                        <a:gd name="connsiteX18" fmla="*/ 9412 w 1918790"/>
                        <a:gd name="connsiteY18" fmla="*/ 2467922 h 2676457"/>
                        <a:gd name="connsiteX19" fmla="*/ 24685 w 1918790"/>
                        <a:gd name="connsiteY19" fmla="*/ 2653340 h 2676457"/>
                        <a:gd name="connsiteX20" fmla="*/ 277779 w 1918790"/>
                        <a:gd name="connsiteY20" fmla="*/ 2665014 h 2676457"/>
                        <a:gd name="connsiteX21" fmla="*/ 568212 w 1918790"/>
                        <a:gd name="connsiteY21" fmla="*/ 2574384 h 2676457"/>
                        <a:gd name="connsiteX22" fmla="*/ 806291 w 1918790"/>
                        <a:gd name="connsiteY22" fmla="*/ 2508800 h 2676457"/>
                        <a:gd name="connsiteX23" fmla="*/ 1334419 w 1918790"/>
                        <a:gd name="connsiteY23" fmla="*/ 2254562 h 2676457"/>
                        <a:gd name="connsiteX24" fmla="*/ 1415699 w 1918790"/>
                        <a:gd name="connsiteY24" fmla="*/ 1959922 h 2676457"/>
                        <a:gd name="connsiteX25" fmla="*/ 1425859 w 1918790"/>
                        <a:gd name="connsiteY25" fmla="*/ 1573842 h 2676457"/>
                        <a:gd name="connsiteX26" fmla="*/ 1407092 w 1918790"/>
                        <a:gd name="connsiteY26" fmla="*/ 1238562 h 2676457"/>
                        <a:gd name="connsiteX27" fmla="*/ 1415699 w 1918790"/>
                        <a:gd name="connsiteY27" fmla="*/ 1086162 h 2676457"/>
                        <a:gd name="connsiteX28" fmla="*/ 1679859 w 1918790"/>
                        <a:gd name="connsiteY28" fmla="*/ 1025202 h 2676457"/>
                        <a:gd name="connsiteX29" fmla="*/ 1700179 w 1918790"/>
                        <a:gd name="connsiteY29" fmla="*/ 913442 h 2676457"/>
                        <a:gd name="connsiteX30" fmla="*/ 1527459 w 1918790"/>
                        <a:gd name="connsiteY30" fmla="*/ 923602 h 2676457"/>
                        <a:gd name="connsiteX31" fmla="*/ 1415699 w 1918790"/>
                        <a:gd name="connsiteY31" fmla="*/ 954082 h 2676457"/>
                        <a:gd name="connsiteX32" fmla="*/ 1415699 w 1918790"/>
                        <a:gd name="connsiteY32" fmla="*/ 893122 h 2676457"/>
                        <a:gd name="connsiteX33" fmla="*/ 1415699 w 1918790"/>
                        <a:gd name="connsiteY33" fmla="*/ 913442 h 2676457"/>
                        <a:gd name="connsiteX34" fmla="*/ 1537619 w 1918790"/>
                        <a:gd name="connsiteY34" fmla="*/ 882962 h 2676457"/>
                        <a:gd name="connsiteX35" fmla="*/ 1629059 w 1918790"/>
                        <a:gd name="connsiteY35" fmla="*/ 842322 h 2676457"/>
                        <a:gd name="connsiteX36" fmla="*/ 1730659 w 1918790"/>
                        <a:gd name="connsiteY36" fmla="*/ 740722 h 2676457"/>
                        <a:gd name="connsiteX37" fmla="*/ 1883059 w 1918790"/>
                        <a:gd name="connsiteY37" fmla="*/ 496882 h 2676457"/>
                        <a:gd name="connsiteX38" fmla="*/ 1913539 w 1918790"/>
                        <a:gd name="connsiteY38" fmla="*/ 425762 h 2676457"/>
                        <a:gd name="connsiteX39" fmla="*/ 1801779 w 1918790"/>
                        <a:gd name="connsiteY39" fmla="*/ 385122 h 2676457"/>
                        <a:gd name="connsiteX40" fmla="*/ 1679859 w 1918790"/>
                        <a:gd name="connsiteY40" fmla="*/ 608642 h 2676457"/>
                        <a:gd name="connsiteX41" fmla="*/ 1592173 w 1918790"/>
                        <a:gd name="connsiteY41" fmla="*/ 724634 h 2676457"/>
                        <a:gd name="connsiteX42" fmla="*/ 1415699 w 1918790"/>
                        <a:gd name="connsiteY42" fmla="*/ 750882 h 2676457"/>
                        <a:gd name="connsiteX0" fmla="*/ 1415699 w 1918790"/>
                        <a:gd name="connsiteY0" fmla="*/ 750882 h 2672760"/>
                        <a:gd name="connsiteX1" fmla="*/ 1273459 w 1918790"/>
                        <a:gd name="connsiteY1" fmla="*/ 192082 h 2672760"/>
                        <a:gd name="connsiteX2" fmla="*/ 907699 w 1918790"/>
                        <a:gd name="connsiteY2" fmla="*/ 9202 h 2672760"/>
                        <a:gd name="connsiteX3" fmla="*/ 562259 w 1918790"/>
                        <a:gd name="connsiteY3" fmla="*/ 435922 h 2672760"/>
                        <a:gd name="connsiteX4" fmla="*/ 379379 w 1918790"/>
                        <a:gd name="connsiteY4" fmla="*/ 954082 h 2672760"/>
                        <a:gd name="connsiteX5" fmla="*/ 298099 w 1918790"/>
                        <a:gd name="connsiteY5" fmla="*/ 1330002 h 2672760"/>
                        <a:gd name="connsiteX6" fmla="*/ 577725 w 1918790"/>
                        <a:gd name="connsiteY6" fmla="*/ 1308839 h 2672760"/>
                        <a:gd name="connsiteX7" fmla="*/ 785779 w 1918790"/>
                        <a:gd name="connsiteY7" fmla="*/ 1299522 h 2672760"/>
                        <a:gd name="connsiteX8" fmla="*/ 1039779 w 1918790"/>
                        <a:gd name="connsiteY8" fmla="*/ 1238562 h 2672760"/>
                        <a:gd name="connsiteX9" fmla="*/ 1192179 w 1918790"/>
                        <a:gd name="connsiteY9" fmla="*/ 1136962 h 2672760"/>
                        <a:gd name="connsiteX10" fmla="*/ 1283619 w 1918790"/>
                        <a:gd name="connsiteY10" fmla="*/ 1004882 h 2672760"/>
                        <a:gd name="connsiteX11" fmla="*/ 1344579 w 1918790"/>
                        <a:gd name="connsiteY11" fmla="*/ 913442 h 2672760"/>
                        <a:gd name="connsiteX12" fmla="*/ 1226412 w 1918790"/>
                        <a:gd name="connsiteY12" fmla="*/ 1123422 h 2672760"/>
                        <a:gd name="connsiteX13" fmla="*/ 1070259 w 1918790"/>
                        <a:gd name="connsiteY13" fmla="*/ 1250417 h 2672760"/>
                        <a:gd name="connsiteX14" fmla="*/ 810953 w 1918790"/>
                        <a:gd name="connsiteY14" fmla="*/ 1314767 h 2672760"/>
                        <a:gd name="connsiteX15" fmla="*/ 247299 w 1918790"/>
                        <a:gd name="connsiteY15" fmla="*/ 1401122 h 2672760"/>
                        <a:gd name="connsiteX16" fmla="*/ 84739 w 1918790"/>
                        <a:gd name="connsiteY16" fmla="*/ 1919282 h 2672760"/>
                        <a:gd name="connsiteX17" fmla="*/ 22679 w 1918790"/>
                        <a:gd name="connsiteY17" fmla="*/ 2323987 h 2672760"/>
                        <a:gd name="connsiteX18" fmla="*/ 9412 w 1918790"/>
                        <a:gd name="connsiteY18" fmla="*/ 2467922 h 2672760"/>
                        <a:gd name="connsiteX19" fmla="*/ 24685 w 1918790"/>
                        <a:gd name="connsiteY19" fmla="*/ 2653340 h 2672760"/>
                        <a:gd name="connsiteX20" fmla="*/ 277779 w 1918790"/>
                        <a:gd name="connsiteY20" fmla="*/ 2665014 h 2672760"/>
                        <a:gd name="connsiteX21" fmla="*/ 622861 w 1918790"/>
                        <a:gd name="connsiteY21" fmla="*/ 2634720 h 2672760"/>
                        <a:gd name="connsiteX22" fmla="*/ 806291 w 1918790"/>
                        <a:gd name="connsiteY22" fmla="*/ 2508800 h 2672760"/>
                        <a:gd name="connsiteX23" fmla="*/ 1334419 w 1918790"/>
                        <a:gd name="connsiteY23" fmla="*/ 2254562 h 2672760"/>
                        <a:gd name="connsiteX24" fmla="*/ 1415699 w 1918790"/>
                        <a:gd name="connsiteY24" fmla="*/ 1959922 h 2672760"/>
                        <a:gd name="connsiteX25" fmla="*/ 1425859 w 1918790"/>
                        <a:gd name="connsiteY25" fmla="*/ 1573842 h 2672760"/>
                        <a:gd name="connsiteX26" fmla="*/ 1407092 w 1918790"/>
                        <a:gd name="connsiteY26" fmla="*/ 1238562 h 2672760"/>
                        <a:gd name="connsiteX27" fmla="*/ 1415699 w 1918790"/>
                        <a:gd name="connsiteY27" fmla="*/ 1086162 h 2672760"/>
                        <a:gd name="connsiteX28" fmla="*/ 1679859 w 1918790"/>
                        <a:gd name="connsiteY28" fmla="*/ 1025202 h 2672760"/>
                        <a:gd name="connsiteX29" fmla="*/ 1700179 w 1918790"/>
                        <a:gd name="connsiteY29" fmla="*/ 913442 h 2672760"/>
                        <a:gd name="connsiteX30" fmla="*/ 1527459 w 1918790"/>
                        <a:gd name="connsiteY30" fmla="*/ 923602 h 2672760"/>
                        <a:gd name="connsiteX31" fmla="*/ 1415699 w 1918790"/>
                        <a:gd name="connsiteY31" fmla="*/ 954082 h 2672760"/>
                        <a:gd name="connsiteX32" fmla="*/ 1415699 w 1918790"/>
                        <a:gd name="connsiteY32" fmla="*/ 893122 h 2672760"/>
                        <a:gd name="connsiteX33" fmla="*/ 1415699 w 1918790"/>
                        <a:gd name="connsiteY33" fmla="*/ 913442 h 2672760"/>
                        <a:gd name="connsiteX34" fmla="*/ 1537619 w 1918790"/>
                        <a:gd name="connsiteY34" fmla="*/ 882962 h 2672760"/>
                        <a:gd name="connsiteX35" fmla="*/ 1629059 w 1918790"/>
                        <a:gd name="connsiteY35" fmla="*/ 842322 h 2672760"/>
                        <a:gd name="connsiteX36" fmla="*/ 1730659 w 1918790"/>
                        <a:gd name="connsiteY36" fmla="*/ 740722 h 2672760"/>
                        <a:gd name="connsiteX37" fmla="*/ 1883059 w 1918790"/>
                        <a:gd name="connsiteY37" fmla="*/ 496882 h 2672760"/>
                        <a:gd name="connsiteX38" fmla="*/ 1913539 w 1918790"/>
                        <a:gd name="connsiteY38" fmla="*/ 425762 h 2672760"/>
                        <a:gd name="connsiteX39" fmla="*/ 1801779 w 1918790"/>
                        <a:gd name="connsiteY39" fmla="*/ 385122 h 2672760"/>
                        <a:gd name="connsiteX40" fmla="*/ 1679859 w 1918790"/>
                        <a:gd name="connsiteY40" fmla="*/ 608642 h 2672760"/>
                        <a:gd name="connsiteX41" fmla="*/ 1592173 w 1918790"/>
                        <a:gd name="connsiteY41" fmla="*/ 724634 h 2672760"/>
                        <a:gd name="connsiteX42" fmla="*/ 1415699 w 1918790"/>
                        <a:gd name="connsiteY42" fmla="*/ 750882 h 2672760"/>
                        <a:gd name="connsiteX0" fmla="*/ 1415699 w 1918790"/>
                        <a:gd name="connsiteY0" fmla="*/ 750882 h 2672760"/>
                        <a:gd name="connsiteX1" fmla="*/ 1273459 w 1918790"/>
                        <a:gd name="connsiteY1" fmla="*/ 192082 h 2672760"/>
                        <a:gd name="connsiteX2" fmla="*/ 907699 w 1918790"/>
                        <a:gd name="connsiteY2" fmla="*/ 9202 h 2672760"/>
                        <a:gd name="connsiteX3" fmla="*/ 562259 w 1918790"/>
                        <a:gd name="connsiteY3" fmla="*/ 435922 h 2672760"/>
                        <a:gd name="connsiteX4" fmla="*/ 379379 w 1918790"/>
                        <a:gd name="connsiteY4" fmla="*/ 954082 h 2672760"/>
                        <a:gd name="connsiteX5" fmla="*/ 298099 w 1918790"/>
                        <a:gd name="connsiteY5" fmla="*/ 1330002 h 2672760"/>
                        <a:gd name="connsiteX6" fmla="*/ 577725 w 1918790"/>
                        <a:gd name="connsiteY6" fmla="*/ 1308839 h 2672760"/>
                        <a:gd name="connsiteX7" fmla="*/ 785779 w 1918790"/>
                        <a:gd name="connsiteY7" fmla="*/ 1299522 h 2672760"/>
                        <a:gd name="connsiteX8" fmla="*/ 1039779 w 1918790"/>
                        <a:gd name="connsiteY8" fmla="*/ 1238562 h 2672760"/>
                        <a:gd name="connsiteX9" fmla="*/ 1192179 w 1918790"/>
                        <a:gd name="connsiteY9" fmla="*/ 1136962 h 2672760"/>
                        <a:gd name="connsiteX10" fmla="*/ 1283619 w 1918790"/>
                        <a:gd name="connsiteY10" fmla="*/ 1004882 h 2672760"/>
                        <a:gd name="connsiteX11" fmla="*/ 1344579 w 1918790"/>
                        <a:gd name="connsiteY11" fmla="*/ 913442 h 2672760"/>
                        <a:gd name="connsiteX12" fmla="*/ 1226412 w 1918790"/>
                        <a:gd name="connsiteY12" fmla="*/ 1123422 h 2672760"/>
                        <a:gd name="connsiteX13" fmla="*/ 1070259 w 1918790"/>
                        <a:gd name="connsiteY13" fmla="*/ 1250417 h 2672760"/>
                        <a:gd name="connsiteX14" fmla="*/ 810953 w 1918790"/>
                        <a:gd name="connsiteY14" fmla="*/ 1314767 h 2672760"/>
                        <a:gd name="connsiteX15" fmla="*/ 247299 w 1918790"/>
                        <a:gd name="connsiteY15" fmla="*/ 1401122 h 2672760"/>
                        <a:gd name="connsiteX16" fmla="*/ 84739 w 1918790"/>
                        <a:gd name="connsiteY16" fmla="*/ 1919282 h 2672760"/>
                        <a:gd name="connsiteX17" fmla="*/ 22679 w 1918790"/>
                        <a:gd name="connsiteY17" fmla="*/ 2323987 h 2672760"/>
                        <a:gd name="connsiteX18" fmla="*/ 9412 w 1918790"/>
                        <a:gd name="connsiteY18" fmla="*/ 2467922 h 2672760"/>
                        <a:gd name="connsiteX19" fmla="*/ 24685 w 1918790"/>
                        <a:gd name="connsiteY19" fmla="*/ 2653340 h 2672760"/>
                        <a:gd name="connsiteX20" fmla="*/ 277779 w 1918790"/>
                        <a:gd name="connsiteY20" fmla="*/ 2665014 h 2672760"/>
                        <a:gd name="connsiteX21" fmla="*/ 622861 w 1918790"/>
                        <a:gd name="connsiteY21" fmla="*/ 2634720 h 2672760"/>
                        <a:gd name="connsiteX22" fmla="*/ 879157 w 1918790"/>
                        <a:gd name="connsiteY22" fmla="*/ 2591077 h 2672760"/>
                        <a:gd name="connsiteX23" fmla="*/ 1334419 w 1918790"/>
                        <a:gd name="connsiteY23" fmla="*/ 2254562 h 2672760"/>
                        <a:gd name="connsiteX24" fmla="*/ 1415699 w 1918790"/>
                        <a:gd name="connsiteY24" fmla="*/ 1959922 h 2672760"/>
                        <a:gd name="connsiteX25" fmla="*/ 1425859 w 1918790"/>
                        <a:gd name="connsiteY25" fmla="*/ 1573842 h 2672760"/>
                        <a:gd name="connsiteX26" fmla="*/ 1407092 w 1918790"/>
                        <a:gd name="connsiteY26" fmla="*/ 1238562 h 2672760"/>
                        <a:gd name="connsiteX27" fmla="*/ 1415699 w 1918790"/>
                        <a:gd name="connsiteY27" fmla="*/ 1086162 h 2672760"/>
                        <a:gd name="connsiteX28" fmla="*/ 1679859 w 1918790"/>
                        <a:gd name="connsiteY28" fmla="*/ 1025202 h 2672760"/>
                        <a:gd name="connsiteX29" fmla="*/ 1700179 w 1918790"/>
                        <a:gd name="connsiteY29" fmla="*/ 913442 h 2672760"/>
                        <a:gd name="connsiteX30" fmla="*/ 1527459 w 1918790"/>
                        <a:gd name="connsiteY30" fmla="*/ 923602 h 2672760"/>
                        <a:gd name="connsiteX31" fmla="*/ 1415699 w 1918790"/>
                        <a:gd name="connsiteY31" fmla="*/ 954082 h 2672760"/>
                        <a:gd name="connsiteX32" fmla="*/ 1415699 w 1918790"/>
                        <a:gd name="connsiteY32" fmla="*/ 893122 h 2672760"/>
                        <a:gd name="connsiteX33" fmla="*/ 1415699 w 1918790"/>
                        <a:gd name="connsiteY33" fmla="*/ 913442 h 2672760"/>
                        <a:gd name="connsiteX34" fmla="*/ 1537619 w 1918790"/>
                        <a:gd name="connsiteY34" fmla="*/ 882962 h 2672760"/>
                        <a:gd name="connsiteX35" fmla="*/ 1629059 w 1918790"/>
                        <a:gd name="connsiteY35" fmla="*/ 842322 h 2672760"/>
                        <a:gd name="connsiteX36" fmla="*/ 1730659 w 1918790"/>
                        <a:gd name="connsiteY36" fmla="*/ 740722 h 2672760"/>
                        <a:gd name="connsiteX37" fmla="*/ 1883059 w 1918790"/>
                        <a:gd name="connsiteY37" fmla="*/ 496882 h 2672760"/>
                        <a:gd name="connsiteX38" fmla="*/ 1913539 w 1918790"/>
                        <a:gd name="connsiteY38" fmla="*/ 425762 h 2672760"/>
                        <a:gd name="connsiteX39" fmla="*/ 1801779 w 1918790"/>
                        <a:gd name="connsiteY39" fmla="*/ 385122 h 2672760"/>
                        <a:gd name="connsiteX40" fmla="*/ 1679859 w 1918790"/>
                        <a:gd name="connsiteY40" fmla="*/ 608642 h 2672760"/>
                        <a:gd name="connsiteX41" fmla="*/ 1592173 w 1918790"/>
                        <a:gd name="connsiteY41" fmla="*/ 724634 h 2672760"/>
                        <a:gd name="connsiteX42" fmla="*/ 1415699 w 1918790"/>
                        <a:gd name="connsiteY42" fmla="*/ 750882 h 2672760"/>
                        <a:gd name="connsiteX0" fmla="*/ 1415699 w 1918790"/>
                        <a:gd name="connsiteY0" fmla="*/ 750882 h 2672760"/>
                        <a:gd name="connsiteX1" fmla="*/ 1273459 w 1918790"/>
                        <a:gd name="connsiteY1" fmla="*/ 192082 h 2672760"/>
                        <a:gd name="connsiteX2" fmla="*/ 907699 w 1918790"/>
                        <a:gd name="connsiteY2" fmla="*/ 9202 h 2672760"/>
                        <a:gd name="connsiteX3" fmla="*/ 562259 w 1918790"/>
                        <a:gd name="connsiteY3" fmla="*/ 435922 h 2672760"/>
                        <a:gd name="connsiteX4" fmla="*/ 379379 w 1918790"/>
                        <a:gd name="connsiteY4" fmla="*/ 954082 h 2672760"/>
                        <a:gd name="connsiteX5" fmla="*/ 298099 w 1918790"/>
                        <a:gd name="connsiteY5" fmla="*/ 1330002 h 2672760"/>
                        <a:gd name="connsiteX6" fmla="*/ 577725 w 1918790"/>
                        <a:gd name="connsiteY6" fmla="*/ 1308839 h 2672760"/>
                        <a:gd name="connsiteX7" fmla="*/ 785779 w 1918790"/>
                        <a:gd name="connsiteY7" fmla="*/ 1299522 h 2672760"/>
                        <a:gd name="connsiteX8" fmla="*/ 1039779 w 1918790"/>
                        <a:gd name="connsiteY8" fmla="*/ 1238562 h 2672760"/>
                        <a:gd name="connsiteX9" fmla="*/ 1192179 w 1918790"/>
                        <a:gd name="connsiteY9" fmla="*/ 1136962 h 2672760"/>
                        <a:gd name="connsiteX10" fmla="*/ 1283619 w 1918790"/>
                        <a:gd name="connsiteY10" fmla="*/ 1004882 h 2672760"/>
                        <a:gd name="connsiteX11" fmla="*/ 1344579 w 1918790"/>
                        <a:gd name="connsiteY11" fmla="*/ 913442 h 2672760"/>
                        <a:gd name="connsiteX12" fmla="*/ 1226412 w 1918790"/>
                        <a:gd name="connsiteY12" fmla="*/ 1123422 h 2672760"/>
                        <a:gd name="connsiteX13" fmla="*/ 1070259 w 1918790"/>
                        <a:gd name="connsiteY13" fmla="*/ 1250417 h 2672760"/>
                        <a:gd name="connsiteX14" fmla="*/ 810953 w 1918790"/>
                        <a:gd name="connsiteY14" fmla="*/ 1314767 h 2672760"/>
                        <a:gd name="connsiteX15" fmla="*/ 247299 w 1918790"/>
                        <a:gd name="connsiteY15" fmla="*/ 1401122 h 2672760"/>
                        <a:gd name="connsiteX16" fmla="*/ 84739 w 1918790"/>
                        <a:gd name="connsiteY16" fmla="*/ 1919282 h 2672760"/>
                        <a:gd name="connsiteX17" fmla="*/ 22679 w 1918790"/>
                        <a:gd name="connsiteY17" fmla="*/ 2323987 h 2672760"/>
                        <a:gd name="connsiteX18" fmla="*/ 9412 w 1918790"/>
                        <a:gd name="connsiteY18" fmla="*/ 2467922 h 2672760"/>
                        <a:gd name="connsiteX19" fmla="*/ 24685 w 1918790"/>
                        <a:gd name="connsiteY19" fmla="*/ 2653340 h 2672760"/>
                        <a:gd name="connsiteX20" fmla="*/ 277779 w 1918790"/>
                        <a:gd name="connsiteY20" fmla="*/ 2665014 h 2672760"/>
                        <a:gd name="connsiteX21" fmla="*/ 622861 w 1918790"/>
                        <a:gd name="connsiteY21" fmla="*/ 2634720 h 2672760"/>
                        <a:gd name="connsiteX22" fmla="*/ 879157 w 1918790"/>
                        <a:gd name="connsiteY22" fmla="*/ 2591077 h 2672760"/>
                        <a:gd name="connsiteX23" fmla="*/ 1334419 w 1918790"/>
                        <a:gd name="connsiteY23" fmla="*/ 2254562 h 2672760"/>
                        <a:gd name="connsiteX24" fmla="*/ 1415699 w 1918790"/>
                        <a:gd name="connsiteY24" fmla="*/ 1959922 h 2672760"/>
                        <a:gd name="connsiteX25" fmla="*/ 1425859 w 1918790"/>
                        <a:gd name="connsiteY25" fmla="*/ 1573842 h 2672760"/>
                        <a:gd name="connsiteX26" fmla="*/ 1407092 w 1918790"/>
                        <a:gd name="connsiteY26" fmla="*/ 1238562 h 2672760"/>
                        <a:gd name="connsiteX27" fmla="*/ 1415699 w 1918790"/>
                        <a:gd name="connsiteY27" fmla="*/ 1086162 h 2672760"/>
                        <a:gd name="connsiteX28" fmla="*/ 1679859 w 1918790"/>
                        <a:gd name="connsiteY28" fmla="*/ 1025202 h 2672760"/>
                        <a:gd name="connsiteX29" fmla="*/ 1700179 w 1918790"/>
                        <a:gd name="connsiteY29" fmla="*/ 913442 h 2672760"/>
                        <a:gd name="connsiteX30" fmla="*/ 1527459 w 1918790"/>
                        <a:gd name="connsiteY30" fmla="*/ 923602 h 2672760"/>
                        <a:gd name="connsiteX31" fmla="*/ 1415699 w 1918790"/>
                        <a:gd name="connsiteY31" fmla="*/ 954082 h 2672760"/>
                        <a:gd name="connsiteX32" fmla="*/ 1415699 w 1918790"/>
                        <a:gd name="connsiteY32" fmla="*/ 893122 h 2672760"/>
                        <a:gd name="connsiteX33" fmla="*/ 1415699 w 1918790"/>
                        <a:gd name="connsiteY33" fmla="*/ 913442 h 2672760"/>
                        <a:gd name="connsiteX34" fmla="*/ 1537619 w 1918790"/>
                        <a:gd name="connsiteY34" fmla="*/ 882962 h 2672760"/>
                        <a:gd name="connsiteX35" fmla="*/ 1629059 w 1918790"/>
                        <a:gd name="connsiteY35" fmla="*/ 842322 h 2672760"/>
                        <a:gd name="connsiteX36" fmla="*/ 1730659 w 1918790"/>
                        <a:gd name="connsiteY36" fmla="*/ 740722 h 2672760"/>
                        <a:gd name="connsiteX37" fmla="*/ 1883059 w 1918790"/>
                        <a:gd name="connsiteY37" fmla="*/ 496882 h 2672760"/>
                        <a:gd name="connsiteX38" fmla="*/ 1913539 w 1918790"/>
                        <a:gd name="connsiteY38" fmla="*/ 425762 h 2672760"/>
                        <a:gd name="connsiteX39" fmla="*/ 1801779 w 1918790"/>
                        <a:gd name="connsiteY39" fmla="*/ 385122 h 2672760"/>
                        <a:gd name="connsiteX40" fmla="*/ 1679859 w 1918790"/>
                        <a:gd name="connsiteY40" fmla="*/ 608642 h 2672760"/>
                        <a:gd name="connsiteX41" fmla="*/ 1592173 w 1918790"/>
                        <a:gd name="connsiteY41" fmla="*/ 724634 h 2672760"/>
                        <a:gd name="connsiteX42" fmla="*/ 1415699 w 1918790"/>
                        <a:gd name="connsiteY42" fmla="*/ 750882 h 2672760"/>
                        <a:gd name="connsiteX0" fmla="*/ 1415699 w 1918790"/>
                        <a:gd name="connsiteY0" fmla="*/ 750882 h 2672760"/>
                        <a:gd name="connsiteX1" fmla="*/ 1273459 w 1918790"/>
                        <a:gd name="connsiteY1" fmla="*/ 192082 h 2672760"/>
                        <a:gd name="connsiteX2" fmla="*/ 907699 w 1918790"/>
                        <a:gd name="connsiteY2" fmla="*/ 9202 h 2672760"/>
                        <a:gd name="connsiteX3" fmla="*/ 562259 w 1918790"/>
                        <a:gd name="connsiteY3" fmla="*/ 435922 h 2672760"/>
                        <a:gd name="connsiteX4" fmla="*/ 379379 w 1918790"/>
                        <a:gd name="connsiteY4" fmla="*/ 954082 h 2672760"/>
                        <a:gd name="connsiteX5" fmla="*/ 298099 w 1918790"/>
                        <a:gd name="connsiteY5" fmla="*/ 1330002 h 2672760"/>
                        <a:gd name="connsiteX6" fmla="*/ 577725 w 1918790"/>
                        <a:gd name="connsiteY6" fmla="*/ 1308839 h 2672760"/>
                        <a:gd name="connsiteX7" fmla="*/ 785779 w 1918790"/>
                        <a:gd name="connsiteY7" fmla="*/ 1299522 h 2672760"/>
                        <a:gd name="connsiteX8" fmla="*/ 1039779 w 1918790"/>
                        <a:gd name="connsiteY8" fmla="*/ 1238562 h 2672760"/>
                        <a:gd name="connsiteX9" fmla="*/ 1192179 w 1918790"/>
                        <a:gd name="connsiteY9" fmla="*/ 1136962 h 2672760"/>
                        <a:gd name="connsiteX10" fmla="*/ 1283619 w 1918790"/>
                        <a:gd name="connsiteY10" fmla="*/ 1004882 h 2672760"/>
                        <a:gd name="connsiteX11" fmla="*/ 1344579 w 1918790"/>
                        <a:gd name="connsiteY11" fmla="*/ 913442 h 2672760"/>
                        <a:gd name="connsiteX12" fmla="*/ 1226412 w 1918790"/>
                        <a:gd name="connsiteY12" fmla="*/ 1123422 h 2672760"/>
                        <a:gd name="connsiteX13" fmla="*/ 1070259 w 1918790"/>
                        <a:gd name="connsiteY13" fmla="*/ 1250417 h 2672760"/>
                        <a:gd name="connsiteX14" fmla="*/ 810953 w 1918790"/>
                        <a:gd name="connsiteY14" fmla="*/ 1314767 h 2672760"/>
                        <a:gd name="connsiteX15" fmla="*/ 247299 w 1918790"/>
                        <a:gd name="connsiteY15" fmla="*/ 1401122 h 2672760"/>
                        <a:gd name="connsiteX16" fmla="*/ 84739 w 1918790"/>
                        <a:gd name="connsiteY16" fmla="*/ 1919282 h 2672760"/>
                        <a:gd name="connsiteX17" fmla="*/ 22679 w 1918790"/>
                        <a:gd name="connsiteY17" fmla="*/ 2323987 h 2672760"/>
                        <a:gd name="connsiteX18" fmla="*/ 9412 w 1918790"/>
                        <a:gd name="connsiteY18" fmla="*/ 2467922 h 2672760"/>
                        <a:gd name="connsiteX19" fmla="*/ 24685 w 1918790"/>
                        <a:gd name="connsiteY19" fmla="*/ 2653340 h 2672760"/>
                        <a:gd name="connsiteX20" fmla="*/ 277779 w 1918790"/>
                        <a:gd name="connsiteY20" fmla="*/ 2665014 h 2672760"/>
                        <a:gd name="connsiteX21" fmla="*/ 622861 w 1918790"/>
                        <a:gd name="connsiteY21" fmla="*/ 2634720 h 2672760"/>
                        <a:gd name="connsiteX22" fmla="*/ 885229 w 1918790"/>
                        <a:gd name="connsiteY22" fmla="*/ 2613018 h 2672760"/>
                        <a:gd name="connsiteX23" fmla="*/ 1334419 w 1918790"/>
                        <a:gd name="connsiteY23" fmla="*/ 2254562 h 2672760"/>
                        <a:gd name="connsiteX24" fmla="*/ 1415699 w 1918790"/>
                        <a:gd name="connsiteY24" fmla="*/ 1959922 h 2672760"/>
                        <a:gd name="connsiteX25" fmla="*/ 1425859 w 1918790"/>
                        <a:gd name="connsiteY25" fmla="*/ 1573842 h 2672760"/>
                        <a:gd name="connsiteX26" fmla="*/ 1407092 w 1918790"/>
                        <a:gd name="connsiteY26" fmla="*/ 1238562 h 2672760"/>
                        <a:gd name="connsiteX27" fmla="*/ 1415699 w 1918790"/>
                        <a:gd name="connsiteY27" fmla="*/ 1086162 h 2672760"/>
                        <a:gd name="connsiteX28" fmla="*/ 1679859 w 1918790"/>
                        <a:gd name="connsiteY28" fmla="*/ 1025202 h 2672760"/>
                        <a:gd name="connsiteX29" fmla="*/ 1700179 w 1918790"/>
                        <a:gd name="connsiteY29" fmla="*/ 913442 h 2672760"/>
                        <a:gd name="connsiteX30" fmla="*/ 1527459 w 1918790"/>
                        <a:gd name="connsiteY30" fmla="*/ 923602 h 2672760"/>
                        <a:gd name="connsiteX31" fmla="*/ 1415699 w 1918790"/>
                        <a:gd name="connsiteY31" fmla="*/ 954082 h 2672760"/>
                        <a:gd name="connsiteX32" fmla="*/ 1415699 w 1918790"/>
                        <a:gd name="connsiteY32" fmla="*/ 893122 h 2672760"/>
                        <a:gd name="connsiteX33" fmla="*/ 1415699 w 1918790"/>
                        <a:gd name="connsiteY33" fmla="*/ 913442 h 2672760"/>
                        <a:gd name="connsiteX34" fmla="*/ 1537619 w 1918790"/>
                        <a:gd name="connsiteY34" fmla="*/ 882962 h 2672760"/>
                        <a:gd name="connsiteX35" fmla="*/ 1629059 w 1918790"/>
                        <a:gd name="connsiteY35" fmla="*/ 842322 h 2672760"/>
                        <a:gd name="connsiteX36" fmla="*/ 1730659 w 1918790"/>
                        <a:gd name="connsiteY36" fmla="*/ 740722 h 2672760"/>
                        <a:gd name="connsiteX37" fmla="*/ 1883059 w 1918790"/>
                        <a:gd name="connsiteY37" fmla="*/ 496882 h 2672760"/>
                        <a:gd name="connsiteX38" fmla="*/ 1913539 w 1918790"/>
                        <a:gd name="connsiteY38" fmla="*/ 425762 h 2672760"/>
                        <a:gd name="connsiteX39" fmla="*/ 1801779 w 1918790"/>
                        <a:gd name="connsiteY39" fmla="*/ 385122 h 2672760"/>
                        <a:gd name="connsiteX40" fmla="*/ 1679859 w 1918790"/>
                        <a:gd name="connsiteY40" fmla="*/ 608642 h 2672760"/>
                        <a:gd name="connsiteX41" fmla="*/ 1592173 w 1918790"/>
                        <a:gd name="connsiteY41" fmla="*/ 724634 h 2672760"/>
                        <a:gd name="connsiteX42" fmla="*/ 1415699 w 1918790"/>
                        <a:gd name="connsiteY42" fmla="*/ 750882 h 2672760"/>
                        <a:gd name="connsiteX0" fmla="*/ 1415699 w 1918790"/>
                        <a:gd name="connsiteY0" fmla="*/ 750882 h 2672760"/>
                        <a:gd name="connsiteX1" fmla="*/ 1273459 w 1918790"/>
                        <a:gd name="connsiteY1" fmla="*/ 192082 h 2672760"/>
                        <a:gd name="connsiteX2" fmla="*/ 907699 w 1918790"/>
                        <a:gd name="connsiteY2" fmla="*/ 9202 h 2672760"/>
                        <a:gd name="connsiteX3" fmla="*/ 562259 w 1918790"/>
                        <a:gd name="connsiteY3" fmla="*/ 435922 h 2672760"/>
                        <a:gd name="connsiteX4" fmla="*/ 379379 w 1918790"/>
                        <a:gd name="connsiteY4" fmla="*/ 954082 h 2672760"/>
                        <a:gd name="connsiteX5" fmla="*/ 298099 w 1918790"/>
                        <a:gd name="connsiteY5" fmla="*/ 1330002 h 2672760"/>
                        <a:gd name="connsiteX6" fmla="*/ 577725 w 1918790"/>
                        <a:gd name="connsiteY6" fmla="*/ 1308839 h 2672760"/>
                        <a:gd name="connsiteX7" fmla="*/ 785779 w 1918790"/>
                        <a:gd name="connsiteY7" fmla="*/ 1299522 h 2672760"/>
                        <a:gd name="connsiteX8" fmla="*/ 1039779 w 1918790"/>
                        <a:gd name="connsiteY8" fmla="*/ 1238562 h 2672760"/>
                        <a:gd name="connsiteX9" fmla="*/ 1192179 w 1918790"/>
                        <a:gd name="connsiteY9" fmla="*/ 1136962 h 2672760"/>
                        <a:gd name="connsiteX10" fmla="*/ 1283619 w 1918790"/>
                        <a:gd name="connsiteY10" fmla="*/ 1004882 h 2672760"/>
                        <a:gd name="connsiteX11" fmla="*/ 1344579 w 1918790"/>
                        <a:gd name="connsiteY11" fmla="*/ 913442 h 2672760"/>
                        <a:gd name="connsiteX12" fmla="*/ 1226412 w 1918790"/>
                        <a:gd name="connsiteY12" fmla="*/ 1123422 h 2672760"/>
                        <a:gd name="connsiteX13" fmla="*/ 1070259 w 1918790"/>
                        <a:gd name="connsiteY13" fmla="*/ 1250417 h 2672760"/>
                        <a:gd name="connsiteX14" fmla="*/ 810953 w 1918790"/>
                        <a:gd name="connsiteY14" fmla="*/ 1314767 h 2672760"/>
                        <a:gd name="connsiteX15" fmla="*/ 247299 w 1918790"/>
                        <a:gd name="connsiteY15" fmla="*/ 1401122 h 2672760"/>
                        <a:gd name="connsiteX16" fmla="*/ 84739 w 1918790"/>
                        <a:gd name="connsiteY16" fmla="*/ 1919282 h 2672760"/>
                        <a:gd name="connsiteX17" fmla="*/ 22679 w 1918790"/>
                        <a:gd name="connsiteY17" fmla="*/ 2323987 h 2672760"/>
                        <a:gd name="connsiteX18" fmla="*/ 9412 w 1918790"/>
                        <a:gd name="connsiteY18" fmla="*/ 2467922 h 2672760"/>
                        <a:gd name="connsiteX19" fmla="*/ 24685 w 1918790"/>
                        <a:gd name="connsiteY19" fmla="*/ 2653340 h 2672760"/>
                        <a:gd name="connsiteX20" fmla="*/ 277779 w 1918790"/>
                        <a:gd name="connsiteY20" fmla="*/ 2665014 h 2672760"/>
                        <a:gd name="connsiteX21" fmla="*/ 622861 w 1918790"/>
                        <a:gd name="connsiteY21" fmla="*/ 2634720 h 2672760"/>
                        <a:gd name="connsiteX22" fmla="*/ 885229 w 1918790"/>
                        <a:gd name="connsiteY22" fmla="*/ 2613018 h 2672760"/>
                        <a:gd name="connsiteX23" fmla="*/ 1184064 w 1918790"/>
                        <a:gd name="connsiteY23" fmla="*/ 2484750 h 2672760"/>
                        <a:gd name="connsiteX24" fmla="*/ 1334419 w 1918790"/>
                        <a:gd name="connsiteY24" fmla="*/ 2254562 h 2672760"/>
                        <a:gd name="connsiteX25" fmla="*/ 1415699 w 1918790"/>
                        <a:gd name="connsiteY25" fmla="*/ 1959922 h 2672760"/>
                        <a:gd name="connsiteX26" fmla="*/ 1425859 w 1918790"/>
                        <a:gd name="connsiteY26" fmla="*/ 1573842 h 2672760"/>
                        <a:gd name="connsiteX27" fmla="*/ 1407092 w 1918790"/>
                        <a:gd name="connsiteY27" fmla="*/ 1238562 h 2672760"/>
                        <a:gd name="connsiteX28" fmla="*/ 1415699 w 1918790"/>
                        <a:gd name="connsiteY28" fmla="*/ 1086162 h 2672760"/>
                        <a:gd name="connsiteX29" fmla="*/ 1679859 w 1918790"/>
                        <a:gd name="connsiteY29" fmla="*/ 1025202 h 2672760"/>
                        <a:gd name="connsiteX30" fmla="*/ 1700179 w 1918790"/>
                        <a:gd name="connsiteY30" fmla="*/ 913442 h 2672760"/>
                        <a:gd name="connsiteX31" fmla="*/ 1527459 w 1918790"/>
                        <a:gd name="connsiteY31" fmla="*/ 923602 h 2672760"/>
                        <a:gd name="connsiteX32" fmla="*/ 1415699 w 1918790"/>
                        <a:gd name="connsiteY32" fmla="*/ 954082 h 2672760"/>
                        <a:gd name="connsiteX33" fmla="*/ 1415699 w 1918790"/>
                        <a:gd name="connsiteY33" fmla="*/ 893122 h 2672760"/>
                        <a:gd name="connsiteX34" fmla="*/ 1415699 w 1918790"/>
                        <a:gd name="connsiteY34" fmla="*/ 913442 h 2672760"/>
                        <a:gd name="connsiteX35" fmla="*/ 1537619 w 1918790"/>
                        <a:gd name="connsiteY35" fmla="*/ 882962 h 2672760"/>
                        <a:gd name="connsiteX36" fmla="*/ 1629059 w 1918790"/>
                        <a:gd name="connsiteY36" fmla="*/ 842322 h 2672760"/>
                        <a:gd name="connsiteX37" fmla="*/ 1730659 w 1918790"/>
                        <a:gd name="connsiteY37" fmla="*/ 740722 h 2672760"/>
                        <a:gd name="connsiteX38" fmla="*/ 1883059 w 1918790"/>
                        <a:gd name="connsiteY38" fmla="*/ 496882 h 2672760"/>
                        <a:gd name="connsiteX39" fmla="*/ 1913539 w 1918790"/>
                        <a:gd name="connsiteY39" fmla="*/ 425762 h 2672760"/>
                        <a:gd name="connsiteX40" fmla="*/ 1801779 w 1918790"/>
                        <a:gd name="connsiteY40" fmla="*/ 385122 h 2672760"/>
                        <a:gd name="connsiteX41" fmla="*/ 1679859 w 1918790"/>
                        <a:gd name="connsiteY41" fmla="*/ 608642 h 2672760"/>
                        <a:gd name="connsiteX42" fmla="*/ 1592173 w 1918790"/>
                        <a:gd name="connsiteY42" fmla="*/ 724634 h 2672760"/>
                        <a:gd name="connsiteX43" fmla="*/ 1415699 w 1918790"/>
                        <a:gd name="connsiteY43" fmla="*/ 750882 h 2672760"/>
                        <a:gd name="connsiteX0" fmla="*/ 1415699 w 1918790"/>
                        <a:gd name="connsiteY0" fmla="*/ 750882 h 2671846"/>
                        <a:gd name="connsiteX1" fmla="*/ 1273459 w 1918790"/>
                        <a:gd name="connsiteY1" fmla="*/ 192082 h 2671846"/>
                        <a:gd name="connsiteX2" fmla="*/ 907699 w 1918790"/>
                        <a:gd name="connsiteY2" fmla="*/ 9202 h 2671846"/>
                        <a:gd name="connsiteX3" fmla="*/ 562259 w 1918790"/>
                        <a:gd name="connsiteY3" fmla="*/ 435922 h 2671846"/>
                        <a:gd name="connsiteX4" fmla="*/ 379379 w 1918790"/>
                        <a:gd name="connsiteY4" fmla="*/ 954082 h 2671846"/>
                        <a:gd name="connsiteX5" fmla="*/ 298099 w 1918790"/>
                        <a:gd name="connsiteY5" fmla="*/ 1330002 h 2671846"/>
                        <a:gd name="connsiteX6" fmla="*/ 577725 w 1918790"/>
                        <a:gd name="connsiteY6" fmla="*/ 1308839 h 2671846"/>
                        <a:gd name="connsiteX7" fmla="*/ 785779 w 1918790"/>
                        <a:gd name="connsiteY7" fmla="*/ 1299522 h 2671846"/>
                        <a:gd name="connsiteX8" fmla="*/ 1039779 w 1918790"/>
                        <a:gd name="connsiteY8" fmla="*/ 1238562 h 2671846"/>
                        <a:gd name="connsiteX9" fmla="*/ 1192179 w 1918790"/>
                        <a:gd name="connsiteY9" fmla="*/ 1136962 h 2671846"/>
                        <a:gd name="connsiteX10" fmla="*/ 1283619 w 1918790"/>
                        <a:gd name="connsiteY10" fmla="*/ 1004882 h 2671846"/>
                        <a:gd name="connsiteX11" fmla="*/ 1344579 w 1918790"/>
                        <a:gd name="connsiteY11" fmla="*/ 913442 h 2671846"/>
                        <a:gd name="connsiteX12" fmla="*/ 1226412 w 1918790"/>
                        <a:gd name="connsiteY12" fmla="*/ 1123422 h 2671846"/>
                        <a:gd name="connsiteX13" fmla="*/ 1070259 w 1918790"/>
                        <a:gd name="connsiteY13" fmla="*/ 1250417 h 2671846"/>
                        <a:gd name="connsiteX14" fmla="*/ 810953 w 1918790"/>
                        <a:gd name="connsiteY14" fmla="*/ 1314767 h 2671846"/>
                        <a:gd name="connsiteX15" fmla="*/ 247299 w 1918790"/>
                        <a:gd name="connsiteY15" fmla="*/ 1401122 h 2671846"/>
                        <a:gd name="connsiteX16" fmla="*/ 84739 w 1918790"/>
                        <a:gd name="connsiteY16" fmla="*/ 1919282 h 2671846"/>
                        <a:gd name="connsiteX17" fmla="*/ 22679 w 1918790"/>
                        <a:gd name="connsiteY17" fmla="*/ 2323987 h 2671846"/>
                        <a:gd name="connsiteX18" fmla="*/ 9412 w 1918790"/>
                        <a:gd name="connsiteY18" fmla="*/ 2467922 h 2671846"/>
                        <a:gd name="connsiteX19" fmla="*/ 24685 w 1918790"/>
                        <a:gd name="connsiteY19" fmla="*/ 2653340 h 2671846"/>
                        <a:gd name="connsiteX20" fmla="*/ 277779 w 1918790"/>
                        <a:gd name="connsiteY20" fmla="*/ 2665014 h 2671846"/>
                        <a:gd name="connsiteX21" fmla="*/ 622861 w 1918790"/>
                        <a:gd name="connsiteY21" fmla="*/ 2651175 h 2671846"/>
                        <a:gd name="connsiteX22" fmla="*/ 885229 w 1918790"/>
                        <a:gd name="connsiteY22" fmla="*/ 2613018 h 2671846"/>
                        <a:gd name="connsiteX23" fmla="*/ 1184064 w 1918790"/>
                        <a:gd name="connsiteY23" fmla="*/ 2484750 h 2671846"/>
                        <a:gd name="connsiteX24" fmla="*/ 1334419 w 1918790"/>
                        <a:gd name="connsiteY24" fmla="*/ 2254562 h 2671846"/>
                        <a:gd name="connsiteX25" fmla="*/ 1415699 w 1918790"/>
                        <a:gd name="connsiteY25" fmla="*/ 1959922 h 2671846"/>
                        <a:gd name="connsiteX26" fmla="*/ 1425859 w 1918790"/>
                        <a:gd name="connsiteY26" fmla="*/ 1573842 h 2671846"/>
                        <a:gd name="connsiteX27" fmla="*/ 1407092 w 1918790"/>
                        <a:gd name="connsiteY27" fmla="*/ 1238562 h 2671846"/>
                        <a:gd name="connsiteX28" fmla="*/ 1415699 w 1918790"/>
                        <a:gd name="connsiteY28" fmla="*/ 1086162 h 2671846"/>
                        <a:gd name="connsiteX29" fmla="*/ 1679859 w 1918790"/>
                        <a:gd name="connsiteY29" fmla="*/ 1025202 h 2671846"/>
                        <a:gd name="connsiteX30" fmla="*/ 1700179 w 1918790"/>
                        <a:gd name="connsiteY30" fmla="*/ 913442 h 2671846"/>
                        <a:gd name="connsiteX31" fmla="*/ 1527459 w 1918790"/>
                        <a:gd name="connsiteY31" fmla="*/ 923602 h 2671846"/>
                        <a:gd name="connsiteX32" fmla="*/ 1415699 w 1918790"/>
                        <a:gd name="connsiteY32" fmla="*/ 954082 h 2671846"/>
                        <a:gd name="connsiteX33" fmla="*/ 1415699 w 1918790"/>
                        <a:gd name="connsiteY33" fmla="*/ 893122 h 2671846"/>
                        <a:gd name="connsiteX34" fmla="*/ 1415699 w 1918790"/>
                        <a:gd name="connsiteY34" fmla="*/ 913442 h 2671846"/>
                        <a:gd name="connsiteX35" fmla="*/ 1537619 w 1918790"/>
                        <a:gd name="connsiteY35" fmla="*/ 882962 h 2671846"/>
                        <a:gd name="connsiteX36" fmla="*/ 1629059 w 1918790"/>
                        <a:gd name="connsiteY36" fmla="*/ 842322 h 2671846"/>
                        <a:gd name="connsiteX37" fmla="*/ 1730659 w 1918790"/>
                        <a:gd name="connsiteY37" fmla="*/ 740722 h 2671846"/>
                        <a:gd name="connsiteX38" fmla="*/ 1883059 w 1918790"/>
                        <a:gd name="connsiteY38" fmla="*/ 496882 h 2671846"/>
                        <a:gd name="connsiteX39" fmla="*/ 1913539 w 1918790"/>
                        <a:gd name="connsiteY39" fmla="*/ 425762 h 2671846"/>
                        <a:gd name="connsiteX40" fmla="*/ 1801779 w 1918790"/>
                        <a:gd name="connsiteY40" fmla="*/ 385122 h 2671846"/>
                        <a:gd name="connsiteX41" fmla="*/ 1679859 w 1918790"/>
                        <a:gd name="connsiteY41" fmla="*/ 608642 h 2671846"/>
                        <a:gd name="connsiteX42" fmla="*/ 1592173 w 1918790"/>
                        <a:gd name="connsiteY42" fmla="*/ 724634 h 2671846"/>
                        <a:gd name="connsiteX43" fmla="*/ 1415699 w 1918790"/>
                        <a:gd name="connsiteY43" fmla="*/ 750882 h 2671846"/>
                        <a:gd name="connsiteX0" fmla="*/ 1415699 w 1925394"/>
                        <a:gd name="connsiteY0" fmla="*/ 750882 h 2671846"/>
                        <a:gd name="connsiteX1" fmla="*/ 1273459 w 1925394"/>
                        <a:gd name="connsiteY1" fmla="*/ 192082 h 2671846"/>
                        <a:gd name="connsiteX2" fmla="*/ 907699 w 1925394"/>
                        <a:gd name="connsiteY2" fmla="*/ 9202 h 2671846"/>
                        <a:gd name="connsiteX3" fmla="*/ 562259 w 1925394"/>
                        <a:gd name="connsiteY3" fmla="*/ 435922 h 2671846"/>
                        <a:gd name="connsiteX4" fmla="*/ 379379 w 1925394"/>
                        <a:gd name="connsiteY4" fmla="*/ 954082 h 2671846"/>
                        <a:gd name="connsiteX5" fmla="*/ 298099 w 1925394"/>
                        <a:gd name="connsiteY5" fmla="*/ 1330002 h 2671846"/>
                        <a:gd name="connsiteX6" fmla="*/ 577725 w 1925394"/>
                        <a:gd name="connsiteY6" fmla="*/ 1308839 h 2671846"/>
                        <a:gd name="connsiteX7" fmla="*/ 785779 w 1925394"/>
                        <a:gd name="connsiteY7" fmla="*/ 1299522 h 2671846"/>
                        <a:gd name="connsiteX8" fmla="*/ 1039779 w 1925394"/>
                        <a:gd name="connsiteY8" fmla="*/ 1238562 h 2671846"/>
                        <a:gd name="connsiteX9" fmla="*/ 1192179 w 1925394"/>
                        <a:gd name="connsiteY9" fmla="*/ 1136962 h 2671846"/>
                        <a:gd name="connsiteX10" fmla="*/ 1283619 w 1925394"/>
                        <a:gd name="connsiteY10" fmla="*/ 1004882 h 2671846"/>
                        <a:gd name="connsiteX11" fmla="*/ 1344579 w 1925394"/>
                        <a:gd name="connsiteY11" fmla="*/ 913442 h 2671846"/>
                        <a:gd name="connsiteX12" fmla="*/ 1226412 w 1925394"/>
                        <a:gd name="connsiteY12" fmla="*/ 1123422 h 2671846"/>
                        <a:gd name="connsiteX13" fmla="*/ 1070259 w 1925394"/>
                        <a:gd name="connsiteY13" fmla="*/ 1250417 h 2671846"/>
                        <a:gd name="connsiteX14" fmla="*/ 810953 w 1925394"/>
                        <a:gd name="connsiteY14" fmla="*/ 1314767 h 2671846"/>
                        <a:gd name="connsiteX15" fmla="*/ 247299 w 1925394"/>
                        <a:gd name="connsiteY15" fmla="*/ 1401122 h 2671846"/>
                        <a:gd name="connsiteX16" fmla="*/ 84739 w 1925394"/>
                        <a:gd name="connsiteY16" fmla="*/ 1919282 h 2671846"/>
                        <a:gd name="connsiteX17" fmla="*/ 22679 w 1925394"/>
                        <a:gd name="connsiteY17" fmla="*/ 2323987 h 2671846"/>
                        <a:gd name="connsiteX18" fmla="*/ 9412 w 1925394"/>
                        <a:gd name="connsiteY18" fmla="*/ 2467922 h 2671846"/>
                        <a:gd name="connsiteX19" fmla="*/ 24685 w 1925394"/>
                        <a:gd name="connsiteY19" fmla="*/ 2653340 h 2671846"/>
                        <a:gd name="connsiteX20" fmla="*/ 277779 w 1925394"/>
                        <a:gd name="connsiteY20" fmla="*/ 2665014 h 2671846"/>
                        <a:gd name="connsiteX21" fmla="*/ 622861 w 1925394"/>
                        <a:gd name="connsiteY21" fmla="*/ 2651175 h 2671846"/>
                        <a:gd name="connsiteX22" fmla="*/ 885229 w 1925394"/>
                        <a:gd name="connsiteY22" fmla="*/ 2613018 h 2671846"/>
                        <a:gd name="connsiteX23" fmla="*/ 1184064 w 1925394"/>
                        <a:gd name="connsiteY23" fmla="*/ 2484750 h 2671846"/>
                        <a:gd name="connsiteX24" fmla="*/ 1334419 w 1925394"/>
                        <a:gd name="connsiteY24" fmla="*/ 2254562 h 2671846"/>
                        <a:gd name="connsiteX25" fmla="*/ 1415699 w 1925394"/>
                        <a:gd name="connsiteY25" fmla="*/ 1959922 h 2671846"/>
                        <a:gd name="connsiteX26" fmla="*/ 1425859 w 1925394"/>
                        <a:gd name="connsiteY26" fmla="*/ 1573842 h 2671846"/>
                        <a:gd name="connsiteX27" fmla="*/ 1407092 w 1925394"/>
                        <a:gd name="connsiteY27" fmla="*/ 1238562 h 2671846"/>
                        <a:gd name="connsiteX28" fmla="*/ 1415699 w 1925394"/>
                        <a:gd name="connsiteY28" fmla="*/ 1086162 h 2671846"/>
                        <a:gd name="connsiteX29" fmla="*/ 1679859 w 1925394"/>
                        <a:gd name="connsiteY29" fmla="*/ 1025202 h 2671846"/>
                        <a:gd name="connsiteX30" fmla="*/ 1700179 w 1925394"/>
                        <a:gd name="connsiteY30" fmla="*/ 913442 h 2671846"/>
                        <a:gd name="connsiteX31" fmla="*/ 1527459 w 1925394"/>
                        <a:gd name="connsiteY31" fmla="*/ 923602 h 2671846"/>
                        <a:gd name="connsiteX32" fmla="*/ 1415699 w 1925394"/>
                        <a:gd name="connsiteY32" fmla="*/ 954082 h 2671846"/>
                        <a:gd name="connsiteX33" fmla="*/ 1415699 w 1925394"/>
                        <a:gd name="connsiteY33" fmla="*/ 893122 h 2671846"/>
                        <a:gd name="connsiteX34" fmla="*/ 1415699 w 1925394"/>
                        <a:gd name="connsiteY34" fmla="*/ 913442 h 2671846"/>
                        <a:gd name="connsiteX35" fmla="*/ 1537619 w 1925394"/>
                        <a:gd name="connsiteY35" fmla="*/ 882962 h 2671846"/>
                        <a:gd name="connsiteX36" fmla="*/ 1629059 w 1925394"/>
                        <a:gd name="connsiteY36" fmla="*/ 842322 h 2671846"/>
                        <a:gd name="connsiteX37" fmla="*/ 1730659 w 1925394"/>
                        <a:gd name="connsiteY37" fmla="*/ 740722 h 2671846"/>
                        <a:gd name="connsiteX38" fmla="*/ 1883059 w 1925394"/>
                        <a:gd name="connsiteY38" fmla="*/ 496882 h 2671846"/>
                        <a:gd name="connsiteX39" fmla="*/ 1913539 w 1925394"/>
                        <a:gd name="connsiteY39" fmla="*/ 425762 h 2671846"/>
                        <a:gd name="connsiteX40" fmla="*/ 1710697 w 1925394"/>
                        <a:gd name="connsiteY40" fmla="*/ 357696 h 2671846"/>
                        <a:gd name="connsiteX41" fmla="*/ 1679859 w 1925394"/>
                        <a:gd name="connsiteY41" fmla="*/ 608642 h 2671846"/>
                        <a:gd name="connsiteX42" fmla="*/ 1592173 w 1925394"/>
                        <a:gd name="connsiteY42" fmla="*/ 724634 h 2671846"/>
                        <a:gd name="connsiteX43" fmla="*/ 1415699 w 1925394"/>
                        <a:gd name="connsiteY43" fmla="*/ 750882 h 2671846"/>
                        <a:gd name="connsiteX0" fmla="*/ 1415699 w 1925394"/>
                        <a:gd name="connsiteY0" fmla="*/ 750882 h 2671846"/>
                        <a:gd name="connsiteX1" fmla="*/ 1273459 w 1925394"/>
                        <a:gd name="connsiteY1" fmla="*/ 192082 h 2671846"/>
                        <a:gd name="connsiteX2" fmla="*/ 907699 w 1925394"/>
                        <a:gd name="connsiteY2" fmla="*/ 9202 h 2671846"/>
                        <a:gd name="connsiteX3" fmla="*/ 562259 w 1925394"/>
                        <a:gd name="connsiteY3" fmla="*/ 435922 h 2671846"/>
                        <a:gd name="connsiteX4" fmla="*/ 379379 w 1925394"/>
                        <a:gd name="connsiteY4" fmla="*/ 954082 h 2671846"/>
                        <a:gd name="connsiteX5" fmla="*/ 298099 w 1925394"/>
                        <a:gd name="connsiteY5" fmla="*/ 1330002 h 2671846"/>
                        <a:gd name="connsiteX6" fmla="*/ 577725 w 1925394"/>
                        <a:gd name="connsiteY6" fmla="*/ 1308839 h 2671846"/>
                        <a:gd name="connsiteX7" fmla="*/ 785779 w 1925394"/>
                        <a:gd name="connsiteY7" fmla="*/ 1299522 h 2671846"/>
                        <a:gd name="connsiteX8" fmla="*/ 1039779 w 1925394"/>
                        <a:gd name="connsiteY8" fmla="*/ 1238562 h 2671846"/>
                        <a:gd name="connsiteX9" fmla="*/ 1192179 w 1925394"/>
                        <a:gd name="connsiteY9" fmla="*/ 1136962 h 2671846"/>
                        <a:gd name="connsiteX10" fmla="*/ 1283619 w 1925394"/>
                        <a:gd name="connsiteY10" fmla="*/ 1004882 h 2671846"/>
                        <a:gd name="connsiteX11" fmla="*/ 1344579 w 1925394"/>
                        <a:gd name="connsiteY11" fmla="*/ 913442 h 2671846"/>
                        <a:gd name="connsiteX12" fmla="*/ 1226412 w 1925394"/>
                        <a:gd name="connsiteY12" fmla="*/ 1123422 h 2671846"/>
                        <a:gd name="connsiteX13" fmla="*/ 1070259 w 1925394"/>
                        <a:gd name="connsiteY13" fmla="*/ 1250417 h 2671846"/>
                        <a:gd name="connsiteX14" fmla="*/ 810953 w 1925394"/>
                        <a:gd name="connsiteY14" fmla="*/ 1314767 h 2671846"/>
                        <a:gd name="connsiteX15" fmla="*/ 247299 w 1925394"/>
                        <a:gd name="connsiteY15" fmla="*/ 1401122 h 2671846"/>
                        <a:gd name="connsiteX16" fmla="*/ 84739 w 1925394"/>
                        <a:gd name="connsiteY16" fmla="*/ 1919282 h 2671846"/>
                        <a:gd name="connsiteX17" fmla="*/ 22679 w 1925394"/>
                        <a:gd name="connsiteY17" fmla="*/ 2323987 h 2671846"/>
                        <a:gd name="connsiteX18" fmla="*/ 9412 w 1925394"/>
                        <a:gd name="connsiteY18" fmla="*/ 2467922 h 2671846"/>
                        <a:gd name="connsiteX19" fmla="*/ 24685 w 1925394"/>
                        <a:gd name="connsiteY19" fmla="*/ 2653340 h 2671846"/>
                        <a:gd name="connsiteX20" fmla="*/ 277779 w 1925394"/>
                        <a:gd name="connsiteY20" fmla="*/ 2665014 h 2671846"/>
                        <a:gd name="connsiteX21" fmla="*/ 622861 w 1925394"/>
                        <a:gd name="connsiteY21" fmla="*/ 2651175 h 2671846"/>
                        <a:gd name="connsiteX22" fmla="*/ 885229 w 1925394"/>
                        <a:gd name="connsiteY22" fmla="*/ 2613018 h 2671846"/>
                        <a:gd name="connsiteX23" fmla="*/ 1184064 w 1925394"/>
                        <a:gd name="connsiteY23" fmla="*/ 2484750 h 2671846"/>
                        <a:gd name="connsiteX24" fmla="*/ 1334419 w 1925394"/>
                        <a:gd name="connsiteY24" fmla="*/ 2254562 h 2671846"/>
                        <a:gd name="connsiteX25" fmla="*/ 1415699 w 1925394"/>
                        <a:gd name="connsiteY25" fmla="*/ 1959922 h 2671846"/>
                        <a:gd name="connsiteX26" fmla="*/ 1425859 w 1925394"/>
                        <a:gd name="connsiteY26" fmla="*/ 1573842 h 2671846"/>
                        <a:gd name="connsiteX27" fmla="*/ 1407092 w 1925394"/>
                        <a:gd name="connsiteY27" fmla="*/ 1238562 h 2671846"/>
                        <a:gd name="connsiteX28" fmla="*/ 1415699 w 1925394"/>
                        <a:gd name="connsiteY28" fmla="*/ 1086162 h 2671846"/>
                        <a:gd name="connsiteX29" fmla="*/ 1679859 w 1925394"/>
                        <a:gd name="connsiteY29" fmla="*/ 1025202 h 2671846"/>
                        <a:gd name="connsiteX30" fmla="*/ 1700179 w 1925394"/>
                        <a:gd name="connsiteY30" fmla="*/ 913442 h 2671846"/>
                        <a:gd name="connsiteX31" fmla="*/ 1527459 w 1925394"/>
                        <a:gd name="connsiteY31" fmla="*/ 923602 h 2671846"/>
                        <a:gd name="connsiteX32" fmla="*/ 1415699 w 1925394"/>
                        <a:gd name="connsiteY32" fmla="*/ 954082 h 2671846"/>
                        <a:gd name="connsiteX33" fmla="*/ 1415699 w 1925394"/>
                        <a:gd name="connsiteY33" fmla="*/ 893122 h 2671846"/>
                        <a:gd name="connsiteX34" fmla="*/ 1415699 w 1925394"/>
                        <a:gd name="connsiteY34" fmla="*/ 913442 h 2671846"/>
                        <a:gd name="connsiteX35" fmla="*/ 1537619 w 1925394"/>
                        <a:gd name="connsiteY35" fmla="*/ 882962 h 2671846"/>
                        <a:gd name="connsiteX36" fmla="*/ 1629059 w 1925394"/>
                        <a:gd name="connsiteY36" fmla="*/ 842322 h 2671846"/>
                        <a:gd name="connsiteX37" fmla="*/ 1730659 w 1925394"/>
                        <a:gd name="connsiteY37" fmla="*/ 740722 h 2671846"/>
                        <a:gd name="connsiteX38" fmla="*/ 1883059 w 1925394"/>
                        <a:gd name="connsiteY38" fmla="*/ 496882 h 2671846"/>
                        <a:gd name="connsiteX39" fmla="*/ 1913539 w 1925394"/>
                        <a:gd name="connsiteY39" fmla="*/ 425762 h 2671846"/>
                        <a:gd name="connsiteX40" fmla="*/ 1710697 w 1925394"/>
                        <a:gd name="connsiteY40" fmla="*/ 357696 h 2671846"/>
                        <a:gd name="connsiteX41" fmla="*/ 1625210 w 1925394"/>
                        <a:gd name="connsiteY41" fmla="*/ 575731 h 2671846"/>
                        <a:gd name="connsiteX42" fmla="*/ 1592173 w 1925394"/>
                        <a:gd name="connsiteY42" fmla="*/ 724634 h 2671846"/>
                        <a:gd name="connsiteX43" fmla="*/ 1415699 w 1925394"/>
                        <a:gd name="connsiteY43" fmla="*/ 750882 h 2671846"/>
                        <a:gd name="connsiteX0" fmla="*/ 1415699 w 1925394"/>
                        <a:gd name="connsiteY0" fmla="*/ 750882 h 2671846"/>
                        <a:gd name="connsiteX1" fmla="*/ 1273459 w 1925394"/>
                        <a:gd name="connsiteY1" fmla="*/ 192082 h 2671846"/>
                        <a:gd name="connsiteX2" fmla="*/ 907699 w 1925394"/>
                        <a:gd name="connsiteY2" fmla="*/ 9202 h 2671846"/>
                        <a:gd name="connsiteX3" fmla="*/ 562259 w 1925394"/>
                        <a:gd name="connsiteY3" fmla="*/ 435922 h 2671846"/>
                        <a:gd name="connsiteX4" fmla="*/ 379379 w 1925394"/>
                        <a:gd name="connsiteY4" fmla="*/ 954082 h 2671846"/>
                        <a:gd name="connsiteX5" fmla="*/ 298099 w 1925394"/>
                        <a:gd name="connsiteY5" fmla="*/ 1330002 h 2671846"/>
                        <a:gd name="connsiteX6" fmla="*/ 577725 w 1925394"/>
                        <a:gd name="connsiteY6" fmla="*/ 1308839 h 2671846"/>
                        <a:gd name="connsiteX7" fmla="*/ 785779 w 1925394"/>
                        <a:gd name="connsiteY7" fmla="*/ 1299522 h 2671846"/>
                        <a:gd name="connsiteX8" fmla="*/ 1039779 w 1925394"/>
                        <a:gd name="connsiteY8" fmla="*/ 1238562 h 2671846"/>
                        <a:gd name="connsiteX9" fmla="*/ 1192179 w 1925394"/>
                        <a:gd name="connsiteY9" fmla="*/ 1136962 h 2671846"/>
                        <a:gd name="connsiteX10" fmla="*/ 1283619 w 1925394"/>
                        <a:gd name="connsiteY10" fmla="*/ 1004882 h 2671846"/>
                        <a:gd name="connsiteX11" fmla="*/ 1344579 w 1925394"/>
                        <a:gd name="connsiteY11" fmla="*/ 913442 h 2671846"/>
                        <a:gd name="connsiteX12" fmla="*/ 1226412 w 1925394"/>
                        <a:gd name="connsiteY12" fmla="*/ 1123422 h 2671846"/>
                        <a:gd name="connsiteX13" fmla="*/ 1070259 w 1925394"/>
                        <a:gd name="connsiteY13" fmla="*/ 1250417 h 2671846"/>
                        <a:gd name="connsiteX14" fmla="*/ 810953 w 1925394"/>
                        <a:gd name="connsiteY14" fmla="*/ 1314767 h 2671846"/>
                        <a:gd name="connsiteX15" fmla="*/ 247299 w 1925394"/>
                        <a:gd name="connsiteY15" fmla="*/ 1401122 h 2671846"/>
                        <a:gd name="connsiteX16" fmla="*/ 84739 w 1925394"/>
                        <a:gd name="connsiteY16" fmla="*/ 1919282 h 2671846"/>
                        <a:gd name="connsiteX17" fmla="*/ 22679 w 1925394"/>
                        <a:gd name="connsiteY17" fmla="*/ 2323987 h 2671846"/>
                        <a:gd name="connsiteX18" fmla="*/ 9412 w 1925394"/>
                        <a:gd name="connsiteY18" fmla="*/ 2467922 h 2671846"/>
                        <a:gd name="connsiteX19" fmla="*/ 24685 w 1925394"/>
                        <a:gd name="connsiteY19" fmla="*/ 2653340 h 2671846"/>
                        <a:gd name="connsiteX20" fmla="*/ 277779 w 1925394"/>
                        <a:gd name="connsiteY20" fmla="*/ 2665014 h 2671846"/>
                        <a:gd name="connsiteX21" fmla="*/ 622861 w 1925394"/>
                        <a:gd name="connsiteY21" fmla="*/ 2651175 h 2671846"/>
                        <a:gd name="connsiteX22" fmla="*/ 885229 w 1925394"/>
                        <a:gd name="connsiteY22" fmla="*/ 2613018 h 2671846"/>
                        <a:gd name="connsiteX23" fmla="*/ 1184064 w 1925394"/>
                        <a:gd name="connsiteY23" fmla="*/ 2484750 h 2671846"/>
                        <a:gd name="connsiteX24" fmla="*/ 1334419 w 1925394"/>
                        <a:gd name="connsiteY24" fmla="*/ 2254562 h 2671846"/>
                        <a:gd name="connsiteX25" fmla="*/ 1415699 w 1925394"/>
                        <a:gd name="connsiteY25" fmla="*/ 1959922 h 2671846"/>
                        <a:gd name="connsiteX26" fmla="*/ 1425859 w 1925394"/>
                        <a:gd name="connsiteY26" fmla="*/ 1573842 h 2671846"/>
                        <a:gd name="connsiteX27" fmla="*/ 1407092 w 1925394"/>
                        <a:gd name="connsiteY27" fmla="*/ 1238562 h 2671846"/>
                        <a:gd name="connsiteX28" fmla="*/ 1415699 w 1925394"/>
                        <a:gd name="connsiteY28" fmla="*/ 1086162 h 2671846"/>
                        <a:gd name="connsiteX29" fmla="*/ 1679859 w 1925394"/>
                        <a:gd name="connsiteY29" fmla="*/ 1025202 h 2671846"/>
                        <a:gd name="connsiteX30" fmla="*/ 1700179 w 1925394"/>
                        <a:gd name="connsiteY30" fmla="*/ 913442 h 2671846"/>
                        <a:gd name="connsiteX31" fmla="*/ 1527459 w 1925394"/>
                        <a:gd name="connsiteY31" fmla="*/ 923602 h 2671846"/>
                        <a:gd name="connsiteX32" fmla="*/ 1415699 w 1925394"/>
                        <a:gd name="connsiteY32" fmla="*/ 954082 h 2671846"/>
                        <a:gd name="connsiteX33" fmla="*/ 1415699 w 1925394"/>
                        <a:gd name="connsiteY33" fmla="*/ 893122 h 2671846"/>
                        <a:gd name="connsiteX34" fmla="*/ 1415699 w 1925394"/>
                        <a:gd name="connsiteY34" fmla="*/ 913442 h 2671846"/>
                        <a:gd name="connsiteX35" fmla="*/ 1537619 w 1925394"/>
                        <a:gd name="connsiteY35" fmla="*/ 882962 h 2671846"/>
                        <a:gd name="connsiteX36" fmla="*/ 1629059 w 1925394"/>
                        <a:gd name="connsiteY36" fmla="*/ 842322 h 2671846"/>
                        <a:gd name="connsiteX37" fmla="*/ 1730659 w 1925394"/>
                        <a:gd name="connsiteY37" fmla="*/ 740722 h 2671846"/>
                        <a:gd name="connsiteX38" fmla="*/ 1883059 w 1925394"/>
                        <a:gd name="connsiteY38" fmla="*/ 496882 h 2671846"/>
                        <a:gd name="connsiteX39" fmla="*/ 1913539 w 1925394"/>
                        <a:gd name="connsiteY39" fmla="*/ 425762 h 2671846"/>
                        <a:gd name="connsiteX40" fmla="*/ 1710697 w 1925394"/>
                        <a:gd name="connsiteY40" fmla="*/ 357696 h 2671846"/>
                        <a:gd name="connsiteX41" fmla="*/ 1625210 w 1925394"/>
                        <a:gd name="connsiteY41" fmla="*/ 575731 h 2671846"/>
                        <a:gd name="connsiteX42" fmla="*/ 1531452 w 1925394"/>
                        <a:gd name="connsiteY42" fmla="*/ 702693 h 2671846"/>
                        <a:gd name="connsiteX43" fmla="*/ 1415699 w 1925394"/>
                        <a:gd name="connsiteY43" fmla="*/ 750882 h 2671846"/>
                        <a:gd name="connsiteX0" fmla="*/ 1415699 w 1925394"/>
                        <a:gd name="connsiteY0" fmla="*/ 750882 h 2671846"/>
                        <a:gd name="connsiteX1" fmla="*/ 1273459 w 1925394"/>
                        <a:gd name="connsiteY1" fmla="*/ 192082 h 2671846"/>
                        <a:gd name="connsiteX2" fmla="*/ 907699 w 1925394"/>
                        <a:gd name="connsiteY2" fmla="*/ 9202 h 2671846"/>
                        <a:gd name="connsiteX3" fmla="*/ 562259 w 1925394"/>
                        <a:gd name="connsiteY3" fmla="*/ 435922 h 2671846"/>
                        <a:gd name="connsiteX4" fmla="*/ 379379 w 1925394"/>
                        <a:gd name="connsiteY4" fmla="*/ 954082 h 2671846"/>
                        <a:gd name="connsiteX5" fmla="*/ 298099 w 1925394"/>
                        <a:gd name="connsiteY5" fmla="*/ 1330002 h 2671846"/>
                        <a:gd name="connsiteX6" fmla="*/ 577725 w 1925394"/>
                        <a:gd name="connsiteY6" fmla="*/ 1308839 h 2671846"/>
                        <a:gd name="connsiteX7" fmla="*/ 785779 w 1925394"/>
                        <a:gd name="connsiteY7" fmla="*/ 1299522 h 2671846"/>
                        <a:gd name="connsiteX8" fmla="*/ 1039779 w 1925394"/>
                        <a:gd name="connsiteY8" fmla="*/ 1238562 h 2671846"/>
                        <a:gd name="connsiteX9" fmla="*/ 1192179 w 1925394"/>
                        <a:gd name="connsiteY9" fmla="*/ 1136962 h 2671846"/>
                        <a:gd name="connsiteX10" fmla="*/ 1283619 w 1925394"/>
                        <a:gd name="connsiteY10" fmla="*/ 1004882 h 2671846"/>
                        <a:gd name="connsiteX11" fmla="*/ 1344579 w 1925394"/>
                        <a:gd name="connsiteY11" fmla="*/ 913442 h 2671846"/>
                        <a:gd name="connsiteX12" fmla="*/ 1226412 w 1925394"/>
                        <a:gd name="connsiteY12" fmla="*/ 1123422 h 2671846"/>
                        <a:gd name="connsiteX13" fmla="*/ 1070259 w 1925394"/>
                        <a:gd name="connsiteY13" fmla="*/ 1250417 h 2671846"/>
                        <a:gd name="connsiteX14" fmla="*/ 810953 w 1925394"/>
                        <a:gd name="connsiteY14" fmla="*/ 1314767 h 2671846"/>
                        <a:gd name="connsiteX15" fmla="*/ 247299 w 1925394"/>
                        <a:gd name="connsiteY15" fmla="*/ 1401122 h 2671846"/>
                        <a:gd name="connsiteX16" fmla="*/ 84739 w 1925394"/>
                        <a:gd name="connsiteY16" fmla="*/ 1919282 h 2671846"/>
                        <a:gd name="connsiteX17" fmla="*/ 22679 w 1925394"/>
                        <a:gd name="connsiteY17" fmla="*/ 2323987 h 2671846"/>
                        <a:gd name="connsiteX18" fmla="*/ 9412 w 1925394"/>
                        <a:gd name="connsiteY18" fmla="*/ 2467922 h 2671846"/>
                        <a:gd name="connsiteX19" fmla="*/ 24685 w 1925394"/>
                        <a:gd name="connsiteY19" fmla="*/ 2653340 h 2671846"/>
                        <a:gd name="connsiteX20" fmla="*/ 277779 w 1925394"/>
                        <a:gd name="connsiteY20" fmla="*/ 2665014 h 2671846"/>
                        <a:gd name="connsiteX21" fmla="*/ 622861 w 1925394"/>
                        <a:gd name="connsiteY21" fmla="*/ 2651175 h 2671846"/>
                        <a:gd name="connsiteX22" fmla="*/ 885229 w 1925394"/>
                        <a:gd name="connsiteY22" fmla="*/ 2613018 h 2671846"/>
                        <a:gd name="connsiteX23" fmla="*/ 1184064 w 1925394"/>
                        <a:gd name="connsiteY23" fmla="*/ 2484750 h 2671846"/>
                        <a:gd name="connsiteX24" fmla="*/ 1334419 w 1925394"/>
                        <a:gd name="connsiteY24" fmla="*/ 2254562 h 2671846"/>
                        <a:gd name="connsiteX25" fmla="*/ 1415699 w 1925394"/>
                        <a:gd name="connsiteY25" fmla="*/ 1959922 h 2671846"/>
                        <a:gd name="connsiteX26" fmla="*/ 1425859 w 1925394"/>
                        <a:gd name="connsiteY26" fmla="*/ 1573842 h 2671846"/>
                        <a:gd name="connsiteX27" fmla="*/ 1407092 w 1925394"/>
                        <a:gd name="connsiteY27" fmla="*/ 1238562 h 2671846"/>
                        <a:gd name="connsiteX28" fmla="*/ 1415699 w 1925394"/>
                        <a:gd name="connsiteY28" fmla="*/ 1086162 h 2671846"/>
                        <a:gd name="connsiteX29" fmla="*/ 1679859 w 1925394"/>
                        <a:gd name="connsiteY29" fmla="*/ 1025202 h 2671846"/>
                        <a:gd name="connsiteX30" fmla="*/ 1700179 w 1925394"/>
                        <a:gd name="connsiteY30" fmla="*/ 913442 h 2671846"/>
                        <a:gd name="connsiteX31" fmla="*/ 1527459 w 1925394"/>
                        <a:gd name="connsiteY31" fmla="*/ 923602 h 2671846"/>
                        <a:gd name="connsiteX32" fmla="*/ 1415699 w 1925394"/>
                        <a:gd name="connsiteY32" fmla="*/ 954082 h 2671846"/>
                        <a:gd name="connsiteX33" fmla="*/ 1415699 w 1925394"/>
                        <a:gd name="connsiteY33" fmla="*/ 893122 h 2671846"/>
                        <a:gd name="connsiteX34" fmla="*/ 1415699 w 1925394"/>
                        <a:gd name="connsiteY34" fmla="*/ 913442 h 2671846"/>
                        <a:gd name="connsiteX35" fmla="*/ 1537619 w 1925394"/>
                        <a:gd name="connsiteY35" fmla="*/ 882962 h 2671846"/>
                        <a:gd name="connsiteX36" fmla="*/ 1629059 w 1925394"/>
                        <a:gd name="connsiteY36" fmla="*/ 842322 h 2671846"/>
                        <a:gd name="connsiteX37" fmla="*/ 1730659 w 1925394"/>
                        <a:gd name="connsiteY37" fmla="*/ 740722 h 2671846"/>
                        <a:gd name="connsiteX38" fmla="*/ 1883059 w 1925394"/>
                        <a:gd name="connsiteY38" fmla="*/ 496882 h 2671846"/>
                        <a:gd name="connsiteX39" fmla="*/ 1913539 w 1925394"/>
                        <a:gd name="connsiteY39" fmla="*/ 425762 h 2671846"/>
                        <a:gd name="connsiteX40" fmla="*/ 1710697 w 1925394"/>
                        <a:gd name="connsiteY40" fmla="*/ 357696 h 2671846"/>
                        <a:gd name="connsiteX41" fmla="*/ 1564489 w 1925394"/>
                        <a:gd name="connsiteY41" fmla="*/ 542821 h 2671846"/>
                        <a:gd name="connsiteX42" fmla="*/ 1531452 w 1925394"/>
                        <a:gd name="connsiteY42" fmla="*/ 702693 h 2671846"/>
                        <a:gd name="connsiteX43" fmla="*/ 1415699 w 1925394"/>
                        <a:gd name="connsiteY43" fmla="*/ 750882 h 2671846"/>
                        <a:gd name="connsiteX0" fmla="*/ 1415699 w 1935210"/>
                        <a:gd name="connsiteY0" fmla="*/ 750882 h 2671846"/>
                        <a:gd name="connsiteX1" fmla="*/ 1273459 w 1935210"/>
                        <a:gd name="connsiteY1" fmla="*/ 192082 h 2671846"/>
                        <a:gd name="connsiteX2" fmla="*/ 907699 w 1935210"/>
                        <a:gd name="connsiteY2" fmla="*/ 9202 h 2671846"/>
                        <a:gd name="connsiteX3" fmla="*/ 562259 w 1935210"/>
                        <a:gd name="connsiteY3" fmla="*/ 435922 h 2671846"/>
                        <a:gd name="connsiteX4" fmla="*/ 379379 w 1935210"/>
                        <a:gd name="connsiteY4" fmla="*/ 954082 h 2671846"/>
                        <a:gd name="connsiteX5" fmla="*/ 298099 w 1935210"/>
                        <a:gd name="connsiteY5" fmla="*/ 1330002 h 2671846"/>
                        <a:gd name="connsiteX6" fmla="*/ 577725 w 1935210"/>
                        <a:gd name="connsiteY6" fmla="*/ 1308839 h 2671846"/>
                        <a:gd name="connsiteX7" fmla="*/ 785779 w 1935210"/>
                        <a:gd name="connsiteY7" fmla="*/ 1299522 h 2671846"/>
                        <a:gd name="connsiteX8" fmla="*/ 1039779 w 1935210"/>
                        <a:gd name="connsiteY8" fmla="*/ 1238562 h 2671846"/>
                        <a:gd name="connsiteX9" fmla="*/ 1192179 w 1935210"/>
                        <a:gd name="connsiteY9" fmla="*/ 1136962 h 2671846"/>
                        <a:gd name="connsiteX10" fmla="*/ 1283619 w 1935210"/>
                        <a:gd name="connsiteY10" fmla="*/ 1004882 h 2671846"/>
                        <a:gd name="connsiteX11" fmla="*/ 1344579 w 1935210"/>
                        <a:gd name="connsiteY11" fmla="*/ 913442 h 2671846"/>
                        <a:gd name="connsiteX12" fmla="*/ 1226412 w 1935210"/>
                        <a:gd name="connsiteY12" fmla="*/ 1123422 h 2671846"/>
                        <a:gd name="connsiteX13" fmla="*/ 1070259 w 1935210"/>
                        <a:gd name="connsiteY13" fmla="*/ 1250417 h 2671846"/>
                        <a:gd name="connsiteX14" fmla="*/ 810953 w 1935210"/>
                        <a:gd name="connsiteY14" fmla="*/ 1314767 h 2671846"/>
                        <a:gd name="connsiteX15" fmla="*/ 247299 w 1935210"/>
                        <a:gd name="connsiteY15" fmla="*/ 1401122 h 2671846"/>
                        <a:gd name="connsiteX16" fmla="*/ 84739 w 1935210"/>
                        <a:gd name="connsiteY16" fmla="*/ 1919282 h 2671846"/>
                        <a:gd name="connsiteX17" fmla="*/ 22679 w 1935210"/>
                        <a:gd name="connsiteY17" fmla="*/ 2323987 h 2671846"/>
                        <a:gd name="connsiteX18" fmla="*/ 9412 w 1935210"/>
                        <a:gd name="connsiteY18" fmla="*/ 2467922 h 2671846"/>
                        <a:gd name="connsiteX19" fmla="*/ 24685 w 1935210"/>
                        <a:gd name="connsiteY19" fmla="*/ 2653340 h 2671846"/>
                        <a:gd name="connsiteX20" fmla="*/ 277779 w 1935210"/>
                        <a:gd name="connsiteY20" fmla="*/ 2665014 h 2671846"/>
                        <a:gd name="connsiteX21" fmla="*/ 622861 w 1935210"/>
                        <a:gd name="connsiteY21" fmla="*/ 2651175 h 2671846"/>
                        <a:gd name="connsiteX22" fmla="*/ 885229 w 1935210"/>
                        <a:gd name="connsiteY22" fmla="*/ 2613018 h 2671846"/>
                        <a:gd name="connsiteX23" fmla="*/ 1184064 w 1935210"/>
                        <a:gd name="connsiteY23" fmla="*/ 2484750 h 2671846"/>
                        <a:gd name="connsiteX24" fmla="*/ 1334419 w 1935210"/>
                        <a:gd name="connsiteY24" fmla="*/ 2254562 h 2671846"/>
                        <a:gd name="connsiteX25" fmla="*/ 1415699 w 1935210"/>
                        <a:gd name="connsiteY25" fmla="*/ 1959922 h 2671846"/>
                        <a:gd name="connsiteX26" fmla="*/ 1425859 w 1935210"/>
                        <a:gd name="connsiteY26" fmla="*/ 1573842 h 2671846"/>
                        <a:gd name="connsiteX27" fmla="*/ 1407092 w 1935210"/>
                        <a:gd name="connsiteY27" fmla="*/ 1238562 h 2671846"/>
                        <a:gd name="connsiteX28" fmla="*/ 1415699 w 1935210"/>
                        <a:gd name="connsiteY28" fmla="*/ 1086162 h 2671846"/>
                        <a:gd name="connsiteX29" fmla="*/ 1679859 w 1935210"/>
                        <a:gd name="connsiteY29" fmla="*/ 1025202 h 2671846"/>
                        <a:gd name="connsiteX30" fmla="*/ 1700179 w 1935210"/>
                        <a:gd name="connsiteY30" fmla="*/ 913442 h 2671846"/>
                        <a:gd name="connsiteX31" fmla="*/ 1527459 w 1935210"/>
                        <a:gd name="connsiteY31" fmla="*/ 923602 h 2671846"/>
                        <a:gd name="connsiteX32" fmla="*/ 1415699 w 1935210"/>
                        <a:gd name="connsiteY32" fmla="*/ 954082 h 2671846"/>
                        <a:gd name="connsiteX33" fmla="*/ 1415699 w 1935210"/>
                        <a:gd name="connsiteY33" fmla="*/ 893122 h 2671846"/>
                        <a:gd name="connsiteX34" fmla="*/ 1415699 w 1935210"/>
                        <a:gd name="connsiteY34" fmla="*/ 913442 h 2671846"/>
                        <a:gd name="connsiteX35" fmla="*/ 1537619 w 1935210"/>
                        <a:gd name="connsiteY35" fmla="*/ 882962 h 2671846"/>
                        <a:gd name="connsiteX36" fmla="*/ 1629059 w 1935210"/>
                        <a:gd name="connsiteY36" fmla="*/ 842322 h 2671846"/>
                        <a:gd name="connsiteX37" fmla="*/ 1730659 w 1935210"/>
                        <a:gd name="connsiteY37" fmla="*/ 740722 h 2671846"/>
                        <a:gd name="connsiteX38" fmla="*/ 1883059 w 1935210"/>
                        <a:gd name="connsiteY38" fmla="*/ 496882 h 2671846"/>
                        <a:gd name="connsiteX39" fmla="*/ 1913539 w 1935210"/>
                        <a:gd name="connsiteY39" fmla="*/ 425762 h 2671846"/>
                        <a:gd name="connsiteX40" fmla="*/ 1577110 w 1935210"/>
                        <a:gd name="connsiteY40" fmla="*/ 324785 h 2671846"/>
                        <a:gd name="connsiteX41" fmla="*/ 1564489 w 1935210"/>
                        <a:gd name="connsiteY41" fmla="*/ 542821 h 2671846"/>
                        <a:gd name="connsiteX42" fmla="*/ 1531452 w 1935210"/>
                        <a:gd name="connsiteY42" fmla="*/ 702693 h 2671846"/>
                        <a:gd name="connsiteX43" fmla="*/ 1415699 w 1935210"/>
                        <a:gd name="connsiteY43" fmla="*/ 750882 h 2671846"/>
                        <a:gd name="connsiteX0" fmla="*/ 1415699 w 1883068"/>
                        <a:gd name="connsiteY0" fmla="*/ 750882 h 2671846"/>
                        <a:gd name="connsiteX1" fmla="*/ 1273459 w 1883068"/>
                        <a:gd name="connsiteY1" fmla="*/ 192082 h 2671846"/>
                        <a:gd name="connsiteX2" fmla="*/ 907699 w 1883068"/>
                        <a:gd name="connsiteY2" fmla="*/ 9202 h 2671846"/>
                        <a:gd name="connsiteX3" fmla="*/ 562259 w 1883068"/>
                        <a:gd name="connsiteY3" fmla="*/ 435922 h 2671846"/>
                        <a:gd name="connsiteX4" fmla="*/ 379379 w 1883068"/>
                        <a:gd name="connsiteY4" fmla="*/ 954082 h 2671846"/>
                        <a:gd name="connsiteX5" fmla="*/ 298099 w 1883068"/>
                        <a:gd name="connsiteY5" fmla="*/ 1330002 h 2671846"/>
                        <a:gd name="connsiteX6" fmla="*/ 577725 w 1883068"/>
                        <a:gd name="connsiteY6" fmla="*/ 1308839 h 2671846"/>
                        <a:gd name="connsiteX7" fmla="*/ 785779 w 1883068"/>
                        <a:gd name="connsiteY7" fmla="*/ 1299522 h 2671846"/>
                        <a:gd name="connsiteX8" fmla="*/ 1039779 w 1883068"/>
                        <a:gd name="connsiteY8" fmla="*/ 1238562 h 2671846"/>
                        <a:gd name="connsiteX9" fmla="*/ 1192179 w 1883068"/>
                        <a:gd name="connsiteY9" fmla="*/ 1136962 h 2671846"/>
                        <a:gd name="connsiteX10" fmla="*/ 1283619 w 1883068"/>
                        <a:gd name="connsiteY10" fmla="*/ 1004882 h 2671846"/>
                        <a:gd name="connsiteX11" fmla="*/ 1344579 w 1883068"/>
                        <a:gd name="connsiteY11" fmla="*/ 913442 h 2671846"/>
                        <a:gd name="connsiteX12" fmla="*/ 1226412 w 1883068"/>
                        <a:gd name="connsiteY12" fmla="*/ 1123422 h 2671846"/>
                        <a:gd name="connsiteX13" fmla="*/ 1070259 w 1883068"/>
                        <a:gd name="connsiteY13" fmla="*/ 1250417 h 2671846"/>
                        <a:gd name="connsiteX14" fmla="*/ 810953 w 1883068"/>
                        <a:gd name="connsiteY14" fmla="*/ 1314767 h 2671846"/>
                        <a:gd name="connsiteX15" fmla="*/ 247299 w 1883068"/>
                        <a:gd name="connsiteY15" fmla="*/ 1401122 h 2671846"/>
                        <a:gd name="connsiteX16" fmla="*/ 84739 w 1883068"/>
                        <a:gd name="connsiteY16" fmla="*/ 1919282 h 2671846"/>
                        <a:gd name="connsiteX17" fmla="*/ 22679 w 1883068"/>
                        <a:gd name="connsiteY17" fmla="*/ 2323987 h 2671846"/>
                        <a:gd name="connsiteX18" fmla="*/ 9412 w 1883068"/>
                        <a:gd name="connsiteY18" fmla="*/ 2467922 h 2671846"/>
                        <a:gd name="connsiteX19" fmla="*/ 24685 w 1883068"/>
                        <a:gd name="connsiteY19" fmla="*/ 2653340 h 2671846"/>
                        <a:gd name="connsiteX20" fmla="*/ 277779 w 1883068"/>
                        <a:gd name="connsiteY20" fmla="*/ 2665014 h 2671846"/>
                        <a:gd name="connsiteX21" fmla="*/ 622861 w 1883068"/>
                        <a:gd name="connsiteY21" fmla="*/ 2651175 h 2671846"/>
                        <a:gd name="connsiteX22" fmla="*/ 885229 w 1883068"/>
                        <a:gd name="connsiteY22" fmla="*/ 2613018 h 2671846"/>
                        <a:gd name="connsiteX23" fmla="*/ 1184064 w 1883068"/>
                        <a:gd name="connsiteY23" fmla="*/ 2484750 h 2671846"/>
                        <a:gd name="connsiteX24" fmla="*/ 1334419 w 1883068"/>
                        <a:gd name="connsiteY24" fmla="*/ 2254562 h 2671846"/>
                        <a:gd name="connsiteX25" fmla="*/ 1415699 w 1883068"/>
                        <a:gd name="connsiteY25" fmla="*/ 1959922 h 2671846"/>
                        <a:gd name="connsiteX26" fmla="*/ 1425859 w 1883068"/>
                        <a:gd name="connsiteY26" fmla="*/ 1573842 h 2671846"/>
                        <a:gd name="connsiteX27" fmla="*/ 1407092 w 1883068"/>
                        <a:gd name="connsiteY27" fmla="*/ 1238562 h 2671846"/>
                        <a:gd name="connsiteX28" fmla="*/ 1415699 w 1883068"/>
                        <a:gd name="connsiteY28" fmla="*/ 1086162 h 2671846"/>
                        <a:gd name="connsiteX29" fmla="*/ 1679859 w 1883068"/>
                        <a:gd name="connsiteY29" fmla="*/ 1025202 h 2671846"/>
                        <a:gd name="connsiteX30" fmla="*/ 1700179 w 1883068"/>
                        <a:gd name="connsiteY30" fmla="*/ 913442 h 2671846"/>
                        <a:gd name="connsiteX31" fmla="*/ 1527459 w 1883068"/>
                        <a:gd name="connsiteY31" fmla="*/ 923602 h 2671846"/>
                        <a:gd name="connsiteX32" fmla="*/ 1415699 w 1883068"/>
                        <a:gd name="connsiteY32" fmla="*/ 954082 h 2671846"/>
                        <a:gd name="connsiteX33" fmla="*/ 1415699 w 1883068"/>
                        <a:gd name="connsiteY33" fmla="*/ 893122 h 2671846"/>
                        <a:gd name="connsiteX34" fmla="*/ 1415699 w 1883068"/>
                        <a:gd name="connsiteY34" fmla="*/ 913442 h 2671846"/>
                        <a:gd name="connsiteX35" fmla="*/ 1537619 w 1883068"/>
                        <a:gd name="connsiteY35" fmla="*/ 882962 h 2671846"/>
                        <a:gd name="connsiteX36" fmla="*/ 1629059 w 1883068"/>
                        <a:gd name="connsiteY36" fmla="*/ 842322 h 2671846"/>
                        <a:gd name="connsiteX37" fmla="*/ 1730659 w 1883068"/>
                        <a:gd name="connsiteY37" fmla="*/ 740722 h 2671846"/>
                        <a:gd name="connsiteX38" fmla="*/ 1883059 w 1883068"/>
                        <a:gd name="connsiteY38" fmla="*/ 496882 h 2671846"/>
                        <a:gd name="connsiteX39" fmla="*/ 1737448 w 1883068"/>
                        <a:gd name="connsiteY39" fmla="*/ 294120 h 2671846"/>
                        <a:gd name="connsiteX40" fmla="*/ 1577110 w 1883068"/>
                        <a:gd name="connsiteY40" fmla="*/ 324785 h 2671846"/>
                        <a:gd name="connsiteX41" fmla="*/ 1564489 w 1883068"/>
                        <a:gd name="connsiteY41" fmla="*/ 542821 h 2671846"/>
                        <a:gd name="connsiteX42" fmla="*/ 1531452 w 1883068"/>
                        <a:gd name="connsiteY42" fmla="*/ 702693 h 2671846"/>
                        <a:gd name="connsiteX43" fmla="*/ 1415699 w 1883068"/>
                        <a:gd name="connsiteY43" fmla="*/ 750882 h 2671846"/>
                        <a:gd name="connsiteX0" fmla="*/ 1415699 w 1883068"/>
                        <a:gd name="connsiteY0" fmla="*/ 750882 h 2671846"/>
                        <a:gd name="connsiteX1" fmla="*/ 1273459 w 1883068"/>
                        <a:gd name="connsiteY1" fmla="*/ 192082 h 2671846"/>
                        <a:gd name="connsiteX2" fmla="*/ 907699 w 1883068"/>
                        <a:gd name="connsiteY2" fmla="*/ 9202 h 2671846"/>
                        <a:gd name="connsiteX3" fmla="*/ 562259 w 1883068"/>
                        <a:gd name="connsiteY3" fmla="*/ 435922 h 2671846"/>
                        <a:gd name="connsiteX4" fmla="*/ 379379 w 1883068"/>
                        <a:gd name="connsiteY4" fmla="*/ 954082 h 2671846"/>
                        <a:gd name="connsiteX5" fmla="*/ 298099 w 1883068"/>
                        <a:gd name="connsiteY5" fmla="*/ 1330002 h 2671846"/>
                        <a:gd name="connsiteX6" fmla="*/ 577725 w 1883068"/>
                        <a:gd name="connsiteY6" fmla="*/ 1308839 h 2671846"/>
                        <a:gd name="connsiteX7" fmla="*/ 785779 w 1883068"/>
                        <a:gd name="connsiteY7" fmla="*/ 1299522 h 2671846"/>
                        <a:gd name="connsiteX8" fmla="*/ 1039779 w 1883068"/>
                        <a:gd name="connsiteY8" fmla="*/ 1238562 h 2671846"/>
                        <a:gd name="connsiteX9" fmla="*/ 1192179 w 1883068"/>
                        <a:gd name="connsiteY9" fmla="*/ 1136962 h 2671846"/>
                        <a:gd name="connsiteX10" fmla="*/ 1283619 w 1883068"/>
                        <a:gd name="connsiteY10" fmla="*/ 1004882 h 2671846"/>
                        <a:gd name="connsiteX11" fmla="*/ 1344579 w 1883068"/>
                        <a:gd name="connsiteY11" fmla="*/ 913442 h 2671846"/>
                        <a:gd name="connsiteX12" fmla="*/ 1226412 w 1883068"/>
                        <a:gd name="connsiteY12" fmla="*/ 1123422 h 2671846"/>
                        <a:gd name="connsiteX13" fmla="*/ 1070259 w 1883068"/>
                        <a:gd name="connsiteY13" fmla="*/ 1250417 h 2671846"/>
                        <a:gd name="connsiteX14" fmla="*/ 810953 w 1883068"/>
                        <a:gd name="connsiteY14" fmla="*/ 1314767 h 2671846"/>
                        <a:gd name="connsiteX15" fmla="*/ 247299 w 1883068"/>
                        <a:gd name="connsiteY15" fmla="*/ 1401122 h 2671846"/>
                        <a:gd name="connsiteX16" fmla="*/ 84739 w 1883068"/>
                        <a:gd name="connsiteY16" fmla="*/ 1919282 h 2671846"/>
                        <a:gd name="connsiteX17" fmla="*/ 22679 w 1883068"/>
                        <a:gd name="connsiteY17" fmla="*/ 2323987 h 2671846"/>
                        <a:gd name="connsiteX18" fmla="*/ 9412 w 1883068"/>
                        <a:gd name="connsiteY18" fmla="*/ 2467922 h 2671846"/>
                        <a:gd name="connsiteX19" fmla="*/ 24685 w 1883068"/>
                        <a:gd name="connsiteY19" fmla="*/ 2653340 h 2671846"/>
                        <a:gd name="connsiteX20" fmla="*/ 277779 w 1883068"/>
                        <a:gd name="connsiteY20" fmla="*/ 2665014 h 2671846"/>
                        <a:gd name="connsiteX21" fmla="*/ 622861 w 1883068"/>
                        <a:gd name="connsiteY21" fmla="*/ 2651175 h 2671846"/>
                        <a:gd name="connsiteX22" fmla="*/ 885229 w 1883068"/>
                        <a:gd name="connsiteY22" fmla="*/ 2613018 h 2671846"/>
                        <a:gd name="connsiteX23" fmla="*/ 1184064 w 1883068"/>
                        <a:gd name="connsiteY23" fmla="*/ 2484750 h 2671846"/>
                        <a:gd name="connsiteX24" fmla="*/ 1334419 w 1883068"/>
                        <a:gd name="connsiteY24" fmla="*/ 2254562 h 2671846"/>
                        <a:gd name="connsiteX25" fmla="*/ 1415699 w 1883068"/>
                        <a:gd name="connsiteY25" fmla="*/ 1959922 h 2671846"/>
                        <a:gd name="connsiteX26" fmla="*/ 1425859 w 1883068"/>
                        <a:gd name="connsiteY26" fmla="*/ 1573842 h 2671846"/>
                        <a:gd name="connsiteX27" fmla="*/ 1407092 w 1883068"/>
                        <a:gd name="connsiteY27" fmla="*/ 1238562 h 2671846"/>
                        <a:gd name="connsiteX28" fmla="*/ 1415699 w 1883068"/>
                        <a:gd name="connsiteY28" fmla="*/ 1086162 h 2671846"/>
                        <a:gd name="connsiteX29" fmla="*/ 1679859 w 1883068"/>
                        <a:gd name="connsiteY29" fmla="*/ 1025202 h 2671846"/>
                        <a:gd name="connsiteX30" fmla="*/ 1700179 w 1883068"/>
                        <a:gd name="connsiteY30" fmla="*/ 913442 h 2671846"/>
                        <a:gd name="connsiteX31" fmla="*/ 1527459 w 1883068"/>
                        <a:gd name="connsiteY31" fmla="*/ 923602 h 2671846"/>
                        <a:gd name="connsiteX32" fmla="*/ 1415699 w 1883068"/>
                        <a:gd name="connsiteY32" fmla="*/ 954082 h 2671846"/>
                        <a:gd name="connsiteX33" fmla="*/ 1415699 w 1883068"/>
                        <a:gd name="connsiteY33" fmla="*/ 893122 h 2671846"/>
                        <a:gd name="connsiteX34" fmla="*/ 1415699 w 1883068"/>
                        <a:gd name="connsiteY34" fmla="*/ 913442 h 2671846"/>
                        <a:gd name="connsiteX35" fmla="*/ 1537619 w 1883068"/>
                        <a:gd name="connsiteY35" fmla="*/ 882962 h 2671846"/>
                        <a:gd name="connsiteX36" fmla="*/ 1622987 w 1883068"/>
                        <a:gd name="connsiteY36" fmla="*/ 771016 h 2671846"/>
                        <a:gd name="connsiteX37" fmla="*/ 1730659 w 1883068"/>
                        <a:gd name="connsiteY37" fmla="*/ 740722 h 2671846"/>
                        <a:gd name="connsiteX38" fmla="*/ 1883059 w 1883068"/>
                        <a:gd name="connsiteY38" fmla="*/ 496882 h 2671846"/>
                        <a:gd name="connsiteX39" fmla="*/ 1737448 w 1883068"/>
                        <a:gd name="connsiteY39" fmla="*/ 294120 h 2671846"/>
                        <a:gd name="connsiteX40" fmla="*/ 1577110 w 1883068"/>
                        <a:gd name="connsiteY40" fmla="*/ 324785 h 2671846"/>
                        <a:gd name="connsiteX41" fmla="*/ 1564489 w 1883068"/>
                        <a:gd name="connsiteY41" fmla="*/ 542821 h 2671846"/>
                        <a:gd name="connsiteX42" fmla="*/ 1531452 w 1883068"/>
                        <a:gd name="connsiteY42" fmla="*/ 702693 h 2671846"/>
                        <a:gd name="connsiteX43" fmla="*/ 1415699 w 1883068"/>
                        <a:gd name="connsiteY43" fmla="*/ 750882 h 2671846"/>
                        <a:gd name="connsiteX0" fmla="*/ 1415699 w 1883757"/>
                        <a:gd name="connsiteY0" fmla="*/ 750882 h 2671846"/>
                        <a:gd name="connsiteX1" fmla="*/ 1273459 w 1883757"/>
                        <a:gd name="connsiteY1" fmla="*/ 192082 h 2671846"/>
                        <a:gd name="connsiteX2" fmla="*/ 907699 w 1883757"/>
                        <a:gd name="connsiteY2" fmla="*/ 9202 h 2671846"/>
                        <a:gd name="connsiteX3" fmla="*/ 562259 w 1883757"/>
                        <a:gd name="connsiteY3" fmla="*/ 435922 h 2671846"/>
                        <a:gd name="connsiteX4" fmla="*/ 379379 w 1883757"/>
                        <a:gd name="connsiteY4" fmla="*/ 954082 h 2671846"/>
                        <a:gd name="connsiteX5" fmla="*/ 298099 w 1883757"/>
                        <a:gd name="connsiteY5" fmla="*/ 1330002 h 2671846"/>
                        <a:gd name="connsiteX6" fmla="*/ 577725 w 1883757"/>
                        <a:gd name="connsiteY6" fmla="*/ 1308839 h 2671846"/>
                        <a:gd name="connsiteX7" fmla="*/ 785779 w 1883757"/>
                        <a:gd name="connsiteY7" fmla="*/ 1299522 h 2671846"/>
                        <a:gd name="connsiteX8" fmla="*/ 1039779 w 1883757"/>
                        <a:gd name="connsiteY8" fmla="*/ 1238562 h 2671846"/>
                        <a:gd name="connsiteX9" fmla="*/ 1192179 w 1883757"/>
                        <a:gd name="connsiteY9" fmla="*/ 1136962 h 2671846"/>
                        <a:gd name="connsiteX10" fmla="*/ 1283619 w 1883757"/>
                        <a:gd name="connsiteY10" fmla="*/ 1004882 h 2671846"/>
                        <a:gd name="connsiteX11" fmla="*/ 1344579 w 1883757"/>
                        <a:gd name="connsiteY11" fmla="*/ 913442 h 2671846"/>
                        <a:gd name="connsiteX12" fmla="*/ 1226412 w 1883757"/>
                        <a:gd name="connsiteY12" fmla="*/ 1123422 h 2671846"/>
                        <a:gd name="connsiteX13" fmla="*/ 1070259 w 1883757"/>
                        <a:gd name="connsiteY13" fmla="*/ 1250417 h 2671846"/>
                        <a:gd name="connsiteX14" fmla="*/ 810953 w 1883757"/>
                        <a:gd name="connsiteY14" fmla="*/ 1314767 h 2671846"/>
                        <a:gd name="connsiteX15" fmla="*/ 247299 w 1883757"/>
                        <a:gd name="connsiteY15" fmla="*/ 1401122 h 2671846"/>
                        <a:gd name="connsiteX16" fmla="*/ 84739 w 1883757"/>
                        <a:gd name="connsiteY16" fmla="*/ 1919282 h 2671846"/>
                        <a:gd name="connsiteX17" fmla="*/ 22679 w 1883757"/>
                        <a:gd name="connsiteY17" fmla="*/ 2323987 h 2671846"/>
                        <a:gd name="connsiteX18" fmla="*/ 9412 w 1883757"/>
                        <a:gd name="connsiteY18" fmla="*/ 2467922 h 2671846"/>
                        <a:gd name="connsiteX19" fmla="*/ 24685 w 1883757"/>
                        <a:gd name="connsiteY19" fmla="*/ 2653340 h 2671846"/>
                        <a:gd name="connsiteX20" fmla="*/ 277779 w 1883757"/>
                        <a:gd name="connsiteY20" fmla="*/ 2665014 h 2671846"/>
                        <a:gd name="connsiteX21" fmla="*/ 622861 w 1883757"/>
                        <a:gd name="connsiteY21" fmla="*/ 2651175 h 2671846"/>
                        <a:gd name="connsiteX22" fmla="*/ 885229 w 1883757"/>
                        <a:gd name="connsiteY22" fmla="*/ 2613018 h 2671846"/>
                        <a:gd name="connsiteX23" fmla="*/ 1184064 w 1883757"/>
                        <a:gd name="connsiteY23" fmla="*/ 2484750 h 2671846"/>
                        <a:gd name="connsiteX24" fmla="*/ 1334419 w 1883757"/>
                        <a:gd name="connsiteY24" fmla="*/ 2254562 h 2671846"/>
                        <a:gd name="connsiteX25" fmla="*/ 1415699 w 1883757"/>
                        <a:gd name="connsiteY25" fmla="*/ 1959922 h 2671846"/>
                        <a:gd name="connsiteX26" fmla="*/ 1425859 w 1883757"/>
                        <a:gd name="connsiteY26" fmla="*/ 1573842 h 2671846"/>
                        <a:gd name="connsiteX27" fmla="*/ 1407092 w 1883757"/>
                        <a:gd name="connsiteY27" fmla="*/ 1238562 h 2671846"/>
                        <a:gd name="connsiteX28" fmla="*/ 1415699 w 1883757"/>
                        <a:gd name="connsiteY28" fmla="*/ 1086162 h 2671846"/>
                        <a:gd name="connsiteX29" fmla="*/ 1679859 w 1883757"/>
                        <a:gd name="connsiteY29" fmla="*/ 1025202 h 2671846"/>
                        <a:gd name="connsiteX30" fmla="*/ 1700179 w 1883757"/>
                        <a:gd name="connsiteY30" fmla="*/ 913442 h 2671846"/>
                        <a:gd name="connsiteX31" fmla="*/ 1527459 w 1883757"/>
                        <a:gd name="connsiteY31" fmla="*/ 923602 h 2671846"/>
                        <a:gd name="connsiteX32" fmla="*/ 1415699 w 1883757"/>
                        <a:gd name="connsiteY32" fmla="*/ 954082 h 2671846"/>
                        <a:gd name="connsiteX33" fmla="*/ 1415699 w 1883757"/>
                        <a:gd name="connsiteY33" fmla="*/ 893122 h 2671846"/>
                        <a:gd name="connsiteX34" fmla="*/ 1415699 w 1883757"/>
                        <a:gd name="connsiteY34" fmla="*/ 913442 h 2671846"/>
                        <a:gd name="connsiteX35" fmla="*/ 1537619 w 1883757"/>
                        <a:gd name="connsiteY35" fmla="*/ 882962 h 2671846"/>
                        <a:gd name="connsiteX36" fmla="*/ 1622987 w 1883757"/>
                        <a:gd name="connsiteY36" fmla="*/ 771016 h 2671846"/>
                        <a:gd name="connsiteX37" fmla="*/ 1676010 w 1883757"/>
                        <a:gd name="connsiteY37" fmla="*/ 641990 h 2671846"/>
                        <a:gd name="connsiteX38" fmla="*/ 1883059 w 1883757"/>
                        <a:gd name="connsiteY38" fmla="*/ 496882 h 2671846"/>
                        <a:gd name="connsiteX39" fmla="*/ 1737448 w 1883757"/>
                        <a:gd name="connsiteY39" fmla="*/ 294120 h 2671846"/>
                        <a:gd name="connsiteX40" fmla="*/ 1577110 w 1883757"/>
                        <a:gd name="connsiteY40" fmla="*/ 324785 h 2671846"/>
                        <a:gd name="connsiteX41" fmla="*/ 1564489 w 1883757"/>
                        <a:gd name="connsiteY41" fmla="*/ 542821 h 2671846"/>
                        <a:gd name="connsiteX42" fmla="*/ 1531452 w 1883757"/>
                        <a:gd name="connsiteY42" fmla="*/ 702693 h 2671846"/>
                        <a:gd name="connsiteX43" fmla="*/ 1415699 w 1883757"/>
                        <a:gd name="connsiteY43" fmla="*/ 750882 h 2671846"/>
                        <a:gd name="connsiteX0" fmla="*/ 1415699 w 1751890"/>
                        <a:gd name="connsiteY0" fmla="*/ 750882 h 2671846"/>
                        <a:gd name="connsiteX1" fmla="*/ 1273459 w 1751890"/>
                        <a:gd name="connsiteY1" fmla="*/ 192082 h 2671846"/>
                        <a:gd name="connsiteX2" fmla="*/ 907699 w 1751890"/>
                        <a:gd name="connsiteY2" fmla="*/ 9202 h 2671846"/>
                        <a:gd name="connsiteX3" fmla="*/ 562259 w 1751890"/>
                        <a:gd name="connsiteY3" fmla="*/ 435922 h 2671846"/>
                        <a:gd name="connsiteX4" fmla="*/ 379379 w 1751890"/>
                        <a:gd name="connsiteY4" fmla="*/ 954082 h 2671846"/>
                        <a:gd name="connsiteX5" fmla="*/ 298099 w 1751890"/>
                        <a:gd name="connsiteY5" fmla="*/ 1330002 h 2671846"/>
                        <a:gd name="connsiteX6" fmla="*/ 577725 w 1751890"/>
                        <a:gd name="connsiteY6" fmla="*/ 1308839 h 2671846"/>
                        <a:gd name="connsiteX7" fmla="*/ 785779 w 1751890"/>
                        <a:gd name="connsiteY7" fmla="*/ 1299522 h 2671846"/>
                        <a:gd name="connsiteX8" fmla="*/ 1039779 w 1751890"/>
                        <a:gd name="connsiteY8" fmla="*/ 1238562 h 2671846"/>
                        <a:gd name="connsiteX9" fmla="*/ 1192179 w 1751890"/>
                        <a:gd name="connsiteY9" fmla="*/ 1136962 h 2671846"/>
                        <a:gd name="connsiteX10" fmla="*/ 1283619 w 1751890"/>
                        <a:gd name="connsiteY10" fmla="*/ 1004882 h 2671846"/>
                        <a:gd name="connsiteX11" fmla="*/ 1344579 w 1751890"/>
                        <a:gd name="connsiteY11" fmla="*/ 913442 h 2671846"/>
                        <a:gd name="connsiteX12" fmla="*/ 1226412 w 1751890"/>
                        <a:gd name="connsiteY12" fmla="*/ 1123422 h 2671846"/>
                        <a:gd name="connsiteX13" fmla="*/ 1070259 w 1751890"/>
                        <a:gd name="connsiteY13" fmla="*/ 1250417 h 2671846"/>
                        <a:gd name="connsiteX14" fmla="*/ 810953 w 1751890"/>
                        <a:gd name="connsiteY14" fmla="*/ 1314767 h 2671846"/>
                        <a:gd name="connsiteX15" fmla="*/ 247299 w 1751890"/>
                        <a:gd name="connsiteY15" fmla="*/ 1401122 h 2671846"/>
                        <a:gd name="connsiteX16" fmla="*/ 84739 w 1751890"/>
                        <a:gd name="connsiteY16" fmla="*/ 1919282 h 2671846"/>
                        <a:gd name="connsiteX17" fmla="*/ 22679 w 1751890"/>
                        <a:gd name="connsiteY17" fmla="*/ 2323987 h 2671846"/>
                        <a:gd name="connsiteX18" fmla="*/ 9412 w 1751890"/>
                        <a:gd name="connsiteY18" fmla="*/ 2467922 h 2671846"/>
                        <a:gd name="connsiteX19" fmla="*/ 24685 w 1751890"/>
                        <a:gd name="connsiteY19" fmla="*/ 2653340 h 2671846"/>
                        <a:gd name="connsiteX20" fmla="*/ 277779 w 1751890"/>
                        <a:gd name="connsiteY20" fmla="*/ 2665014 h 2671846"/>
                        <a:gd name="connsiteX21" fmla="*/ 622861 w 1751890"/>
                        <a:gd name="connsiteY21" fmla="*/ 2651175 h 2671846"/>
                        <a:gd name="connsiteX22" fmla="*/ 885229 w 1751890"/>
                        <a:gd name="connsiteY22" fmla="*/ 2613018 h 2671846"/>
                        <a:gd name="connsiteX23" fmla="*/ 1184064 w 1751890"/>
                        <a:gd name="connsiteY23" fmla="*/ 2484750 h 2671846"/>
                        <a:gd name="connsiteX24" fmla="*/ 1334419 w 1751890"/>
                        <a:gd name="connsiteY24" fmla="*/ 2254562 h 2671846"/>
                        <a:gd name="connsiteX25" fmla="*/ 1415699 w 1751890"/>
                        <a:gd name="connsiteY25" fmla="*/ 1959922 h 2671846"/>
                        <a:gd name="connsiteX26" fmla="*/ 1425859 w 1751890"/>
                        <a:gd name="connsiteY26" fmla="*/ 1573842 h 2671846"/>
                        <a:gd name="connsiteX27" fmla="*/ 1407092 w 1751890"/>
                        <a:gd name="connsiteY27" fmla="*/ 1238562 h 2671846"/>
                        <a:gd name="connsiteX28" fmla="*/ 1415699 w 1751890"/>
                        <a:gd name="connsiteY28" fmla="*/ 1086162 h 2671846"/>
                        <a:gd name="connsiteX29" fmla="*/ 1679859 w 1751890"/>
                        <a:gd name="connsiteY29" fmla="*/ 1025202 h 2671846"/>
                        <a:gd name="connsiteX30" fmla="*/ 1700179 w 1751890"/>
                        <a:gd name="connsiteY30" fmla="*/ 913442 h 2671846"/>
                        <a:gd name="connsiteX31" fmla="*/ 1527459 w 1751890"/>
                        <a:gd name="connsiteY31" fmla="*/ 923602 h 2671846"/>
                        <a:gd name="connsiteX32" fmla="*/ 1415699 w 1751890"/>
                        <a:gd name="connsiteY32" fmla="*/ 954082 h 2671846"/>
                        <a:gd name="connsiteX33" fmla="*/ 1415699 w 1751890"/>
                        <a:gd name="connsiteY33" fmla="*/ 893122 h 2671846"/>
                        <a:gd name="connsiteX34" fmla="*/ 1415699 w 1751890"/>
                        <a:gd name="connsiteY34" fmla="*/ 913442 h 2671846"/>
                        <a:gd name="connsiteX35" fmla="*/ 1537619 w 1751890"/>
                        <a:gd name="connsiteY35" fmla="*/ 882962 h 2671846"/>
                        <a:gd name="connsiteX36" fmla="*/ 1622987 w 1751890"/>
                        <a:gd name="connsiteY36" fmla="*/ 771016 h 2671846"/>
                        <a:gd name="connsiteX37" fmla="*/ 1676010 w 1751890"/>
                        <a:gd name="connsiteY37" fmla="*/ 641990 h 2671846"/>
                        <a:gd name="connsiteX38" fmla="*/ 1737328 w 1751890"/>
                        <a:gd name="connsiteY38" fmla="*/ 414605 h 2671846"/>
                        <a:gd name="connsiteX39" fmla="*/ 1737448 w 1751890"/>
                        <a:gd name="connsiteY39" fmla="*/ 294120 h 2671846"/>
                        <a:gd name="connsiteX40" fmla="*/ 1577110 w 1751890"/>
                        <a:gd name="connsiteY40" fmla="*/ 324785 h 2671846"/>
                        <a:gd name="connsiteX41" fmla="*/ 1564489 w 1751890"/>
                        <a:gd name="connsiteY41" fmla="*/ 542821 h 2671846"/>
                        <a:gd name="connsiteX42" fmla="*/ 1531452 w 1751890"/>
                        <a:gd name="connsiteY42" fmla="*/ 702693 h 2671846"/>
                        <a:gd name="connsiteX43" fmla="*/ 1415699 w 1751890"/>
                        <a:gd name="connsiteY43" fmla="*/ 750882 h 2671846"/>
                        <a:gd name="connsiteX0" fmla="*/ 1415699 w 1749290"/>
                        <a:gd name="connsiteY0" fmla="*/ 750882 h 2671846"/>
                        <a:gd name="connsiteX1" fmla="*/ 1273459 w 1749290"/>
                        <a:gd name="connsiteY1" fmla="*/ 192082 h 2671846"/>
                        <a:gd name="connsiteX2" fmla="*/ 907699 w 1749290"/>
                        <a:gd name="connsiteY2" fmla="*/ 9202 h 2671846"/>
                        <a:gd name="connsiteX3" fmla="*/ 562259 w 1749290"/>
                        <a:gd name="connsiteY3" fmla="*/ 435922 h 2671846"/>
                        <a:gd name="connsiteX4" fmla="*/ 379379 w 1749290"/>
                        <a:gd name="connsiteY4" fmla="*/ 954082 h 2671846"/>
                        <a:gd name="connsiteX5" fmla="*/ 298099 w 1749290"/>
                        <a:gd name="connsiteY5" fmla="*/ 1330002 h 2671846"/>
                        <a:gd name="connsiteX6" fmla="*/ 577725 w 1749290"/>
                        <a:gd name="connsiteY6" fmla="*/ 1308839 h 2671846"/>
                        <a:gd name="connsiteX7" fmla="*/ 785779 w 1749290"/>
                        <a:gd name="connsiteY7" fmla="*/ 1299522 h 2671846"/>
                        <a:gd name="connsiteX8" fmla="*/ 1039779 w 1749290"/>
                        <a:gd name="connsiteY8" fmla="*/ 1238562 h 2671846"/>
                        <a:gd name="connsiteX9" fmla="*/ 1192179 w 1749290"/>
                        <a:gd name="connsiteY9" fmla="*/ 1136962 h 2671846"/>
                        <a:gd name="connsiteX10" fmla="*/ 1283619 w 1749290"/>
                        <a:gd name="connsiteY10" fmla="*/ 1004882 h 2671846"/>
                        <a:gd name="connsiteX11" fmla="*/ 1344579 w 1749290"/>
                        <a:gd name="connsiteY11" fmla="*/ 913442 h 2671846"/>
                        <a:gd name="connsiteX12" fmla="*/ 1226412 w 1749290"/>
                        <a:gd name="connsiteY12" fmla="*/ 1123422 h 2671846"/>
                        <a:gd name="connsiteX13" fmla="*/ 1070259 w 1749290"/>
                        <a:gd name="connsiteY13" fmla="*/ 1250417 h 2671846"/>
                        <a:gd name="connsiteX14" fmla="*/ 810953 w 1749290"/>
                        <a:gd name="connsiteY14" fmla="*/ 1314767 h 2671846"/>
                        <a:gd name="connsiteX15" fmla="*/ 247299 w 1749290"/>
                        <a:gd name="connsiteY15" fmla="*/ 1401122 h 2671846"/>
                        <a:gd name="connsiteX16" fmla="*/ 84739 w 1749290"/>
                        <a:gd name="connsiteY16" fmla="*/ 1919282 h 2671846"/>
                        <a:gd name="connsiteX17" fmla="*/ 22679 w 1749290"/>
                        <a:gd name="connsiteY17" fmla="*/ 2323987 h 2671846"/>
                        <a:gd name="connsiteX18" fmla="*/ 9412 w 1749290"/>
                        <a:gd name="connsiteY18" fmla="*/ 2467922 h 2671846"/>
                        <a:gd name="connsiteX19" fmla="*/ 24685 w 1749290"/>
                        <a:gd name="connsiteY19" fmla="*/ 2653340 h 2671846"/>
                        <a:gd name="connsiteX20" fmla="*/ 277779 w 1749290"/>
                        <a:gd name="connsiteY20" fmla="*/ 2665014 h 2671846"/>
                        <a:gd name="connsiteX21" fmla="*/ 622861 w 1749290"/>
                        <a:gd name="connsiteY21" fmla="*/ 2651175 h 2671846"/>
                        <a:gd name="connsiteX22" fmla="*/ 885229 w 1749290"/>
                        <a:gd name="connsiteY22" fmla="*/ 2613018 h 2671846"/>
                        <a:gd name="connsiteX23" fmla="*/ 1184064 w 1749290"/>
                        <a:gd name="connsiteY23" fmla="*/ 2484750 h 2671846"/>
                        <a:gd name="connsiteX24" fmla="*/ 1334419 w 1749290"/>
                        <a:gd name="connsiteY24" fmla="*/ 2254562 h 2671846"/>
                        <a:gd name="connsiteX25" fmla="*/ 1415699 w 1749290"/>
                        <a:gd name="connsiteY25" fmla="*/ 1959922 h 2671846"/>
                        <a:gd name="connsiteX26" fmla="*/ 1425859 w 1749290"/>
                        <a:gd name="connsiteY26" fmla="*/ 1573842 h 2671846"/>
                        <a:gd name="connsiteX27" fmla="*/ 1407092 w 1749290"/>
                        <a:gd name="connsiteY27" fmla="*/ 1238562 h 2671846"/>
                        <a:gd name="connsiteX28" fmla="*/ 1415699 w 1749290"/>
                        <a:gd name="connsiteY28" fmla="*/ 1086162 h 2671846"/>
                        <a:gd name="connsiteX29" fmla="*/ 1679859 w 1749290"/>
                        <a:gd name="connsiteY29" fmla="*/ 1025202 h 2671846"/>
                        <a:gd name="connsiteX30" fmla="*/ 1700179 w 1749290"/>
                        <a:gd name="connsiteY30" fmla="*/ 913442 h 2671846"/>
                        <a:gd name="connsiteX31" fmla="*/ 1527459 w 1749290"/>
                        <a:gd name="connsiteY31" fmla="*/ 923602 h 2671846"/>
                        <a:gd name="connsiteX32" fmla="*/ 1415699 w 1749290"/>
                        <a:gd name="connsiteY32" fmla="*/ 954082 h 2671846"/>
                        <a:gd name="connsiteX33" fmla="*/ 1415699 w 1749290"/>
                        <a:gd name="connsiteY33" fmla="*/ 893122 h 2671846"/>
                        <a:gd name="connsiteX34" fmla="*/ 1415699 w 1749290"/>
                        <a:gd name="connsiteY34" fmla="*/ 913442 h 2671846"/>
                        <a:gd name="connsiteX35" fmla="*/ 1537619 w 1749290"/>
                        <a:gd name="connsiteY35" fmla="*/ 882962 h 2671846"/>
                        <a:gd name="connsiteX36" fmla="*/ 1622987 w 1749290"/>
                        <a:gd name="connsiteY36" fmla="*/ 771016 h 2671846"/>
                        <a:gd name="connsiteX37" fmla="*/ 1676010 w 1749290"/>
                        <a:gd name="connsiteY37" fmla="*/ 641990 h 2671846"/>
                        <a:gd name="connsiteX38" fmla="*/ 1737328 w 1749290"/>
                        <a:gd name="connsiteY38" fmla="*/ 414605 h 2671846"/>
                        <a:gd name="connsiteX39" fmla="*/ 1737448 w 1749290"/>
                        <a:gd name="connsiteY39" fmla="*/ 294120 h 2671846"/>
                        <a:gd name="connsiteX40" fmla="*/ 1613543 w 1749290"/>
                        <a:gd name="connsiteY40" fmla="*/ 291874 h 2671846"/>
                        <a:gd name="connsiteX41" fmla="*/ 1564489 w 1749290"/>
                        <a:gd name="connsiteY41" fmla="*/ 542821 h 2671846"/>
                        <a:gd name="connsiteX42" fmla="*/ 1531452 w 1749290"/>
                        <a:gd name="connsiteY42" fmla="*/ 702693 h 2671846"/>
                        <a:gd name="connsiteX43" fmla="*/ 1415699 w 1749290"/>
                        <a:gd name="connsiteY43" fmla="*/ 750882 h 2671846"/>
                        <a:gd name="connsiteX0" fmla="*/ 1415699 w 1749290"/>
                        <a:gd name="connsiteY0" fmla="*/ 750882 h 2671846"/>
                        <a:gd name="connsiteX1" fmla="*/ 1273459 w 1749290"/>
                        <a:gd name="connsiteY1" fmla="*/ 192082 h 2671846"/>
                        <a:gd name="connsiteX2" fmla="*/ 907699 w 1749290"/>
                        <a:gd name="connsiteY2" fmla="*/ 9202 h 2671846"/>
                        <a:gd name="connsiteX3" fmla="*/ 562259 w 1749290"/>
                        <a:gd name="connsiteY3" fmla="*/ 435922 h 2671846"/>
                        <a:gd name="connsiteX4" fmla="*/ 379379 w 1749290"/>
                        <a:gd name="connsiteY4" fmla="*/ 954082 h 2671846"/>
                        <a:gd name="connsiteX5" fmla="*/ 298099 w 1749290"/>
                        <a:gd name="connsiteY5" fmla="*/ 1330002 h 2671846"/>
                        <a:gd name="connsiteX6" fmla="*/ 577725 w 1749290"/>
                        <a:gd name="connsiteY6" fmla="*/ 1308839 h 2671846"/>
                        <a:gd name="connsiteX7" fmla="*/ 785779 w 1749290"/>
                        <a:gd name="connsiteY7" fmla="*/ 1299522 h 2671846"/>
                        <a:gd name="connsiteX8" fmla="*/ 1039779 w 1749290"/>
                        <a:gd name="connsiteY8" fmla="*/ 1238562 h 2671846"/>
                        <a:gd name="connsiteX9" fmla="*/ 1192179 w 1749290"/>
                        <a:gd name="connsiteY9" fmla="*/ 1136962 h 2671846"/>
                        <a:gd name="connsiteX10" fmla="*/ 1283619 w 1749290"/>
                        <a:gd name="connsiteY10" fmla="*/ 1004882 h 2671846"/>
                        <a:gd name="connsiteX11" fmla="*/ 1344579 w 1749290"/>
                        <a:gd name="connsiteY11" fmla="*/ 913442 h 2671846"/>
                        <a:gd name="connsiteX12" fmla="*/ 1226412 w 1749290"/>
                        <a:gd name="connsiteY12" fmla="*/ 1123422 h 2671846"/>
                        <a:gd name="connsiteX13" fmla="*/ 1070259 w 1749290"/>
                        <a:gd name="connsiteY13" fmla="*/ 1250417 h 2671846"/>
                        <a:gd name="connsiteX14" fmla="*/ 810953 w 1749290"/>
                        <a:gd name="connsiteY14" fmla="*/ 1314767 h 2671846"/>
                        <a:gd name="connsiteX15" fmla="*/ 247299 w 1749290"/>
                        <a:gd name="connsiteY15" fmla="*/ 1401122 h 2671846"/>
                        <a:gd name="connsiteX16" fmla="*/ 84739 w 1749290"/>
                        <a:gd name="connsiteY16" fmla="*/ 1919282 h 2671846"/>
                        <a:gd name="connsiteX17" fmla="*/ 22679 w 1749290"/>
                        <a:gd name="connsiteY17" fmla="*/ 2323987 h 2671846"/>
                        <a:gd name="connsiteX18" fmla="*/ 9412 w 1749290"/>
                        <a:gd name="connsiteY18" fmla="*/ 2467922 h 2671846"/>
                        <a:gd name="connsiteX19" fmla="*/ 24685 w 1749290"/>
                        <a:gd name="connsiteY19" fmla="*/ 2653340 h 2671846"/>
                        <a:gd name="connsiteX20" fmla="*/ 277779 w 1749290"/>
                        <a:gd name="connsiteY20" fmla="*/ 2665014 h 2671846"/>
                        <a:gd name="connsiteX21" fmla="*/ 622861 w 1749290"/>
                        <a:gd name="connsiteY21" fmla="*/ 2651175 h 2671846"/>
                        <a:gd name="connsiteX22" fmla="*/ 885229 w 1749290"/>
                        <a:gd name="connsiteY22" fmla="*/ 2613018 h 2671846"/>
                        <a:gd name="connsiteX23" fmla="*/ 1184064 w 1749290"/>
                        <a:gd name="connsiteY23" fmla="*/ 2484750 h 2671846"/>
                        <a:gd name="connsiteX24" fmla="*/ 1334419 w 1749290"/>
                        <a:gd name="connsiteY24" fmla="*/ 2254562 h 2671846"/>
                        <a:gd name="connsiteX25" fmla="*/ 1415699 w 1749290"/>
                        <a:gd name="connsiteY25" fmla="*/ 1959922 h 2671846"/>
                        <a:gd name="connsiteX26" fmla="*/ 1425859 w 1749290"/>
                        <a:gd name="connsiteY26" fmla="*/ 1573842 h 2671846"/>
                        <a:gd name="connsiteX27" fmla="*/ 1407092 w 1749290"/>
                        <a:gd name="connsiteY27" fmla="*/ 1238562 h 2671846"/>
                        <a:gd name="connsiteX28" fmla="*/ 1415699 w 1749290"/>
                        <a:gd name="connsiteY28" fmla="*/ 1086162 h 2671846"/>
                        <a:gd name="connsiteX29" fmla="*/ 1679859 w 1749290"/>
                        <a:gd name="connsiteY29" fmla="*/ 1025202 h 2671846"/>
                        <a:gd name="connsiteX30" fmla="*/ 1700179 w 1749290"/>
                        <a:gd name="connsiteY30" fmla="*/ 913442 h 2671846"/>
                        <a:gd name="connsiteX31" fmla="*/ 1527459 w 1749290"/>
                        <a:gd name="connsiteY31" fmla="*/ 923602 h 2671846"/>
                        <a:gd name="connsiteX32" fmla="*/ 1415699 w 1749290"/>
                        <a:gd name="connsiteY32" fmla="*/ 954082 h 2671846"/>
                        <a:gd name="connsiteX33" fmla="*/ 1415699 w 1749290"/>
                        <a:gd name="connsiteY33" fmla="*/ 893122 h 2671846"/>
                        <a:gd name="connsiteX34" fmla="*/ 1415699 w 1749290"/>
                        <a:gd name="connsiteY34" fmla="*/ 913442 h 2671846"/>
                        <a:gd name="connsiteX35" fmla="*/ 1537619 w 1749290"/>
                        <a:gd name="connsiteY35" fmla="*/ 882962 h 2671846"/>
                        <a:gd name="connsiteX36" fmla="*/ 1622987 w 1749290"/>
                        <a:gd name="connsiteY36" fmla="*/ 771016 h 2671846"/>
                        <a:gd name="connsiteX37" fmla="*/ 1676010 w 1749290"/>
                        <a:gd name="connsiteY37" fmla="*/ 641990 h 2671846"/>
                        <a:gd name="connsiteX38" fmla="*/ 1737328 w 1749290"/>
                        <a:gd name="connsiteY38" fmla="*/ 414605 h 2671846"/>
                        <a:gd name="connsiteX39" fmla="*/ 1737448 w 1749290"/>
                        <a:gd name="connsiteY39" fmla="*/ 294120 h 2671846"/>
                        <a:gd name="connsiteX40" fmla="*/ 1613543 w 1749290"/>
                        <a:gd name="connsiteY40" fmla="*/ 291874 h 2671846"/>
                        <a:gd name="connsiteX41" fmla="*/ 1576633 w 1749290"/>
                        <a:gd name="connsiteY41" fmla="*/ 548306 h 2671846"/>
                        <a:gd name="connsiteX42" fmla="*/ 1531452 w 1749290"/>
                        <a:gd name="connsiteY42" fmla="*/ 702693 h 2671846"/>
                        <a:gd name="connsiteX43" fmla="*/ 1415699 w 1749290"/>
                        <a:gd name="connsiteY43" fmla="*/ 750882 h 2671846"/>
                        <a:gd name="connsiteX0" fmla="*/ 1415699 w 1749290"/>
                        <a:gd name="connsiteY0" fmla="*/ 750882 h 2671846"/>
                        <a:gd name="connsiteX1" fmla="*/ 1273459 w 1749290"/>
                        <a:gd name="connsiteY1" fmla="*/ 192082 h 2671846"/>
                        <a:gd name="connsiteX2" fmla="*/ 907699 w 1749290"/>
                        <a:gd name="connsiteY2" fmla="*/ 9202 h 2671846"/>
                        <a:gd name="connsiteX3" fmla="*/ 562259 w 1749290"/>
                        <a:gd name="connsiteY3" fmla="*/ 435922 h 2671846"/>
                        <a:gd name="connsiteX4" fmla="*/ 379379 w 1749290"/>
                        <a:gd name="connsiteY4" fmla="*/ 954082 h 2671846"/>
                        <a:gd name="connsiteX5" fmla="*/ 298099 w 1749290"/>
                        <a:gd name="connsiteY5" fmla="*/ 1330002 h 2671846"/>
                        <a:gd name="connsiteX6" fmla="*/ 577725 w 1749290"/>
                        <a:gd name="connsiteY6" fmla="*/ 1308839 h 2671846"/>
                        <a:gd name="connsiteX7" fmla="*/ 785779 w 1749290"/>
                        <a:gd name="connsiteY7" fmla="*/ 1299522 h 2671846"/>
                        <a:gd name="connsiteX8" fmla="*/ 1039779 w 1749290"/>
                        <a:gd name="connsiteY8" fmla="*/ 1238562 h 2671846"/>
                        <a:gd name="connsiteX9" fmla="*/ 1192179 w 1749290"/>
                        <a:gd name="connsiteY9" fmla="*/ 1136962 h 2671846"/>
                        <a:gd name="connsiteX10" fmla="*/ 1283619 w 1749290"/>
                        <a:gd name="connsiteY10" fmla="*/ 1004882 h 2671846"/>
                        <a:gd name="connsiteX11" fmla="*/ 1344579 w 1749290"/>
                        <a:gd name="connsiteY11" fmla="*/ 913442 h 2671846"/>
                        <a:gd name="connsiteX12" fmla="*/ 1226412 w 1749290"/>
                        <a:gd name="connsiteY12" fmla="*/ 1123422 h 2671846"/>
                        <a:gd name="connsiteX13" fmla="*/ 1070259 w 1749290"/>
                        <a:gd name="connsiteY13" fmla="*/ 1250417 h 2671846"/>
                        <a:gd name="connsiteX14" fmla="*/ 810953 w 1749290"/>
                        <a:gd name="connsiteY14" fmla="*/ 1314767 h 2671846"/>
                        <a:gd name="connsiteX15" fmla="*/ 247299 w 1749290"/>
                        <a:gd name="connsiteY15" fmla="*/ 1401122 h 2671846"/>
                        <a:gd name="connsiteX16" fmla="*/ 84739 w 1749290"/>
                        <a:gd name="connsiteY16" fmla="*/ 1919282 h 2671846"/>
                        <a:gd name="connsiteX17" fmla="*/ 22679 w 1749290"/>
                        <a:gd name="connsiteY17" fmla="*/ 2323987 h 2671846"/>
                        <a:gd name="connsiteX18" fmla="*/ 9412 w 1749290"/>
                        <a:gd name="connsiteY18" fmla="*/ 2467922 h 2671846"/>
                        <a:gd name="connsiteX19" fmla="*/ 24685 w 1749290"/>
                        <a:gd name="connsiteY19" fmla="*/ 2653340 h 2671846"/>
                        <a:gd name="connsiteX20" fmla="*/ 277779 w 1749290"/>
                        <a:gd name="connsiteY20" fmla="*/ 2665014 h 2671846"/>
                        <a:gd name="connsiteX21" fmla="*/ 622861 w 1749290"/>
                        <a:gd name="connsiteY21" fmla="*/ 2651175 h 2671846"/>
                        <a:gd name="connsiteX22" fmla="*/ 885229 w 1749290"/>
                        <a:gd name="connsiteY22" fmla="*/ 2613018 h 2671846"/>
                        <a:gd name="connsiteX23" fmla="*/ 1184064 w 1749290"/>
                        <a:gd name="connsiteY23" fmla="*/ 2484750 h 2671846"/>
                        <a:gd name="connsiteX24" fmla="*/ 1334419 w 1749290"/>
                        <a:gd name="connsiteY24" fmla="*/ 2254562 h 2671846"/>
                        <a:gd name="connsiteX25" fmla="*/ 1415699 w 1749290"/>
                        <a:gd name="connsiteY25" fmla="*/ 1959922 h 2671846"/>
                        <a:gd name="connsiteX26" fmla="*/ 1425859 w 1749290"/>
                        <a:gd name="connsiteY26" fmla="*/ 1573842 h 2671846"/>
                        <a:gd name="connsiteX27" fmla="*/ 1407092 w 1749290"/>
                        <a:gd name="connsiteY27" fmla="*/ 1238562 h 2671846"/>
                        <a:gd name="connsiteX28" fmla="*/ 1415699 w 1749290"/>
                        <a:gd name="connsiteY28" fmla="*/ 1086162 h 2671846"/>
                        <a:gd name="connsiteX29" fmla="*/ 1679859 w 1749290"/>
                        <a:gd name="connsiteY29" fmla="*/ 1025202 h 2671846"/>
                        <a:gd name="connsiteX30" fmla="*/ 1700179 w 1749290"/>
                        <a:gd name="connsiteY30" fmla="*/ 913442 h 2671846"/>
                        <a:gd name="connsiteX31" fmla="*/ 1527459 w 1749290"/>
                        <a:gd name="connsiteY31" fmla="*/ 923602 h 2671846"/>
                        <a:gd name="connsiteX32" fmla="*/ 1415699 w 1749290"/>
                        <a:gd name="connsiteY32" fmla="*/ 954082 h 2671846"/>
                        <a:gd name="connsiteX33" fmla="*/ 1415699 w 1749290"/>
                        <a:gd name="connsiteY33" fmla="*/ 893122 h 2671846"/>
                        <a:gd name="connsiteX34" fmla="*/ 1415699 w 1749290"/>
                        <a:gd name="connsiteY34" fmla="*/ 913442 h 2671846"/>
                        <a:gd name="connsiteX35" fmla="*/ 1537619 w 1749290"/>
                        <a:gd name="connsiteY35" fmla="*/ 882962 h 2671846"/>
                        <a:gd name="connsiteX36" fmla="*/ 1622987 w 1749290"/>
                        <a:gd name="connsiteY36" fmla="*/ 771016 h 2671846"/>
                        <a:gd name="connsiteX37" fmla="*/ 1676010 w 1749290"/>
                        <a:gd name="connsiteY37" fmla="*/ 641990 h 2671846"/>
                        <a:gd name="connsiteX38" fmla="*/ 1737328 w 1749290"/>
                        <a:gd name="connsiteY38" fmla="*/ 414605 h 2671846"/>
                        <a:gd name="connsiteX39" fmla="*/ 1737448 w 1749290"/>
                        <a:gd name="connsiteY39" fmla="*/ 294120 h 2671846"/>
                        <a:gd name="connsiteX40" fmla="*/ 1613543 w 1749290"/>
                        <a:gd name="connsiteY40" fmla="*/ 291874 h 2671846"/>
                        <a:gd name="connsiteX41" fmla="*/ 1576633 w 1749290"/>
                        <a:gd name="connsiteY41" fmla="*/ 548306 h 2671846"/>
                        <a:gd name="connsiteX42" fmla="*/ 1531452 w 1749290"/>
                        <a:gd name="connsiteY42" fmla="*/ 702693 h 2671846"/>
                        <a:gd name="connsiteX43" fmla="*/ 1415699 w 1749290"/>
                        <a:gd name="connsiteY43" fmla="*/ 750882 h 2671846"/>
                        <a:gd name="connsiteX0" fmla="*/ 1415699 w 1749290"/>
                        <a:gd name="connsiteY0" fmla="*/ 750882 h 2671846"/>
                        <a:gd name="connsiteX1" fmla="*/ 1273459 w 1749290"/>
                        <a:gd name="connsiteY1" fmla="*/ 192082 h 2671846"/>
                        <a:gd name="connsiteX2" fmla="*/ 907699 w 1749290"/>
                        <a:gd name="connsiteY2" fmla="*/ 9202 h 2671846"/>
                        <a:gd name="connsiteX3" fmla="*/ 562259 w 1749290"/>
                        <a:gd name="connsiteY3" fmla="*/ 435922 h 2671846"/>
                        <a:gd name="connsiteX4" fmla="*/ 379379 w 1749290"/>
                        <a:gd name="connsiteY4" fmla="*/ 954082 h 2671846"/>
                        <a:gd name="connsiteX5" fmla="*/ 298099 w 1749290"/>
                        <a:gd name="connsiteY5" fmla="*/ 1330002 h 2671846"/>
                        <a:gd name="connsiteX6" fmla="*/ 577725 w 1749290"/>
                        <a:gd name="connsiteY6" fmla="*/ 1308839 h 2671846"/>
                        <a:gd name="connsiteX7" fmla="*/ 785779 w 1749290"/>
                        <a:gd name="connsiteY7" fmla="*/ 1299522 h 2671846"/>
                        <a:gd name="connsiteX8" fmla="*/ 1039779 w 1749290"/>
                        <a:gd name="connsiteY8" fmla="*/ 1238562 h 2671846"/>
                        <a:gd name="connsiteX9" fmla="*/ 1192179 w 1749290"/>
                        <a:gd name="connsiteY9" fmla="*/ 1136962 h 2671846"/>
                        <a:gd name="connsiteX10" fmla="*/ 1283619 w 1749290"/>
                        <a:gd name="connsiteY10" fmla="*/ 1004882 h 2671846"/>
                        <a:gd name="connsiteX11" fmla="*/ 1344579 w 1749290"/>
                        <a:gd name="connsiteY11" fmla="*/ 913442 h 2671846"/>
                        <a:gd name="connsiteX12" fmla="*/ 1226412 w 1749290"/>
                        <a:gd name="connsiteY12" fmla="*/ 1123422 h 2671846"/>
                        <a:gd name="connsiteX13" fmla="*/ 1070259 w 1749290"/>
                        <a:gd name="connsiteY13" fmla="*/ 1250417 h 2671846"/>
                        <a:gd name="connsiteX14" fmla="*/ 810953 w 1749290"/>
                        <a:gd name="connsiteY14" fmla="*/ 1314767 h 2671846"/>
                        <a:gd name="connsiteX15" fmla="*/ 247299 w 1749290"/>
                        <a:gd name="connsiteY15" fmla="*/ 1401122 h 2671846"/>
                        <a:gd name="connsiteX16" fmla="*/ 84739 w 1749290"/>
                        <a:gd name="connsiteY16" fmla="*/ 1919282 h 2671846"/>
                        <a:gd name="connsiteX17" fmla="*/ 22679 w 1749290"/>
                        <a:gd name="connsiteY17" fmla="*/ 2323987 h 2671846"/>
                        <a:gd name="connsiteX18" fmla="*/ 9412 w 1749290"/>
                        <a:gd name="connsiteY18" fmla="*/ 2467922 h 2671846"/>
                        <a:gd name="connsiteX19" fmla="*/ 24685 w 1749290"/>
                        <a:gd name="connsiteY19" fmla="*/ 2653340 h 2671846"/>
                        <a:gd name="connsiteX20" fmla="*/ 277779 w 1749290"/>
                        <a:gd name="connsiteY20" fmla="*/ 2665014 h 2671846"/>
                        <a:gd name="connsiteX21" fmla="*/ 622861 w 1749290"/>
                        <a:gd name="connsiteY21" fmla="*/ 2651175 h 2671846"/>
                        <a:gd name="connsiteX22" fmla="*/ 885229 w 1749290"/>
                        <a:gd name="connsiteY22" fmla="*/ 2613018 h 2671846"/>
                        <a:gd name="connsiteX23" fmla="*/ 1184064 w 1749290"/>
                        <a:gd name="connsiteY23" fmla="*/ 2484750 h 2671846"/>
                        <a:gd name="connsiteX24" fmla="*/ 1334419 w 1749290"/>
                        <a:gd name="connsiteY24" fmla="*/ 2254562 h 2671846"/>
                        <a:gd name="connsiteX25" fmla="*/ 1415699 w 1749290"/>
                        <a:gd name="connsiteY25" fmla="*/ 1959922 h 2671846"/>
                        <a:gd name="connsiteX26" fmla="*/ 1425859 w 1749290"/>
                        <a:gd name="connsiteY26" fmla="*/ 1573842 h 2671846"/>
                        <a:gd name="connsiteX27" fmla="*/ 1407092 w 1749290"/>
                        <a:gd name="connsiteY27" fmla="*/ 1238562 h 2671846"/>
                        <a:gd name="connsiteX28" fmla="*/ 1415699 w 1749290"/>
                        <a:gd name="connsiteY28" fmla="*/ 1086162 h 2671846"/>
                        <a:gd name="connsiteX29" fmla="*/ 1679859 w 1749290"/>
                        <a:gd name="connsiteY29" fmla="*/ 1025202 h 2671846"/>
                        <a:gd name="connsiteX30" fmla="*/ 1700179 w 1749290"/>
                        <a:gd name="connsiteY30" fmla="*/ 913442 h 2671846"/>
                        <a:gd name="connsiteX31" fmla="*/ 1527459 w 1749290"/>
                        <a:gd name="connsiteY31" fmla="*/ 923602 h 2671846"/>
                        <a:gd name="connsiteX32" fmla="*/ 1415699 w 1749290"/>
                        <a:gd name="connsiteY32" fmla="*/ 954082 h 2671846"/>
                        <a:gd name="connsiteX33" fmla="*/ 1415699 w 1749290"/>
                        <a:gd name="connsiteY33" fmla="*/ 893122 h 2671846"/>
                        <a:gd name="connsiteX34" fmla="*/ 1415699 w 1749290"/>
                        <a:gd name="connsiteY34" fmla="*/ 913442 h 2671846"/>
                        <a:gd name="connsiteX35" fmla="*/ 1537619 w 1749290"/>
                        <a:gd name="connsiteY35" fmla="*/ 882962 h 2671846"/>
                        <a:gd name="connsiteX36" fmla="*/ 1622987 w 1749290"/>
                        <a:gd name="connsiteY36" fmla="*/ 771016 h 2671846"/>
                        <a:gd name="connsiteX37" fmla="*/ 1676010 w 1749290"/>
                        <a:gd name="connsiteY37" fmla="*/ 641990 h 2671846"/>
                        <a:gd name="connsiteX38" fmla="*/ 1737328 w 1749290"/>
                        <a:gd name="connsiteY38" fmla="*/ 414605 h 2671846"/>
                        <a:gd name="connsiteX39" fmla="*/ 1737448 w 1749290"/>
                        <a:gd name="connsiteY39" fmla="*/ 294120 h 2671846"/>
                        <a:gd name="connsiteX40" fmla="*/ 1613543 w 1749290"/>
                        <a:gd name="connsiteY40" fmla="*/ 291874 h 2671846"/>
                        <a:gd name="connsiteX41" fmla="*/ 1576633 w 1749290"/>
                        <a:gd name="connsiteY41" fmla="*/ 548306 h 2671846"/>
                        <a:gd name="connsiteX42" fmla="*/ 1531452 w 1749290"/>
                        <a:gd name="connsiteY42" fmla="*/ 675267 h 2671846"/>
                        <a:gd name="connsiteX43" fmla="*/ 1415699 w 1749290"/>
                        <a:gd name="connsiteY43" fmla="*/ 750882 h 2671846"/>
                        <a:gd name="connsiteX0" fmla="*/ 1415699 w 1749290"/>
                        <a:gd name="connsiteY0" fmla="*/ 750882 h 2671846"/>
                        <a:gd name="connsiteX1" fmla="*/ 1273459 w 1749290"/>
                        <a:gd name="connsiteY1" fmla="*/ 192082 h 2671846"/>
                        <a:gd name="connsiteX2" fmla="*/ 907699 w 1749290"/>
                        <a:gd name="connsiteY2" fmla="*/ 9202 h 2671846"/>
                        <a:gd name="connsiteX3" fmla="*/ 562259 w 1749290"/>
                        <a:gd name="connsiteY3" fmla="*/ 435922 h 2671846"/>
                        <a:gd name="connsiteX4" fmla="*/ 379379 w 1749290"/>
                        <a:gd name="connsiteY4" fmla="*/ 954082 h 2671846"/>
                        <a:gd name="connsiteX5" fmla="*/ 298099 w 1749290"/>
                        <a:gd name="connsiteY5" fmla="*/ 1330002 h 2671846"/>
                        <a:gd name="connsiteX6" fmla="*/ 577725 w 1749290"/>
                        <a:gd name="connsiteY6" fmla="*/ 1308839 h 2671846"/>
                        <a:gd name="connsiteX7" fmla="*/ 785779 w 1749290"/>
                        <a:gd name="connsiteY7" fmla="*/ 1299522 h 2671846"/>
                        <a:gd name="connsiteX8" fmla="*/ 1039779 w 1749290"/>
                        <a:gd name="connsiteY8" fmla="*/ 1238562 h 2671846"/>
                        <a:gd name="connsiteX9" fmla="*/ 1192179 w 1749290"/>
                        <a:gd name="connsiteY9" fmla="*/ 1136962 h 2671846"/>
                        <a:gd name="connsiteX10" fmla="*/ 1283619 w 1749290"/>
                        <a:gd name="connsiteY10" fmla="*/ 1004882 h 2671846"/>
                        <a:gd name="connsiteX11" fmla="*/ 1306392 w 1749290"/>
                        <a:gd name="connsiteY11" fmla="*/ 953917 h 2671846"/>
                        <a:gd name="connsiteX12" fmla="*/ 1226412 w 1749290"/>
                        <a:gd name="connsiteY12" fmla="*/ 1123422 h 2671846"/>
                        <a:gd name="connsiteX13" fmla="*/ 1070259 w 1749290"/>
                        <a:gd name="connsiteY13" fmla="*/ 1250417 h 2671846"/>
                        <a:gd name="connsiteX14" fmla="*/ 810953 w 1749290"/>
                        <a:gd name="connsiteY14" fmla="*/ 1314767 h 2671846"/>
                        <a:gd name="connsiteX15" fmla="*/ 247299 w 1749290"/>
                        <a:gd name="connsiteY15" fmla="*/ 1401122 h 2671846"/>
                        <a:gd name="connsiteX16" fmla="*/ 84739 w 1749290"/>
                        <a:gd name="connsiteY16" fmla="*/ 1919282 h 2671846"/>
                        <a:gd name="connsiteX17" fmla="*/ 22679 w 1749290"/>
                        <a:gd name="connsiteY17" fmla="*/ 2323987 h 2671846"/>
                        <a:gd name="connsiteX18" fmla="*/ 9412 w 1749290"/>
                        <a:gd name="connsiteY18" fmla="*/ 2467922 h 2671846"/>
                        <a:gd name="connsiteX19" fmla="*/ 24685 w 1749290"/>
                        <a:gd name="connsiteY19" fmla="*/ 2653340 h 2671846"/>
                        <a:gd name="connsiteX20" fmla="*/ 277779 w 1749290"/>
                        <a:gd name="connsiteY20" fmla="*/ 2665014 h 2671846"/>
                        <a:gd name="connsiteX21" fmla="*/ 622861 w 1749290"/>
                        <a:gd name="connsiteY21" fmla="*/ 2651175 h 2671846"/>
                        <a:gd name="connsiteX22" fmla="*/ 885229 w 1749290"/>
                        <a:gd name="connsiteY22" fmla="*/ 2613018 h 2671846"/>
                        <a:gd name="connsiteX23" fmla="*/ 1184064 w 1749290"/>
                        <a:gd name="connsiteY23" fmla="*/ 2484750 h 2671846"/>
                        <a:gd name="connsiteX24" fmla="*/ 1334419 w 1749290"/>
                        <a:gd name="connsiteY24" fmla="*/ 2254562 h 2671846"/>
                        <a:gd name="connsiteX25" fmla="*/ 1415699 w 1749290"/>
                        <a:gd name="connsiteY25" fmla="*/ 1959922 h 2671846"/>
                        <a:gd name="connsiteX26" fmla="*/ 1425859 w 1749290"/>
                        <a:gd name="connsiteY26" fmla="*/ 1573842 h 2671846"/>
                        <a:gd name="connsiteX27" fmla="*/ 1407092 w 1749290"/>
                        <a:gd name="connsiteY27" fmla="*/ 1238562 h 2671846"/>
                        <a:gd name="connsiteX28" fmla="*/ 1415699 w 1749290"/>
                        <a:gd name="connsiteY28" fmla="*/ 1086162 h 2671846"/>
                        <a:gd name="connsiteX29" fmla="*/ 1679859 w 1749290"/>
                        <a:gd name="connsiteY29" fmla="*/ 1025202 h 2671846"/>
                        <a:gd name="connsiteX30" fmla="*/ 1700179 w 1749290"/>
                        <a:gd name="connsiteY30" fmla="*/ 913442 h 2671846"/>
                        <a:gd name="connsiteX31" fmla="*/ 1527459 w 1749290"/>
                        <a:gd name="connsiteY31" fmla="*/ 923602 h 2671846"/>
                        <a:gd name="connsiteX32" fmla="*/ 1415699 w 1749290"/>
                        <a:gd name="connsiteY32" fmla="*/ 954082 h 2671846"/>
                        <a:gd name="connsiteX33" fmla="*/ 1415699 w 1749290"/>
                        <a:gd name="connsiteY33" fmla="*/ 893122 h 2671846"/>
                        <a:gd name="connsiteX34" fmla="*/ 1415699 w 1749290"/>
                        <a:gd name="connsiteY34" fmla="*/ 913442 h 2671846"/>
                        <a:gd name="connsiteX35" fmla="*/ 1537619 w 1749290"/>
                        <a:gd name="connsiteY35" fmla="*/ 882962 h 2671846"/>
                        <a:gd name="connsiteX36" fmla="*/ 1622987 w 1749290"/>
                        <a:gd name="connsiteY36" fmla="*/ 771016 h 2671846"/>
                        <a:gd name="connsiteX37" fmla="*/ 1676010 w 1749290"/>
                        <a:gd name="connsiteY37" fmla="*/ 641990 h 2671846"/>
                        <a:gd name="connsiteX38" fmla="*/ 1737328 w 1749290"/>
                        <a:gd name="connsiteY38" fmla="*/ 414605 h 2671846"/>
                        <a:gd name="connsiteX39" fmla="*/ 1737448 w 1749290"/>
                        <a:gd name="connsiteY39" fmla="*/ 294120 h 2671846"/>
                        <a:gd name="connsiteX40" fmla="*/ 1613543 w 1749290"/>
                        <a:gd name="connsiteY40" fmla="*/ 291874 h 2671846"/>
                        <a:gd name="connsiteX41" fmla="*/ 1576633 w 1749290"/>
                        <a:gd name="connsiteY41" fmla="*/ 548306 h 2671846"/>
                        <a:gd name="connsiteX42" fmla="*/ 1531452 w 1749290"/>
                        <a:gd name="connsiteY42" fmla="*/ 675267 h 2671846"/>
                        <a:gd name="connsiteX43" fmla="*/ 1415699 w 1749290"/>
                        <a:gd name="connsiteY43" fmla="*/ 750882 h 2671846"/>
                        <a:gd name="connsiteX0" fmla="*/ 1415699 w 1749290"/>
                        <a:gd name="connsiteY0" fmla="*/ 750882 h 2671846"/>
                        <a:gd name="connsiteX1" fmla="*/ 1273459 w 1749290"/>
                        <a:gd name="connsiteY1" fmla="*/ 192082 h 2671846"/>
                        <a:gd name="connsiteX2" fmla="*/ 907699 w 1749290"/>
                        <a:gd name="connsiteY2" fmla="*/ 9202 h 2671846"/>
                        <a:gd name="connsiteX3" fmla="*/ 562259 w 1749290"/>
                        <a:gd name="connsiteY3" fmla="*/ 435922 h 2671846"/>
                        <a:gd name="connsiteX4" fmla="*/ 379379 w 1749290"/>
                        <a:gd name="connsiteY4" fmla="*/ 954082 h 2671846"/>
                        <a:gd name="connsiteX5" fmla="*/ 298099 w 1749290"/>
                        <a:gd name="connsiteY5" fmla="*/ 1330002 h 2671846"/>
                        <a:gd name="connsiteX6" fmla="*/ 577725 w 1749290"/>
                        <a:gd name="connsiteY6" fmla="*/ 1308839 h 2671846"/>
                        <a:gd name="connsiteX7" fmla="*/ 785779 w 1749290"/>
                        <a:gd name="connsiteY7" fmla="*/ 1299522 h 2671846"/>
                        <a:gd name="connsiteX8" fmla="*/ 1039779 w 1749290"/>
                        <a:gd name="connsiteY8" fmla="*/ 1238562 h 2671846"/>
                        <a:gd name="connsiteX9" fmla="*/ 1192179 w 1749290"/>
                        <a:gd name="connsiteY9" fmla="*/ 1136962 h 2671846"/>
                        <a:gd name="connsiteX10" fmla="*/ 1283619 w 1749290"/>
                        <a:gd name="connsiteY10" fmla="*/ 1004882 h 2671846"/>
                        <a:gd name="connsiteX11" fmla="*/ 1306392 w 1749290"/>
                        <a:gd name="connsiteY11" fmla="*/ 953917 h 2671846"/>
                        <a:gd name="connsiteX12" fmla="*/ 1226412 w 1749290"/>
                        <a:gd name="connsiteY12" fmla="*/ 1123422 h 2671846"/>
                        <a:gd name="connsiteX13" fmla="*/ 1070259 w 1749290"/>
                        <a:gd name="connsiteY13" fmla="*/ 1250417 h 2671846"/>
                        <a:gd name="connsiteX14" fmla="*/ 810953 w 1749290"/>
                        <a:gd name="connsiteY14" fmla="*/ 1314767 h 2671846"/>
                        <a:gd name="connsiteX15" fmla="*/ 247299 w 1749290"/>
                        <a:gd name="connsiteY15" fmla="*/ 1401122 h 2671846"/>
                        <a:gd name="connsiteX16" fmla="*/ 84739 w 1749290"/>
                        <a:gd name="connsiteY16" fmla="*/ 1919282 h 2671846"/>
                        <a:gd name="connsiteX17" fmla="*/ 22679 w 1749290"/>
                        <a:gd name="connsiteY17" fmla="*/ 2323987 h 2671846"/>
                        <a:gd name="connsiteX18" fmla="*/ 9412 w 1749290"/>
                        <a:gd name="connsiteY18" fmla="*/ 2467922 h 2671846"/>
                        <a:gd name="connsiteX19" fmla="*/ 24685 w 1749290"/>
                        <a:gd name="connsiteY19" fmla="*/ 2653340 h 2671846"/>
                        <a:gd name="connsiteX20" fmla="*/ 277779 w 1749290"/>
                        <a:gd name="connsiteY20" fmla="*/ 2665014 h 2671846"/>
                        <a:gd name="connsiteX21" fmla="*/ 622861 w 1749290"/>
                        <a:gd name="connsiteY21" fmla="*/ 2651175 h 2671846"/>
                        <a:gd name="connsiteX22" fmla="*/ 885229 w 1749290"/>
                        <a:gd name="connsiteY22" fmla="*/ 2613018 h 2671846"/>
                        <a:gd name="connsiteX23" fmla="*/ 1184064 w 1749290"/>
                        <a:gd name="connsiteY23" fmla="*/ 2484750 h 2671846"/>
                        <a:gd name="connsiteX24" fmla="*/ 1334419 w 1749290"/>
                        <a:gd name="connsiteY24" fmla="*/ 2254562 h 2671846"/>
                        <a:gd name="connsiteX25" fmla="*/ 1415699 w 1749290"/>
                        <a:gd name="connsiteY25" fmla="*/ 1959922 h 2671846"/>
                        <a:gd name="connsiteX26" fmla="*/ 1425859 w 1749290"/>
                        <a:gd name="connsiteY26" fmla="*/ 1573842 h 2671846"/>
                        <a:gd name="connsiteX27" fmla="*/ 1407092 w 1749290"/>
                        <a:gd name="connsiteY27" fmla="*/ 1238562 h 2671846"/>
                        <a:gd name="connsiteX28" fmla="*/ 1415699 w 1749290"/>
                        <a:gd name="connsiteY28" fmla="*/ 1086162 h 2671846"/>
                        <a:gd name="connsiteX29" fmla="*/ 1679859 w 1749290"/>
                        <a:gd name="connsiteY29" fmla="*/ 1025202 h 2671846"/>
                        <a:gd name="connsiteX30" fmla="*/ 1700179 w 1749290"/>
                        <a:gd name="connsiteY30" fmla="*/ 913442 h 2671846"/>
                        <a:gd name="connsiteX31" fmla="*/ 1527459 w 1749290"/>
                        <a:gd name="connsiteY31" fmla="*/ 923602 h 2671846"/>
                        <a:gd name="connsiteX32" fmla="*/ 1415699 w 1749290"/>
                        <a:gd name="connsiteY32" fmla="*/ 954082 h 2671846"/>
                        <a:gd name="connsiteX33" fmla="*/ 1415699 w 1749290"/>
                        <a:gd name="connsiteY33" fmla="*/ 893122 h 2671846"/>
                        <a:gd name="connsiteX34" fmla="*/ 1415699 w 1749290"/>
                        <a:gd name="connsiteY34" fmla="*/ 913442 h 2671846"/>
                        <a:gd name="connsiteX35" fmla="*/ 1537619 w 1749290"/>
                        <a:gd name="connsiteY35" fmla="*/ 882962 h 2671846"/>
                        <a:gd name="connsiteX36" fmla="*/ 1591036 w 1749290"/>
                        <a:gd name="connsiteY36" fmla="*/ 844695 h 2671846"/>
                        <a:gd name="connsiteX37" fmla="*/ 1676010 w 1749290"/>
                        <a:gd name="connsiteY37" fmla="*/ 641990 h 2671846"/>
                        <a:gd name="connsiteX38" fmla="*/ 1737328 w 1749290"/>
                        <a:gd name="connsiteY38" fmla="*/ 414605 h 2671846"/>
                        <a:gd name="connsiteX39" fmla="*/ 1737448 w 1749290"/>
                        <a:gd name="connsiteY39" fmla="*/ 294120 h 2671846"/>
                        <a:gd name="connsiteX40" fmla="*/ 1613543 w 1749290"/>
                        <a:gd name="connsiteY40" fmla="*/ 291874 h 2671846"/>
                        <a:gd name="connsiteX41" fmla="*/ 1576633 w 1749290"/>
                        <a:gd name="connsiteY41" fmla="*/ 548306 h 2671846"/>
                        <a:gd name="connsiteX42" fmla="*/ 1531452 w 1749290"/>
                        <a:gd name="connsiteY42" fmla="*/ 675267 h 2671846"/>
                        <a:gd name="connsiteX43" fmla="*/ 1415699 w 1749290"/>
                        <a:gd name="connsiteY43" fmla="*/ 750882 h 2671846"/>
                        <a:gd name="connsiteX0" fmla="*/ 1415699 w 1751343"/>
                        <a:gd name="connsiteY0" fmla="*/ 750882 h 2671846"/>
                        <a:gd name="connsiteX1" fmla="*/ 1273459 w 1751343"/>
                        <a:gd name="connsiteY1" fmla="*/ 192082 h 2671846"/>
                        <a:gd name="connsiteX2" fmla="*/ 907699 w 1751343"/>
                        <a:gd name="connsiteY2" fmla="*/ 9202 h 2671846"/>
                        <a:gd name="connsiteX3" fmla="*/ 562259 w 1751343"/>
                        <a:gd name="connsiteY3" fmla="*/ 435922 h 2671846"/>
                        <a:gd name="connsiteX4" fmla="*/ 379379 w 1751343"/>
                        <a:gd name="connsiteY4" fmla="*/ 954082 h 2671846"/>
                        <a:gd name="connsiteX5" fmla="*/ 298099 w 1751343"/>
                        <a:gd name="connsiteY5" fmla="*/ 1330002 h 2671846"/>
                        <a:gd name="connsiteX6" fmla="*/ 577725 w 1751343"/>
                        <a:gd name="connsiteY6" fmla="*/ 1308839 h 2671846"/>
                        <a:gd name="connsiteX7" fmla="*/ 785779 w 1751343"/>
                        <a:gd name="connsiteY7" fmla="*/ 1299522 h 2671846"/>
                        <a:gd name="connsiteX8" fmla="*/ 1039779 w 1751343"/>
                        <a:gd name="connsiteY8" fmla="*/ 1238562 h 2671846"/>
                        <a:gd name="connsiteX9" fmla="*/ 1192179 w 1751343"/>
                        <a:gd name="connsiteY9" fmla="*/ 1136962 h 2671846"/>
                        <a:gd name="connsiteX10" fmla="*/ 1283619 w 1751343"/>
                        <a:gd name="connsiteY10" fmla="*/ 1004882 h 2671846"/>
                        <a:gd name="connsiteX11" fmla="*/ 1306392 w 1751343"/>
                        <a:gd name="connsiteY11" fmla="*/ 953917 h 2671846"/>
                        <a:gd name="connsiteX12" fmla="*/ 1226412 w 1751343"/>
                        <a:gd name="connsiteY12" fmla="*/ 1123422 h 2671846"/>
                        <a:gd name="connsiteX13" fmla="*/ 1070259 w 1751343"/>
                        <a:gd name="connsiteY13" fmla="*/ 1250417 h 2671846"/>
                        <a:gd name="connsiteX14" fmla="*/ 810953 w 1751343"/>
                        <a:gd name="connsiteY14" fmla="*/ 1314767 h 2671846"/>
                        <a:gd name="connsiteX15" fmla="*/ 247299 w 1751343"/>
                        <a:gd name="connsiteY15" fmla="*/ 1401122 h 2671846"/>
                        <a:gd name="connsiteX16" fmla="*/ 84739 w 1751343"/>
                        <a:gd name="connsiteY16" fmla="*/ 1919282 h 2671846"/>
                        <a:gd name="connsiteX17" fmla="*/ 22679 w 1751343"/>
                        <a:gd name="connsiteY17" fmla="*/ 2323987 h 2671846"/>
                        <a:gd name="connsiteX18" fmla="*/ 9412 w 1751343"/>
                        <a:gd name="connsiteY18" fmla="*/ 2467922 h 2671846"/>
                        <a:gd name="connsiteX19" fmla="*/ 24685 w 1751343"/>
                        <a:gd name="connsiteY19" fmla="*/ 2653340 h 2671846"/>
                        <a:gd name="connsiteX20" fmla="*/ 277779 w 1751343"/>
                        <a:gd name="connsiteY20" fmla="*/ 2665014 h 2671846"/>
                        <a:gd name="connsiteX21" fmla="*/ 622861 w 1751343"/>
                        <a:gd name="connsiteY21" fmla="*/ 2651175 h 2671846"/>
                        <a:gd name="connsiteX22" fmla="*/ 885229 w 1751343"/>
                        <a:gd name="connsiteY22" fmla="*/ 2613018 h 2671846"/>
                        <a:gd name="connsiteX23" fmla="*/ 1184064 w 1751343"/>
                        <a:gd name="connsiteY23" fmla="*/ 2484750 h 2671846"/>
                        <a:gd name="connsiteX24" fmla="*/ 1334419 w 1751343"/>
                        <a:gd name="connsiteY24" fmla="*/ 2254562 h 2671846"/>
                        <a:gd name="connsiteX25" fmla="*/ 1415699 w 1751343"/>
                        <a:gd name="connsiteY25" fmla="*/ 1959922 h 2671846"/>
                        <a:gd name="connsiteX26" fmla="*/ 1425859 w 1751343"/>
                        <a:gd name="connsiteY26" fmla="*/ 1573842 h 2671846"/>
                        <a:gd name="connsiteX27" fmla="*/ 1407092 w 1751343"/>
                        <a:gd name="connsiteY27" fmla="*/ 1238562 h 2671846"/>
                        <a:gd name="connsiteX28" fmla="*/ 1415699 w 1751343"/>
                        <a:gd name="connsiteY28" fmla="*/ 1086162 h 2671846"/>
                        <a:gd name="connsiteX29" fmla="*/ 1679859 w 1751343"/>
                        <a:gd name="connsiteY29" fmla="*/ 1025202 h 2671846"/>
                        <a:gd name="connsiteX30" fmla="*/ 1700179 w 1751343"/>
                        <a:gd name="connsiteY30" fmla="*/ 913442 h 2671846"/>
                        <a:gd name="connsiteX31" fmla="*/ 1527459 w 1751343"/>
                        <a:gd name="connsiteY31" fmla="*/ 923602 h 2671846"/>
                        <a:gd name="connsiteX32" fmla="*/ 1415699 w 1751343"/>
                        <a:gd name="connsiteY32" fmla="*/ 954082 h 2671846"/>
                        <a:gd name="connsiteX33" fmla="*/ 1415699 w 1751343"/>
                        <a:gd name="connsiteY33" fmla="*/ 893122 h 2671846"/>
                        <a:gd name="connsiteX34" fmla="*/ 1415699 w 1751343"/>
                        <a:gd name="connsiteY34" fmla="*/ 913442 h 2671846"/>
                        <a:gd name="connsiteX35" fmla="*/ 1537619 w 1751343"/>
                        <a:gd name="connsiteY35" fmla="*/ 882962 h 2671846"/>
                        <a:gd name="connsiteX36" fmla="*/ 1591036 w 1751343"/>
                        <a:gd name="connsiteY36" fmla="*/ 844695 h 2671846"/>
                        <a:gd name="connsiteX37" fmla="*/ 1638735 w 1751343"/>
                        <a:gd name="connsiteY37" fmla="*/ 773837 h 2671846"/>
                        <a:gd name="connsiteX38" fmla="*/ 1737328 w 1751343"/>
                        <a:gd name="connsiteY38" fmla="*/ 414605 h 2671846"/>
                        <a:gd name="connsiteX39" fmla="*/ 1737448 w 1751343"/>
                        <a:gd name="connsiteY39" fmla="*/ 294120 h 2671846"/>
                        <a:gd name="connsiteX40" fmla="*/ 1613543 w 1751343"/>
                        <a:gd name="connsiteY40" fmla="*/ 291874 h 2671846"/>
                        <a:gd name="connsiteX41" fmla="*/ 1576633 w 1751343"/>
                        <a:gd name="connsiteY41" fmla="*/ 548306 h 2671846"/>
                        <a:gd name="connsiteX42" fmla="*/ 1531452 w 1751343"/>
                        <a:gd name="connsiteY42" fmla="*/ 675267 h 2671846"/>
                        <a:gd name="connsiteX43" fmla="*/ 1415699 w 1751343"/>
                        <a:gd name="connsiteY43" fmla="*/ 750882 h 2671846"/>
                        <a:gd name="connsiteX0" fmla="*/ 1415699 w 1739464"/>
                        <a:gd name="connsiteY0" fmla="*/ 750882 h 2671846"/>
                        <a:gd name="connsiteX1" fmla="*/ 1273459 w 1739464"/>
                        <a:gd name="connsiteY1" fmla="*/ 192082 h 2671846"/>
                        <a:gd name="connsiteX2" fmla="*/ 907699 w 1739464"/>
                        <a:gd name="connsiteY2" fmla="*/ 9202 h 2671846"/>
                        <a:gd name="connsiteX3" fmla="*/ 562259 w 1739464"/>
                        <a:gd name="connsiteY3" fmla="*/ 435922 h 2671846"/>
                        <a:gd name="connsiteX4" fmla="*/ 379379 w 1739464"/>
                        <a:gd name="connsiteY4" fmla="*/ 954082 h 2671846"/>
                        <a:gd name="connsiteX5" fmla="*/ 298099 w 1739464"/>
                        <a:gd name="connsiteY5" fmla="*/ 1330002 h 2671846"/>
                        <a:gd name="connsiteX6" fmla="*/ 577725 w 1739464"/>
                        <a:gd name="connsiteY6" fmla="*/ 1308839 h 2671846"/>
                        <a:gd name="connsiteX7" fmla="*/ 785779 w 1739464"/>
                        <a:gd name="connsiteY7" fmla="*/ 1299522 h 2671846"/>
                        <a:gd name="connsiteX8" fmla="*/ 1039779 w 1739464"/>
                        <a:gd name="connsiteY8" fmla="*/ 1238562 h 2671846"/>
                        <a:gd name="connsiteX9" fmla="*/ 1192179 w 1739464"/>
                        <a:gd name="connsiteY9" fmla="*/ 1136962 h 2671846"/>
                        <a:gd name="connsiteX10" fmla="*/ 1283619 w 1739464"/>
                        <a:gd name="connsiteY10" fmla="*/ 1004882 h 2671846"/>
                        <a:gd name="connsiteX11" fmla="*/ 1306392 w 1739464"/>
                        <a:gd name="connsiteY11" fmla="*/ 953917 h 2671846"/>
                        <a:gd name="connsiteX12" fmla="*/ 1226412 w 1739464"/>
                        <a:gd name="connsiteY12" fmla="*/ 1123422 h 2671846"/>
                        <a:gd name="connsiteX13" fmla="*/ 1070259 w 1739464"/>
                        <a:gd name="connsiteY13" fmla="*/ 1250417 h 2671846"/>
                        <a:gd name="connsiteX14" fmla="*/ 810953 w 1739464"/>
                        <a:gd name="connsiteY14" fmla="*/ 1314767 h 2671846"/>
                        <a:gd name="connsiteX15" fmla="*/ 247299 w 1739464"/>
                        <a:gd name="connsiteY15" fmla="*/ 1401122 h 2671846"/>
                        <a:gd name="connsiteX16" fmla="*/ 84739 w 1739464"/>
                        <a:gd name="connsiteY16" fmla="*/ 1919282 h 2671846"/>
                        <a:gd name="connsiteX17" fmla="*/ 22679 w 1739464"/>
                        <a:gd name="connsiteY17" fmla="*/ 2323987 h 2671846"/>
                        <a:gd name="connsiteX18" fmla="*/ 9412 w 1739464"/>
                        <a:gd name="connsiteY18" fmla="*/ 2467922 h 2671846"/>
                        <a:gd name="connsiteX19" fmla="*/ 24685 w 1739464"/>
                        <a:gd name="connsiteY19" fmla="*/ 2653340 h 2671846"/>
                        <a:gd name="connsiteX20" fmla="*/ 277779 w 1739464"/>
                        <a:gd name="connsiteY20" fmla="*/ 2665014 h 2671846"/>
                        <a:gd name="connsiteX21" fmla="*/ 622861 w 1739464"/>
                        <a:gd name="connsiteY21" fmla="*/ 2651175 h 2671846"/>
                        <a:gd name="connsiteX22" fmla="*/ 885229 w 1739464"/>
                        <a:gd name="connsiteY22" fmla="*/ 2613018 h 2671846"/>
                        <a:gd name="connsiteX23" fmla="*/ 1184064 w 1739464"/>
                        <a:gd name="connsiteY23" fmla="*/ 2484750 h 2671846"/>
                        <a:gd name="connsiteX24" fmla="*/ 1334419 w 1739464"/>
                        <a:gd name="connsiteY24" fmla="*/ 2254562 h 2671846"/>
                        <a:gd name="connsiteX25" fmla="*/ 1415699 w 1739464"/>
                        <a:gd name="connsiteY25" fmla="*/ 1959922 h 2671846"/>
                        <a:gd name="connsiteX26" fmla="*/ 1425859 w 1739464"/>
                        <a:gd name="connsiteY26" fmla="*/ 1573842 h 2671846"/>
                        <a:gd name="connsiteX27" fmla="*/ 1407092 w 1739464"/>
                        <a:gd name="connsiteY27" fmla="*/ 1238562 h 2671846"/>
                        <a:gd name="connsiteX28" fmla="*/ 1415699 w 1739464"/>
                        <a:gd name="connsiteY28" fmla="*/ 1086162 h 2671846"/>
                        <a:gd name="connsiteX29" fmla="*/ 1679859 w 1739464"/>
                        <a:gd name="connsiteY29" fmla="*/ 1025202 h 2671846"/>
                        <a:gd name="connsiteX30" fmla="*/ 1700179 w 1739464"/>
                        <a:gd name="connsiteY30" fmla="*/ 913442 h 2671846"/>
                        <a:gd name="connsiteX31" fmla="*/ 1527459 w 1739464"/>
                        <a:gd name="connsiteY31" fmla="*/ 923602 h 2671846"/>
                        <a:gd name="connsiteX32" fmla="*/ 1415699 w 1739464"/>
                        <a:gd name="connsiteY32" fmla="*/ 954082 h 2671846"/>
                        <a:gd name="connsiteX33" fmla="*/ 1415699 w 1739464"/>
                        <a:gd name="connsiteY33" fmla="*/ 893122 h 2671846"/>
                        <a:gd name="connsiteX34" fmla="*/ 1415699 w 1739464"/>
                        <a:gd name="connsiteY34" fmla="*/ 913442 h 2671846"/>
                        <a:gd name="connsiteX35" fmla="*/ 1537619 w 1739464"/>
                        <a:gd name="connsiteY35" fmla="*/ 882962 h 2671846"/>
                        <a:gd name="connsiteX36" fmla="*/ 1591036 w 1739464"/>
                        <a:gd name="connsiteY36" fmla="*/ 844695 h 2671846"/>
                        <a:gd name="connsiteX37" fmla="*/ 1638735 w 1739464"/>
                        <a:gd name="connsiteY37" fmla="*/ 773837 h 2671846"/>
                        <a:gd name="connsiteX38" fmla="*/ 1686740 w 1739464"/>
                        <a:gd name="connsiteY38" fmla="*/ 705445 h 2671846"/>
                        <a:gd name="connsiteX39" fmla="*/ 1737448 w 1739464"/>
                        <a:gd name="connsiteY39" fmla="*/ 294120 h 2671846"/>
                        <a:gd name="connsiteX40" fmla="*/ 1613543 w 1739464"/>
                        <a:gd name="connsiteY40" fmla="*/ 291874 h 2671846"/>
                        <a:gd name="connsiteX41" fmla="*/ 1576633 w 1739464"/>
                        <a:gd name="connsiteY41" fmla="*/ 548306 h 2671846"/>
                        <a:gd name="connsiteX42" fmla="*/ 1531452 w 1739464"/>
                        <a:gd name="connsiteY42" fmla="*/ 675267 h 2671846"/>
                        <a:gd name="connsiteX43" fmla="*/ 1415699 w 1739464"/>
                        <a:gd name="connsiteY43" fmla="*/ 750882 h 2671846"/>
                        <a:gd name="connsiteX0" fmla="*/ 1415699 w 1726651"/>
                        <a:gd name="connsiteY0" fmla="*/ 750882 h 2671846"/>
                        <a:gd name="connsiteX1" fmla="*/ 1273459 w 1726651"/>
                        <a:gd name="connsiteY1" fmla="*/ 192082 h 2671846"/>
                        <a:gd name="connsiteX2" fmla="*/ 907699 w 1726651"/>
                        <a:gd name="connsiteY2" fmla="*/ 9202 h 2671846"/>
                        <a:gd name="connsiteX3" fmla="*/ 562259 w 1726651"/>
                        <a:gd name="connsiteY3" fmla="*/ 435922 h 2671846"/>
                        <a:gd name="connsiteX4" fmla="*/ 379379 w 1726651"/>
                        <a:gd name="connsiteY4" fmla="*/ 954082 h 2671846"/>
                        <a:gd name="connsiteX5" fmla="*/ 298099 w 1726651"/>
                        <a:gd name="connsiteY5" fmla="*/ 1330002 h 2671846"/>
                        <a:gd name="connsiteX6" fmla="*/ 577725 w 1726651"/>
                        <a:gd name="connsiteY6" fmla="*/ 1308839 h 2671846"/>
                        <a:gd name="connsiteX7" fmla="*/ 785779 w 1726651"/>
                        <a:gd name="connsiteY7" fmla="*/ 1299522 h 2671846"/>
                        <a:gd name="connsiteX8" fmla="*/ 1039779 w 1726651"/>
                        <a:gd name="connsiteY8" fmla="*/ 1238562 h 2671846"/>
                        <a:gd name="connsiteX9" fmla="*/ 1192179 w 1726651"/>
                        <a:gd name="connsiteY9" fmla="*/ 1136962 h 2671846"/>
                        <a:gd name="connsiteX10" fmla="*/ 1283619 w 1726651"/>
                        <a:gd name="connsiteY10" fmla="*/ 1004882 h 2671846"/>
                        <a:gd name="connsiteX11" fmla="*/ 1306392 w 1726651"/>
                        <a:gd name="connsiteY11" fmla="*/ 953917 h 2671846"/>
                        <a:gd name="connsiteX12" fmla="*/ 1226412 w 1726651"/>
                        <a:gd name="connsiteY12" fmla="*/ 1123422 h 2671846"/>
                        <a:gd name="connsiteX13" fmla="*/ 1070259 w 1726651"/>
                        <a:gd name="connsiteY13" fmla="*/ 1250417 h 2671846"/>
                        <a:gd name="connsiteX14" fmla="*/ 810953 w 1726651"/>
                        <a:gd name="connsiteY14" fmla="*/ 1314767 h 2671846"/>
                        <a:gd name="connsiteX15" fmla="*/ 247299 w 1726651"/>
                        <a:gd name="connsiteY15" fmla="*/ 1401122 h 2671846"/>
                        <a:gd name="connsiteX16" fmla="*/ 84739 w 1726651"/>
                        <a:gd name="connsiteY16" fmla="*/ 1919282 h 2671846"/>
                        <a:gd name="connsiteX17" fmla="*/ 22679 w 1726651"/>
                        <a:gd name="connsiteY17" fmla="*/ 2323987 h 2671846"/>
                        <a:gd name="connsiteX18" fmla="*/ 9412 w 1726651"/>
                        <a:gd name="connsiteY18" fmla="*/ 2467922 h 2671846"/>
                        <a:gd name="connsiteX19" fmla="*/ 24685 w 1726651"/>
                        <a:gd name="connsiteY19" fmla="*/ 2653340 h 2671846"/>
                        <a:gd name="connsiteX20" fmla="*/ 277779 w 1726651"/>
                        <a:gd name="connsiteY20" fmla="*/ 2665014 h 2671846"/>
                        <a:gd name="connsiteX21" fmla="*/ 622861 w 1726651"/>
                        <a:gd name="connsiteY21" fmla="*/ 2651175 h 2671846"/>
                        <a:gd name="connsiteX22" fmla="*/ 885229 w 1726651"/>
                        <a:gd name="connsiteY22" fmla="*/ 2613018 h 2671846"/>
                        <a:gd name="connsiteX23" fmla="*/ 1184064 w 1726651"/>
                        <a:gd name="connsiteY23" fmla="*/ 2484750 h 2671846"/>
                        <a:gd name="connsiteX24" fmla="*/ 1334419 w 1726651"/>
                        <a:gd name="connsiteY24" fmla="*/ 2254562 h 2671846"/>
                        <a:gd name="connsiteX25" fmla="*/ 1415699 w 1726651"/>
                        <a:gd name="connsiteY25" fmla="*/ 1959922 h 2671846"/>
                        <a:gd name="connsiteX26" fmla="*/ 1425859 w 1726651"/>
                        <a:gd name="connsiteY26" fmla="*/ 1573842 h 2671846"/>
                        <a:gd name="connsiteX27" fmla="*/ 1407092 w 1726651"/>
                        <a:gd name="connsiteY27" fmla="*/ 1238562 h 2671846"/>
                        <a:gd name="connsiteX28" fmla="*/ 1415699 w 1726651"/>
                        <a:gd name="connsiteY28" fmla="*/ 1086162 h 2671846"/>
                        <a:gd name="connsiteX29" fmla="*/ 1679859 w 1726651"/>
                        <a:gd name="connsiteY29" fmla="*/ 1025202 h 2671846"/>
                        <a:gd name="connsiteX30" fmla="*/ 1700179 w 1726651"/>
                        <a:gd name="connsiteY30" fmla="*/ 913442 h 2671846"/>
                        <a:gd name="connsiteX31" fmla="*/ 1527459 w 1726651"/>
                        <a:gd name="connsiteY31" fmla="*/ 923602 h 2671846"/>
                        <a:gd name="connsiteX32" fmla="*/ 1415699 w 1726651"/>
                        <a:gd name="connsiteY32" fmla="*/ 954082 h 2671846"/>
                        <a:gd name="connsiteX33" fmla="*/ 1415699 w 1726651"/>
                        <a:gd name="connsiteY33" fmla="*/ 893122 h 2671846"/>
                        <a:gd name="connsiteX34" fmla="*/ 1415699 w 1726651"/>
                        <a:gd name="connsiteY34" fmla="*/ 913442 h 2671846"/>
                        <a:gd name="connsiteX35" fmla="*/ 1537619 w 1726651"/>
                        <a:gd name="connsiteY35" fmla="*/ 882962 h 2671846"/>
                        <a:gd name="connsiteX36" fmla="*/ 1591036 w 1726651"/>
                        <a:gd name="connsiteY36" fmla="*/ 844695 h 2671846"/>
                        <a:gd name="connsiteX37" fmla="*/ 1638735 w 1726651"/>
                        <a:gd name="connsiteY37" fmla="*/ 773837 h 2671846"/>
                        <a:gd name="connsiteX38" fmla="*/ 1686740 w 1726651"/>
                        <a:gd name="connsiteY38" fmla="*/ 705445 h 2671846"/>
                        <a:gd name="connsiteX39" fmla="*/ 1724135 w 1726651"/>
                        <a:gd name="connsiteY39" fmla="*/ 635372 h 2671846"/>
                        <a:gd name="connsiteX40" fmla="*/ 1613543 w 1726651"/>
                        <a:gd name="connsiteY40" fmla="*/ 291874 h 2671846"/>
                        <a:gd name="connsiteX41" fmla="*/ 1576633 w 1726651"/>
                        <a:gd name="connsiteY41" fmla="*/ 548306 h 2671846"/>
                        <a:gd name="connsiteX42" fmla="*/ 1531452 w 1726651"/>
                        <a:gd name="connsiteY42" fmla="*/ 675267 h 2671846"/>
                        <a:gd name="connsiteX43" fmla="*/ 1415699 w 1726651"/>
                        <a:gd name="connsiteY43" fmla="*/ 750882 h 2671846"/>
                        <a:gd name="connsiteX0" fmla="*/ 1415699 w 1726512"/>
                        <a:gd name="connsiteY0" fmla="*/ 750882 h 2671846"/>
                        <a:gd name="connsiteX1" fmla="*/ 1273459 w 1726512"/>
                        <a:gd name="connsiteY1" fmla="*/ 192082 h 2671846"/>
                        <a:gd name="connsiteX2" fmla="*/ 907699 w 1726512"/>
                        <a:gd name="connsiteY2" fmla="*/ 9202 h 2671846"/>
                        <a:gd name="connsiteX3" fmla="*/ 562259 w 1726512"/>
                        <a:gd name="connsiteY3" fmla="*/ 435922 h 2671846"/>
                        <a:gd name="connsiteX4" fmla="*/ 379379 w 1726512"/>
                        <a:gd name="connsiteY4" fmla="*/ 954082 h 2671846"/>
                        <a:gd name="connsiteX5" fmla="*/ 298099 w 1726512"/>
                        <a:gd name="connsiteY5" fmla="*/ 1330002 h 2671846"/>
                        <a:gd name="connsiteX6" fmla="*/ 577725 w 1726512"/>
                        <a:gd name="connsiteY6" fmla="*/ 1308839 h 2671846"/>
                        <a:gd name="connsiteX7" fmla="*/ 785779 w 1726512"/>
                        <a:gd name="connsiteY7" fmla="*/ 1299522 h 2671846"/>
                        <a:gd name="connsiteX8" fmla="*/ 1039779 w 1726512"/>
                        <a:gd name="connsiteY8" fmla="*/ 1238562 h 2671846"/>
                        <a:gd name="connsiteX9" fmla="*/ 1192179 w 1726512"/>
                        <a:gd name="connsiteY9" fmla="*/ 1136962 h 2671846"/>
                        <a:gd name="connsiteX10" fmla="*/ 1283619 w 1726512"/>
                        <a:gd name="connsiteY10" fmla="*/ 1004882 h 2671846"/>
                        <a:gd name="connsiteX11" fmla="*/ 1306392 w 1726512"/>
                        <a:gd name="connsiteY11" fmla="*/ 953917 h 2671846"/>
                        <a:gd name="connsiteX12" fmla="*/ 1226412 w 1726512"/>
                        <a:gd name="connsiteY12" fmla="*/ 1123422 h 2671846"/>
                        <a:gd name="connsiteX13" fmla="*/ 1070259 w 1726512"/>
                        <a:gd name="connsiteY13" fmla="*/ 1250417 h 2671846"/>
                        <a:gd name="connsiteX14" fmla="*/ 810953 w 1726512"/>
                        <a:gd name="connsiteY14" fmla="*/ 1314767 h 2671846"/>
                        <a:gd name="connsiteX15" fmla="*/ 247299 w 1726512"/>
                        <a:gd name="connsiteY15" fmla="*/ 1401122 h 2671846"/>
                        <a:gd name="connsiteX16" fmla="*/ 84739 w 1726512"/>
                        <a:gd name="connsiteY16" fmla="*/ 1919282 h 2671846"/>
                        <a:gd name="connsiteX17" fmla="*/ 22679 w 1726512"/>
                        <a:gd name="connsiteY17" fmla="*/ 2323987 h 2671846"/>
                        <a:gd name="connsiteX18" fmla="*/ 9412 w 1726512"/>
                        <a:gd name="connsiteY18" fmla="*/ 2467922 h 2671846"/>
                        <a:gd name="connsiteX19" fmla="*/ 24685 w 1726512"/>
                        <a:gd name="connsiteY19" fmla="*/ 2653340 h 2671846"/>
                        <a:gd name="connsiteX20" fmla="*/ 277779 w 1726512"/>
                        <a:gd name="connsiteY20" fmla="*/ 2665014 h 2671846"/>
                        <a:gd name="connsiteX21" fmla="*/ 622861 w 1726512"/>
                        <a:gd name="connsiteY21" fmla="*/ 2651175 h 2671846"/>
                        <a:gd name="connsiteX22" fmla="*/ 885229 w 1726512"/>
                        <a:gd name="connsiteY22" fmla="*/ 2613018 h 2671846"/>
                        <a:gd name="connsiteX23" fmla="*/ 1184064 w 1726512"/>
                        <a:gd name="connsiteY23" fmla="*/ 2484750 h 2671846"/>
                        <a:gd name="connsiteX24" fmla="*/ 1334419 w 1726512"/>
                        <a:gd name="connsiteY24" fmla="*/ 2254562 h 2671846"/>
                        <a:gd name="connsiteX25" fmla="*/ 1415699 w 1726512"/>
                        <a:gd name="connsiteY25" fmla="*/ 1959922 h 2671846"/>
                        <a:gd name="connsiteX26" fmla="*/ 1425859 w 1726512"/>
                        <a:gd name="connsiteY26" fmla="*/ 1573842 h 2671846"/>
                        <a:gd name="connsiteX27" fmla="*/ 1407092 w 1726512"/>
                        <a:gd name="connsiteY27" fmla="*/ 1238562 h 2671846"/>
                        <a:gd name="connsiteX28" fmla="*/ 1415699 w 1726512"/>
                        <a:gd name="connsiteY28" fmla="*/ 1086162 h 2671846"/>
                        <a:gd name="connsiteX29" fmla="*/ 1679859 w 1726512"/>
                        <a:gd name="connsiteY29" fmla="*/ 1025202 h 2671846"/>
                        <a:gd name="connsiteX30" fmla="*/ 1700179 w 1726512"/>
                        <a:gd name="connsiteY30" fmla="*/ 913442 h 2671846"/>
                        <a:gd name="connsiteX31" fmla="*/ 1527459 w 1726512"/>
                        <a:gd name="connsiteY31" fmla="*/ 923602 h 2671846"/>
                        <a:gd name="connsiteX32" fmla="*/ 1415699 w 1726512"/>
                        <a:gd name="connsiteY32" fmla="*/ 954082 h 2671846"/>
                        <a:gd name="connsiteX33" fmla="*/ 1415699 w 1726512"/>
                        <a:gd name="connsiteY33" fmla="*/ 893122 h 2671846"/>
                        <a:gd name="connsiteX34" fmla="*/ 1415699 w 1726512"/>
                        <a:gd name="connsiteY34" fmla="*/ 913442 h 2671846"/>
                        <a:gd name="connsiteX35" fmla="*/ 1537619 w 1726512"/>
                        <a:gd name="connsiteY35" fmla="*/ 882962 h 2671846"/>
                        <a:gd name="connsiteX36" fmla="*/ 1591036 w 1726512"/>
                        <a:gd name="connsiteY36" fmla="*/ 844695 h 2671846"/>
                        <a:gd name="connsiteX37" fmla="*/ 1638735 w 1726512"/>
                        <a:gd name="connsiteY37" fmla="*/ 773837 h 2671846"/>
                        <a:gd name="connsiteX38" fmla="*/ 1686740 w 1726512"/>
                        <a:gd name="connsiteY38" fmla="*/ 705445 h 2671846"/>
                        <a:gd name="connsiteX39" fmla="*/ 1724135 w 1726512"/>
                        <a:gd name="connsiteY39" fmla="*/ 635372 h 2671846"/>
                        <a:gd name="connsiteX40" fmla="*/ 1616206 w 1726512"/>
                        <a:gd name="connsiteY40" fmla="*/ 516790 h 2671846"/>
                        <a:gd name="connsiteX41" fmla="*/ 1576633 w 1726512"/>
                        <a:gd name="connsiteY41" fmla="*/ 548306 h 2671846"/>
                        <a:gd name="connsiteX42" fmla="*/ 1531452 w 1726512"/>
                        <a:gd name="connsiteY42" fmla="*/ 675267 h 2671846"/>
                        <a:gd name="connsiteX43" fmla="*/ 1415699 w 1726512"/>
                        <a:gd name="connsiteY43" fmla="*/ 750882 h 2671846"/>
                        <a:gd name="connsiteX0" fmla="*/ 1415699 w 1726512"/>
                        <a:gd name="connsiteY0" fmla="*/ 750882 h 2671846"/>
                        <a:gd name="connsiteX1" fmla="*/ 1273459 w 1726512"/>
                        <a:gd name="connsiteY1" fmla="*/ 192082 h 2671846"/>
                        <a:gd name="connsiteX2" fmla="*/ 907699 w 1726512"/>
                        <a:gd name="connsiteY2" fmla="*/ 9202 h 2671846"/>
                        <a:gd name="connsiteX3" fmla="*/ 562259 w 1726512"/>
                        <a:gd name="connsiteY3" fmla="*/ 435922 h 2671846"/>
                        <a:gd name="connsiteX4" fmla="*/ 379379 w 1726512"/>
                        <a:gd name="connsiteY4" fmla="*/ 954082 h 2671846"/>
                        <a:gd name="connsiteX5" fmla="*/ 298099 w 1726512"/>
                        <a:gd name="connsiteY5" fmla="*/ 1330002 h 2671846"/>
                        <a:gd name="connsiteX6" fmla="*/ 577725 w 1726512"/>
                        <a:gd name="connsiteY6" fmla="*/ 1308839 h 2671846"/>
                        <a:gd name="connsiteX7" fmla="*/ 785779 w 1726512"/>
                        <a:gd name="connsiteY7" fmla="*/ 1299522 h 2671846"/>
                        <a:gd name="connsiteX8" fmla="*/ 1039779 w 1726512"/>
                        <a:gd name="connsiteY8" fmla="*/ 1238562 h 2671846"/>
                        <a:gd name="connsiteX9" fmla="*/ 1192179 w 1726512"/>
                        <a:gd name="connsiteY9" fmla="*/ 1136962 h 2671846"/>
                        <a:gd name="connsiteX10" fmla="*/ 1283619 w 1726512"/>
                        <a:gd name="connsiteY10" fmla="*/ 1004882 h 2671846"/>
                        <a:gd name="connsiteX11" fmla="*/ 1306392 w 1726512"/>
                        <a:gd name="connsiteY11" fmla="*/ 953917 h 2671846"/>
                        <a:gd name="connsiteX12" fmla="*/ 1226412 w 1726512"/>
                        <a:gd name="connsiteY12" fmla="*/ 1123422 h 2671846"/>
                        <a:gd name="connsiteX13" fmla="*/ 1070259 w 1726512"/>
                        <a:gd name="connsiteY13" fmla="*/ 1250417 h 2671846"/>
                        <a:gd name="connsiteX14" fmla="*/ 810953 w 1726512"/>
                        <a:gd name="connsiteY14" fmla="*/ 1314767 h 2671846"/>
                        <a:gd name="connsiteX15" fmla="*/ 247299 w 1726512"/>
                        <a:gd name="connsiteY15" fmla="*/ 1401122 h 2671846"/>
                        <a:gd name="connsiteX16" fmla="*/ 84739 w 1726512"/>
                        <a:gd name="connsiteY16" fmla="*/ 1919282 h 2671846"/>
                        <a:gd name="connsiteX17" fmla="*/ 22679 w 1726512"/>
                        <a:gd name="connsiteY17" fmla="*/ 2323987 h 2671846"/>
                        <a:gd name="connsiteX18" fmla="*/ 9412 w 1726512"/>
                        <a:gd name="connsiteY18" fmla="*/ 2467922 h 2671846"/>
                        <a:gd name="connsiteX19" fmla="*/ 24685 w 1726512"/>
                        <a:gd name="connsiteY19" fmla="*/ 2653340 h 2671846"/>
                        <a:gd name="connsiteX20" fmla="*/ 277779 w 1726512"/>
                        <a:gd name="connsiteY20" fmla="*/ 2665014 h 2671846"/>
                        <a:gd name="connsiteX21" fmla="*/ 622861 w 1726512"/>
                        <a:gd name="connsiteY21" fmla="*/ 2651175 h 2671846"/>
                        <a:gd name="connsiteX22" fmla="*/ 885229 w 1726512"/>
                        <a:gd name="connsiteY22" fmla="*/ 2613018 h 2671846"/>
                        <a:gd name="connsiteX23" fmla="*/ 1184064 w 1726512"/>
                        <a:gd name="connsiteY23" fmla="*/ 2484750 h 2671846"/>
                        <a:gd name="connsiteX24" fmla="*/ 1334419 w 1726512"/>
                        <a:gd name="connsiteY24" fmla="*/ 2254562 h 2671846"/>
                        <a:gd name="connsiteX25" fmla="*/ 1415699 w 1726512"/>
                        <a:gd name="connsiteY25" fmla="*/ 1959922 h 2671846"/>
                        <a:gd name="connsiteX26" fmla="*/ 1425859 w 1726512"/>
                        <a:gd name="connsiteY26" fmla="*/ 1573842 h 2671846"/>
                        <a:gd name="connsiteX27" fmla="*/ 1407092 w 1726512"/>
                        <a:gd name="connsiteY27" fmla="*/ 1238562 h 2671846"/>
                        <a:gd name="connsiteX28" fmla="*/ 1415699 w 1726512"/>
                        <a:gd name="connsiteY28" fmla="*/ 1086162 h 2671846"/>
                        <a:gd name="connsiteX29" fmla="*/ 1679859 w 1726512"/>
                        <a:gd name="connsiteY29" fmla="*/ 1025202 h 2671846"/>
                        <a:gd name="connsiteX30" fmla="*/ 1700179 w 1726512"/>
                        <a:gd name="connsiteY30" fmla="*/ 913442 h 2671846"/>
                        <a:gd name="connsiteX31" fmla="*/ 1527459 w 1726512"/>
                        <a:gd name="connsiteY31" fmla="*/ 923602 h 2671846"/>
                        <a:gd name="connsiteX32" fmla="*/ 1415699 w 1726512"/>
                        <a:gd name="connsiteY32" fmla="*/ 954082 h 2671846"/>
                        <a:gd name="connsiteX33" fmla="*/ 1415699 w 1726512"/>
                        <a:gd name="connsiteY33" fmla="*/ 893122 h 2671846"/>
                        <a:gd name="connsiteX34" fmla="*/ 1415699 w 1726512"/>
                        <a:gd name="connsiteY34" fmla="*/ 913442 h 2671846"/>
                        <a:gd name="connsiteX35" fmla="*/ 1537619 w 1726512"/>
                        <a:gd name="connsiteY35" fmla="*/ 882962 h 2671846"/>
                        <a:gd name="connsiteX36" fmla="*/ 1591036 w 1726512"/>
                        <a:gd name="connsiteY36" fmla="*/ 844695 h 2671846"/>
                        <a:gd name="connsiteX37" fmla="*/ 1638735 w 1726512"/>
                        <a:gd name="connsiteY37" fmla="*/ 773837 h 2671846"/>
                        <a:gd name="connsiteX38" fmla="*/ 1686740 w 1726512"/>
                        <a:gd name="connsiteY38" fmla="*/ 705445 h 2671846"/>
                        <a:gd name="connsiteX39" fmla="*/ 1724135 w 1726512"/>
                        <a:gd name="connsiteY39" fmla="*/ 635372 h 2671846"/>
                        <a:gd name="connsiteX40" fmla="*/ 1616206 w 1726512"/>
                        <a:gd name="connsiteY40" fmla="*/ 516790 h 2671846"/>
                        <a:gd name="connsiteX41" fmla="*/ 1576633 w 1726512"/>
                        <a:gd name="connsiteY41" fmla="*/ 548306 h 2671846"/>
                        <a:gd name="connsiteX42" fmla="*/ 1512814 w 1726512"/>
                        <a:gd name="connsiteY42" fmla="*/ 702412 h 2671846"/>
                        <a:gd name="connsiteX43" fmla="*/ 1415699 w 1726512"/>
                        <a:gd name="connsiteY43" fmla="*/ 750882 h 2671846"/>
                        <a:gd name="connsiteX0" fmla="*/ 1415699 w 1726512"/>
                        <a:gd name="connsiteY0" fmla="*/ 750882 h 2671846"/>
                        <a:gd name="connsiteX1" fmla="*/ 1273459 w 1726512"/>
                        <a:gd name="connsiteY1" fmla="*/ 192082 h 2671846"/>
                        <a:gd name="connsiteX2" fmla="*/ 907699 w 1726512"/>
                        <a:gd name="connsiteY2" fmla="*/ 9202 h 2671846"/>
                        <a:gd name="connsiteX3" fmla="*/ 562259 w 1726512"/>
                        <a:gd name="connsiteY3" fmla="*/ 435922 h 2671846"/>
                        <a:gd name="connsiteX4" fmla="*/ 379379 w 1726512"/>
                        <a:gd name="connsiteY4" fmla="*/ 954082 h 2671846"/>
                        <a:gd name="connsiteX5" fmla="*/ 298099 w 1726512"/>
                        <a:gd name="connsiteY5" fmla="*/ 1330002 h 2671846"/>
                        <a:gd name="connsiteX6" fmla="*/ 577725 w 1726512"/>
                        <a:gd name="connsiteY6" fmla="*/ 1308839 h 2671846"/>
                        <a:gd name="connsiteX7" fmla="*/ 785779 w 1726512"/>
                        <a:gd name="connsiteY7" fmla="*/ 1299522 h 2671846"/>
                        <a:gd name="connsiteX8" fmla="*/ 1039779 w 1726512"/>
                        <a:gd name="connsiteY8" fmla="*/ 1238562 h 2671846"/>
                        <a:gd name="connsiteX9" fmla="*/ 1192179 w 1726512"/>
                        <a:gd name="connsiteY9" fmla="*/ 1136962 h 2671846"/>
                        <a:gd name="connsiteX10" fmla="*/ 1283619 w 1726512"/>
                        <a:gd name="connsiteY10" fmla="*/ 1004882 h 2671846"/>
                        <a:gd name="connsiteX11" fmla="*/ 1306392 w 1726512"/>
                        <a:gd name="connsiteY11" fmla="*/ 953917 h 2671846"/>
                        <a:gd name="connsiteX12" fmla="*/ 1226412 w 1726512"/>
                        <a:gd name="connsiteY12" fmla="*/ 1123422 h 2671846"/>
                        <a:gd name="connsiteX13" fmla="*/ 1070259 w 1726512"/>
                        <a:gd name="connsiteY13" fmla="*/ 1250417 h 2671846"/>
                        <a:gd name="connsiteX14" fmla="*/ 810953 w 1726512"/>
                        <a:gd name="connsiteY14" fmla="*/ 1314767 h 2671846"/>
                        <a:gd name="connsiteX15" fmla="*/ 247299 w 1726512"/>
                        <a:gd name="connsiteY15" fmla="*/ 1401122 h 2671846"/>
                        <a:gd name="connsiteX16" fmla="*/ 84739 w 1726512"/>
                        <a:gd name="connsiteY16" fmla="*/ 1919282 h 2671846"/>
                        <a:gd name="connsiteX17" fmla="*/ 22679 w 1726512"/>
                        <a:gd name="connsiteY17" fmla="*/ 2323987 h 2671846"/>
                        <a:gd name="connsiteX18" fmla="*/ 9412 w 1726512"/>
                        <a:gd name="connsiteY18" fmla="*/ 2467922 h 2671846"/>
                        <a:gd name="connsiteX19" fmla="*/ 24685 w 1726512"/>
                        <a:gd name="connsiteY19" fmla="*/ 2653340 h 2671846"/>
                        <a:gd name="connsiteX20" fmla="*/ 277779 w 1726512"/>
                        <a:gd name="connsiteY20" fmla="*/ 2665014 h 2671846"/>
                        <a:gd name="connsiteX21" fmla="*/ 622861 w 1726512"/>
                        <a:gd name="connsiteY21" fmla="*/ 2651175 h 2671846"/>
                        <a:gd name="connsiteX22" fmla="*/ 885229 w 1726512"/>
                        <a:gd name="connsiteY22" fmla="*/ 2613018 h 2671846"/>
                        <a:gd name="connsiteX23" fmla="*/ 1184064 w 1726512"/>
                        <a:gd name="connsiteY23" fmla="*/ 2484750 h 2671846"/>
                        <a:gd name="connsiteX24" fmla="*/ 1334419 w 1726512"/>
                        <a:gd name="connsiteY24" fmla="*/ 2254562 h 2671846"/>
                        <a:gd name="connsiteX25" fmla="*/ 1415699 w 1726512"/>
                        <a:gd name="connsiteY25" fmla="*/ 1959922 h 2671846"/>
                        <a:gd name="connsiteX26" fmla="*/ 1425859 w 1726512"/>
                        <a:gd name="connsiteY26" fmla="*/ 1573842 h 2671846"/>
                        <a:gd name="connsiteX27" fmla="*/ 1407092 w 1726512"/>
                        <a:gd name="connsiteY27" fmla="*/ 1238562 h 2671846"/>
                        <a:gd name="connsiteX28" fmla="*/ 1415699 w 1726512"/>
                        <a:gd name="connsiteY28" fmla="*/ 1086162 h 2671846"/>
                        <a:gd name="connsiteX29" fmla="*/ 1679859 w 1726512"/>
                        <a:gd name="connsiteY29" fmla="*/ 1025202 h 2671846"/>
                        <a:gd name="connsiteX30" fmla="*/ 1700179 w 1726512"/>
                        <a:gd name="connsiteY30" fmla="*/ 913442 h 2671846"/>
                        <a:gd name="connsiteX31" fmla="*/ 1527459 w 1726512"/>
                        <a:gd name="connsiteY31" fmla="*/ 923602 h 2671846"/>
                        <a:gd name="connsiteX32" fmla="*/ 1415699 w 1726512"/>
                        <a:gd name="connsiteY32" fmla="*/ 954082 h 2671846"/>
                        <a:gd name="connsiteX33" fmla="*/ 1415699 w 1726512"/>
                        <a:gd name="connsiteY33" fmla="*/ 893122 h 2671846"/>
                        <a:gd name="connsiteX34" fmla="*/ 1415699 w 1726512"/>
                        <a:gd name="connsiteY34" fmla="*/ 913442 h 2671846"/>
                        <a:gd name="connsiteX35" fmla="*/ 1537619 w 1726512"/>
                        <a:gd name="connsiteY35" fmla="*/ 882962 h 2671846"/>
                        <a:gd name="connsiteX36" fmla="*/ 1591036 w 1726512"/>
                        <a:gd name="connsiteY36" fmla="*/ 844695 h 2671846"/>
                        <a:gd name="connsiteX37" fmla="*/ 1638735 w 1726512"/>
                        <a:gd name="connsiteY37" fmla="*/ 773837 h 2671846"/>
                        <a:gd name="connsiteX38" fmla="*/ 1686740 w 1726512"/>
                        <a:gd name="connsiteY38" fmla="*/ 705445 h 2671846"/>
                        <a:gd name="connsiteX39" fmla="*/ 1724135 w 1726512"/>
                        <a:gd name="connsiteY39" fmla="*/ 635372 h 2671846"/>
                        <a:gd name="connsiteX40" fmla="*/ 1616206 w 1726512"/>
                        <a:gd name="connsiteY40" fmla="*/ 516790 h 2671846"/>
                        <a:gd name="connsiteX41" fmla="*/ 1550008 w 1726512"/>
                        <a:gd name="connsiteY41" fmla="*/ 641375 h 2671846"/>
                        <a:gd name="connsiteX42" fmla="*/ 1512814 w 1726512"/>
                        <a:gd name="connsiteY42" fmla="*/ 702412 h 2671846"/>
                        <a:gd name="connsiteX43" fmla="*/ 1415699 w 1726512"/>
                        <a:gd name="connsiteY43" fmla="*/ 750882 h 2671846"/>
                        <a:gd name="connsiteX0" fmla="*/ 1415699 w 1727079"/>
                        <a:gd name="connsiteY0" fmla="*/ 750882 h 2671846"/>
                        <a:gd name="connsiteX1" fmla="*/ 1273459 w 1727079"/>
                        <a:gd name="connsiteY1" fmla="*/ 192082 h 2671846"/>
                        <a:gd name="connsiteX2" fmla="*/ 907699 w 1727079"/>
                        <a:gd name="connsiteY2" fmla="*/ 9202 h 2671846"/>
                        <a:gd name="connsiteX3" fmla="*/ 562259 w 1727079"/>
                        <a:gd name="connsiteY3" fmla="*/ 435922 h 2671846"/>
                        <a:gd name="connsiteX4" fmla="*/ 379379 w 1727079"/>
                        <a:gd name="connsiteY4" fmla="*/ 954082 h 2671846"/>
                        <a:gd name="connsiteX5" fmla="*/ 298099 w 1727079"/>
                        <a:gd name="connsiteY5" fmla="*/ 1330002 h 2671846"/>
                        <a:gd name="connsiteX6" fmla="*/ 577725 w 1727079"/>
                        <a:gd name="connsiteY6" fmla="*/ 1308839 h 2671846"/>
                        <a:gd name="connsiteX7" fmla="*/ 785779 w 1727079"/>
                        <a:gd name="connsiteY7" fmla="*/ 1299522 h 2671846"/>
                        <a:gd name="connsiteX8" fmla="*/ 1039779 w 1727079"/>
                        <a:gd name="connsiteY8" fmla="*/ 1238562 h 2671846"/>
                        <a:gd name="connsiteX9" fmla="*/ 1192179 w 1727079"/>
                        <a:gd name="connsiteY9" fmla="*/ 1136962 h 2671846"/>
                        <a:gd name="connsiteX10" fmla="*/ 1283619 w 1727079"/>
                        <a:gd name="connsiteY10" fmla="*/ 1004882 h 2671846"/>
                        <a:gd name="connsiteX11" fmla="*/ 1306392 w 1727079"/>
                        <a:gd name="connsiteY11" fmla="*/ 953917 h 2671846"/>
                        <a:gd name="connsiteX12" fmla="*/ 1226412 w 1727079"/>
                        <a:gd name="connsiteY12" fmla="*/ 1123422 h 2671846"/>
                        <a:gd name="connsiteX13" fmla="*/ 1070259 w 1727079"/>
                        <a:gd name="connsiteY13" fmla="*/ 1250417 h 2671846"/>
                        <a:gd name="connsiteX14" fmla="*/ 810953 w 1727079"/>
                        <a:gd name="connsiteY14" fmla="*/ 1314767 h 2671846"/>
                        <a:gd name="connsiteX15" fmla="*/ 247299 w 1727079"/>
                        <a:gd name="connsiteY15" fmla="*/ 1401122 h 2671846"/>
                        <a:gd name="connsiteX16" fmla="*/ 84739 w 1727079"/>
                        <a:gd name="connsiteY16" fmla="*/ 1919282 h 2671846"/>
                        <a:gd name="connsiteX17" fmla="*/ 22679 w 1727079"/>
                        <a:gd name="connsiteY17" fmla="*/ 2323987 h 2671846"/>
                        <a:gd name="connsiteX18" fmla="*/ 9412 w 1727079"/>
                        <a:gd name="connsiteY18" fmla="*/ 2467922 h 2671846"/>
                        <a:gd name="connsiteX19" fmla="*/ 24685 w 1727079"/>
                        <a:gd name="connsiteY19" fmla="*/ 2653340 h 2671846"/>
                        <a:gd name="connsiteX20" fmla="*/ 277779 w 1727079"/>
                        <a:gd name="connsiteY20" fmla="*/ 2665014 h 2671846"/>
                        <a:gd name="connsiteX21" fmla="*/ 622861 w 1727079"/>
                        <a:gd name="connsiteY21" fmla="*/ 2651175 h 2671846"/>
                        <a:gd name="connsiteX22" fmla="*/ 885229 w 1727079"/>
                        <a:gd name="connsiteY22" fmla="*/ 2613018 h 2671846"/>
                        <a:gd name="connsiteX23" fmla="*/ 1184064 w 1727079"/>
                        <a:gd name="connsiteY23" fmla="*/ 2484750 h 2671846"/>
                        <a:gd name="connsiteX24" fmla="*/ 1334419 w 1727079"/>
                        <a:gd name="connsiteY24" fmla="*/ 2254562 h 2671846"/>
                        <a:gd name="connsiteX25" fmla="*/ 1415699 w 1727079"/>
                        <a:gd name="connsiteY25" fmla="*/ 1959922 h 2671846"/>
                        <a:gd name="connsiteX26" fmla="*/ 1425859 w 1727079"/>
                        <a:gd name="connsiteY26" fmla="*/ 1573842 h 2671846"/>
                        <a:gd name="connsiteX27" fmla="*/ 1407092 w 1727079"/>
                        <a:gd name="connsiteY27" fmla="*/ 1238562 h 2671846"/>
                        <a:gd name="connsiteX28" fmla="*/ 1415699 w 1727079"/>
                        <a:gd name="connsiteY28" fmla="*/ 1086162 h 2671846"/>
                        <a:gd name="connsiteX29" fmla="*/ 1679859 w 1727079"/>
                        <a:gd name="connsiteY29" fmla="*/ 1025202 h 2671846"/>
                        <a:gd name="connsiteX30" fmla="*/ 1700179 w 1727079"/>
                        <a:gd name="connsiteY30" fmla="*/ 913442 h 2671846"/>
                        <a:gd name="connsiteX31" fmla="*/ 1527459 w 1727079"/>
                        <a:gd name="connsiteY31" fmla="*/ 923602 h 2671846"/>
                        <a:gd name="connsiteX32" fmla="*/ 1415699 w 1727079"/>
                        <a:gd name="connsiteY32" fmla="*/ 954082 h 2671846"/>
                        <a:gd name="connsiteX33" fmla="*/ 1415699 w 1727079"/>
                        <a:gd name="connsiteY33" fmla="*/ 893122 h 2671846"/>
                        <a:gd name="connsiteX34" fmla="*/ 1415699 w 1727079"/>
                        <a:gd name="connsiteY34" fmla="*/ 913442 h 2671846"/>
                        <a:gd name="connsiteX35" fmla="*/ 1537619 w 1727079"/>
                        <a:gd name="connsiteY35" fmla="*/ 882962 h 2671846"/>
                        <a:gd name="connsiteX36" fmla="*/ 1591036 w 1727079"/>
                        <a:gd name="connsiteY36" fmla="*/ 844695 h 2671846"/>
                        <a:gd name="connsiteX37" fmla="*/ 1638735 w 1727079"/>
                        <a:gd name="connsiteY37" fmla="*/ 773837 h 2671846"/>
                        <a:gd name="connsiteX38" fmla="*/ 1686740 w 1727079"/>
                        <a:gd name="connsiteY38" fmla="*/ 705445 h 2671846"/>
                        <a:gd name="connsiteX39" fmla="*/ 1724135 w 1727079"/>
                        <a:gd name="connsiteY39" fmla="*/ 635372 h 2671846"/>
                        <a:gd name="connsiteX40" fmla="*/ 1605556 w 1727079"/>
                        <a:gd name="connsiteY40" fmla="*/ 567202 h 2671846"/>
                        <a:gd name="connsiteX41" fmla="*/ 1550008 w 1727079"/>
                        <a:gd name="connsiteY41" fmla="*/ 641375 h 2671846"/>
                        <a:gd name="connsiteX42" fmla="*/ 1512814 w 1727079"/>
                        <a:gd name="connsiteY42" fmla="*/ 702412 h 2671846"/>
                        <a:gd name="connsiteX43" fmla="*/ 1415699 w 1727079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38735 w 1717777"/>
                        <a:gd name="connsiteY37" fmla="*/ 773837 h 2671846"/>
                        <a:gd name="connsiteX38" fmla="*/ 1686740 w 1717777"/>
                        <a:gd name="connsiteY38" fmla="*/ 705445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550008 w 1717777"/>
                        <a:gd name="connsiteY41" fmla="*/ 641375 h 2671846"/>
                        <a:gd name="connsiteX42" fmla="*/ 1512814 w 1717777"/>
                        <a:gd name="connsiteY42" fmla="*/ 702412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38735 w 1717777"/>
                        <a:gd name="connsiteY37" fmla="*/ 773837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550008 w 1717777"/>
                        <a:gd name="connsiteY41" fmla="*/ 641375 h 2671846"/>
                        <a:gd name="connsiteX42" fmla="*/ 1512814 w 1717777"/>
                        <a:gd name="connsiteY42" fmla="*/ 702412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09447 w 1717777"/>
                        <a:gd name="connsiteY37" fmla="*/ 812616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550008 w 1717777"/>
                        <a:gd name="connsiteY41" fmla="*/ 641375 h 2671846"/>
                        <a:gd name="connsiteX42" fmla="*/ 1512814 w 1717777"/>
                        <a:gd name="connsiteY42" fmla="*/ 702412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09447 w 1717777"/>
                        <a:gd name="connsiteY37" fmla="*/ 812616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550008 w 1717777"/>
                        <a:gd name="connsiteY41" fmla="*/ 641375 h 2671846"/>
                        <a:gd name="connsiteX42" fmla="*/ 1518139 w 1717777"/>
                        <a:gd name="connsiteY42" fmla="*/ 702412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09447 w 1717777"/>
                        <a:gd name="connsiteY37" fmla="*/ 812616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550008 w 1717777"/>
                        <a:gd name="connsiteY41" fmla="*/ 641375 h 2671846"/>
                        <a:gd name="connsiteX42" fmla="*/ 1518139 w 1717777"/>
                        <a:gd name="connsiteY42" fmla="*/ 702412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09447 w 1717777"/>
                        <a:gd name="connsiteY37" fmla="*/ 812616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550008 w 1717777"/>
                        <a:gd name="connsiteY41" fmla="*/ 641375 h 2671846"/>
                        <a:gd name="connsiteX42" fmla="*/ 1518139 w 1717777"/>
                        <a:gd name="connsiteY42" fmla="*/ 702412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09447 w 1717777"/>
                        <a:gd name="connsiteY37" fmla="*/ 812616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550008 w 1717777"/>
                        <a:gd name="connsiteY41" fmla="*/ 641375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09447 w 1717777"/>
                        <a:gd name="connsiteY37" fmla="*/ 812616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05556 w 1717777"/>
                        <a:gd name="connsiteY40" fmla="*/ 567202 h 2671846"/>
                        <a:gd name="connsiteX41" fmla="*/ 1600596 w 1717777"/>
                        <a:gd name="connsiteY41" fmla="*/ 684032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91036 w 1717777"/>
                        <a:gd name="connsiteY36" fmla="*/ 844695 h 2671846"/>
                        <a:gd name="connsiteX37" fmla="*/ 1609447 w 1717777"/>
                        <a:gd name="connsiteY37" fmla="*/ 812616 h 2671846"/>
                        <a:gd name="connsiteX38" fmla="*/ 1668102 w 1717777"/>
                        <a:gd name="connsiteY38" fmla="*/ 709323 h 2671846"/>
                        <a:gd name="connsiteX39" fmla="*/ 1692185 w 1717777"/>
                        <a:gd name="connsiteY39" fmla="*/ 674151 h 2671846"/>
                        <a:gd name="connsiteX40" fmla="*/ 1642832 w 1717777"/>
                        <a:gd name="connsiteY40" fmla="*/ 679660 h 2671846"/>
                        <a:gd name="connsiteX41" fmla="*/ 1600596 w 1717777"/>
                        <a:gd name="connsiteY41" fmla="*/ 684032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35036"/>
                        <a:gd name="connsiteY0" fmla="*/ 750882 h 2671846"/>
                        <a:gd name="connsiteX1" fmla="*/ 1273459 w 1735036"/>
                        <a:gd name="connsiteY1" fmla="*/ 192082 h 2671846"/>
                        <a:gd name="connsiteX2" fmla="*/ 907699 w 1735036"/>
                        <a:gd name="connsiteY2" fmla="*/ 9202 h 2671846"/>
                        <a:gd name="connsiteX3" fmla="*/ 562259 w 1735036"/>
                        <a:gd name="connsiteY3" fmla="*/ 435922 h 2671846"/>
                        <a:gd name="connsiteX4" fmla="*/ 379379 w 1735036"/>
                        <a:gd name="connsiteY4" fmla="*/ 954082 h 2671846"/>
                        <a:gd name="connsiteX5" fmla="*/ 298099 w 1735036"/>
                        <a:gd name="connsiteY5" fmla="*/ 1330002 h 2671846"/>
                        <a:gd name="connsiteX6" fmla="*/ 577725 w 1735036"/>
                        <a:gd name="connsiteY6" fmla="*/ 1308839 h 2671846"/>
                        <a:gd name="connsiteX7" fmla="*/ 785779 w 1735036"/>
                        <a:gd name="connsiteY7" fmla="*/ 1299522 h 2671846"/>
                        <a:gd name="connsiteX8" fmla="*/ 1039779 w 1735036"/>
                        <a:gd name="connsiteY8" fmla="*/ 1238562 h 2671846"/>
                        <a:gd name="connsiteX9" fmla="*/ 1192179 w 1735036"/>
                        <a:gd name="connsiteY9" fmla="*/ 1136962 h 2671846"/>
                        <a:gd name="connsiteX10" fmla="*/ 1283619 w 1735036"/>
                        <a:gd name="connsiteY10" fmla="*/ 1004882 h 2671846"/>
                        <a:gd name="connsiteX11" fmla="*/ 1306392 w 1735036"/>
                        <a:gd name="connsiteY11" fmla="*/ 953917 h 2671846"/>
                        <a:gd name="connsiteX12" fmla="*/ 1226412 w 1735036"/>
                        <a:gd name="connsiteY12" fmla="*/ 1123422 h 2671846"/>
                        <a:gd name="connsiteX13" fmla="*/ 1070259 w 1735036"/>
                        <a:gd name="connsiteY13" fmla="*/ 1250417 h 2671846"/>
                        <a:gd name="connsiteX14" fmla="*/ 810953 w 1735036"/>
                        <a:gd name="connsiteY14" fmla="*/ 1314767 h 2671846"/>
                        <a:gd name="connsiteX15" fmla="*/ 247299 w 1735036"/>
                        <a:gd name="connsiteY15" fmla="*/ 1401122 h 2671846"/>
                        <a:gd name="connsiteX16" fmla="*/ 84739 w 1735036"/>
                        <a:gd name="connsiteY16" fmla="*/ 1919282 h 2671846"/>
                        <a:gd name="connsiteX17" fmla="*/ 22679 w 1735036"/>
                        <a:gd name="connsiteY17" fmla="*/ 2323987 h 2671846"/>
                        <a:gd name="connsiteX18" fmla="*/ 9412 w 1735036"/>
                        <a:gd name="connsiteY18" fmla="*/ 2467922 h 2671846"/>
                        <a:gd name="connsiteX19" fmla="*/ 24685 w 1735036"/>
                        <a:gd name="connsiteY19" fmla="*/ 2653340 h 2671846"/>
                        <a:gd name="connsiteX20" fmla="*/ 277779 w 1735036"/>
                        <a:gd name="connsiteY20" fmla="*/ 2665014 h 2671846"/>
                        <a:gd name="connsiteX21" fmla="*/ 622861 w 1735036"/>
                        <a:gd name="connsiteY21" fmla="*/ 2651175 h 2671846"/>
                        <a:gd name="connsiteX22" fmla="*/ 885229 w 1735036"/>
                        <a:gd name="connsiteY22" fmla="*/ 2613018 h 2671846"/>
                        <a:gd name="connsiteX23" fmla="*/ 1184064 w 1735036"/>
                        <a:gd name="connsiteY23" fmla="*/ 2484750 h 2671846"/>
                        <a:gd name="connsiteX24" fmla="*/ 1334419 w 1735036"/>
                        <a:gd name="connsiteY24" fmla="*/ 2254562 h 2671846"/>
                        <a:gd name="connsiteX25" fmla="*/ 1415699 w 1735036"/>
                        <a:gd name="connsiteY25" fmla="*/ 1959922 h 2671846"/>
                        <a:gd name="connsiteX26" fmla="*/ 1425859 w 1735036"/>
                        <a:gd name="connsiteY26" fmla="*/ 1573842 h 2671846"/>
                        <a:gd name="connsiteX27" fmla="*/ 1407092 w 1735036"/>
                        <a:gd name="connsiteY27" fmla="*/ 1238562 h 2671846"/>
                        <a:gd name="connsiteX28" fmla="*/ 1415699 w 1735036"/>
                        <a:gd name="connsiteY28" fmla="*/ 1086162 h 2671846"/>
                        <a:gd name="connsiteX29" fmla="*/ 1679859 w 1735036"/>
                        <a:gd name="connsiteY29" fmla="*/ 1025202 h 2671846"/>
                        <a:gd name="connsiteX30" fmla="*/ 1700179 w 1735036"/>
                        <a:gd name="connsiteY30" fmla="*/ 913442 h 2671846"/>
                        <a:gd name="connsiteX31" fmla="*/ 1527459 w 1735036"/>
                        <a:gd name="connsiteY31" fmla="*/ 923602 h 2671846"/>
                        <a:gd name="connsiteX32" fmla="*/ 1415699 w 1735036"/>
                        <a:gd name="connsiteY32" fmla="*/ 954082 h 2671846"/>
                        <a:gd name="connsiteX33" fmla="*/ 1415699 w 1735036"/>
                        <a:gd name="connsiteY33" fmla="*/ 893122 h 2671846"/>
                        <a:gd name="connsiteX34" fmla="*/ 1415699 w 1735036"/>
                        <a:gd name="connsiteY34" fmla="*/ 913442 h 2671846"/>
                        <a:gd name="connsiteX35" fmla="*/ 1537619 w 1735036"/>
                        <a:gd name="connsiteY35" fmla="*/ 882962 h 2671846"/>
                        <a:gd name="connsiteX36" fmla="*/ 1591036 w 1735036"/>
                        <a:gd name="connsiteY36" fmla="*/ 844695 h 2671846"/>
                        <a:gd name="connsiteX37" fmla="*/ 1609447 w 1735036"/>
                        <a:gd name="connsiteY37" fmla="*/ 812616 h 2671846"/>
                        <a:gd name="connsiteX38" fmla="*/ 1668102 w 1735036"/>
                        <a:gd name="connsiteY38" fmla="*/ 709323 h 2671846"/>
                        <a:gd name="connsiteX39" fmla="*/ 1734786 w 1735036"/>
                        <a:gd name="connsiteY39" fmla="*/ 685785 h 2671846"/>
                        <a:gd name="connsiteX40" fmla="*/ 1642832 w 1735036"/>
                        <a:gd name="connsiteY40" fmla="*/ 679660 h 2671846"/>
                        <a:gd name="connsiteX41" fmla="*/ 1600596 w 1735036"/>
                        <a:gd name="connsiteY41" fmla="*/ 684032 h 2671846"/>
                        <a:gd name="connsiteX42" fmla="*/ 1504826 w 1735036"/>
                        <a:gd name="connsiteY42" fmla="*/ 741191 h 2671846"/>
                        <a:gd name="connsiteX43" fmla="*/ 1415699 w 1735036"/>
                        <a:gd name="connsiteY43" fmla="*/ 750882 h 2671846"/>
                        <a:gd name="connsiteX0" fmla="*/ 1415699 w 1735494"/>
                        <a:gd name="connsiteY0" fmla="*/ 750882 h 2671846"/>
                        <a:gd name="connsiteX1" fmla="*/ 1273459 w 1735494"/>
                        <a:gd name="connsiteY1" fmla="*/ 192082 h 2671846"/>
                        <a:gd name="connsiteX2" fmla="*/ 907699 w 1735494"/>
                        <a:gd name="connsiteY2" fmla="*/ 9202 h 2671846"/>
                        <a:gd name="connsiteX3" fmla="*/ 562259 w 1735494"/>
                        <a:gd name="connsiteY3" fmla="*/ 435922 h 2671846"/>
                        <a:gd name="connsiteX4" fmla="*/ 379379 w 1735494"/>
                        <a:gd name="connsiteY4" fmla="*/ 954082 h 2671846"/>
                        <a:gd name="connsiteX5" fmla="*/ 298099 w 1735494"/>
                        <a:gd name="connsiteY5" fmla="*/ 1330002 h 2671846"/>
                        <a:gd name="connsiteX6" fmla="*/ 577725 w 1735494"/>
                        <a:gd name="connsiteY6" fmla="*/ 1308839 h 2671846"/>
                        <a:gd name="connsiteX7" fmla="*/ 785779 w 1735494"/>
                        <a:gd name="connsiteY7" fmla="*/ 1299522 h 2671846"/>
                        <a:gd name="connsiteX8" fmla="*/ 1039779 w 1735494"/>
                        <a:gd name="connsiteY8" fmla="*/ 1238562 h 2671846"/>
                        <a:gd name="connsiteX9" fmla="*/ 1192179 w 1735494"/>
                        <a:gd name="connsiteY9" fmla="*/ 1136962 h 2671846"/>
                        <a:gd name="connsiteX10" fmla="*/ 1283619 w 1735494"/>
                        <a:gd name="connsiteY10" fmla="*/ 1004882 h 2671846"/>
                        <a:gd name="connsiteX11" fmla="*/ 1306392 w 1735494"/>
                        <a:gd name="connsiteY11" fmla="*/ 953917 h 2671846"/>
                        <a:gd name="connsiteX12" fmla="*/ 1226412 w 1735494"/>
                        <a:gd name="connsiteY12" fmla="*/ 1123422 h 2671846"/>
                        <a:gd name="connsiteX13" fmla="*/ 1070259 w 1735494"/>
                        <a:gd name="connsiteY13" fmla="*/ 1250417 h 2671846"/>
                        <a:gd name="connsiteX14" fmla="*/ 810953 w 1735494"/>
                        <a:gd name="connsiteY14" fmla="*/ 1314767 h 2671846"/>
                        <a:gd name="connsiteX15" fmla="*/ 247299 w 1735494"/>
                        <a:gd name="connsiteY15" fmla="*/ 1401122 h 2671846"/>
                        <a:gd name="connsiteX16" fmla="*/ 84739 w 1735494"/>
                        <a:gd name="connsiteY16" fmla="*/ 1919282 h 2671846"/>
                        <a:gd name="connsiteX17" fmla="*/ 22679 w 1735494"/>
                        <a:gd name="connsiteY17" fmla="*/ 2323987 h 2671846"/>
                        <a:gd name="connsiteX18" fmla="*/ 9412 w 1735494"/>
                        <a:gd name="connsiteY18" fmla="*/ 2467922 h 2671846"/>
                        <a:gd name="connsiteX19" fmla="*/ 24685 w 1735494"/>
                        <a:gd name="connsiteY19" fmla="*/ 2653340 h 2671846"/>
                        <a:gd name="connsiteX20" fmla="*/ 277779 w 1735494"/>
                        <a:gd name="connsiteY20" fmla="*/ 2665014 h 2671846"/>
                        <a:gd name="connsiteX21" fmla="*/ 622861 w 1735494"/>
                        <a:gd name="connsiteY21" fmla="*/ 2651175 h 2671846"/>
                        <a:gd name="connsiteX22" fmla="*/ 885229 w 1735494"/>
                        <a:gd name="connsiteY22" fmla="*/ 2613018 h 2671846"/>
                        <a:gd name="connsiteX23" fmla="*/ 1184064 w 1735494"/>
                        <a:gd name="connsiteY23" fmla="*/ 2484750 h 2671846"/>
                        <a:gd name="connsiteX24" fmla="*/ 1334419 w 1735494"/>
                        <a:gd name="connsiteY24" fmla="*/ 2254562 h 2671846"/>
                        <a:gd name="connsiteX25" fmla="*/ 1415699 w 1735494"/>
                        <a:gd name="connsiteY25" fmla="*/ 1959922 h 2671846"/>
                        <a:gd name="connsiteX26" fmla="*/ 1425859 w 1735494"/>
                        <a:gd name="connsiteY26" fmla="*/ 1573842 h 2671846"/>
                        <a:gd name="connsiteX27" fmla="*/ 1407092 w 1735494"/>
                        <a:gd name="connsiteY27" fmla="*/ 1238562 h 2671846"/>
                        <a:gd name="connsiteX28" fmla="*/ 1415699 w 1735494"/>
                        <a:gd name="connsiteY28" fmla="*/ 1086162 h 2671846"/>
                        <a:gd name="connsiteX29" fmla="*/ 1679859 w 1735494"/>
                        <a:gd name="connsiteY29" fmla="*/ 1025202 h 2671846"/>
                        <a:gd name="connsiteX30" fmla="*/ 1700179 w 1735494"/>
                        <a:gd name="connsiteY30" fmla="*/ 913442 h 2671846"/>
                        <a:gd name="connsiteX31" fmla="*/ 1527459 w 1735494"/>
                        <a:gd name="connsiteY31" fmla="*/ 923602 h 2671846"/>
                        <a:gd name="connsiteX32" fmla="*/ 1415699 w 1735494"/>
                        <a:gd name="connsiteY32" fmla="*/ 954082 h 2671846"/>
                        <a:gd name="connsiteX33" fmla="*/ 1415699 w 1735494"/>
                        <a:gd name="connsiteY33" fmla="*/ 893122 h 2671846"/>
                        <a:gd name="connsiteX34" fmla="*/ 1415699 w 1735494"/>
                        <a:gd name="connsiteY34" fmla="*/ 913442 h 2671846"/>
                        <a:gd name="connsiteX35" fmla="*/ 1537619 w 1735494"/>
                        <a:gd name="connsiteY35" fmla="*/ 882962 h 2671846"/>
                        <a:gd name="connsiteX36" fmla="*/ 1591036 w 1735494"/>
                        <a:gd name="connsiteY36" fmla="*/ 844695 h 2671846"/>
                        <a:gd name="connsiteX37" fmla="*/ 1609447 w 1735494"/>
                        <a:gd name="connsiteY37" fmla="*/ 812616 h 2671846"/>
                        <a:gd name="connsiteX38" fmla="*/ 1681415 w 1735494"/>
                        <a:gd name="connsiteY38" fmla="*/ 814025 h 2671846"/>
                        <a:gd name="connsiteX39" fmla="*/ 1734786 w 1735494"/>
                        <a:gd name="connsiteY39" fmla="*/ 685785 h 2671846"/>
                        <a:gd name="connsiteX40" fmla="*/ 1642832 w 1735494"/>
                        <a:gd name="connsiteY40" fmla="*/ 679660 h 2671846"/>
                        <a:gd name="connsiteX41" fmla="*/ 1600596 w 1735494"/>
                        <a:gd name="connsiteY41" fmla="*/ 684032 h 2671846"/>
                        <a:gd name="connsiteX42" fmla="*/ 1504826 w 1735494"/>
                        <a:gd name="connsiteY42" fmla="*/ 741191 h 2671846"/>
                        <a:gd name="connsiteX43" fmla="*/ 1415699 w 1735494"/>
                        <a:gd name="connsiteY43" fmla="*/ 750882 h 2671846"/>
                        <a:gd name="connsiteX0" fmla="*/ 1415699 w 1735494"/>
                        <a:gd name="connsiteY0" fmla="*/ 750882 h 2671846"/>
                        <a:gd name="connsiteX1" fmla="*/ 1273459 w 1735494"/>
                        <a:gd name="connsiteY1" fmla="*/ 192082 h 2671846"/>
                        <a:gd name="connsiteX2" fmla="*/ 907699 w 1735494"/>
                        <a:gd name="connsiteY2" fmla="*/ 9202 h 2671846"/>
                        <a:gd name="connsiteX3" fmla="*/ 562259 w 1735494"/>
                        <a:gd name="connsiteY3" fmla="*/ 435922 h 2671846"/>
                        <a:gd name="connsiteX4" fmla="*/ 379379 w 1735494"/>
                        <a:gd name="connsiteY4" fmla="*/ 954082 h 2671846"/>
                        <a:gd name="connsiteX5" fmla="*/ 298099 w 1735494"/>
                        <a:gd name="connsiteY5" fmla="*/ 1330002 h 2671846"/>
                        <a:gd name="connsiteX6" fmla="*/ 577725 w 1735494"/>
                        <a:gd name="connsiteY6" fmla="*/ 1308839 h 2671846"/>
                        <a:gd name="connsiteX7" fmla="*/ 785779 w 1735494"/>
                        <a:gd name="connsiteY7" fmla="*/ 1299522 h 2671846"/>
                        <a:gd name="connsiteX8" fmla="*/ 1039779 w 1735494"/>
                        <a:gd name="connsiteY8" fmla="*/ 1238562 h 2671846"/>
                        <a:gd name="connsiteX9" fmla="*/ 1192179 w 1735494"/>
                        <a:gd name="connsiteY9" fmla="*/ 1136962 h 2671846"/>
                        <a:gd name="connsiteX10" fmla="*/ 1283619 w 1735494"/>
                        <a:gd name="connsiteY10" fmla="*/ 1004882 h 2671846"/>
                        <a:gd name="connsiteX11" fmla="*/ 1306392 w 1735494"/>
                        <a:gd name="connsiteY11" fmla="*/ 953917 h 2671846"/>
                        <a:gd name="connsiteX12" fmla="*/ 1226412 w 1735494"/>
                        <a:gd name="connsiteY12" fmla="*/ 1123422 h 2671846"/>
                        <a:gd name="connsiteX13" fmla="*/ 1070259 w 1735494"/>
                        <a:gd name="connsiteY13" fmla="*/ 1250417 h 2671846"/>
                        <a:gd name="connsiteX14" fmla="*/ 810953 w 1735494"/>
                        <a:gd name="connsiteY14" fmla="*/ 1314767 h 2671846"/>
                        <a:gd name="connsiteX15" fmla="*/ 247299 w 1735494"/>
                        <a:gd name="connsiteY15" fmla="*/ 1401122 h 2671846"/>
                        <a:gd name="connsiteX16" fmla="*/ 84739 w 1735494"/>
                        <a:gd name="connsiteY16" fmla="*/ 1919282 h 2671846"/>
                        <a:gd name="connsiteX17" fmla="*/ 22679 w 1735494"/>
                        <a:gd name="connsiteY17" fmla="*/ 2323987 h 2671846"/>
                        <a:gd name="connsiteX18" fmla="*/ 9412 w 1735494"/>
                        <a:gd name="connsiteY18" fmla="*/ 2467922 h 2671846"/>
                        <a:gd name="connsiteX19" fmla="*/ 24685 w 1735494"/>
                        <a:gd name="connsiteY19" fmla="*/ 2653340 h 2671846"/>
                        <a:gd name="connsiteX20" fmla="*/ 277779 w 1735494"/>
                        <a:gd name="connsiteY20" fmla="*/ 2665014 h 2671846"/>
                        <a:gd name="connsiteX21" fmla="*/ 622861 w 1735494"/>
                        <a:gd name="connsiteY21" fmla="*/ 2651175 h 2671846"/>
                        <a:gd name="connsiteX22" fmla="*/ 885229 w 1735494"/>
                        <a:gd name="connsiteY22" fmla="*/ 2613018 h 2671846"/>
                        <a:gd name="connsiteX23" fmla="*/ 1184064 w 1735494"/>
                        <a:gd name="connsiteY23" fmla="*/ 2484750 h 2671846"/>
                        <a:gd name="connsiteX24" fmla="*/ 1334419 w 1735494"/>
                        <a:gd name="connsiteY24" fmla="*/ 2254562 h 2671846"/>
                        <a:gd name="connsiteX25" fmla="*/ 1415699 w 1735494"/>
                        <a:gd name="connsiteY25" fmla="*/ 1959922 h 2671846"/>
                        <a:gd name="connsiteX26" fmla="*/ 1425859 w 1735494"/>
                        <a:gd name="connsiteY26" fmla="*/ 1573842 h 2671846"/>
                        <a:gd name="connsiteX27" fmla="*/ 1407092 w 1735494"/>
                        <a:gd name="connsiteY27" fmla="*/ 1238562 h 2671846"/>
                        <a:gd name="connsiteX28" fmla="*/ 1415699 w 1735494"/>
                        <a:gd name="connsiteY28" fmla="*/ 1086162 h 2671846"/>
                        <a:gd name="connsiteX29" fmla="*/ 1679859 w 1735494"/>
                        <a:gd name="connsiteY29" fmla="*/ 1025202 h 2671846"/>
                        <a:gd name="connsiteX30" fmla="*/ 1700179 w 1735494"/>
                        <a:gd name="connsiteY30" fmla="*/ 913442 h 2671846"/>
                        <a:gd name="connsiteX31" fmla="*/ 1527459 w 1735494"/>
                        <a:gd name="connsiteY31" fmla="*/ 923602 h 2671846"/>
                        <a:gd name="connsiteX32" fmla="*/ 1415699 w 1735494"/>
                        <a:gd name="connsiteY32" fmla="*/ 954082 h 2671846"/>
                        <a:gd name="connsiteX33" fmla="*/ 1415699 w 1735494"/>
                        <a:gd name="connsiteY33" fmla="*/ 893122 h 2671846"/>
                        <a:gd name="connsiteX34" fmla="*/ 1415699 w 1735494"/>
                        <a:gd name="connsiteY34" fmla="*/ 913442 h 2671846"/>
                        <a:gd name="connsiteX35" fmla="*/ 1537619 w 1735494"/>
                        <a:gd name="connsiteY35" fmla="*/ 882962 h 2671846"/>
                        <a:gd name="connsiteX36" fmla="*/ 1591036 w 1735494"/>
                        <a:gd name="connsiteY36" fmla="*/ 844695 h 2671846"/>
                        <a:gd name="connsiteX37" fmla="*/ 1609447 w 1735494"/>
                        <a:gd name="connsiteY37" fmla="*/ 843639 h 2671846"/>
                        <a:gd name="connsiteX38" fmla="*/ 1681415 w 1735494"/>
                        <a:gd name="connsiteY38" fmla="*/ 814025 h 2671846"/>
                        <a:gd name="connsiteX39" fmla="*/ 1734786 w 1735494"/>
                        <a:gd name="connsiteY39" fmla="*/ 685785 h 2671846"/>
                        <a:gd name="connsiteX40" fmla="*/ 1642832 w 1735494"/>
                        <a:gd name="connsiteY40" fmla="*/ 679660 h 2671846"/>
                        <a:gd name="connsiteX41" fmla="*/ 1600596 w 1735494"/>
                        <a:gd name="connsiteY41" fmla="*/ 684032 h 2671846"/>
                        <a:gd name="connsiteX42" fmla="*/ 1504826 w 1735494"/>
                        <a:gd name="connsiteY42" fmla="*/ 741191 h 2671846"/>
                        <a:gd name="connsiteX43" fmla="*/ 1415699 w 1735494"/>
                        <a:gd name="connsiteY43" fmla="*/ 750882 h 2671846"/>
                        <a:gd name="connsiteX0" fmla="*/ 1415699 w 1735501"/>
                        <a:gd name="connsiteY0" fmla="*/ 750882 h 2671846"/>
                        <a:gd name="connsiteX1" fmla="*/ 1273459 w 1735501"/>
                        <a:gd name="connsiteY1" fmla="*/ 192082 h 2671846"/>
                        <a:gd name="connsiteX2" fmla="*/ 907699 w 1735501"/>
                        <a:gd name="connsiteY2" fmla="*/ 9202 h 2671846"/>
                        <a:gd name="connsiteX3" fmla="*/ 562259 w 1735501"/>
                        <a:gd name="connsiteY3" fmla="*/ 435922 h 2671846"/>
                        <a:gd name="connsiteX4" fmla="*/ 379379 w 1735501"/>
                        <a:gd name="connsiteY4" fmla="*/ 954082 h 2671846"/>
                        <a:gd name="connsiteX5" fmla="*/ 298099 w 1735501"/>
                        <a:gd name="connsiteY5" fmla="*/ 1330002 h 2671846"/>
                        <a:gd name="connsiteX6" fmla="*/ 577725 w 1735501"/>
                        <a:gd name="connsiteY6" fmla="*/ 1308839 h 2671846"/>
                        <a:gd name="connsiteX7" fmla="*/ 785779 w 1735501"/>
                        <a:gd name="connsiteY7" fmla="*/ 1299522 h 2671846"/>
                        <a:gd name="connsiteX8" fmla="*/ 1039779 w 1735501"/>
                        <a:gd name="connsiteY8" fmla="*/ 1238562 h 2671846"/>
                        <a:gd name="connsiteX9" fmla="*/ 1192179 w 1735501"/>
                        <a:gd name="connsiteY9" fmla="*/ 1136962 h 2671846"/>
                        <a:gd name="connsiteX10" fmla="*/ 1283619 w 1735501"/>
                        <a:gd name="connsiteY10" fmla="*/ 1004882 h 2671846"/>
                        <a:gd name="connsiteX11" fmla="*/ 1306392 w 1735501"/>
                        <a:gd name="connsiteY11" fmla="*/ 953917 h 2671846"/>
                        <a:gd name="connsiteX12" fmla="*/ 1226412 w 1735501"/>
                        <a:gd name="connsiteY12" fmla="*/ 1123422 h 2671846"/>
                        <a:gd name="connsiteX13" fmla="*/ 1070259 w 1735501"/>
                        <a:gd name="connsiteY13" fmla="*/ 1250417 h 2671846"/>
                        <a:gd name="connsiteX14" fmla="*/ 810953 w 1735501"/>
                        <a:gd name="connsiteY14" fmla="*/ 1314767 h 2671846"/>
                        <a:gd name="connsiteX15" fmla="*/ 247299 w 1735501"/>
                        <a:gd name="connsiteY15" fmla="*/ 1401122 h 2671846"/>
                        <a:gd name="connsiteX16" fmla="*/ 84739 w 1735501"/>
                        <a:gd name="connsiteY16" fmla="*/ 1919282 h 2671846"/>
                        <a:gd name="connsiteX17" fmla="*/ 22679 w 1735501"/>
                        <a:gd name="connsiteY17" fmla="*/ 2323987 h 2671846"/>
                        <a:gd name="connsiteX18" fmla="*/ 9412 w 1735501"/>
                        <a:gd name="connsiteY18" fmla="*/ 2467922 h 2671846"/>
                        <a:gd name="connsiteX19" fmla="*/ 24685 w 1735501"/>
                        <a:gd name="connsiteY19" fmla="*/ 2653340 h 2671846"/>
                        <a:gd name="connsiteX20" fmla="*/ 277779 w 1735501"/>
                        <a:gd name="connsiteY20" fmla="*/ 2665014 h 2671846"/>
                        <a:gd name="connsiteX21" fmla="*/ 622861 w 1735501"/>
                        <a:gd name="connsiteY21" fmla="*/ 2651175 h 2671846"/>
                        <a:gd name="connsiteX22" fmla="*/ 885229 w 1735501"/>
                        <a:gd name="connsiteY22" fmla="*/ 2613018 h 2671846"/>
                        <a:gd name="connsiteX23" fmla="*/ 1184064 w 1735501"/>
                        <a:gd name="connsiteY23" fmla="*/ 2484750 h 2671846"/>
                        <a:gd name="connsiteX24" fmla="*/ 1334419 w 1735501"/>
                        <a:gd name="connsiteY24" fmla="*/ 2254562 h 2671846"/>
                        <a:gd name="connsiteX25" fmla="*/ 1415699 w 1735501"/>
                        <a:gd name="connsiteY25" fmla="*/ 1959922 h 2671846"/>
                        <a:gd name="connsiteX26" fmla="*/ 1425859 w 1735501"/>
                        <a:gd name="connsiteY26" fmla="*/ 1573842 h 2671846"/>
                        <a:gd name="connsiteX27" fmla="*/ 1407092 w 1735501"/>
                        <a:gd name="connsiteY27" fmla="*/ 1238562 h 2671846"/>
                        <a:gd name="connsiteX28" fmla="*/ 1415699 w 1735501"/>
                        <a:gd name="connsiteY28" fmla="*/ 1086162 h 2671846"/>
                        <a:gd name="connsiteX29" fmla="*/ 1679859 w 1735501"/>
                        <a:gd name="connsiteY29" fmla="*/ 1025202 h 2671846"/>
                        <a:gd name="connsiteX30" fmla="*/ 1700179 w 1735501"/>
                        <a:gd name="connsiteY30" fmla="*/ 913442 h 2671846"/>
                        <a:gd name="connsiteX31" fmla="*/ 1527459 w 1735501"/>
                        <a:gd name="connsiteY31" fmla="*/ 923602 h 2671846"/>
                        <a:gd name="connsiteX32" fmla="*/ 1415699 w 1735501"/>
                        <a:gd name="connsiteY32" fmla="*/ 954082 h 2671846"/>
                        <a:gd name="connsiteX33" fmla="*/ 1415699 w 1735501"/>
                        <a:gd name="connsiteY33" fmla="*/ 893122 h 2671846"/>
                        <a:gd name="connsiteX34" fmla="*/ 1415699 w 1735501"/>
                        <a:gd name="connsiteY34" fmla="*/ 913442 h 2671846"/>
                        <a:gd name="connsiteX35" fmla="*/ 1537619 w 1735501"/>
                        <a:gd name="connsiteY35" fmla="*/ 882962 h 2671846"/>
                        <a:gd name="connsiteX36" fmla="*/ 1591036 w 1735501"/>
                        <a:gd name="connsiteY36" fmla="*/ 844695 h 2671846"/>
                        <a:gd name="connsiteX37" fmla="*/ 1606785 w 1735501"/>
                        <a:gd name="connsiteY37" fmla="*/ 863028 h 2671846"/>
                        <a:gd name="connsiteX38" fmla="*/ 1681415 w 1735501"/>
                        <a:gd name="connsiteY38" fmla="*/ 814025 h 2671846"/>
                        <a:gd name="connsiteX39" fmla="*/ 1734786 w 1735501"/>
                        <a:gd name="connsiteY39" fmla="*/ 685785 h 2671846"/>
                        <a:gd name="connsiteX40" fmla="*/ 1642832 w 1735501"/>
                        <a:gd name="connsiteY40" fmla="*/ 679660 h 2671846"/>
                        <a:gd name="connsiteX41" fmla="*/ 1600596 w 1735501"/>
                        <a:gd name="connsiteY41" fmla="*/ 684032 h 2671846"/>
                        <a:gd name="connsiteX42" fmla="*/ 1504826 w 1735501"/>
                        <a:gd name="connsiteY42" fmla="*/ 741191 h 2671846"/>
                        <a:gd name="connsiteX43" fmla="*/ 1415699 w 1735501"/>
                        <a:gd name="connsiteY43" fmla="*/ 750882 h 2671846"/>
                        <a:gd name="connsiteX0" fmla="*/ 1415699 w 1735501"/>
                        <a:gd name="connsiteY0" fmla="*/ 750882 h 2671846"/>
                        <a:gd name="connsiteX1" fmla="*/ 1273459 w 1735501"/>
                        <a:gd name="connsiteY1" fmla="*/ 192082 h 2671846"/>
                        <a:gd name="connsiteX2" fmla="*/ 907699 w 1735501"/>
                        <a:gd name="connsiteY2" fmla="*/ 9202 h 2671846"/>
                        <a:gd name="connsiteX3" fmla="*/ 562259 w 1735501"/>
                        <a:gd name="connsiteY3" fmla="*/ 435922 h 2671846"/>
                        <a:gd name="connsiteX4" fmla="*/ 379379 w 1735501"/>
                        <a:gd name="connsiteY4" fmla="*/ 954082 h 2671846"/>
                        <a:gd name="connsiteX5" fmla="*/ 298099 w 1735501"/>
                        <a:gd name="connsiteY5" fmla="*/ 1330002 h 2671846"/>
                        <a:gd name="connsiteX6" fmla="*/ 577725 w 1735501"/>
                        <a:gd name="connsiteY6" fmla="*/ 1308839 h 2671846"/>
                        <a:gd name="connsiteX7" fmla="*/ 785779 w 1735501"/>
                        <a:gd name="connsiteY7" fmla="*/ 1299522 h 2671846"/>
                        <a:gd name="connsiteX8" fmla="*/ 1039779 w 1735501"/>
                        <a:gd name="connsiteY8" fmla="*/ 1238562 h 2671846"/>
                        <a:gd name="connsiteX9" fmla="*/ 1192179 w 1735501"/>
                        <a:gd name="connsiteY9" fmla="*/ 1136962 h 2671846"/>
                        <a:gd name="connsiteX10" fmla="*/ 1283619 w 1735501"/>
                        <a:gd name="connsiteY10" fmla="*/ 1004882 h 2671846"/>
                        <a:gd name="connsiteX11" fmla="*/ 1306392 w 1735501"/>
                        <a:gd name="connsiteY11" fmla="*/ 953917 h 2671846"/>
                        <a:gd name="connsiteX12" fmla="*/ 1226412 w 1735501"/>
                        <a:gd name="connsiteY12" fmla="*/ 1123422 h 2671846"/>
                        <a:gd name="connsiteX13" fmla="*/ 1070259 w 1735501"/>
                        <a:gd name="connsiteY13" fmla="*/ 1250417 h 2671846"/>
                        <a:gd name="connsiteX14" fmla="*/ 810953 w 1735501"/>
                        <a:gd name="connsiteY14" fmla="*/ 1314767 h 2671846"/>
                        <a:gd name="connsiteX15" fmla="*/ 247299 w 1735501"/>
                        <a:gd name="connsiteY15" fmla="*/ 1401122 h 2671846"/>
                        <a:gd name="connsiteX16" fmla="*/ 84739 w 1735501"/>
                        <a:gd name="connsiteY16" fmla="*/ 1919282 h 2671846"/>
                        <a:gd name="connsiteX17" fmla="*/ 22679 w 1735501"/>
                        <a:gd name="connsiteY17" fmla="*/ 2323987 h 2671846"/>
                        <a:gd name="connsiteX18" fmla="*/ 9412 w 1735501"/>
                        <a:gd name="connsiteY18" fmla="*/ 2467922 h 2671846"/>
                        <a:gd name="connsiteX19" fmla="*/ 24685 w 1735501"/>
                        <a:gd name="connsiteY19" fmla="*/ 2653340 h 2671846"/>
                        <a:gd name="connsiteX20" fmla="*/ 277779 w 1735501"/>
                        <a:gd name="connsiteY20" fmla="*/ 2665014 h 2671846"/>
                        <a:gd name="connsiteX21" fmla="*/ 622861 w 1735501"/>
                        <a:gd name="connsiteY21" fmla="*/ 2651175 h 2671846"/>
                        <a:gd name="connsiteX22" fmla="*/ 885229 w 1735501"/>
                        <a:gd name="connsiteY22" fmla="*/ 2613018 h 2671846"/>
                        <a:gd name="connsiteX23" fmla="*/ 1184064 w 1735501"/>
                        <a:gd name="connsiteY23" fmla="*/ 2484750 h 2671846"/>
                        <a:gd name="connsiteX24" fmla="*/ 1334419 w 1735501"/>
                        <a:gd name="connsiteY24" fmla="*/ 2254562 h 2671846"/>
                        <a:gd name="connsiteX25" fmla="*/ 1415699 w 1735501"/>
                        <a:gd name="connsiteY25" fmla="*/ 1959922 h 2671846"/>
                        <a:gd name="connsiteX26" fmla="*/ 1425859 w 1735501"/>
                        <a:gd name="connsiteY26" fmla="*/ 1573842 h 2671846"/>
                        <a:gd name="connsiteX27" fmla="*/ 1407092 w 1735501"/>
                        <a:gd name="connsiteY27" fmla="*/ 1238562 h 2671846"/>
                        <a:gd name="connsiteX28" fmla="*/ 1415699 w 1735501"/>
                        <a:gd name="connsiteY28" fmla="*/ 1086162 h 2671846"/>
                        <a:gd name="connsiteX29" fmla="*/ 1679859 w 1735501"/>
                        <a:gd name="connsiteY29" fmla="*/ 1025202 h 2671846"/>
                        <a:gd name="connsiteX30" fmla="*/ 1700179 w 1735501"/>
                        <a:gd name="connsiteY30" fmla="*/ 913442 h 2671846"/>
                        <a:gd name="connsiteX31" fmla="*/ 1527459 w 1735501"/>
                        <a:gd name="connsiteY31" fmla="*/ 923602 h 2671846"/>
                        <a:gd name="connsiteX32" fmla="*/ 1415699 w 1735501"/>
                        <a:gd name="connsiteY32" fmla="*/ 954082 h 2671846"/>
                        <a:gd name="connsiteX33" fmla="*/ 1415699 w 1735501"/>
                        <a:gd name="connsiteY33" fmla="*/ 893122 h 2671846"/>
                        <a:gd name="connsiteX34" fmla="*/ 1415699 w 1735501"/>
                        <a:gd name="connsiteY34" fmla="*/ 913442 h 2671846"/>
                        <a:gd name="connsiteX35" fmla="*/ 1537619 w 1735501"/>
                        <a:gd name="connsiteY35" fmla="*/ 882962 h 2671846"/>
                        <a:gd name="connsiteX36" fmla="*/ 1591036 w 1735501"/>
                        <a:gd name="connsiteY36" fmla="*/ 844695 h 2671846"/>
                        <a:gd name="connsiteX37" fmla="*/ 1606785 w 1735501"/>
                        <a:gd name="connsiteY37" fmla="*/ 863028 h 2671846"/>
                        <a:gd name="connsiteX38" fmla="*/ 1681415 w 1735501"/>
                        <a:gd name="connsiteY38" fmla="*/ 814025 h 2671846"/>
                        <a:gd name="connsiteX39" fmla="*/ 1734786 w 1735501"/>
                        <a:gd name="connsiteY39" fmla="*/ 685785 h 2671846"/>
                        <a:gd name="connsiteX40" fmla="*/ 1642832 w 1735501"/>
                        <a:gd name="connsiteY40" fmla="*/ 679660 h 2671846"/>
                        <a:gd name="connsiteX41" fmla="*/ 1600596 w 1735501"/>
                        <a:gd name="connsiteY41" fmla="*/ 684032 h 2671846"/>
                        <a:gd name="connsiteX42" fmla="*/ 1504826 w 1735501"/>
                        <a:gd name="connsiteY42" fmla="*/ 741191 h 2671846"/>
                        <a:gd name="connsiteX43" fmla="*/ 1415699 w 1735501"/>
                        <a:gd name="connsiteY43" fmla="*/ 750882 h 2671846"/>
                        <a:gd name="connsiteX0" fmla="*/ 1415699 w 1735501"/>
                        <a:gd name="connsiteY0" fmla="*/ 750882 h 2671846"/>
                        <a:gd name="connsiteX1" fmla="*/ 1273459 w 1735501"/>
                        <a:gd name="connsiteY1" fmla="*/ 192082 h 2671846"/>
                        <a:gd name="connsiteX2" fmla="*/ 907699 w 1735501"/>
                        <a:gd name="connsiteY2" fmla="*/ 9202 h 2671846"/>
                        <a:gd name="connsiteX3" fmla="*/ 562259 w 1735501"/>
                        <a:gd name="connsiteY3" fmla="*/ 435922 h 2671846"/>
                        <a:gd name="connsiteX4" fmla="*/ 379379 w 1735501"/>
                        <a:gd name="connsiteY4" fmla="*/ 954082 h 2671846"/>
                        <a:gd name="connsiteX5" fmla="*/ 298099 w 1735501"/>
                        <a:gd name="connsiteY5" fmla="*/ 1330002 h 2671846"/>
                        <a:gd name="connsiteX6" fmla="*/ 577725 w 1735501"/>
                        <a:gd name="connsiteY6" fmla="*/ 1308839 h 2671846"/>
                        <a:gd name="connsiteX7" fmla="*/ 785779 w 1735501"/>
                        <a:gd name="connsiteY7" fmla="*/ 1299522 h 2671846"/>
                        <a:gd name="connsiteX8" fmla="*/ 1039779 w 1735501"/>
                        <a:gd name="connsiteY8" fmla="*/ 1238562 h 2671846"/>
                        <a:gd name="connsiteX9" fmla="*/ 1192179 w 1735501"/>
                        <a:gd name="connsiteY9" fmla="*/ 1136962 h 2671846"/>
                        <a:gd name="connsiteX10" fmla="*/ 1283619 w 1735501"/>
                        <a:gd name="connsiteY10" fmla="*/ 1004882 h 2671846"/>
                        <a:gd name="connsiteX11" fmla="*/ 1306392 w 1735501"/>
                        <a:gd name="connsiteY11" fmla="*/ 953917 h 2671846"/>
                        <a:gd name="connsiteX12" fmla="*/ 1226412 w 1735501"/>
                        <a:gd name="connsiteY12" fmla="*/ 1123422 h 2671846"/>
                        <a:gd name="connsiteX13" fmla="*/ 1070259 w 1735501"/>
                        <a:gd name="connsiteY13" fmla="*/ 1250417 h 2671846"/>
                        <a:gd name="connsiteX14" fmla="*/ 810953 w 1735501"/>
                        <a:gd name="connsiteY14" fmla="*/ 1314767 h 2671846"/>
                        <a:gd name="connsiteX15" fmla="*/ 247299 w 1735501"/>
                        <a:gd name="connsiteY15" fmla="*/ 1401122 h 2671846"/>
                        <a:gd name="connsiteX16" fmla="*/ 84739 w 1735501"/>
                        <a:gd name="connsiteY16" fmla="*/ 1919282 h 2671846"/>
                        <a:gd name="connsiteX17" fmla="*/ 22679 w 1735501"/>
                        <a:gd name="connsiteY17" fmla="*/ 2323987 h 2671846"/>
                        <a:gd name="connsiteX18" fmla="*/ 9412 w 1735501"/>
                        <a:gd name="connsiteY18" fmla="*/ 2467922 h 2671846"/>
                        <a:gd name="connsiteX19" fmla="*/ 24685 w 1735501"/>
                        <a:gd name="connsiteY19" fmla="*/ 2653340 h 2671846"/>
                        <a:gd name="connsiteX20" fmla="*/ 277779 w 1735501"/>
                        <a:gd name="connsiteY20" fmla="*/ 2665014 h 2671846"/>
                        <a:gd name="connsiteX21" fmla="*/ 622861 w 1735501"/>
                        <a:gd name="connsiteY21" fmla="*/ 2651175 h 2671846"/>
                        <a:gd name="connsiteX22" fmla="*/ 885229 w 1735501"/>
                        <a:gd name="connsiteY22" fmla="*/ 2613018 h 2671846"/>
                        <a:gd name="connsiteX23" fmla="*/ 1184064 w 1735501"/>
                        <a:gd name="connsiteY23" fmla="*/ 2484750 h 2671846"/>
                        <a:gd name="connsiteX24" fmla="*/ 1334419 w 1735501"/>
                        <a:gd name="connsiteY24" fmla="*/ 2254562 h 2671846"/>
                        <a:gd name="connsiteX25" fmla="*/ 1415699 w 1735501"/>
                        <a:gd name="connsiteY25" fmla="*/ 1959922 h 2671846"/>
                        <a:gd name="connsiteX26" fmla="*/ 1425859 w 1735501"/>
                        <a:gd name="connsiteY26" fmla="*/ 1573842 h 2671846"/>
                        <a:gd name="connsiteX27" fmla="*/ 1407092 w 1735501"/>
                        <a:gd name="connsiteY27" fmla="*/ 1238562 h 2671846"/>
                        <a:gd name="connsiteX28" fmla="*/ 1415699 w 1735501"/>
                        <a:gd name="connsiteY28" fmla="*/ 1086162 h 2671846"/>
                        <a:gd name="connsiteX29" fmla="*/ 1679859 w 1735501"/>
                        <a:gd name="connsiteY29" fmla="*/ 1025202 h 2671846"/>
                        <a:gd name="connsiteX30" fmla="*/ 1700179 w 1735501"/>
                        <a:gd name="connsiteY30" fmla="*/ 913442 h 2671846"/>
                        <a:gd name="connsiteX31" fmla="*/ 1527459 w 1735501"/>
                        <a:gd name="connsiteY31" fmla="*/ 923602 h 2671846"/>
                        <a:gd name="connsiteX32" fmla="*/ 1415699 w 1735501"/>
                        <a:gd name="connsiteY32" fmla="*/ 954082 h 2671846"/>
                        <a:gd name="connsiteX33" fmla="*/ 1415699 w 1735501"/>
                        <a:gd name="connsiteY33" fmla="*/ 893122 h 2671846"/>
                        <a:gd name="connsiteX34" fmla="*/ 1415699 w 1735501"/>
                        <a:gd name="connsiteY34" fmla="*/ 913442 h 2671846"/>
                        <a:gd name="connsiteX35" fmla="*/ 1537619 w 1735501"/>
                        <a:gd name="connsiteY35" fmla="*/ 882962 h 2671846"/>
                        <a:gd name="connsiteX36" fmla="*/ 1583049 w 1735501"/>
                        <a:gd name="connsiteY36" fmla="*/ 871840 h 2671846"/>
                        <a:gd name="connsiteX37" fmla="*/ 1606785 w 1735501"/>
                        <a:gd name="connsiteY37" fmla="*/ 863028 h 2671846"/>
                        <a:gd name="connsiteX38" fmla="*/ 1681415 w 1735501"/>
                        <a:gd name="connsiteY38" fmla="*/ 814025 h 2671846"/>
                        <a:gd name="connsiteX39" fmla="*/ 1734786 w 1735501"/>
                        <a:gd name="connsiteY39" fmla="*/ 685785 h 2671846"/>
                        <a:gd name="connsiteX40" fmla="*/ 1642832 w 1735501"/>
                        <a:gd name="connsiteY40" fmla="*/ 679660 h 2671846"/>
                        <a:gd name="connsiteX41" fmla="*/ 1600596 w 1735501"/>
                        <a:gd name="connsiteY41" fmla="*/ 684032 h 2671846"/>
                        <a:gd name="connsiteX42" fmla="*/ 1504826 w 1735501"/>
                        <a:gd name="connsiteY42" fmla="*/ 741191 h 2671846"/>
                        <a:gd name="connsiteX43" fmla="*/ 1415699 w 1735501"/>
                        <a:gd name="connsiteY43" fmla="*/ 750882 h 2671846"/>
                        <a:gd name="connsiteX0" fmla="*/ 1415699 w 1734814"/>
                        <a:gd name="connsiteY0" fmla="*/ 750882 h 2671846"/>
                        <a:gd name="connsiteX1" fmla="*/ 1273459 w 1734814"/>
                        <a:gd name="connsiteY1" fmla="*/ 192082 h 2671846"/>
                        <a:gd name="connsiteX2" fmla="*/ 907699 w 1734814"/>
                        <a:gd name="connsiteY2" fmla="*/ 9202 h 2671846"/>
                        <a:gd name="connsiteX3" fmla="*/ 562259 w 1734814"/>
                        <a:gd name="connsiteY3" fmla="*/ 435922 h 2671846"/>
                        <a:gd name="connsiteX4" fmla="*/ 379379 w 1734814"/>
                        <a:gd name="connsiteY4" fmla="*/ 954082 h 2671846"/>
                        <a:gd name="connsiteX5" fmla="*/ 298099 w 1734814"/>
                        <a:gd name="connsiteY5" fmla="*/ 1330002 h 2671846"/>
                        <a:gd name="connsiteX6" fmla="*/ 577725 w 1734814"/>
                        <a:gd name="connsiteY6" fmla="*/ 1308839 h 2671846"/>
                        <a:gd name="connsiteX7" fmla="*/ 785779 w 1734814"/>
                        <a:gd name="connsiteY7" fmla="*/ 1299522 h 2671846"/>
                        <a:gd name="connsiteX8" fmla="*/ 1039779 w 1734814"/>
                        <a:gd name="connsiteY8" fmla="*/ 1238562 h 2671846"/>
                        <a:gd name="connsiteX9" fmla="*/ 1192179 w 1734814"/>
                        <a:gd name="connsiteY9" fmla="*/ 1136962 h 2671846"/>
                        <a:gd name="connsiteX10" fmla="*/ 1283619 w 1734814"/>
                        <a:gd name="connsiteY10" fmla="*/ 1004882 h 2671846"/>
                        <a:gd name="connsiteX11" fmla="*/ 1306392 w 1734814"/>
                        <a:gd name="connsiteY11" fmla="*/ 953917 h 2671846"/>
                        <a:gd name="connsiteX12" fmla="*/ 1226412 w 1734814"/>
                        <a:gd name="connsiteY12" fmla="*/ 1123422 h 2671846"/>
                        <a:gd name="connsiteX13" fmla="*/ 1070259 w 1734814"/>
                        <a:gd name="connsiteY13" fmla="*/ 1250417 h 2671846"/>
                        <a:gd name="connsiteX14" fmla="*/ 810953 w 1734814"/>
                        <a:gd name="connsiteY14" fmla="*/ 1314767 h 2671846"/>
                        <a:gd name="connsiteX15" fmla="*/ 247299 w 1734814"/>
                        <a:gd name="connsiteY15" fmla="*/ 1401122 h 2671846"/>
                        <a:gd name="connsiteX16" fmla="*/ 84739 w 1734814"/>
                        <a:gd name="connsiteY16" fmla="*/ 1919282 h 2671846"/>
                        <a:gd name="connsiteX17" fmla="*/ 22679 w 1734814"/>
                        <a:gd name="connsiteY17" fmla="*/ 2323987 h 2671846"/>
                        <a:gd name="connsiteX18" fmla="*/ 9412 w 1734814"/>
                        <a:gd name="connsiteY18" fmla="*/ 2467922 h 2671846"/>
                        <a:gd name="connsiteX19" fmla="*/ 24685 w 1734814"/>
                        <a:gd name="connsiteY19" fmla="*/ 2653340 h 2671846"/>
                        <a:gd name="connsiteX20" fmla="*/ 277779 w 1734814"/>
                        <a:gd name="connsiteY20" fmla="*/ 2665014 h 2671846"/>
                        <a:gd name="connsiteX21" fmla="*/ 622861 w 1734814"/>
                        <a:gd name="connsiteY21" fmla="*/ 2651175 h 2671846"/>
                        <a:gd name="connsiteX22" fmla="*/ 885229 w 1734814"/>
                        <a:gd name="connsiteY22" fmla="*/ 2613018 h 2671846"/>
                        <a:gd name="connsiteX23" fmla="*/ 1184064 w 1734814"/>
                        <a:gd name="connsiteY23" fmla="*/ 2484750 h 2671846"/>
                        <a:gd name="connsiteX24" fmla="*/ 1334419 w 1734814"/>
                        <a:gd name="connsiteY24" fmla="*/ 2254562 h 2671846"/>
                        <a:gd name="connsiteX25" fmla="*/ 1415699 w 1734814"/>
                        <a:gd name="connsiteY25" fmla="*/ 1959922 h 2671846"/>
                        <a:gd name="connsiteX26" fmla="*/ 1425859 w 1734814"/>
                        <a:gd name="connsiteY26" fmla="*/ 1573842 h 2671846"/>
                        <a:gd name="connsiteX27" fmla="*/ 1407092 w 1734814"/>
                        <a:gd name="connsiteY27" fmla="*/ 1238562 h 2671846"/>
                        <a:gd name="connsiteX28" fmla="*/ 1415699 w 1734814"/>
                        <a:gd name="connsiteY28" fmla="*/ 1086162 h 2671846"/>
                        <a:gd name="connsiteX29" fmla="*/ 1679859 w 1734814"/>
                        <a:gd name="connsiteY29" fmla="*/ 1025202 h 2671846"/>
                        <a:gd name="connsiteX30" fmla="*/ 1700179 w 1734814"/>
                        <a:gd name="connsiteY30" fmla="*/ 913442 h 2671846"/>
                        <a:gd name="connsiteX31" fmla="*/ 1527459 w 1734814"/>
                        <a:gd name="connsiteY31" fmla="*/ 923602 h 2671846"/>
                        <a:gd name="connsiteX32" fmla="*/ 1415699 w 1734814"/>
                        <a:gd name="connsiteY32" fmla="*/ 954082 h 2671846"/>
                        <a:gd name="connsiteX33" fmla="*/ 1415699 w 1734814"/>
                        <a:gd name="connsiteY33" fmla="*/ 893122 h 2671846"/>
                        <a:gd name="connsiteX34" fmla="*/ 1415699 w 1734814"/>
                        <a:gd name="connsiteY34" fmla="*/ 913442 h 2671846"/>
                        <a:gd name="connsiteX35" fmla="*/ 1537619 w 1734814"/>
                        <a:gd name="connsiteY35" fmla="*/ 882962 h 2671846"/>
                        <a:gd name="connsiteX36" fmla="*/ 1583049 w 1734814"/>
                        <a:gd name="connsiteY36" fmla="*/ 871840 h 2671846"/>
                        <a:gd name="connsiteX37" fmla="*/ 1606785 w 1734814"/>
                        <a:gd name="connsiteY37" fmla="*/ 863028 h 2671846"/>
                        <a:gd name="connsiteX38" fmla="*/ 1652127 w 1734814"/>
                        <a:gd name="connsiteY38" fmla="*/ 845048 h 2671846"/>
                        <a:gd name="connsiteX39" fmla="*/ 1734786 w 1734814"/>
                        <a:gd name="connsiteY39" fmla="*/ 685785 h 2671846"/>
                        <a:gd name="connsiteX40" fmla="*/ 1642832 w 1734814"/>
                        <a:gd name="connsiteY40" fmla="*/ 679660 h 2671846"/>
                        <a:gd name="connsiteX41" fmla="*/ 1600596 w 1734814"/>
                        <a:gd name="connsiteY41" fmla="*/ 684032 h 2671846"/>
                        <a:gd name="connsiteX42" fmla="*/ 1504826 w 1734814"/>
                        <a:gd name="connsiteY42" fmla="*/ 741191 h 2671846"/>
                        <a:gd name="connsiteX43" fmla="*/ 1415699 w 1734814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42832 w 1717777"/>
                        <a:gd name="connsiteY40" fmla="*/ 679660 h 2671846"/>
                        <a:gd name="connsiteX41" fmla="*/ 1600596 w 1717777"/>
                        <a:gd name="connsiteY41" fmla="*/ 684032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74782 w 1717777"/>
                        <a:gd name="connsiteY40" fmla="*/ 691293 h 2671846"/>
                        <a:gd name="connsiteX41" fmla="*/ 1600596 w 1717777"/>
                        <a:gd name="connsiteY41" fmla="*/ 684032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74782 w 1717777"/>
                        <a:gd name="connsiteY40" fmla="*/ 702927 h 2671846"/>
                        <a:gd name="connsiteX41" fmla="*/ 1600596 w 1717777"/>
                        <a:gd name="connsiteY41" fmla="*/ 684032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74782 w 1717777"/>
                        <a:gd name="connsiteY40" fmla="*/ 702927 h 2671846"/>
                        <a:gd name="connsiteX41" fmla="*/ 1608584 w 1717777"/>
                        <a:gd name="connsiteY41" fmla="*/ 718933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74782 w 1717777"/>
                        <a:gd name="connsiteY40" fmla="*/ 702927 h 2671846"/>
                        <a:gd name="connsiteX41" fmla="*/ 1608584 w 1717777"/>
                        <a:gd name="connsiteY41" fmla="*/ 718933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74782 w 1717777"/>
                        <a:gd name="connsiteY40" fmla="*/ 702927 h 2671846"/>
                        <a:gd name="connsiteX41" fmla="*/ 1608584 w 1717777"/>
                        <a:gd name="connsiteY41" fmla="*/ 718933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74782 w 1717777"/>
                        <a:gd name="connsiteY40" fmla="*/ 702927 h 2671846"/>
                        <a:gd name="connsiteX41" fmla="*/ 1608584 w 1717777"/>
                        <a:gd name="connsiteY41" fmla="*/ 718933 h 2671846"/>
                        <a:gd name="connsiteX42" fmla="*/ 1504826 w 1717777"/>
                        <a:gd name="connsiteY42" fmla="*/ 741191 h 2671846"/>
                        <a:gd name="connsiteX43" fmla="*/ 1415699 w 1717777"/>
                        <a:gd name="connsiteY43" fmla="*/ 750882 h 2671846"/>
                        <a:gd name="connsiteX0" fmla="*/ 1415699 w 1717777"/>
                        <a:gd name="connsiteY0" fmla="*/ 750882 h 2671846"/>
                        <a:gd name="connsiteX1" fmla="*/ 1273459 w 1717777"/>
                        <a:gd name="connsiteY1" fmla="*/ 192082 h 2671846"/>
                        <a:gd name="connsiteX2" fmla="*/ 907699 w 1717777"/>
                        <a:gd name="connsiteY2" fmla="*/ 9202 h 2671846"/>
                        <a:gd name="connsiteX3" fmla="*/ 562259 w 1717777"/>
                        <a:gd name="connsiteY3" fmla="*/ 435922 h 2671846"/>
                        <a:gd name="connsiteX4" fmla="*/ 379379 w 1717777"/>
                        <a:gd name="connsiteY4" fmla="*/ 954082 h 2671846"/>
                        <a:gd name="connsiteX5" fmla="*/ 298099 w 1717777"/>
                        <a:gd name="connsiteY5" fmla="*/ 1330002 h 2671846"/>
                        <a:gd name="connsiteX6" fmla="*/ 577725 w 1717777"/>
                        <a:gd name="connsiteY6" fmla="*/ 1308839 h 2671846"/>
                        <a:gd name="connsiteX7" fmla="*/ 785779 w 1717777"/>
                        <a:gd name="connsiteY7" fmla="*/ 1299522 h 2671846"/>
                        <a:gd name="connsiteX8" fmla="*/ 1039779 w 1717777"/>
                        <a:gd name="connsiteY8" fmla="*/ 1238562 h 2671846"/>
                        <a:gd name="connsiteX9" fmla="*/ 1192179 w 1717777"/>
                        <a:gd name="connsiteY9" fmla="*/ 1136962 h 2671846"/>
                        <a:gd name="connsiteX10" fmla="*/ 1283619 w 1717777"/>
                        <a:gd name="connsiteY10" fmla="*/ 1004882 h 2671846"/>
                        <a:gd name="connsiteX11" fmla="*/ 1306392 w 1717777"/>
                        <a:gd name="connsiteY11" fmla="*/ 953917 h 2671846"/>
                        <a:gd name="connsiteX12" fmla="*/ 1226412 w 1717777"/>
                        <a:gd name="connsiteY12" fmla="*/ 1123422 h 2671846"/>
                        <a:gd name="connsiteX13" fmla="*/ 1070259 w 1717777"/>
                        <a:gd name="connsiteY13" fmla="*/ 1250417 h 2671846"/>
                        <a:gd name="connsiteX14" fmla="*/ 810953 w 1717777"/>
                        <a:gd name="connsiteY14" fmla="*/ 1314767 h 2671846"/>
                        <a:gd name="connsiteX15" fmla="*/ 247299 w 1717777"/>
                        <a:gd name="connsiteY15" fmla="*/ 1401122 h 2671846"/>
                        <a:gd name="connsiteX16" fmla="*/ 84739 w 1717777"/>
                        <a:gd name="connsiteY16" fmla="*/ 1919282 h 2671846"/>
                        <a:gd name="connsiteX17" fmla="*/ 22679 w 1717777"/>
                        <a:gd name="connsiteY17" fmla="*/ 2323987 h 2671846"/>
                        <a:gd name="connsiteX18" fmla="*/ 9412 w 1717777"/>
                        <a:gd name="connsiteY18" fmla="*/ 2467922 h 2671846"/>
                        <a:gd name="connsiteX19" fmla="*/ 24685 w 1717777"/>
                        <a:gd name="connsiteY19" fmla="*/ 2653340 h 2671846"/>
                        <a:gd name="connsiteX20" fmla="*/ 277779 w 1717777"/>
                        <a:gd name="connsiteY20" fmla="*/ 2665014 h 2671846"/>
                        <a:gd name="connsiteX21" fmla="*/ 622861 w 1717777"/>
                        <a:gd name="connsiteY21" fmla="*/ 2651175 h 2671846"/>
                        <a:gd name="connsiteX22" fmla="*/ 885229 w 1717777"/>
                        <a:gd name="connsiteY22" fmla="*/ 2613018 h 2671846"/>
                        <a:gd name="connsiteX23" fmla="*/ 1184064 w 1717777"/>
                        <a:gd name="connsiteY23" fmla="*/ 2484750 h 2671846"/>
                        <a:gd name="connsiteX24" fmla="*/ 1334419 w 1717777"/>
                        <a:gd name="connsiteY24" fmla="*/ 2254562 h 2671846"/>
                        <a:gd name="connsiteX25" fmla="*/ 1415699 w 1717777"/>
                        <a:gd name="connsiteY25" fmla="*/ 1959922 h 2671846"/>
                        <a:gd name="connsiteX26" fmla="*/ 1425859 w 1717777"/>
                        <a:gd name="connsiteY26" fmla="*/ 1573842 h 2671846"/>
                        <a:gd name="connsiteX27" fmla="*/ 1407092 w 1717777"/>
                        <a:gd name="connsiteY27" fmla="*/ 1238562 h 2671846"/>
                        <a:gd name="connsiteX28" fmla="*/ 1415699 w 1717777"/>
                        <a:gd name="connsiteY28" fmla="*/ 1086162 h 2671846"/>
                        <a:gd name="connsiteX29" fmla="*/ 1679859 w 1717777"/>
                        <a:gd name="connsiteY29" fmla="*/ 1025202 h 2671846"/>
                        <a:gd name="connsiteX30" fmla="*/ 1700179 w 1717777"/>
                        <a:gd name="connsiteY30" fmla="*/ 913442 h 2671846"/>
                        <a:gd name="connsiteX31" fmla="*/ 1527459 w 1717777"/>
                        <a:gd name="connsiteY31" fmla="*/ 923602 h 2671846"/>
                        <a:gd name="connsiteX32" fmla="*/ 1415699 w 1717777"/>
                        <a:gd name="connsiteY32" fmla="*/ 954082 h 2671846"/>
                        <a:gd name="connsiteX33" fmla="*/ 1415699 w 1717777"/>
                        <a:gd name="connsiteY33" fmla="*/ 893122 h 2671846"/>
                        <a:gd name="connsiteX34" fmla="*/ 1415699 w 1717777"/>
                        <a:gd name="connsiteY34" fmla="*/ 913442 h 2671846"/>
                        <a:gd name="connsiteX35" fmla="*/ 1537619 w 1717777"/>
                        <a:gd name="connsiteY35" fmla="*/ 882962 h 2671846"/>
                        <a:gd name="connsiteX36" fmla="*/ 1583049 w 1717777"/>
                        <a:gd name="connsiteY36" fmla="*/ 871840 h 2671846"/>
                        <a:gd name="connsiteX37" fmla="*/ 1606785 w 1717777"/>
                        <a:gd name="connsiteY37" fmla="*/ 863028 h 2671846"/>
                        <a:gd name="connsiteX38" fmla="*/ 1652127 w 1717777"/>
                        <a:gd name="connsiteY38" fmla="*/ 845048 h 2671846"/>
                        <a:gd name="connsiteX39" fmla="*/ 1681535 w 1717777"/>
                        <a:gd name="connsiteY39" fmla="*/ 809877 h 2671846"/>
                        <a:gd name="connsiteX40" fmla="*/ 1674782 w 1717777"/>
                        <a:gd name="connsiteY40" fmla="*/ 702927 h 2671846"/>
                        <a:gd name="connsiteX41" fmla="*/ 1608584 w 1717777"/>
                        <a:gd name="connsiteY41" fmla="*/ 718933 h 2671846"/>
                        <a:gd name="connsiteX42" fmla="*/ 1510151 w 1717777"/>
                        <a:gd name="connsiteY42" fmla="*/ 752825 h 2671846"/>
                        <a:gd name="connsiteX43" fmla="*/ 1415699 w 1717777"/>
                        <a:gd name="connsiteY43" fmla="*/ 750882 h 2671846"/>
                        <a:gd name="connsiteX0" fmla="*/ 1415699 w 1706627"/>
                        <a:gd name="connsiteY0" fmla="*/ 750882 h 2671846"/>
                        <a:gd name="connsiteX1" fmla="*/ 1273459 w 1706627"/>
                        <a:gd name="connsiteY1" fmla="*/ 192082 h 2671846"/>
                        <a:gd name="connsiteX2" fmla="*/ 907699 w 1706627"/>
                        <a:gd name="connsiteY2" fmla="*/ 9202 h 2671846"/>
                        <a:gd name="connsiteX3" fmla="*/ 562259 w 1706627"/>
                        <a:gd name="connsiteY3" fmla="*/ 435922 h 2671846"/>
                        <a:gd name="connsiteX4" fmla="*/ 379379 w 1706627"/>
                        <a:gd name="connsiteY4" fmla="*/ 954082 h 2671846"/>
                        <a:gd name="connsiteX5" fmla="*/ 298099 w 1706627"/>
                        <a:gd name="connsiteY5" fmla="*/ 1330002 h 2671846"/>
                        <a:gd name="connsiteX6" fmla="*/ 577725 w 1706627"/>
                        <a:gd name="connsiteY6" fmla="*/ 1308839 h 2671846"/>
                        <a:gd name="connsiteX7" fmla="*/ 785779 w 1706627"/>
                        <a:gd name="connsiteY7" fmla="*/ 1299522 h 2671846"/>
                        <a:gd name="connsiteX8" fmla="*/ 1039779 w 1706627"/>
                        <a:gd name="connsiteY8" fmla="*/ 1238562 h 2671846"/>
                        <a:gd name="connsiteX9" fmla="*/ 1192179 w 1706627"/>
                        <a:gd name="connsiteY9" fmla="*/ 1136962 h 2671846"/>
                        <a:gd name="connsiteX10" fmla="*/ 1283619 w 1706627"/>
                        <a:gd name="connsiteY10" fmla="*/ 1004882 h 2671846"/>
                        <a:gd name="connsiteX11" fmla="*/ 1306392 w 1706627"/>
                        <a:gd name="connsiteY11" fmla="*/ 953917 h 2671846"/>
                        <a:gd name="connsiteX12" fmla="*/ 1226412 w 1706627"/>
                        <a:gd name="connsiteY12" fmla="*/ 1123422 h 2671846"/>
                        <a:gd name="connsiteX13" fmla="*/ 1070259 w 1706627"/>
                        <a:gd name="connsiteY13" fmla="*/ 1250417 h 2671846"/>
                        <a:gd name="connsiteX14" fmla="*/ 810953 w 1706627"/>
                        <a:gd name="connsiteY14" fmla="*/ 1314767 h 2671846"/>
                        <a:gd name="connsiteX15" fmla="*/ 247299 w 1706627"/>
                        <a:gd name="connsiteY15" fmla="*/ 1401122 h 2671846"/>
                        <a:gd name="connsiteX16" fmla="*/ 84739 w 1706627"/>
                        <a:gd name="connsiteY16" fmla="*/ 1919282 h 2671846"/>
                        <a:gd name="connsiteX17" fmla="*/ 22679 w 1706627"/>
                        <a:gd name="connsiteY17" fmla="*/ 2323987 h 2671846"/>
                        <a:gd name="connsiteX18" fmla="*/ 9412 w 1706627"/>
                        <a:gd name="connsiteY18" fmla="*/ 2467922 h 2671846"/>
                        <a:gd name="connsiteX19" fmla="*/ 24685 w 1706627"/>
                        <a:gd name="connsiteY19" fmla="*/ 2653340 h 2671846"/>
                        <a:gd name="connsiteX20" fmla="*/ 277779 w 1706627"/>
                        <a:gd name="connsiteY20" fmla="*/ 2665014 h 2671846"/>
                        <a:gd name="connsiteX21" fmla="*/ 622861 w 1706627"/>
                        <a:gd name="connsiteY21" fmla="*/ 2651175 h 2671846"/>
                        <a:gd name="connsiteX22" fmla="*/ 885229 w 1706627"/>
                        <a:gd name="connsiteY22" fmla="*/ 2613018 h 2671846"/>
                        <a:gd name="connsiteX23" fmla="*/ 1184064 w 1706627"/>
                        <a:gd name="connsiteY23" fmla="*/ 2484750 h 2671846"/>
                        <a:gd name="connsiteX24" fmla="*/ 1334419 w 1706627"/>
                        <a:gd name="connsiteY24" fmla="*/ 2254562 h 2671846"/>
                        <a:gd name="connsiteX25" fmla="*/ 1415699 w 1706627"/>
                        <a:gd name="connsiteY25" fmla="*/ 1959922 h 2671846"/>
                        <a:gd name="connsiteX26" fmla="*/ 1425859 w 1706627"/>
                        <a:gd name="connsiteY26" fmla="*/ 1573842 h 2671846"/>
                        <a:gd name="connsiteX27" fmla="*/ 1407092 w 1706627"/>
                        <a:gd name="connsiteY27" fmla="*/ 1238562 h 2671846"/>
                        <a:gd name="connsiteX28" fmla="*/ 1415699 w 1706627"/>
                        <a:gd name="connsiteY28" fmla="*/ 1086162 h 2671846"/>
                        <a:gd name="connsiteX29" fmla="*/ 1645246 w 1706627"/>
                        <a:gd name="connsiteY29" fmla="*/ 1075614 h 2671846"/>
                        <a:gd name="connsiteX30" fmla="*/ 1700179 w 1706627"/>
                        <a:gd name="connsiteY30" fmla="*/ 913442 h 2671846"/>
                        <a:gd name="connsiteX31" fmla="*/ 1527459 w 1706627"/>
                        <a:gd name="connsiteY31" fmla="*/ 923602 h 2671846"/>
                        <a:gd name="connsiteX32" fmla="*/ 1415699 w 1706627"/>
                        <a:gd name="connsiteY32" fmla="*/ 954082 h 2671846"/>
                        <a:gd name="connsiteX33" fmla="*/ 1415699 w 1706627"/>
                        <a:gd name="connsiteY33" fmla="*/ 893122 h 2671846"/>
                        <a:gd name="connsiteX34" fmla="*/ 1415699 w 1706627"/>
                        <a:gd name="connsiteY34" fmla="*/ 913442 h 2671846"/>
                        <a:gd name="connsiteX35" fmla="*/ 1537619 w 1706627"/>
                        <a:gd name="connsiteY35" fmla="*/ 882962 h 2671846"/>
                        <a:gd name="connsiteX36" fmla="*/ 1583049 w 1706627"/>
                        <a:gd name="connsiteY36" fmla="*/ 871840 h 2671846"/>
                        <a:gd name="connsiteX37" fmla="*/ 1606785 w 1706627"/>
                        <a:gd name="connsiteY37" fmla="*/ 863028 h 2671846"/>
                        <a:gd name="connsiteX38" fmla="*/ 1652127 w 1706627"/>
                        <a:gd name="connsiteY38" fmla="*/ 845048 h 2671846"/>
                        <a:gd name="connsiteX39" fmla="*/ 1681535 w 1706627"/>
                        <a:gd name="connsiteY39" fmla="*/ 809877 h 2671846"/>
                        <a:gd name="connsiteX40" fmla="*/ 1674782 w 1706627"/>
                        <a:gd name="connsiteY40" fmla="*/ 702927 h 2671846"/>
                        <a:gd name="connsiteX41" fmla="*/ 1608584 w 1706627"/>
                        <a:gd name="connsiteY41" fmla="*/ 718933 h 2671846"/>
                        <a:gd name="connsiteX42" fmla="*/ 1510151 w 1706627"/>
                        <a:gd name="connsiteY42" fmla="*/ 752825 h 2671846"/>
                        <a:gd name="connsiteX43" fmla="*/ 1415699 w 1706627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45246 w 1684294"/>
                        <a:gd name="connsiteY29" fmla="*/ 1075614 h 2671846"/>
                        <a:gd name="connsiteX30" fmla="*/ 1652253 w 1684294"/>
                        <a:gd name="connsiteY30" fmla="*/ 971610 h 2671846"/>
                        <a:gd name="connsiteX31" fmla="*/ 1527459 w 1684294"/>
                        <a:gd name="connsiteY31" fmla="*/ 923602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45246 w 1684294"/>
                        <a:gd name="connsiteY29" fmla="*/ 1075614 h 2671846"/>
                        <a:gd name="connsiteX30" fmla="*/ 1652253 w 1684294"/>
                        <a:gd name="connsiteY30" fmla="*/ 971610 h 2671846"/>
                        <a:gd name="connsiteX31" fmla="*/ 1527459 w 1684294"/>
                        <a:gd name="connsiteY31" fmla="*/ 981770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45246 w 1684294"/>
                        <a:gd name="connsiteY29" fmla="*/ 1075614 h 2671846"/>
                        <a:gd name="connsiteX30" fmla="*/ 1652253 w 1684294"/>
                        <a:gd name="connsiteY30" fmla="*/ 971610 h 2671846"/>
                        <a:gd name="connsiteX31" fmla="*/ 1530122 w 1684294"/>
                        <a:gd name="connsiteY31" fmla="*/ 981770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45246 w 1684294"/>
                        <a:gd name="connsiteY29" fmla="*/ 1075614 h 2671846"/>
                        <a:gd name="connsiteX30" fmla="*/ 1652253 w 1684294"/>
                        <a:gd name="connsiteY30" fmla="*/ 971610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45246 w 1684294"/>
                        <a:gd name="connsiteY29" fmla="*/ 1075614 h 2671846"/>
                        <a:gd name="connsiteX30" fmla="*/ 1652253 w 1684294"/>
                        <a:gd name="connsiteY30" fmla="*/ 971610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45246 w 1684294"/>
                        <a:gd name="connsiteY29" fmla="*/ 1075614 h 2671846"/>
                        <a:gd name="connsiteX30" fmla="*/ 1622965 w 1684294"/>
                        <a:gd name="connsiteY30" fmla="*/ 971610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15958 w 1684294"/>
                        <a:gd name="connsiteY29" fmla="*/ 1075614 h 2671846"/>
                        <a:gd name="connsiteX30" fmla="*/ 1622965 w 1684294"/>
                        <a:gd name="connsiteY30" fmla="*/ 971610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15958 w 1684294"/>
                        <a:gd name="connsiteY29" fmla="*/ 1075614 h 2671846"/>
                        <a:gd name="connsiteX30" fmla="*/ 1630953 w 1684294"/>
                        <a:gd name="connsiteY30" fmla="*/ 979366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15958 w 1684294"/>
                        <a:gd name="connsiteY29" fmla="*/ 1075614 h 2671846"/>
                        <a:gd name="connsiteX30" fmla="*/ 1630953 w 1684294"/>
                        <a:gd name="connsiteY30" fmla="*/ 979366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31933 w 1684294"/>
                        <a:gd name="connsiteY29" fmla="*/ 1071736 h 2671846"/>
                        <a:gd name="connsiteX30" fmla="*/ 1630953 w 1684294"/>
                        <a:gd name="connsiteY30" fmla="*/ 979366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31933 w 1684294"/>
                        <a:gd name="connsiteY29" fmla="*/ 1071736 h 2671846"/>
                        <a:gd name="connsiteX30" fmla="*/ 1630953 w 1684294"/>
                        <a:gd name="connsiteY30" fmla="*/ 979366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37619 w 1684294"/>
                        <a:gd name="connsiteY35" fmla="*/ 882962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31933 w 1684294"/>
                        <a:gd name="connsiteY29" fmla="*/ 1071736 h 2671846"/>
                        <a:gd name="connsiteX30" fmla="*/ 1630953 w 1684294"/>
                        <a:gd name="connsiteY30" fmla="*/ 979366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29632 w 1684294"/>
                        <a:gd name="connsiteY35" fmla="*/ 906229 h 2671846"/>
                        <a:gd name="connsiteX36" fmla="*/ 1583049 w 1684294"/>
                        <a:gd name="connsiteY36" fmla="*/ 871840 h 2671846"/>
                        <a:gd name="connsiteX37" fmla="*/ 1606785 w 1684294"/>
                        <a:gd name="connsiteY37" fmla="*/ 863028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31933 w 1684294"/>
                        <a:gd name="connsiteY29" fmla="*/ 1071736 h 2671846"/>
                        <a:gd name="connsiteX30" fmla="*/ 1630953 w 1684294"/>
                        <a:gd name="connsiteY30" fmla="*/ 979366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29632 w 1684294"/>
                        <a:gd name="connsiteY35" fmla="*/ 906229 h 2671846"/>
                        <a:gd name="connsiteX36" fmla="*/ 1583049 w 1684294"/>
                        <a:gd name="connsiteY36" fmla="*/ 871840 h 2671846"/>
                        <a:gd name="connsiteX37" fmla="*/ 1612110 w 1684294"/>
                        <a:gd name="connsiteY37" fmla="*/ 901807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294"/>
                        <a:gd name="connsiteY0" fmla="*/ 750882 h 2671846"/>
                        <a:gd name="connsiteX1" fmla="*/ 1273459 w 1684294"/>
                        <a:gd name="connsiteY1" fmla="*/ 192082 h 2671846"/>
                        <a:gd name="connsiteX2" fmla="*/ 907699 w 1684294"/>
                        <a:gd name="connsiteY2" fmla="*/ 9202 h 2671846"/>
                        <a:gd name="connsiteX3" fmla="*/ 562259 w 1684294"/>
                        <a:gd name="connsiteY3" fmla="*/ 435922 h 2671846"/>
                        <a:gd name="connsiteX4" fmla="*/ 379379 w 1684294"/>
                        <a:gd name="connsiteY4" fmla="*/ 954082 h 2671846"/>
                        <a:gd name="connsiteX5" fmla="*/ 298099 w 1684294"/>
                        <a:gd name="connsiteY5" fmla="*/ 1330002 h 2671846"/>
                        <a:gd name="connsiteX6" fmla="*/ 577725 w 1684294"/>
                        <a:gd name="connsiteY6" fmla="*/ 1308839 h 2671846"/>
                        <a:gd name="connsiteX7" fmla="*/ 785779 w 1684294"/>
                        <a:gd name="connsiteY7" fmla="*/ 1299522 h 2671846"/>
                        <a:gd name="connsiteX8" fmla="*/ 1039779 w 1684294"/>
                        <a:gd name="connsiteY8" fmla="*/ 1238562 h 2671846"/>
                        <a:gd name="connsiteX9" fmla="*/ 1192179 w 1684294"/>
                        <a:gd name="connsiteY9" fmla="*/ 1136962 h 2671846"/>
                        <a:gd name="connsiteX10" fmla="*/ 1283619 w 1684294"/>
                        <a:gd name="connsiteY10" fmla="*/ 1004882 h 2671846"/>
                        <a:gd name="connsiteX11" fmla="*/ 1306392 w 1684294"/>
                        <a:gd name="connsiteY11" fmla="*/ 953917 h 2671846"/>
                        <a:gd name="connsiteX12" fmla="*/ 1226412 w 1684294"/>
                        <a:gd name="connsiteY12" fmla="*/ 1123422 h 2671846"/>
                        <a:gd name="connsiteX13" fmla="*/ 1070259 w 1684294"/>
                        <a:gd name="connsiteY13" fmla="*/ 1250417 h 2671846"/>
                        <a:gd name="connsiteX14" fmla="*/ 810953 w 1684294"/>
                        <a:gd name="connsiteY14" fmla="*/ 1314767 h 2671846"/>
                        <a:gd name="connsiteX15" fmla="*/ 247299 w 1684294"/>
                        <a:gd name="connsiteY15" fmla="*/ 1401122 h 2671846"/>
                        <a:gd name="connsiteX16" fmla="*/ 84739 w 1684294"/>
                        <a:gd name="connsiteY16" fmla="*/ 1919282 h 2671846"/>
                        <a:gd name="connsiteX17" fmla="*/ 22679 w 1684294"/>
                        <a:gd name="connsiteY17" fmla="*/ 2323987 h 2671846"/>
                        <a:gd name="connsiteX18" fmla="*/ 9412 w 1684294"/>
                        <a:gd name="connsiteY18" fmla="*/ 2467922 h 2671846"/>
                        <a:gd name="connsiteX19" fmla="*/ 24685 w 1684294"/>
                        <a:gd name="connsiteY19" fmla="*/ 2653340 h 2671846"/>
                        <a:gd name="connsiteX20" fmla="*/ 277779 w 1684294"/>
                        <a:gd name="connsiteY20" fmla="*/ 2665014 h 2671846"/>
                        <a:gd name="connsiteX21" fmla="*/ 622861 w 1684294"/>
                        <a:gd name="connsiteY21" fmla="*/ 2651175 h 2671846"/>
                        <a:gd name="connsiteX22" fmla="*/ 885229 w 1684294"/>
                        <a:gd name="connsiteY22" fmla="*/ 2613018 h 2671846"/>
                        <a:gd name="connsiteX23" fmla="*/ 1184064 w 1684294"/>
                        <a:gd name="connsiteY23" fmla="*/ 2484750 h 2671846"/>
                        <a:gd name="connsiteX24" fmla="*/ 1334419 w 1684294"/>
                        <a:gd name="connsiteY24" fmla="*/ 2254562 h 2671846"/>
                        <a:gd name="connsiteX25" fmla="*/ 1415699 w 1684294"/>
                        <a:gd name="connsiteY25" fmla="*/ 1959922 h 2671846"/>
                        <a:gd name="connsiteX26" fmla="*/ 1425859 w 1684294"/>
                        <a:gd name="connsiteY26" fmla="*/ 1573842 h 2671846"/>
                        <a:gd name="connsiteX27" fmla="*/ 1407092 w 1684294"/>
                        <a:gd name="connsiteY27" fmla="*/ 1238562 h 2671846"/>
                        <a:gd name="connsiteX28" fmla="*/ 1415699 w 1684294"/>
                        <a:gd name="connsiteY28" fmla="*/ 1086162 h 2671846"/>
                        <a:gd name="connsiteX29" fmla="*/ 1631933 w 1684294"/>
                        <a:gd name="connsiteY29" fmla="*/ 1071736 h 2671846"/>
                        <a:gd name="connsiteX30" fmla="*/ 1630953 w 1684294"/>
                        <a:gd name="connsiteY30" fmla="*/ 979366 h 2671846"/>
                        <a:gd name="connsiteX31" fmla="*/ 1532785 w 1684294"/>
                        <a:gd name="connsiteY31" fmla="*/ 970136 h 2671846"/>
                        <a:gd name="connsiteX32" fmla="*/ 1415699 w 1684294"/>
                        <a:gd name="connsiteY32" fmla="*/ 954082 h 2671846"/>
                        <a:gd name="connsiteX33" fmla="*/ 1415699 w 1684294"/>
                        <a:gd name="connsiteY33" fmla="*/ 893122 h 2671846"/>
                        <a:gd name="connsiteX34" fmla="*/ 1415699 w 1684294"/>
                        <a:gd name="connsiteY34" fmla="*/ 913442 h 2671846"/>
                        <a:gd name="connsiteX35" fmla="*/ 1529632 w 1684294"/>
                        <a:gd name="connsiteY35" fmla="*/ 906229 h 2671846"/>
                        <a:gd name="connsiteX36" fmla="*/ 1583049 w 1684294"/>
                        <a:gd name="connsiteY36" fmla="*/ 902863 h 2671846"/>
                        <a:gd name="connsiteX37" fmla="*/ 1612110 w 1684294"/>
                        <a:gd name="connsiteY37" fmla="*/ 901807 h 2671846"/>
                        <a:gd name="connsiteX38" fmla="*/ 1652127 w 1684294"/>
                        <a:gd name="connsiteY38" fmla="*/ 845048 h 2671846"/>
                        <a:gd name="connsiteX39" fmla="*/ 1681535 w 1684294"/>
                        <a:gd name="connsiteY39" fmla="*/ 809877 h 2671846"/>
                        <a:gd name="connsiteX40" fmla="*/ 1674782 w 1684294"/>
                        <a:gd name="connsiteY40" fmla="*/ 702927 h 2671846"/>
                        <a:gd name="connsiteX41" fmla="*/ 1608584 w 1684294"/>
                        <a:gd name="connsiteY41" fmla="*/ 718933 h 2671846"/>
                        <a:gd name="connsiteX42" fmla="*/ 1510151 w 1684294"/>
                        <a:gd name="connsiteY42" fmla="*/ 752825 h 2671846"/>
                        <a:gd name="connsiteX43" fmla="*/ 1415699 w 1684294"/>
                        <a:gd name="connsiteY43" fmla="*/ 750882 h 2671846"/>
                        <a:gd name="connsiteX0" fmla="*/ 1415699 w 1684484"/>
                        <a:gd name="connsiteY0" fmla="*/ 750882 h 2671846"/>
                        <a:gd name="connsiteX1" fmla="*/ 1273459 w 1684484"/>
                        <a:gd name="connsiteY1" fmla="*/ 192082 h 2671846"/>
                        <a:gd name="connsiteX2" fmla="*/ 907699 w 1684484"/>
                        <a:gd name="connsiteY2" fmla="*/ 9202 h 2671846"/>
                        <a:gd name="connsiteX3" fmla="*/ 562259 w 1684484"/>
                        <a:gd name="connsiteY3" fmla="*/ 435922 h 2671846"/>
                        <a:gd name="connsiteX4" fmla="*/ 379379 w 1684484"/>
                        <a:gd name="connsiteY4" fmla="*/ 954082 h 2671846"/>
                        <a:gd name="connsiteX5" fmla="*/ 298099 w 1684484"/>
                        <a:gd name="connsiteY5" fmla="*/ 1330002 h 2671846"/>
                        <a:gd name="connsiteX6" fmla="*/ 577725 w 1684484"/>
                        <a:gd name="connsiteY6" fmla="*/ 1308839 h 2671846"/>
                        <a:gd name="connsiteX7" fmla="*/ 785779 w 1684484"/>
                        <a:gd name="connsiteY7" fmla="*/ 1299522 h 2671846"/>
                        <a:gd name="connsiteX8" fmla="*/ 1039779 w 1684484"/>
                        <a:gd name="connsiteY8" fmla="*/ 1238562 h 2671846"/>
                        <a:gd name="connsiteX9" fmla="*/ 1192179 w 1684484"/>
                        <a:gd name="connsiteY9" fmla="*/ 1136962 h 2671846"/>
                        <a:gd name="connsiteX10" fmla="*/ 1283619 w 1684484"/>
                        <a:gd name="connsiteY10" fmla="*/ 1004882 h 2671846"/>
                        <a:gd name="connsiteX11" fmla="*/ 1306392 w 1684484"/>
                        <a:gd name="connsiteY11" fmla="*/ 953917 h 2671846"/>
                        <a:gd name="connsiteX12" fmla="*/ 1226412 w 1684484"/>
                        <a:gd name="connsiteY12" fmla="*/ 1123422 h 2671846"/>
                        <a:gd name="connsiteX13" fmla="*/ 1070259 w 1684484"/>
                        <a:gd name="connsiteY13" fmla="*/ 1250417 h 2671846"/>
                        <a:gd name="connsiteX14" fmla="*/ 810953 w 1684484"/>
                        <a:gd name="connsiteY14" fmla="*/ 1314767 h 2671846"/>
                        <a:gd name="connsiteX15" fmla="*/ 247299 w 1684484"/>
                        <a:gd name="connsiteY15" fmla="*/ 1401122 h 2671846"/>
                        <a:gd name="connsiteX16" fmla="*/ 84739 w 1684484"/>
                        <a:gd name="connsiteY16" fmla="*/ 1919282 h 2671846"/>
                        <a:gd name="connsiteX17" fmla="*/ 22679 w 1684484"/>
                        <a:gd name="connsiteY17" fmla="*/ 2323987 h 2671846"/>
                        <a:gd name="connsiteX18" fmla="*/ 9412 w 1684484"/>
                        <a:gd name="connsiteY18" fmla="*/ 2467922 h 2671846"/>
                        <a:gd name="connsiteX19" fmla="*/ 24685 w 1684484"/>
                        <a:gd name="connsiteY19" fmla="*/ 2653340 h 2671846"/>
                        <a:gd name="connsiteX20" fmla="*/ 277779 w 1684484"/>
                        <a:gd name="connsiteY20" fmla="*/ 2665014 h 2671846"/>
                        <a:gd name="connsiteX21" fmla="*/ 622861 w 1684484"/>
                        <a:gd name="connsiteY21" fmla="*/ 2651175 h 2671846"/>
                        <a:gd name="connsiteX22" fmla="*/ 885229 w 1684484"/>
                        <a:gd name="connsiteY22" fmla="*/ 2613018 h 2671846"/>
                        <a:gd name="connsiteX23" fmla="*/ 1184064 w 1684484"/>
                        <a:gd name="connsiteY23" fmla="*/ 2484750 h 2671846"/>
                        <a:gd name="connsiteX24" fmla="*/ 1334419 w 1684484"/>
                        <a:gd name="connsiteY24" fmla="*/ 2254562 h 2671846"/>
                        <a:gd name="connsiteX25" fmla="*/ 1415699 w 1684484"/>
                        <a:gd name="connsiteY25" fmla="*/ 1959922 h 2671846"/>
                        <a:gd name="connsiteX26" fmla="*/ 1425859 w 1684484"/>
                        <a:gd name="connsiteY26" fmla="*/ 1573842 h 2671846"/>
                        <a:gd name="connsiteX27" fmla="*/ 1407092 w 1684484"/>
                        <a:gd name="connsiteY27" fmla="*/ 1238562 h 2671846"/>
                        <a:gd name="connsiteX28" fmla="*/ 1415699 w 1684484"/>
                        <a:gd name="connsiteY28" fmla="*/ 1086162 h 2671846"/>
                        <a:gd name="connsiteX29" fmla="*/ 1631933 w 1684484"/>
                        <a:gd name="connsiteY29" fmla="*/ 1071736 h 2671846"/>
                        <a:gd name="connsiteX30" fmla="*/ 1630953 w 1684484"/>
                        <a:gd name="connsiteY30" fmla="*/ 979366 h 2671846"/>
                        <a:gd name="connsiteX31" fmla="*/ 1532785 w 1684484"/>
                        <a:gd name="connsiteY31" fmla="*/ 970136 h 2671846"/>
                        <a:gd name="connsiteX32" fmla="*/ 1415699 w 1684484"/>
                        <a:gd name="connsiteY32" fmla="*/ 954082 h 2671846"/>
                        <a:gd name="connsiteX33" fmla="*/ 1415699 w 1684484"/>
                        <a:gd name="connsiteY33" fmla="*/ 893122 h 2671846"/>
                        <a:gd name="connsiteX34" fmla="*/ 1415699 w 1684484"/>
                        <a:gd name="connsiteY34" fmla="*/ 913442 h 2671846"/>
                        <a:gd name="connsiteX35" fmla="*/ 1529632 w 1684484"/>
                        <a:gd name="connsiteY35" fmla="*/ 906229 h 2671846"/>
                        <a:gd name="connsiteX36" fmla="*/ 1583049 w 1684484"/>
                        <a:gd name="connsiteY36" fmla="*/ 902863 h 2671846"/>
                        <a:gd name="connsiteX37" fmla="*/ 1612110 w 1684484"/>
                        <a:gd name="connsiteY37" fmla="*/ 901807 h 2671846"/>
                        <a:gd name="connsiteX38" fmla="*/ 1649464 w 1684484"/>
                        <a:gd name="connsiteY38" fmla="*/ 883827 h 2671846"/>
                        <a:gd name="connsiteX39" fmla="*/ 1681535 w 1684484"/>
                        <a:gd name="connsiteY39" fmla="*/ 809877 h 2671846"/>
                        <a:gd name="connsiteX40" fmla="*/ 1674782 w 1684484"/>
                        <a:gd name="connsiteY40" fmla="*/ 702927 h 2671846"/>
                        <a:gd name="connsiteX41" fmla="*/ 1608584 w 1684484"/>
                        <a:gd name="connsiteY41" fmla="*/ 718933 h 2671846"/>
                        <a:gd name="connsiteX42" fmla="*/ 1510151 w 1684484"/>
                        <a:gd name="connsiteY42" fmla="*/ 752825 h 2671846"/>
                        <a:gd name="connsiteX43" fmla="*/ 1415699 w 1684484"/>
                        <a:gd name="connsiteY43" fmla="*/ 750882 h 2671846"/>
                        <a:gd name="connsiteX0" fmla="*/ 1415699 w 1676638"/>
                        <a:gd name="connsiteY0" fmla="*/ 750882 h 2671846"/>
                        <a:gd name="connsiteX1" fmla="*/ 1273459 w 1676638"/>
                        <a:gd name="connsiteY1" fmla="*/ 192082 h 2671846"/>
                        <a:gd name="connsiteX2" fmla="*/ 907699 w 1676638"/>
                        <a:gd name="connsiteY2" fmla="*/ 9202 h 2671846"/>
                        <a:gd name="connsiteX3" fmla="*/ 562259 w 1676638"/>
                        <a:gd name="connsiteY3" fmla="*/ 435922 h 2671846"/>
                        <a:gd name="connsiteX4" fmla="*/ 379379 w 1676638"/>
                        <a:gd name="connsiteY4" fmla="*/ 954082 h 2671846"/>
                        <a:gd name="connsiteX5" fmla="*/ 298099 w 1676638"/>
                        <a:gd name="connsiteY5" fmla="*/ 1330002 h 2671846"/>
                        <a:gd name="connsiteX6" fmla="*/ 577725 w 1676638"/>
                        <a:gd name="connsiteY6" fmla="*/ 1308839 h 2671846"/>
                        <a:gd name="connsiteX7" fmla="*/ 785779 w 1676638"/>
                        <a:gd name="connsiteY7" fmla="*/ 1299522 h 2671846"/>
                        <a:gd name="connsiteX8" fmla="*/ 1039779 w 1676638"/>
                        <a:gd name="connsiteY8" fmla="*/ 1238562 h 2671846"/>
                        <a:gd name="connsiteX9" fmla="*/ 1192179 w 1676638"/>
                        <a:gd name="connsiteY9" fmla="*/ 1136962 h 2671846"/>
                        <a:gd name="connsiteX10" fmla="*/ 1283619 w 1676638"/>
                        <a:gd name="connsiteY10" fmla="*/ 1004882 h 2671846"/>
                        <a:gd name="connsiteX11" fmla="*/ 1306392 w 1676638"/>
                        <a:gd name="connsiteY11" fmla="*/ 953917 h 2671846"/>
                        <a:gd name="connsiteX12" fmla="*/ 1226412 w 1676638"/>
                        <a:gd name="connsiteY12" fmla="*/ 1123422 h 2671846"/>
                        <a:gd name="connsiteX13" fmla="*/ 1070259 w 1676638"/>
                        <a:gd name="connsiteY13" fmla="*/ 1250417 h 2671846"/>
                        <a:gd name="connsiteX14" fmla="*/ 810953 w 1676638"/>
                        <a:gd name="connsiteY14" fmla="*/ 1314767 h 2671846"/>
                        <a:gd name="connsiteX15" fmla="*/ 247299 w 1676638"/>
                        <a:gd name="connsiteY15" fmla="*/ 1401122 h 2671846"/>
                        <a:gd name="connsiteX16" fmla="*/ 84739 w 1676638"/>
                        <a:gd name="connsiteY16" fmla="*/ 1919282 h 2671846"/>
                        <a:gd name="connsiteX17" fmla="*/ 22679 w 1676638"/>
                        <a:gd name="connsiteY17" fmla="*/ 2323987 h 2671846"/>
                        <a:gd name="connsiteX18" fmla="*/ 9412 w 1676638"/>
                        <a:gd name="connsiteY18" fmla="*/ 2467922 h 2671846"/>
                        <a:gd name="connsiteX19" fmla="*/ 24685 w 1676638"/>
                        <a:gd name="connsiteY19" fmla="*/ 2653340 h 2671846"/>
                        <a:gd name="connsiteX20" fmla="*/ 277779 w 1676638"/>
                        <a:gd name="connsiteY20" fmla="*/ 2665014 h 2671846"/>
                        <a:gd name="connsiteX21" fmla="*/ 622861 w 1676638"/>
                        <a:gd name="connsiteY21" fmla="*/ 2651175 h 2671846"/>
                        <a:gd name="connsiteX22" fmla="*/ 885229 w 1676638"/>
                        <a:gd name="connsiteY22" fmla="*/ 2613018 h 2671846"/>
                        <a:gd name="connsiteX23" fmla="*/ 1184064 w 1676638"/>
                        <a:gd name="connsiteY23" fmla="*/ 2484750 h 2671846"/>
                        <a:gd name="connsiteX24" fmla="*/ 1334419 w 1676638"/>
                        <a:gd name="connsiteY24" fmla="*/ 2254562 h 2671846"/>
                        <a:gd name="connsiteX25" fmla="*/ 1415699 w 1676638"/>
                        <a:gd name="connsiteY25" fmla="*/ 1959922 h 2671846"/>
                        <a:gd name="connsiteX26" fmla="*/ 1425859 w 1676638"/>
                        <a:gd name="connsiteY26" fmla="*/ 1573842 h 2671846"/>
                        <a:gd name="connsiteX27" fmla="*/ 1407092 w 1676638"/>
                        <a:gd name="connsiteY27" fmla="*/ 1238562 h 2671846"/>
                        <a:gd name="connsiteX28" fmla="*/ 1415699 w 1676638"/>
                        <a:gd name="connsiteY28" fmla="*/ 1086162 h 2671846"/>
                        <a:gd name="connsiteX29" fmla="*/ 1631933 w 1676638"/>
                        <a:gd name="connsiteY29" fmla="*/ 1071736 h 2671846"/>
                        <a:gd name="connsiteX30" fmla="*/ 1630953 w 1676638"/>
                        <a:gd name="connsiteY30" fmla="*/ 979366 h 2671846"/>
                        <a:gd name="connsiteX31" fmla="*/ 1532785 w 1676638"/>
                        <a:gd name="connsiteY31" fmla="*/ 970136 h 2671846"/>
                        <a:gd name="connsiteX32" fmla="*/ 1415699 w 1676638"/>
                        <a:gd name="connsiteY32" fmla="*/ 954082 h 2671846"/>
                        <a:gd name="connsiteX33" fmla="*/ 1415699 w 1676638"/>
                        <a:gd name="connsiteY33" fmla="*/ 893122 h 2671846"/>
                        <a:gd name="connsiteX34" fmla="*/ 1415699 w 1676638"/>
                        <a:gd name="connsiteY34" fmla="*/ 913442 h 2671846"/>
                        <a:gd name="connsiteX35" fmla="*/ 1529632 w 1676638"/>
                        <a:gd name="connsiteY35" fmla="*/ 906229 h 2671846"/>
                        <a:gd name="connsiteX36" fmla="*/ 1583049 w 1676638"/>
                        <a:gd name="connsiteY36" fmla="*/ 902863 h 2671846"/>
                        <a:gd name="connsiteX37" fmla="*/ 1612110 w 1676638"/>
                        <a:gd name="connsiteY37" fmla="*/ 901807 h 2671846"/>
                        <a:gd name="connsiteX38" fmla="*/ 1649464 w 1676638"/>
                        <a:gd name="connsiteY38" fmla="*/ 883827 h 2671846"/>
                        <a:gd name="connsiteX39" fmla="*/ 1657572 w 1676638"/>
                        <a:gd name="connsiteY39" fmla="*/ 852533 h 2671846"/>
                        <a:gd name="connsiteX40" fmla="*/ 1674782 w 1676638"/>
                        <a:gd name="connsiteY40" fmla="*/ 702927 h 2671846"/>
                        <a:gd name="connsiteX41" fmla="*/ 1608584 w 1676638"/>
                        <a:gd name="connsiteY41" fmla="*/ 718933 h 2671846"/>
                        <a:gd name="connsiteX42" fmla="*/ 1510151 w 1676638"/>
                        <a:gd name="connsiteY42" fmla="*/ 752825 h 2671846"/>
                        <a:gd name="connsiteX43" fmla="*/ 1415699 w 1676638"/>
                        <a:gd name="connsiteY43" fmla="*/ 750882 h 2671846"/>
                        <a:gd name="connsiteX0" fmla="*/ 1415699 w 1657762"/>
                        <a:gd name="connsiteY0" fmla="*/ 750882 h 2671846"/>
                        <a:gd name="connsiteX1" fmla="*/ 1273459 w 1657762"/>
                        <a:gd name="connsiteY1" fmla="*/ 192082 h 2671846"/>
                        <a:gd name="connsiteX2" fmla="*/ 907699 w 1657762"/>
                        <a:gd name="connsiteY2" fmla="*/ 9202 h 2671846"/>
                        <a:gd name="connsiteX3" fmla="*/ 562259 w 1657762"/>
                        <a:gd name="connsiteY3" fmla="*/ 435922 h 2671846"/>
                        <a:gd name="connsiteX4" fmla="*/ 379379 w 1657762"/>
                        <a:gd name="connsiteY4" fmla="*/ 954082 h 2671846"/>
                        <a:gd name="connsiteX5" fmla="*/ 298099 w 1657762"/>
                        <a:gd name="connsiteY5" fmla="*/ 1330002 h 2671846"/>
                        <a:gd name="connsiteX6" fmla="*/ 577725 w 1657762"/>
                        <a:gd name="connsiteY6" fmla="*/ 1308839 h 2671846"/>
                        <a:gd name="connsiteX7" fmla="*/ 785779 w 1657762"/>
                        <a:gd name="connsiteY7" fmla="*/ 1299522 h 2671846"/>
                        <a:gd name="connsiteX8" fmla="*/ 1039779 w 1657762"/>
                        <a:gd name="connsiteY8" fmla="*/ 1238562 h 2671846"/>
                        <a:gd name="connsiteX9" fmla="*/ 1192179 w 1657762"/>
                        <a:gd name="connsiteY9" fmla="*/ 1136962 h 2671846"/>
                        <a:gd name="connsiteX10" fmla="*/ 1283619 w 1657762"/>
                        <a:gd name="connsiteY10" fmla="*/ 1004882 h 2671846"/>
                        <a:gd name="connsiteX11" fmla="*/ 1306392 w 1657762"/>
                        <a:gd name="connsiteY11" fmla="*/ 953917 h 2671846"/>
                        <a:gd name="connsiteX12" fmla="*/ 1226412 w 1657762"/>
                        <a:gd name="connsiteY12" fmla="*/ 1123422 h 2671846"/>
                        <a:gd name="connsiteX13" fmla="*/ 1070259 w 1657762"/>
                        <a:gd name="connsiteY13" fmla="*/ 1250417 h 2671846"/>
                        <a:gd name="connsiteX14" fmla="*/ 810953 w 1657762"/>
                        <a:gd name="connsiteY14" fmla="*/ 1314767 h 2671846"/>
                        <a:gd name="connsiteX15" fmla="*/ 247299 w 1657762"/>
                        <a:gd name="connsiteY15" fmla="*/ 1401122 h 2671846"/>
                        <a:gd name="connsiteX16" fmla="*/ 84739 w 1657762"/>
                        <a:gd name="connsiteY16" fmla="*/ 1919282 h 2671846"/>
                        <a:gd name="connsiteX17" fmla="*/ 22679 w 1657762"/>
                        <a:gd name="connsiteY17" fmla="*/ 2323987 h 2671846"/>
                        <a:gd name="connsiteX18" fmla="*/ 9412 w 1657762"/>
                        <a:gd name="connsiteY18" fmla="*/ 2467922 h 2671846"/>
                        <a:gd name="connsiteX19" fmla="*/ 24685 w 1657762"/>
                        <a:gd name="connsiteY19" fmla="*/ 2653340 h 2671846"/>
                        <a:gd name="connsiteX20" fmla="*/ 277779 w 1657762"/>
                        <a:gd name="connsiteY20" fmla="*/ 2665014 h 2671846"/>
                        <a:gd name="connsiteX21" fmla="*/ 622861 w 1657762"/>
                        <a:gd name="connsiteY21" fmla="*/ 2651175 h 2671846"/>
                        <a:gd name="connsiteX22" fmla="*/ 885229 w 1657762"/>
                        <a:gd name="connsiteY22" fmla="*/ 2613018 h 2671846"/>
                        <a:gd name="connsiteX23" fmla="*/ 1184064 w 1657762"/>
                        <a:gd name="connsiteY23" fmla="*/ 2484750 h 2671846"/>
                        <a:gd name="connsiteX24" fmla="*/ 1334419 w 1657762"/>
                        <a:gd name="connsiteY24" fmla="*/ 2254562 h 2671846"/>
                        <a:gd name="connsiteX25" fmla="*/ 1415699 w 1657762"/>
                        <a:gd name="connsiteY25" fmla="*/ 1959922 h 2671846"/>
                        <a:gd name="connsiteX26" fmla="*/ 1425859 w 1657762"/>
                        <a:gd name="connsiteY26" fmla="*/ 1573842 h 2671846"/>
                        <a:gd name="connsiteX27" fmla="*/ 1407092 w 1657762"/>
                        <a:gd name="connsiteY27" fmla="*/ 1238562 h 2671846"/>
                        <a:gd name="connsiteX28" fmla="*/ 1415699 w 1657762"/>
                        <a:gd name="connsiteY28" fmla="*/ 1086162 h 2671846"/>
                        <a:gd name="connsiteX29" fmla="*/ 1631933 w 1657762"/>
                        <a:gd name="connsiteY29" fmla="*/ 1071736 h 2671846"/>
                        <a:gd name="connsiteX30" fmla="*/ 1630953 w 1657762"/>
                        <a:gd name="connsiteY30" fmla="*/ 979366 h 2671846"/>
                        <a:gd name="connsiteX31" fmla="*/ 1532785 w 1657762"/>
                        <a:gd name="connsiteY31" fmla="*/ 970136 h 2671846"/>
                        <a:gd name="connsiteX32" fmla="*/ 1415699 w 1657762"/>
                        <a:gd name="connsiteY32" fmla="*/ 954082 h 2671846"/>
                        <a:gd name="connsiteX33" fmla="*/ 1415699 w 1657762"/>
                        <a:gd name="connsiteY33" fmla="*/ 893122 h 2671846"/>
                        <a:gd name="connsiteX34" fmla="*/ 1415699 w 1657762"/>
                        <a:gd name="connsiteY34" fmla="*/ 913442 h 2671846"/>
                        <a:gd name="connsiteX35" fmla="*/ 1529632 w 1657762"/>
                        <a:gd name="connsiteY35" fmla="*/ 906229 h 2671846"/>
                        <a:gd name="connsiteX36" fmla="*/ 1583049 w 1657762"/>
                        <a:gd name="connsiteY36" fmla="*/ 902863 h 2671846"/>
                        <a:gd name="connsiteX37" fmla="*/ 1612110 w 1657762"/>
                        <a:gd name="connsiteY37" fmla="*/ 901807 h 2671846"/>
                        <a:gd name="connsiteX38" fmla="*/ 1649464 w 1657762"/>
                        <a:gd name="connsiteY38" fmla="*/ 883827 h 2671846"/>
                        <a:gd name="connsiteX39" fmla="*/ 1657572 w 1657762"/>
                        <a:gd name="connsiteY39" fmla="*/ 852533 h 2671846"/>
                        <a:gd name="connsiteX40" fmla="*/ 1650819 w 1657762"/>
                        <a:gd name="connsiteY40" fmla="*/ 757217 h 2671846"/>
                        <a:gd name="connsiteX41" fmla="*/ 1608584 w 1657762"/>
                        <a:gd name="connsiteY41" fmla="*/ 718933 h 2671846"/>
                        <a:gd name="connsiteX42" fmla="*/ 1510151 w 1657762"/>
                        <a:gd name="connsiteY42" fmla="*/ 752825 h 2671846"/>
                        <a:gd name="connsiteX43" fmla="*/ 1415699 w 1657762"/>
                        <a:gd name="connsiteY43" fmla="*/ 750882 h 2671846"/>
                        <a:gd name="connsiteX0" fmla="*/ 1415699 w 1657700"/>
                        <a:gd name="connsiteY0" fmla="*/ 750882 h 2671846"/>
                        <a:gd name="connsiteX1" fmla="*/ 1273459 w 1657700"/>
                        <a:gd name="connsiteY1" fmla="*/ 192082 h 2671846"/>
                        <a:gd name="connsiteX2" fmla="*/ 907699 w 1657700"/>
                        <a:gd name="connsiteY2" fmla="*/ 9202 h 2671846"/>
                        <a:gd name="connsiteX3" fmla="*/ 562259 w 1657700"/>
                        <a:gd name="connsiteY3" fmla="*/ 435922 h 2671846"/>
                        <a:gd name="connsiteX4" fmla="*/ 379379 w 1657700"/>
                        <a:gd name="connsiteY4" fmla="*/ 954082 h 2671846"/>
                        <a:gd name="connsiteX5" fmla="*/ 298099 w 1657700"/>
                        <a:gd name="connsiteY5" fmla="*/ 1330002 h 2671846"/>
                        <a:gd name="connsiteX6" fmla="*/ 577725 w 1657700"/>
                        <a:gd name="connsiteY6" fmla="*/ 1308839 h 2671846"/>
                        <a:gd name="connsiteX7" fmla="*/ 785779 w 1657700"/>
                        <a:gd name="connsiteY7" fmla="*/ 1299522 h 2671846"/>
                        <a:gd name="connsiteX8" fmla="*/ 1039779 w 1657700"/>
                        <a:gd name="connsiteY8" fmla="*/ 1238562 h 2671846"/>
                        <a:gd name="connsiteX9" fmla="*/ 1192179 w 1657700"/>
                        <a:gd name="connsiteY9" fmla="*/ 1136962 h 2671846"/>
                        <a:gd name="connsiteX10" fmla="*/ 1283619 w 1657700"/>
                        <a:gd name="connsiteY10" fmla="*/ 1004882 h 2671846"/>
                        <a:gd name="connsiteX11" fmla="*/ 1306392 w 1657700"/>
                        <a:gd name="connsiteY11" fmla="*/ 953917 h 2671846"/>
                        <a:gd name="connsiteX12" fmla="*/ 1226412 w 1657700"/>
                        <a:gd name="connsiteY12" fmla="*/ 1123422 h 2671846"/>
                        <a:gd name="connsiteX13" fmla="*/ 1070259 w 1657700"/>
                        <a:gd name="connsiteY13" fmla="*/ 1250417 h 2671846"/>
                        <a:gd name="connsiteX14" fmla="*/ 810953 w 1657700"/>
                        <a:gd name="connsiteY14" fmla="*/ 1314767 h 2671846"/>
                        <a:gd name="connsiteX15" fmla="*/ 247299 w 1657700"/>
                        <a:gd name="connsiteY15" fmla="*/ 1401122 h 2671846"/>
                        <a:gd name="connsiteX16" fmla="*/ 84739 w 1657700"/>
                        <a:gd name="connsiteY16" fmla="*/ 1919282 h 2671846"/>
                        <a:gd name="connsiteX17" fmla="*/ 22679 w 1657700"/>
                        <a:gd name="connsiteY17" fmla="*/ 2323987 h 2671846"/>
                        <a:gd name="connsiteX18" fmla="*/ 9412 w 1657700"/>
                        <a:gd name="connsiteY18" fmla="*/ 2467922 h 2671846"/>
                        <a:gd name="connsiteX19" fmla="*/ 24685 w 1657700"/>
                        <a:gd name="connsiteY19" fmla="*/ 2653340 h 2671846"/>
                        <a:gd name="connsiteX20" fmla="*/ 277779 w 1657700"/>
                        <a:gd name="connsiteY20" fmla="*/ 2665014 h 2671846"/>
                        <a:gd name="connsiteX21" fmla="*/ 622861 w 1657700"/>
                        <a:gd name="connsiteY21" fmla="*/ 2651175 h 2671846"/>
                        <a:gd name="connsiteX22" fmla="*/ 885229 w 1657700"/>
                        <a:gd name="connsiteY22" fmla="*/ 2613018 h 2671846"/>
                        <a:gd name="connsiteX23" fmla="*/ 1184064 w 1657700"/>
                        <a:gd name="connsiteY23" fmla="*/ 2484750 h 2671846"/>
                        <a:gd name="connsiteX24" fmla="*/ 1334419 w 1657700"/>
                        <a:gd name="connsiteY24" fmla="*/ 2254562 h 2671846"/>
                        <a:gd name="connsiteX25" fmla="*/ 1415699 w 1657700"/>
                        <a:gd name="connsiteY25" fmla="*/ 1959922 h 2671846"/>
                        <a:gd name="connsiteX26" fmla="*/ 1425859 w 1657700"/>
                        <a:gd name="connsiteY26" fmla="*/ 1573842 h 2671846"/>
                        <a:gd name="connsiteX27" fmla="*/ 1407092 w 1657700"/>
                        <a:gd name="connsiteY27" fmla="*/ 1238562 h 2671846"/>
                        <a:gd name="connsiteX28" fmla="*/ 1415699 w 1657700"/>
                        <a:gd name="connsiteY28" fmla="*/ 1086162 h 2671846"/>
                        <a:gd name="connsiteX29" fmla="*/ 1631933 w 1657700"/>
                        <a:gd name="connsiteY29" fmla="*/ 1071736 h 2671846"/>
                        <a:gd name="connsiteX30" fmla="*/ 1630953 w 1657700"/>
                        <a:gd name="connsiteY30" fmla="*/ 979366 h 2671846"/>
                        <a:gd name="connsiteX31" fmla="*/ 1532785 w 1657700"/>
                        <a:gd name="connsiteY31" fmla="*/ 970136 h 2671846"/>
                        <a:gd name="connsiteX32" fmla="*/ 1415699 w 1657700"/>
                        <a:gd name="connsiteY32" fmla="*/ 954082 h 2671846"/>
                        <a:gd name="connsiteX33" fmla="*/ 1415699 w 1657700"/>
                        <a:gd name="connsiteY33" fmla="*/ 893122 h 2671846"/>
                        <a:gd name="connsiteX34" fmla="*/ 1415699 w 1657700"/>
                        <a:gd name="connsiteY34" fmla="*/ 913442 h 2671846"/>
                        <a:gd name="connsiteX35" fmla="*/ 1529632 w 1657700"/>
                        <a:gd name="connsiteY35" fmla="*/ 906229 h 2671846"/>
                        <a:gd name="connsiteX36" fmla="*/ 1583049 w 1657700"/>
                        <a:gd name="connsiteY36" fmla="*/ 902863 h 2671846"/>
                        <a:gd name="connsiteX37" fmla="*/ 1612110 w 1657700"/>
                        <a:gd name="connsiteY37" fmla="*/ 901807 h 2671846"/>
                        <a:gd name="connsiteX38" fmla="*/ 1649464 w 1657700"/>
                        <a:gd name="connsiteY38" fmla="*/ 883827 h 2671846"/>
                        <a:gd name="connsiteX39" fmla="*/ 1657572 w 1657700"/>
                        <a:gd name="connsiteY39" fmla="*/ 852533 h 2671846"/>
                        <a:gd name="connsiteX40" fmla="*/ 1650819 w 1657700"/>
                        <a:gd name="connsiteY40" fmla="*/ 757217 h 2671846"/>
                        <a:gd name="connsiteX41" fmla="*/ 1611247 w 1657700"/>
                        <a:gd name="connsiteY41" fmla="*/ 761590 h 2671846"/>
                        <a:gd name="connsiteX42" fmla="*/ 1510151 w 1657700"/>
                        <a:gd name="connsiteY42" fmla="*/ 752825 h 2671846"/>
                        <a:gd name="connsiteX43" fmla="*/ 1415699 w 1657700"/>
                        <a:gd name="connsiteY43" fmla="*/ 750882 h 2671846"/>
                        <a:gd name="connsiteX0" fmla="*/ 1415699 w 1657700"/>
                        <a:gd name="connsiteY0" fmla="*/ 750882 h 2671846"/>
                        <a:gd name="connsiteX1" fmla="*/ 1273459 w 1657700"/>
                        <a:gd name="connsiteY1" fmla="*/ 192082 h 2671846"/>
                        <a:gd name="connsiteX2" fmla="*/ 907699 w 1657700"/>
                        <a:gd name="connsiteY2" fmla="*/ 9202 h 2671846"/>
                        <a:gd name="connsiteX3" fmla="*/ 562259 w 1657700"/>
                        <a:gd name="connsiteY3" fmla="*/ 435922 h 2671846"/>
                        <a:gd name="connsiteX4" fmla="*/ 379379 w 1657700"/>
                        <a:gd name="connsiteY4" fmla="*/ 954082 h 2671846"/>
                        <a:gd name="connsiteX5" fmla="*/ 298099 w 1657700"/>
                        <a:gd name="connsiteY5" fmla="*/ 1330002 h 2671846"/>
                        <a:gd name="connsiteX6" fmla="*/ 577725 w 1657700"/>
                        <a:gd name="connsiteY6" fmla="*/ 1308839 h 2671846"/>
                        <a:gd name="connsiteX7" fmla="*/ 785779 w 1657700"/>
                        <a:gd name="connsiteY7" fmla="*/ 1299522 h 2671846"/>
                        <a:gd name="connsiteX8" fmla="*/ 1039779 w 1657700"/>
                        <a:gd name="connsiteY8" fmla="*/ 1238562 h 2671846"/>
                        <a:gd name="connsiteX9" fmla="*/ 1192179 w 1657700"/>
                        <a:gd name="connsiteY9" fmla="*/ 1136962 h 2671846"/>
                        <a:gd name="connsiteX10" fmla="*/ 1283619 w 1657700"/>
                        <a:gd name="connsiteY10" fmla="*/ 1004882 h 2671846"/>
                        <a:gd name="connsiteX11" fmla="*/ 1306392 w 1657700"/>
                        <a:gd name="connsiteY11" fmla="*/ 953917 h 2671846"/>
                        <a:gd name="connsiteX12" fmla="*/ 1226412 w 1657700"/>
                        <a:gd name="connsiteY12" fmla="*/ 1123422 h 2671846"/>
                        <a:gd name="connsiteX13" fmla="*/ 1070259 w 1657700"/>
                        <a:gd name="connsiteY13" fmla="*/ 1250417 h 2671846"/>
                        <a:gd name="connsiteX14" fmla="*/ 810953 w 1657700"/>
                        <a:gd name="connsiteY14" fmla="*/ 1314767 h 2671846"/>
                        <a:gd name="connsiteX15" fmla="*/ 247299 w 1657700"/>
                        <a:gd name="connsiteY15" fmla="*/ 1401122 h 2671846"/>
                        <a:gd name="connsiteX16" fmla="*/ 84739 w 1657700"/>
                        <a:gd name="connsiteY16" fmla="*/ 1919282 h 2671846"/>
                        <a:gd name="connsiteX17" fmla="*/ 22679 w 1657700"/>
                        <a:gd name="connsiteY17" fmla="*/ 2323987 h 2671846"/>
                        <a:gd name="connsiteX18" fmla="*/ 9412 w 1657700"/>
                        <a:gd name="connsiteY18" fmla="*/ 2467922 h 2671846"/>
                        <a:gd name="connsiteX19" fmla="*/ 24685 w 1657700"/>
                        <a:gd name="connsiteY19" fmla="*/ 2653340 h 2671846"/>
                        <a:gd name="connsiteX20" fmla="*/ 277779 w 1657700"/>
                        <a:gd name="connsiteY20" fmla="*/ 2665014 h 2671846"/>
                        <a:gd name="connsiteX21" fmla="*/ 622861 w 1657700"/>
                        <a:gd name="connsiteY21" fmla="*/ 2651175 h 2671846"/>
                        <a:gd name="connsiteX22" fmla="*/ 885229 w 1657700"/>
                        <a:gd name="connsiteY22" fmla="*/ 2613018 h 2671846"/>
                        <a:gd name="connsiteX23" fmla="*/ 1184064 w 1657700"/>
                        <a:gd name="connsiteY23" fmla="*/ 2484750 h 2671846"/>
                        <a:gd name="connsiteX24" fmla="*/ 1334419 w 1657700"/>
                        <a:gd name="connsiteY24" fmla="*/ 2254562 h 2671846"/>
                        <a:gd name="connsiteX25" fmla="*/ 1415699 w 1657700"/>
                        <a:gd name="connsiteY25" fmla="*/ 1959922 h 2671846"/>
                        <a:gd name="connsiteX26" fmla="*/ 1425859 w 1657700"/>
                        <a:gd name="connsiteY26" fmla="*/ 1573842 h 2671846"/>
                        <a:gd name="connsiteX27" fmla="*/ 1407092 w 1657700"/>
                        <a:gd name="connsiteY27" fmla="*/ 1238562 h 2671846"/>
                        <a:gd name="connsiteX28" fmla="*/ 1415699 w 1657700"/>
                        <a:gd name="connsiteY28" fmla="*/ 1086162 h 2671846"/>
                        <a:gd name="connsiteX29" fmla="*/ 1631933 w 1657700"/>
                        <a:gd name="connsiteY29" fmla="*/ 1071736 h 2671846"/>
                        <a:gd name="connsiteX30" fmla="*/ 1630953 w 1657700"/>
                        <a:gd name="connsiteY30" fmla="*/ 979366 h 2671846"/>
                        <a:gd name="connsiteX31" fmla="*/ 1532785 w 1657700"/>
                        <a:gd name="connsiteY31" fmla="*/ 970136 h 2671846"/>
                        <a:gd name="connsiteX32" fmla="*/ 1415699 w 1657700"/>
                        <a:gd name="connsiteY32" fmla="*/ 954082 h 2671846"/>
                        <a:gd name="connsiteX33" fmla="*/ 1415699 w 1657700"/>
                        <a:gd name="connsiteY33" fmla="*/ 893122 h 2671846"/>
                        <a:gd name="connsiteX34" fmla="*/ 1415699 w 1657700"/>
                        <a:gd name="connsiteY34" fmla="*/ 913442 h 2671846"/>
                        <a:gd name="connsiteX35" fmla="*/ 1529632 w 1657700"/>
                        <a:gd name="connsiteY35" fmla="*/ 906229 h 2671846"/>
                        <a:gd name="connsiteX36" fmla="*/ 1583049 w 1657700"/>
                        <a:gd name="connsiteY36" fmla="*/ 902863 h 2671846"/>
                        <a:gd name="connsiteX37" fmla="*/ 1612110 w 1657700"/>
                        <a:gd name="connsiteY37" fmla="*/ 901807 h 2671846"/>
                        <a:gd name="connsiteX38" fmla="*/ 1649464 w 1657700"/>
                        <a:gd name="connsiteY38" fmla="*/ 883827 h 2671846"/>
                        <a:gd name="connsiteX39" fmla="*/ 1657572 w 1657700"/>
                        <a:gd name="connsiteY39" fmla="*/ 852533 h 2671846"/>
                        <a:gd name="connsiteX40" fmla="*/ 1650819 w 1657700"/>
                        <a:gd name="connsiteY40" fmla="*/ 757217 h 2671846"/>
                        <a:gd name="connsiteX41" fmla="*/ 1611247 w 1657700"/>
                        <a:gd name="connsiteY41" fmla="*/ 761590 h 2671846"/>
                        <a:gd name="connsiteX42" fmla="*/ 1510151 w 1657700"/>
                        <a:gd name="connsiteY42" fmla="*/ 779970 h 2671846"/>
                        <a:gd name="connsiteX43" fmla="*/ 1415699 w 1657700"/>
                        <a:gd name="connsiteY43" fmla="*/ 750882 h 2671846"/>
                        <a:gd name="connsiteX0" fmla="*/ 1415699 w 1657762"/>
                        <a:gd name="connsiteY0" fmla="*/ 750882 h 2671846"/>
                        <a:gd name="connsiteX1" fmla="*/ 1273459 w 1657762"/>
                        <a:gd name="connsiteY1" fmla="*/ 192082 h 2671846"/>
                        <a:gd name="connsiteX2" fmla="*/ 907699 w 1657762"/>
                        <a:gd name="connsiteY2" fmla="*/ 9202 h 2671846"/>
                        <a:gd name="connsiteX3" fmla="*/ 562259 w 1657762"/>
                        <a:gd name="connsiteY3" fmla="*/ 435922 h 2671846"/>
                        <a:gd name="connsiteX4" fmla="*/ 379379 w 1657762"/>
                        <a:gd name="connsiteY4" fmla="*/ 954082 h 2671846"/>
                        <a:gd name="connsiteX5" fmla="*/ 298099 w 1657762"/>
                        <a:gd name="connsiteY5" fmla="*/ 1330002 h 2671846"/>
                        <a:gd name="connsiteX6" fmla="*/ 577725 w 1657762"/>
                        <a:gd name="connsiteY6" fmla="*/ 1308839 h 2671846"/>
                        <a:gd name="connsiteX7" fmla="*/ 785779 w 1657762"/>
                        <a:gd name="connsiteY7" fmla="*/ 1299522 h 2671846"/>
                        <a:gd name="connsiteX8" fmla="*/ 1039779 w 1657762"/>
                        <a:gd name="connsiteY8" fmla="*/ 1238562 h 2671846"/>
                        <a:gd name="connsiteX9" fmla="*/ 1192179 w 1657762"/>
                        <a:gd name="connsiteY9" fmla="*/ 1136962 h 2671846"/>
                        <a:gd name="connsiteX10" fmla="*/ 1283619 w 1657762"/>
                        <a:gd name="connsiteY10" fmla="*/ 1004882 h 2671846"/>
                        <a:gd name="connsiteX11" fmla="*/ 1306392 w 1657762"/>
                        <a:gd name="connsiteY11" fmla="*/ 953917 h 2671846"/>
                        <a:gd name="connsiteX12" fmla="*/ 1226412 w 1657762"/>
                        <a:gd name="connsiteY12" fmla="*/ 1123422 h 2671846"/>
                        <a:gd name="connsiteX13" fmla="*/ 1070259 w 1657762"/>
                        <a:gd name="connsiteY13" fmla="*/ 1250417 h 2671846"/>
                        <a:gd name="connsiteX14" fmla="*/ 810953 w 1657762"/>
                        <a:gd name="connsiteY14" fmla="*/ 1314767 h 2671846"/>
                        <a:gd name="connsiteX15" fmla="*/ 247299 w 1657762"/>
                        <a:gd name="connsiteY15" fmla="*/ 1401122 h 2671846"/>
                        <a:gd name="connsiteX16" fmla="*/ 84739 w 1657762"/>
                        <a:gd name="connsiteY16" fmla="*/ 1919282 h 2671846"/>
                        <a:gd name="connsiteX17" fmla="*/ 22679 w 1657762"/>
                        <a:gd name="connsiteY17" fmla="*/ 2323987 h 2671846"/>
                        <a:gd name="connsiteX18" fmla="*/ 9412 w 1657762"/>
                        <a:gd name="connsiteY18" fmla="*/ 2467922 h 2671846"/>
                        <a:gd name="connsiteX19" fmla="*/ 24685 w 1657762"/>
                        <a:gd name="connsiteY19" fmla="*/ 2653340 h 2671846"/>
                        <a:gd name="connsiteX20" fmla="*/ 277779 w 1657762"/>
                        <a:gd name="connsiteY20" fmla="*/ 2665014 h 2671846"/>
                        <a:gd name="connsiteX21" fmla="*/ 622861 w 1657762"/>
                        <a:gd name="connsiteY21" fmla="*/ 2651175 h 2671846"/>
                        <a:gd name="connsiteX22" fmla="*/ 885229 w 1657762"/>
                        <a:gd name="connsiteY22" fmla="*/ 2613018 h 2671846"/>
                        <a:gd name="connsiteX23" fmla="*/ 1184064 w 1657762"/>
                        <a:gd name="connsiteY23" fmla="*/ 2484750 h 2671846"/>
                        <a:gd name="connsiteX24" fmla="*/ 1334419 w 1657762"/>
                        <a:gd name="connsiteY24" fmla="*/ 2254562 h 2671846"/>
                        <a:gd name="connsiteX25" fmla="*/ 1415699 w 1657762"/>
                        <a:gd name="connsiteY25" fmla="*/ 1959922 h 2671846"/>
                        <a:gd name="connsiteX26" fmla="*/ 1425859 w 1657762"/>
                        <a:gd name="connsiteY26" fmla="*/ 1573842 h 2671846"/>
                        <a:gd name="connsiteX27" fmla="*/ 1407092 w 1657762"/>
                        <a:gd name="connsiteY27" fmla="*/ 1238562 h 2671846"/>
                        <a:gd name="connsiteX28" fmla="*/ 1415699 w 1657762"/>
                        <a:gd name="connsiteY28" fmla="*/ 1086162 h 2671846"/>
                        <a:gd name="connsiteX29" fmla="*/ 1631933 w 1657762"/>
                        <a:gd name="connsiteY29" fmla="*/ 1071736 h 2671846"/>
                        <a:gd name="connsiteX30" fmla="*/ 1630953 w 1657762"/>
                        <a:gd name="connsiteY30" fmla="*/ 979366 h 2671846"/>
                        <a:gd name="connsiteX31" fmla="*/ 1532785 w 1657762"/>
                        <a:gd name="connsiteY31" fmla="*/ 970136 h 2671846"/>
                        <a:gd name="connsiteX32" fmla="*/ 1415699 w 1657762"/>
                        <a:gd name="connsiteY32" fmla="*/ 954082 h 2671846"/>
                        <a:gd name="connsiteX33" fmla="*/ 1415699 w 1657762"/>
                        <a:gd name="connsiteY33" fmla="*/ 893122 h 2671846"/>
                        <a:gd name="connsiteX34" fmla="*/ 1415699 w 1657762"/>
                        <a:gd name="connsiteY34" fmla="*/ 913442 h 2671846"/>
                        <a:gd name="connsiteX35" fmla="*/ 1529632 w 1657762"/>
                        <a:gd name="connsiteY35" fmla="*/ 906229 h 2671846"/>
                        <a:gd name="connsiteX36" fmla="*/ 1583049 w 1657762"/>
                        <a:gd name="connsiteY36" fmla="*/ 902863 h 2671846"/>
                        <a:gd name="connsiteX37" fmla="*/ 1612110 w 1657762"/>
                        <a:gd name="connsiteY37" fmla="*/ 901807 h 2671846"/>
                        <a:gd name="connsiteX38" fmla="*/ 1649464 w 1657762"/>
                        <a:gd name="connsiteY38" fmla="*/ 883827 h 2671846"/>
                        <a:gd name="connsiteX39" fmla="*/ 1657572 w 1657762"/>
                        <a:gd name="connsiteY39" fmla="*/ 852533 h 2671846"/>
                        <a:gd name="connsiteX40" fmla="*/ 1650819 w 1657762"/>
                        <a:gd name="connsiteY40" fmla="*/ 757217 h 2671846"/>
                        <a:gd name="connsiteX41" fmla="*/ 1608584 w 1657762"/>
                        <a:gd name="connsiteY41" fmla="*/ 780979 h 2671846"/>
                        <a:gd name="connsiteX42" fmla="*/ 1510151 w 1657762"/>
                        <a:gd name="connsiteY42" fmla="*/ 779970 h 2671846"/>
                        <a:gd name="connsiteX43" fmla="*/ 1415699 w 1657762"/>
                        <a:gd name="connsiteY43" fmla="*/ 750882 h 2671846"/>
                        <a:gd name="connsiteX0" fmla="*/ 1415699 w 1657762"/>
                        <a:gd name="connsiteY0" fmla="*/ 750882 h 2671846"/>
                        <a:gd name="connsiteX1" fmla="*/ 1273459 w 1657762"/>
                        <a:gd name="connsiteY1" fmla="*/ 192082 h 2671846"/>
                        <a:gd name="connsiteX2" fmla="*/ 907699 w 1657762"/>
                        <a:gd name="connsiteY2" fmla="*/ 9202 h 2671846"/>
                        <a:gd name="connsiteX3" fmla="*/ 562259 w 1657762"/>
                        <a:gd name="connsiteY3" fmla="*/ 435922 h 2671846"/>
                        <a:gd name="connsiteX4" fmla="*/ 379379 w 1657762"/>
                        <a:gd name="connsiteY4" fmla="*/ 954082 h 2671846"/>
                        <a:gd name="connsiteX5" fmla="*/ 298099 w 1657762"/>
                        <a:gd name="connsiteY5" fmla="*/ 1330002 h 2671846"/>
                        <a:gd name="connsiteX6" fmla="*/ 577725 w 1657762"/>
                        <a:gd name="connsiteY6" fmla="*/ 1308839 h 2671846"/>
                        <a:gd name="connsiteX7" fmla="*/ 785779 w 1657762"/>
                        <a:gd name="connsiteY7" fmla="*/ 1299522 h 2671846"/>
                        <a:gd name="connsiteX8" fmla="*/ 1039779 w 1657762"/>
                        <a:gd name="connsiteY8" fmla="*/ 1238562 h 2671846"/>
                        <a:gd name="connsiteX9" fmla="*/ 1192179 w 1657762"/>
                        <a:gd name="connsiteY9" fmla="*/ 1136962 h 2671846"/>
                        <a:gd name="connsiteX10" fmla="*/ 1283619 w 1657762"/>
                        <a:gd name="connsiteY10" fmla="*/ 1004882 h 2671846"/>
                        <a:gd name="connsiteX11" fmla="*/ 1306392 w 1657762"/>
                        <a:gd name="connsiteY11" fmla="*/ 953917 h 2671846"/>
                        <a:gd name="connsiteX12" fmla="*/ 1226412 w 1657762"/>
                        <a:gd name="connsiteY12" fmla="*/ 1123422 h 2671846"/>
                        <a:gd name="connsiteX13" fmla="*/ 1070259 w 1657762"/>
                        <a:gd name="connsiteY13" fmla="*/ 1250417 h 2671846"/>
                        <a:gd name="connsiteX14" fmla="*/ 810953 w 1657762"/>
                        <a:gd name="connsiteY14" fmla="*/ 1314767 h 2671846"/>
                        <a:gd name="connsiteX15" fmla="*/ 247299 w 1657762"/>
                        <a:gd name="connsiteY15" fmla="*/ 1401122 h 2671846"/>
                        <a:gd name="connsiteX16" fmla="*/ 84739 w 1657762"/>
                        <a:gd name="connsiteY16" fmla="*/ 1919282 h 2671846"/>
                        <a:gd name="connsiteX17" fmla="*/ 22679 w 1657762"/>
                        <a:gd name="connsiteY17" fmla="*/ 2323987 h 2671846"/>
                        <a:gd name="connsiteX18" fmla="*/ 9412 w 1657762"/>
                        <a:gd name="connsiteY18" fmla="*/ 2467922 h 2671846"/>
                        <a:gd name="connsiteX19" fmla="*/ 24685 w 1657762"/>
                        <a:gd name="connsiteY19" fmla="*/ 2653340 h 2671846"/>
                        <a:gd name="connsiteX20" fmla="*/ 277779 w 1657762"/>
                        <a:gd name="connsiteY20" fmla="*/ 2665014 h 2671846"/>
                        <a:gd name="connsiteX21" fmla="*/ 622861 w 1657762"/>
                        <a:gd name="connsiteY21" fmla="*/ 2651175 h 2671846"/>
                        <a:gd name="connsiteX22" fmla="*/ 885229 w 1657762"/>
                        <a:gd name="connsiteY22" fmla="*/ 2613018 h 2671846"/>
                        <a:gd name="connsiteX23" fmla="*/ 1184064 w 1657762"/>
                        <a:gd name="connsiteY23" fmla="*/ 2484750 h 2671846"/>
                        <a:gd name="connsiteX24" fmla="*/ 1334419 w 1657762"/>
                        <a:gd name="connsiteY24" fmla="*/ 2254562 h 2671846"/>
                        <a:gd name="connsiteX25" fmla="*/ 1415699 w 1657762"/>
                        <a:gd name="connsiteY25" fmla="*/ 1959922 h 2671846"/>
                        <a:gd name="connsiteX26" fmla="*/ 1425859 w 1657762"/>
                        <a:gd name="connsiteY26" fmla="*/ 1573842 h 2671846"/>
                        <a:gd name="connsiteX27" fmla="*/ 1407092 w 1657762"/>
                        <a:gd name="connsiteY27" fmla="*/ 1238562 h 2671846"/>
                        <a:gd name="connsiteX28" fmla="*/ 1415699 w 1657762"/>
                        <a:gd name="connsiteY28" fmla="*/ 1086162 h 2671846"/>
                        <a:gd name="connsiteX29" fmla="*/ 1631933 w 1657762"/>
                        <a:gd name="connsiteY29" fmla="*/ 1071736 h 2671846"/>
                        <a:gd name="connsiteX30" fmla="*/ 1630953 w 1657762"/>
                        <a:gd name="connsiteY30" fmla="*/ 979366 h 2671846"/>
                        <a:gd name="connsiteX31" fmla="*/ 1532785 w 1657762"/>
                        <a:gd name="connsiteY31" fmla="*/ 970136 h 2671846"/>
                        <a:gd name="connsiteX32" fmla="*/ 1415699 w 1657762"/>
                        <a:gd name="connsiteY32" fmla="*/ 954082 h 2671846"/>
                        <a:gd name="connsiteX33" fmla="*/ 1415699 w 1657762"/>
                        <a:gd name="connsiteY33" fmla="*/ 893122 h 2671846"/>
                        <a:gd name="connsiteX34" fmla="*/ 1415699 w 1657762"/>
                        <a:gd name="connsiteY34" fmla="*/ 913442 h 2671846"/>
                        <a:gd name="connsiteX35" fmla="*/ 1529632 w 1657762"/>
                        <a:gd name="connsiteY35" fmla="*/ 906229 h 2671846"/>
                        <a:gd name="connsiteX36" fmla="*/ 1583049 w 1657762"/>
                        <a:gd name="connsiteY36" fmla="*/ 902863 h 2671846"/>
                        <a:gd name="connsiteX37" fmla="*/ 1612110 w 1657762"/>
                        <a:gd name="connsiteY37" fmla="*/ 901807 h 2671846"/>
                        <a:gd name="connsiteX38" fmla="*/ 1649464 w 1657762"/>
                        <a:gd name="connsiteY38" fmla="*/ 883827 h 2671846"/>
                        <a:gd name="connsiteX39" fmla="*/ 1657572 w 1657762"/>
                        <a:gd name="connsiteY39" fmla="*/ 852533 h 2671846"/>
                        <a:gd name="connsiteX40" fmla="*/ 1650819 w 1657762"/>
                        <a:gd name="connsiteY40" fmla="*/ 757217 h 2671846"/>
                        <a:gd name="connsiteX41" fmla="*/ 1608584 w 1657762"/>
                        <a:gd name="connsiteY41" fmla="*/ 780979 h 2671846"/>
                        <a:gd name="connsiteX42" fmla="*/ 1510151 w 1657762"/>
                        <a:gd name="connsiteY42" fmla="*/ 795482 h 2671846"/>
                        <a:gd name="connsiteX43" fmla="*/ 1415699 w 1657762"/>
                        <a:gd name="connsiteY43" fmla="*/ 750882 h 2671846"/>
                        <a:gd name="connsiteX0" fmla="*/ 1415699 w 1657762"/>
                        <a:gd name="connsiteY0" fmla="*/ 750882 h 2671846"/>
                        <a:gd name="connsiteX1" fmla="*/ 1273459 w 1657762"/>
                        <a:gd name="connsiteY1" fmla="*/ 192082 h 2671846"/>
                        <a:gd name="connsiteX2" fmla="*/ 907699 w 1657762"/>
                        <a:gd name="connsiteY2" fmla="*/ 9202 h 2671846"/>
                        <a:gd name="connsiteX3" fmla="*/ 562259 w 1657762"/>
                        <a:gd name="connsiteY3" fmla="*/ 435922 h 2671846"/>
                        <a:gd name="connsiteX4" fmla="*/ 379379 w 1657762"/>
                        <a:gd name="connsiteY4" fmla="*/ 954082 h 2671846"/>
                        <a:gd name="connsiteX5" fmla="*/ 298099 w 1657762"/>
                        <a:gd name="connsiteY5" fmla="*/ 1330002 h 2671846"/>
                        <a:gd name="connsiteX6" fmla="*/ 577725 w 1657762"/>
                        <a:gd name="connsiteY6" fmla="*/ 1308839 h 2671846"/>
                        <a:gd name="connsiteX7" fmla="*/ 785779 w 1657762"/>
                        <a:gd name="connsiteY7" fmla="*/ 1299522 h 2671846"/>
                        <a:gd name="connsiteX8" fmla="*/ 1039779 w 1657762"/>
                        <a:gd name="connsiteY8" fmla="*/ 1238562 h 2671846"/>
                        <a:gd name="connsiteX9" fmla="*/ 1192179 w 1657762"/>
                        <a:gd name="connsiteY9" fmla="*/ 1136962 h 2671846"/>
                        <a:gd name="connsiteX10" fmla="*/ 1283619 w 1657762"/>
                        <a:gd name="connsiteY10" fmla="*/ 1004882 h 2671846"/>
                        <a:gd name="connsiteX11" fmla="*/ 1306392 w 1657762"/>
                        <a:gd name="connsiteY11" fmla="*/ 953917 h 2671846"/>
                        <a:gd name="connsiteX12" fmla="*/ 1226412 w 1657762"/>
                        <a:gd name="connsiteY12" fmla="*/ 1123422 h 2671846"/>
                        <a:gd name="connsiteX13" fmla="*/ 1070259 w 1657762"/>
                        <a:gd name="connsiteY13" fmla="*/ 1250417 h 2671846"/>
                        <a:gd name="connsiteX14" fmla="*/ 810953 w 1657762"/>
                        <a:gd name="connsiteY14" fmla="*/ 1314767 h 2671846"/>
                        <a:gd name="connsiteX15" fmla="*/ 247299 w 1657762"/>
                        <a:gd name="connsiteY15" fmla="*/ 1401122 h 2671846"/>
                        <a:gd name="connsiteX16" fmla="*/ 84739 w 1657762"/>
                        <a:gd name="connsiteY16" fmla="*/ 1919282 h 2671846"/>
                        <a:gd name="connsiteX17" fmla="*/ 22679 w 1657762"/>
                        <a:gd name="connsiteY17" fmla="*/ 2323987 h 2671846"/>
                        <a:gd name="connsiteX18" fmla="*/ 9412 w 1657762"/>
                        <a:gd name="connsiteY18" fmla="*/ 2467922 h 2671846"/>
                        <a:gd name="connsiteX19" fmla="*/ 24685 w 1657762"/>
                        <a:gd name="connsiteY19" fmla="*/ 2653340 h 2671846"/>
                        <a:gd name="connsiteX20" fmla="*/ 277779 w 1657762"/>
                        <a:gd name="connsiteY20" fmla="*/ 2665014 h 2671846"/>
                        <a:gd name="connsiteX21" fmla="*/ 622861 w 1657762"/>
                        <a:gd name="connsiteY21" fmla="*/ 2651175 h 2671846"/>
                        <a:gd name="connsiteX22" fmla="*/ 885229 w 1657762"/>
                        <a:gd name="connsiteY22" fmla="*/ 2613018 h 2671846"/>
                        <a:gd name="connsiteX23" fmla="*/ 1184064 w 1657762"/>
                        <a:gd name="connsiteY23" fmla="*/ 2484750 h 2671846"/>
                        <a:gd name="connsiteX24" fmla="*/ 1334419 w 1657762"/>
                        <a:gd name="connsiteY24" fmla="*/ 2254562 h 2671846"/>
                        <a:gd name="connsiteX25" fmla="*/ 1415699 w 1657762"/>
                        <a:gd name="connsiteY25" fmla="*/ 1959922 h 2671846"/>
                        <a:gd name="connsiteX26" fmla="*/ 1425859 w 1657762"/>
                        <a:gd name="connsiteY26" fmla="*/ 1573842 h 2671846"/>
                        <a:gd name="connsiteX27" fmla="*/ 1407092 w 1657762"/>
                        <a:gd name="connsiteY27" fmla="*/ 1238562 h 2671846"/>
                        <a:gd name="connsiteX28" fmla="*/ 1415699 w 1657762"/>
                        <a:gd name="connsiteY28" fmla="*/ 1086162 h 2671846"/>
                        <a:gd name="connsiteX29" fmla="*/ 1631933 w 1657762"/>
                        <a:gd name="connsiteY29" fmla="*/ 1071736 h 2671846"/>
                        <a:gd name="connsiteX30" fmla="*/ 1630953 w 1657762"/>
                        <a:gd name="connsiteY30" fmla="*/ 979366 h 2671846"/>
                        <a:gd name="connsiteX31" fmla="*/ 1532785 w 1657762"/>
                        <a:gd name="connsiteY31" fmla="*/ 970136 h 2671846"/>
                        <a:gd name="connsiteX32" fmla="*/ 1415699 w 1657762"/>
                        <a:gd name="connsiteY32" fmla="*/ 954082 h 2671846"/>
                        <a:gd name="connsiteX33" fmla="*/ 1415699 w 1657762"/>
                        <a:gd name="connsiteY33" fmla="*/ 893122 h 2671846"/>
                        <a:gd name="connsiteX34" fmla="*/ 1415699 w 1657762"/>
                        <a:gd name="connsiteY34" fmla="*/ 913442 h 2671846"/>
                        <a:gd name="connsiteX35" fmla="*/ 1529632 w 1657762"/>
                        <a:gd name="connsiteY35" fmla="*/ 906229 h 2671846"/>
                        <a:gd name="connsiteX36" fmla="*/ 1583049 w 1657762"/>
                        <a:gd name="connsiteY36" fmla="*/ 902863 h 2671846"/>
                        <a:gd name="connsiteX37" fmla="*/ 1612110 w 1657762"/>
                        <a:gd name="connsiteY37" fmla="*/ 901807 h 2671846"/>
                        <a:gd name="connsiteX38" fmla="*/ 1649464 w 1657762"/>
                        <a:gd name="connsiteY38" fmla="*/ 883827 h 2671846"/>
                        <a:gd name="connsiteX39" fmla="*/ 1657572 w 1657762"/>
                        <a:gd name="connsiteY39" fmla="*/ 852533 h 2671846"/>
                        <a:gd name="connsiteX40" fmla="*/ 1650819 w 1657762"/>
                        <a:gd name="connsiteY40" fmla="*/ 757217 h 2671846"/>
                        <a:gd name="connsiteX41" fmla="*/ 1608584 w 1657762"/>
                        <a:gd name="connsiteY41" fmla="*/ 780979 h 2671846"/>
                        <a:gd name="connsiteX42" fmla="*/ 1510151 w 1657762"/>
                        <a:gd name="connsiteY42" fmla="*/ 795482 h 2671846"/>
                        <a:gd name="connsiteX43" fmla="*/ 1415699 w 1657762"/>
                        <a:gd name="connsiteY43" fmla="*/ 750882 h 2671846"/>
                        <a:gd name="connsiteX0" fmla="*/ 1415699 w 1657762"/>
                        <a:gd name="connsiteY0" fmla="*/ 750882 h 2671846"/>
                        <a:gd name="connsiteX1" fmla="*/ 1273459 w 1657762"/>
                        <a:gd name="connsiteY1" fmla="*/ 192082 h 2671846"/>
                        <a:gd name="connsiteX2" fmla="*/ 907699 w 1657762"/>
                        <a:gd name="connsiteY2" fmla="*/ 9202 h 2671846"/>
                        <a:gd name="connsiteX3" fmla="*/ 562259 w 1657762"/>
                        <a:gd name="connsiteY3" fmla="*/ 435922 h 2671846"/>
                        <a:gd name="connsiteX4" fmla="*/ 379379 w 1657762"/>
                        <a:gd name="connsiteY4" fmla="*/ 954082 h 2671846"/>
                        <a:gd name="connsiteX5" fmla="*/ 298099 w 1657762"/>
                        <a:gd name="connsiteY5" fmla="*/ 1330002 h 2671846"/>
                        <a:gd name="connsiteX6" fmla="*/ 577725 w 1657762"/>
                        <a:gd name="connsiteY6" fmla="*/ 1308839 h 2671846"/>
                        <a:gd name="connsiteX7" fmla="*/ 785779 w 1657762"/>
                        <a:gd name="connsiteY7" fmla="*/ 1299522 h 2671846"/>
                        <a:gd name="connsiteX8" fmla="*/ 1039779 w 1657762"/>
                        <a:gd name="connsiteY8" fmla="*/ 1238562 h 2671846"/>
                        <a:gd name="connsiteX9" fmla="*/ 1192179 w 1657762"/>
                        <a:gd name="connsiteY9" fmla="*/ 1136962 h 2671846"/>
                        <a:gd name="connsiteX10" fmla="*/ 1283619 w 1657762"/>
                        <a:gd name="connsiteY10" fmla="*/ 1004882 h 2671846"/>
                        <a:gd name="connsiteX11" fmla="*/ 1306392 w 1657762"/>
                        <a:gd name="connsiteY11" fmla="*/ 953917 h 2671846"/>
                        <a:gd name="connsiteX12" fmla="*/ 1226412 w 1657762"/>
                        <a:gd name="connsiteY12" fmla="*/ 1123422 h 2671846"/>
                        <a:gd name="connsiteX13" fmla="*/ 1070259 w 1657762"/>
                        <a:gd name="connsiteY13" fmla="*/ 1250417 h 2671846"/>
                        <a:gd name="connsiteX14" fmla="*/ 810953 w 1657762"/>
                        <a:gd name="connsiteY14" fmla="*/ 1314767 h 2671846"/>
                        <a:gd name="connsiteX15" fmla="*/ 247299 w 1657762"/>
                        <a:gd name="connsiteY15" fmla="*/ 1401122 h 2671846"/>
                        <a:gd name="connsiteX16" fmla="*/ 84739 w 1657762"/>
                        <a:gd name="connsiteY16" fmla="*/ 1919282 h 2671846"/>
                        <a:gd name="connsiteX17" fmla="*/ 22679 w 1657762"/>
                        <a:gd name="connsiteY17" fmla="*/ 2323987 h 2671846"/>
                        <a:gd name="connsiteX18" fmla="*/ 9412 w 1657762"/>
                        <a:gd name="connsiteY18" fmla="*/ 2467922 h 2671846"/>
                        <a:gd name="connsiteX19" fmla="*/ 24685 w 1657762"/>
                        <a:gd name="connsiteY19" fmla="*/ 2653340 h 2671846"/>
                        <a:gd name="connsiteX20" fmla="*/ 277779 w 1657762"/>
                        <a:gd name="connsiteY20" fmla="*/ 2665014 h 2671846"/>
                        <a:gd name="connsiteX21" fmla="*/ 622861 w 1657762"/>
                        <a:gd name="connsiteY21" fmla="*/ 2651175 h 2671846"/>
                        <a:gd name="connsiteX22" fmla="*/ 885229 w 1657762"/>
                        <a:gd name="connsiteY22" fmla="*/ 2613018 h 2671846"/>
                        <a:gd name="connsiteX23" fmla="*/ 1184064 w 1657762"/>
                        <a:gd name="connsiteY23" fmla="*/ 2484750 h 2671846"/>
                        <a:gd name="connsiteX24" fmla="*/ 1334419 w 1657762"/>
                        <a:gd name="connsiteY24" fmla="*/ 2254562 h 2671846"/>
                        <a:gd name="connsiteX25" fmla="*/ 1415699 w 1657762"/>
                        <a:gd name="connsiteY25" fmla="*/ 1959922 h 2671846"/>
                        <a:gd name="connsiteX26" fmla="*/ 1425859 w 1657762"/>
                        <a:gd name="connsiteY26" fmla="*/ 1573842 h 2671846"/>
                        <a:gd name="connsiteX27" fmla="*/ 1407092 w 1657762"/>
                        <a:gd name="connsiteY27" fmla="*/ 1238562 h 2671846"/>
                        <a:gd name="connsiteX28" fmla="*/ 1415699 w 1657762"/>
                        <a:gd name="connsiteY28" fmla="*/ 1086162 h 2671846"/>
                        <a:gd name="connsiteX29" fmla="*/ 1631933 w 1657762"/>
                        <a:gd name="connsiteY29" fmla="*/ 1071736 h 2671846"/>
                        <a:gd name="connsiteX30" fmla="*/ 1630953 w 1657762"/>
                        <a:gd name="connsiteY30" fmla="*/ 979366 h 2671846"/>
                        <a:gd name="connsiteX31" fmla="*/ 1532785 w 1657762"/>
                        <a:gd name="connsiteY31" fmla="*/ 970136 h 2671846"/>
                        <a:gd name="connsiteX32" fmla="*/ 1415699 w 1657762"/>
                        <a:gd name="connsiteY32" fmla="*/ 954082 h 2671846"/>
                        <a:gd name="connsiteX33" fmla="*/ 1415699 w 1657762"/>
                        <a:gd name="connsiteY33" fmla="*/ 893122 h 2671846"/>
                        <a:gd name="connsiteX34" fmla="*/ 1415699 w 1657762"/>
                        <a:gd name="connsiteY34" fmla="*/ 913442 h 2671846"/>
                        <a:gd name="connsiteX35" fmla="*/ 1529632 w 1657762"/>
                        <a:gd name="connsiteY35" fmla="*/ 906229 h 2671846"/>
                        <a:gd name="connsiteX36" fmla="*/ 1583049 w 1657762"/>
                        <a:gd name="connsiteY36" fmla="*/ 902863 h 2671846"/>
                        <a:gd name="connsiteX37" fmla="*/ 1612110 w 1657762"/>
                        <a:gd name="connsiteY37" fmla="*/ 901807 h 2671846"/>
                        <a:gd name="connsiteX38" fmla="*/ 1649464 w 1657762"/>
                        <a:gd name="connsiteY38" fmla="*/ 883827 h 2671846"/>
                        <a:gd name="connsiteX39" fmla="*/ 1657572 w 1657762"/>
                        <a:gd name="connsiteY39" fmla="*/ 852533 h 2671846"/>
                        <a:gd name="connsiteX40" fmla="*/ 1650819 w 1657762"/>
                        <a:gd name="connsiteY40" fmla="*/ 757217 h 2671846"/>
                        <a:gd name="connsiteX41" fmla="*/ 1608584 w 1657762"/>
                        <a:gd name="connsiteY41" fmla="*/ 780979 h 2671846"/>
                        <a:gd name="connsiteX42" fmla="*/ 1510151 w 1657762"/>
                        <a:gd name="connsiteY42" fmla="*/ 795482 h 2671846"/>
                        <a:gd name="connsiteX43" fmla="*/ 1415699 w 1657762"/>
                        <a:gd name="connsiteY43" fmla="*/ 750882 h 2671846"/>
                        <a:gd name="connsiteX0" fmla="*/ 1415699 w 1657729"/>
                        <a:gd name="connsiteY0" fmla="*/ 750882 h 2671846"/>
                        <a:gd name="connsiteX1" fmla="*/ 1273459 w 1657729"/>
                        <a:gd name="connsiteY1" fmla="*/ 192082 h 2671846"/>
                        <a:gd name="connsiteX2" fmla="*/ 907699 w 1657729"/>
                        <a:gd name="connsiteY2" fmla="*/ 9202 h 2671846"/>
                        <a:gd name="connsiteX3" fmla="*/ 562259 w 1657729"/>
                        <a:gd name="connsiteY3" fmla="*/ 435922 h 2671846"/>
                        <a:gd name="connsiteX4" fmla="*/ 379379 w 1657729"/>
                        <a:gd name="connsiteY4" fmla="*/ 954082 h 2671846"/>
                        <a:gd name="connsiteX5" fmla="*/ 298099 w 1657729"/>
                        <a:gd name="connsiteY5" fmla="*/ 1330002 h 2671846"/>
                        <a:gd name="connsiteX6" fmla="*/ 577725 w 1657729"/>
                        <a:gd name="connsiteY6" fmla="*/ 1308839 h 2671846"/>
                        <a:gd name="connsiteX7" fmla="*/ 785779 w 1657729"/>
                        <a:gd name="connsiteY7" fmla="*/ 1299522 h 2671846"/>
                        <a:gd name="connsiteX8" fmla="*/ 1039779 w 1657729"/>
                        <a:gd name="connsiteY8" fmla="*/ 1238562 h 2671846"/>
                        <a:gd name="connsiteX9" fmla="*/ 1192179 w 1657729"/>
                        <a:gd name="connsiteY9" fmla="*/ 1136962 h 2671846"/>
                        <a:gd name="connsiteX10" fmla="*/ 1283619 w 1657729"/>
                        <a:gd name="connsiteY10" fmla="*/ 1004882 h 2671846"/>
                        <a:gd name="connsiteX11" fmla="*/ 1306392 w 1657729"/>
                        <a:gd name="connsiteY11" fmla="*/ 953917 h 2671846"/>
                        <a:gd name="connsiteX12" fmla="*/ 1226412 w 1657729"/>
                        <a:gd name="connsiteY12" fmla="*/ 1123422 h 2671846"/>
                        <a:gd name="connsiteX13" fmla="*/ 1070259 w 1657729"/>
                        <a:gd name="connsiteY13" fmla="*/ 1250417 h 2671846"/>
                        <a:gd name="connsiteX14" fmla="*/ 810953 w 1657729"/>
                        <a:gd name="connsiteY14" fmla="*/ 1314767 h 2671846"/>
                        <a:gd name="connsiteX15" fmla="*/ 247299 w 1657729"/>
                        <a:gd name="connsiteY15" fmla="*/ 1401122 h 2671846"/>
                        <a:gd name="connsiteX16" fmla="*/ 84739 w 1657729"/>
                        <a:gd name="connsiteY16" fmla="*/ 1919282 h 2671846"/>
                        <a:gd name="connsiteX17" fmla="*/ 22679 w 1657729"/>
                        <a:gd name="connsiteY17" fmla="*/ 2323987 h 2671846"/>
                        <a:gd name="connsiteX18" fmla="*/ 9412 w 1657729"/>
                        <a:gd name="connsiteY18" fmla="*/ 2467922 h 2671846"/>
                        <a:gd name="connsiteX19" fmla="*/ 24685 w 1657729"/>
                        <a:gd name="connsiteY19" fmla="*/ 2653340 h 2671846"/>
                        <a:gd name="connsiteX20" fmla="*/ 277779 w 1657729"/>
                        <a:gd name="connsiteY20" fmla="*/ 2665014 h 2671846"/>
                        <a:gd name="connsiteX21" fmla="*/ 622861 w 1657729"/>
                        <a:gd name="connsiteY21" fmla="*/ 2651175 h 2671846"/>
                        <a:gd name="connsiteX22" fmla="*/ 885229 w 1657729"/>
                        <a:gd name="connsiteY22" fmla="*/ 2613018 h 2671846"/>
                        <a:gd name="connsiteX23" fmla="*/ 1184064 w 1657729"/>
                        <a:gd name="connsiteY23" fmla="*/ 2484750 h 2671846"/>
                        <a:gd name="connsiteX24" fmla="*/ 1334419 w 1657729"/>
                        <a:gd name="connsiteY24" fmla="*/ 2254562 h 2671846"/>
                        <a:gd name="connsiteX25" fmla="*/ 1415699 w 1657729"/>
                        <a:gd name="connsiteY25" fmla="*/ 1959922 h 2671846"/>
                        <a:gd name="connsiteX26" fmla="*/ 1425859 w 1657729"/>
                        <a:gd name="connsiteY26" fmla="*/ 1573842 h 2671846"/>
                        <a:gd name="connsiteX27" fmla="*/ 1407092 w 1657729"/>
                        <a:gd name="connsiteY27" fmla="*/ 1238562 h 2671846"/>
                        <a:gd name="connsiteX28" fmla="*/ 1415699 w 1657729"/>
                        <a:gd name="connsiteY28" fmla="*/ 1086162 h 2671846"/>
                        <a:gd name="connsiteX29" fmla="*/ 1631933 w 1657729"/>
                        <a:gd name="connsiteY29" fmla="*/ 1071736 h 2671846"/>
                        <a:gd name="connsiteX30" fmla="*/ 1630953 w 1657729"/>
                        <a:gd name="connsiteY30" fmla="*/ 979366 h 2671846"/>
                        <a:gd name="connsiteX31" fmla="*/ 1532785 w 1657729"/>
                        <a:gd name="connsiteY31" fmla="*/ 970136 h 2671846"/>
                        <a:gd name="connsiteX32" fmla="*/ 1415699 w 1657729"/>
                        <a:gd name="connsiteY32" fmla="*/ 954082 h 2671846"/>
                        <a:gd name="connsiteX33" fmla="*/ 1415699 w 1657729"/>
                        <a:gd name="connsiteY33" fmla="*/ 893122 h 2671846"/>
                        <a:gd name="connsiteX34" fmla="*/ 1415699 w 1657729"/>
                        <a:gd name="connsiteY34" fmla="*/ 913442 h 2671846"/>
                        <a:gd name="connsiteX35" fmla="*/ 1529632 w 1657729"/>
                        <a:gd name="connsiteY35" fmla="*/ 906229 h 2671846"/>
                        <a:gd name="connsiteX36" fmla="*/ 1583049 w 1657729"/>
                        <a:gd name="connsiteY36" fmla="*/ 902863 h 2671846"/>
                        <a:gd name="connsiteX37" fmla="*/ 1612110 w 1657729"/>
                        <a:gd name="connsiteY37" fmla="*/ 901807 h 2671846"/>
                        <a:gd name="connsiteX38" fmla="*/ 1649464 w 1657729"/>
                        <a:gd name="connsiteY38" fmla="*/ 883827 h 2671846"/>
                        <a:gd name="connsiteX39" fmla="*/ 1657572 w 1657729"/>
                        <a:gd name="connsiteY39" fmla="*/ 852533 h 2671846"/>
                        <a:gd name="connsiteX40" fmla="*/ 1645494 w 1657729"/>
                        <a:gd name="connsiteY40" fmla="*/ 784362 h 2671846"/>
                        <a:gd name="connsiteX41" fmla="*/ 1608584 w 1657729"/>
                        <a:gd name="connsiteY41" fmla="*/ 780979 h 2671846"/>
                        <a:gd name="connsiteX42" fmla="*/ 1510151 w 1657729"/>
                        <a:gd name="connsiteY42" fmla="*/ 795482 h 2671846"/>
                        <a:gd name="connsiteX43" fmla="*/ 1415699 w 1657729"/>
                        <a:gd name="connsiteY43" fmla="*/ 750882 h 2671846"/>
                        <a:gd name="connsiteX0" fmla="*/ 1415699 w 1657580"/>
                        <a:gd name="connsiteY0" fmla="*/ 750882 h 2671846"/>
                        <a:gd name="connsiteX1" fmla="*/ 1273459 w 1657580"/>
                        <a:gd name="connsiteY1" fmla="*/ 192082 h 2671846"/>
                        <a:gd name="connsiteX2" fmla="*/ 907699 w 1657580"/>
                        <a:gd name="connsiteY2" fmla="*/ 9202 h 2671846"/>
                        <a:gd name="connsiteX3" fmla="*/ 562259 w 1657580"/>
                        <a:gd name="connsiteY3" fmla="*/ 435922 h 2671846"/>
                        <a:gd name="connsiteX4" fmla="*/ 379379 w 1657580"/>
                        <a:gd name="connsiteY4" fmla="*/ 954082 h 2671846"/>
                        <a:gd name="connsiteX5" fmla="*/ 298099 w 1657580"/>
                        <a:gd name="connsiteY5" fmla="*/ 1330002 h 2671846"/>
                        <a:gd name="connsiteX6" fmla="*/ 577725 w 1657580"/>
                        <a:gd name="connsiteY6" fmla="*/ 1308839 h 2671846"/>
                        <a:gd name="connsiteX7" fmla="*/ 785779 w 1657580"/>
                        <a:gd name="connsiteY7" fmla="*/ 1299522 h 2671846"/>
                        <a:gd name="connsiteX8" fmla="*/ 1039779 w 1657580"/>
                        <a:gd name="connsiteY8" fmla="*/ 1238562 h 2671846"/>
                        <a:gd name="connsiteX9" fmla="*/ 1192179 w 1657580"/>
                        <a:gd name="connsiteY9" fmla="*/ 1136962 h 2671846"/>
                        <a:gd name="connsiteX10" fmla="*/ 1283619 w 1657580"/>
                        <a:gd name="connsiteY10" fmla="*/ 1004882 h 2671846"/>
                        <a:gd name="connsiteX11" fmla="*/ 1306392 w 1657580"/>
                        <a:gd name="connsiteY11" fmla="*/ 953917 h 2671846"/>
                        <a:gd name="connsiteX12" fmla="*/ 1226412 w 1657580"/>
                        <a:gd name="connsiteY12" fmla="*/ 1123422 h 2671846"/>
                        <a:gd name="connsiteX13" fmla="*/ 1070259 w 1657580"/>
                        <a:gd name="connsiteY13" fmla="*/ 1250417 h 2671846"/>
                        <a:gd name="connsiteX14" fmla="*/ 810953 w 1657580"/>
                        <a:gd name="connsiteY14" fmla="*/ 1314767 h 2671846"/>
                        <a:gd name="connsiteX15" fmla="*/ 247299 w 1657580"/>
                        <a:gd name="connsiteY15" fmla="*/ 1401122 h 2671846"/>
                        <a:gd name="connsiteX16" fmla="*/ 84739 w 1657580"/>
                        <a:gd name="connsiteY16" fmla="*/ 1919282 h 2671846"/>
                        <a:gd name="connsiteX17" fmla="*/ 22679 w 1657580"/>
                        <a:gd name="connsiteY17" fmla="*/ 2323987 h 2671846"/>
                        <a:gd name="connsiteX18" fmla="*/ 9412 w 1657580"/>
                        <a:gd name="connsiteY18" fmla="*/ 2467922 h 2671846"/>
                        <a:gd name="connsiteX19" fmla="*/ 24685 w 1657580"/>
                        <a:gd name="connsiteY19" fmla="*/ 2653340 h 2671846"/>
                        <a:gd name="connsiteX20" fmla="*/ 277779 w 1657580"/>
                        <a:gd name="connsiteY20" fmla="*/ 2665014 h 2671846"/>
                        <a:gd name="connsiteX21" fmla="*/ 622861 w 1657580"/>
                        <a:gd name="connsiteY21" fmla="*/ 2651175 h 2671846"/>
                        <a:gd name="connsiteX22" fmla="*/ 885229 w 1657580"/>
                        <a:gd name="connsiteY22" fmla="*/ 2613018 h 2671846"/>
                        <a:gd name="connsiteX23" fmla="*/ 1184064 w 1657580"/>
                        <a:gd name="connsiteY23" fmla="*/ 2484750 h 2671846"/>
                        <a:gd name="connsiteX24" fmla="*/ 1334419 w 1657580"/>
                        <a:gd name="connsiteY24" fmla="*/ 2254562 h 2671846"/>
                        <a:gd name="connsiteX25" fmla="*/ 1415699 w 1657580"/>
                        <a:gd name="connsiteY25" fmla="*/ 1959922 h 2671846"/>
                        <a:gd name="connsiteX26" fmla="*/ 1425859 w 1657580"/>
                        <a:gd name="connsiteY26" fmla="*/ 1573842 h 2671846"/>
                        <a:gd name="connsiteX27" fmla="*/ 1407092 w 1657580"/>
                        <a:gd name="connsiteY27" fmla="*/ 1238562 h 2671846"/>
                        <a:gd name="connsiteX28" fmla="*/ 1415699 w 1657580"/>
                        <a:gd name="connsiteY28" fmla="*/ 1086162 h 2671846"/>
                        <a:gd name="connsiteX29" fmla="*/ 1631933 w 1657580"/>
                        <a:gd name="connsiteY29" fmla="*/ 1071736 h 2671846"/>
                        <a:gd name="connsiteX30" fmla="*/ 1630953 w 1657580"/>
                        <a:gd name="connsiteY30" fmla="*/ 979366 h 2671846"/>
                        <a:gd name="connsiteX31" fmla="*/ 1532785 w 1657580"/>
                        <a:gd name="connsiteY31" fmla="*/ 970136 h 2671846"/>
                        <a:gd name="connsiteX32" fmla="*/ 1415699 w 1657580"/>
                        <a:gd name="connsiteY32" fmla="*/ 954082 h 2671846"/>
                        <a:gd name="connsiteX33" fmla="*/ 1415699 w 1657580"/>
                        <a:gd name="connsiteY33" fmla="*/ 893122 h 2671846"/>
                        <a:gd name="connsiteX34" fmla="*/ 1415699 w 1657580"/>
                        <a:gd name="connsiteY34" fmla="*/ 913442 h 2671846"/>
                        <a:gd name="connsiteX35" fmla="*/ 1529632 w 1657580"/>
                        <a:gd name="connsiteY35" fmla="*/ 906229 h 2671846"/>
                        <a:gd name="connsiteX36" fmla="*/ 1583049 w 1657580"/>
                        <a:gd name="connsiteY36" fmla="*/ 902863 h 2671846"/>
                        <a:gd name="connsiteX37" fmla="*/ 1612110 w 1657580"/>
                        <a:gd name="connsiteY37" fmla="*/ 901807 h 2671846"/>
                        <a:gd name="connsiteX38" fmla="*/ 1644139 w 1657580"/>
                        <a:gd name="connsiteY38" fmla="*/ 899338 h 2671846"/>
                        <a:gd name="connsiteX39" fmla="*/ 1657572 w 1657580"/>
                        <a:gd name="connsiteY39" fmla="*/ 852533 h 2671846"/>
                        <a:gd name="connsiteX40" fmla="*/ 1645494 w 1657580"/>
                        <a:gd name="connsiteY40" fmla="*/ 784362 h 2671846"/>
                        <a:gd name="connsiteX41" fmla="*/ 1608584 w 1657580"/>
                        <a:gd name="connsiteY41" fmla="*/ 780979 h 2671846"/>
                        <a:gd name="connsiteX42" fmla="*/ 1510151 w 1657580"/>
                        <a:gd name="connsiteY42" fmla="*/ 795482 h 2671846"/>
                        <a:gd name="connsiteX43" fmla="*/ 1415699 w 1657580"/>
                        <a:gd name="connsiteY43" fmla="*/ 750882 h 2671846"/>
                        <a:gd name="connsiteX0" fmla="*/ 1415699 w 1652331"/>
                        <a:gd name="connsiteY0" fmla="*/ 750882 h 2671846"/>
                        <a:gd name="connsiteX1" fmla="*/ 1273459 w 1652331"/>
                        <a:gd name="connsiteY1" fmla="*/ 192082 h 2671846"/>
                        <a:gd name="connsiteX2" fmla="*/ 907699 w 1652331"/>
                        <a:gd name="connsiteY2" fmla="*/ 9202 h 2671846"/>
                        <a:gd name="connsiteX3" fmla="*/ 562259 w 1652331"/>
                        <a:gd name="connsiteY3" fmla="*/ 435922 h 2671846"/>
                        <a:gd name="connsiteX4" fmla="*/ 379379 w 1652331"/>
                        <a:gd name="connsiteY4" fmla="*/ 954082 h 2671846"/>
                        <a:gd name="connsiteX5" fmla="*/ 298099 w 1652331"/>
                        <a:gd name="connsiteY5" fmla="*/ 1330002 h 2671846"/>
                        <a:gd name="connsiteX6" fmla="*/ 577725 w 1652331"/>
                        <a:gd name="connsiteY6" fmla="*/ 1308839 h 2671846"/>
                        <a:gd name="connsiteX7" fmla="*/ 785779 w 1652331"/>
                        <a:gd name="connsiteY7" fmla="*/ 1299522 h 2671846"/>
                        <a:gd name="connsiteX8" fmla="*/ 1039779 w 1652331"/>
                        <a:gd name="connsiteY8" fmla="*/ 1238562 h 2671846"/>
                        <a:gd name="connsiteX9" fmla="*/ 1192179 w 1652331"/>
                        <a:gd name="connsiteY9" fmla="*/ 1136962 h 2671846"/>
                        <a:gd name="connsiteX10" fmla="*/ 1283619 w 1652331"/>
                        <a:gd name="connsiteY10" fmla="*/ 1004882 h 2671846"/>
                        <a:gd name="connsiteX11" fmla="*/ 1306392 w 1652331"/>
                        <a:gd name="connsiteY11" fmla="*/ 953917 h 2671846"/>
                        <a:gd name="connsiteX12" fmla="*/ 1226412 w 1652331"/>
                        <a:gd name="connsiteY12" fmla="*/ 1123422 h 2671846"/>
                        <a:gd name="connsiteX13" fmla="*/ 1070259 w 1652331"/>
                        <a:gd name="connsiteY13" fmla="*/ 1250417 h 2671846"/>
                        <a:gd name="connsiteX14" fmla="*/ 810953 w 1652331"/>
                        <a:gd name="connsiteY14" fmla="*/ 1314767 h 2671846"/>
                        <a:gd name="connsiteX15" fmla="*/ 247299 w 1652331"/>
                        <a:gd name="connsiteY15" fmla="*/ 1401122 h 2671846"/>
                        <a:gd name="connsiteX16" fmla="*/ 84739 w 1652331"/>
                        <a:gd name="connsiteY16" fmla="*/ 1919282 h 2671846"/>
                        <a:gd name="connsiteX17" fmla="*/ 22679 w 1652331"/>
                        <a:gd name="connsiteY17" fmla="*/ 2323987 h 2671846"/>
                        <a:gd name="connsiteX18" fmla="*/ 9412 w 1652331"/>
                        <a:gd name="connsiteY18" fmla="*/ 2467922 h 2671846"/>
                        <a:gd name="connsiteX19" fmla="*/ 24685 w 1652331"/>
                        <a:gd name="connsiteY19" fmla="*/ 2653340 h 2671846"/>
                        <a:gd name="connsiteX20" fmla="*/ 277779 w 1652331"/>
                        <a:gd name="connsiteY20" fmla="*/ 2665014 h 2671846"/>
                        <a:gd name="connsiteX21" fmla="*/ 622861 w 1652331"/>
                        <a:gd name="connsiteY21" fmla="*/ 2651175 h 2671846"/>
                        <a:gd name="connsiteX22" fmla="*/ 885229 w 1652331"/>
                        <a:gd name="connsiteY22" fmla="*/ 2613018 h 2671846"/>
                        <a:gd name="connsiteX23" fmla="*/ 1184064 w 1652331"/>
                        <a:gd name="connsiteY23" fmla="*/ 2484750 h 2671846"/>
                        <a:gd name="connsiteX24" fmla="*/ 1334419 w 1652331"/>
                        <a:gd name="connsiteY24" fmla="*/ 2254562 h 2671846"/>
                        <a:gd name="connsiteX25" fmla="*/ 1415699 w 1652331"/>
                        <a:gd name="connsiteY25" fmla="*/ 1959922 h 2671846"/>
                        <a:gd name="connsiteX26" fmla="*/ 1425859 w 1652331"/>
                        <a:gd name="connsiteY26" fmla="*/ 1573842 h 2671846"/>
                        <a:gd name="connsiteX27" fmla="*/ 1407092 w 1652331"/>
                        <a:gd name="connsiteY27" fmla="*/ 1238562 h 2671846"/>
                        <a:gd name="connsiteX28" fmla="*/ 1415699 w 1652331"/>
                        <a:gd name="connsiteY28" fmla="*/ 1086162 h 2671846"/>
                        <a:gd name="connsiteX29" fmla="*/ 1631933 w 1652331"/>
                        <a:gd name="connsiteY29" fmla="*/ 1071736 h 2671846"/>
                        <a:gd name="connsiteX30" fmla="*/ 1630953 w 1652331"/>
                        <a:gd name="connsiteY30" fmla="*/ 979366 h 2671846"/>
                        <a:gd name="connsiteX31" fmla="*/ 1532785 w 1652331"/>
                        <a:gd name="connsiteY31" fmla="*/ 970136 h 2671846"/>
                        <a:gd name="connsiteX32" fmla="*/ 1415699 w 1652331"/>
                        <a:gd name="connsiteY32" fmla="*/ 954082 h 2671846"/>
                        <a:gd name="connsiteX33" fmla="*/ 1415699 w 1652331"/>
                        <a:gd name="connsiteY33" fmla="*/ 893122 h 2671846"/>
                        <a:gd name="connsiteX34" fmla="*/ 1415699 w 1652331"/>
                        <a:gd name="connsiteY34" fmla="*/ 913442 h 2671846"/>
                        <a:gd name="connsiteX35" fmla="*/ 1529632 w 1652331"/>
                        <a:gd name="connsiteY35" fmla="*/ 906229 h 2671846"/>
                        <a:gd name="connsiteX36" fmla="*/ 1583049 w 1652331"/>
                        <a:gd name="connsiteY36" fmla="*/ 902863 h 2671846"/>
                        <a:gd name="connsiteX37" fmla="*/ 1612110 w 1652331"/>
                        <a:gd name="connsiteY37" fmla="*/ 901807 h 2671846"/>
                        <a:gd name="connsiteX38" fmla="*/ 1644139 w 1652331"/>
                        <a:gd name="connsiteY38" fmla="*/ 899338 h 2671846"/>
                        <a:gd name="connsiteX39" fmla="*/ 1652247 w 1652331"/>
                        <a:gd name="connsiteY39" fmla="*/ 852533 h 2671846"/>
                        <a:gd name="connsiteX40" fmla="*/ 1645494 w 1652331"/>
                        <a:gd name="connsiteY40" fmla="*/ 784362 h 2671846"/>
                        <a:gd name="connsiteX41" fmla="*/ 1608584 w 1652331"/>
                        <a:gd name="connsiteY41" fmla="*/ 780979 h 2671846"/>
                        <a:gd name="connsiteX42" fmla="*/ 1510151 w 1652331"/>
                        <a:gd name="connsiteY42" fmla="*/ 795482 h 2671846"/>
                        <a:gd name="connsiteX43" fmla="*/ 1415699 w 1652331"/>
                        <a:gd name="connsiteY43" fmla="*/ 750882 h 2671846"/>
                        <a:gd name="connsiteX0" fmla="*/ 1415699 w 1652331"/>
                        <a:gd name="connsiteY0" fmla="*/ 750882 h 2671846"/>
                        <a:gd name="connsiteX1" fmla="*/ 1273459 w 1652331"/>
                        <a:gd name="connsiteY1" fmla="*/ 192082 h 2671846"/>
                        <a:gd name="connsiteX2" fmla="*/ 907699 w 1652331"/>
                        <a:gd name="connsiteY2" fmla="*/ 9202 h 2671846"/>
                        <a:gd name="connsiteX3" fmla="*/ 562259 w 1652331"/>
                        <a:gd name="connsiteY3" fmla="*/ 435922 h 2671846"/>
                        <a:gd name="connsiteX4" fmla="*/ 379379 w 1652331"/>
                        <a:gd name="connsiteY4" fmla="*/ 954082 h 2671846"/>
                        <a:gd name="connsiteX5" fmla="*/ 298099 w 1652331"/>
                        <a:gd name="connsiteY5" fmla="*/ 1330002 h 2671846"/>
                        <a:gd name="connsiteX6" fmla="*/ 577725 w 1652331"/>
                        <a:gd name="connsiteY6" fmla="*/ 1308839 h 2671846"/>
                        <a:gd name="connsiteX7" fmla="*/ 785779 w 1652331"/>
                        <a:gd name="connsiteY7" fmla="*/ 1299522 h 2671846"/>
                        <a:gd name="connsiteX8" fmla="*/ 1039779 w 1652331"/>
                        <a:gd name="connsiteY8" fmla="*/ 1238562 h 2671846"/>
                        <a:gd name="connsiteX9" fmla="*/ 1192179 w 1652331"/>
                        <a:gd name="connsiteY9" fmla="*/ 1136962 h 2671846"/>
                        <a:gd name="connsiteX10" fmla="*/ 1283619 w 1652331"/>
                        <a:gd name="connsiteY10" fmla="*/ 1004882 h 2671846"/>
                        <a:gd name="connsiteX11" fmla="*/ 1306392 w 1652331"/>
                        <a:gd name="connsiteY11" fmla="*/ 953917 h 2671846"/>
                        <a:gd name="connsiteX12" fmla="*/ 1226412 w 1652331"/>
                        <a:gd name="connsiteY12" fmla="*/ 1123422 h 2671846"/>
                        <a:gd name="connsiteX13" fmla="*/ 1070259 w 1652331"/>
                        <a:gd name="connsiteY13" fmla="*/ 1250417 h 2671846"/>
                        <a:gd name="connsiteX14" fmla="*/ 810953 w 1652331"/>
                        <a:gd name="connsiteY14" fmla="*/ 1314767 h 2671846"/>
                        <a:gd name="connsiteX15" fmla="*/ 247299 w 1652331"/>
                        <a:gd name="connsiteY15" fmla="*/ 1401122 h 2671846"/>
                        <a:gd name="connsiteX16" fmla="*/ 84739 w 1652331"/>
                        <a:gd name="connsiteY16" fmla="*/ 1919282 h 2671846"/>
                        <a:gd name="connsiteX17" fmla="*/ 22679 w 1652331"/>
                        <a:gd name="connsiteY17" fmla="*/ 2323987 h 2671846"/>
                        <a:gd name="connsiteX18" fmla="*/ 9412 w 1652331"/>
                        <a:gd name="connsiteY18" fmla="*/ 2467922 h 2671846"/>
                        <a:gd name="connsiteX19" fmla="*/ 24685 w 1652331"/>
                        <a:gd name="connsiteY19" fmla="*/ 2653340 h 2671846"/>
                        <a:gd name="connsiteX20" fmla="*/ 277779 w 1652331"/>
                        <a:gd name="connsiteY20" fmla="*/ 2665014 h 2671846"/>
                        <a:gd name="connsiteX21" fmla="*/ 622861 w 1652331"/>
                        <a:gd name="connsiteY21" fmla="*/ 2651175 h 2671846"/>
                        <a:gd name="connsiteX22" fmla="*/ 885229 w 1652331"/>
                        <a:gd name="connsiteY22" fmla="*/ 2613018 h 2671846"/>
                        <a:gd name="connsiteX23" fmla="*/ 1184064 w 1652331"/>
                        <a:gd name="connsiteY23" fmla="*/ 2484750 h 2671846"/>
                        <a:gd name="connsiteX24" fmla="*/ 1334419 w 1652331"/>
                        <a:gd name="connsiteY24" fmla="*/ 2254562 h 2671846"/>
                        <a:gd name="connsiteX25" fmla="*/ 1415699 w 1652331"/>
                        <a:gd name="connsiteY25" fmla="*/ 1959922 h 2671846"/>
                        <a:gd name="connsiteX26" fmla="*/ 1425859 w 1652331"/>
                        <a:gd name="connsiteY26" fmla="*/ 1573842 h 2671846"/>
                        <a:gd name="connsiteX27" fmla="*/ 1407092 w 1652331"/>
                        <a:gd name="connsiteY27" fmla="*/ 1238562 h 2671846"/>
                        <a:gd name="connsiteX28" fmla="*/ 1415699 w 1652331"/>
                        <a:gd name="connsiteY28" fmla="*/ 1086162 h 2671846"/>
                        <a:gd name="connsiteX29" fmla="*/ 1631933 w 1652331"/>
                        <a:gd name="connsiteY29" fmla="*/ 1071736 h 2671846"/>
                        <a:gd name="connsiteX30" fmla="*/ 1630953 w 1652331"/>
                        <a:gd name="connsiteY30" fmla="*/ 979366 h 2671846"/>
                        <a:gd name="connsiteX31" fmla="*/ 1532785 w 1652331"/>
                        <a:gd name="connsiteY31" fmla="*/ 970136 h 2671846"/>
                        <a:gd name="connsiteX32" fmla="*/ 1415699 w 1652331"/>
                        <a:gd name="connsiteY32" fmla="*/ 954082 h 2671846"/>
                        <a:gd name="connsiteX33" fmla="*/ 1415699 w 1652331"/>
                        <a:gd name="connsiteY33" fmla="*/ 893122 h 2671846"/>
                        <a:gd name="connsiteX34" fmla="*/ 1415699 w 1652331"/>
                        <a:gd name="connsiteY34" fmla="*/ 913442 h 2671846"/>
                        <a:gd name="connsiteX35" fmla="*/ 1484369 w 1652331"/>
                        <a:gd name="connsiteY35" fmla="*/ 910107 h 2671846"/>
                        <a:gd name="connsiteX36" fmla="*/ 1583049 w 1652331"/>
                        <a:gd name="connsiteY36" fmla="*/ 902863 h 2671846"/>
                        <a:gd name="connsiteX37" fmla="*/ 1612110 w 1652331"/>
                        <a:gd name="connsiteY37" fmla="*/ 901807 h 2671846"/>
                        <a:gd name="connsiteX38" fmla="*/ 1644139 w 1652331"/>
                        <a:gd name="connsiteY38" fmla="*/ 899338 h 2671846"/>
                        <a:gd name="connsiteX39" fmla="*/ 1652247 w 1652331"/>
                        <a:gd name="connsiteY39" fmla="*/ 852533 h 2671846"/>
                        <a:gd name="connsiteX40" fmla="*/ 1645494 w 1652331"/>
                        <a:gd name="connsiteY40" fmla="*/ 784362 h 2671846"/>
                        <a:gd name="connsiteX41" fmla="*/ 1608584 w 1652331"/>
                        <a:gd name="connsiteY41" fmla="*/ 780979 h 2671846"/>
                        <a:gd name="connsiteX42" fmla="*/ 1510151 w 1652331"/>
                        <a:gd name="connsiteY42" fmla="*/ 795482 h 2671846"/>
                        <a:gd name="connsiteX43" fmla="*/ 1415699 w 1652331"/>
                        <a:gd name="connsiteY43" fmla="*/ 750882 h 2671846"/>
                        <a:gd name="connsiteX0" fmla="*/ 1415699 w 1652331"/>
                        <a:gd name="connsiteY0" fmla="*/ 750882 h 2671846"/>
                        <a:gd name="connsiteX1" fmla="*/ 1273459 w 1652331"/>
                        <a:gd name="connsiteY1" fmla="*/ 192082 h 2671846"/>
                        <a:gd name="connsiteX2" fmla="*/ 907699 w 1652331"/>
                        <a:gd name="connsiteY2" fmla="*/ 9202 h 2671846"/>
                        <a:gd name="connsiteX3" fmla="*/ 562259 w 1652331"/>
                        <a:gd name="connsiteY3" fmla="*/ 435922 h 2671846"/>
                        <a:gd name="connsiteX4" fmla="*/ 379379 w 1652331"/>
                        <a:gd name="connsiteY4" fmla="*/ 954082 h 2671846"/>
                        <a:gd name="connsiteX5" fmla="*/ 298099 w 1652331"/>
                        <a:gd name="connsiteY5" fmla="*/ 1330002 h 2671846"/>
                        <a:gd name="connsiteX6" fmla="*/ 577725 w 1652331"/>
                        <a:gd name="connsiteY6" fmla="*/ 1308839 h 2671846"/>
                        <a:gd name="connsiteX7" fmla="*/ 785779 w 1652331"/>
                        <a:gd name="connsiteY7" fmla="*/ 1299522 h 2671846"/>
                        <a:gd name="connsiteX8" fmla="*/ 1039779 w 1652331"/>
                        <a:gd name="connsiteY8" fmla="*/ 1238562 h 2671846"/>
                        <a:gd name="connsiteX9" fmla="*/ 1192179 w 1652331"/>
                        <a:gd name="connsiteY9" fmla="*/ 1136962 h 2671846"/>
                        <a:gd name="connsiteX10" fmla="*/ 1283619 w 1652331"/>
                        <a:gd name="connsiteY10" fmla="*/ 1004882 h 2671846"/>
                        <a:gd name="connsiteX11" fmla="*/ 1306392 w 1652331"/>
                        <a:gd name="connsiteY11" fmla="*/ 953917 h 2671846"/>
                        <a:gd name="connsiteX12" fmla="*/ 1226412 w 1652331"/>
                        <a:gd name="connsiteY12" fmla="*/ 1123422 h 2671846"/>
                        <a:gd name="connsiteX13" fmla="*/ 1070259 w 1652331"/>
                        <a:gd name="connsiteY13" fmla="*/ 1250417 h 2671846"/>
                        <a:gd name="connsiteX14" fmla="*/ 810953 w 1652331"/>
                        <a:gd name="connsiteY14" fmla="*/ 1314767 h 2671846"/>
                        <a:gd name="connsiteX15" fmla="*/ 247299 w 1652331"/>
                        <a:gd name="connsiteY15" fmla="*/ 1401122 h 2671846"/>
                        <a:gd name="connsiteX16" fmla="*/ 84739 w 1652331"/>
                        <a:gd name="connsiteY16" fmla="*/ 1919282 h 2671846"/>
                        <a:gd name="connsiteX17" fmla="*/ 22679 w 1652331"/>
                        <a:gd name="connsiteY17" fmla="*/ 2323987 h 2671846"/>
                        <a:gd name="connsiteX18" fmla="*/ 9412 w 1652331"/>
                        <a:gd name="connsiteY18" fmla="*/ 2467922 h 2671846"/>
                        <a:gd name="connsiteX19" fmla="*/ 24685 w 1652331"/>
                        <a:gd name="connsiteY19" fmla="*/ 2653340 h 2671846"/>
                        <a:gd name="connsiteX20" fmla="*/ 277779 w 1652331"/>
                        <a:gd name="connsiteY20" fmla="*/ 2665014 h 2671846"/>
                        <a:gd name="connsiteX21" fmla="*/ 622861 w 1652331"/>
                        <a:gd name="connsiteY21" fmla="*/ 2651175 h 2671846"/>
                        <a:gd name="connsiteX22" fmla="*/ 885229 w 1652331"/>
                        <a:gd name="connsiteY22" fmla="*/ 2613018 h 2671846"/>
                        <a:gd name="connsiteX23" fmla="*/ 1184064 w 1652331"/>
                        <a:gd name="connsiteY23" fmla="*/ 2484750 h 2671846"/>
                        <a:gd name="connsiteX24" fmla="*/ 1334419 w 1652331"/>
                        <a:gd name="connsiteY24" fmla="*/ 2254562 h 2671846"/>
                        <a:gd name="connsiteX25" fmla="*/ 1415699 w 1652331"/>
                        <a:gd name="connsiteY25" fmla="*/ 1959922 h 2671846"/>
                        <a:gd name="connsiteX26" fmla="*/ 1425859 w 1652331"/>
                        <a:gd name="connsiteY26" fmla="*/ 1573842 h 2671846"/>
                        <a:gd name="connsiteX27" fmla="*/ 1407092 w 1652331"/>
                        <a:gd name="connsiteY27" fmla="*/ 1238562 h 2671846"/>
                        <a:gd name="connsiteX28" fmla="*/ 1415699 w 1652331"/>
                        <a:gd name="connsiteY28" fmla="*/ 1086162 h 2671846"/>
                        <a:gd name="connsiteX29" fmla="*/ 1631933 w 1652331"/>
                        <a:gd name="connsiteY29" fmla="*/ 1071736 h 2671846"/>
                        <a:gd name="connsiteX30" fmla="*/ 1630953 w 1652331"/>
                        <a:gd name="connsiteY30" fmla="*/ 979366 h 2671846"/>
                        <a:gd name="connsiteX31" fmla="*/ 1532785 w 1652331"/>
                        <a:gd name="connsiteY31" fmla="*/ 970136 h 2671846"/>
                        <a:gd name="connsiteX32" fmla="*/ 1415699 w 1652331"/>
                        <a:gd name="connsiteY32" fmla="*/ 954082 h 2671846"/>
                        <a:gd name="connsiteX33" fmla="*/ 1415699 w 1652331"/>
                        <a:gd name="connsiteY33" fmla="*/ 893122 h 2671846"/>
                        <a:gd name="connsiteX34" fmla="*/ 1415699 w 1652331"/>
                        <a:gd name="connsiteY34" fmla="*/ 913442 h 2671846"/>
                        <a:gd name="connsiteX35" fmla="*/ 1484369 w 1652331"/>
                        <a:gd name="connsiteY35" fmla="*/ 910107 h 2671846"/>
                        <a:gd name="connsiteX36" fmla="*/ 1540448 w 1652331"/>
                        <a:gd name="connsiteY36" fmla="*/ 902863 h 2671846"/>
                        <a:gd name="connsiteX37" fmla="*/ 1612110 w 1652331"/>
                        <a:gd name="connsiteY37" fmla="*/ 901807 h 2671846"/>
                        <a:gd name="connsiteX38" fmla="*/ 1644139 w 1652331"/>
                        <a:gd name="connsiteY38" fmla="*/ 899338 h 2671846"/>
                        <a:gd name="connsiteX39" fmla="*/ 1652247 w 1652331"/>
                        <a:gd name="connsiteY39" fmla="*/ 852533 h 2671846"/>
                        <a:gd name="connsiteX40" fmla="*/ 1645494 w 1652331"/>
                        <a:gd name="connsiteY40" fmla="*/ 784362 h 2671846"/>
                        <a:gd name="connsiteX41" fmla="*/ 1608584 w 1652331"/>
                        <a:gd name="connsiteY41" fmla="*/ 780979 h 2671846"/>
                        <a:gd name="connsiteX42" fmla="*/ 1510151 w 1652331"/>
                        <a:gd name="connsiteY42" fmla="*/ 795482 h 2671846"/>
                        <a:gd name="connsiteX43" fmla="*/ 1415699 w 1652331"/>
                        <a:gd name="connsiteY43" fmla="*/ 750882 h 2671846"/>
                        <a:gd name="connsiteX0" fmla="*/ 1415699 w 1652520"/>
                        <a:gd name="connsiteY0" fmla="*/ 750882 h 2671846"/>
                        <a:gd name="connsiteX1" fmla="*/ 1273459 w 1652520"/>
                        <a:gd name="connsiteY1" fmla="*/ 192082 h 2671846"/>
                        <a:gd name="connsiteX2" fmla="*/ 907699 w 1652520"/>
                        <a:gd name="connsiteY2" fmla="*/ 9202 h 2671846"/>
                        <a:gd name="connsiteX3" fmla="*/ 562259 w 1652520"/>
                        <a:gd name="connsiteY3" fmla="*/ 435922 h 2671846"/>
                        <a:gd name="connsiteX4" fmla="*/ 379379 w 1652520"/>
                        <a:gd name="connsiteY4" fmla="*/ 954082 h 2671846"/>
                        <a:gd name="connsiteX5" fmla="*/ 298099 w 1652520"/>
                        <a:gd name="connsiteY5" fmla="*/ 1330002 h 2671846"/>
                        <a:gd name="connsiteX6" fmla="*/ 577725 w 1652520"/>
                        <a:gd name="connsiteY6" fmla="*/ 1308839 h 2671846"/>
                        <a:gd name="connsiteX7" fmla="*/ 785779 w 1652520"/>
                        <a:gd name="connsiteY7" fmla="*/ 1299522 h 2671846"/>
                        <a:gd name="connsiteX8" fmla="*/ 1039779 w 1652520"/>
                        <a:gd name="connsiteY8" fmla="*/ 1238562 h 2671846"/>
                        <a:gd name="connsiteX9" fmla="*/ 1192179 w 1652520"/>
                        <a:gd name="connsiteY9" fmla="*/ 1136962 h 2671846"/>
                        <a:gd name="connsiteX10" fmla="*/ 1283619 w 1652520"/>
                        <a:gd name="connsiteY10" fmla="*/ 1004882 h 2671846"/>
                        <a:gd name="connsiteX11" fmla="*/ 1306392 w 1652520"/>
                        <a:gd name="connsiteY11" fmla="*/ 953917 h 2671846"/>
                        <a:gd name="connsiteX12" fmla="*/ 1226412 w 1652520"/>
                        <a:gd name="connsiteY12" fmla="*/ 1123422 h 2671846"/>
                        <a:gd name="connsiteX13" fmla="*/ 1070259 w 1652520"/>
                        <a:gd name="connsiteY13" fmla="*/ 1250417 h 2671846"/>
                        <a:gd name="connsiteX14" fmla="*/ 810953 w 1652520"/>
                        <a:gd name="connsiteY14" fmla="*/ 1314767 h 2671846"/>
                        <a:gd name="connsiteX15" fmla="*/ 247299 w 1652520"/>
                        <a:gd name="connsiteY15" fmla="*/ 1401122 h 2671846"/>
                        <a:gd name="connsiteX16" fmla="*/ 84739 w 1652520"/>
                        <a:gd name="connsiteY16" fmla="*/ 1919282 h 2671846"/>
                        <a:gd name="connsiteX17" fmla="*/ 22679 w 1652520"/>
                        <a:gd name="connsiteY17" fmla="*/ 2323987 h 2671846"/>
                        <a:gd name="connsiteX18" fmla="*/ 9412 w 1652520"/>
                        <a:gd name="connsiteY18" fmla="*/ 2467922 h 2671846"/>
                        <a:gd name="connsiteX19" fmla="*/ 24685 w 1652520"/>
                        <a:gd name="connsiteY19" fmla="*/ 2653340 h 2671846"/>
                        <a:gd name="connsiteX20" fmla="*/ 277779 w 1652520"/>
                        <a:gd name="connsiteY20" fmla="*/ 2665014 h 2671846"/>
                        <a:gd name="connsiteX21" fmla="*/ 622861 w 1652520"/>
                        <a:gd name="connsiteY21" fmla="*/ 2651175 h 2671846"/>
                        <a:gd name="connsiteX22" fmla="*/ 885229 w 1652520"/>
                        <a:gd name="connsiteY22" fmla="*/ 2613018 h 2671846"/>
                        <a:gd name="connsiteX23" fmla="*/ 1184064 w 1652520"/>
                        <a:gd name="connsiteY23" fmla="*/ 2484750 h 2671846"/>
                        <a:gd name="connsiteX24" fmla="*/ 1334419 w 1652520"/>
                        <a:gd name="connsiteY24" fmla="*/ 2254562 h 2671846"/>
                        <a:gd name="connsiteX25" fmla="*/ 1415699 w 1652520"/>
                        <a:gd name="connsiteY25" fmla="*/ 1959922 h 2671846"/>
                        <a:gd name="connsiteX26" fmla="*/ 1425859 w 1652520"/>
                        <a:gd name="connsiteY26" fmla="*/ 1573842 h 2671846"/>
                        <a:gd name="connsiteX27" fmla="*/ 1407092 w 1652520"/>
                        <a:gd name="connsiteY27" fmla="*/ 1238562 h 2671846"/>
                        <a:gd name="connsiteX28" fmla="*/ 1415699 w 1652520"/>
                        <a:gd name="connsiteY28" fmla="*/ 1086162 h 2671846"/>
                        <a:gd name="connsiteX29" fmla="*/ 1631933 w 1652520"/>
                        <a:gd name="connsiteY29" fmla="*/ 1071736 h 2671846"/>
                        <a:gd name="connsiteX30" fmla="*/ 1630953 w 1652520"/>
                        <a:gd name="connsiteY30" fmla="*/ 979366 h 2671846"/>
                        <a:gd name="connsiteX31" fmla="*/ 1532785 w 1652520"/>
                        <a:gd name="connsiteY31" fmla="*/ 970136 h 2671846"/>
                        <a:gd name="connsiteX32" fmla="*/ 1415699 w 1652520"/>
                        <a:gd name="connsiteY32" fmla="*/ 954082 h 2671846"/>
                        <a:gd name="connsiteX33" fmla="*/ 1415699 w 1652520"/>
                        <a:gd name="connsiteY33" fmla="*/ 893122 h 2671846"/>
                        <a:gd name="connsiteX34" fmla="*/ 1415699 w 1652520"/>
                        <a:gd name="connsiteY34" fmla="*/ 913442 h 2671846"/>
                        <a:gd name="connsiteX35" fmla="*/ 1484369 w 1652520"/>
                        <a:gd name="connsiteY35" fmla="*/ 910107 h 2671846"/>
                        <a:gd name="connsiteX36" fmla="*/ 1540448 w 1652520"/>
                        <a:gd name="connsiteY36" fmla="*/ 902863 h 2671846"/>
                        <a:gd name="connsiteX37" fmla="*/ 1585485 w 1652520"/>
                        <a:gd name="connsiteY37" fmla="*/ 901807 h 2671846"/>
                        <a:gd name="connsiteX38" fmla="*/ 1644139 w 1652520"/>
                        <a:gd name="connsiteY38" fmla="*/ 899338 h 2671846"/>
                        <a:gd name="connsiteX39" fmla="*/ 1652247 w 1652520"/>
                        <a:gd name="connsiteY39" fmla="*/ 852533 h 2671846"/>
                        <a:gd name="connsiteX40" fmla="*/ 1645494 w 1652520"/>
                        <a:gd name="connsiteY40" fmla="*/ 784362 h 2671846"/>
                        <a:gd name="connsiteX41" fmla="*/ 1608584 w 1652520"/>
                        <a:gd name="connsiteY41" fmla="*/ 780979 h 2671846"/>
                        <a:gd name="connsiteX42" fmla="*/ 1510151 w 1652520"/>
                        <a:gd name="connsiteY42" fmla="*/ 795482 h 2671846"/>
                        <a:gd name="connsiteX43" fmla="*/ 1415699 w 1652520"/>
                        <a:gd name="connsiteY43" fmla="*/ 750882 h 2671846"/>
                        <a:gd name="connsiteX0" fmla="*/ 1415699 w 1646550"/>
                        <a:gd name="connsiteY0" fmla="*/ 750882 h 2671846"/>
                        <a:gd name="connsiteX1" fmla="*/ 1273459 w 1646550"/>
                        <a:gd name="connsiteY1" fmla="*/ 192082 h 2671846"/>
                        <a:gd name="connsiteX2" fmla="*/ 907699 w 1646550"/>
                        <a:gd name="connsiteY2" fmla="*/ 9202 h 2671846"/>
                        <a:gd name="connsiteX3" fmla="*/ 562259 w 1646550"/>
                        <a:gd name="connsiteY3" fmla="*/ 435922 h 2671846"/>
                        <a:gd name="connsiteX4" fmla="*/ 379379 w 1646550"/>
                        <a:gd name="connsiteY4" fmla="*/ 954082 h 2671846"/>
                        <a:gd name="connsiteX5" fmla="*/ 298099 w 1646550"/>
                        <a:gd name="connsiteY5" fmla="*/ 1330002 h 2671846"/>
                        <a:gd name="connsiteX6" fmla="*/ 577725 w 1646550"/>
                        <a:gd name="connsiteY6" fmla="*/ 1308839 h 2671846"/>
                        <a:gd name="connsiteX7" fmla="*/ 785779 w 1646550"/>
                        <a:gd name="connsiteY7" fmla="*/ 1299522 h 2671846"/>
                        <a:gd name="connsiteX8" fmla="*/ 1039779 w 1646550"/>
                        <a:gd name="connsiteY8" fmla="*/ 1238562 h 2671846"/>
                        <a:gd name="connsiteX9" fmla="*/ 1192179 w 1646550"/>
                        <a:gd name="connsiteY9" fmla="*/ 1136962 h 2671846"/>
                        <a:gd name="connsiteX10" fmla="*/ 1283619 w 1646550"/>
                        <a:gd name="connsiteY10" fmla="*/ 1004882 h 2671846"/>
                        <a:gd name="connsiteX11" fmla="*/ 1306392 w 1646550"/>
                        <a:gd name="connsiteY11" fmla="*/ 953917 h 2671846"/>
                        <a:gd name="connsiteX12" fmla="*/ 1226412 w 1646550"/>
                        <a:gd name="connsiteY12" fmla="*/ 1123422 h 2671846"/>
                        <a:gd name="connsiteX13" fmla="*/ 1070259 w 1646550"/>
                        <a:gd name="connsiteY13" fmla="*/ 1250417 h 2671846"/>
                        <a:gd name="connsiteX14" fmla="*/ 810953 w 1646550"/>
                        <a:gd name="connsiteY14" fmla="*/ 1314767 h 2671846"/>
                        <a:gd name="connsiteX15" fmla="*/ 247299 w 1646550"/>
                        <a:gd name="connsiteY15" fmla="*/ 1401122 h 2671846"/>
                        <a:gd name="connsiteX16" fmla="*/ 84739 w 1646550"/>
                        <a:gd name="connsiteY16" fmla="*/ 1919282 h 2671846"/>
                        <a:gd name="connsiteX17" fmla="*/ 22679 w 1646550"/>
                        <a:gd name="connsiteY17" fmla="*/ 2323987 h 2671846"/>
                        <a:gd name="connsiteX18" fmla="*/ 9412 w 1646550"/>
                        <a:gd name="connsiteY18" fmla="*/ 2467922 h 2671846"/>
                        <a:gd name="connsiteX19" fmla="*/ 24685 w 1646550"/>
                        <a:gd name="connsiteY19" fmla="*/ 2653340 h 2671846"/>
                        <a:gd name="connsiteX20" fmla="*/ 277779 w 1646550"/>
                        <a:gd name="connsiteY20" fmla="*/ 2665014 h 2671846"/>
                        <a:gd name="connsiteX21" fmla="*/ 622861 w 1646550"/>
                        <a:gd name="connsiteY21" fmla="*/ 2651175 h 2671846"/>
                        <a:gd name="connsiteX22" fmla="*/ 885229 w 1646550"/>
                        <a:gd name="connsiteY22" fmla="*/ 2613018 h 2671846"/>
                        <a:gd name="connsiteX23" fmla="*/ 1184064 w 1646550"/>
                        <a:gd name="connsiteY23" fmla="*/ 2484750 h 2671846"/>
                        <a:gd name="connsiteX24" fmla="*/ 1334419 w 1646550"/>
                        <a:gd name="connsiteY24" fmla="*/ 2254562 h 2671846"/>
                        <a:gd name="connsiteX25" fmla="*/ 1415699 w 1646550"/>
                        <a:gd name="connsiteY25" fmla="*/ 1959922 h 2671846"/>
                        <a:gd name="connsiteX26" fmla="*/ 1425859 w 1646550"/>
                        <a:gd name="connsiteY26" fmla="*/ 1573842 h 2671846"/>
                        <a:gd name="connsiteX27" fmla="*/ 1407092 w 1646550"/>
                        <a:gd name="connsiteY27" fmla="*/ 1238562 h 2671846"/>
                        <a:gd name="connsiteX28" fmla="*/ 1415699 w 1646550"/>
                        <a:gd name="connsiteY28" fmla="*/ 1086162 h 2671846"/>
                        <a:gd name="connsiteX29" fmla="*/ 1631933 w 1646550"/>
                        <a:gd name="connsiteY29" fmla="*/ 1071736 h 2671846"/>
                        <a:gd name="connsiteX30" fmla="*/ 1630953 w 1646550"/>
                        <a:gd name="connsiteY30" fmla="*/ 979366 h 2671846"/>
                        <a:gd name="connsiteX31" fmla="*/ 1532785 w 1646550"/>
                        <a:gd name="connsiteY31" fmla="*/ 970136 h 2671846"/>
                        <a:gd name="connsiteX32" fmla="*/ 1415699 w 1646550"/>
                        <a:gd name="connsiteY32" fmla="*/ 954082 h 2671846"/>
                        <a:gd name="connsiteX33" fmla="*/ 1415699 w 1646550"/>
                        <a:gd name="connsiteY33" fmla="*/ 893122 h 2671846"/>
                        <a:gd name="connsiteX34" fmla="*/ 1415699 w 1646550"/>
                        <a:gd name="connsiteY34" fmla="*/ 913442 h 2671846"/>
                        <a:gd name="connsiteX35" fmla="*/ 1484369 w 1646550"/>
                        <a:gd name="connsiteY35" fmla="*/ 910107 h 2671846"/>
                        <a:gd name="connsiteX36" fmla="*/ 1540448 w 1646550"/>
                        <a:gd name="connsiteY36" fmla="*/ 902863 h 2671846"/>
                        <a:gd name="connsiteX37" fmla="*/ 1585485 w 1646550"/>
                        <a:gd name="connsiteY37" fmla="*/ 901807 h 2671846"/>
                        <a:gd name="connsiteX38" fmla="*/ 1644139 w 1646550"/>
                        <a:gd name="connsiteY38" fmla="*/ 899338 h 2671846"/>
                        <a:gd name="connsiteX39" fmla="*/ 1636272 w 1646550"/>
                        <a:gd name="connsiteY39" fmla="*/ 868044 h 2671846"/>
                        <a:gd name="connsiteX40" fmla="*/ 1645494 w 1646550"/>
                        <a:gd name="connsiteY40" fmla="*/ 784362 h 2671846"/>
                        <a:gd name="connsiteX41" fmla="*/ 1608584 w 1646550"/>
                        <a:gd name="connsiteY41" fmla="*/ 780979 h 2671846"/>
                        <a:gd name="connsiteX42" fmla="*/ 1510151 w 1646550"/>
                        <a:gd name="connsiteY42" fmla="*/ 795482 h 2671846"/>
                        <a:gd name="connsiteX43" fmla="*/ 1415699 w 1646550"/>
                        <a:gd name="connsiteY43" fmla="*/ 750882 h 2671846"/>
                        <a:gd name="connsiteX0" fmla="*/ 1415699 w 1646738"/>
                        <a:gd name="connsiteY0" fmla="*/ 750882 h 2671846"/>
                        <a:gd name="connsiteX1" fmla="*/ 1273459 w 1646738"/>
                        <a:gd name="connsiteY1" fmla="*/ 192082 h 2671846"/>
                        <a:gd name="connsiteX2" fmla="*/ 907699 w 1646738"/>
                        <a:gd name="connsiteY2" fmla="*/ 9202 h 2671846"/>
                        <a:gd name="connsiteX3" fmla="*/ 562259 w 1646738"/>
                        <a:gd name="connsiteY3" fmla="*/ 435922 h 2671846"/>
                        <a:gd name="connsiteX4" fmla="*/ 379379 w 1646738"/>
                        <a:gd name="connsiteY4" fmla="*/ 954082 h 2671846"/>
                        <a:gd name="connsiteX5" fmla="*/ 298099 w 1646738"/>
                        <a:gd name="connsiteY5" fmla="*/ 1330002 h 2671846"/>
                        <a:gd name="connsiteX6" fmla="*/ 577725 w 1646738"/>
                        <a:gd name="connsiteY6" fmla="*/ 1308839 h 2671846"/>
                        <a:gd name="connsiteX7" fmla="*/ 785779 w 1646738"/>
                        <a:gd name="connsiteY7" fmla="*/ 1299522 h 2671846"/>
                        <a:gd name="connsiteX8" fmla="*/ 1039779 w 1646738"/>
                        <a:gd name="connsiteY8" fmla="*/ 1238562 h 2671846"/>
                        <a:gd name="connsiteX9" fmla="*/ 1192179 w 1646738"/>
                        <a:gd name="connsiteY9" fmla="*/ 1136962 h 2671846"/>
                        <a:gd name="connsiteX10" fmla="*/ 1283619 w 1646738"/>
                        <a:gd name="connsiteY10" fmla="*/ 1004882 h 2671846"/>
                        <a:gd name="connsiteX11" fmla="*/ 1306392 w 1646738"/>
                        <a:gd name="connsiteY11" fmla="*/ 953917 h 2671846"/>
                        <a:gd name="connsiteX12" fmla="*/ 1226412 w 1646738"/>
                        <a:gd name="connsiteY12" fmla="*/ 1123422 h 2671846"/>
                        <a:gd name="connsiteX13" fmla="*/ 1070259 w 1646738"/>
                        <a:gd name="connsiteY13" fmla="*/ 1250417 h 2671846"/>
                        <a:gd name="connsiteX14" fmla="*/ 810953 w 1646738"/>
                        <a:gd name="connsiteY14" fmla="*/ 1314767 h 2671846"/>
                        <a:gd name="connsiteX15" fmla="*/ 247299 w 1646738"/>
                        <a:gd name="connsiteY15" fmla="*/ 1401122 h 2671846"/>
                        <a:gd name="connsiteX16" fmla="*/ 84739 w 1646738"/>
                        <a:gd name="connsiteY16" fmla="*/ 1919282 h 2671846"/>
                        <a:gd name="connsiteX17" fmla="*/ 22679 w 1646738"/>
                        <a:gd name="connsiteY17" fmla="*/ 2323987 h 2671846"/>
                        <a:gd name="connsiteX18" fmla="*/ 9412 w 1646738"/>
                        <a:gd name="connsiteY18" fmla="*/ 2467922 h 2671846"/>
                        <a:gd name="connsiteX19" fmla="*/ 24685 w 1646738"/>
                        <a:gd name="connsiteY19" fmla="*/ 2653340 h 2671846"/>
                        <a:gd name="connsiteX20" fmla="*/ 277779 w 1646738"/>
                        <a:gd name="connsiteY20" fmla="*/ 2665014 h 2671846"/>
                        <a:gd name="connsiteX21" fmla="*/ 622861 w 1646738"/>
                        <a:gd name="connsiteY21" fmla="*/ 2651175 h 2671846"/>
                        <a:gd name="connsiteX22" fmla="*/ 885229 w 1646738"/>
                        <a:gd name="connsiteY22" fmla="*/ 2613018 h 2671846"/>
                        <a:gd name="connsiteX23" fmla="*/ 1184064 w 1646738"/>
                        <a:gd name="connsiteY23" fmla="*/ 2484750 h 2671846"/>
                        <a:gd name="connsiteX24" fmla="*/ 1334419 w 1646738"/>
                        <a:gd name="connsiteY24" fmla="*/ 2254562 h 2671846"/>
                        <a:gd name="connsiteX25" fmla="*/ 1415699 w 1646738"/>
                        <a:gd name="connsiteY25" fmla="*/ 1959922 h 2671846"/>
                        <a:gd name="connsiteX26" fmla="*/ 1425859 w 1646738"/>
                        <a:gd name="connsiteY26" fmla="*/ 1573842 h 2671846"/>
                        <a:gd name="connsiteX27" fmla="*/ 1407092 w 1646738"/>
                        <a:gd name="connsiteY27" fmla="*/ 1238562 h 2671846"/>
                        <a:gd name="connsiteX28" fmla="*/ 1415699 w 1646738"/>
                        <a:gd name="connsiteY28" fmla="*/ 1086162 h 2671846"/>
                        <a:gd name="connsiteX29" fmla="*/ 1631933 w 1646738"/>
                        <a:gd name="connsiteY29" fmla="*/ 1071736 h 2671846"/>
                        <a:gd name="connsiteX30" fmla="*/ 1630953 w 1646738"/>
                        <a:gd name="connsiteY30" fmla="*/ 979366 h 2671846"/>
                        <a:gd name="connsiteX31" fmla="*/ 1532785 w 1646738"/>
                        <a:gd name="connsiteY31" fmla="*/ 970136 h 2671846"/>
                        <a:gd name="connsiteX32" fmla="*/ 1415699 w 1646738"/>
                        <a:gd name="connsiteY32" fmla="*/ 954082 h 2671846"/>
                        <a:gd name="connsiteX33" fmla="*/ 1415699 w 1646738"/>
                        <a:gd name="connsiteY33" fmla="*/ 893122 h 2671846"/>
                        <a:gd name="connsiteX34" fmla="*/ 1415699 w 1646738"/>
                        <a:gd name="connsiteY34" fmla="*/ 913442 h 2671846"/>
                        <a:gd name="connsiteX35" fmla="*/ 1484369 w 1646738"/>
                        <a:gd name="connsiteY35" fmla="*/ 910107 h 2671846"/>
                        <a:gd name="connsiteX36" fmla="*/ 1540448 w 1646738"/>
                        <a:gd name="connsiteY36" fmla="*/ 902863 h 2671846"/>
                        <a:gd name="connsiteX37" fmla="*/ 1585485 w 1646738"/>
                        <a:gd name="connsiteY37" fmla="*/ 901807 h 2671846"/>
                        <a:gd name="connsiteX38" fmla="*/ 1644139 w 1646738"/>
                        <a:gd name="connsiteY38" fmla="*/ 899338 h 2671846"/>
                        <a:gd name="connsiteX39" fmla="*/ 1636272 w 1646738"/>
                        <a:gd name="connsiteY39" fmla="*/ 868044 h 2671846"/>
                        <a:gd name="connsiteX40" fmla="*/ 1634844 w 1646738"/>
                        <a:gd name="connsiteY40" fmla="*/ 780484 h 2671846"/>
                        <a:gd name="connsiteX41" fmla="*/ 1608584 w 1646738"/>
                        <a:gd name="connsiteY41" fmla="*/ 780979 h 2671846"/>
                        <a:gd name="connsiteX42" fmla="*/ 1510151 w 1646738"/>
                        <a:gd name="connsiteY42" fmla="*/ 795482 h 2671846"/>
                        <a:gd name="connsiteX43" fmla="*/ 1415699 w 1646738"/>
                        <a:gd name="connsiteY43" fmla="*/ 750882 h 2671846"/>
                        <a:gd name="connsiteX0" fmla="*/ 1415699 w 1646738"/>
                        <a:gd name="connsiteY0" fmla="*/ 750882 h 2671846"/>
                        <a:gd name="connsiteX1" fmla="*/ 1273459 w 1646738"/>
                        <a:gd name="connsiteY1" fmla="*/ 192082 h 2671846"/>
                        <a:gd name="connsiteX2" fmla="*/ 907699 w 1646738"/>
                        <a:gd name="connsiteY2" fmla="*/ 9202 h 2671846"/>
                        <a:gd name="connsiteX3" fmla="*/ 562259 w 1646738"/>
                        <a:gd name="connsiteY3" fmla="*/ 435922 h 2671846"/>
                        <a:gd name="connsiteX4" fmla="*/ 379379 w 1646738"/>
                        <a:gd name="connsiteY4" fmla="*/ 954082 h 2671846"/>
                        <a:gd name="connsiteX5" fmla="*/ 298099 w 1646738"/>
                        <a:gd name="connsiteY5" fmla="*/ 1330002 h 2671846"/>
                        <a:gd name="connsiteX6" fmla="*/ 577725 w 1646738"/>
                        <a:gd name="connsiteY6" fmla="*/ 1308839 h 2671846"/>
                        <a:gd name="connsiteX7" fmla="*/ 785779 w 1646738"/>
                        <a:gd name="connsiteY7" fmla="*/ 1299522 h 2671846"/>
                        <a:gd name="connsiteX8" fmla="*/ 1039779 w 1646738"/>
                        <a:gd name="connsiteY8" fmla="*/ 1238562 h 2671846"/>
                        <a:gd name="connsiteX9" fmla="*/ 1192179 w 1646738"/>
                        <a:gd name="connsiteY9" fmla="*/ 1136962 h 2671846"/>
                        <a:gd name="connsiteX10" fmla="*/ 1283619 w 1646738"/>
                        <a:gd name="connsiteY10" fmla="*/ 1004882 h 2671846"/>
                        <a:gd name="connsiteX11" fmla="*/ 1306392 w 1646738"/>
                        <a:gd name="connsiteY11" fmla="*/ 953917 h 2671846"/>
                        <a:gd name="connsiteX12" fmla="*/ 1226412 w 1646738"/>
                        <a:gd name="connsiteY12" fmla="*/ 1123422 h 2671846"/>
                        <a:gd name="connsiteX13" fmla="*/ 1070259 w 1646738"/>
                        <a:gd name="connsiteY13" fmla="*/ 1250417 h 2671846"/>
                        <a:gd name="connsiteX14" fmla="*/ 810953 w 1646738"/>
                        <a:gd name="connsiteY14" fmla="*/ 1314767 h 2671846"/>
                        <a:gd name="connsiteX15" fmla="*/ 247299 w 1646738"/>
                        <a:gd name="connsiteY15" fmla="*/ 1401122 h 2671846"/>
                        <a:gd name="connsiteX16" fmla="*/ 84739 w 1646738"/>
                        <a:gd name="connsiteY16" fmla="*/ 1919282 h 2671846"/>
                        <a:gd name="connsiteX17" fmla="*/ 22679 w 1646738"/>
                        <a:gd name="connsiteY17" fmla="*/ 2323987 h 2671846"/>
                        <a:gd name="connsiteX18" fmla="*/ 9412 w 1646738"/>
                        <a:gd name="connsiteY18" fmla="*/ 2467922 h 2671846"/>
                        <a:gd name="connsiteX19" fmla="*/ 24685 w 1646738"/>
                        <a:gd name="connsiteY19" fmla="*/ 2653340 h 2671846"/>
                        <a:gd name="connsiteX20" fmla="*/ 277779 w 1646738"/>
                        <a:gd name="connsiteY20" fmla="*/ 2665014 h 2671846"/>
                        <a:gd name="connsiteX21" fmla="*/ 622861 w 1646738"/>
                        <a:gd name="connsiteY21" fmla="*/ 2651175 h 2671846"/>
                        <a:gd name="connsiteX22" fmla="*/ 885229 w 1646738"/>
                        <a:gd name="connsiteY22" fmla="*/ 2613018 h 2671846"/>
                        <a:gd name="connsiteX23" fmla="*/ 1184064 w 1646738"/>
                        <a:gd name="connsiteY23" fmla="*/ 2484750 h 2671846"/>
                        <a:gd name="connsiteX24" fmla="*/ 1334419 w 1646738"/>
                        <a:gd name="connsiteY24" fmla="*/ 2254562 h 2671846"/>
                        <a:gd name="connsiteX25" fmla="*/ 1415699 w 1646738"/>
                        <a:gd name="connsiteY25" fmla="*/ 1959922 h 2671846"/>
                        <a:gd name="connsiteX26" fmla="*/ 1425859 w 1646738"/>
                        <a:gd name="connsiteY26" fmla="*/ 1573842 h 2671846"/>
                        <a:gd name="connsiteX27" fmla="*/ 1407092 w 1646738"/>
                        <a:gd name="connsiteY27" fmla="*/ 1238562 h 2671846"/>
                        <a:gd name="connsiteX28" fmla="*/ 1415699 w 1646738"/>
                        <a:gd name="connsiteY28" fmla="*/ 1086162 h 2671846"/>
                        <a:gd name="connsiteX29" fmla="*/ 1631933 w 1646738"/>
                        <a:gd name="connsiteY29" fmla="*/ 1071736 h 2671846"/>
                        <a:gd name="connsiteX30" fmla="*/ 1630953 w 1646738"/>
                        <a:gd name="connsiteY30" fmla="*/ 979366 h 2671846"/>
                        <a:gd name="connsiteX31" fmla="*/ 1532785 w 1646738"/>
                        <a:gd name="connsiteY31" fmla="*/ 970136 h 2671846"/>
                        <a:gd name="connsiteX32" fmla="*/ 1415699 w 1646738"/>
                        <a:gd name="connsiteY32" fmla="*/ 954082 h 2671846"/>
                        <a:gd name="connsiteX33" fmla="*/ 1415699 w 1646738"/>
                        <a:gd name="connsiteY33" fmla="*/ 893122 h 2671846"/>
                        <a:gd name="connsiteX34" fmla="*/ 1415699 w 1646738"/>
                        <a:gd name="connsiteY34" fmla="*/ 913442 h 2671846"/>
                        <a:gd name="connsiteX35" fmla="*/ 1484369 w 1646738"/>
                        <a:gd name="connsiteY35" fmla="*/ 910107 h 2671846"/>
                        <a:gd name="connsiteX36" fmla="*/ 1540448 w 1646738"/>
                        <a:gd name="connsiteY36" fmla="*/ 902863 h 2671846"/>
                        <a:gd name="connsiteX37" fmla="*/ 1585485 w 1646738"/>
                        <a:gd name="connsiteY37" fmla="*/ 901807 h 2671846"/>
                        <a:gd name="connsiteX38" fmla="*/ 1644139 w 1646738"/>
                        <a:gd name="connsiteY38" fmla="*/ 899338 h 2671846"/>
                        <a:gd name="connsiteX39" fmla="*/ 1636272 w 1646738"/>
                        <a:gd name="connsiteY39" fmla="*/ 868044 h 2671846"/>
                        <a:gd name="connsiteX40" fmla="*/ 1634844 w 1646738"/>
                        <a:gd name="connsiteY40" fmla="*/ 780484 h 2671846"/>
                        <a:gd name="connsiteX41" fmla="*/ 1584621 w 1646738"/>
                        <a:gd name="connsiteY41" fmla="*/ 780979 h 2671846"/>
                        <a:gd name="connsiteX42" fmla="*/ 1510151 w 1646738"/>
                        <a:gd name="connsiteY42" fmla="*/ 795482 h 2671846"/>
                        <a:gd name="connsiteX43" fmla="*/ 1415699 w 1646738"/>
                        <a:gd name="connsiteY43" fmla="*/ 750882 h 2671846"/>
                        <a:gd name="connsiteX0" fmla="*/ 1415699 w 1646738"/>
                        <a:gd name="connsiteY0" fmla="*/ 750882 h 2671846"/>
                        <a:gd name="connsiteX1" fmla="*/ 1273459 w 1646738"/>
                        <a:gd name="connsiteY1" fmla="*/ 192082 h 2671846"/>
                        <a:gd name="connsiteX2" fmla="*/ 907699 w 1646738"/>
                        <a:gd name="connsiteY2" fmla="*/ 9202 h 2671846"/>
                        <a:gd name="connsiteX3" fmla="*/ 562259 w 1646738"/>
                        <a:gd name="connsiteY3" fmla="*/ 435922 h 2671846"/>
                        <a:gd name="connsiteX4" fmla="*/ 379379 w 1646738"/>
                        <a:gd name="connsiteY4" fmla="*/ 954082 h 2671846"/>
                        <a:gd name="connsiteX5" fmla="*/ 298099 w 1646738"/>
                        <a:gd name="connsiteY5" fmla="*/ 1330002 h 2671846"/>
                        <a:gd name="connsiteX6" fmla="*/ 577725 w 1646738"/>
                        <a:gd name="connsiteY6" fmla="*/ 1308839 h 2671846"/>
                        <a:gd name="connsiteX7" fmla="*/ 785779 w 1646738"/>
                        <a:gd name="connsiteY7" fmla="*/ 1299522 h 2671846"/>
                        <a:gd name="connsiteX8" fmla="*/ 1039779 w 1646738"/>
                        <a:gd name="connsiteY8" fmla="*/ 1238562 h 2671846"/>
                        <a:gd name="connsiteX9" fmla="*/ 1192179 w 1646738"/>
                        <a:gd name="connsiteY9" fmla="*/ 1136962 h 2671846"/>
                        <a:gd name="connsiteX10" fmla="*/ 1283619 w 1646738"/>
                        <a:gd name="connsiteY10" fmla="*/ 1004882 h 2671846"/>
                        <a:gd name="connsiteX11" fmla="*/ 1306392 w 1646738"/>
                        <a:gd name="connsiteY11" fmla="*/ 953917 h 2671846"/>
                        <a:gd name="connsiteX12" fmla="*/ 1226412 w 1646738"/>
                        <a:gd name="connsiteY12" fmla="*/ 1123422 h 2671846"/>
                        <a:gd name="connsiteX13" fmla="*/ 1070259 w 1646738"/>
                        <a:gd name="connsiteY13" fmla="*/ 1250417 h 2671846"/>
                        <a:gd name="connsiteX14" fmla="*/ 810953 w 1646738"/>
                        <a:gd name="connsiteY14" fmla="*/ 1314767 h 2671846"/>
                        <a:gd name="connsiteX15" fmla="*/ 247299 w 1646738"/>
                        <a:gd name="connsiteY15" fmla="*/ 1401122 h 2671846"/>
                        <a:gd name="connsiteX16" fmla="*/ 84739 w 1646738"/>
                        <a:gd name="connsiteY16" fmla="*/ 1919282 h 2671846"/>
                        <a:gd name="connsiteX17" fmla="*/ 22679 w 1646738"/>
                        <a:gd name="connsiteY17" fmla="*/ 2323987 h 2671846"/>
                        <a:gd name="connsiteX18" fmla="*/ 9412 w 1646738"/>
                        <a:gd name="connsiteY18" fmla="*/ 2467922 h 2671846"/>
                        <a:gd name="connsiteX19" fmla="*/ 24685 w 1646738"/>
                        <a:gd name="connsiteY19" fmla="*/ 2653340 h 2671846"/>
                        <a:gd name="connsiteX20" fmla="*/ 277779 w 1646738"/>
                        <a:gd name="connsiteY20" fmla="*/ 2665014 h 2671846"/>
                        <a:gd name="connsiteX21" fmla="*/ 622861 w 1646738"/>
                        <a:gd name="connsiteY21" fmla="*/ 2651175 h 2671846"/>
                        <a:gd name="connsiteX22" fmla="*/ 885229 w 1646738"/>
                        <a:gd name="connsiteY22" fmla="*/ 2613018 h 2671846"/>
                        <a:gd name="connsiteX23" fmla="*/ 1184064 w 1646738"/>
                        <a:gd name="connsiteY23" fmla="*/ 2484750 h 2671846"/>
                        <a:gd name="connsiteX24" fmla="*/ 1334419 w 1646738"/>
                        <a:gd name="connsiteY24" fmla="*/ 2254562 h 2671846"/>
                        <a:gd name="connsiteX25" fmla="*/ 1415699 w 1646738"/>
                        <a:gd name="connsiteY25" fmla="*/ 1959922 h 2671846"/>
                        <a:gd name="connsiteX26" fmla="*/ 1425859 w 1646738"/>
                        <a:gd name="connsiteY26" fmla="*/ 1573842 h 2671846"/>
                        <a:gd name="connsiteX27" fmla="*/ 1407092 w 1646738"/>
                        <a:gd name="connsiteY27" fmla="*/ 1238562 h 2671846"/>
                        <a:gd name="connsiteX28" fmla="*/ 1415699 w 1646738"/>
                        <a:gd name="connsiteY28" fmla="*/ 1086162 h 2671846"/>
                        <a:gd name="connsiteX29" fmla="*/ 1631933 w 1646738"/>
                        <a:gd name="connsiteY29" fmla="*/ 1071736 h 2671846"/>
                        <a:gd name="connsiteX30" fmla="*/ 1630953 w 1646738"/>
                        <a:gd name="connsiteY30" fmla="*/ 979366 h 2671846"/>
                        <a:gd name="connsiteX31" fmla="*/ 1532785 w 1646738"/>
                        <a:gd name="connsiteY31" fmla="*/ 970136 h 2671846"/>
                        <a:gd name="connsiteX32" fmla="*/ 1415699 w 1646738"/>
                        <a:gd name="connsiteY32" fmla="*/ 954082 h 2671846"/>
                        <a:gd name="connsiteX33" fmla="*/ 1415699 w 1646738"/>
                        <a:gd name="connsiteY33" fmla="*/ 893122 h 2671846"/>
                        <a:gd name="connsiteX34" fmla="*/ 1415699 w 1646738"/>
                        <a:gd name="connsiteY34" fmla="*/ 913442 h 2671846"/>
                        <a:gd name="connsiteX35" fmla="*/ 1484369 w 1646738"/>
                        <a:gd name="connsiteY35" fmla="*/ 910107 h 2671846"/>
                        <a:gd name="connsiteX36" fmla="*/ 1540448 w 1646738"/>
                        <a:gd name="connsiteY36" fmla="*/ 902863 h 2671846"/>
                        <a:gd name="connsiteX37" fmla="*/ 1585485 w 1646738"/>
                        <a:gd name="connsiteY37" fmla="*/ 901807 h 2671846"/>
                        <a:gd name="connsiteX38" fmla="*/ 1644139 w 1646738"/>
                        <a:gd name="connsiteY38" fmla="*/ 899338 h 2671846"/>
                        <a:gd name="connsiteX39" fmla="*/ 1636272 w 1646738"/>
                        <a:gd name="connsiteY39" fmla="*/ 868044 h 2671846"/>
                        <a:gd name="connsiteX40" fmla="*/ 1634844 w 1646738"/>
                        <a:gd name="connsiteY40" fmla="*/ 780484 h 2671846"/>
                        <a:gd name="connsiteX41" fmla="*/ 1584621 w 1646738"/>
                        <a:gd name="connsiteY41" fmla="*/ 780979 h 2671846"/>
                        <a:gd name="connsiteX42" fmla="*/ 1491513 w 1646738"/>
                        <a:gd name="connsiteY42" fmla="*/ 795482 h 2671846"/>
                        <a:gd name="connsiteX43" fmla="*/ 1415699 w 1646738"/>
                        <a:gd name="connsiteY43" fmla="*/ 750882 h 2671846"/>
                        <a:gd name="connsiteX0" fmla="*/ 1415699 w 1646738"/>
                        <a:gd name="connsiteY0" fmla="*/ 750882 h 2671846"/>
                        <a:gd name="connsiteX1" fmla="*/ 1273459 w 1646738"/>
                        <a:gd name="connsiteY1" fmla="*/ 192082 h 2671846"/>
                        <a:gd name="connsiteX2" fmla="*/ 907699 w 1646738"/>
                        <a:gd name="connsiteY2" fmla="*/ 9202 h 2671846"/>
                        <a:gd name="connsiteX3" fmla="*/ 562259 w 1646738"/>
                        <a:gd name="connsiteY3" fmla="*/ 435922 h 2671846"/>
                        <a:gd name="connsiteX4" fmla="*/ 379379 w 1646738"/>
                        <a:gd name="connsiteY4" fmla="*/ 954082 h 2671846"/>
                        <a:gd name="connsiteX5" fmla="*/ 298099 w 1646738"/>
                        <a:gd name="connsiteY5" fmla="*/ 1330002 h 2671846"/>
                        <a:gd name="connsiteX6" fmla="*/ 577725 w 1646738"/>
                        <a:gd name="connsiteY6" fmla="*/ 1308839 h 2671846"/>
                        <a:gd name="connsiteX7" fmla="*/ 785779 w 1646738"/>
                        <a:gd name="connsiteY7" fmla="*/ 1299522 h 2671846"/>
                        <a:gd name="connsiteX8" fmla="*/ 1039779 w 1646738"/>
                        <a:gd name="connsiteY8" fmla="*/ 1238562 h 2671846"/>
                        <a:gd name="connsiteX9" fmla="*/ 1192179 w 1646738"/>
                        <a:gd name="connsiteY9" fmla="*/ 1136962 h 2671846"/>
                        <a:gd name="connsiteX10" fmla="*/ 1283619 w 1646738"/>
                        <a:gd name="connsiteY10" fmla="*/ 1004882 h 2671846"/>
                        <a:gd name="connsiteX11" fmla="*/ 1306392 w 1646738"/>
                        <a:gd name="connsiteY11" fmla="*/ 953917 h 2671846"/>
                        <a:gd name="connsiteX12" fmla="*/ 1226412 w 1646738"/>
                        <a:gd name="connsiteY12" fmla="*/ 1123422 h 2671846"/>
                        <a:gd name="connsiteX13" fmla="*/ 1070259 w 1646738"/>
                        <a:gd name="connsiteY13" fmla="*/ 1250417 h 2671846"/>
                        <a:gd name="connsiteX14" fmla="*/ 810953 w 1646738"/>
                        <a:gd name="connsiteY14" fmla="*/ 1314767 h 2671846"/>
                        <a:gd name="connsiteX15" fmla="*/ 247299 w 1646738"/>
                        <a:gd name="connsiteY15" fmla="*/ 1401122 h 2671846"/>
                        <a:gd name="connsiteX16" fmla="*/ 84739 w 1646738"/>
                        <a:gd name="connsiteY16" fmla="*/ 1919282 h 2671846"/>
                        <a:gd name="connsiteX17" fmla="*/ 22679 w 1646738"/>
                        <a:gd name="connsiteY17" fmla="*/ 2323987 h 2671846"/>
                        <a:gd name="connsiteX18" fmla="*/ 9412 w 1646738"/>
                        <a:gd name="connsiteY18" fmla="*/ 2467922 h 2671846"/>
                        <a:gd name="connsiteX19" fmla="*/ 24685 w 1646738"/>
                        <a:gd name="connsiteY19" fmla="*/ 2653340 h 2671846"/>
                        <a:gd name="connsiteX20" fmla="*/ 277779 w 1646738"/>
                        <a:gd name="connsiteY20" fmla="*/ 2665014 h 2671846"/>
                        <a:gd name="connsiteX21" fmla="*/ 622861 w 1646738"/>
                        <a:gd name="connsiteY21" fmla="*/ 2651175 h 2671846"/>
                        <a:gd name="connsiteX22" fmla="*/ 885229 w 1646738"/>
                        <a:gd name="connsiteY22" fmla="*/ 2613018 h 2671846"/>
                        <a:gd name="connsiteX23" fmla="*/ 1184064 w 1646738"/>
                        <a:gd name="connsiteY23" fmla="*/ 2484750 h 2671846"/>
                        <a:gd name="connsiteX24" fmla="*/ 1334419 w 1646738"/>
                        <a:gd name="connsiteY24" fmla="*/ 2254562 h 2671846"/>
                        <a:gd name="connsiteX25" fmla="*/ 1415699 w 1646738"/>
                        <a:gd name="connsiteY25" fmla="*/ 1959922 h 2671846"/>
                        <a:gd name="connsiteX26" fmla="*/ 1425859 w 1646738"/>
                        <a:gd name="connsiteY26" fmla="*/ 1573842 h 2671846"/>
                        <a:gd name="connsiteX27" fmla="*/ 1407092 w 1646738"/>
                        <a:gd name="connsiteY27" fmla="*/ 1238562 h 2671846"/>
                        <a:gd name="connsiteX28" fmla="*/ 1415699 w 1646738"/>
                        <a:gd name="connsiteY28" fmla="*/ 1086162 h 2671846"/>
                        <a:gd name="connsiteX29" fmla="*/ 1631933 w 1646738"/>
                        <a:gd name="connsiteY29" fmla="*/ 1071736 h 2671846"/>
                        <a:gd name="connsiteX30" fmla="*/ 1630953 w 1646738"/>
                        <a:gd name="connsiteY30" fmla="*/ 979366 h 2671846"/>
                        <a:gd name="connsiteX31" fmla="*/ 1532785 w 1646738"/>
                        <a:gd name="connsiteY31" fmla="*/ 970136 h 2671846"/>
                        <a:gd name="connsiteX32" fmla="*/ 1415699 w 1646738"/>
                        <a:gd name="connsiteY32" fmla="*/ 954082 h 2671846"/>
                        <a:gd name="connsiteX33" fmla="*/ 1415699 w 1646738"/>
                        <a:gd name="connsiteY33" fmla="*/ 893122 h 2671846"/>
                        <a:gd name="connsiteX34" fmla="*/ 1415699 w 1646738"/>
                        <a:gd name="connsiteY34" fmla="*/ 913442 h 2671846"/>
                        <a:gd name="connsiteX35" fmla="*/ 1484369 w 1646738"/>
                        <a:gd name="connsiteY35" fmla="*/ 910107 h 2671846"/>
                        <a:gd name="connsiteX36" fmla="*/ 1540448 w 1646738"/>
                        <a:gd name="connsiteY36" fmla="*/ 902863 h 2671846"/>
                        <a:gd name="connsiteX37" fmla="*/ 1585485 w 1646738"/>
                        <a:gd name="connsiteY37" fmla="*/ 901807 h 2671846"/>
                        <a:gd name="connsiteX38" fmla="*/ 1644139 w 1646738"/>
                        <a:gd name="connsiteY38" fmla="*/ 899338 h 2671846"/>
                        <a:gd name="connsiteX39" fmla="*/ 1636272 w 1646738"/>
                        <a:gd name="connsiteY39" fmla="*/ 868044 h 2671846"/>
                        <a:gd name="connsiteX40" fmla="*/ 1634844 w 1646738"/>
                        <a:gd name="connsiteY40" fmla="*/ 780484 h 2671846"/>
                        <a:gd name="connsiteX41" fmla="*/ 1584621 w 1646738"/>
                        <a:gd name="connsiteY41" fmla="*/ 792612 h 2671846"/>
                        <a:gd name="connsiteX42" fmla="*/ 1491513 w 1646738"/>
                        <a:gd name="connsiteY42" fmla="*/ 795482 h 2671846"/>
                        <a:gd name="connsiteX43" fmla="*/ 1415699 w 1646738"/>
                        <a:gd name="connsiteY43" fmla="*/ 750882 h 2671846"/>
                        <a:gd name="connsiteX0" fmla="*/ 1415699 w 1646738"/>
                        <a:gd name="connsiteY0" fmla="*/ 750882 h 2671846"/>
                        <a:gd name="connsiteX1" fmla="*/ 1273459 w 1646738"/>
                        <a:gd name="connsiteY1" fmla="*/ 192082 h 2671846"/>
                        <a:gd name="connsiteX2" fmla="*/ 907699 w 1646738"/>
                        <a:gd name="connsiteY2" fmla="*/ 9202 h 2671846"/>
                        <a:gd name="connsiteX3" fmla="*/ 562259 w 1646738"/>
                        <a:gd name="connsiteY3" fmla="*/ 435922 h 2671846"/>
                        <a:gd name="connsiteX4" fmla="*/ 379379 w 1646738"/>
                        <a:gd name="connsiteY4" fmla="*/ 954082 h 2671846"/>
                        <a:gd name="connsiteX5" fmla="*/ 298099 w 1646738"/>
                        <a:gd name="connsiteY5" fmla="*/ 1330002 h 2671846"/>
                        <a:gd name="connsiteX6" fmla="*/ 577725 w 1646738"/>
                        <a:gd name="connsiteY6" fmla="*/ 1308839 h 2671846"/>
                        <a:gd name="connsiteX7" fmla="*/ 785779 w 1646738"/>
                        <a:gd name="connsiteY7" fmla="*/ 1299522 h 2671846"/>
                        <a:gd name="connsiteX8" fmla="*/ 1039779 w 1646738"/>
                        <a:gd name="connsiteY8" fmla="*/ 1238562 h 2671846"/>
                        <a:gd name="connsiteX9" fmla="*/ 1192179 w 1646738"/>
                        <a:gd name="connsiteY9" fmla="*/ 1136962 h 2671846"/>
                        <a:gd name="connsiteX10" fmla="*/ 1283619 w 1646738"/>
                        <a:gd name="connsiteY10" fmla="*/ 1004882 h 2671846"/>
                        <a:gd name="connsiteX11" fmla="*/ 1306392 w 1646738"/>
                        <a:gd name="connsiteY11" fmla="*/ 953917 h 2671846"/>
                        <a:gd name="connsiteX12" fmla="*/ 1226412 w 1646738"/>
                        <a:gd name="connsiteY12" fmla="*/ 1123422 h 2671846"/>
                        <a:gd name="connsiteX13" fmla="*/ 1070259 w 1646738"/>
                        <a:gd name="connsiteY13" fmla="*/ 1250417 h 2671846"/>
                        <a:gd name="connsiteX14" fmla="*/ 810953 w 1646738"/>
                        <a:gd name="connsiteY14" fmla="*/ 1314767 h 2671846"/>
                        <a:gd name="connsiteX15" fmla="*/ 247299 w 1646738"/>
                        <a:gd name="connsiteY15" fmla="*/ 1401122 h 2671846"/>
                        <a:gd name="connsiteX16" fmla="*/ 84739 w 1646738"/>
                        <a:gd name="connsiteY16" fmla="*/ 1919282 h 2671846"/>
                        <a:gd name="connsiteX17" fmla="*/ 22679 w 1646738"/>
                        <a:gd name="connsiteY17" fmla="*/ 2323987 h 2671846"/>
                        <a:gd name="connsiteX18" fmla="*/ 9412 w 1646738"/>
                        <a:gd name="connsiteY18" fmla="*/ 2467922 h 2671846"/>
                        <a:gd name="connsiteX19" fmla="*/ 24685 w 1646738"/>
                        <a:gd name="connsiteY19" fmla="*/ 2653340 h 2671846"/>
                        <a:gd name="connsiteX20" fmla="*/ 277779 w 1646738"/>
                        <a:gd name="connsiteY20" fmla="*/ 2665014 h 2671846"/>
                        <a:gd name="connsiteX21" fmla="*/ 622861 w 1646738"/>
                        <a:gd name="connsiteY21" fmla="*/ 2651175 h 2671846"/>
                        <a:gd name="connsiteX22" fmla="*/ 885229 w 1646738"/>
                        <a:gd name="connsiteY22" fmla="*/ 2613018 h 2671846"/>
                        <a:gd name="connsiteX23" fmla="*/ 1184064 w 1646738"/>
                        <a:gd name="connsiteY23" fmla="*/ 2484750 h 2671846"/>
                        <a:gd name="connsiteX24" fmla="*/ 1334419 w 1646738"/>
                        <a:gd name="connsiteY24" fmla="*/ 2254562 h 2671846"/>
                        <a:gd name="connsiteX25" fmla="*/ 1415699 w 1646738"/>
                        <a:gd name="connsiteY25" fmla="*/ 1959922 h 2671846"/>
                        <a:gd name="connsiteX26" fmla="*/ 1425859 w 1646738"/>
                        <a:gd name="connsiteY26" fmla="*/ 1573842 h 2671846"/>
                        <a:gd name="connsiteX27" fmla="*/ 1407092 w 1646738"/>
                        <a:gd name="connsiteY27" fmla="*/ 1238562 h 2671846"/>
                        <a:gd name="connsiteX28" fmla="*/ 1415699 w 1646738"/>
                        <a:gd name="connsiteY28" fmla="*/ 1086162 h 2671846"/>
                        <a:gd name="connsiteX29" fmla="*/ 1631933 w 1646738"/>
                        <a:gd name="connsiteY29" fmla="*/ 1071736 h 2671846"/>
                        <a:gd name="connsiteX30" fmla="*/ 1630953 w 1646738"/>
                        <a:gd name="connsiteY30" fmla="*/ 979366 h 2671846"/>
                        <a:gd name="connsiteX31" fmla="*/ 1532785 w 1646738"/>
                        <a:gd name="connsiteY31" fmla="*/ 970136 h 2671846"/>
                        <a:gd name="connsiteX32" fmla="*/ 1415699 w 1646738"/>
                        <a:gd name="connsiteY32" fmla="*/ 954082 h 2671846"/>
                        <a:gd name="connsiteX33" fmla="*/ 1415699 w 1646738"/>
                        <a:gd name="connsiteY33" fmla="*/ 893122 h 2671846"/>
                        <a:gd name="connsiteX34" fmla="*/ 1415699 w 1646738"/>
                        <a:gd name="connsiteY34" fmla="*/ 913442 h 2671846"/>
                        <a:gd name="connsiteX35" fmla="*/ 1484369 w 1646738"/>
                        <a:gd name="connsiteY35" fmla="*/ 910107 h 2671846"/>
                        <a:gd name="connsiteX36" fmla="*/ 1540448 w 1646738"/>
                        <a:gd name="connsiteY36" fmla="*/ 902863 h 2671846"/>
                        <a:gd name="connsiteX37" fmla="*/ 1585485 w 1646738"/>
                        <a:gd name="connsiteY37" fmla="*/ 901807 h 2671846"/>
                        <a:gd name="connsiteX38" fmla="*/ 1644139 w 1646738"/>
                        <a:gd name="connsiteY38" fmla="*/ 899338 h 2671846"/>
                        <a:gd name="connsiteX39" fmla="*/ 1636272 w 1646738"/>
                        <a:gd name="connsiteY39" fmla="*/ 868044 h 2671846"/>
                        <a:gd name="connsiteX40" fmla="*/ 1634844 w 1646738"/>
                        <a:gd name="connsiteY40" fmla="*/ 788240 h 2671846"/>
                        <a:gd name="connsiteX41" fmla="*/ 1584621 w 1646738"/>
                        <a:gd name="connsiteY41" fmla="*/ 792612 h 2671846"/>
                        <a:gd name="connsiteX42" fmla="*/ 1491513 w 1646738"/>
                        <a:gd name="connsiteY42" fmla="*/ 795482 h 2671846"/>
                        <a:gd name="connsiteX43" fmla="*/ 1415699 w 1646738"/>
                        <a:gd name="connsiteY43" fmla="*/ 750882 h 2671846"/>
                        <a:gd name="connsiteX0" fmla="*/ 1415699 w 1646842"/>
                        <a:gd name="connsiteY0" fmla="*/ 750882 h 2671846"/>
                        <a:gd name="connsiteX1" fmla="*/ 1273459 w 1646842"/>
                        <a:gd name="connsiteY1" fmla="*/ 192082 h 2671846"/>
                        <a:gd name="connsiteX2" fmla="*/ 907699 w 1646842"/>
                        <a:gd name="connsiteY2" fmla="*/ 9202 h 2671846"/>
                        <a:gd name="connsiteX3" fmla="*/ 562259 w 1646842"/>
                        <a:gd name="connsiteY3" fmla="*/ 435922 h 2671846"/>
                        <a:gd name="connsiteX4" fmla="*/ 379379 w 1646842"/>
                        <a:gd name="connsiteY4" fmla="*/ 954082 h 2671846"/>
                        <a:gd name="connsiteX5" fmla="*/ 298099 w 1646842"/>
                        <a:gd name="connsiteY5" fmla="*/ 1330002 h 2671846"/>
                        <a:gd name="connsiteX6" fmla="*/ 577725 w 1646842"/>
                        <a:gd name="connsiteY6" fmla="*/ 1308839 h 2671846"/>
                        <a:gd name="connsiteX7" fmla="*/ 785779 w 1646842"/>
                        <a:gd name="connsiteY7" fmla="*/ 1299522 h 2671846"/>
                        <a:gd name="connsiteX8" fmla="*/ 1039779 w 1646842"/>
                        <a:gd name="connsiteY8" fmla="*/ 1238562 h 2671846"/>
                        <a:gd name="connsiteX9" fmla="*/ 1192179 w 1646842"/>
                        <a:gd name="connsiteY9" fmla="*/ 1136962 h 2671846"/>
                        <a:gd name="connsiteX10" fmla="*/ 1283619 w 1646842"/>
                        <a:gd name="connsiteY10" fmla="*/ 1004882 h 2671846"/>
                        <a:gd name="connsiteX11" fmla="*/ 1306392 w 1646842"/>
                        <a:gd name="connsiteY11" fmla="*/ 953917 h 2671846"/>
                        <a:gd name="connsiteX12" fmla="*/ 1226412 w 1646842"/>
                        <a:gd name="connsiteY12" fmla="*/ 1123422 h 2671846"/>
                        <a:gd name="connsiteX13" fmla="*/ 1070259 w 1646842"/>
                        <a:gd name="connsiteY13" fmla="*/ 1250417 h 2671846"/>
                        <a:gd name="connsiteX14" fmla="*/ 810953 w 1646842"/>
                        <a:gd name="connsiteY14" fmla="*/ 1314767 h 2671846"/>
                        <a:gd name="connsiteX15" fmla="*/ 247299 w 1646842"/>
                        <a:gd name="connsiteY15" fmla="*/ 1401122 h 2671846"/>
                        <a:gd name="connsiteX16" fmla="*/ 84739 w 1646842"/>
                        <a:gd name="connsiteY16" fmla="*/ 1919282 h 2671846"/>
                        <a:gd name="connsiteX17" fmla="*/ 22679 w 1646842"/>
                        <a:gd name="connsiteY17" fmla="*/ 2323987 h 2671846"/>
                        <a:gd name="connsiteX18" fmla="*/ 9412 w 1646842"/>
                        <a:gd name="connsiteY18" fmla="*/ 2467922 h 2671846"/>
                        <a:gd name="connsiteX19" fmla="*/ 24685 w 1646842"/>
                        <a:gd name="connsiteY19" fmla="*/ 2653340 h 2671846"/>
                        <a:gd name="connsiteX20" fmla="*/ 277779 w 1646842"/>
                        <a:gd name="connsiteY20" fmla="*/ 2665014 h 2671846"/>
                        <a:gd name="connsiteX21" fmla="*/ 622861 w 1646842"/>
                        <a:gd name="connsiteY21" fmla="*/ 2651175 h 2671846"/>
                        <a:gd name="connsiteX22" fmla="*/ 885229 w 1646842"/>
                        <a:gd name="connsiteY22" fmla="*/ 2613018 h 2671846"/>
                        <a:gd name="connsiteX23" fmla="*/ 1184064 w 1646842"/>
                        <a:gd name="connsiteY23" fmla="*/ 2484750 h 2671846"/>
                        <a:gd name="connsiteX24" fmla="*/ 1334419 w 1646842"/>
                        <a:gd name="connsiteY24" fmla="*/ 2254562 h 2671846"/>
                        <a:gd name="connsiteX25" fmla="*/ 1415699 w 1646842"/>
                        <a:gd name="connsiteY25" fmla="*/ 1959922 h 2671846"/>
                        <a:gd name="connsiteX26" fmla="*/ 1425859 w 1646842"/>
                        <a:gd name="connsiteY26" fmla="*/ 1573842 h 2671846"/>
                        <a:gd name="connsiteX27" fmla="*/ 1407092 w 1646842"/>
                        <a:gd name="connsiteY27" fmla="*/ 1238562 h 2671846"/>
                        <a:gd name="connsiteX28" fmla="*/ 1415699 w 1646842"/>
                        <a:gd name="connsiteY28" fmla="*/ 1086162 h 2671846"/>
                        <a:gd name="connsiteX29" fmla="*/ 1631933 w 1646842"/>
                        <a:gd name="connsiteY29" fmla="*/ 1071736 h 2671846"/>
                        <a:gd name="connsiteX30" fmla="*/ 1630953 w 1646842"/>
                        <a:gd name="connsiteY30" fmla="*/ 979366 h 2671846"/>
                        <a:gd name="connsiteX31" fmla="*/ 1532785 w 1646842"/>
                        <a:gd name="connsiteY31" fmla="*/ 970136 h 2671846"/>
                        <a:gd name="connsiteX32" fmla="*/ 1415699 w 1646842"/>
                        <a:gd name="connsiteY32" fmla="*/ 954082 h 2671846"/>
                        <a:gd name="connsiteX33" fmla="*/ 1415699 w 1646842"/>
                        <a:gd name="connsiteY33" fmla="*/ 893122 h 2671846"/>
                        <a:gd name="connsiteX34" fmla="*/ 1415699 w 1646842"/>
                        <a:gd name="connsiteY34" fmla="*/ 913442 h 2671846"/>
                        <a:gd name="connsiteX35" fmla="*/ 1484369 w 1646842"/>
                        <a:gd name="connsiteY35" fmla="*/ 910107 h 2671846"/>
                        <a:gd name="connsiteX36" fmla="*/ 1540448 w 1646842"/>
                        <a:gd name="connsiteY36" fmla="*/ 902863 h 2671846"/>
                        <a:gd name="connsiteX37" fmla="*/ 1585485 w 1646842"/>
                        <a:gd name="connsiteY37" fmla="*/ 901807 h 2671846"/>
                        <a:gd name="connsiteX38" fmla="*/ 1644139 w 1646842"/>
                        <a:gd name="connsiteY38" fmla="*/ 899338 h 2671846"/>
                        <a:gd name="connsiteX39" fmla="*/ 1636272 w 1646842"/>
                        <a:gd name="connsiteY39" fmla="*/ 868044 h 2671846"/>
                        <a:gd name="connsiteX40" fmla="*/ 1629519 w 1646842"/>
                        <a:gd name="connsiteY40" fmla="*/ 803751 h 2671846"/>
                        <a:gd name="connsiteX41" fmla="*/ 1584621 w 1646842"/>
                        <a:gd name="connsiteY41" fmla="*/ 792612 h 2671846"/>
                        <a:gd name="connsiteX42" fmla="*/ 1491513 w 1646842"/>
                        <a:gd name="connsiteY42" fmla="*/ 795482 h 2671846"/>
                        <a:gd name="connsiteX43" fmla="*/ 1415699 w 1646842"/>
                        <a:gd name="connsiteY43" fmla="*/ 750882 h 2671846"/>
                        <a:gd name="connsiteX0" fmla="*/ 1415699 w 1645962"/>
                        <a:gd name="connsiteY0" fmla="*/ 750882 h 2671846"/>
                        <a:gd name="connsiteX1" fmla="*/ 1273459 w 1645962"/>
                        <a:gd name="connsiteY1" fmla="*/ 192082 h 2671846"/>
                        <a:gd name="connsiteX2" fmla="*/ 907699 w 1645962"/>
                        <a:gd name="connsiteY2" fmla="*/ 9202 h 2671846"/>
                        <a:gd name="connsiteX3" fmla="*/ 562259 w 1645962"/>
                        <a:gd name="connsiteY3" fmla="*/ 435922 h 2671846"/>
                        <a:gd name="connsiteX4" fmla="*/ 379379 w 1645962"/>
                        <a:gd name="connsiteY4" fmla="*/ 954082 h 2671846"/>
                        <a:gd name="connsiteX5" fmla="*/ 298099 w 1645962"/>
                        <a:gd name="connsiteY5" fmla="*/ 1330002 h 2671846"/>
                        <a:gd name="connsiteX6" fmla="*/ 577725 w 1645962"/>
                        <a:gd name="connsiteY6" fmla="*/ 1308839 h 2671846"/>
                        <a:gd name="connsiteX7" fmla="*/ 785779 w 1645962"/>
                        <a:gd name="connsiteY7" fmla="*/ 1299522 h 2671846"/>
                        <a:gd name="connsiteX8" fmla="*/ 1039779 w 1645962"/>
                        <a:gd name="connsiteY8" fmla="*/ 1238562 h 2671846"/>
                        <a:gd name="connsiteX9" fmla="*/ 1192179 w 1645962"/>
                        <a:gd name="connsiteY9" fmla="*/ 1136962 h 2671846"/>
                        <a:gd name="connsiteX10" fmla="*/ 1283619 w 1645962"/>
                        <a:gd name="connsiteY10" fmla="*/ 1004882 h 2671846"/>
                        <a:gd name="connsiteX11" fmla="*/ 1306392 w 1645962"/>
                        <a:gd name="connsiteY11" fmla="*/ 953917 h 2671846"/>
                        <a:gd name="connsiteX12" fmla="*/ 1226412 w 1645962"/>
                        <a:gd name="connsiteY12" fmla="*/ 1123422 h 2671846"/>
                        <a:gd name="connsiteX13" fmla="*/ 1070259 w 1645962"/>
                        <a:gd name="connsiteY13" fmla="*/ 1250417 h 2671846"/>
                        <a:gd name="connsiteX14" fmla="*/ 810953 w 1645962"/>
                        <a:gd name="connsiteY14" fmla="*/ 1314767 h 2671846"/>
                        <a:gd name="connsiteX15" fmla="*/ 247299 w 1645962"/>
                        <a:gd name="connsiteY15" fmla="*/ 1401122 h 2671846"/>
                        <a:gd name="connsiteX16" fmla="*/ 84739 w 1645962"/>
                        <a:gd name="connsiteY16" fmla="*/ 1919282 h 2671846"/>
                        <a:gd name="connsiteX17" fmla="*/ 22679 w 1645962"/>
                        <a:gd name="connsiteY17" fmla="*/ 2323987 h 2671846"/>
                        <a:gd name="connsiteX18" fmla="*/ 9412 w 1645962"/>
                        <a:gd name="connsiteY18" fmla="*/ 2467922 h 2671846"/>
                        <a:gd name="connsiteX19" fmla="*/ 24685 w 1645962"/>
                        <a:gd name="connsiteY19" fmla="*/ 2653340 h 2671846"/>
                        <a:gd name="connsiteX20" fmla="*/ 277779 w 1645962"/>
                        <a:gd name="connsiteY20" fmla="*/ 2665014 h 2671846"/>
                        <a:gd name="connsiteX21" fmla="*/ 622861 w 1645962"/>
                        <a:gd name="connsiteY21" fmla="*/ 2651175 h 2671846"/>
                        <a:gd name="connsiteX22" fmla="*/ 885229 w 1645962"/>
                        <a:gd name="connsiteY22" fmla="*/ 2613018 h 2671846"/>
                        <a:gd name="connsiteX23" fmla="*/ 1184064 w 1645962"/>
                        <a:gd name="connsiteY23" fmla="*/ 2484750 h 2671846"/>
                        <a:gd name="connsiteX24" fmla="*/ 1334419 w 1645962"/>
                        <a:gd name="connsiteY24" fmla="*/ 2254562 h 2671846"/>
                        <a:gd name="connsiteX25" fmla="*/ 1415699 w 1645962"/>
                        <a:gd name="connsiteY25" fmla="*/ 1959922 h 2671846"/>
                        <a:gd name="connsiteX26" fmla="*/ 1425859 w 1645962"/>
                        <a:gd name="connsiteY26" fmla="*/ 1573842 h 2671846"/>
                        <a:gd name="connsiteX27" fmla="*/ 1407092 w 1645962"/>
                        <a:gd name="connsiteY27" fmla="*/ 1238562 h 2671846"/>
                        <a:gd name="connsiteX28" fmla="*/ 1415699 w 1645962"/>
                        <a:gd name="connsiteY28" fmla="*/ 1086162 h 2671846"/>
                        <a:gd name="connsiteX29" fmla="*/ 1631933 w 1645962"/>
                        <a:gd name="connsiteY29" fmla="*/ 1071736 h 2671846"/>
                        <a:gd name="connsiteX30" fmla="*/ 1630953 w 1645962"/>
                        <a:gd name="connsiteY30" fmla="*/ 979366 h 2671846"/>
                        <a:gd name="connsiteX31" fmla="*/ 1532785 w 1645962"/>
                        <a:gd name="connsiteY31" fmla="*/ 970136 h 2671846"/>
                        <a:gd name="connsiteX32" fmla="*/ 1415699 w 1645962"/>
                        <a:gd name="connsiteY32" fmla="*/ 954082 h 2671846"/>
                        <a:gd name="connsiteX33" fmla="*/ 1415699 w 1645962"/>
                        <a:gd name="connsiteY33" fmla="*/ 893122 h 2671846"/>
                        <a:gd name="connsiteX34" fmla="*/ 1415699 w 1645962"/>
                        <a:gd name="connsiteY34" fmla="*/ 913442 h 2671846"/>
                        <a:gd name="connsiteX35" fmla="*/ 1484369 w 1645962"/>
                        <a:gd name="connsiteY35" fmla="*/ 910107 h 2671846"/>
                        <a:gd name="connsiteX36" fmla="*/ 1540448 w 1645962"/>
                        <a:gd name="connsiteY36" fmla="*/ 902863 h 2671846"/>
                        <a:gd name="connsiteX37" fmla="*/ 1585485 w 1645962"/>
                        <a:gd name="connsiteY37" fmla="*/ 901807 h 2671846"/>
                        <a:gd name="connsiteX38" fmla="*/ 1644139 w 1645962"/>
                        <a:gd name="connsiteY38" fmla="*/ 899338 h 2671846"/>
                        <a:gd name="connsiteX39" fmla="*/ 1630947 w 1645962"/>
                        <a:gd name="connsiteY39" fmla="*/ 864166 h 2671846"/>
                        <a:gd name="connsiteX40" fmla="*/ 1629519 w 1645962"/>
                        <a:gd name="connsiteY40" fmla="*/ 803751 h 2671846"/>
                        <a:gd name="connsiteX41" fmla="*/ 1584621 w 1645962"/>
                        <a:gd name="connsiteY41" fmla="*/ 792612 h 2671846"/>
                        <a:gd name="connsiteX42" fmla="*/ 1491513 w 1645962"/>
                        <a:gd name="connsiteY42" fmla="*/ 795482 h 2671846"/>
                        <a:gd name="connsiteX43" fmla="*/ 1415699 w 1645962"/>
                        <a:gd name="connsiteY43" fmla="*/ 750882 h 2671846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  <a:cxn ang="0">
                          <a:pos x="connsiteX42" y="connsiteY42"/>
                        </a:cxn>
                        <a:cxn ang="0">
                          <a:pos x="connsiteX43" y="connsiteY43"/>
                        </a:cxn>
                      </a:cxnLst>
                      <a:rect l="l" t="t" r="r" b="b"/>
                      <a:pathLst>
                        <a:path w="1645962" h="2671846">
                          <a:moveTo>
                            <a:pt x="1415699" y="750882"/>
                          </a:moveTo>
                          <a:cubicBezTo>
                            <a:pt x="1379357" y="650315"/>
                            <a:pt x="1358126" y="315695"/>
                            <a:pt x="1273459" y="192082"/>
                          </a:cubicBezTo>
                          <a:cubicBezTo>
                            <a:pt x="1188792" y="68469"/>
                            <a:pt x="1026232" y="-31438"/>
                            <a:pt x="907699" y="9202"/>
                          </a:cubicBezTo>
                          <a:cubicBezTo>
                            <a:pt x="789166" y="49842"/>
                            <a:pt x="650312" y="278442"/>
                            <a:pt x="562259" y="435922"/>
                          </a:cubicBezTo>
                          <a:cubicBezTo>
                            <a:pt x="474206" y="593402"/>
                            <a:pt x="423406" y="805069"/>
                            <a:pt x="379379" y="954082"/>
                          </a:cubicBezTo>
                          <a:cubicBezTo>
                            <a:pt x="335352" y="1103095"/>
                            <a:pt x="265041" y="1270876"/>
                            <a:pt x="298099" y="1330002"/>
                          </a:cubicBezTo>
                          <a:cubicBezTo>
                            <a:pt x="331157" y="1389128"/>
                            <a:pt x="466418" y="1309686"/>
                            <a:pt x="577725" y="1308839"/>
                          </a:cubicBezTo>
                          <a:cubicBezTo>
                            <a:pt x="689032" y="1307992"/>
                            <a:pt x="708770" y="1311235"/>
                            <a:pt x="785779" y="1299522"/>
                          </a:cubicBezTo>
                          <a:cubicBezTo>
                            <a:pt x="862788" y="1287809"/>
                            <a:pt x="972046" y="1265655"/>
                            <a:pt x="1039779" y="1238562"/>
                          </a:cubicBezTo>
                          <a:cubicBezTo>
                            <a:pt x="1107512" y="1211469"/>
                            <a:pt x="1151539" y="1175909"/>
                            <a:pt x="1192179" y="1136962"/>
                          </a:cubicBezTo>
                          <a:cubicBezTo>
                            <a:pt x="1232819" y="1098015"/>
                            <a:pt x="1264584" y="1035390"/>
                            <a:pt x="1283619" y="1004882"/>
                          </a:cubicBezTo>
                          <a:cubicBezTo>
                            <a:pt x="1302655" y="974375"/>
                            <a:pt x="1315927" y="934160"/>
                            <a:pt x="1306392" y="953917"/>
                          </a:cubicBezTo>
                          <a:cubicBezTo>
                            <a:pt x="1296858" y="973674"/>
                            <a:pt x="1265767" y="1074005"/>
                            <a:pt x="1226412" y="1123422"/>
                          </a:cubicBezTo>
                          <a:cubicBezTo>
                            <a:pt x="1187057" y="1172839"/>
                            <a:pt x="1139502" y="1218526"/>
                            <a:pt x="1070259" y="1250417"/>
                          </a:cubicBezTo>
                          <a:cubicBezTo>
                            <a:pt x="1001016" y="1282308"/>
                            <a:pt x="948113" y="1289650"/>
                            <a:pt x="810953" y="1314767"/>
                          </a:cubicBezTo>
                          <a:cubicBezTo>
                            <a:pt x="673793" y="1339884"/>
                            <a:pt x="368335" y="1300370"/>
                            <a:pt x="247299" y="1401122"/>
                          </a:cubicBezTo>
                          <a:cubicBezTo>
                            <a:pt x="126263" y="1501874"/>
                            <a:pt x="122176" y="1765471"/>
                            <a:pt x="84739" y="1919282"/>
                          </a:cubicBezTo>
                          <a:cubicBezTo>
                            <a:pt x="47302" y="2073093"/>
                            <a:pt x="35233" y="2232547"/>
                            <a:pt x="22679" y="2323987"/>
                          </a:cubicBezTo>
                          <a:cubicBezTo>
                            <a:pt x="10125" y="2415427"/>
                            <a:pt x="9078" y="2413030"/>
                            <a:pt x="9412" y="2467922"/>
                          </a:cubicBezTo>
                          <a:cubicBezTo>
                            <a:pt x="9746" y="2522814"/>
                            <a:pt x="-20043" y="2620491"/>
                            <a:pt x="24685" y="2653340"/>
                          </a:cubicBezTo>
                          <a:cubicBezTo>
                            <a:pt x="69413" y="2686189"/>
                            <a:pt x="178083" y="2665375"/>
                            <a:pt x="277779" y="2665014"/>
                          </a:cubicBezTo>
                          <a:cubicBezTo>
                            <a:pt x="377475" y="2664653"/>
                            <a:pt x="521619" y="2659841"/>
                            <a:pt x="622861" y="2651175"/>
                          </a:cubicBezTo>
                          <a:cubicBezTo>
                            <a:pt x="724103" y="2642509"/>
                            <a:pt x="791695" y="2640755"/>
                            <a:pt x="885229" y="2613018"/>
                          </a:cubicBezTo>
                          <a:cubicBezTo>
                            <a:pt x="978763" y="2585281"/>
                            <a:pt x="1109199" y="2544493"/>
                            <a:pt x="1184064" y="2484750"/>
                          </a:cubicBezTo>
                          <a:cubicBezTo>
                            <a:pt x="1258929" y="2425007"/>
                            <a:pt x="1295813" y="2342033"/>
                            <a:pt x="1334419" y="2254562"/>
                          </a:cubicBezTo>
                          <a:cubicBezTo>
                            <a:pt x="1373025" y="2167091"/>
                            <a:pt x="1400459" y="2073375"/>
                            <a:pt x="1415699" y="1959922"/>
                          </a:cubicBezTo>
                          <a:cubicBezTo>
                            <a:pt x="1430939" y="1846469"/>
                            <a:pt x="1427293" y="1694069"/>
                            <a:pt x="1425859" y="1573842"/>
                          </a:cubicBezTo>
                          <a:cubicBezTo>
                            <a:pt x="1424425" y="1453615"/>
                            <a:pt x="1408785" y="1319842"/>
                            <a:pt x="1407092" y="1238562"/>
                          </a:cubicBezTo>
                          <a:cubicBezTo>
                            <a:pt x="1405399" y="1157282"/>
                            <a:pt x="1378226" y="1113966"/>
                            <a:pt x="1415699" y="1086162"/>
                          </a:cubicBezTo>
                          <a:cubicBezTo>
                            <a:pt x="1453172" y="1058358"/>
                            <a:pt x="1617357" y="1066268"/>
                            <a:pt x="1631933" y="1071736"/>
                          </a:cubicBezTo>
                          <a:cubicBezTo>
                            <a:pt x="1646509" y="1077204"/>
                            <a:pt x="1647478" y="996299"/>
                            <a:pt x="1630953" y="979366"/>
                          </a:cubicBezTo>
                          <a:cubicBezTo>
                            <a:pt x="1614428" y="962433"/>
                            <a:pt x="1568661" y="974350"/>
                            <a:pt x="1532785" y="970136"/>
                          </a:cubicBezTo>
                          <a:cubicBezTo>
                            <a:pt x="1496909" y="965922"/>
                            <a:pt x="1435213" y="966918"/>
                            <a:pt x="1415699" y="954082"/>
                          </a:cubicBezTo>
                          <a:cubicBezTo>
                            <a:pt x="1396185" y="941246"/>
                            <a:pt x="1415699" y="893122"/>
                            <a:pt x="1415699" y="893122"/>
                          </a:cubicBezTo>
                          <a:cubicBezTo>
                            <a:pt x="1415699" y="886349"/>
                            <a:pt x="1404254" y="910611"/>
                            <a:pt x="1415699" y="913442"/>
                          </a:cubicBezTo>
                          <a:cubicBezTo>
                            <a:pt x="1427144" y="916273"/>
                            <a:pt x="1463578" y="911870"/>
                            <a:pt x="1484369" y="910107"/>
                          </a:cubicBezTo>
                          <a:cubicBezTo>
                            <a:pt x="1505160" y="908344"/>
                            <a:pt x="1523595" y="904246"/>
                            <a:pt x="1540448" y="902863"/>
                          </a:cubicBezTo>
                          <a:cubicBezTo>
                            <a:pt x="1557301" y="901480"/>
                            <a:pt x="1568203" y="902394"/>
                            <a:pt x="1585485" y="901807"/>
                          </a:cubicBezTo>
                          <a:cubicBezTo>
                            <a:pt x="1602767" y="901220"/>
                            <a:pt x="1636562" y="905611"/>
                            <a:pt x="1644139" y="899338"/>
                          </a:cubicBezTo>
                          <a:cubicBezTo>
                            <a:pt x="1651716" y="893065"/>
                            <a:pt x="1633384" y="880097"/>
                            <a:pt x="1630947" y="864166"/>
                          </a:cubicBezTo>
                          <a:cubicBezTo>
                            <a:pt x="1628510" y="848235"/>
                            <a:pt x="1637240" y="815677"/>
                            <a:pt x="1629519" y="803751"/>
                          </a:cubicBezTo>
                          <a:cubicBezTo>
                            <a:pt x="1621798" y="791825"/>
                            <a:pt x="1625506" y="763877"/>
                            <a:pt x="1584621" y="792612"/>
                          </a:cubicBezTo>
                          <a:cubicBezTo>
                            <a:pt x="1545976" y="793538"/>
                            <a:pt x="1519667" y="802437"/>
                            <a:pt x="1491513" y="795482"/>
                          </a:cubicBezTo>
                          <a:cubicBezTo>
                            <a:pt x="1463359" y="788527"/>
                            <a:pt x="1452041" y="851449"/>
                            <a:pt x="1415699" y="750882"/>
                          </a:cubicBezTo>
                          <a:close/>
                        </a:path>
                      </a:pathLst>
                    </a:custGeom>
                    <a:gradFill flip="none" rotWithShape="1">
                      <a:gsLst>
                        <a:gs pos="100000">
                          <a:srgbClr val="FFC5D4">
                            <a:alpha val="49000"/>
                            <a:lumMod val="90000"/>
                            <a:lumOff val="10000"/>
                          </a:srgbClr>
                        </a:gs>
                        <a:gs pos="66000">
                          <a:srgbClr val="FFC5D4">
                            <a:lumMod val="96000"/>
                            <a:alpha val="82000"/>
                          </a:srgbClr>
                        </a:gs>
                        <a:gs pos="7000">
                          <a:schemeClr val="accent2">
                            <a:lumMod val="20000"/>
                            <a:lumOff val="80000"/>
                          </a:schemeClr>
                        </a:gs>
                        <a:gs pos="100000">
                          <a:srgbClr val="FFD1F6">
                            <a:lumMod val="0"/>
                            <a:lumOff val="100000"/>
                            <a:alpha val="56000"/>
                          </a:srgbClr>
                        </a:gs>
                      </a:gsLst>
                      <a:lin ang="5400000" scaled="1"/>
                      <a:tileRect/>
                    </a:gradFill>
                    <a:ln>
                      <a:solidFill>
                        <a:srgbClr val="F2E6E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600">
                        <a:solidFill>
                          <a:srgbClr val="FFC5D4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" name="任意多边形: 形状 4">
                      <a:extLst>
                        <a:ext uri="{FF2B5EF4-FFF2-40B4-BE49-F238E27FC236}">
                          <a16:creationId xmlns:a16="http://schemas.microsoft.com/office/drawing/2014/main" id="{D2B1EE42-E85E-4276-A600-9964B6645D7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8800355" y="1854997"/>
                      <a:ext cx="1562151" cy="1944231"/>
                    </a:xfrm>
                    <a:custGeom>
                      <a:avLst/>
                      <a:gdLst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3008 w 1218420"/>
                        <a:gd name="connsiteY11" fmla="*/ 322446 h 1494426"/>
                        <a:gd name="connsiteX12" fmla="*/ 544928 w 1218420"/>
                        <a:gd name="connsiteY12" fmla="*/ 322446 h 1494426"/>
                        <a:gd name="connsiteX13" fmla="*/ 798928 w 1218420"/>
                        <a:gd name="connsiteY13" fmla="*/ 403726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301088 w 1218420"/>
                        <a:gd name="connsiteY24" fmla="*/ 921886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48606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3008 w 1218420"/>
                        <a:gd name="connsiteY11" fmla="*/ 322446 h 1494426"/>
                        <a:gd name="connsiteX12" fmla="*/ 544928 w 1218420"/>
                        <a:gd name="connsiteY12" fmla="*/ 322446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301088 w 1218420"/>
                        <a:gd name="connsiteY24" fmla="*/ 921886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48606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3008 w 1218420"/>
                        <a:gd name="connsiteY11" fmla="*/ 322446 h 1494426"/>
                        <a:gd name="connsiteX12" fmla="*/ 544928 w 1218420"/>
                        <a:gd name="connsiteY12" fmla="*/ 322446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301088 w 1218420"/>
                        <a:gd name="connsiteY24" fmla="*/ 921886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48606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3008 w 1218420"/>
                        <a:gd name="connsiteY11" fmla="*/ 322446 h 1494426"/>
                        <a:gd name="connsiteX12" fmla="*/ 563766 w 1218420"/>
                        <a:gd name="connsiteY12" fmla="*/ 309618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301088 w 1218420"/>
                        <a:gd name="connsiteY24" fmla="*/ 921886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48606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7718 w 1218420"/>
                        <a:gd name="connsiteY11" fmla="*/ 296791 h 1494426"/>
                        <a:gd name="connsiteX12" fmla="*/ 563766 w 1218420"/>
                        <a:gd name="connsiteY12" fmla="*/ 309618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301088 w 1218420"/>
                        <a:gd name="connsiteY24" fmla="*/ 921886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48606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7718 w 1218420"/>
                        <a:gd name="connsiteY11" fmla="*/ 296791 h 1494426"/>
                        <a:gd name="connsiteX12" fmla="*/ 563766 w 1218420"/>
                        <a:gd name="connsiteY12" fmla="*/ 309618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291669 w 1218420"/>
                        <a:gd name="connsiteY24" fmla="*/ 905852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48606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7718 w 1218420"/>
                        <a:gd name="connsiteY11" fmla="*/ 296791 h 1494426"/>
                        <a:gd name="connsiteX12" fmla="*/ 563766 w 1218420"/>
                        <a:gd name="connsiteY12" fmla="*/ 309618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291669 w 1218420"/>
                        <a:gd name="connsiteY24" fmla="*/ 905852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48606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7718 w 1218420"/>
                        <a:gd name="connsiteY11" fmla="*/ 296791 h 1494426"/>
                        <a:gd name="connsiteX12" fmla="*/ 563766 w 1218420"/>
                        <a:gd name="connsiteY12" fmla="*/ 309618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291669 w 1218420"/>
                        <a:gd name="connsiteY24" fmla="*/ 905852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9566 h 1494426"/>
                        <a:gd name="connsiteX31" fmla="*/ 382368 w 1218420"/>
                        <a:gd name="connsiteY31" fmla="*/ 1332571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8420"/>
                        <a:gd name="connsiteY0" fmla="*/ 820286 h 1494426"/>
                        <a:gd name="connsiteX1" fmla="*/ 991968 w 1218420"/>
                        <a:gd name="connsiteY1" fmla="*/ 637406 h 1494426"/>
                        <a:gd name="connsiteX2" fmla="*/ 910688 w 1218420"/>
                        <a:gd name="connsiteY2" fmla="*/ 363086 h 1494426"/>
                        <a:gd name="connsiteX3" fmla="*/ 849728 w 1218420"/>
                        <a:gd name="connsiteY3" fmla="*/ 170046 h 1494426"/>
                        <a:gd name="connsiteX4" fmla="*/ 758288 w 1218420"/>
                        <a:gd name="connsiteY4" fmla="*/ 27806 h 1494426"/>
                        <a:gd name="connsiteX5" fmla="*/ 717648 w 1218420"/>
                        <a:gd name="connsiteY5" fmla="*/ 17646 h 1494426"/>
                        <a:gd name="connsiteX6" fmla="*/ 839568 w 1218420"/>
                        <a:gd name="connsiteY6" fmla="*/ 220846 h 1494426"/>
                        <a:gd name="connsiteX7" fmla="*/ 890368 w 1218420"/>
                        <a:gd name="connsiteY7" fmla="*/ 464686 h 1494426"/>
                        <a:gd name="connsiteX8" fmla="*/ 758288 w 1218420"/>
                        <a:gd name="connsiteY8" fmla="*/ 352926 h 1494426"/>
                        <a:gd name="connsiteX9" fmla="*/ 534768 w 1218420"/>
                        <a:gd name="connsiteY9" fmla="*/ 281806 h 1494426"/>
                        <a:gd name="connsiteX10" fmla="*/ 311248 w 1218420"/>
                        <a:gd name="connsiteY10" fmla="*/ 271646 h 1494426"/>
                        <a:gd name="connsiteX11" fmla="*/ 427718 w 1218420"/>
                        <a:gd name="connsiteY11" fmla="*/ 296791 h 1494426"/>
                        <a:gd name="connsiteX12" fmla="*/ 563766 w 1218420"/>
                        <a:gd name="connsiteY12" fmla="*/ 309618 h 1494426"/>
                        <a:gd name="connsiteX13" fmla="*/ 784800 w 1218420"/>
                        <a:gd name="connsiteY13" fmla="*/ 410140 h 1494426"/>
                        <a:gd name="connsiteX14" fmla="*/ 870048 w 1218420"/>
                        <a:gd name="connsiteY14" fmla="*/ 545966 h 1494426"/>
                        <a:gd name="connsiteX15" fmla="*/ 910688 w 1218420"/>
                        <a:gd name="connsiteY15" fmla="*/ 657726 h 1494426"/>
                        <a:gd name="connsiteX16" fmla="*/ 961488 w 1218420"/>
                        <a:gd name="connsiteY16" fmla="*/ 789806 h 1494426"/>
                        <a:gd name="connsiteX17" fmla="*/ 646528 w 1218420"/>
                        <a:gd name="connsiteY17" fmla="*/ 840606 h 1494426"/>
                        <a:gd name="connsiteX18" fmla="*/ 524608 w 1218420"/>
                        <a:gd name="connsiteY18" fmla="*/ 637406 h 1494426"/>
                        <a:gd name="connsiteX19" fmla="*/ 483968 w 1218420"/>
                        <a:gd name="connsiteY19" fmla="*/ 515486 h 1494426"/>
                        <a:gd name="connsiteX20" fmla="*/ 453488 w 1218420"/>
                        <a:gd name="connsiteY20" fmla="*/ 545966 h 1494426"/>
                        <a:gd name="connsiteX21" fmla="*/ 544928 w 1218420"/>
                        <a:gd name="connsiteY21" fmla="*/ 789806 h 1494426"/>
                        <a:gd name="connsiteX22" fmla="*/ 595728 w 1218420"/>
                        <a:gd name="connsiteY22" fmla="*/ 881246 h 1494426"/>
                        <a:gd name="connsiteX23" fmla="*/ 169008 w 1218420"/>
                        <a:gd name="connsiteY23" fmla="*/ 871086 h 1494426"/>
                        <a:gd name="connsiteX24" fmla="*/ 291669 w 1218420"/>
                        <a:gd name="connsiteY24" fmla="*/ 905852 h 1494426"/>
                        <a:gd name="connsiteX25" fmla="*/ 717648 w 1218420"/>
                        <a:gd name="connsiteY25" fmla="*/ 921886 h 1494426"/>
                        <a:gd name="connsiteX26" fmla="*/ 880208 w 1218420"/>
                        <a:gd name="connsiteY26" fmla="*/ 881246 h 1494426"/>
                        <a:gd name="connsiteX27" fmla="*/ 626208 w 1218420"/>
                        <a:gd name="connsiteY27" fmla="*/ 1165726 h 1494426"/>
                        <a:gd name="connsiteX28" fmla="*/ 199488 w 1218420"/>
                        <a:gd name="connsiteY28" fmla="*/ 1348606 h 1494426"/>
                        <a:gd name="connsiteX29" fmla="*/ 6448 w 1218420"/>
                        <a:gd name="connsiteY29" fmla="*/ 1379086 h 1494426"/>
                        <a:gd name="connsiteX30" fmla="*/ 77568 w 1218420"/>
                        <a:gd name="connsiteY30" fmla="*/ 1403152 h 1494426"/>
                        <a:gd name="connsiteX31" fmla="*/ 382368 w 1218420"/>
                        <a:gd name="connsiteY31" fmla="*/ 1332571 h 1494426"/>
                        <a:gd name="connsiteX32" fmla="*/ 636368 w 1218420"/>
                        <a:gd name="connsiteY32" fmla="*/ 1226686 h 1494426"/>
                        <a:gd name="connsiteX33" fmla="*/ 575408 w 1218420"/>
                        <a:gd name="connsiteY33" fmla="*/ 1480686 h 1494426"/>
                        <a:gd name="connsiteX34" fmla="*/ 646528 w 1218420"/>
                        <a:gd name="connsiteY34" fmla="*/ 1440046 h 1494426"/>
                        <a:gd name="connsiteX35" fmla="*/ 687168 w 1218420"/>
                        <a:gd name="connsiteY35" fmla="*/ 1267326 h 1494426"/>
                        <a:gd name="connsiteX36" fmla="*/ 717648 w 1218420"/>
                        <a:gd name="connsiteY36" fmla="*/ 1165726 h 1494426"/>
                        <a:gd name="connsiteX37" fmla="*/ 890368 w 1218420"/>
                        <a:gd name="connsiteY37" fmla="*/ 1053966 h 1494426"/>
                        <a:gd name="connsiteX38" fmla="*/ 1124048 w 1218420"/>
                        <a:gd name="connsiteY38" fmla="*/ 962526 h 1494426"/>
                        <a:gd name="connsiteX39" fmla="*/ 1185008 w 1218420"/>
                        <a:gd name="connsiteY39" fmla="*/ 972686 h 1494426"/>
                        <a:gd name="connsiteX40" fmla="*/ 1215488 w 1218420"/>
                        <a:gd name="connsiteY40" fmla="*/ 1003166 h 1494426"/>
                        <a:gd name="connsiteX41" fmla="*/ 1215488 w 1218420"/>
                        <a:gd name="connsiteY41" fmla="*/ 1013326 h 1494426"/>
                        <a:gd name="connsiteX0" fmla="*/ 1144368 w 1216495"/>
                        <a:gd name="connsiteY0" fmla="*/ 820286 h 1494426"/>
                        <a:gd name="connsiteX1" fmla="*/ 991968 w 1216495"/>
                        <a:gd name="connsiteY1" fmla="*/ 637406 h 1494426"/>
                        <a:gd name="connsiteX2" fmla="*/ 910688 w 1216495"/>
                        <a:gd name="connsiteY2" fmla="*/ 363086 h 1494426"/>
                        <a:gd name="connsiteX3" fmla="*/ 849728 w 1216495"/>
                        <a:gd name="connsiteY3" fmla="*/ 170046 h 1494426"/>
                        <a:gd name="connsiteX4" fmla="*/ 758288 w 1216495"/>
                        <a:gd name="connsiteY4" fmla="*/ 27806 h 1494426"/>
                        <a:gd name="connsiteX5" fmla="*/ 717648 w 1216495"/>
                        <a:gd name="connsiteY5" fmla="*/ 17646 h 1494426"/>
                        <a:gd name="connsiteX6" fmla="*/ 839568 w 1216495"/>
                        <a:gd name="connsiteY6" fmla="*/ 220846 h 1494426"/>
                        <a:gd name="connsiteX7" fmla="*/ 890368 w 1216495"/>
                        <a:gd name="connsiteY7" fmla="*/ 464686 h 1494426"/>
                        <a:gd name="connsiteX8" fmla="*/ 758288 w 1216495"/>
                        <a:gd name="connsiteY8" fmla="*/ 352926 h 1494426"/>
                        <a:gd name="connsiteX9" fmla="*/ 534768 w 1216495"/>
                        <a:gd name="connsiteY9" fmla="*/ 281806 h 1494426"/>
                        <a:gd name="connsiteX10" fmla="*/ 311248 w 1216495"/>
                        <a:gd name="connsiteY10" fmla="*/ 271646 h 1494426"/>
                        <a:gd name="connsiteX11" fmla="*/ 427718 w 1216495"/>
                        <a:gd name="connsiteY11" fmla="*/ 296791 h 1494426"/>
                        <a:gd name="connsiteX12" fmla="*/ 563766 w 1216495"/>
                        <a:gd name="connsiteY12" fmla="*/ 309618 h 1494426"/>
                        <a:gd name="connsiteX13" fmla="*/ 784800 w 1216495"/>
                        <a:gd name="connsiteY13" fmla="*/ 410140 h 1494426"/>
                        <a:gd name="connsiteX14" fmla="*/ 870048 w 1216495"/>
                        <a:gd name="connsiteY14" fmla="*/ 545966 h 1494426"/>
                        <a:gd name="connsiteX15" fmla="*/ 910688 w 1216495"/>
                        <a:gd name="connsiteY15" fmla="*/ 657726 h 1494426"/>
                        <a:gd name="connsiteX16" fmla="*/ 961488 w 1216495"/>
                        <a:gd name="connsiteY16" fmla="*/ 789806 h 1494426"/>
                        <a:gd name="connsiteX17" fmla="*/ 646528 w 1216495"/>
                        <a:gd name="connsiteY17" fmla="*/ 840606 h 1494426"/>
                        <a:gd name="connsiteX18" fmla="*/ 524608 w 1216495"/>
                        <a:gd name="connsiteY18" fmla="*/ 637406 h 1494426"/>
                        <a:gd name="connsiteX19" fmla="*/ 483968 w 1216495"/>
                        <a:gd name="connsiteY19" fmla="*/ 515486 h 1494426"/>
                        <a:gd name="connsiteX20" fmla="*/ 453488 w 1216495"/>
                        <a:gd name="connsiteY20" fmla="*/ 545966 h 1494426"/>
                        <a:gd name="connsiteX21" fmla="*/ 544928 w 1216495"/>
                        <a:gd name="connsiteY21" fmla="*/ 789806 h 1494426"/>
                        <a:gd name="connsiteX22" fmla="*/ 595728 w 1216495"/>
                        <a:gd name="connsiteY22" fmla="*/ 881246 h 1494426"/>
                        <a:gd name="connsiteX23" fmla="*/ 169008 w 1216495"/>
                        <a:gd name="connsiteY23" fmla="*/ 871086 h 1494426"/>
                        <a:gd name="connsiteX24" fmla="*/ 291669 w 1216495"/>
                        <a:gd name="connsiteY24" fmla="*/ 905852 h 1494426"/>
                        <a:gd name="connsiteX25" fmla="*/ 717648 w 1216495"/>
                        <a:gd name="connsiteY25" fmla="*/ 921886 h 1494426"/>
                        <a:gd name="connsiteX26" fmla="*/ 880208 w 1216495"/>
                        <a:gd name="connsiteY26" fmla="*/ 881246 h 1494426"/>
                        <a:gd name="connsiteX27" fmla="*/ 626208 w 1216495"/>
                        <a:gd name="connsiteY27" fmla="*/ 1165726 h 1494426"/>
                        <a:gd name="connsiteX28" fmla="*/ 199488 w 1216495"/>
                        <a:gd name="connsiteY28" fmla="*/ 1348606 h 1494426"/>
                        <a:gd name="connsiteX29" fmla="*/ 6448 w 1216495"/>
                        <a:gd name="connsiteY29" fmla="*/ 1379086 h 1494426"/>
                        <a:gd name="connsiteX30" fmla="*/ 77568 w 1216495"/>
                        <a:gd name="connsiteY30" fmla="*/ 1403152 h 1494426"/>
                        <a:gd name="connsiteX31" fmla="*/ 382368 w 1216495"/>
                        <a:gd name="connsiteY31" fmla="*/ 1332571 h 1494426"/>
                        <a:gd name="connsiteX32" fmla="*/ 636368 w 1216495"/>
                        <a:gd name="connsiteY32" fmla="*/ 1226686 h 1494426"/>
                        <a:gd name="connsiteX33" fmla="*/ 575408 w 1216495"/>
                        <a:gd name="connsiteY33" fmla="*/ 1480686 h 1494426"/>
                        <a:gd name="connsiteX34" fmla="*/ 646528 w 1216495"/>
                        <a:gd name="connsiteY34" fmla="*/ 1440046 h 1494426"/>
                        <a:gd name="connsiteX35" fmla="*/ 687168 w 1216495"/>
                        <a:gd name="connsiteY35" fmla="*/ 1267326 h 1494426"/>
                        <a:gd name="connsiteX36" fmla="*/ 717648 w 1216495"/>
                        <a:gd name="connsiteY36" fmla="*/ 1165726 h 1494426"/>
                        <a:gd name="connsiteX37" fmla="*/ 890368 w 1216495"/>
                        <a:gd name="connsiteY37" fmla="*/ 1053966 h 1494426"/>
                        <a:gd name="connsiteX38" fmla="*/ 1124048 w 1216495"/>
                        <a:gd name="connsiteY38" fmla="*/ 962526 h 1494426"/>
                        <a:gd name="connsiteX39" fmla="*/ 1185008 w 1216495"/>
                        <a:gd name="connsiteY39" fmla="*/ 972686 h 1494426"/>
                        <a:gd name="connsiteX40" fmla="*/ 1215488 w 1216495"/>
                        <a:gd name="connsiteY40" fmla="*/ 1003166 h 1494426"/>
                        <a:gd name="connsiteX41" fmla="*/ 1202380 w 1216495"/>
                        <a:gd name="connsiteY41" fmla="*/ 1062192 h 1494426"/>
                        <a:gd name="connsiteX0" fmla="*/ 1144368 w 1202635"/>
                        <a:gd name="connsiteY0" fmla="*/ 820286 h 1494426"/>
                        <a:gd name="connsiteX1" fmla="*/ 991968 w 1202635"/>
                        <a:gd name="connsiteY1" fmla="*/ 637406 h 1494426"/>
                        <a:gd name="connsiteX2" fmla="*/ 910688 w 1202635"/>
                        <a:gd name="connsiteY2" fmla="*/ 363086 h 1494426"/>
                        <a:gd name="connsiteX3" fmla="*/ 849728 w 1202635"/>
                        <a:gd name="connsiteY3" fmla="*/ 170046 h 1494426"/>
                        <a:gd name="connsiteX4" fmla="*/ 758288 w 1202635"/>
                        <a:gd name="connsiteY4" fmla="*/ 27806 h 1494426"/>
                        <a:gd name="connsiteX5" fmla="*/ 717648 w 1202635"/>
                        <a:gd name="connsiteY5" fmla="*/ 17646 h 1494426"/>
                        <a:gd name="connsiteX6" fmla="*/ 839568 w 1202635"/>
                        <a:gd name="connsiteY6" fmla="*/ 220846 h 1494426"/>
                        <a:gd name="connsiteX7" fmla="*/ 890368 w 1202635"/>
                        <a:gd name="connsiteY7" fmla="*/ 464686 h 1494426"/>
                        <a:gd name="connsiteX8" fmla="*/ 758288 w 1202635"/>
                        <a:gd name="connsiteY8" fmla="*/ 352926 h 1494426"/>
                        <a:gd name="connsiteX9" fmla="*/ 534768 w 1202635"/>
                        <a:gd name="connsiteY9" fmla="*/ 281806 h 1494426"/>
                        <a:gd name="connsiteX10" fmla="*/ 311248 w 1202635"/>
                        <a:gd name="connsiteY10" fmla="*/ 271646 h 1494426"/>
                        <a:gd name="connsiteX11" fmla="*/ 427718 w 1202635"/>
                        <a:gd name="connsiteY11" fmla="*/ 296791 h 1494426"/>
                        <a:gd name="connsiteX12" fmla="*/ 563766 w 1202635"/>
                        <a:gd name="connsiteY12" fmla="*/ 309618 h 1494426"/>
                        <a:gd name="connsiteX13" fmla="*/ 784800 w 1202635"/>
                        <a:gd name="connsiteY13" fmla="*/ 410140 h 1494426"/>
                        <a:gd name="connsiteX14" fmla="*/ 870048 w 1202635"/>
                        <a:gd name="connsiteY14" fmla="*/ 545966 h 1494426"/>
                        <a:gd name="connsiteX15" fmla="*/ 910688 w 1202635"/>
                        <a:gd name="connsiteY15" fmla="*/ 657726 h 1494426"/>
                        <a:gd name="connsiteX16" fmla="*/ 961488 w 1202635"/>
                        <a:gd name="connsiteY16" fmla="*/ 789806 h 1494426"/>
                        <a:gd name="connsiteX17" fmla="*/ 646528 w 1202635"/>
                        <a:gd name="connsiteY17" fmla="*/ 840606 h 1494426"/>
                        <a:gd name="connsiteX18" fmla="*/ 524608 w 1202635"/>
                        <a:gd name="connsiteY18" fmla="*/ 637406 h 1494426"/>
                        <a:gd name="connsiteX19" fmla="*/ 483968 w 1202635"/>
                        <a:gd name="connsiteY19" fmla="*/ 515486 h 1494426"/>
                        <a:gd name="connsiteX20" fmla="*/ 453488 w 1202635"/>
                        <a:gd name="connsiteY20" fmla="*/ 545966 h 1494426"/>
                        <a:gd name="connsiteX21" fmla="*/ 544928 w 1202635"/>
                        <a:gd name="connsiteY21" fmla="*/ 789806 h 1494426"/>
                        <a:gd name="connsiteX22" fmla="*/ 595728 w 1202635"/>
                        <a:gd name="connsiteY22" fmla="*/ 881246 h 1494426"/>
                        <a:gd name="connsiteX23" fmla="*/ 169008 w 1202635"/>
                        <a:gd name="connsiteY23" fmla="*/ 871086 h 1494426"/>
                        <a:gd name="connsiteX24" fmla="*/ 291669 w 1202635"/>
                        <a:gd name="connsiteY24" fmla="*/ 905852 h 1494426"/>
                        <a:gd name="connsiteX25" fmla="*/ 717648 w 1202635"/>
                        <a:gd name="connsiteY25" fmla="*/ 921886 h 1494426"/>
                        <a:gd name="connsiteX26" fmla="*/ 880208 w 1202635"/>
                        <a:gd name="connsiteY26" fmla="*/ 881246 h 1494426"/>
                        <a:gd name="connsiteX27" fmla="*/ 626208 w 1202635"/>
                        <a:gd name="connsiteY27" fmla="*/ 1165726 h 1494426"/>
                        <a:gd name="connsiteX28" fmla="*/ 199488 w 1202635"/>
                        <a:gd name="connsiteY28" fmla="*/ 1348606 h 1494426"/>
                        <a:gd name="connsiteX29" fmla="*/ 6448 w 1202635"/>
                        <a:gd name="connsiteY29" fmla="*/ 1379086 h 1494426"/>
                        <a:gd name="connsiteX30" fmla="*/ 77568 w 1202635"/>
                        <a:gd name="connsiteY30" fmla="*/ 1403152 h 1494426"/>
                        <a:gd name="connsiteX31" fmla="*/ 382368 w 1202635"/>
                        <a:gd name="connsiteY31" fmla="*/ 1332571 h 1494426"/>
                        <a:gd name="connsiteX32" fmla="*/ 636368 w 1202635"/>
                        <a:gd name="connsiteY32" fmla="*/ 1226686 h 1494426"/>
                        <a:gd name="connsiteX33" fmla="*/ 575408 w 1202635"/>
                        <a:gd name="connsiteY33" fmla="*/ 1480686 h 1494426"/>
                        <a:gd name="connsiteX34" fmla="*/ 646528 w 1202635"/>
                        <a:gd name="connsiteY34" fmla="*/ 1440046 h 1494426"/>
                        <a:gd name="connsiteX35" fmla="*/ 687168 w 1202635"/>
                        <a:gd name="connsiteY35" fmla="*/ 1267326 h 1494426"/>
                        <a:gd name="connsiteX36" fmla="*/ 717648 w 1202635"/>
                        <a:gd name="connsiteY36" fmla="*/ 1165726 h 1494426"/>
                        <a:gd name="connsiteX37" fmla="*/ 890368 w 1202635"/>
                        <a:gd name="connsiteY37" fmla="*/ 1053966 h 1494426"/>
                        <a:gd name="connsiteX38" fmla="*/ 1124048 w 1202635"/>
                        <a:gd name="connsiteY38" fmla="*/ 962526 h 1494426"/>
                        <a:gd name="connsiteX39" fmla="*/ 1185008 w 1202635"/>
                        <a:gd name="connsiteY39" fmla="*/ 972686 h 1494426"/>
                        <a:gd name="connsiteX40" fmla="*/ 1182717 w 1202635"/>
                        <a:gd name="connsiteY40" fmla="*/ 1019455 h 1494426"/>
                        <a:gd name="connsiteX41" fmla="*/ 1202380 w 1202635"/>
                        <a:gd name="connsiteY41" fmla="*/ 1062192 h 1494426"/>
                        <a:gd name="connsiteX0" fmla="*/ 1144368 w 1202635"/>
                        <a:gd name="connsiteY0" fmla="*/ 820286 h 1494426"/>
                        <a:gd name="connsiteX1" fmla="*/ 991968 w 1202635"/>
                        <a:gd name="connsiteY1" fmla="*/ 637406 h 1494426"/>
                        <a:gd name="connsiteX2" fmla="*/ 910688 w 1202635"/>
                        <a:gd name="connsiteY2" fmla="*/ 363086 h 1494426"/>
                        <a:gd name="connsiteX3" fmla="*/ 849728 w 1202635"/>
                        <a:gd name="connsiteY3" fmla="*/ 170046 h 1494426"/>
                        <a:gd name="connsiteX4" fmla="*/ 758288 w 1202635"/>
                        <a:gd name="connsiteY4" fmla="*/ 27806 h 1494426"/>
                        <a:gd name="connsiteX5" fmla="*/ 717648 w 1202635"/>
                        <a:gd name="connsiteY5" fmla="*/ 17646 h 1494426"/>
                        <a:gd name="connsiteX6" fmla="*/ 839568 w 1202635"/>
                        <a:gd name="connsiteY6" fmla="*/ 220846 h 1494426"/>
                        <a:gd name="connsiteX7" fmla="*/ 890368 w 1202635"/>
                        <a:gd name="connsiteY7" fmla="*/ 464686 h 1494426"/>
                        <a:gd name="connsiteX8" fmla="*/ 758288 w 1202635"/>
                        <a:gd name="connsiteY8" fmla="*/ 352926 h 1494426"/>
                        <a:gd name="connsiteX9" fmla="*/ 534768 w 1202635"/>
                        <a:gd name="connsiteY9" fmla="*/ 281806 h 1494426"/>
                        <a:gd name="connsiteX10" fmla="*/ 311248 w 1202635"/>
                        <a:gd name="connsiteY10" fmla="*/ 271646 h 1494426"/>
                        <a:gd name="connsiteX11" fmla="*/ 427718 w 1202635"/>
                        <a:gd name="connsiteY11" fmla="*/ 296791 h 1494426"/>
                        <a:gd name="connsiteX12" fmla="*/ 563766 w 1202635"/>
                        <a:gd name="connsiteY12" fmla="*/ 309618 h 1494426"/>
                        <a:gd name="connsiteX13" fmla="*/ 784800 w 1202635"/>
                        <a:gd name="connsiteY13" fmla="*/ 410140 h 1494426"/>
                        <a:gd name="connsiteX14" fmla="*/ 870048 w 1202635"/>
                        <a:gd name="connsiteY14" fmla="*/ 545966 h 1494426"/>
                        <a:gd name="connsiteX15" fmla="*/ 910688 w 1202635"/>
                        <a:gd name="connsiteY15" fmla="*/ 657726 h 1494426"/>
                        <a:gd name="connsiteX16" fmla="*/ 961488 w 1202635"/>
                        <a:gd name="connsiteY16" fmla="*/ 789806 h 1494426"/>
                        <a:gd name="connsiteX17" fmla="*/ 646528 w 1202635"/>
                        <a:gd name="connsiteY17" fmla="*/ 840606 h 1494426"/>
                        <a:gd name="connsiteX18" fmla="*/ 524608 w 1202635"/>
                        <a:gd name="connsiteY18" fmla="*/ 637406 h 1494426"/>
                        <a:gd name="connsiteX19" fmla="*/ 483968 w 1202635"/>
                        <a:gd name="connsiteY19" fmla="*/ 515486 h 1494426"/>
                        <a:gd name="connsiteX20" fmla="*/ 453488 w 1202635"/>
                        <a:gd name="connsiteY20" fmla="*/ 545966 h 1494426"/>
                        <a:gd name="connsiteX21" fmla="*/ 544928 w 1202635"/>
                        <a:gd name="connsiteY21" fmla="*/ 789806 h 1494426"/>
                        <a:gd name="connsiteX22" fmla="*/ 595728 w 1202635"/>
                        <a:gd name="connsiteY22" fmla="*/ 881246 h 1494426"/>
                        <a:gd name="connsiteX23" fmla="*/ 169008 w 1202635"/>
                        <a:gd name="connsiteY23" fmla="*/ 871086 h 1494426"/>
                        <a:gd name="connsiteX24" fmla="*/ 291669 w 1202635"/>
                        <a:gd name="connsiteY24" fmla="*/ 905852 h 1494426"/>
                        <a:gd name="connsiteX25" fmla="*/ 717648 w 1202635"/>
                        <a:gd name="connsiteY25" fmla="*/ 921886 h 1494426"/>
                        <a:gd name="connsiteX26" fmla="*/ 880208 w 1202635"/>
                        <a:gd name="connsiteY26" fmla="*/ 881246 h 1494426"/>
                        <a:gd name="connsiteX27" fmla="*/ 626208 w 1202635"/>
                        <a:gd name="connsiteY27" fmla="*/ 1165726 h 1494426"/>
                        <a:gd name="connsiteX28" fmla="*/ 199488 w 1202635"/>
                        <a:gd name="connsiteY28" fmla="*/ 1348606 h 1494426"/>
                        <a:gd name="connsiteX29" fmla="*/ 6448 w 1202635"/>
                        <a:gd name="connsiteY29" fmla="*/ 1379086 h 1494426"/>
                        <a:gd name="connsiteX30" fmla="*/ 77568 w 1202635"/>
                        <a:gd name="connsiteY30" fmla="*/ 1403152 h 1494426"/>
                        <a:gd name="connsiteX31" fmla="*/ 382368 w 1202635"/>
                        <a:gd name="connsiteY31" fmla="*/ 1332571 h 1494426"/>
                        <a:gd name="connsiteX32" fmla="*/ 636368 w 1202635"/>
                        <a:gd name="connsiteY32" fmla="*/ 1226686 h 1494426"/>
                        <a:gd name="connsiteX33" fmla="*/ 575408 w 1202635"/>
                        <a:gd name="connsiteY33" fmla="*/ 1480686 h 1494426"/>
                        <a:gd name="connsiteX34" fmla="*/ 646528 w 1202635"/>
                        <a:gd name="connsiteY34" fmla="*/ 1440046 h 1494426"/>
                        <a:gd name="connsiteX35" fmla="*/ 687168 w 1202635"/>
                        <a:gd name="connsiteY35" fmla="*/ 1267326 h 1494426"/>
                        <a:gd name="connsiteX36" fmla="*/ 717648 w 1202635"/>
                        <a:gd name="connsiteY36" fmla="*/ 1165726 h 1494426"/>
                        <a:gd name="connsiteX37" fmla="*/ 890368 w 1202635"/>
                        <a:gd name="connsiteY37" fmla="*/ 1053966 h 1494426"/>
                        <a:gd name="connsiteX38" fmla="*/ 1124048 w 1202635"/>
                        <a:gd name="connsiteY38" fmla="*/ 962526 h 1494426"/>
                        <a:gd name="connsiteX39" fmla="*/ 1156517 w 1202635"/>
                        <a:gd name="connsiteY39" fmla="*/ 989644 h 1494426"/>
                        <a:gd name="connsiteX40" fmla="*/ 1182717 w 1202635"/>
                        <a:gd name="connsiteY40" fmla="*/ 1019455 h 1494426"/>
                        <a:gd name="connsiteX41" fmla="*/ 1202380 w 1202635"/>
                        <a:gd name="connsiteY41" fmla="*/ 1062192 h 1494426"/>
                        <a:gd name="connsiteX0" fmla="*/ 1144368 w 1202635"/>
                        <a:gd name="connsiteY0" fmla="*/ 820286 h 1494426"/>
                        <a:gd name="connsiteX1" fmla="*/ 991968 w 1202635"/>
                        <a:gd name="connsiteY1" fmla="*/ 637406 h 1494426"/>
                        <a:gd name="connsiteX2" fmla="*/ 910688 w 1202635"/>
                        <a:gd name="connsiteY2" fmla="*/ 363086 h 1494426"/>
                        <a:gd name="connsiteX3" fmla="*/ 849728 w 1202635"/>
                        <a:gd name="connsiteY3" fmla="*/ 170046 h 1494426"/>
                        <a:gd name="connsiteX4" fmla="*/ 758288 w 1202635"/>
                        <a:gd name="connsiteY4" fmla="*/ 27806 h 1494426"/>
                        <a:gd name="connsiteX5" fmla="*/ 717648 w 1202635"/>
                        <a:gd name="connsiteY5" fmla="*/ 17646 h 1494426"/>
                        <a:gd name="connsiteX6" fmla="*/ 839568 w 1202635"/>
                        <a:gd name="connsiteY6" fmla="*/ 220846 h 1494426"/>
                        <a:gd name="connsiteX7" fmla="*/ 890368 w 1202635"/>
                        <a:gd name="connsiteY7" fmla="*/ 464686 h 1494426"/>
                        <a:gd name="connsiteX8" fmla="*/ 758288 w 1202635"/>
                        <a:gd name="connsiteY8" fmla="*/ 352926 h 1494426"/>
                        <a:gd name="connsiteX9" fmla="*/ 534768 w 1202635"/>
                        <a:gd name="connsiteY9" fmla="*/ 281806 h 1494426"/>
                        <a:gd name="connsiteX10" fmla="*/ 311248 w 1202635"/>
                        <a:gd name="connsiteY10" fmla="*/ 271646 h 1494426"/>
                        <a:gd name="connsiteX11" fmla="*/ 427718 w 1202635"/>
                        <a:gd name="connsiteY11" fmla="*/ 296791 h 1494426"/>
                        <a:gd name="connsiteX12" fmla="*/ 563766 w 1202635"/>
                        <a:gd name="connsiteY12" fmla="*/ 309618 h 1494426"/>
                        <a:gd name="connsiteX13" fmla="*/ 784800 w 1202635"/>
                        <a:gd name="connsiteY13" fmla="*/ 410140 h 1494426"/>
                        <a:gd name="connsiteX14" fmla="*/ 870048 w 1202635"/>
                        <a:gd name="connsiteY14" fmla="*/ 545966 h 1494426"/>
                        <a:gd name="connsiteX15" fmla="*/ 910688 w 1202635"/>
                        <a:gd name="connsiteY15" fmla="*/ 657726 h 1494426"/>
                        <a:gd name="connsiteX16" fmla="*/ 961488 w 1202635"/>
                        <a:gd name="connsiteY16" fmla="*/ 789806 h 1494426"/>
                        <a:gd name="connsiteX17" fmla="*/ 646528 w 1202635"/>
                        <a:gd name="connsiteY17" fmla="*/ 840606 h 1494426"/>
                        <a:gd name="connsiteX18" fmla="*/ 524608 w 1202635"/>
                        <a:gd name="connsiteY18" fmla="*/ 637406 h 1494426"/>
                        <a:gd name="connsiteX19" fmla="*/ 483968 w 1202635"/>
                        <a:gd name="connsiteY19" fmla="*/ 515486 h 1494426"/>
                        <a:gd name="connsiteX20" fmla="*/ 453488 w 1202635"/>
                        <a:gd name="connsiteY20" fmla="*/ 545966 h 1494426"/>
                        <a:gd name="connsiteX21" fmla="*/ 544928 w 1202635"/>
                        <a:gd name="connsiteY21" fmla="*/ 789806 h 1494426"/>
                        <a:gd name="connsiteX22" fmla="*/ 595728 w 1202635"/>
                        <a:gd name="connsiteY22" fmla="*/ 881246 h 1494426"/>
                        <a:gd name="connsiteX23" fmla="*/ 169008 w 1202635"/>
                        <a:gd name="connsiteY23" fmla="*/ 871086 h 1494426"/>
                        <a:gd name="connsiteX24" fmla="*/ 291669 w 1202635"/>
                        <a:gd name="connsiteY24" fmla="*/ 905852 h 1494426"/>
                        <a:gd name="connsiteX25" fmla="*/ 717648 w 1202635"/>
                        <a:gd name="connsiteY25" fmla="*/ 921886 h 1494426"/>
                        <a:gd name="connsiteX26" fmla="*/ 880208 w 1202635"/>
                        <a:gd name="connsiteY26" fmla="*/ 881246 h 1494426"/>
                        <a:gd name="connsiteX27" fmla="*/ 626208 w 1202635"/>
                        <a:gd name="connsiteY27" fmla="*/ 1165726 h 1494426"/>
                        <a:gd name="connsiteX28" fmla="*/ 199488 w 1202635"/>
                        <a:gd name="connsiteY28" fmla="*/ 1348606 h 1494426"/>
                        <a:gd name="connsiteX29" fmla="*/ 6448 w 1202635"/>
                        <a:gd name="connsiteY29" fmla="*/ 1379086 h 1494426"/>
                        <a:gd name="connsiteX30" fmla="*/ 77568 w 1202635"/>
                        <a:gd name="connsiteY30" fmla="*/ 1403152 h 1494426"/>
                        <a:gd name="connsiteX31" fmla="*/ 382368 w 1202635"/>
                        <a:gd name="connsiteY31" fmla="*/ 1332571 h 1494426"/>
                        <a:gd name="connsiteX32" fmla="*/ 636368 w 1202635"/>
                        <a:gd name="connsiteY32" fmla="*/ 1226686 h 1494426"/>
                        <a:gd name="connsiteX33" fmla="*/ 575408 w 1202635"/>
                        <a:gd name="connsiteY33" fmla="*/ 1480686 h 1494426"/>
                        <a:gd name="connsiteX34" fmla="*/ 646528 w 1202635"/>
                        <a:gd name="connsiteY34" fmla="*/ 1440046 h 1494426"/>
                        <a:gd name="connsiteX35" fmla="*/ 687168 w 1202635"/>
                        <a:gd name="connsiteY35" fmla="*/ 1267326 h 1494426"/>
                        <a:gd name="connsiteX36" fmla="*/ 717648 w 1202635"/>
                        <a:gd name="connsiteY36" fmla="*/ 1165726 h 1494426"/>
                        <a:gd name="connsiteX37" fmla="*/ 890368 w 1202635"/>
                        <a:gd name="connsiteY37" fmla="*/ 1053966 h 1494426"/>
                        <a:gd name="connsiteX38" fmla="*/ 1095557 w 1202635"/>
                        <a:gd name="connsiteY38" fmla="*/ 983724 h 1494426"/>
                        <a:gd name="connsiteX39" fmla="*/ 1156517 w 1202635"/>
                        <a:gd name="connsiteY39" fmla="*/ 989644 h 1494426"/>
                        <a:gd name="connsiteX40" fmla="*/ 1182717 w 1202635"/>
                        <a:gd name="connsiteY40" fmla="*/ 1019455 h 1494426"/>
                        <a:gd name="connsiteX41" fmla="*/ 1202380 w 1202635"/>
                        <a:gd name="connsiteY41" fmla="*/ 1062192 h 1494426"/>
                        <a:gd name="connsiteX0" fmla="*/ 1144368 w 1202635"/>
                        <a:gd name="connsiteY0" fmla="*/ 820286 h 1494426"/>
                        <a:gd name="connsiteX1" fmla="*/ 991968 w 1202635"/>
                        <a:gd name="connsiteY1" fmla="*/ 637406 h 1494426"/>
                        <a:gd name="connsiteX2" fmla="*/ 910688 w 1202635"/>
                        <a:gd name="connsiteY2" fmla="*/ 363086 h 1494426"/>
                        <a:gd name="connsiteX3" fmla="*/ 849728 w 1202635"/>
                        <a:gd name="connsiteY3" fmla="*/ 170046 h 1494426"/>
                        <a:gd name="connsiteX4" fmla="*/ 758288 w 1202635"/>
                        <a:gd name="connsiteY4" fmla="*/ 27806 h 1494426"/>
                        <a:gd name="connsiteX5" fmla="*/ 717648 w 1202635"/>
                        <a:gd name="connsiteY5" fmla="*/ 17646 h 1494426"/>
                        <a:gd name="connsiteX6" fmla="*/ 839568 w 1202635"/>
                        <a:gd name="connsiteY6" fmla="*/ 220846 h 1494426"/>
                        <a:gd name="connsiteX7" fmla="*/ 890368 w 1202635"/>
                        <a:gd name="connsiteY7" fmla="*/ 464686 h 1494426"/>
                        <a:gd name="connsiteX8" fmla="*/ 758288 w 1202635"/>
                        <a:gd name="connsiteY8" fmla="*/ 352926 h 1494426"/>
                        <a:gd name="connsiteX9" fmla="*/ 534768 w 1202635"/>
                        <a:gd name="connsiteY9" fmla="*/ 281806 h 1494426"/>
                        <a:gd name="connsiteX10" fmla="*/ 311248 w 1202635"/>
                        <a:gd name="connsiteY10" fmla="*/ 271646 h 1494426"/>
                        <a:gd name="connsiteX11" fmla="*/ 427718 w 1202635"/>
                        <a:gd name="connsiteY11" fmla="*/ 296791 h 1494426"/>
                        <a:gd name="connsiteX12" fmla="*/ 563766 w 1202635"/>
                        <a:gd name="connsiteY12" fmla="*/ 309618 h 1494426"/>
                        <a:gd name="connsiteX13" fmla="*/ 784800 w 1202635"/>
                        <a:gd name="connsiteY13" fmla="*/ 410140 h 1494426"/>
                        <a:gd name="connsiteX14" fmla="*/ 870048 w 1202635"/>
                        <a:gd name="connsiteY14" fmla="*/ 545966 h 1494426"/>
                        <a:gd name="connsiteX15" fmla="*/ 910688 w 1202635"/>
                        <a:gd name="connsiteY15" fmla="*/ 657726 h 1494426"/>
                        <a:gd name="connsiteX16" fmla="*/ 961488 w 1202635"/>
                        <a:gd name="connsiteY16" fmla="*/ 789806 h 1494426"/>
                        <a:gd name="connsiteX17" fmla="*/ 646528 w 1202635"/>
                        <a:gd name="connsiteY17" fmla="*/ 840606 h 1494426"/>
                        <a:gd name="connsiteX18" fmla="*/ 524608 w 1202635"/>
                        <a:gd name="connsiteY18" fmla="*/ 637406 h 1494426"/>
                        <a:gd name="connsiteX19" fmla="*/ 483968 w 1202635"/>
                        <a:gd name="connsiteY19" fmla="*/ 515486 h 1494426"/>
                        <a:gd name="connsiteX20" fmla="*/ 453488 w 1202635"/>
                        <a:gd name="connsiteY20" fmla="*/ 545966 h 1494426"/>
                        <a:gd name="connsiteX21" fmla="*/ 544928 w 1202635"/>
                        <a:gd name="connsiteY21" fmla="*/ 789806 h 1494426"/>
                        <a:gd name="connsiteX22" fmla="*/ 595728 w 1202635"/>
                        <a:gd name="connsiteY22" fmla="*/ 881246 h 1494426"/>
                        <a:gd name="connsiteX23" fmla="*/ 169008 w 1202635"/>
                        <a:gd name="connsiteY23" fmla="*/ 871086 h 1494426"/>
                        <a:gd name="connsiteX24" fmla="*/ 291669 w 1202635"/>
                        <a:gd name="connsiteY24" fmla="*/ 905852 h 1494426"/>
                        <a:gd name="connsiteX25" fmla="*/ 717648 w 1202635"/>
                        <a:gd name="connsiteY25" fmla="*/ 921886 h 1494426"/>
                        <a:gd name="connsiteX26" fmla="*/ 880208 w 1202635"/>
                        <a:gd name="connsiteY26" fmla="*/ 881246 h 1494426"/>
                        <a:gd name="connsiteX27" fmla="*/ 626208 w 1202635"/>
                        <a:gd name="connsiteY27" fmla="*/ 1165726 h 1494426"/>
                        <a:gd name="connsiteX28" fmla="*/ 199488 w 1202635"/>
                        <a:gd name="connsiteY28" fmla="*/ 1348606 h 1494426"/>
                        <a:gd name="connsiteX29" fmla="*/ 6448 w 1202635"/>
                        <a:gd name="connsiteY29" fmla="*/ 1379086 h 1494426"/>
                        <a:gd name="connsiteX30" fmla="*/ 77568 w 1202635"/>
                        <a:gd name="connsiteY30" fmla="*/ 1403152 h 1494426"/>
                        <a:gd name="connsiteX31" fmla="*/ 382368 w 1202635"/>
                        <a:gd name="connsiteY31" fmla="*/ 1332571 h 1494426"/>
                        <a:gd name="connsiteX32" fmla="*/ 636368 w 1202635"/>
                        <a:gd name="connsiteY32" fmla="*/ 1226686 h 1494426"/>
                        <a:gd name="connsiteX33" fmla="*/ 575408 w 1202635"/>
                        <a:gd name="connsiteY33" fmla="*/ 1480686 h 1494426"/>
                        <a:gd name="connsiteX34" fmla="*/ 646528 w 1202635"/>
                        <a:gd name="connsiteY34" fmla="*/ 1440046 h 1494426"/>
                        <a:gd name="connsiteX35" fmla="*/ 687168 w 1202635"/>
                        <a:gd name="connsiteY35" fmla="*/ 1267326 h 1494426"/>
                        <a:gd name="connsiteX36" fmla="*/ 717648 w 1202635"/>
                        <a:gd name="connsiteY36" fmla="*/ 1165726 h 1494426"/>
                        <a:gd name="connsiteX37" fmla="*/ 890368 w 1202635"/>
                        <a:gd name="connsiteY37" fmla="*/ 1053966 h 1494426"/>
                        <a:gd name="connsiteX38" fmla="*/ 1095557 w 1202635"/>
                        <a:gd name="connsiteY38" fmla="*/ 983724 h 1494426"/>
                        <a:gd name="connsiteX39" fmla="*/ 1131192 w 1202635"/>
                        <a:gd name="connsiteY39" fmla="*/ 1019321 h 1494426"/>
                        <a:gd name="connsiteX40" fmla="*/ 1182717 w 1202635"/>
                        <a:gd name="connsiteY40" fmla="*/ 1019455 h 1494426"/>
                        <a:gd name="connsiteX41" fmla="*/ 1202380 w 1202635"/>
                        <a:gd name="connsiteY41" fmla="*/ 1062192 h 1494426"/>
                        <a:gd name="connsiteX0" fmla="*/ 1144368 w 1202497"/>
                        <a:gd name="connsiteY0" fmla="*/ 820286 h 1494426"/>
                        <a:gd name="connsiteX1" fmla="*/ 991968 w 1202497"/>
                        <a:gd name="connsiteY1" fmla="*/ 637406 h 1494426"/>
                        <a:gd name="connsiteX2" fmla="*/ 910688 w 1202497"/>
                        <a:gd name="connsiteY2" fmla="*/ 363086 h 1494426"/>
                        <a:gd name="connsiteX3" fmla="*/ 849728 w 1202497"/>
                        <a:gd name="connsiteY3" fmla="*/ 170046 h 1494426"/>
                        <a:gd name="connsiteX4" fmla="*/ 758288 w 1202497"/>
                        <a:gd name="connsiteY4" fmla="*/ 27806 h 1494426"/>
                        <a:gd name="connsiteX5" fmla="*/ 717648 w 1202497"/>
                        <a:gd name="connsiteY5" fmla="*/ 17646 h 1494426"/>
                        <a:gd name="connsiteX6" fmla="*/ 839568 w 1202497"/>
                        <a:gd name="connsiteY6" fmla="*/ 220846 h 1494426"/>
                        <a:gd name="connsiteX7" fmla="*/ 890368 w 1202497"/>
                        <a:gd name="connsiteY7" fmla="*/ 464686 h 1494426"/>
                        <a:gd name="connsiteX8" fmla="*/ 758288 w 1202497"/>
                        <a:gd name="connsiteY8" fmla="*/ 352926 h 1494426"/>
                        <a:gd name="connsiteX9" fmla="*/ 534768 w 1202497"/>
                        <a:gd name="connsiteY9" fmla="*/ 281806 h 1494426"/>
                        <a:gd name="connsiteX10" fmla="*/ 311248 w 1202497"/>
                        <a:gd name="connsiteY10" fmla="*/ 271646 h 1494426"/>
                        <a:gd name="connsiteX11" fmla="*/ 427718 w 1202497"/>
                        <a:gd name="connsiteY11" fmla="*/ 296791 h 1494426"/>
                        <a:gd name="connsiteX12" fmla="*/ 563766 w 1202497"/>
                        <a:gd name="connsiteY12" fmla="*/ 309618 h 1494426"/>
                        <a:gd name="connsiteX13" fmla="*/ 784800 w 1202497"/>
                        <a:gd name="connsiteY13" fmla="*/ 410140 h 1494426"/>
                        <a:gd name="connsiteX14" fmla="*/ 870048 w 1202497"/>
                        <a:gd name="connsiteY14" fmla="*/ 545966 h 1494426"/>
                        <a:gd name="connsiteX15" fmla="*/ 910688 w 1202497"/>
                        <a:gd name="connsiteY15" fmla="*/ 657726 h 1494426"/>
                        <a:gd name="connsiteX16" fmla="*/ 961488 w 1202497"/>
                        <a:gd name="connsiteY16" fmla="*/ 789806 h 1494426"/>
                        <a:gd name="connsiteX17" fmla="*/ 646528 w 1202497"/>
                        <a:gd name="connsiteY17" fmla="*/ 840606 h 1494426"/>
                        <a:gd name="connsiteX18" fmla="*/ 524608 w 1202497"/>
                        <a:gd name="connsiteY18" fmla="*/ 637406 h 1494426"/>
                        <a:gd name="connsiteX19" fmla="*/ 483968 w 1202497"/>
                        <a:gd name="connsiteY19" fmla="*/ 515486 h 1494426"/>
                        <a:gd name="connsiteX20" fmla="*/ 453488 w 1202497"/>
                        <a:gd name="connsiteY20" fmla="*/ 545966 h 1494426"/>
                        <a:gd name="connsiteX21" fmla="*/ 544928 w 1202497"/>
                        <a:gd name="connsiteY21" fmla="*/ 789806 h 1494426"/>
                        <a:gd name="connsiteX22" fmla="*/ 595728 w 1202497"/>
                        <a:gd name="connsiteY22" fmla="*/ 881246 h 1494426"/>
                        <a:gd name="connsiteX23" fmla="*/ 169008 w 1202497"/>
                        <a:gd name="connsiteY23" fmla="*/ 871086 h 1494426"/>
                        <a:gd name="connsiteX24" fmla="*/ 291669 w 1202497"/>
                        <a:gd name="connsiteY24" fmla="*/ 905852 h 1494426"/>
                        <a:gd name="connsiteX25" fmla="*/ 717648 w 1202497"/>
                        <a:gd name="connsiteY25" fmla="*/ 921886 h 1494426"/>
                        <a:gd name="connsiteX26" fmla="*/ 880208 w 1202497"/>
                        <a:gd name="connsiteY26" fmla="*/ 881246 h 1494426"/>
                        <a:gd name="connsiteX27" fmla="*/ 626208 w 1202497"/>
                        <a:gd name="connsiteY27" fmla="*/ 1165726 h 1494426"/>
                        <a:gd name="connsiteX28" fmla="*/ 199488 w 1202497"/>
                        <a:gd name="connsiteY28" fmla="*/ 1348606 h 1494426"/>
                        <a:gd name="connsiteX29" fmla="*/ 6448 w 1202497"/>
                        <a:gd name="connsiteY29" fmla="*/ 1379086 h 1494426"/>
                        <a:gd name="connsiteX30" fmla="*/ 77568 w 1202497"/>
                        <a:gd name="connsiteY30" fmla="*/ 1403152 h 1494426"/>
                        <a:gd name="connsiteX31" fmla="*/ 382368 w 1202497"/>
                        <a:gd name="connsiteY31" fmla="*/ 1332571 h 1494426"/>
                        <a:gd name="connsiteX32" fmla="*/ 636368 w 1202497"/>
                        <a:gd name="connsiteY32" fmla="*/ 1226686 h 1494426"/>
                        <a:gd name="connsiteX33" fmla="*/ 575408 w 1202497"/>
                        <a:gd name="connsiteY33" fmla="*/ 1480686 h 1494426"/>
                        <a:gd name="connsiteX34" fmla="*/ 646528 w 1202497"/>
                        <a:gd name="connsiteY34" fmla="*/ 1440046 h 1494426"/>
                        <a:gd name="connsiteX35" fmla="*/ 687168 w 1202497"/>
                        <a:gd name="connsiteY35" fmla="*/ 1267326 h 1494426"/>
                        <a:gd name="connsiteX36" fmla="*/ 717648 w 1202497"/>
                        <a:gd name="connsiteY36" fmla="*/ 1165726 h 1494426"/>
                        <a:gd name="connsiteX37" fmla="*/ 890368 w 1202497"/>
                        <a:gd name="connsiteY37" fmla="*/ 1053966 h 1494426"/>
                        <a:gd name="connsiteX38" fmla="*/ 1095557 w 1202497"/>
                        <a:gd name="connsiteY38" fmla="*/ 983724 h 1494426"/>
                        <a:gd name="connsiteX39" fmla="*/ 1131192 w 1202497"/>
                        <a:gd name="connsiteY39" fmla="*/ 1019321 h 1494426"/>
                        <a:gd name="connsiteX40" fmla="*/ 1160557 w 1202497"/>
                        <a:gd name="connsiteY40" fmla="*/ 1074569 h 1494426"/>
                        <a:gd name="connsiteX41" fmla="*/ 1202380 w 1202497"/>
                        <a:gd name="connsiteY41" fmla="*/ 1062192 h 1494426"/>
                        <a:gd name="connsiteX0" fmla="*/ 1144368 w 1163766"/>
                        <a:gd name="connsiteY0" fmla="*/ 820286 h 1494426"/>
                        <a:gd name="connsiteX1" fmla="*/ 991968 w 1163766"/>
                        <a:gd name="connsiteY1" fmla="*/ 637406 h 1494426"/>
                        <a:gd name="connsiteX2" fmla="*/ 910688 w 1163766"/>
                        <a:gd name="connsiteY2" fmla="*/ 363086 h 1494426"/>
                        <a:gd name="connsiteX3" fmla="*/ 849728 w 1163766"/>
                        <a:gd name="connsiteY3" fmla="*/ 170046 h 1494426"/>
                        <a:gd name="connsiteX4" fmla="*/ 758288 w 1163766"/>
                        <a:gd name="connsiteY4" fmla="*/ 27806 h 1494426"/>
                        <a:gd name="connsiteX5" fmla="*/ 717648 w 1163766"/>
                        <a:gd name="connsiteY5" fmla="*/ 17646 h 1494426"/>
                        <a:gd name="connsiteX6" fmla="*/ 839568 w 1163766"/>
                        <a:gd name="connsiteY6" fmla="*/ 220846 h 1494426"/>
                        <a:gd name="connsiteX7" fmla="*/ 890368 w 1163766"/>
                        <a:gd name="connsiteY7" fmla="*/ 464686 h 1494426"/>
                        <a:gd name="connsiteX8" fmla="*/ 758288 w 1163766"/>
                        <a:gd name="connsiteY8" fmla="*/ 352926 h 1494426"/>
                        <a:gd name="connsiteX9" fmla="*/ 534768 w 1163766"/>
                        <a:gd name="connsiteY9" fmla="*/ 281806 h 1494426"/>
                        <a:gd name="connsiteX10" fmla="*/ 311248 w 1163766"/>
                        <a:gd name="connsiteY10" fmla="*/ 271646 h 1494426"/>
                        <a:gd name="connsiteX11" fmla="*/ 427718 w 1163766"/>
                        <a:gd name="connsiteY11" fmla="*/ 296791 h 1494426"/>
                        <a:gd name="connsiteX12" fmla="*/ 563766 w 1163766"/>
                        <a:gd name="connsiteY12" fmla="*/ 309618 h 1494426"/>
                        <a:gd name="connsiteX13" fmla="*/ 784800 w 1163766"/>
                        <a:gd name="connsiteY13" fmla="*/ 410140 h 1494426"/>
                        <a:gd name="connsiteX14" fmla="*/ 870048 w 1163766"/>
                        <a:gd name="connsiteY14" fmla="*/ 545966 h 1494426"/>
                        <a:gd name="connsiteX15" fmla="*/ 910688 w 1163766"/>
                        <a:gd name="connsiteY15" fmla="*/ 657726 h 1494426"/>
                        <a:gd name="connsiteX16" fmla="*/ 961488 w 1163766"/>
                        <a:gd name="connsiteY16" fmla="*/ 789806 h 1494426"/>
                        <a:gd name="connsiteX17" fmla="*/ 646528 w 1163766"/>
                        <a:gd name="connsiteY17" fmla="*/ 840606 h 1494426"/>
                        <a:gd name="connsiteX18" fmla="*/ 524608 w 1163766"/>
                        <a:gd name="connsiteY18" fmla="*/ 637406 h 1494426"/>
                        <a:gd name="connsiteX19" fmla="*/ 483968 w 1163766"/>
                        <a:gd name="connsiteY19" fmla="*/ 515486 h 1494426"/>
                        <a:gd name="connsiteX20" fmla="*/ 453488 w 1163766"/>
                        <a:gd name="connsiteY20" fmla="*/ 545966 h 1494426"/>
                        <a:gd name="connsiteX21" fmla="*/ 544928 w 1163766"/>
                        <a:gd name="connsiteY21" fmla="*/ 789806 h 1494426"/>
                        <a:gd name="connsiteX22" fmla="*/ 595728 w 1163766"/>
                        <a:gd name="connsiteY22" fmla="*/ 881246 h 1494426"/>
                        <a:gd name="connsiteX23" fmla="*/ 169008 w 1163766"/>
                        <a:gd name="connsiteY23" fmla="*/ 871086 h 1494426"/>
                        <a:gd name="connsiteX24" fmla="*/ 291669 w 1163766"/>
                        <a:gd name="connsiteY24" fmla="*/ 905852 h 1494426"/>
                        <a:gd name="connsiteX25" fmla="*/ 717648 w 1163766"/>
                        <a:gd name="connsiteY25" fmla="*/ 921886 h 1494426"/>
                        <a:gd name="connsiteX26" fmla="*/ 880208 w 1163766"/>
                        <a:gd name="connsiteY26" fmla="*/ 881246 h 1494426"/>
                        <a:gd name="connsiteX27" fmla="*/ 626208 w 1163766"/>
                        <a:gd name="connsiteY27" fmla="*/ 1165726 h 1494426"/>
                        <a:gd name="connsiteX28" fmla="*/ 199488 w 1163766"/>
                        <a:gd name="connsiteY28" fmla="*/ 1348606 h 1494426"/>
                        <a:gd name="connsiteX29" fmla="*/ 6448 w 1163766"/>
                        <a:gd name="connsiteY29" fmla="*/ 1379086 h 1494426"/>
                        <a:gd name="connsiteX30" fmla="*/ 77568 w 1163766"/>
                        <a:gd name="connsiteY30" fmla="*/ 1403152 h 1494426"/>
                        <a:gd name="connsiteX31" fmla="*/ 382368 w 1163766"/>
                        <a:gd name="connsiteY31" fmla="*/ 1332571 h 1494426"/>
                        <a:gd name="connsiteX32" fmla="*/ 636368 w 1163766"/>
                        <a:gd name="connsiteY32" fmla="*/ 1226686 h 1494426"/>
                        <a:gd name="connsiteX33" fmla="*/ 575408 w 1163766"/>
                        <a:gd name="connsiteY33" fmla="*/ 1480686 h 1494426"/>
                        <a:gd name="connsiteX34" fmla="*/ 646528 w 1163766"/>
                        <a:gd name="connsiteY34" fmla="*/ 1440046 h 1494426"/>
                        <a:gd name="connsiteX35" fmla="*/ 687168 w 1163766"/>
                        <a:gd name="connsiteY35" fmla="*/ 1267326 h 1494426"/>
                        <a:gd name="connsiteX36" fmla="*/ 717648 w 1163766"/>
                        <a:gd name="connsiteY36" fmla="*/ 1165726 h 1494426"/>
                        <a:gd name="connsiteX37" fmla="*/ 890368 w 1163766"/>
                        <a:gd name="connsiteY37" fmla="*/ 1053966 h 1494426"/>
                        <a:gd name="connsiteX38" fmla="*/ 1095557 w 1163766"/>
                        <a:gd name="connsiteY38" fmla="*/ 983724 h 1494426"/>
                        <a:gd name="connsiteX39" fmla="*/ 1131192 w 1163766"/>
                        <a:gd name="connsiteY39" fmla="*/ 1019321 h 1494426"/>
                        <a:gd name="connsiteX40" fmla="*/ 1160557 w 1163766"/>
                        <a:gd name="connsiteY40" fmla="*/ 1074569 h 1494426"/>
                        <a:gd name="connsiteX41" fmla="*/ 1161227 w 1163766"/>
                        <a:gd name="connsiteY41" fmla="*/ 1104587 h 1494426"/>
                        <a:gd name="connsiteX0" fmla="*/ 1144368 w 1161533"/>
                        <a:gd name="connsiteY0" fmla="*/ 820286 h 1494426"/>
                        <a:gd name="connsiteX1" fmla="*/ 991968 w 1161533"/>
                        <a:gd name="connsiteY1" fmla="*/ 637406 h 1494426"/>
                        <a:gd name="connsiteX2" fmla="*/ 910688 w 1161533"/>
                        <a:gd name="connsiteY2" fmla="*/ 363086 h 1494426"/>
                        <a:gd name="connsiteX3" fmla="*/ 849728 w 1161533"/>
                        <a:gd name="connsiteY3" fmla="*/ 170046 h 1494426"/>
                        <a:gd name="connsiteX4" fmla="*/ 758288 w 1161533"/>
                        <a:gd name="connsiteY4" fmla="*/ 27806 h 1494426"/>
                        <a:gd name="connsiteX5" fmla="*/ 717648 w 1161533"/>
                        <a:gd name="connsiteY5" fmla="*/ 17646 h 1494426"/>
                        <a:gd name="connsiteX6" fmla="*/ 839568 w 1161533"/>
                        <a:gd name="connsiteY6" fmla="*/ 220846 h 1494426"/>
                        <a:gd name="connsiteX7" fmla="*/ 890368 w 1161533"/>
                        <a:gd name="connsiteY7" fmla="*/ 464686 h 1494426"/>
                        <a:gd name="connsiteX8" fmla="*/ 758288 w 1161533"/>
                        <a:gd name="connsiteY8" fmla="*/ 352926 h 1494426"/>
                        <a:gd name="connsiteX9" fmla="*/ 534768 w 1161533"/>
                        <a:gd name="connsiteY9" fmla="*/ 281806 h 1494426"/>
                        <a:gd name="connsiteX10" fmla="*/ 311248 w 1161533"/>
                        <a:gd name="connsiteY10" fmla="*/ 271646 h 1494426"/>
                        <a:gd name="connsiteX11" fmla="*/ 427718 w 1161533"/>
                        <a:gd name="connsiteY11" fmla="*/ 296791 h 1494426"/>
                        <a:gd name="connsiteX12" fmla="*/ 563766 w 1161533"/>
                        <a:gd name="connsiteY12" fmla="*/ 309618 h 1494426"/>
                        <a:gd name="connsiteX13" fmla="*/ 784800 w 1161533"/>
                        <a:gd name="connsiteY13" fmla="*/ 410140 h 1494426"/>
                        <a:gd name="connsiteX14" fmla="*/ 870048 w 1161533"/>
                        <a:gd name="connsiteY14" fmla="*/ 545966 h 1494426"/>
                        <a:gd name="connsiteX15" fmla="*/ 910688 w 1161533"/>
                        <a:gd name="connsiteY15" fmla="*/ 657726 h 1494426"/>
                        <a:gd name="connsiteX16" fmla="*/ 961488 w 1161533"/>
                        <a:gd name="connsiteY16" fmla="*/ 789806 h 1494426"/>
                        <a:gd name="connsiteX17" fmla="*/ 646528 w 1161533"/>
                        <a:gd name="connsiteY17" fmla="*/ 840606 h 1494426"/>
                        <a:gd name="connsiteX18" fmla="*/ 524608 w 1161533"/>
                        <a:gd name="connsiteY18" fmla="*/ 637406 h 1494426"/>
                        <a:gd name="connsiteX19" fmla="*/ 483968 w 1161533"/>
                        <a:gd name="connsiteY19" fmla="*/ 515486 h 1494426"/>
                        <a:gd name="connsiteX20" fmla="*/ 453488 w 1161533"/>
                        <a:gd name="connsiteY20" fmla="*/ 545966 h 1494426"/>
                        <a:gd name="connsiteX21" fmla="*/ 544928 w 1161533"/>
                        <a:gd name="connsiteY21" fmla="*/ 789806 h 1494426"/>
                        <a:gd name="connsiteX22" fmla="*/ 595728 w 1161533"/>
                        <a:gd name="connsiteY22" fmla="*/ 881246 h 1494426"/>
                        <a:gd name="connsiteX23" fmla="*/ 169008 w 1161533"/>
                        <a:gd name="connsiteY23" fmla="*/ 871086 h 1494426"/>
                        <a:gd name="connsiteX24" fmla="*/ 291669 w 1161533"/>
                        <a:gd name="connsiteY24" fmla="*/ 905852 h 1494426"/>
                        <a:gd name="connsiteX25" fmla="*/ 717648 w 1161533"/>
                        <a:gd name="connsiteY25" fmla="*/ 921886 h 1494426"/>
                        <a:gd name="connsiteX26" fmla="*/ 880208 w 1161533"/>
                        <a:gd name="connsiteY26" fmla="*/ 881246 h 1494426"/>
                        <a:gd name="connsiteX27" fmla="*/ 626208 w 1161533"/>
                        <a:gd name="connsiteY27" fmla="*/ 1165726 h 1494426"/>
                        <a:gd name="connsiteX28" fmla="*/ 199488 w 1161533"/>
                        <a:gd name="connsiteY28" fmla="*/ 1348606 h 1494426"/>
                        <a:gd name="connsiteX29" fmla="*/ 6448 w 1161533"/>
                        <a:gd name="connsiteY29" fmla="*/ 1379086 h 1494426"/>
                        <a:gd name="connsiteX30" fmla="*/ 77568 w 1161533"/>
                        <a:gd name="connsiteY30" fmla="*/ 1403152 h 1494426"/>
                        <a:gd name="connsiteX31" fmla="*/ 382368 w 1161533"/>
                        <a:gd name="connsiteY31" fmla="*/ 1332571 h 1494426"/>
                        <a:gd name="connsiteX32" fmla="*/ 636368 w 1161533"/>
                        <a:gd name="connsiteY32" fmla="*/ 1226686 h 1494426"/>
                        <a:gd name="connsiteX33" fmla="*/ 575408 w 1161533"/>
                        <a:gd name="connsiteY33" fmla="*/ 1480686 h 1494426"/>
                        <a:gd name="connsiteX34" fmla="*/ 646528 w 1161533"/>
                        <a:gd name="connsiteY34" fmla="*/ 1440046 h 1494426"/>
                        <a:gd name="connsiteX35" fmla="*/ 687168 w 1161533"/>
                        <a:gd name="connsiteY35" fmla="*/ 1267326 h 1494426"/>
                        <a:gd name="connsiteX36" fmla="*/ 717648 w 1161533"/>
                        <a:gd name="connsiteY36" fmla="*/ 1165726 h 1494426"/>
                        <a:gd name="connsiteX37" fmla="*/ 890368 w 1161533"/>
                        <a:gd name="connsiteY37" fmla="*/ 1053966 h 1494426"/>
                        <a:gd name="connsiteX38" fmla="*/ 1095557 w 1161533"/>
                        <a:gd name="connsiteY38" fmla="*/ 983724 h 1494426"/>
                        <a:gd name="connsiteX39" fmla="*/ 1131192 w 1161533"/>
                        <a:gd name="connsiteY39" fmla="*/ 1019321 h 1494426"/>
                        <a:gd name="connsiteX40" fmla="*/ 1144729 w 1161533"/>
                        <a:gd name="connsiteY40" fmla="*/ 1074569 h 1494426"/>
                        <a:gd name="connsiteX41" fmla="*/ 1161227 w 1161533"/>
                        <a:gd name="connsiteY41" fmla="*/ 1104587 h 1494426"/>
                        <a:gd name="connsiteX0" fmla="*/ 1144368 w 1145211"/>
                        <a:gd name="connsiteY0" fmla="*/ 820286 h 1494426"/>
                        <a:gd name="connsiteX1" fmla="*/ 991968 w 1145211"/>
                        <a:gd name="connsiteY1" fmla="*/ 637406 h 1494426"/>
                        <a:gd name="connsiteX2" fmla="*/ 910688 w 1145211"/>
                        <a:gd name="connsiteY2" fmla="*/ 363086 h 1494426"/>
                        <a:gd name="connsiteX3" fmla="*/ 849728 w 1145211"/>
                        <a:gd name="connsiteY3" fmla="*/ 170046 h 1494426"/>
                        <a:gd name="connsiteX4" fmla="*/ 758288 w 1145211"/>
                        <a:gd name="connsiteY4" fmla="*/ 27806 h 1494426"/>
                        <a:gd name="connsiteX5" fmla="*/ 717648 w 1145211"/>
                        <a:gd name="connsiteY5" fmla="*/ 17646 h 1494426"/>
                        <a:gd name="connsiteX6" fmla="*/ 839568 w 1145211"/>
                        <a:gd name="connsiteY6" fmla="*/ 220846 h 1494426"/>
                        <a:gd name="connsiteX7" fmla="*/ 890368 w 1145211"/>
                        <a:gd name="connsiteY7" fmla="*/ 464686 h 1494426"/>
                        <a:gd name="connsiteX8" fmla="*/ 758288 w 1145211"/>
                        <a:gd name="connsiteY8" fmla="*/ 352926 h 1494426"/>
                        <a:gd name="connsiteX9" fmla="*/ 534768 w 1145211"/>
                        <a:gd name="connsiteY9" fmla="*/ 281806 h 1494426"/>
                        <a:gd name="connsiteX10" fmla="*/ 311248 w 1145211"/>
                        <a:gd name="connsiteY10" fmla="*/ 271646 h 1494426"/>
                        <a:gd name="connsiteX11" fmla="*/ 427718 w 1145211"/>
                        <a:gd name="connsiteY11" fmla="*/ 296791 h 1494426"/>
                        <a:gd name="connsiteX12" fmla="*/ 563766 w 1145211"/>
                        <a:gd name="connsiteY12" fmla="*/ 309618 h 1494426"/>
                        <a:gd name="connsiteX13" fmla="*/ 784800 w 1145211"/>
                        <a:gd name="connsiteY13" fmla="*/ 410140 h 1494426"/>
                        <a:gd name="connsiteX14" fmla="*/ 870048 w 1145211"/>
                        <a:gd name="connsiteY14" fmla="*/ 545966 h 1494426"/>
                        <a:gd name="connsiteX15" fmla="*/ 910688 w 1145211"/>
                        <a:gd name="connsiteY15" fmla="*/ 657726 h 1494426"/>
                        <a:gd name="connsiteX16" fmla="*/ 961488 w 1145211"/>
                        <a:gd name="connsiteY16" fmla="*/ 789806 h 1494426"/>
                        <a:gd name="connsiteX17" fmla="*/ 646528 w 1145211"/>
                        <a:gd name="connsiteY17" fmla="*/ 840606 h 1494426"/>
                        <a:gd name="connsiteX18" fmla="*/ 524608 w 1145211"/>
                        <a:gd name="connsiteY18" fmla="*/ 637406 h 1494426"/>
                        <a:gd name="connsiteX19" fmla="*/ 483968 w 1145211"/>
                        <a:gd name="connsiteY19" fmla="*/ 515486 h 1494426"/>
                        <a:gd name="connsiteX20" fmla="*/ 453488 w 1145211"/>
                        <a:gd name="connsiteY20" fmla="*/ 545966 h 1494426"/>
                        <a:gd name="connsiteX21" fmla="*/ 544928 w 1145211"/>
                        <a:gd name="connsiteY21" fmla="*/ 789806 h 1494426"/>
                        <a:gd name="connsiteX22" fmla="*/ 595728 w 1145211"/>
                        <a:gd name="connsiteY22" fmla="*/ 881246 h 1494426"/>
                        <a:gd name="connsiteX23" fmla="*/ 169008 w 1145211"/>
                        <a:gd name="connsiteY23" fmla="*/ 871086 h 1494426"/>
                        <a:gd name="connsiteX24" fmla="*/ 291669 w 1145211"/>
                        <a:gd name="connsiteY24" fmla="*/ 905852 h 1494426"/>
                        <a:gd name="connsiteX25" fmla="*/ 717648 w 1145211"/>
                        <a:gd name="connsiteY25" fmla="*/ 921886 h 1494426"/>
                        <a:gd name="connsiteX26" fmla="*/ 880208 w 1145211"/>
                        <a:gd name="connsiteY26" fmla="*/ 881246 h 1494426"/>
                        <a:gd name="connsiteX27" fmla="*/ 626208 w 1145211"/>
                        <a:gd name="connsiteY27" fmla="*/ 1165726 h 1494426"/>
                        <a:gd name="connsiteX28" fmla="*/ 199488 w 1145211"/>
                        <a:gd name="connsiteY28" fmla="*/ 1348606 h 1494426"/>
                        <a:gd name="connsiteX29" fmla="*/ 6448 w 1145211"/>
                        <a:gd name="connsiteY29" fmla="*/ 1379086 h 1494426"/>
                        <a:gd name="connsiteX30" fmla="*/ 77568 w 1145211"/>
                        <a:gd name="connsiteY30" fmla="*/ 1403152 h 1494426"/>
                        <a:gd name="connsiteX31" fmla="*/ 382368 w 1145211"/>
                        <a:gd name="connsiteY31" fmla="*/ 1332571 h 1494426"/>
                        <a:gd name="connsiteX32" fmla="*/ 636368 w 1145211"/>
                        <a:gd name="connsiteY32" fmla="*/ 1226686 h 1494426"/>
                        <a:gd name="connsiteX33" fmla="*/ 575408 w 1145211"/>
                        <a:gd name="connsiteY33" fmla="*/ 1480686 h 1494426"/>
                        <a:gd name="connsiteX34" fmla="*/ 646528 w 1145211"/>
                        <a:gd name="connsiteY34" fmla="*/ 1440046 h 1494426"/>
                        <a:gd name="connsiteX35" fmla="*/ 687168 w 1145211"/>
                        <a:gd name="connsiteY35" fmla="*/ 1267326 h 1494426"/>
                        <a:gd name="connsiteX36" fmla="*/ 717648 w 1145211"/>
                        <a:gd name="connsiteY36" fmla="*/ 1165726 h 1494426"/>
                        <a:gd name="connsiteX37" fmla="*/ 890368 w 1145211"/>
                        <a:gd name="connsiteY37" fmla="*/ 1053966 h 1494426"/>
                        <a:gd name="connsiteX38" fmla="*/ 1095557 w 1145211"/>
                        <a:gd name="connsiteY38" fmla="*/ 983724 h 1494426"/>
                        <a:gd name="connsiteX39" fmla="*/ 1131192 w 1145211"/>
                        <a:gd name="connsiteY39" fmla="*/ 1019321 h 1494426"/>
                        <a:gd name="connsiteX40" fmla="*/ 1144729 w 1145211"/>
                        <a:gd name="connsiteY40" fmla="*/ 1074569 h 1494426"/>
                        <a:gd name="connsiteX41" fmla="*/ 1110577 w 1145211"/>
                        <a:gd name="connsiteY41" fmla="*/ 1100347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35232 w 1144368"/>
                        <a:gd name="connsiteY40" fmla="*/ 1074569 h 1494426"/>
                        <a:gd name="connsiteX41" fmla="*/ 1110577 w 1144368"/>
                        <a:gd name="connsiteY41" fmla="*/ 1100347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35232 w 1144368"/>
                        <a:gd name="connsiteY40" fmla="*/ 1074569 h 1494426"/>
                        <a:gd name="connsiteX41" fmla="*/ 1110577 w 1144368"/>
                        <a:gd name="connsiteY41" fmla="*/ 1100347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35232 w 1144368"/>
                        <a:gd name="connsiteY40" fmla="*/ 1074569 h 1494426"/>
                        <a:gd name="connsiteX41" fmla="*/ 1110577 w 1144368"/>
                        <a:gd name="connsiteY41" fmla="*/ 1100347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16238 w 1144368"/>
                        <a:gd name="connsiteY40" fmla="*/ 1066090 h 1494426"/>
                        <a:gd name="connsiteX41" fmla="*/ 1110577 w 1144368"/>
                        <a:gd name="connsiteY41" fmla="*/ 1100347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16238 w 1144368"/>
                        <a:gd name="connsiteY40" fmla="*/ 1066090 h 1494426"/>
                        <a:gd name="connsiteX41" fmla="*/ 1091583 w 1144368"/>
                        <a:gd name="connsiteY41" fmla="*/ 1079149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16238 w 1144368"/>
                        <a:gd name="connsiteY40" fmla="*/ 1066090 h 1494426"/>
                        <a:gd name="connsiteX41" fmla="*/ 1069423 w 1144368"/>
                        <a:gd name="connsiteY41" fmla="*/ 1104586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16238 w 1144368"/>
                        <a:gd name="connsiteY40" fmla="*/ 1061850 h 1494426"/>
                        <a:gd name="connsiteX41" fmla="*/ 1069423 w 1144368"/>
                        <a:gd name="connsiteY41" fmla="*/ 1104586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95557 w 1144368"/>
                        <a:gd name="connsiteY38" fmla="*/ 983724 h 1494426"/>
                        <a:gd name="connsiteX39" fmla="*/ 1131192 w 1144368"/>
                        <a:gd name="connsiteY39" fmla="*/ 1019321 h 1494426"/>
                        <a:gd name="connsiteX40" fmla="*/ 1116238 w 1144368"/>
                        <a:gd name="connsiteY40" fmla="*/ 1061850 h 1494426"/>
                        <a:gd name="connsiteX41" fmla="*/ 1088417 w 1144368"/>
                        <a:gd name="connsiteY41" fmla="*/ 1104586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16408 w 1144368"/>
                        <a:gd name="connsiteY38" fmla="*/ 956797 h 1494426"/>
                        <a:gd name="connsiteX39" fmla="*/ 1131192 w 1144368"/>
                        <a:gd name="connsiteY39" fmla="*/ 1019321 h 1494426"/>
                        <a:gd name="connsiteX40" fmla="*/ 1116238 w 1144368"/>
                        <a:gd name="connsiteY40" fmla="*/ 1061850 h 1494426"/>
                        <a:gd name="connsiteX41" fmla="*/ 1088417 w 1144368"/>
                        <a:gd name="connsiteY41" fmla="*/ 1104586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16408 w 1144368"/>
                        <a:gd name="connsiteY38" fmla="*/ 956797 h 1494426"/>
                        <a:gd name="connsiteX39" fmla="*/ 1022362 w 1144368"/>
                        <a:gd name="connsiteY39" fmla="*/ 1050735 h 1494426"/>
                        <a:gd name="connsiteX40" fmla="*/ 1116238 w 1144368"/>
                        <a:gd name="connsiteY40" fmla="*/ 1061850 h 1494426"/>
                        <a:gd name="connsiteX41" fmla="*/ 1088417 w 1144368"/>
                        <a:gd name="connsiteY41" fmla="*/ 1104586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16408 w 1144368"/>
                        <a:gd name="connsiteY38" fmla="*/ 956797 h 1494426"/>
                        <a:gd name="connsiteX39" fmla="*/ 1022362 w 1144368"/>
                        <a:gd name="connsiteY39" fmla="*/ 1050735 h 1494426"/>
                        <a:gd name="connsiteX40" fmla="*/ 1014003 w 1144368"/>
                        <a:gd name="connsiteY40" fmla="*/ 1088777 h 1494426"/>
                        <a:gd name="connsiteX41" fmla="*/ 1088417 w 1144368"/>
                        <a:gd name="connsiteY41" fmla="*/ 1104586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16408 w 1144368"/>
                        <a:gd name="connsiteY38" fmla="*/ 956797 h 1494426"/>
                        <a:gd name="connsiteX39" fmla="*/ 1022362 w 1144368"/>
                        <a:gd name="connsiteY39" fmla="*/ 1050735 h 1494426"/>
                        <a:gd name="connsiteX40" fmla="*/ 1014003 w 1144368"/>
                        <a:gd name="connsiteY40" fmla="*/ 1088777 h 1494426"/>
                        <a:gd name="connsiteX41" fmla="*/ 1015864 w 1144368"/>
                        <a:gd name="connsiteY41" fmla="*/ 1127025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16408 w 1144368"/>
                        <a:gd name="connsiteY38" fmla="*/ 956797 h 1494426"/>
                        <a:gd name="connsiteX39" fmla="*/ 1022362 w 1144368"/>
                        <a:gd name="connsiteY39" fmla="*/ 1050735 h 1494426"/>
                        <a:gd name="connsiteX40" fmla="*/ 1014003 w 1144368"/>
                        <a:gd name="connsiteY40" fmla="*/ 1088777 h 1494426"/>
                        <a:gd name="connsiteX41" fmla="*/ 1005970 w 1144368"/>
                        <a:gd name="connsiteY41" fmla="*/ 1109074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16408 w 1144368"/>
                        <a:gd name="connsiteY38" fmla="*/ 956797 h 1494426"/>
                        <a:gd name="connsiteX39" fmla="*/ 1022362 w 1144368"/>
                        <a:gd name="connsiteY39" fmla="*/ 1041760 h 1494426"/>
                        <a:gd name="connsiteX40" fmla="*/ 1014003 w 1144368"/>
                        <a:gd name="connsiteY40" fmla="*/ 1088777 h 1494426"/>
                        <a:gd name="connsiteX41" fmla="*/ 1005970 w 1144368"/>
                        <a:gd name="connsiteY41" fmla="*/ 1109074 h 1494426"/>
                        <a:gd name="connsiteX0" fmla="*/ 1144368 w 1144368"/>
                        <a:gd name="connsiteY0" fmla="*/ 820286 h 1494426"/>
                        <a:gd name="connsiteX1" fmla="*/ 991968 w 1144368"/>
                        <a:gd name="connsiteY1" fmla="*/ 637406 h 1494426"/>
                        <a:gd name="connsiteX2" fmla="*/ 910688 w 1144368"/>
                        <a:gd name="connsiteY2" fmla="*/ 363086 h 1494426"/>
                        <a:gd name="connsiteX3" fmla="*/ 849728 w 1144368"/>
                        <a:gd name="connsiteY3" fmla="*/ 170046 h 1494426"/>
                        <a:gd name="connsiteX4" fmla="*/ 758288 w 1144368"/>
                        <a:gd name="connsiteY4" fmla="*/ 27806 h 1494426"/>
                        <a:gd name="connsiteX5" fmla="*/ 717648 w 1144368"/>
                        <a:gd name="connsiteY5" fmla="*/ 17646 h 1494426"/>
                        <a:gd name="connsiteX6" fmla="*/ 839568 w 1144368"/>
                        <a:gd name="connsiteY6" fmla="*/ 220846 h 1494426"/>
                        <a:gd name="connsiteX7" fmla="*/ 890368 w 1144368"/>
                        <a:gd name="connsiteY7" fmla="*/ 464686 h 1494426"/>
                        <a:gd name="connsiteX8" fmla="*/ 758288 w 1144368"/>
                        <a:gd name="connsiteY8" fmla="*/ 352926 h 1494426"/>
                        <a:gd name="connsiteX9" fmla="*/ 534768 w 1144368"/>
                        <a:gd name="connsiteY9" fmla="*/ 281806 h 1494426"/>
                        <a:gd name="connsiteX10" fmla="*/ 311248 w 1144368"/>
                        <a:gd name="connsiteY10" fmla="*/ 271646 h 1494426"/>
                        <a:gd name="connsiteX11" fmla="*/ 427718 w 1144368"/>
                        <a:gd name="connsiteY11" fmla="*/ 296791 h 1494426"/>
                        <a:gd name="connsiteX12" fmla="*/ 563766 w 1144368"/>
                        <a:gd name="connsiteY12" fmla="*/ 309618 h 1494426"/>
                        <a:gd name="connsiteX13" fmla="*/ 784800 w 1144368"/>
                        <a:gd name="connsiteY13" fmla="*/ 410140 h 1494426"/>
                        <a:gd name="connsiteX14" fmla="*/ 870048 w 1144368"/>
                        <a:gd name="connsiteY14" fmla="*/ 545966 h 1494426"/>
                        <a:gd name="connsiteX15" fmla="*/ 910688 w 1144368"/>
                        <a:gd name="connsiteY15" fmla="*/ 657726 h 1494426"/>
                        <a:gd name="connsiteX16" fmla="*/ 961488 w 1144368"/>
                        <a:gd name="connsiteY16" fmla="*/ 789806 h 1494426"/>
                        <a:gd name="connsiteX17" fmla="*/ 646528 w 1144368"/>
                        <a:gd name="connsiteY17" fmla="*/ 840606 h 1494426"/>
                        <a:gd name="connsiteX18" fmla="*/ 524608 w 1144368"/>
                        <a:gd name="connsiteY18" fmla="*/ 637406 h 1494426"/>
                        <a:gd name="connsiteX19" fmla="*/ 483968 w 1144368"/>
                        <a:gd name="connsiteY19" fmla="*/ 515486 h 1494426"/>
                        <a:gd name="connsiteX20" fmla="*/ 453488 w 1144368"/>
                        <a:gd name="connsiteY20" fmla="*/ 545966 h 1494426"/>
                        <a:gd name="connsiteX21" fmla="*/ 544928 w 1144368"/>
                        <a:gd name="connsiteY21" fmla="*/ 789806 h 1494426"/>
                        <a:gd name="connsiteX22" fmla="*/ 595728 w 1144368"/>
                        <a:gd name="connsiteY22" fmla="*/ 881246 h 1494426"/>
                        <a:gd name="connsiteX23" fmla="*/ 169008 w 1144368"/>
                        <a:gd name="connsiteY23" fmla="*/ 871086 h 1494426"/>
                        <a:gd name="connsiteX24" fmla="*/ 291669 w 1144368"/>
                        <a:gd name="connsiteY24" fmla="*/ 905852 h 1494426"/>
                        <a:gd name="connsiteX25" fmla="*/ 717648 w 1144368"/>
                        <a:gd name="connsiteY25" fmla="*/ 921886 h 1494426"/>
                        <a:gd name="connsiteX26" fmla="*/ 880208 w 1144368"/>
                        <a:gd name="connsiteY26" fmla="*/ 881246 h 1494426"/>
                        <a:gd name="connsiteX27" fmla="*/ 626208 w 1144368"/>
                        <a:gd name="connsiteY27" fmla="*/ 1165726 h 1494426"/>
                        <a:gd name="connsiteX28" fmla="*/ 199488 w 1144368"/>
                        <a:gd name="connsiteY28" fmla="*/ 1348606 h 1494426"/>
                        <a:gd name="connsiteX29" fmla="*/ 6448 w 1144368"/>
                        <a:gd name="connsiteY29" fmla="*/ 1379086 h 1494426"/>
                        <a:gd name="connsiteX30" fmla="*/ 77568 w 1144368"/>
                        <a:gd name="connsiteY30" fmla="*/ 1403152 h 1494426"/>
                        <a:gd name="connsiteX31" fmla="*/ 382368 w 1144368"/>
                        <a:gd name="connsiteY31" fmla="*/ 1332571 h 1494426"/>
                        <a:gd name="connsiteX32" fmla="*/ 636368 w 1144368"/>
                        <a:gd name="connsiteY32" fmla="*/ 1226686 h 1494426"/>
                        <a:gd name="connsiteX33" fmla="*/ 575408 w 1144368"/>
                        <a:gd name="connsiteY33" fmla="*/ 1480686 h 1494426"/>
                        <a:gd name="connsiteX34" fmla="*/ 646528 w 1144368"/>
                        <a:gd name="connsiteY34" fmla="*/ 1440046 h 1494426"/>
                        <a:gd name="connsiteX35" fmla="*/ 687168 w 1144368"/>
                        <a:gd name="connsiteY35" fmla="*/ 1267326 h 1494426"/>
                        <a:gd name="connsiteX36" fmla="*/ 717648 w 1144368"/>
                        <a:gd name="connsiteY36" fmla="*/ 1165726 h 1494426"/>
                        <a:gd name="connsiteX37" fmla="*/ 890368 w 1144368"/>
                        <a:gd name="connsiteY37" fmla="*/ 1053966 h 1494426"/>
                        <a:gd name="connsiteX38" fmla="*/ 1016408 w 1144368"/>
                        <a:gd name="connsiteY38" fmla="*/ 956797 h 1494426"/>
                        <a:gd name="connsiteX39" fmla="*/ 1022362 w 1144368"/>
                        <a:gd name="connsiteY39" fmla="*/ 1041760 h 1494426"/>
                        <a:gd name="connsiteX40" fmla="*/ 1014003 w 1144368"/>
                        <a:gd name="connsiteY40" fmla="*/ 1088777 h 1494426"/>
                        <a:gd name="connsiteX41" fmla="*/ 1002672 w 1144368"/>
                        <a:gd name="connsiteY41" fmla="*/ 1082147 h 1494426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  <a:cxn ang="0">
                          <a:pos x="connsiteX18" y="connsiteY18"/>
                        </a:cxn>
                        <a:cxn ang="0">
                          <a:pos x="connsiteX19" y="connsiteY19"/>
                        </a:cxn>
                        <a:cxn ang="0">
                          <a:pos x="connsiteX20" y="connsiteY20"/>
                        </a:cxn>
                        <a:cxn ang="0">
                          <a:pos x="connsiteX21" y="connsiteY21"/>
                        </a:cxn>
                        <a:cxn ang="0">
                          <a:pos x="connsiteX22" y="connsiteY22"/>
                        </a:cxn>
                        <a:cxn ang="0">
                          <a:pos x="connsiteX23" y="connsiteY23"/>
                        </a:cxn>
                        <a:cxn ang="0">
                          <a:pos x="connsiteX24" y="connsiteY24"/>
                        </a:cxn>
                        <a:cxn ang="0">
                          <a:pos x="connsiteX25" y="connsiteY25"/>
                        </a:cxn>
                        <a:cxn ang="0">
                          <a:pos x="connsiteX26" y="connsiteY26"/>
                        </a:cxn>
                        <a:cxn ang="0">
                          <a:pos x="connsiteX27" y="connsiteY27"/>
                        </a:cxn>
                        <a:cxn ang="0">
                          <a:pos x="connsiteX28" y="connsiteY28"/>
                        </a:cxn>
                        <a:cxn ang="0">
                          <a:pos x="connsiteX29" y="connsiteY29"/>
                        </a:cxn>
                        <a:cxn ang="0">
                          <a:pos x="connsiteX30" y="connsiteY30"/>
                        </a:cxn>
                        <a:cxn ang="0">
                          <a:pos x="connsiteX31" y="connsiteY31"/>
                        </a:cxn>
                        <a:cxn ang="0">
                          <a:pos x="connsiteX32" y="connsiteY32"/>
                        </a:cxn>
                        <a:cxn ang="0">
                          <a:pos x="connsiteX33" y="connsiteY33"/>
                        </a:cxn>
                        <a:cxn ang="0">
                          <a:pos x="connsiteX34" y="connsiteY34"/>
                        </a:cxn>
                        <a:cxn ang="0">
                          <a:pos x="connsiteX35" y="connsiteY35"/>
                        </a:cxn>
                        <a:cxn ang="0">
                          <a:pos x="connsiteX36" y="connsiteY36"/>
                        </a:cxn>
                        <a:cxn ang="0">
                          <a:pos x="connsiteX37" y="connsiteY37"/>
                        </a:cxn>
                        <a:cxn ang="0">
                          <a:pos x="connsiteX38" y="connsiteY38"/>
                        </a:cxn>
                        <a:cxn ang="0">
                          <a:pos x="connsiteX39" y="connsiteY39"/>
                        </a:cxn>
                        <a:cxn ang="0">
                          <a:pos x="connsiteX40" y="connsiteY40"/>
                        </a:cxn>
                        <a:cxn ang="0">
                          <a:pos x="connsiteX41" y="connsiteY41"/>
                        </a:cxn>
                      </a:cxnLst>
                      <a:rect l="l" t="t" r="r" b="b"/>
                      <a:pathLst>
                        <a:path w="1144368" h="1494426">
                          <a:moveTo>
                            <a:pt x="1144368" y="820286"/>
                          </a:moveTo>
                          <a:cubicBezTo>
                            <a:pt x="1087641" y="766946"/>
                            <a:pt x="1030915" y="713606"/>
                            <a:pt x="991968" y="637406"/>
                          </a:cubicBezTo>
                          <a:cubicBezTo>
                            <a:pt x="953021" y="561206"/>
                            <a:pt x="934395" y="440979"/>
                            <a:pt x="910688" y="363086"/>
                          </a:cubicBezTo>
                          <a:cubicBezTo>
                            <a:pt x="886981" y="285193"/>
                            <a:pt x="875128" y="225926"/>
                            <a:pt x="849728" y="170046"/>
                          </a:cubicBezTo>
                          <a:cubicBezTo>
                            <a:pt x="824328" y="114166"/>
                            <a:pt x="780301" y="53206"/>
                            <a:pt x="758288" y="27806"/>
                          </a:cubicBezTo>
                          <a:cubicBezTo>
                            <a:pt x="736275" y="2406"/>
                            <a:pt x="704101" y="-14527"/>
                            <a:pt x="717648" y="17646"/>
                          </a:cubicBezTo>
                          <a:cubicBezTo>
                            <a:pt x="731195" y="49819"/>
                            <a:pt x="810781" y="146339"/>
                            <a:pt x="839568" y="220846"/>
                          </a:cubicBezTo>
                          <a:cubicBezTo>
                            <a:pt x="868355" y="295353"/>
                            <a:pt x="903915" y="442673"/>
                            <a:pt x="890368" y="464686"/>
                          </a:cubicBezTo>
                          <a:cubicBezTo>
                            <a:pt x="876821" y="486699"/>
                            <a:pt x="817555" y="383406"/>
                            <a:pt x="758288" y="352926"/>
                          </a:cubicBezTo>
                          <a:cubicBezTo>
                            <a:pt x="699021" y="322446"/>
                            <a:pt x="609275" y="295353"/>
                            <a:pt x="534768" y="281806"/>
                          </a:cubicBezTo>
                          <a:cubicBezTo>
                            <a:pt x="460261" y="268259"/>
                            <a:pt x="329090" y="269149"/>
                            <a:pt x="311248" y="271646"/>
                          </a:cubicBezTo>
                          <a:cubicBezTo>
                            <a:pt x="293406" y="274143"/>
                            <a:pt x="385632" y="290462"/>
                            <a:pt x="427718" y="296791"/>
                          </a:cubicBezTo>
                          <a:cubicBezTo>
                            <a:pt x="469804" y="303120"/>
                            <a:pt x="504252" y="290727"/>
                            <a:pt x="563766" y="309618"/>
                          </a:cubicBezTo>
                          <a:cubicBezTo>
                            <a:pt x="623280" y="328509"/>
                            <a:pt x="733753" y="370749"/>
                            <a:pt x="784800" y="410140"/>
                          </a:cubicBezTo>
                          <a:cubicBezTo>
                            <a:pt x="835847" y="449531"/>
                            <a:pt x="849067" y="504702"/>
                            <a:pt x="870048" y="545966"/>
                          </a:cubicBezTo>
                          <a:cubicBezTo>
                            <a:pt x="891029" y="587230"/>
                            <a:pt x="895448" y="617086"/>
                            <a:pt x="910688" y="657726"/>
                          </a:cubicBezTo>
                          <a:cubicBezTo>
                            <a:pt x="925928" y="698366"/>
                            <a:pt x="1005515" y="759326"/>
                            <a:pt x="961488" y="789806"/>
                          </a:cubicBezTo>
                          <a:cubicBezTo>
                            <a:pt x="917461" y="820286"/>
                            <a:pt x="719341" y="866006"/>
                            <a:pt x="646528" y="840606"/>
                          </a:cubicBezTo>
                          <a:cubicBezTo>
                            <a:pt x="573715" y="815206"/>
                            <a:pt x="551701" y="691593"/>
                            <a:pt x="524608" y="637406"/>
                          </a:cubicBezTo>
                          <a:cubicBezTo>
                            <a:pt x="497515" y="583219"/>
                            <a:pt x="495821" y="530726"/>
                            <a:pt x="483968" y="515486"/>
                          </a:cubicBezTo>
                          <a:cubicBezTo>
                            <a:pt x="472115" y="500246"/>
                            <a:pt x="443328" y="500246"/>
                            <a:pt x="453488" y="545966"/>
                          </a:cubicBezTo>
                          <a:cubicBezTo>
                            <a:pt x="463648" y="591686"/>
                            <a:pt x="521221" y="733926"/>
                            <a:pt x="544928" y="789806"/>
                          </a:cubicBezTo>
                          <a:cubicBezTo>
                            <a:pt x="568635" y="845686"/>
                            <a:pt x="658381" y="867699"/>
                            <a:pt x="595728" y="881246"/>
                          </a:cubicBezTo>
                          <a:cubicBezTo>
                            <a:pt x="533075" y="894793"/>
                            <a:pt x="219685" y="866985"/>
                            <a:pt x="169008" y="871086"/>
                          </a:cubicBezTo>
                          <a:cubicBezTo>
                            <a:pt x="118332" y="875187"/>
                            <a:pt x="195520" y="900592"/>
                            <a:pt x="291669" y="905852"/>
                          </a:cubicBezTo>
                          <a:cubicBezTo>
                            <a:pt x="387818" y="911112"/>
                            <a:pt x="619558" y="925987"/>
                            <a:pt x="717648" y="921886"/>
                          </a:cubicBezTo>
                          <a:cubicBezTo>
                            <a:pt x="815738" y="917785"/>
                            <a:pt x="895448" y="840606"/>
                            <a:pt x="880208" y="881246"/>
                          </a:cubicBezTo>
                          <a:cubicBezTo>
                            <a:pt x="864968" y="921886"/>
                            <a:pt x="739661" y="1087833"/>
                            <a:pt x="626208" y="1165726"/>
                          </a:cubicBezTo>
                          <a:cubicBezTo>
                            <a:pt x="512755" y="1243619"/>
                            <a:pt x="302781" y="1313046"/>
                            <a:pt x="199488" y="1348606"/>
                          </a:cubicBezTo>
                          <a:cubicBezTo>
                            <a:pt x="96195" y="1384166"/>
                            <a:pt x="26768" y="1369995"/>
                            <a:pt x="6448" y="1379086"/>
                          </a:cubicBezTo>
                          <a:cubicBezTo>
                            <a:pt x="-13872" y="1388177"/>
                            <a:pt x="14915" y="1410905"/>
                            <a:pt x="77568" y="1403152"/>
                          </a:cubicBezTo>
                          <a:cubicBezTo>
                            <a:pt x="140221" y="1395399"/>
                            <a:pt x="289235" y="1361982"/>
                            <a:pt x="382368" y="1332571"/>
                          </a:cubicBezTo>
                          <a:cubicBezTo>
                            <a:pt x="475501" y="1303160"/>
                            <a:pt x="604195" y="1202000"/>
                            <a:pt x="636368" y="1226686"/>
                          </a:cubicBezTo>
                          <a:cubicBezTo>
                            <a:pt x="668541" y="1251372"/>
                            <a:pt x="573715" y="1445126"/>
                            <a:pt x="575408" y="1480686"/>
                          </a:cubicBezTo>
                          <a:cubicBezTo>
                            <a:pt x="577101" y="1516246"/>
                            <a:pt x="627901" y="1475606"/>
                            <a:pt x="646528" y="1440046"/>
                          </a:cubicBezTo>
                          <a:cubicBezTo>
                            <a:pt x="665155" y="1404486"/>
                            <a:pt x="675315" y="1313046"/>
                            <a:pt x="687168" y="1267326"/>
                          </a:cubicBezTo>
                          <a:cubicBezTo>
                            <a:pt x="699021" y="1221606"/>
                            <a:pt x="683781" y="1201286"/>
                            <a:pt x="717648" y="1165726"/>
                          </a:cubicBezTo>
                          <a:cubicBezTo>
                            <a:pt x="751515" y="1130166"/>
                            <a:pt x="840575" y="1088788"/>
                            <a:pt x="890368" y="1053966"/>
                          </a:cubicBezTo>
                          <a:cubicBezTo>
                            <a:pt x="940161" y="1019145"/>
                            <a:pt x="994409" y="958831"/>
                            <a:pt x="1016408" y="956797"/>
                          </a:cubicBezTo>
                          <a:cubicBezTo>
                            <a:pt x="1038407" y="954763"/>
                            <a:pt x="1022763" y="1019763"/>
                            <a:pt x="1022362" y="1041760"/>
                          </a:cubicBezTo>
                          <a:cubicBezTo>
                            <a:pt x="1021961" y="1063757"/>
                            <a:pt x="1008923" y="1082004"/>
                            <a:pt x="1014003" y="1088777"/>
                          </a:cubicBezTo>
                          <a:cubicBezTo>
                            <a:pt x="1019083" y="1095550"/>
                            <a:pt x="1005212" y="1080453"/>
                            <a:pt x="1002672" y="1082147"/>
                          </a:cubicBezTo>
                        </a:path>
                      </a:pathLst>
                    </a:custGeom>
                    <a:noFill/>
                    <a:ln>
                      <a:solidFill>
                        <a:srgbClr val="F2E6E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sz="1600">
                        <a:ln>
                          <a:solidFill>
                            <a:srgbClr val="FFC5D4"/>
                          </a:solidFill>
                        </a:ln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7" name="任意多边形: 形状 6">
                    <a:extLst>
                      <a:ext uri="{FF2B5EF4-FFF2-40B4-BE49-F238E27FC236}">
                        <a16:creationId xmlns:a16="http://schemas.microsoft.com/office/drawing/2014/main" id="{5B997941-6C9F-4FD9-B895-A6D629A33245}"/>
                      </a:ext>
                    </a:extLst>
                  </p:cNvPr>
                  <p:cNvSpPr/>
                  <p:nvPr/>
                </p:nvSpPr>
                <p:spPr>
                  <a:xfrm>
                    <a:off x="3969593" y="3602295"/>
                    <a:ext cx="3224744" cy="4136731"/>
                  </a:xfrm>
                  <a:custGeom>
                    <a:avLst/>
                    <a:gdLst>
                      <a:gd name="connsiteX0" fmla="*/ 1592950 w 1633590"/>
                      <a:gd name="connsiteY0" fmla="*/ 0 h 2502273"/>
                      <a:gd name="connsiteX1" fmla="*/ 1328790 w 1633590"/>
                      <a:gd name="connsiteY1" fmla="*/ 538480 h 2502273"/>
                      <a:gd name="connsiteX2" fmla="*/ 1328790 w 1633590"/>
                      <a:gd name="connsiteY2" fmla="*/ 538480 h 2502273"/>
                      <a:gd name="connsiteX3" fmla="*/ 1227190 w 1633590"/>
                      <a:gd name="connsiteY3" fmla="*/ 690880 h 2502273"/>
                      <a:gd name="connsiteX4" fmla="*/ 942710 w 1633590"/>
                      <a:gd name="connsiteY4" fmla="*/ 904240 h 2502273"/>
                      <a:gd name="connsiteX5" fmla="*/ 333110 w 1633590"/>
                      <a:gd name="connsiteY5" fmla="*/ 1117600 h 2502273"/>
                      <a:gd name="connsiteX6" fmla="*/ 18150 w 1633590"/>
                      <a:gd name="connsiteY6" fmla="*/ 1198880 h 2502273"/>
                      <a:gd name="connsiteX7" fmla="*/ 109590 w 1633590"/>
                      <a:gd name="connsiteY7" fmla="*/ 1249680 h 2502273"/>
                      <a:gd name="connsiteX8" fmla="*/ 698870 w 1633590"/>
                      <a:gd name="connsiteY8" fmla="*/ 1076960 h 2502273"/>
                      <a:gd name="connsiteX9" fmla="*/ 566790 w 1633590"/>
                      <a:gd name="connsiteY9" fmla="*/ 1310640 h 2502273"/>
                      <a:gd name="connsiteX10" fmla="*/ 190870 w 1633590"/>
                      <a:gd name="connsiteY10" fmla="*/ 1524000 h 2502273"/>
                      <a:gd name="connsiteX11" fmla="*/ 383910 w 1633590"/>
                      <a:gd name="connsiteY11" fmla="*/ 1513840 h 2502273"/>
                      <a:gd name="connsiteX12" fmla="*/ 678550 w 1633590"/>
                      <a:gd name="connsiteY12" fmla="*/ 1310640 h 2502273"/>
                      <a:gd name="connsiteX13" fmla="*/ 871590 w 1633590"/>
                      <a:gd name="connsiteY13" fmla="*/ 1076960 h 2502273"/>
                      <a:gd name="connsiteX14" fmla="*/ 1095110 w 1633590"/>
                      <a:gd name="connsiteY14" fmla="*/ 955040 h 2502273"/>
                      <a:gd name="connsiteX15" fmla="*/ 1237350 w 1633590"/>
                      <a:gd name="connsiteY15" fmla="*/ 812800 h 2502273"/>
                      <a:gd name="connsiteX16" fmla="*/ 1115430 w 1633590"/>
                      <a:gd name="connsiteY16" fmla="*/ 1056640 h 2502273"/>
                      <a:gd name="connsiteX17" fmla="*/ 963030 w 1633590"/>
                      <a:gd name="connsiteY17" fmla="*/ 1442720 h 2502273"/>
                      <a:gd name="connsiteX18" fmla="*/ 739510 w 1633590"/>
                      <a:gd name="connsiteY18" fmla="*/ 1656080 h 2502273"/>
                      <a:gd name="connsiteX19" fmla="*/ 404230 w 1633590"/>
                      <a:gd name="connsiteY19" fmla="*/ 1930400 h 2502273"/>
                      <a:gd name="connsiteX20" fmla="*/ 68950 w 1633590"/>
                      <a:gd name="connsiteY20" fmla="*/ 2143760 h 2502273"/>
                      <a:gd name="connsiteX21" fmla="*/ 109590 w 1633590"/>
                      <a:gd name="connsiteY21" fmla="*/ 2225040 h 2502273"/>
                      <a:gd name="connsiteX22" fmla="*/ 709030 w 1633590"/>
                      <a:gd name="connsiteY22" fmla="*/ 1788160 h 2502273"/>
                      <a:gd name="connsiteX23" fmla="*/ 739510 w 1633590"/>
                      <a:gd name="connsiteY23" fmla="*/ 2062480 h 2502273"/>
                      <a:gd name="connsiteX24" fmla="*/ 719190 w 1633590"/>
                      <a:gd name="connsiteY24" fmla="*/ 2316480 h 2502273"/>
                      <a:gd name="connsiteX25" fmla="*/ 780150 w 1633590"/>
                      <a:gd name="connsiteY25" fmla="*/ 2265680 h 2502273"/>
                      <a:gd name="connsiteX26" fmla="*/ 810630 w 1633590"/>
                      <a:gd name="connsiteY26" fmla="*/ 1838960 h 2502273"/>
                      <a:gd name="connsiteX27" fmla="*/ 932550 w 1633590"/>
                      <a:gd name="connsiteY27" fmla="*/ 1645920 h 2502273"/>
                      <a:gd name="connsiteX28" fmla="*/ 1105270 w 1633590"/>
                      <a:gd name="connsiteY28" fmla="*/ 1859280 h 2502273"/>
                      <a:gd name="connsiteX29" fmla="*/ 1125590 w 1633590"/>
                      <a:gd name="connsiteY29" fmla="*/ 2438400 h 2502273"/>
                      <a:gd name="connsiteX30" fmla="*/ 1176390 w 1633590"/>
                      <a:gd name="connsiteY30" fmla="*/ 2428240 h 2502273"/>
                      <a:gd name="connsiteX31" fmla="*/ 1166230 w 1633590"/>
                      <a:gd name="connsiteY31" fmla="*/ 1910080 h 2502273"/>
                      <a:gd name="connsiteX32" fmla="*/ 1095110 w 1633590"/>
                      <a:gd name="connsiteY32" fmla="*/ 1564640 h 2502273"/>
                      <a:gd name="connsiteX33" fmla="*/ 1176390 w 1633590"/>
                      <a:gd name="connsiteY33" fmla="*/ 1188720 h 2502273"/>
                      <a:gd name="connsiteX34" fmla="*/ 1379590 w 1633590"/>
                      <a:gd name="connsiteY34" fmla="*/ 1320800 h 2502273"/>
                      <a:gd name="connsiteX35" fmla="*/ 1440550 w 1633590"/>
                      <a:gd name="connsiteY35" fmla="*/ 1717040 h 2502273"/>
                      <a:gd name="connsiteX36" fmla="*/ 1481190 w 1633590"/>
                      <a:gd name="connsiteY36" fmla="*/ 1666240 h 2502273"/>
                      <a:gd name="connsiteX37" fmla="*/ 1430390 w 1633590"/>
                      <a:gd name="connsiteY37" fmla="*/ 1209040 h 2502273"/>
                      <a:gd name="connsiteX38" fmla="*/ 1338950 w 1633590"/>
                      <a:gd name="connsiteY38" fmla="*/ 1066800 h 2502273"/>
                      <a:gd name="connsiteX39" fmla="*/ 1369430 w 1633590"/>
                      <a:gd name="connsiteY39" fmla="*/ 772160 h 2502273"/>
                      <a:gd name="connsiteX40" fmla="*/ 1572630 w 1633590"/>
                      <a:gd name="connsiteY40" fmla="*/ 314960 h 2502273"/>
                      <a:gd name="connsiteX41" fmla="*/ 1603110 w 1633590"/>
                      <a:gd name="connsiteY41" fmla="*/ 132080 h 2502273"/>
                      <a:gd name="connsiteX42" fmla="*/ 1633590 w 1633590"/>
                      <a:gd name="connsiteY42" fmla="*/ 101600 h 2502273"/>
                      <a:gd name="connsiteX0" fmla="*/ 1592950 w 1690328"/>
                      <a:gd name="connsiteY0" fmla="*/ 0 h 2502273"/>
                      <a:gd name="connsiteX1" fmla="*/ 1328790 w 1690328"/>
                      <a:gd name="connsiteY1" fmla="*/ 538480 h 2502273"/>
                      <a:gd name="connsiteX2" fmla="*/ 1328790 w 1690328"/>
                      <a:gd name="connsiteY2" fmla="*/ 538480 h 2502273"/>
                      <a:gd name="connsiteX3" fmla="*/ 1227190 w 1690328"/>
                      <a:gd name="connsiteY3" fmla="*/ 690880 h 2502273"/>
                      <a:gd name="connsiteX4" fmla="*/ 942710 w 1690328"/>
                      <a:gd name="connsiteY4" fmla="*/ 904240 h 2502273"/>
                      <a:gd name="connsiteX5" fmla="*/ 333110 w 1690328"/>
                      <a:gd name="connsiteY5" fmla="*/ 1117600 h 2502273"/>
                      <a:gd name="connsiteX6" fmla="*/ 18150 w 1690328"/>
                      <a:gd name="connsiteY6" fmla="*/ 1198880 h 2502273"/>
                      <a:gd name="connsiteX7" fmla="*/ 109590 w 1690328"/>
                      <a:gd name="connsiteY7" fmla="*/ 1249680 h 2502273"/>
                      <a:gd name="connsiteX8" fmla="*/ 698870 w 1690328"/>
                      <a:gd name="connsiteY8" fmla="*/ 1076960 h 2502273"/>
                      <a:gd name="connsiteX9" fmla="*/ 566790 w 1690328"/>
                      <a:gd name="connsiteY9" fmla="*/ 1310640 h 2502273"/>
                      <a:gd name="connsiteX10" fmla="*/ 190870 w 1690328"/>
                      <a:gd name="connsiteY10" fmla="*/ 1524000 h 2502273"/>
                      <a:gd name="connsiteX11" fmla="*/ 383910 w 1690328"/>
                      <a:gd name="connsiteY11" fmla="*/ 1513840 h 2502273"/>
                      <a:gd name="connsiteX12" fmla="*/ 678550 w 1690328"/>
                      <a:gd name="connsiteY12" fmla="*/ 1310640 h 2502273"/>
                      <a:gd name="connsiteX13" fmla="*/ 871590 w 1690328"/>
                      <a:gd name="connsiteY13" fmla="*/ 1076960 h 2502273"/>
                      <a:gd name="connsiteX14" fmla="*/ 1095110 w 1690328"/>
                      <a:gd name="connsiteY14" fmla="*/ 955040 h 2502273"/>
                      <a:gd name="connsiteX15" fmla="*/ 1237350 w 1690328"/>
                      <a:gd name="connsiteY15" fmla="*/ 812800 h 2502273"/>
                      <a:gd name="connsiteX16" fmla="*/ 1115430 w 1690328"/>
                      <a:gd name="connsiteY16" fmla="*/ 1056640 h 2502273"/>
                      <a:gd name="connsiteX17" fmla="*/ 963030 w 1690328"/>
                      <a:gd name="connsiteY17" fmla="*/ 1442720 h 2502273"/>
                      <a:gd name="connsiteX18" fmla="*/ 739510 w 1690328"/>
                      <a:gd name="connsiteY18" fmla="*/ 1656080 h 2502273"/>
                      <a:gd name="connsiteX19" fmla="*/ 404230 w 1690328"/>
                      <a:gd name="connsiteY19" fmla="*/ 1930400 h 2502273"/>
                      <a:gd name="connsiteX20" fmla="*/ 68950 w 1690328"/>
                      <a:gd name="connsiteY20" fmla="*/ 2143760 h 2502273"/>
                      <a:gd name="connsiteX21" fmla="*/ 109590 w 1690328"/>
                      <a:gd name="connsiteY21" fmla="*/ 2225040 h 2502273"/>
                      <a:gd name="connsiteX22" fmla="*/ 709030 w 1690328"/>
                      <a:gd name="connsiteY22" fmla="*/ 1788160 h 2502273"/>
                      <a:gd name="connsiteX23" fmla="*/ 739510 w 1690328"/>
                      <a:gd name="connsiteY23" fmla="*/ 2062480 h 2502273"/>
                      <a:gd name="connsiteX24" fmla="*/ 719190 w 1690328"/>
                      <a:gd name="connsiteY24" fmla="*/ 2316480 h 2502273"/>
                      <a:gd name="connsiteX25" fmla="*/ 780150 w 1690328"/>
                      <a:gd name="connsiteY25" fmla="*/ 2265680 h 2502273"/>
                      <a:gd name="connsiteX26" fmla="*/ 810630 w 1690328"/>
                      <a:gd name="connsiteY26" fmla="*/ 1838960 h 2502273"/>
                      <a:gd name="connsiteX27" fmla="*/ 932550 w 1690328"/>
                      <a:gd name="connsiteY27" fmla="*/ 1645920 h 2502273"/>
                      <a:gd name="connsiteX28" fmla="*/ 1105270 w 1690328"/>
                      <a:gd name="connsiteY28" fmla="*/ 1859280 h 2502273"/>
                      <a:gd name="connsiteX29" fmla="*/ 1125590 w 1690328"/>
                      <a:gd name="connsiteY29" fmla="*/ 2438400 h 2502273"/>
                      <a:gd name="connsiteX30" fmla="*/ 1176390 w 1690328"/>
                      <a:gd name="connsiteY30" fmla="*/ 2428240 h 2502273"/>
                      <a:gd name="connsiteX31" fmla="*/ 1166230 w 1690328"/>
                      <a:gd name="connsiteY31" fmla="*/ 1910080 h 2502273"/>
                      <a:gd name="connsiteX32" fmla="*/ 1095110 w 1690328"/>
                      <a:gd name="connsiteY32" fmla="*/ 1564640 h 2502273"/>
                      <a:gd name="connsiteX33" fmla="*/ 1176390 w 1690328"/>
                      <a:gd name="connsiteY33" fmla="*/ 1188720 h 2502273"/>
                      <a:gd name="connsiteX34" fmla="*/ 1379590 w 1690328"/>
                      <a:gd name="connsiteY34" fmla="*/ 1320800 h 2502273"/>
                      <a:gd name="connsiteX35" fmla="*/ 1440550 w 1690328"/>
                      <a:gd name="connsiteY35" fmla="*/ 1717040 h 2502273"/>
                      <a:gd name="connsiteX36" fmla="*/ 1481190 w 1690328"/>
                      <a:gd name="connsiteY36" fmla="*/ 1666240 h 2502273"/>
                      <a:gd name="connsiteX37" fmla="*/ 1430390 w 1690328"/>
                      <a:gd name="connsiteY37" fmla="*/ 1209040 h 2502273"/>
                      <a:gd name="connsiteX38" fmla="*/ 1338950 w 1690328"/>
                      <a:gd name="connsiteY38" fmla="*/ 1066800 h 2502273"/>
                      <a:gd name="connsiteX39" fmla="*/ 1369430 w 1690328"/>
                      <a:gd name="connsiteY39" fmla="*/ 772160 h 2502273"/>
                      <a:gd name="connsiteX40" fmla="*/ 1572630 w 1690328"/>
                      <a:gd name="connsiteY40" fmla="*/ 314960 h 2502273"/>
                      <a:gd name="connsiteX41" fmla="*/ 1603110 w 1690328"/>
                      <a:gd name="connsiteY41" fmla="*/ 132080 h 2502273"/>
                      <a:gd name="connsiteX42" fmla="*/ 1690328 w 1690328"/>
                      <a:gd name="connsiteY42" fmla="*/ 13112 h 2502273"/>
                      <a:gd name="connsiteX0" fmla="*/ 1592950 w 1690328"/>
                      <a:gd name="connsiteY0" fmla="*/ 0 h 2502273"/>
                      <a:gd name="connsiteX1" fmla="*/ 1328790 w 1690328"/>
                      <a:gd name="connsiteY1" fmla="*/ 538480 h 2502273"/>
                      <a:gd name="connsiteX2" fmla="*/ 1328790 w 1690328"/>
                      <a:gd name="connsiteY2" fmla="*/ 538480 h 2502273"/>
                      <a:gd name="connsiteX3" fmla="*/ 1227190 w 1690328"/>
                      <a:gd name="connsiteY3" fmla="*/ 690880 h 2502273"/>
                      <a:gd name="connsiteX4" fmla="*/ 942710 w 1690328"/>
                      <a:gd name="connsiteY4" fmla="*/ 904240 h 2502273"/>
                      <a:gd name="connsiteX5" fmla="*/ 333110 w 1690328"/>
                      <a:gd name="connsiteY5" fmla="*/ 1117600 h 2502273"/>
                      <a:gd name="connsiteX6" fmla="*/ 18150 w 1690328"/>
                      <a:gd name="connsiteY6" fmla="*/ 1198880 h 2502273"/>
                      <a:gd name="connsiteX7" fmla="*/ 109590 w 1690328"/>
                      <a:gd name="connsiteY7" fmla="*/ 1249680 h 2502273"/>
                      <a:gd name="connsiteX8" fmla="*/ 698870 w 1690328"/>
                      <a:gd name="connsiteY8" fmla="*/ 1076960 h 2502273"/>
                      <a:gd name="connsiteX9" fmla="*/ 566790 w 1690328"/>
                      <a:gd name="connsiteY9" fmla="*/ 1310640 h 2502273"/>
                      <a:gd name="connsiteX10" fmla="*/ 190870 w 1690328"/>
                      <a:gd name="connsiteY10" fmla="*/ 1524000 h 2502273"/>
                      <a:gd name="connsiteX11" fmla="*/ 383910 w 1690328"/>
                      <a:gd name="connsiteY11" fmla="*/ 1513840 h 2502273"/>
                      <a:gd name="connsiteX12" fmla="*/ 678550 w 1690328"/>
                      <a:gd name="connsiteY12" fmla="*/ 1310640 h 2502273"/>
                      <a:gd name="connsiteX13" fmla="*/ 871590 w 1690328"/>
                      <a:gd name="connsiteY13" fmla="*/ 1076960 h 2502273"/>
                      <a:gd name="connsiteX14" fmla="*/ 1095110 w 1690328"/>
                      <a:gd name="connsiteY14" fmla="*/ 955040 h 2502273"/>
                      <a:gd name="connsiteX15" fmla="*/ 1237350 w 1690328"/>
                      <a:gd name="connsiteY15" fmla="*/ 812800 h 2502273"/>
                      <a:gd name="connsiteX16" fmla="*/ 1115430 w 1690328"/>
                      <a:gd name="connsiteY16" fmla="*/ 1056640 h 2502273"/>
                      <a:gd name="connsiteX17" fmla="*/ 963030 w 1690328"/>
                      <a:gd name="connsiteY17" fmla="*/ 1442720 h 2502273"/>
                      <a:gd name="connsiteX18" fmla="*/ 739510 w 1690328"/>
                      <a:gd name="connsiteY18" fmla="*/ 1656080 h 2502273"/>
                      <a:gd name="connsiteX19" fmla="*/ 404230 w 1690328"/>
                      <a:gd name="connsiteY19" fmla="*/ 1930400 h 2502273"/>
                      <a:gd name="connsiteX20" fmla="*/ 68950 w 1690328"/>
                      <a:gd name="connsiteY20" fmla="*/ 2143760 h 2502273"/>
                      <a:gd name="connsiteX21" fmla="*/ 109590 w 1690328"/>
                      <a:gd name="connsiteY21" fmla="*/ 2225040 h 2502273"/>
                      <a:gd name="connsiteX22" fmla="*/ 709030 w 1690328"/>
                      <a:gd name="connsiteY22" fmla="*/ 1788160 h 2502273"/>
                      <a:gd name="connsiteX23" fmla="*/ 739510 w 1690328"/>
                      <a:gd name="connsiteY23" fmla="*/ 2062480 h 2502273"/>
                      <a:gd name="connsiteX24" fmla="*/ 719190 w 1690328"/>
                      <a:gd name="connsiteY24" fmla="*/ 2316480 h 2502273"/>
                      <a:gd name="connsiteX25" fmla="*/ 780150 w 1690328"/>
                      <a:gd name="connsiteY25" fmla="*/ 2265680 h 2502273"/>
                      <a:gd name="connsiteX26" fmla="*/ 810630 w 1690328"/>
                      <a:gd name="connsiteY26" fmla="*/ 1838960 h 2502273"/>
                      <a:gd name="connsiteX27" fmla="*/ 932550 w 1690328"/>
                      <a:gd name="connsiteY27" fmla="*/ 1645920 h 2502273"/>
                      <a:gd name="connsiteX28" fmla="*/ 1105270 w 1690328"/>
                      <a:gd name="connsiteY28" fmla="*/ 1859280 h 2502273"/>
                      <a:gd name="connsiteX29" fmla="*/ 1125590 w 1690328"/>
                      <a:gd name="connsiteY29" fmla="*/ 2438400 h 2502273"/>
                      <a:gd name="connsiteX30" fmla="*/ 1176390 w 1690328"/>
                      <a:gd name="connsiteY30" fmla="*/ 2428240 h 2502273"/>
                      <a:gd name="connsiteX31" fmla="*/ 1166230 w 1690328"/>
                      <a:gd name="connsiteY31" fmla="*/ 1910080 h 2502273"/>
                      <a:gd name="connsiteX32" fmla="*/ 1095110 w 1690328"/>
                      <a:gd name="connsiteY32" fmla="*/ 1564640 h 2502273"/>
                      <a:gd name="connsiteX33" fmla="*/ 1176390 w 1690328"/>
                      <a:gd name="connsiteY33" fmla="*/ 1188720 h 2502273"/>
                      <a:gd name="connsiteX34" fmla="*/ 1379590 w 1690328"/>
                      <a:gd name="connsiteY34" fmla="*/ 1320800 h 2502273"/>
                      <a:gd name="connsiteX35" fmla="*/ 1440550 w 1690328"/>
                      <a:gd name="connsiteY35" fmla="*/ 1717040 h 2502273"/>
                      <a:gd name="connsiteX36" fmla="*/ 1481190 w 1690328"/>
                      <a:gd name="connsiteY36" fmla="*/ 1666240 h 2502273"/>
                      <a:gd name="connsiteX37" fmla="*/ 1430390 w 1690328"/>
                      <a:gd name="connsiteY37" fmla="*/ 1209040 h 2502273"/>
                      <a:gd name="connsiteX38" fmla="*/ 1338950 w 1690328"/>
                      <a:gd name="connsiteY38" fmla="*/ 1066800 h 2502273"/>
                      <a:gd name="connsiteX39" fmla="*/ 1369430 w 1690328"/>
                      <a:gd name="connsiteY39" fmla="*/ 772160 h 2502273"/>
                      <a:gd name="connsiteX40" fmla="*/ 1572630 w 1690328"/>
                      <a:gd name="connsiteY40" fmla="*/ 314960 h 2502273"/>
                      <a:gd name="connsiteX41" fmla="*/ 1629297 w 1690328"/>
                      <a:gd name="connsiteY41" fmla="*/ 151042 h 2502273"/>
                      <a:gd name="connsiteX42" fmla="*/ 1690328 w 1690328"/>
                      <a:gd name="connsiteY42" fmla="*/ 13112 h 2502273"/>
                      <a:gd name="connsiteX0" fmla="*/ 1592950 w 1681599"/>
                      <a:gd name="connsiteY0" fmla="*/ 0 h 2502273"/>
                      <a:gd name="connsiteX1" fmla="*/ 1328790 w 1681599"/>
                      <a:gd name="connsiteY1" fmla="*/ 538480 h 2502273"/>
                      <a:gd name="connsiteX2" fmla="*/ 1328790 w 1681599"/>
                      <a:gd name="connsiteY2" fmla="*/ 538480 h 2502273"/>
                      <a:gd name="connsiteX3" fmla="*/ 1227190 w 1681599"/>
                      <a:gd name="connsiteY3" fmla="*/ 690880 h 2502273"/>
                      <a:gd name="connsiteX4" fmla="*/ 942710 w 1681599"/>
                      <a:gd name="connsiteY4" fmla="*/ 904240 h 2502273"/>
                      <a:gd name="connsiteX5" fmla="*/ 333110 w 1681599"/>
                      <a:gd name="connsiteY5" fmla="*/ 1117600 h 2502273"/>
                      <a:gd name="connsiteX6" fmla="*/ 18150 w 1681599"/>
                      <a:gd name="connsiteY6" fmla="*/ 1198880 h 2502273"/>
                      <a:gd name="connsiteX7" fmla="*/ 109590 w 1681599"/>
                      <a:gd name="connsiteY7" fmla="*/ 1249680 h 2502273"/>
                      <a:gd name="connsiteX8" fmla="*/ 698870 w 1681599"/>
                      <a:gd name="connsiteY8" fmla="*/ 1076960 h 2502273"/>
                      <a:gd name="connsiteX9" fmla="*/ 566790 w 1681599"/>
                      <a:gd name="connsiteY9" fmla="*/ 1310640 h 2502273"/>
                      <a:gd name="connsiteX10" fmla="*/ 190870 w 1681599"/>
                      <a:gd name="connsiteY10" fmla="*/ 1524000 h 2502273"/>
                      <a:gd name="connsiteX11" fmla="*/ 383910 w 1681599"/>
                      <a:gd name="connsiteY11" fmla="*/ 1513840 h 2502273"/>
                      <a:gd name="connsiteX12" fmla="*/ 678550 w 1681599"/>
                      <a:gd name="connsiteY12" fmla="*/ 1310640 h 2502273"/>
                      <a:gd name="connsiteX13" fmla="*/ 871590 w 1681599"/>
                      <a:gd name="connsiteY13" fmla="*/ 1076960 h 2502273"/>
                      <a:gd name="connsiteX14" fmla="*/ 1095110 w 1681599"/>
                      <a:gd name="connsiteY14" fmla="*/ 955040 h 2502273"/>
                      <a:gd name="connsiteX15" fmla="*/ 1237350 w 1681599"/>
                      <a:gd name="connsiteY15" fmla="*/ 812800 h 2502273"/>
                      <a:gd name="connsiteX16" fmla="*/ 1115430 w 1681599"/>
                      <a:gd name="connsiteY16" fmla="*/ 1056640 h 2502273"/>
                      <a:gd name="connsiteX17" fmla="*/ 963030 w 1681599"/>
                      <a:gd name="connsiteY17" fmla="*/ 1442720 h 2502273"/>
                      <a:gd name="connsiteX18" fmla="*/ 739510 w 1681599"/>
                      <a:gd name="connsiteY18" fmla="*/ 1656080 h 2502273"/>
                      <a:gd name="connsiteX19" fmla="*/ 404230 w 1681599"/>
                      <a:gd name="connsiteY19" fmla="*/ 1930400 h 2502273"/>
                      <a:gd name="connsiteX20" fmla="*/ 68950 w 1681599"/>
                      <a:gd name="connsiteY20" fmla="*/ 2143760 h 2502273"/>
                      <a:gd name="connsiteX21" fmla="*/ 109590 w 1681599"/>
                      <a:gd name="connsiteY21" fmla="*/ 2225040 h 2502273"/>
                      <a:gd name="connsiteX22" fmla="*/ 709030 w 1681599"/>
                      <a:gd name="connsiteY22" fmla="*/ 1788160 h 2502273"/>
                      <a:gd name="connsiteX23" fmla="*/ 739510 w 1681599"/>
                      <a:gd name="connsiteY23" fmla="*/ 2062480 h 2502273"/>
                      <a:gd name="connsiteX24" fmla="*/ 719190 w 1681599"/>
                      <a:gd name="connsiteY24" fmla="*/ 2316480 h 2502273"/>
                      <a:gd name="connsiteX25" fmla="*/ 780150 w 1681599"/>
                      <a:gd name="connsiteY25" fmla="*/ 2265680 h 2502273"/>
                      <a:gd name="connsiteX26" fmla="*/ 810630 w 1681599"/>
                      <a:gd name="connsiteY26" fmla="*/ 1838960 h 2502273"/>
                      <a:gd name="connsiteX27" fmla="*/ 932550 w 1681599"/>
                      <a:gd name="connsiteY27" fmla="*/ 1645920 h 2502273"/>
                      <a:gd name="connsiteX28" fmla="*/ 1105270 w 1681599"/>
                      <a:gd name="connsiteY28" fmla="*/ 1859280 h 2502273"/>
                      <a:gd name="connsiteX29" fmla="*/ 1125590 w 1681599"/>
                      <a:gd name="connsiteY29" fmla="*/ 2438400 h 2502273"/>
                      <a:gd name="connsiteX30" fmla="*/ 1176390 w 1681599"/>
                      <a:gd name="connsiteY30" fmla="*/ 2428240 h 2502273"/>
                      <a:gd name="connsiteX31" fmla="*/ 1166230 w 1681599"/>
                      <a:gd name="connsiteY31" fmla="*/ 1910080 h 2502273"/>
                      <a:gd name="connsiteX32" fmla="*/ 1095110 w 1681599"/>
                      <a:gd name="connsiteY32" fmla="*/ 1564640 h 2502273"/>
                      <a:gd name="connsiteX33" fmla="*/ 1176390 w 1681599"/>
                      <a:gd name="connsiteY33" fmla="*/ 1188720 h 2502273"/>
                      <a:gd name="connsiteX34" fmla="*/ 1379590 w 1681599"/>
                      <a:gd name="connsiteY34" fmla="*/ 1320800 h 2502273"/>
                      <a:gd name="connsiteX35" fmla="*/ 1440550 w 1681599"/>
                      <a:gd name="connsiteY35" fmla="*/ 1717040 h 2502273"/>
                      <a:gd name="connsiteX36" fmla="*/ 1481190 w 1681599"/>
                      <a:gd name="connsiteY36" fmla="*/ 1666240 h 2502273"/>
                      <a:gd name="connsiteX37" fmla="*/ 1430390 w 1681599"/>
                      <a:gd name="connsiteY37" fmla="*/ 1209040 h 2502273"/>
                      <a:gd name="connsiteX38" fmla="*/ 1338950 w 1681599"/>
                      <a:gd name="connsiteY38" fmla="*/ 1066800 h 2502273"/>
                      <a:gd name="connsiteX39" fmla="*/ 1369430 w 1681599"/>
                      <a:gd name="connsiteY39" fmla="*/ 772160 h 2502273"/>
                      <a:gd name="connsiteX40" fmla="*/ 1572630 w 1681599"/>
                      <a:gd name="connsiteY40" fmla="*/ 314960 h 2502273"/>
                      <a:gd name="connsiteX41" fmla="*/ 1629297 w 1681599"/>
                      <a:gd name="connsiteY41" fmla="*/ 151042 h 2502273"/>
                      <a:gd name="connsiteX42" fmla="*/ 1681599 w 1681599"/>
                      <a:gd name="connsiteY42" fmla="*/ 69997 h 2502273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</a:cxnLst>
                    <a:rect l="l" t="t" r="r" b="b"/>
                    <a:pathLst>
                      <a:path w="1681599" h="2502273">
                        <a:moveTo>
                          <a:pt x="1592950" y="0"/>
                        </a:moveTo>
                        <a:lnTo>
                          <a:pt x="1328790" y="538480"/>
                        </a:lnTo>
                        <a:lnTo>
                          <a:pt x="1328790" y="538480"/>
                        </a:lnTo>
                        <a:cubicBezTo>
                          <a:pt x="1311857" y="563880"/>
                          <a:pt x="1291537" y="629920"/>
                          <a:pt x="1227190" y="690880"/>
                        </a:cubicBezTo>
                        <a:cubicBezTo>
                          <a:pt x="1162843" y="751840"/>
                          <a:pt x="1091723" y="833120"/>
                          <a:pt x="942710" y="904240"/>
                        </a:cubicBezTo>
                        <a:cubicBezTo>
                          <a:pt x="793697" y="975360"/>
                          <a:pt x="487203" y="1068493"/>
                          <a:pt x="333110" y="1117600"/>
                        </a:cubicBezTo>
                        <a:cubicBezTo>
                          <a:pt x="179017" y="1166707"/>
                          <a:pt x="55403" y="1176867"/>
                          <a:pt x="18150" y="1198880"/>
                        </a:cubicBezTo>
                        <a:cubicBezTo>
                          <a:pt x="-19103" y="1220893"/>
                          <a:pt x="-3863" y="1270000"/>
                          <a:pt x="109590" y="1249680"/>
                        </a:cubicBezTo>
                        <a:cubicBezTo>
                          <a:pt x="223043" y="1229360"/>
                          <a:pt x="622670" y="1066800"/>
                          <a:pt x="698870" y="1076960"/>
                        </a:cubicBezTo>
                        <a:cubicBezTo>
                          <a:pt x="775070" y="1087120"/>
                          <a:pt x="651457" y="1236133"/>
                          <a:pt x="566790" y="1310640"/>
                        </a:cubicBezTo>
                        <a:cubicBezTo>
                          <a:pt x="482123" y="1385147"/>
                          <a:pt x="221350" y="1490133"/>
                          <a:pt x="190870" y="1524000"/>
                        </a:cubicBezTo>
                        <a:cubicBezTo>
                          <a:pt x="160390" y="1557867"/>
                          <a:pt x="302630" y="1549400"/>
                          <a:pt x="383910" y="1513840"/>
                        </a:cubicBezTo>
                        <a:cubicBezTo>
                          <a:pt x="465190" y="1478280"/>
                          <a:pt x="597270" y="1383453"/>
                          <a:pt x="678550" y="1310640"/>
                        </a:cubicBezTo>
                        <a:cubicBezTo>
                          <a:pt x="759830" y="1237827"/>
                          <a:pt x="802163" y="1136227"/>
                          <a:pt x="871590" y="1076960"/>
                        </a:cubicBezTo>
                        <a:cubicBezTo>
                          <a:pt x="941017" y="1017693"/>
                          <a:pt x="1034150" y="999067"/>
                          <a:pt x="1095110" y="955040"/>
                        </a:cubicBezTo>
                        <a:cubicBezTo>
                          <a:pt x="1156070" y="911013"/>
                          <a:pt x="1233963" y="795867"/>
                          <a:pt x="1237350" y="812800"/>
                        </a:cubicBezTo>
                        <a:cubicBezTo>
                          <a:pt x="1240737" y="829733"/>
                          <a:pt x="1161150" y="951653"/>
                          <a:pt x="1115430" y="1056640"/>
                        </a:cubicBezTo>
                        <a:cubicBezTo>
                          <a:pt x="1069710" y="1161627"/>
                          <a:pt x="1025683" y="1342813"/>
                          <a:pt x="963030" y="1442720"/>
                        </a:cubicBezTo>
                        <a:cubicBezTo>
                          <a:pt x="900377" y="1542627"/>
                          <a:pt x="832643" y="1574800"/>
                          <a:pt x="739510" y="1656080"/>
                        </a:cubicBezTo>
                        <a:cubicBezTo>
                          <a:pt x="646377" y="1737360"/>
                          <a:pt x="515990" y="1849120"/>
                          <a:pt x="404230" y="1930400"/>
                        </a:cubicBezTo>
                        <a:cubicBezTo>
                          <a:pt x="292470" y="2011680"/>
                          <a:pt x="118057" y="2094653"/>
                          <a:pt x="68950" y="2143760"/>
                        </a:cubicBezTo>
                        <a:cubicBezTo>
                          <a:pt x="19843" y="2192867"/>
                          <a:pt x="2910" y="2284307"/>
                          <a:pt x="109590" y="2225040"/>
                        </a:cubicBezTo>
                        <a:cubicBezTo>
                          <a:pt x="216270" y="2165773"/>
                          <a:pt x="604043" y="1815253"/>
                          <a:pt x="709030" y="1788160"/>
                        </a:cubicBezTo>
                        <a:cubicBezTo>
                          <a:pt x="814017" y="1761067"/>
                          <a:pt x="737817" y="1974427"/>
                          <a:pt x="739510" y="2062480"/>
                        </a:cubicBezTo>
                        <a:cubicBezTo>
                          <a:pt x="741203" y="2150533"/>
                          <a:pt x="712417" y="2282613"/>
                          <a:pt x="719190" y="2316480"/>
                        </a:cubicBezTo>
                        <a:cubicBezTo>
                          <a:pt x="725963" y="2350347"/>
                          <a:pt x="764910" y="2345267"/>
                          <a:pt x="780150" y="2265680"/>
                        </a:cubicBezTo>
                        <a:cubicBezTo>
                          <a:pt x="795390" y="2186093"/>
                          <a:pt x="785230" y="1942253"/>
                          <a:pt x="810630" y="1838960"/>
                        </a:cubicBezTo>
                        <a:cubicBezTo>
                          <a:pt x="836030" y="1735667"/>
                          <a:pt x="883443" y="1642533"/>
                          <a:pt x="932550" y="1645920"/>
                        </a:cubicBezTo>
                        <a:cubicBezTo>
                          <a:pt x="981657" y="1649307"/>
                          <a:pt x="1073097" y="1727200"/>
                          <a:pt x="1105270" y="1859280"/>
                        </a:cubicBezTo>
                        <a:cubicBezTo>
                          <a:pt x="1137443" y="1991360"/>
                          <a:pt x="1113737" y="2343574"/>
                          <a:pt x="1125590" y="2438400"/>
                        </a:cubicBezTo>
                        <a:cubicBezTo>
                          <a:pt x="1137443" y="2533226"/>
                          <a:pt x="1169617" y="2516293"/>
                          <a:pt x="1176390" y="2428240"/>
                        </a:cubicBezTo>
                        <a:cubicBezTo>
                          <a:pt x="1183163" y="2340187"/>
                          <a:pt x="1179777" y="2054013"/>
                          <a:pt x="1166230" y="1910080"/>
                        </a:cubicBezTo>
                        <a:cubicBezTo>
                          <a:pt x="1152683" y="1766147"/>
                          <a:pt x="1093417" y="1684867"/>
                          <a:pt x="1095110" y="1564640"/>
                        </a:cubicBezTo>
                        <a:cubicBezTo>
                          <a:pt x="1096803" y="1444413"/>
                          <a:pt x="1128977" y="1229360"/>
                          <a:pt x="1176390" y="1188720"/>
                        </a:cubicBezTo>
                        <a:cubicBezTo>
                          <a:pt x="1223803" y="1148080"/>
                          <a:pt x="1335563" y="1232747"/>
                          <a:pt x="1379590" y="1320800"/>
                        </a:cubicBezTo>
                        <a:cubicBezTo>
                          <a:pt x="1423617" y="1408853"/>
                          <a:pt x="1423617" y="1659467"/>
                          <a:pt x="1440550" y="1717040"/>
                        </a:cubicBezTo>
                        <a:cubicBezTo>
                          <a:pt x="1457483" y="1774613"/>
                          <a:pt x="1482883" y="1750907"/>
                          <a:pt x="1481190" y="1666240"/>
                        </a:cubicBezTo>
                        <a:cubicBezTo>
                          <a:pt x="1479497" y="1581573"/>
                          <a:pt x="1454097" y="1308947"/>
                          <a:pt x="1430390" y="1209040"/>
                        </a:cubicBezTo>
                        <a:cubicBezTo>
                          <a:pt x="1406683" y="1109133"/>
                          <a:pt x="1349110" y="1139613"/>
                          <a:pt x="1338950" y="1066800"/>
                        </a:cubicBezTo>
                        <a:cubicBezTo>
                          <a:pt x="1328790" y="993987"/>
                          <a:pt x="1330483" y="897467"/>
                          <a:pt x="1369430" y="772160"/>
                        </a:cubicBezTo>
                        <a:cubicBezTo>
                          <a:pt x="1408377" y="646853"/>
                          <a:pt x="1529319" y="418480"/>
                          <a:pt x="1572630" y="314960"/>
                        </a:cubicBezTo>
                        <a:cubicBezTo>
                          <a:pt x="1615941" y="211440"/>
                          <a:pt x="1619137" y="186602"/>
                          <a:pt x="1629297" y="151042"/>
                        </a:cubicBezTo>
                        <a:cubicBezTo>
                          <a:pt x="1639457" y="115482"/>
                          <a:pt x="1671439" y="67457"/>
                          <a:pt x="1681599" y="69997"/>
                        </a:cubicBezTo>
                      </a:path>
                    </a:pathLst>
                  </a:custGeom>
                  <a:noFill/>
                  <a:ln>
                    <a:solidFill>
                      <a:srgbClr val="F2E6E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1600">
                      <a:ln>
                        <a:solidFill>
                          <a:srgbClr val="F2E6E0"/>
                        </a:solidFill>
                      </a:ln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2" name="流程图: 直接访问存储器 11">
                  <a:extLst>
                    <a:ext uri="{FF2B5EF4-FFF2-40B4-BE49-F238E27FC236}">
                      <a16:creationId xmlns:a16="http://schemas.microsoft.com/office/drawing/2014/main" id="{F5F6D359-E87D-45C2-A45D-B5E50720DE8B}"/>
                    </a:ext>
                  </a:extLst>
                </p:cNvPr>
                <p:cNvSpPr/>
                <p:nvPr/>
              </p:nvSpPr>
              <p:spPr>
                <a:xfrm flipV="1">
                  <a:off x="6315389" y="4155426"/>
                  <a:ext cx="1076775" cy="49059"/>
                </a:xfrm>
                <a:prstGeom prst="flowChartMagneticDrum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L 形 17">
                  <a:extLst>
                    <a:ext uri="{FF2B5EF4-FFF2-40B4-BE49-F238E27FC236}">
                      <a16:creationId xmlns:a16="http://schemas.microsoft.com/office/drawing/2014/main" id="{023B2E8D-BD25-4210-8D18-D159B1FE210F}"/>
                    </a:ext>
                  </a:extLst>
                </p:cNvPr>
                <p:cNvSpPr/>
                <p:nvPr/>
              </p:nvSpPr>
              <p:spPr>
                <a:xfrm flipH="1">
                  <a:off x="7333340" y="3932838"/>
                  <a:ext cx="723877" cy="258896"/>
                </a:xfrm>
                <a:custGeom>
                  <a:avLst/>
                  <a:gdLst>
                    <a:gd name="connsiteX0" fmla="*/ 0 w 1483358"/>
                    <a:gd name="connsiteY0" fmla="*/ 0 h 1309810"/>
                    <a:gd name="connsiteX1" fmla="*/ 654905 w 1483358"/>
                    <a:gd name="connsiteY1" fmla="*/ 0 h 1309810"/>
                    <a:gd name="connsiteX2" fmla="*/ 654905 w 1483358"/>
                    <a:gd name="connsiteY2" fmla="*/ 654905 h 1309810"/>
                    <a:gd name="connsiteX3" fmla="*/ 1483358 w 1483358"/>
                    <a:gd name="connsiteY3" fmla="*/ 65490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654905 w 1483358"/>
                    <a:gd name="connsiteY1" fmla="*/ 0 h 1309810"/>
                    <a:gd name="connsiteX2" fmla="*/ 604105 w 1483358"/>
                    <a:gd name="connsiteY2" fmla="*/ 949545 h 1309810"/>
                    <a:gd name="connsiteX3" fmla="*/ 1483358 w 1483358"/>
                    <a:gd name="connsiteY3" fmla="*/ 65490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654905 w 1483358"/>
                    <a:gd name="connsiteY1" fmla="*/ 0 h 1309810"/>
                    <a:gd name="connsiteX2" fmla="*/ 604105 w 1483358"/>
                    <a:gd name="connsiteY2" fmla="*/ 949545 h 1309810"/>
                    <a:gd name="connsiteX3" fmla="*/ 1483358 w 1483358"/>
                    <a:gd name="connsiteY3" fmla="*/ 100034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654905 w 1483358"/>
                    <a:gd name="connsiteY1" fmla="*/ 0 h 1309810"/>
                    <a:gd name="connsiteX2" fmla="*/ 604105 w 1483358"/>
                    <a:gd name="connsiteY2" fmla="*/ 990185 h 1309810"/>
                    <a:gd name="connsiteX3" fmla="*/ 1483358 w 1483358"/>
                    <a:gd name="connsiteY3" fmla="*/ 100034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654905 w 1483358"/>
                    <a:gd name="connsiteY1" fmla="*/ 0 h 1309810"/>
                    <a:gd name="connsiteX2" fmla="*/ 593945 w 1483358"/>
                    <a:gd name="connsiteY2" fmla="*/ 1010505 h 1309810"/>
                    <a:gd name="connsiteX3" fmla="*/ 1483358 w 1483358"/>
                    <a:gd name="connsiteY3" fmla="*/ 100034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654905 w 1483358"/>
                    <a:gd name="connsiteY1" fmla="*/ 0 h 1309810"/>
                    <a:gd name="connsiteX2" fmla="*/ 593945 w 1483358"/>
                    <a:gd name="connsiteY2" fmla="*/ 1010505 h 1309810"/>
                    <a:gd name="connsiteX3" fmla="*/ 1483358 w 1483358"/>
                    <a:gd name="connsiteY3" fmla="*/ 100034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593945 w 1483358"/>
                    <a:gd name="connsiteY2" fmla="*/ 1010505 h 1309810"/>
                    <a:gd name="connsiteX3" fmla="*/ 1483358 w 1483358"/>
                    <a:gd name="connsiteY3" fmla="*/ 100034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1483358 w 1483358"/>
                    <a:gd name="connsiteY3" fmla="*/ 1000345 h 1309810"/>
                    <a:gd name="connsiteX4" fmla="*/ 1483358 w 1483358"/>
                    <a:gd name="connsiteY4" fmla="*/ 1309810 h 1309810"/>
                    <a:gd name="connsiteX5" fmla="*/ 0 w 1483358"/>
                    <a:gd name="connsiteY5" fmla="*/ 1309810 h 1309810"/>
                    <a:gd name="connsiteX6" fmla="*/ 0 w 1483358"/>
                    <a:gd name="connsiteY6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94078 w 1483358"/>
                    <a:gd name="connsiteY3" fmla="*/ 944880 h 1309810"/>
                    <a:gd name="connsiteX4" fmla="*/ 1483358 w 1483358"/>
                    <a:gd name="connsiteY4" fmla="*/ 100034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83918 w 1483358"/>
                    <a:gd name="connsiteY3" fmla="*/ 1046480 h 1309810"/>
                    <a:gd name="connsiteX4" fmla="*/ 1483358 w 1483358"/>
                    <a:gd name="connsiteY4" fmla="*/ 100034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83918 w 1483358"/>
                    <a:gd name="connsiteY3" fmla="*/ 1046480 h 1309810"/>
                    <a:gd name="connsiteX4" fmla="*/ 1483358 w 1483358"/>
                    <a:gd name="connsiteY4" fmla="*/ 106130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73758 w 1483358"/>
                    <a:gd name="connsiteY3" fmla="*/ 1056640 h 1309810"/>
                    <a:gd name="connsiteX4" fmla="*/ 1483358 w 1483358"/>
                    <a:gd name="connsiteY4" fmla="*/ 106130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73758 w 1483358"/>
                    <a:gd name="connsiteY3" fmla="*/ 1056640 h 1309810"/>
                    <a:gd name="connsiteX4" fmla="*/ 1483358 w 1483358"/>
                    <a:gd name="connsiteY4" fmla="*/ 106130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73758 w 1483358"/>
                    <a:gd name="connsiteY3" fmla="*/ 1117600 h 1309810"/>
                    <a:gd name="connsiteX4" fmla="*/ 1483358 w 1483358"/>
                    <a:gd name="connsiteY4" fmla="*/ 106130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73758 w 1483358"/>
                    <a:gd name="connsiteY3" fmla="*/ 1117600 h 1309810"/>
                    <a:gd name="connsiteX4" fmla="*/ 1483358 w 1483358"/>
                    <a:gd name="connsiteY4" fmla="*/ 106130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400905 w 1483358"/>
                    <a:gd name="connsiteY2" fmla="*/ 98002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258665 w 1483358"/>
                    <a:gd name="connsiteY2" fmla="*/ 100034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411065 w 1483358"/>
                    <a:gd name="connsiteY1" fmla="*/ 30480 h 1309810"/>
                    <a:gd name="connsiteX2" fmla="*/ 258665 w 1483358"/>
                    <a:gd name="connsiteY2" fmla="*/ 100034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58665 w 1483358"/>
                    <a:gd name="connsiteY1" fmla="*/ 91440 h 1309810"/>
                    <a:gd name="connsiteX2" fmla="*/ 258665 w 1483358"/>
                    <a:gd name="connsiteY2" fmla="*/ 100034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58665 w 1483358"/>
                    <a:gd name="connsiteY1" fmla="*/ 101600 h 1309810"/>
                    <a:gd name="connsiteX2" fmla="*/ 258665 w 1483358"/>
                    <a:gd name="connsiteY2" fmla="*/ 100034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58665 w 1483358"/>
                    <a:gd name="connsiteY1" fmla="*/ 101600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58665 w 1483358"/>
                    <a:gd name="connsiteY1" fmla="*/ 101600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5860 h 1315670"/>
                    <a:gd name="connsiteX1" fmla="*/ 232200 w 1483358"/>
                    <a:gd name="connsiteY1" fmla="*/ 0 h 1315670"/>
                    <a:gd name="connsiteX2" fmla="*/ 248505 w 1483358"/>
                    <a:gd name="connsiteY2" fmla="*/ 1026525 h 1315670"/>
                    <a:gd name="connsiteX3" fmla="*/ 873758 w 1483358"/>
                    <a:gd name="connsiteY3" fmla="*/ 1123460 h 1315670"/>
                    <a:gd name="connsiteX4" fmla="*/ 1473198 w 1483358"/>
                    <a:gd name="connsiteY4" fmla="*/ 1128125 h 1315670"/>
                    <a:gd name="connsiteX5" fmla="*/ 1483358 w 1483358"/>
                    <a:gd name="connsiteY5" fmla="*/ 1315670 h 1315670"/>
                    <a:gd name="connsiteX6" fmla="*/ 0 w 1483358"/>
                    <a:gd name="connsiteY6" fmla="*/ 1315670 h 1315670"/>
                    <a:gd name="connsiteX7" fmla="*/ 0 w 1483358"/>
                    <a:gd name="connsiteY7" fmla="*/ 5860 h 1315670"/>
                    <a:gd name="connsiteX0" fmla="*/ 0 w 1483358"/>
                    <a:gd name="connsiteY0" fmla="*/ 0 h 1309810"/>
                    <a:gd name="connsiteX1" fmla="*/ 205734 w 1483358"/>
                    <a:gd name="connsiteY1" fmla="*/ 24843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05734 w 1483358"/>
                    <a:gd name="connsiteY1" fmla="*/ 24843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05734 w 1483358"/>
                    <a:gd name="connsiteY1" fmla="*/ 24843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05734 w 1483358"/>
                    <a:gd name="connsiteY1" fmla="*/ 40195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205734 w 1483358"/>
                    <a:gd name="connsiteY1" fmla="*/ 40195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0 w 1483358"/>
                    <a:gd name="connsiteY0" fmla="*/ 0 h 1309810"/>
                    <a:gd name="connsiteX1" fmla="*/ 179269 w 1483358"/>
                    <a:gd name="connsiteY1" fmla="*/ 40195 h 1309810"/>
                    <a:gd name="connsiteX2" fmla="*/ 248505 w 1483358"/>
                    <a:gd name="connsiteY2" fmla="*/ 1020665 h 1309810"/>
                    <a:gd name="connsiteX3" fmla="*/ 873758 w 1483358"/>
                    <a:gd name="connsiteY3" fmla="*/ 1117600 h 1309810"/>
                    <a:gd name="connsiteX4" fmla="*/ 1473198 w 1483358"/>
                    <a:gd name="connsiteY4" fmla="*/ 1122265 h 1309810"/>
                    <a:gd name="connsiteX5" fmla="*/ 1483358 w 1483358"/>
                    <a:gd name="connsiteY5" fmla="*/ 1309810 h 1309810"/>
                    <a:gd name="connsiteX6" fmla="*/ 0 w 1483358"/>
                    <a:gd name="connsiteY6" fmla="*/ 1309810 h 1309810"/>
                    <a:gd name="connsiteX7" fmla="*/ 0 w 1483358"/>
                    <a:gd name="connsiteY7" fmla="*/ 0 h 1309810"/>
                    <a:gd name="connsiteX0" fmla="*/ 198489 w 1483358"/>
                    <a:gd name="connsiteY0" fmla="*/ 0 h 1325161"/>
                    <a:gd name="connsiteX1" fmla="*/ 179269 w 1483358"/>
                    <a:gd name="connsiteY1" fmla="*/ 55546 h 1325161"/>
                    <a:gd name="connsiteX2" fmla="*/ 248505 w 1483358"/>
                    <a:gd name="connsiteY2" fmla="*/ 1036016 h 1325161"/>
                    <a:gd name="connsiteX3" fmla="*/ 873758 w 1483358"/>
                    <a:gd name="connsiteY3" fmla="*/ 1132951 h 1325161"/>
                    <a:gd name="connsiteX4" fmla="*/ 1473198 w 1483358"/>
                    <a:gd name="connsiteY4" fmla="*/ 1137616 h 1325161"/>
                    <a:gd name="connsiteX5" fmla="*/ 1483358 w 1483358"/>
                    <a:gd name="connsiteY5" fmla="*/ 1325161 h 1325161"/>
                    <a:gd name="connsiteX6" fmla="*/ 0 w 1483358"/>
                    <a:gd name="connsiteY6" fmla="*/ 1325161 h 1325161"/>
                    <a:gd name="connsiteX7" fmla="*/ 198489 w 1483358"/>
                    <a:gd name="connsiteY7" fmla="*/ 0 h 1325161"/>
                    <a:gd name="connsiteX0" fmla="*/ 0 w 1483358"/>
                    <a:gd name="connsiteY0" fmla="*/ 5860 h 1269615"/>
                    <a:gd name="connsiteX1" fmla="*/ 179269 w 1483358"/>
                    <a:gd name="connsiteY1" fmla="*/ 0 h 1269615"/>
                    <a:gd name="connsiteX2" fmla="*/ 248505 w 1483358"/>
                    <a:gd name="connsiteY2" fmla="*/ 980470 h 1269615"/>
                    <a:gd name="connsiteX3" fmla="*/ 873758 w 1483358"/>
                    <a:gd name="connsiteY3" fmla="*/ 1077405 h 1269615"/>
                    <a:gd name="connsiteX4" fmla="*/ 1473198 w 1483358"/>
                    <a:gd name="connsiteY4" fmla="*/ 1082070 h 1269615"/>
                    <a:gd name="connsiteX5" fmla="*/ 1483358 w 1483358"/>
                    <a:gd name="connsiteY5" fmla="*/ 1269615 h 1269615"/>
                    <a:gd name="connsiteX6" fmla="*/ 0 w 1483358"/>
                    <a:gd name="connsiteY6" fmla="*/ 1269615 h 1269615"/>
                    <a:gd name="connsiteX7" fmla="*/ 0 w 1483358"/>
                    <a:gd name="connsiteY7" fmla="*/ 5860 h 1269615"/>
                    <a:gd name="connsiteX0" fmla="*/ 0 w 1483358"/>
                    <a:gd name="connsiteY0" fmla="*/ 21211 h 1284966"/>
                    <a:gd name="connsiteX1" fmla="*/ 232200 w 1483358"/>
                    <a:gd name="connsiteY1" fmla="*/ 0 h 1284966"/>
                    <a:gd name="connsiteX2" fmla="*/ 248505 w 1483358"/>
                    <a:gd name="connsiteY2" fmla="*/ 995821 h 1284966"/>
                    <a:gd name="connsiteX3" fmla="*/ 873758 w 1483358"/>
                    <a:gd name="connsiteY3" fmla="*/ 1092756 h 1284966"/>
                    <a:gd name="connsiteX4" fmla="*/ 1473198 w 1483358"/>
                    <a:gd name="connsiteY4" fmla="*/ 1097421 h 1284966"/>
                    <a:gd name="connsiteX5" fmla="*/ 1483358 w 1483358"/>
                    <a:gd name="connsiteY5" fmla="*/ 1284966 h 1284966"/>
                    <a:gd name="connsiteX6" fmla="*/ 0 w 1483358"/>
                    <a:gd name="connsiteY6" fmla="*/ 1284966 h 1284966"/>
                    <a:gd name="connsiteX7" fmla="*/ 0 w 1483358"/>
                    <a:gd name="connsiteY7" fmla="*/ 21211 h 1284966"/>
                    <a:gd name="connsiteX0" fmla="*/ 0 w 1483358"/>
                    <a:gd name="connsiteY0" fmla="*/ 21211 h 1284966"/>
                    <a:gd name="connsiteX1" fmla="*/ 232200 w 1483358"/>
                    <a:gd name="connsiteY1" fmla="*/ 0 h 1284966"/>
                    <a:gd name="connsiteX2" fmla="*/ 248505 w 1483358"/>
                    <a:gd name="connsiteY2" fmla="*/ 995821 h 1284966"/>
                    <a:gd name="connsiteX3" fmla="*/ 873758 w 1483358"/>
                    <a:gd name="connsiteY3" fmla="*/ 1092756 h 1284966"/>
                    <a:gd name="connsiteX4" fmla="*/ 1473198 w 1483358"/>
                    <a:gd name="connsiteY4" fmla="*/ 1097421 h 1284966"/>
                    <a:gd name="connsiteX5" fmla="*/ 1483358 w 1483358"/>
                    <a:gd name="connsiteY5" fmla="*/ 1284966 h 1284966"/>
                    <a:gd name="connsiteX6" fmla="*/ 0 w 1483358"/>
                    <a:gd name="connsiteY6" fmla="*/ 1284966 h 1284966"/>
                    <a:gd name="connsiteX7" fmla="*/ 0 w 1483358"/>
                    <a:gd name="connsiteY7" fmla="*/ 21211 h 1284966"/>
                    <a:gd name="connsiteX0" fmla="*/ 0 w 1483358"/>
                    <a:gd name="connsiteY0" fmla="*/ 21211 h 1284966"/>
                    <a:gd name="connsiteX1" fmla="*/ 232200 w 1483358"/>
                    <a:gd name="connsiteY1" fmla="*/ 0 h 1284966"/>
                    <a:gd name="connsiteX2" fmla="*/ 248505 w 1483358"/>
                    <a:gd name="connsiteY2" fmla="*/ 995821 h 1284966"/>
                    <a:gd name="connsiteX3" fmla="*/ 873758 w 1483358"/>
                    <a:gd name="connsiteY3" fmla="*/ 1092756 h 1284966"/>
                    <a:gd name="connsiteX4" fmla="*/ 1473198 w 1483358"/>
                    <a:gd name="connsiteY4" fmla="*/ 1097421 h 1284966"/>
                    <a:gd name="connsiteX5" fmla="*/ 1483358 w 1483358"/>
                    <a:gd name="connsiteY5" fmla="*/ 1284966 h 1284966"/>
                    <a:gd name="connsiteX6" fmla="*/ 0 w 1483358"/>
                    <a:gd name="connsiteY6" fmla="*/ 1284966 h 1284966"/>
                    <a:gd name="connsiteX7" fmla="*/ 0 w 1483358"/>
                    <a:gd name="connsiteY7" fmla="*/ 21211 h 1284966"/>
                    <a:gd name="connsiteX0" fmla="*/ 13233 w 1483358"/>
                    <a:gd name="connsiteY0" fmla="*/ 0 h 1309809"/>
                    <a:gd name="connsiteX1" fmla="*/ 232200 w 1483358"/>
                    <a:gd name="connsiteY1" fmla="*/ 24843 h 1309809"/>
                    <a:gd name="connsiteX2" fmla="*/ 248505 w 1483358"/>
                    <a:gd name="connsiteY2" fmla="*/ 1020664 h 1309809"/>
                    <a:gd name="connsiteX3" fmla="*/ 873758 w 1483358"/>
                    <a:gd name="connsiteY3" fmla="*/ 1117599 h 1309809"/>
                    <a:gd name="connsiteX4" fmla="*/ 1473198 w 1483358"/>
                    <a:gd name="connsiteY4" fmla="*/ 1122264 h 1309809"/>
                    <a:gd name="connsiteX5" fmla="*/ 1483358 w 1483358"/>
                    <a:gd name="connsiteY5" fmla="*/ 1309809 h 1309809"/>
                    <a:gd name="connsiteX6" fmla="*/ 0 w 1483358"/>
                    <a:gd name="connsiteY6" fmla="*/ 1309809 h 1309809"/>
                    <a:gd name="connsiteX7" fmla="*/ 13233 w 1483358"/>
                    <a:gd name="connsiteY7" fmla="*/ 0 h 1309809"/>
                    <a:gd name="connsiteX0" fmla="*/ 13233 w 1483358"/>
                    <a:gd name="connsiteY0" fmla="*/ 0 h 1309809"/>
                    <a:gd name="connsiteX1" fmla="*/ 232200 w 1483358"/>
                    <a:gd name="connsiteY1" fmla="*/ 9492 h 1309809"/>
                    <a:gd name="connsiteX2" fmla="*/ 248505 w 1483358"/>
                    <a:gd name="connsiteY2" fmla="*/ 1020664 h 1309809"/>
                    <a:gd name="connsiteX3" fmla="*/ 873758 w 1483358"/>
                    <a:gd name="connsiteY3" fmla="*/ 1117599 h 1309809"/>
                    <a:gd name="connsiteX4" fmla="*/ 1473198 w 1483358"/>
                    <a:gd name="connsiteY4" fmla="*/ 1122264 h 1309809"/>
                    <a:gd name="connsiteX5" fmla="*/ 1483358 w 1483358"/>
                    <a:gd name="connsiteY5" fmla="*/ 1309809 h 1309809"/>
                    <a:gd name="connsiteX6" fmla="*/ 0 w 1483358"/>
                    <a:gd name="connsiteY6" fmla="*/ 1309809 h 1309809"/>
                    <a:gd name="connsiteX7" fmla="*/ 13233 w 1483358"/>
                    <a:gd name="connsiteY7" fmla="*/ 0 h 1309809"/>
                    <a:gd name="connsiteX0" fmla="*/ 13233 w 1483358"/>
                    <a:gd name="connsiteY0" fmla="*/ 0 h 1309809"/>
                    <a:gd name="connsiteX1" fmla="*/ 232200 w 1483358"/>
                    <a:gd name="connsiteY1" fmla="*/ 9492 h 1309809"/>
                    <a:gd name="connsiteX2" fmla="*/ 248505 w 1483358"/>
                    <a:gd name="connsiteY2" fmla="*/ 1020664 h 1309809"/>
                    <a:gd name="connsiteX3" fmla="*/ 873758 w 1483358"/>
                    <a:gd name="connsiteY3" fmla="*/ 1117599 h 1309809"/>
                    <a:gd name="connsiteX4" fmla="*/ 1473198 w 1483358"/>
                    <a:gd name="connsiteY4" fmla="*/ 1122264 h 1309809"/>
                    <a:gd name="connsiteX5" fmla="*/ 1483358 w 1483358"/>
                    <a:gd name="connsiteY5" fmla="*/ 1309809 h 1309809"/>
                    <a:gd name="connsiteX6" fmla="*/ 0 w 1483358"/>
                    <a:gd name="connsiteY6" fmla="*/ 1309809 h 1309809"/>
                    <a:gd name="connsiteX7" fmla="*/ 13233 w 1483358"/>
                    <a:gd name="connsiteY7" fmla="*/ 0 h 1309809"/>
                    <a:gd name="connsiteX0" fmla="*/ 13233 w 1483358"/>
                    <a:gd name="connsiteY0" fmla="*/ 0 h 1340512"/>
                    <a:gd name="connsiteX1" fmla="*/ 232200 w 1483358"/>
                    <a:gd name="connsiteY1" fmla="*/ 40195 h 1340512"/>
                    <a:gd name="connsiteX2" fmla="*/ 248505 w 1483358"/>
                    <a:gd name="connsiteY2" fmla="*/ 1051367 h 1340512"/>
                    <a:gd name="connsiteX3" fmla="*/ 873758 w 1483358"/>
                    <a:gd name="connsiteY3" fmla="*/ 1148302 h 1340512"/>
                    <a:gd name="connsiteX4" fmla="*/ 1473198 w 1483358"/>
                    <a:gd name="connsiteY4" fmla="*/ 1152967 h 1340512"/>
                    <a:gd name="connsiteX5" fmla="*/ 1483358 w 1483358"/>
                    <a:gd name="connsiteY5" fmla="*/ 1340512 h 1340512"/>
                    <a:gd name="connsiteX6" fmla="*/ 0 w 1483358"/>
                    <a:gd name="connsiteY6" fmla="*/ 1340512 h 1340512"/>
                    <a:gd name="connsiteX7" fmla="*/ 13233 w 1483358"/>
                    <a:gd name="connsiteY7" fmla="*/ 0 h 1340512"/>
                    <a:gd name="connsiteX0" fmla="*/ 13233 w 1483358"/>
                    <a:gd name="connsiteY0" fmla="*/ 36562 h 1300317"/>
                    <a:gd name="connsiteX1" fmla="*/ 232200 w 1483358"/>
                    <a:gd name="connsiteY1" fmla="*/ 0 h 1300317"/>
                    <a:gd name="connsiteX2" fmla="*/ 248505 w 1483358"/>
                    <a:gd name="connsiteY2" fmla="*/ 1011172 h 1300317"/>
                    <a:gd name="connsiteX3" fmla="*/ 873758 w 1483358"/>
                    <a:gd name="connsiteY3" fmla="*/ 1108107 h 1300317"/>
                    <a:gd name="connsiteX4" fmla="*/ 1473198 w 1483358"/>
                    <a:gd name="connsiteY4" fmla="*/ 1112772 h 1300317"/>
                    <a:gd name="connsiteX5" fmla="*/ 1483358 w 1483358"/>
                    <a:gd name="connsiteY5" fmla="*/ 1300317 h 1300317"/>
                    <a:gd name="connsiteX6" fmla="*/ 0 w 1483358"/>
                    <a:gd name="connsiteY6" fmla="*/ 1300317 h 1300317"/>
                    <a:gd name="connsiteX7" fmla="*/ 13233 w 1483358"/>
                    <a:gd name="connsiteY7" fmla="*/ 36562 h 1300317"/>
                    <a:gd name="connsiteX0" fmla="*/ 13233 w 1483358"/>
                    <a:gd name="connsiteY0" fmla="*/ 0 h 1309809"/>
                    <a:gd name="connsiteX1" fmla="*/ 232200 w 1483358"/>
                    <a:gd name="connsiteY1" fmla="*/ 9492 h 1309809"/>
                    <a:gd name="connsiteX2" fmla="*/ 248505 w 1483358"/>
                    <a:gd name="connsiteY2" fmla="*/ 1020664 h 1309809"/>
                    <a:gd name="connsiteX3" fmla="*/ 873758 w 1483358"/>
                    <a:gd name="connsiteY3" fmla="*/ 1117599 h 1309809"/>
                    <a:gd name="connsiteX4" fmla="*/ 1473198 w 1483358"/>
                    <a:gd name="connsiteY4" fmla="*/ 1122264 h 1309809"/>
                    <a:gd name="connsiteX5" fmla="*/ 1483358 w 1483358"/>
                    <a:gd name="connsiteY5" fmla="*/ 1309809 h 1309809"/>
                    <a:gd name="connsiteX6" fmla="*/ 0 w 1483358"/>
                    <a:gd name="connsiteY6" fmla="*/ 1309809 h 1309809"/>
                    <a:gd name="connsiteX7" fmla="*/ 13233 w 1483358"/>
                    <a:gd name="connsiteY7" fmla="*/ 0 h 130980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</a:cxnLst>
                  <a:rect l="l" t="t" r="r" b="b"/>
                  <a:pathLst>
                    <a:path w="1483358" h="1309809">
                      <a:moveTo>
                        <a:pt x="13233" y="0"/>
                      </a:moveTo>
                      <a:lnTo>
                        <a:pt x="232200" y="9492"/>
                      </a:lnTo>
                      <a:cubicBezTo>
                        <a:pt x="247562" y="470944"/>
                        <a:pt x="228185" y="707536"/>
                        <a:pt x="248505" y="1020664"/>
                      </a:cubicBezTo>
                      <a:cubicBezTo>
                        <a:pt x="247727" y="1112104"/>
                        <a:pt x="408869" y="1134532"/>
                        <a:pt x="873758" y="1117599"/>
                      </a:cubicBezTo>
                      <a:lnTo>
                        <a:pt x="1473198" y="1122264"/>
                      </a:lnTo>
                      <a:lnTo>
                        <a:pt x="1483358" y="1309809"/>
                      </a:lnTo>
                      <a:lnTo>
                        <a:pt x="0" y="1309809"/>
                      </a:lnTo>
                      <a:lnTo>
                        <a:pt x="13233" y="0"/>
                      </a:lnTo>
                      <a:close/>
                    </a:path>
                  </a:pathLst>
                </a:custGeom>
                <a:solidFill>
                  <a:srgbClr val="00B0F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" name="矩形: 圆角 18">
                  <a:extLst>
                    <a:ext uri="{FF2B5EF4-FFF2-40B4-BE49-F238E27FC236}">
                      <a16:creationId xmlns:a16="http://schemas.microsoft.com/office/drawing/2014/main" id="{236BDDB1-D10D-47FB-83B7-3F6EC1FC491E}"/>
                    </a:ext>
                  </a:extLst>
                </p:cNvPr>
                <p:cNvSpPr/>
                <p:nvPr/>
              </p:nvSpPr>
              <p:spPr>
                <a:xfrm>
                  <a:off x="7543067" y="3466927"/>
                  <a:ext cx="821919" cy="547415"/>
                </a:xfrm>
                <a:prstGeom prst="roundRect">
                  <a:avLst/>
                </a:prstGeom>
                <a:solidFill>
                  <a:srgbClr val="00B0F0"/>
                </a:solidFill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3" name="泪滴形 32">
              <a:extLst>
                <a:ext uri="{FF2B5EF4-FFF2-40B4-BE49-F238E27FC236}">
                  <a16:creationId xmlns:a16="http://schemas.microsoft.com/office/drawing/2014/main" id="{0917D53C-28A5-483F-85C4-3522FD6F50F0}"/>
                </a:ext>
              </a:extLst>
            </p:cNvPr>
            <p:cNvSpPr/>
            <p:nvPr/>
          </p:nvSpPr>
          <p:spPr>
            <a:xfrm rot="19222675">
              <a:off x="3478810" y="4952997"/>
              <a:ext cx="164225" cy="200042"/>
            </a:xfrm>
            <a:prstGeom prst="teardrop">
              <a:avLst>
                <a:gd name="adj" fmla="val 130457"/>
              </a:avLst>
            </a:prstGeom>
            <a:solidFill>
              <a:srgbClr val="C22014">
                <a:alpha val="67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泪滴形 33">
              <a:extLst>
                <a:ext uri="{FF2B5EF4-FFF2-40B4-BE49-F238E27FC236}">
                  <a16:creationId xmlns:a16="http://schemas.microsoft.com/office/drawing/2014/main" id="{CD837156-D3AE-4AA4-86A4-F102773DC406}"/>
                </a:ext>
              </a:extLst>
            </p:cNvPr>
            <p:cNvSpPr/>
            <p:nvPr/>
          </p:nvSpPr>
          <p:spPr>
            <a:xfrm rot="19222675">
              <a:off x="3729668" y="4950239"/>
              <a:ext cx="121320" cy="129021"/>
            </a:xfrm>
            <a:prstGeom prst="teardrop">
              <a:avLst>
                <a:gd name="adj" fmla="val 130457"/>
              </a:avLst>
            </a:prstGeom>
            <a:solidFill>
              <a:srgbClr val="C22014">
                <a:alpha val="67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L 形 34">
              <a:extLst>
                <a:ext uri="{FF2B5EF4-FFF2-40B4-BE49-F238E27FC236}">
                  <a16:creationId xmlns:a16="http://schemas.microsoft.com/office/drawing/2014/main" id="{5A5ACF0E-9F02-4845-AA6E-02BE13A97570}"/>
                </a:ext>
              </a:extLst>
            </p:cNvPr>
            <p:cNvSpPr/>
            <p:nvPr/>
          </p:nvSpPr>
          <p:spPr>
            <a:xfrm rot="16200000" flipH="1">
              <a:off x="5570809" y="2249071"/>
              <a:ext cx="117131" cy="1991216"/>
            </a:xfrm>
            <a:prstGeom prst="corner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L 形 35">
              <a:extLst>
                <a:ext uri="{FF2B5EF4-FFF2-40B4-BE49-F238E27FC236}">
                  <a16:creationId xmlns:a16="http://schemas.microsoft.com/office/drawing/2014/main" id="{F4E4CC07-FF86-4D96-B9A5-1B2CEB1BEBE8}"/>
                </a:ext>
              </a:extLst>
            </p:cNvPr>
            <p:cNvSpPr/>
            <p:nvPr/>
          </p:nvSpPr>
          <p:spPr>
            <a:xfrm rot="16200000">
              <a:off x="5572720" y="4494649"/>
              <a:ext cx="90493" cy="2014028"/>
            </a:xfrm>
            <a:prstGeom prst="corner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2C400298-88BF-4191-8D03-A53FEA27F598}"/>
                </a:ext>
              </a:extLst>
            </p:cNvPr>
            <p:cNvSpPr/>
            <p:nvPr/>
          </p:nvSpPr>
          <p:spPr>
            <a:xfrm flipH="1">
              <a:off x="6581505" y="3247116"/>
              <a:ext cx="45719" cy="2246032"/>
            </a:xfrm>
            <a:custGeom>
              <a:avLst/>
              <a:gdLst>
                <a:gd name="connsiteX0" fmla="*/ 0 w 45719"/>
                <a:gd name="connsiteY0" fmla="*/ 0 h 2221183"/>
                <a:gd name="connsiteX1" fmla="*/ 45719 w 45719"/>
                <a:gd name="connsiteY1" fmla="*/ 0 h 2221183"/>
                <a:gd name="connsiteX2" fmla="*/ 45719 w 45719"/>
                <a:gd name="connsiteY2" fmla="*/ 2221183 h 2221183"/>
                <a:gd name="connsiteX3" fmla="*/ 0 w 45719"/>
                <a:gd name="connsiteY3" fmla="*/ 2221183 h 2221183"/>
                <a:gd name="connsiteX4" fmla="*/ 0 w 45719"/>
                <a:gd name="connsiteY4" fmla="*/ 0 h 2221183"/>
                <a:gd name="connsiteX0" fmla="*/ 0 w 45719"/>
                <a:gd name="connsiteY0" fmla="*/ 0 h 2221183"/>
                <a:gd name="connsiteX1" fmla="*/ 45719 w 45719"/>
                <a:gd name="connsiteY1" fmla="*/ 0 h 2221183"/>
                <a:gd name="connsiteX2" fmla="*/ 45719 w 45719"/>
                <a:gd name="connsiteY2" fmla="*/ 2221183 h 2221183"/>
                <a:gd name="connsiteX3" fmla="*/ 22746 w 45719"/>
                <a:gd name="connsiteY3" fmla="*/ 2221183 h 2221183"/>
                <a:gd name="connsiteX4" fmla="*/ 0 w 45719"/>
                <a:gd name="connsiteY4" fmla="*/ 0 h 2221183"/>
                <a:gd name="connsiteX0" fmla="*/ 4549 w 22973"/>
                <a:gd name="connsiteY0" fmla="*/ 18197 h 2221183"/>
                <a:gd name="connsiteX1" fmla="*/ 22973 w 22973"/>
                <a:gd name="connsiteY1" fmla="*/ 0 h 2221183"/>
                <a:gd name="connsiteX2" fmla="*/ 22973 w 22973"/>
                <a:gd name="connsiteY2" fmla="*/ 2221183 h 2221183"/>
                <a:gd name="connsiteX3" fmla="*/ 0 w 22973"/>
                <a:gd name="connsiteY3" fmla="*/ 2221183 h 2221183"/>
                <a:gd name="connsiteX4" fmla="*/ 4549 w 22973"/>
                <a:gd name="connsiteY4" fmla="*/ 18197 h 222118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2973" h="2221183">
                  <a:moveTo>
                    <a:pt x="4549" y="18197"/>
                  </a:moveTo>
                  <a:lnTo>
                    <a:pt x="22973" y="0"/>
                  </a:lnTo>
                  <a:lnTo>
                    <a:pt x="22973" y="2221183"/>
                  </a:lnTo>
                  <a:lnTo>
                    <a:pt x="0" y="2221183"/>
                  </a:lnTo>
                  <a:cubicBezTo>
                    <a:pt x="1516" y="1486854"/>
                    <a:pt x="3033" y="752526"/>
                    <a:pt x="4549" y="18197"/>
                  </a:cubicBezTo>
                  <a:close/>
                </a:path>
              </a:pathLst>
            </a:cu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流程图: 汇总连接 36">
              <a:extLst>
                <a:ext uri="{FF2B5EF4-FFF2-40B4-BE49-F238E27FC236}">
                  <a16:creationId xmlns:a16="http://schemas.microsoft.com/office/drawing/2014/main" id="{4099F98B-CA65-416A-9C53-9457A142FF3E}"/>
                </a:ext>
              </a:extLst>
            </p:cNvPr>
            <p:cNvSpPr/>
            <p:nvPr/>
          </p:nvSpPr>
          <p:spPr>
            <a:xfrm>
              <a:off x="6296881" y="3850055"/>
              <a:ext cx="583839" cy="679667"/>
            </a:xfrm>
            <a:prstGeom prst="flowChartSummingJunction">
              <a:avLst/>
            </a:prstGeom>
            <a:solidFill>
              <a:srgbClr val="C0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箭头连接符 41">
              <a:extLst>
                <a:ext uri="{FF2B5EF4-FFF2-40B4-BE49-F238E27FC236}">
                  <a16:creationId xmlns:a16="http://schemas.microsoft.com/office/drawing/2014/main" id="{E35AB953-ACCB-4C42-8749-A6D5ABFD9852}"/>
                </a:ext>
              </a:extLst>
            </p:cNvPr>
            <p:cNvCxnSpPr>
              <a:cxnSpLocks/>
            </p:cNvCxnSpPr>
            <p:nvPr/>
          </p:nvCxnSpPr>
          <p:spPr>
            <a:xfrm>
              <a:off x="5657759" y="5329989"/>
              <a:ext cx="453021" cy="0"/>
            </a:xfrm>
            <a:prstGeom prst="straightConnector1">
              <a:avLst/>
            </a:prstGeom>
            <a:ln w="190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9BF67B62-B638-4580-B8AC-C136022ACD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74201" y="3322551"/>
              <a:ext cx="381173" cy="0"/>
            </a:xfrm>
            <a:prstGeom prst="straightConnector1">
              <a:avLst/>
            </a:prstGeom>
            <a:ln w="190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箭头连接符 45">
              <a:extLst>
                <a:ext uri="{FF2B5EF4-FFF2-40B4-BE49-F238E27FC236}">
                  <a16:creationId xmlns:a16="http://schemas.microsoft.com/office/drawing/2014/main" id="{F7ABE4C6-3A59-46E9-B9C5-38DE1FA9934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74201" y="2936045"/>
              <a:ext cx="369141" cy="0"/>
            </a:xfrm>
            <a:prstGeom prst="straightConnector1">
              <a:avLst/>
            </a:prstGeom>
            <a:ln w="190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FF1519E5-E076-4EC0-B731-FF04C92214E5}"/>
                </a:ext>
              </a:extLst>
            </p:cNvPr>
            <p:cNvSpPr txBox="1"/>
            <p:nvPr/>
          </p:nvSpPr>
          <p:spPr>
            <a:xfrm>
              <a:off x="6335791" y="2334081"/>
              <a:ext cx="6599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MV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3FC0D97E-EEE0-4A5A-AB8B-9E325A375E75}"/>
                </a:ext>
              </a:extLst>
            </p:cNvPr>
            <p:cNvSpPr txBox="1"/>
            <p:nvPr/>
          </p:nvSpPr>
          <p:spPr>
            <a:xfrm>
              <a:off x="7153776" y="2070022"/>
              <a:ext cx="2966532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Volume Control </a:t>
              </a: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Mechanical Ventilation (MV):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767D0C5C-BAD6-4FB2-A02A-8DE597652674}"/>
                </a:ext>
              </a:extLst>
            </p:cNvPr>
            <p:cNvSpPr txBox="1"/>
            <p:nvPr/>
          </p:nvSpPr>
          <p:spPr>
            <a:xfrm>
              <a:off x="6601916" y="3618601"/>
              <a:ext cx="20624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eristaltic Pump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90683A9E-286B-4DCB-871C-6919B47C8BCD}"/>
                </a:ext>
              </a:extLst>
            </p:cNvPr>
            <p:cNvSpPr txBox="1"/>
            <p:nvPr/>
          </p:nvSpPr>
          <p:spPr>
            <a:xfrm>
              <a:off x="2261848" y="5816679"/>
              <a:ext cx="31039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erfusate Reservoir (1350 ml)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11DBDA87-61C4-4796-9D21-3FB34E8E80BD}"/>
                </a:ext>
              </a:extLst>
            </p:cNvPr>
            <p:cNvSpPr txBox="1"/>
            <p:nvPr/>
          </p:nvSpPr>
          <p:spPr>
            <a:xfrm>
              <a:off x="7842688" y="5739699"/>
              <a:ext cx="248398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r>
                <a:rPr lang="zh-CN" altLang="en-US" sz="1600" b="1">
                  <a:latin typeface="Arial" panose="020B0604020202020204" pitchFamily="34" charset="0"/>
                  <a:cs typeface="Arial" panose="020B0604020202020204" pitchFamily="34" charset="0"/>
                </a:rPr>
                <a:t>℃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Water Bath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任意多边形: 形状 52">
              <a:extLst>
                <a:ext uri="{FF2B5EF4-FFF2-40B4-BE49-F238E27FC236}">
                  <a16:creationId xmlns:a16="http://schemas.microsoft.com/office/drawing/2014/main" id="{7D6D4879-57A4-44F8-939A-A336E4D0A069}"/>
                </a:ext>
              </a:extLst>
            </p:cNvPr>
            <p:cNvSpPr/>
            <p:nvPr/>
          </p:nvSpPr>
          <p:spPr>
            <a:xfrm>
              <a:off x="3857171" y="1870490"/>
              <a:ext cx="1981575" cy="2156719"/>
            </a:xfrm>
            <a:custGeom>
              <a:avLst/>
              <a:gdLst>
                <a:gd name="connsiteX0" fmla="*/ 0 w 1374739"/>
                <a:gd name="connsiteY0" fmla="*/ 1086255 h 1086255"/>
                <a:gd name="connsiteX1" fmla="*/ 87549 w 1374739"/>
                <a:gd name="connsiteY1" fmla="*/ 920885 h 1086255"/>
                <a:gd name="connsiteX2" fmla="*/ 165370 w 1374739"/>
                <a:gd name="connsiteY2" fmla="*/ 768485 h 1086255"/>
                <a:gd name="connsiteX3" fmla="*/ 256161 w 1374739"/>
                <a:gd name="connsiteY3" fmla="*/ 612842 h 1086255"/>
                <a:gd name="connsiteX4" fmla="*/ 321013 w 1374739"/>
                <a:gd name="connsiteY4" fmla="*/ 466927 h 1086255"/>
                <a:gd name="connsiteX5" fmla="*/ 324255 w 1374739"/>
                <a:gd name="connsiteY5" fmla="*/ 447472 h 1086255"/>
                <a:gd name="connsiteX6" fmla="*/ 437744 w 1374739"/>
                <a:gd name="connsiteY6" fmla="*/ 450715 h 1086255"/>
                <a:gd name="connsiteX7" fmla="*/ 680936 w 1374739"/>
                <a:gd name="connsiteY7" fmla="*/ 444229 h 1086255"/>
                <a:gd name="connsiteX8" fmla="*/ 1206230 w 1374739"/>
                <a:gd name="connsiteY8" fmla="*/ 440987 h 1086255"/>
                <a:gd name="connsiteX9" fmla="*/ 1355387 w 1374739"/>
                <a:gd name="connsiteY9" fmla="*/ 165370 h 1086255"/>
                <a:gd name="connsiteX10" fmla="*/ 1368357 w 1374739"/>
                <a:gd name="connsiteY10" fmla="*/ 0 h 1086255"/>
                <a:gd name="connsiteX0" fmla="*/ 0 w 1374739"/>
                <a:gd name="connsiteY0" fmla="*/ 1086255 h 1086255"/>
                <a:gd name="connsiteX1" fmla="*/ 87549 w 1374739"/>
                <a:gd name="connsiteY1" fmla="*/ 920885 h 1086255"/>
                <a:gd name="connsiteX2" fmla="*/ 165370 w 1374739"/>
                <a:gd name="connsiteY2" fmla="*/ 768485 h 1086255"/>
                <a:gd name="connsiteX3" fmla="*/ 256161 w 1374739"/>
                <a:gd name="connsiteY3" fmla="*/ 612842 h 1086255"/>
                <a:gd name="connsiteX4" fmla="*/ 321013 w 1374739"/>
                <a:gd name="connsiteY4" fmla="*/ 466927 h 1086255"/>
                <a:gd name="connsiteX5" fmla="*/ 353424 w 1374739"/>
                <a:gd name="connsiteY5" fmla="*/ 457058 h 1086255"/>
                <a:gd name="connsiteX6" fmla="*/ 437744 w 1374739"/>
                <a:gd name="connsiteY6" fmla="*/ 450715 h 1086255"/>
                <a:gd name="connsiteX7" fmla="*/ 680936 w 1374739"/>
                <a:gd name="connsiteY7" fmla="*/ 444229 h 1086255"/>
                <a:gd name="connsiteX8" fmla="*/ 1206230 w 1374739"/>
                <a:gd name="connsiteY8" fmla="*/ 440987 h 1086255"/>
                <a:gd name="connsiteX9" fmla="*/ 1355387 w 1374739"/>
                <a:gd name="connsiteY9" fmla="*/ 165370 h 1086255"/>
                <a:gd name="connsiteX10" fmla="*/ 1368357 w 1374739"/>
                <a:gd name="connsiteY10" fmla="*/ 0 h 1086255"/>
                <a:gd name="connsiteX0" fmla="*/ 0 w 1395761"/>
                <a:gd name="connsiteY0" fmla="*/ 1076669 h 1076669"/>
                <a:gd name="connsiteX1" fmla="*/ 87549 w 1395761"/>
                <a:gd name="connsiteY1" fmla="*/ 911299 h 1076669"/>
                <a:gd name="connsiteX2" fmla="*/ 165370 w 1395761"/>
                <a:gd name="connsiteY2" fmla="*/ 758899 h 1076669"/>
                <a:gd name="connsiteX3" fmla="*/ 256161 w 1395761"/>
                <a:gd name="connsiteY3" fmla="*/ 603256 h 1076669"/>
                <a:gd name="connsiteX4" fmla="*/ 321013 w 1395761"/>
                <a:gd name="connsiteY4" fmla="*/ 457341 h 1076669"/>
                <a:gd name="connsiteX5" fmla="*/ 353424 w 1395761"/>
                <a:gd name="connsiteY5" fmla="*/ 447472 h 1076669"/>
                <a:gd name="connsiteX6" fmla="*/ 437744 w 1395761"/>
                <a:gd name="connsiteY6" fmla="*/ 441129 h 1076669"/>
                <a:gd name="connsiteX7" fmla="*/ 680936 w 1395761"/>
                <a:gd name="connsiteY7" fmla="*/ 434643 h 1076669"/>
                <a:gd name="connsiteX8" fmla="*/ 1206230 w 1395761"/>
                <a:gd name="connsiteY8" fmla="*/ 431401 h 1076669"/>
                <a:gd name="connsiteX9" fmla="*/ 1355387 w 1395761"/>
                <a:gd name="connsiteY9" fmla="*/ 155784 h 1076669"/>
                <a:gd name="connsiteX10" fmla="*/ 1394286 w 1395761"/>
                <a:gd name="connsiteY10" fmla="*/ 0 h 1076669"/>
                <a:gd name="connsiteX0" fmla="*/ 0 w 1394286"/>
                <a:gd name="connsiteY0" fmla="*/ 1076669 h 1076669"/>
                <a:gd name="connsiteX1" fmla="*/ 87549 w 1394286"/>
                <a:gd name="connsiteY1" fmla="*/ 911299 h 1076669"/>
                <a:gd name="connsiteX2" fmla="*/ 165370 w 1394286"/>
                <a:gd name="connsiteY2" fmla="*/ 758899 h 1076669"/>
                <a:gd name="connsiteX3" fmla="*/ 256161 w 1394286"/>
                <a:gd name="connsiteY3" fmla="*/ 603256 h 1076669"/>
                <a:gd name="connsiteX4" fmla="*/ 321013 w 1394286"/>
                <a:gd name="connsiteY4" fmla="*/ 457341 h 1076669"/>
                <a:gd name="connsiteX5" fmla="*/ 353424 w 1394286"/>
                <a:gd name="connsiteY5" fmla="*/ 447472 h 1076669"/>
                <a:gd name="connsiteX6" fmla="*/ 437744 w 1394286"/>
                <a:gd name="connsiteY6" fmla="*/ 441129 h 1076669"/>
                <a:gd name="connsiteX7" fmla="*/ 680936 w 1394286"/>
                <a:gd name="connsiteY7" fmla="*/ 434643 h 1076669"/>
                <a:gd name="connsiteX8" fmla="*/ 1206230 w 1394286"/>
                <a:gd name="connsiteY8" fmla="*/ 431401 h 1076669"/>
                <a:gd name="connsiteX9" fmla="*/ 1355387 w 1394286"/>
                <a:gd name="connsiteY9" fmla="*/ 155784 h 1076669"/>
                <a:gd name="connsiteX10" fmla="*/ 1394286 w 1394286"/>
                <a:gd name="connsiteY10" fmla="*/ 0 h 1076669"/>
                <a:gd name="connsiteX0" fmla="*/ 0 w 1394286"/>
                <a:gd name="connsiteY0" fmla="*/ 1076669 h 1076669"/>
                <a:gd name="connsiteX1" fmla="*/ 87549 w 1394286"/>
                <a:gd name="connsiteY1" fmla="*/ 911299 h 1076669"/>
                <a:gd name="connsiteX2" fmla="*/ 165370 w 1394286"/>
                <a:gd name="connsiteY2" fmla="*/ 758899 h 1076669"/>
                <a:gd name="connsiteX3" fmla="*/ 256161 w 1394286"/>
                <a:gd name="connsiteY3" fmla="*/ 603256 h 1076669"/>
                <a:gd name="connsiteX4" fmla="*/ 321013 w 1394286"/>
                <a:gd name="connsiteY4" fmla="*/ 457341 h 1076669"/>
                <a:gd name="connsiteX5" fmla="*/ 353424 w 1394286"/>
                <a:gd name="connsiteY5" fmla="*/ 447472 h 1076669"/>
                <a:gd name="connsiteX6" fmla="*/ 437744 w 1394286"/>
                <a:gd name="connsiteY6" fmla="*/ 441129 h 1076669"/>
                <a:gd name="connsiteX7" fmla="*/ 680936 w 1394286"/>
                <a:gd name="connsiteY7" fmla="*/ 434643 h 1076669"/>
                <a:gd name="connsiteX8" fmla="*/ 1206230 w 1394286"/>
                <a:gd name="connsiteY8" fmla="*/ 431401 h 1076669"/>
                <a:gd name="connsiteX9" fmla="*/ 1361870 w 1394286"/>
                <a:gd name="connsiteY9" fmla="*/ 162175 h 1076669"/>
                <a:gd name="connsiteX10" fmla="*/ 1394286 w 1394286"/>
                <a:gd name="connsiteY10" fmla="*/ 0 h 1076669"/>
                <a:gd name="connsiteX0" fmla="*/ 0 w 1394286"/>
                <a:gd name="connsiteY0" fmla="*/ 1076669 h 1076669"/>
                <a:gd name="connsiteX1" fmla="*/ 87549 w 1394286"/>
                <a:gd name="connsiteY1" fmla="*/ 911299 h 1076669"/>
                <a:gd name="connsiteX2" fmla="*/ 165370 w 1394286"/>
                <a:gd name="connsiteY2" fmla="*/ 758899 h 1076669"/>
                <a:gd name="connsiteX3" fmla="*/ 256161 w 1394286"/>
                <a:gd name="connsiteY3" fmla="*/ 603256 h 1076669"/>
                <a:gd name="connsiteX4" fmla="*/ 321013 w 1394286"/>
                <a:gd name="connsiteY4" fmla="*/ 457341 h 1076669"/>
                <a:gd name="connsiteX5" fmla="*/ 353424 w 1394286"/>
                <a:gd name="connsiteY5" fmla="*/ 447472 h 1076669"/>
                <a:gd name="connsiteX6" fmla="*/ 437744 w 1394286"/>
                <a:gd name="connsiteY6" fmla="*/ 441129 h 1076669"/>
                <a:gd name="connsiteX7" fmla="*/ 680936 w 1394286"/>
                <a:gd name="connsiteY7" fmla="*/ 434643 h 1076669"/>
                <a:gd name="connsiteX8" fmla="*/ 1206230 w 1394286"/>
                <a:gd name="connsiteY8" fmla="*/ 431401 h 1076669"/>
                <a:gd name="connsiteX9" fmla="*/ 1361870 w 1394286"/>
                <a:gd name="connsiteY9" fmla="*/ 162175 h 1076669"/>
                <a:gd name="connsiteX10" fmla="*/ 1394286 w 1394286"/>
                <a:gd name="connsiteY10" fmla="*/ 0 h 1076669"/>
                <a:gd name="connsiteX0" fmla="*/ 0 w 1387804"/>
                <a:gd name="connsiteY0" fmla="*/ 1076669 h 1076669"/>
                <a:gd name="connsiteX1" fmla="*/ 87549 w 1387804"/>
                <a:gd name="connsiteY1" fmla="*/ 911299 h 1076669"/>
                <a:gd name="connsiteX2" fmla="*/ 165370 w 1387804"/>
                <a:gd name="connsiteY2" fmla="*/ 758899 h 1076669"/>
                <a:gd name="connsiteX3" fmla="*/ 256161 w 1387804"/>
                <a:gd name="connsiteY3" fmla="*/ 603256 h 1076669"/>
                <a:gd name="connsiteX4" fmla="*/ 321013 w 1387804"/>
                <a:gd name="connsiteY4" fmla="*/ 457341 h 1076669"/>
                <a:gd name="connsiteX5" fmla="*/ 353424 w 1387804"/>
                <a:gd name="connsiteY5" fmla="*/ 447472 h 1076669"/>
                <a:gd name="connsiteX6" fmla="*/ 437744 w 1387804"/>
                <a:gd name="connsiteY6" fmla="*/ 441129 h 1076669"/>
                <a:gd name="connsiteX7" fmla="*/ 680936 w 1387804"/>
                <a:gd name="connsiteY7" fmla="*/ 434643 h 1076669"/>
                <a:gd name="connsiteX8" fmla="*/ 1206230 w 1387804"/>
                <a:gd name="connsiteY8" fmla="*/ 431401 h 1076669"/>
                <a:gd name="connsiteX9" fmla="*/ 1361870 w 1387804"/>
                <a:gd name="connsiteY9" fmla="*/ 162175 h 1076669"/>
                <a:gd name="connsiteX10" fmla="*/ 1387804 w 1387804"/>
                <a:gd name="connsiteY10" fmla="*/ 0 h 1076669"/>
                <a:gd name="connsiteX0" fmla="*/ 0 w 1387804"/>
                <a:gd name="connsiteY0" fmla="*/ 1076669 h 1076669"/>
                <a:gd name="connsiteX1" fmla="*/ 87549 w 1387804"/>
                <a:gd name="connsiteY1" fmla="*/ 911299 h 1076669"/>
                <a:gd name="connsiteX2" fmla="*/ 165370 w 1387804"/>
                <a:gd name="connsiteY2" fmla="*/ 758899 h 1076669"/>
                <a:gd name="connsiteX3" fmla="*/ 256161 w 1387804"/>
                <a:gd name="connsiteY3" fmla="*/ 603256 h 1076669"/>
                <a:gd name="connsiteX4" fmla="*/ 321013 w 1387804"/>
                <a:gd name="connsiteY4" fmla="*/ 479708 h 1076669"/>
                <a:gd name="connsiteX5" fmla="*/ 353424 w 1387804"/>
                <a:gd name="connsiteY5" fmla="*/ 447472 h 1076669"/>
                <a:gd name="connsiteX6" fmla="*/ 437744 w 1387804"/>
                <a:gd name="connsiteY6" fmla="*/ 441129 h 1076669"/>
                <a:gd name="connsiteX7" fmla="*/ 680936 w 1387804"/>
                <a:gd name="connsiteY7" fmla="*/ 434643 h 1076669"/>
                <a:gd name="connsiteX8" fmla="*/ 1206230 w 1387804"/>
                <a:gd name="connsiteY8" fmla="*/ 431401 h 1076669"/>
                <a:gd name="connsiteX9" fmla="*/ 1361870 w 1387804"/>
                <a:gd name="connsiteY9" fmla="*/ 162175 h 1076669"/>
                <a:gd name="connsiteX10" fmla="*/ 1387804 w 1387804"/>
                <a:gd name="connsiteY10" fmla="*/ 0 h 1076669"/>
                <a:gd name="connsiteX0" fmla="*/ 0 w 1387804"/>
                <a:gd name="connsiteY0" fmla="*/ 1076669 h 1076669"/>
                <a:gd name="connsiteX1" fmla="*/ 87549 w 1387804"/>
                <a:gd name="connsiteY1" fmla="*/ 911299 h 1076669"/>
                <a:gd name="connsiteX2" fmla="*/ 165370 w 1387804"/>
                <a:gd name="connsiteY2" fmla="*/ 758899 h 1076669"/>
                <a:gd name="connsiteX3" fmla="*/ 256161 w 1387804"/>
                <a:gd name="connsiteY3" fmla="*/ 603256 h 1076669"/>
                <a:gd name="connsiteX4" fmla="*/ 321013 w 1387804"/>
                <a:gd name="connsiteY4" fmla="*/ 479708 h 1076669"/>
                <a:gd name="connsiteX5" fmla="*/ 366388 w 1387804"/>
                <a:gd name="connsiteY5" fmla="*/ 457058 h 1076669"/>
                <a:gd name="connsiteX6" fmla="*/ 437744 w 1387804"/>
                <a:gd name="connsiteY6" fmla="*/ 441129 h 1076669"/>
                <a:gd name="connsiteX7" fmla="*/ 680936 w 1387804"/>
                <a:gd name="connsiteY7" fmla="*/ 434643 h 1076669"/>
                <a:gd name="connsiteX8" fmla="*/ 1206230 w 1387804"/>
                <a:gd name="connsiteY8" fmla="*/ 431401 h 1076669"/>
                <a:gd name="connsiteX9" fmla="*/ 1361870 w 1387804"/>
                <a:gd name="connsiteY9" fmla="*/ 162175 h 1076669"/>
                <a:gd name="connsiteX10" fmla="*/ 1387804 w 1387804"/>
                <a:gd name="connsiteY10" fmla="*/ 0 h 1076669"/>
                <a:gd name="connsiteX0" fmla="*/ 0 w 1387804"/>
                <a:gd name="connsiteY0" fmla="*/ 1076669 h 1076669"/>
                <a:gd name="connsiteX1" fmla="*/ 87549 w 1387804"/>
                <a:gd name="connsiteY1" fmla="*/ 911299 h 1076669"/>
                <a:gd name="connsiteX2" fmla="*/ 165370 w 1387804"/>
                <a:gd name="connsiteY2" fmla="*/ 758899 h 1076669"/>
                <a:gd name="connsiteX3" fmla="*/ 256161 w 1387804"/>
                <a:gd name="connsiteY3" fmla="*/ 603256 h 1076669"/>
                <a:gd name="connsiteX4" fmla="*/ 321013 w 1387804"/>
                <a:gd name="connsiteY4" fmla="*/ 479708 h 1076669"/>
                <a:gd name="connsiteX5" fmla="*/ 364401 w 1387804"/>
                <a:gd name="connsiteY5" fmla="*/ 453141 h 1076669"/>
                <a:gd name="connsiteX6" fmla="*/ 437744 w 1387804"/>
                <a:gd name="connsiteY6" fmla="*/ 441129 h 1076669"/>
                <a:gd name="connsiteX7" fmla="*/ 680936 w 1387804"/>
                <a:gd name="connsiteY7" fmla="*/ 434643 h 1076669"/>
                <a:gd name="connsiteX8" fmla="*/ 1206230 w 1387804"/>
                <a:gd name="connsiteY8" fmla="*/ 431401 h 1076669"/>
                <a:gd name="connsiteX9" fmla="*/ 1361870 w 1387804"/>
                <a:gd name="connsiteY9" fmla="*/ 162175 h 1076669"/>
                <a:gd name="connsiteX10" fmla="*/ 1387804 w 1387804"/>
                <a:gd name="connsiteY10" fmla="*/ 0 h 1076669"/>
                <a:gd name="connsiteX0" fmla="*/ 0 w 1387804"/>
                <a:gd name="connsiteY0" fmla="*/ 1076669 h 1076669"/>
                <a:gd name="connsiteX1" fmla="*/ 87549 w 1387804"/>
                <a:gd name="connsiteY1" fmla="*/ 911299 h 1076669"/>
                <a:gd name="connsiteX2" fmla="*/ 165370 w 1387804"/>
                <a:gd name="connsiteY2" fmla="*/ 758899 h 1076669"/>
                <a:gd name="connsiteX3" fmla="*/ 256161 w 1387804"/>
                <a:gd name="connsiteY3" fmla="*/ 603256 h 1076669"/>
                <a:gd name="connsiteX4" fmla="*/ 321013 w 1387804"/>
                <a:gd name="connsiteY4" fmla="*/ 479708 h 1076669"/>
                <a:gd name="connsiteX5" fmla="*/ 364401 w 1387804"/>
                <a:gd name="connsiteY5" fmla="*/ 453141 h 1076669"/>
                <a:gd name="connsiteX6" fmla="*/ 437744 w 1387804"/>
                <a:gd name="connsiteY6" fmla="*/ 441129 h 1076669"/>
                <a:gd name="connsiteX7" fmla="*/ 680936 w 1387804"/>
                <a:gd name="connsiteY7" fmla="*/ 434643 h 1076669"/>
                <a:gd name="connsiteX8" fmla="*/ 1206230 w 1387804"/>
                <a:gd name="connsiteY8" fmla="*/ 431401 h 1076669"/>
                <a:gd name="connsiteX9" fmla="*/ 1361870 w 1387804"/>
                <a:gd name="connsiteY9" fmla="*/ 162175 h 1076669"/>
                <a:gd name="connsiteX10" fmla="*/ 1387804 w 1387804"/>
                <a:gd name="connsiteY10" fmla="*/ 0 h 1076669"/>
                <a:gd name="connsiteX0" fmla="*/ 0 w 1387804"/>
                <a:gd name="connsiteY0" fmla="*/ 1076669 h 1076669"/>
                <a:gd name="connsiteX1" fmla="*/ 87549 w 1387804"/>
                <a:gd name="connsiteY1" fmla="*/ 911299 h 1076669"/>
                <a:gd name="connsiteX2" fmla="*/ 165370 w 1387804"/>
                <a:gd name="connsiteY2" fmla="*/ 758899 h 1076669"/>
                <a:gd name="connsiteX3" fmla="*/ 256161 w 1387804"/>
                <a:gd name="connsiteY3" fmla="*/ 603256 h 1076669"/>
                <a:gd name="connsiteX4" fmla="*/ 321013 w 1387804"/>
                <a:gd name="connsiteY4" fmla="*/ 479708 h 1076669"/>
                <a:gd name="connsiteX5" fmla="*/ 364401 w 1387804"/>
                <a:gd name="connsiteY5" fmla="*/ 453141 h 1076669"/>
                <a:gd name="connsiteX6" fmla="*/ 437744 w 1387804"/>
                <a:gd name="connsiteY6" fmla="*/ 441129 h 1076669"/>
                <a:gd name="connsiteX7" fmla="*/ 680936 w 1387804"/>
                <a:gd name="connsiteY7" fmla="*/ 434643 h 1076669"/>
                <a:gd name="connsiteX8" fmla="*/ 1206230 w 1387804"/>
                <a:gd name="connsiteY8" fmla="*/ 431401 h 1076669"/>
                <a:gd name="connsiteX9" fmla="*/ 1361870 w 1387804"/>
                <a:gd name="connsiteY9" fmla="*/ 162175 h 1076669"/>
                <a:gd name="connsiteX10" fmla="*/ 1387804 w 1387804"/>
                <a:gd name="connsiteY10" fmla="*/ 0 h 1076669"/>
                <a:gd name="connsiteX0" fmla="*/ 0 w 1395752"/>
                <a:gd name="connsiteY0" fmla="*/ 1082545 h 1082545"/>
                <a:gd name="connsiteX1" fmla="*/ 95497 w 1395752"/>
                <a:gd name="connsiteY1" fmla="*/ 911299 h 1082545"/>
                <a:gd name="connsiteX2" fmla="*/ 173318 w 1395752"/>
                <a:gd name="connsiteY2" fmla="*/ 758899 h 1082545"/>
                <a:gd name="connsiteX3" fmla="*/ 264109 w 1395752"/>
                <a:gd name="connsiteY3" fmla="*/ 603256 h 1082545"/>
                <a:gd name="connsiteX4" fmla="*/ 328961 w 1395752"/>
                <a:gd name="connsiteY4" fmla="*/ 479708 h 1082545"/>
                <a:gd name="connsiteX5" fmla="*/ 372349 w 1395752"/>
                <a:gd name="connsiteY5" fmla="*/ 453141 h 1082545"/>
                <a:gd name="connsiteX6" fmla="*/ 445692 w 1395752"/>
                <a:gd name="connsiteY6" fmla="*/ 441129 h 1082545"/>
                <a:gd name="connsiteX7" fmla="*/ 688884 w 1395752"/>
                <a:gd name="connsiteY7" fmla="*/ 434643 h 1082545"/>
                <a:gd name="connsiteX8" fmla="*/ 1214178 w 1395752"/>
                <a:gd name="connsiteY8" fmla="*/ 431401 h 1082545"/>
                <a:gd name="connsiteX9" fmla="*/ 1369818 w 1395752"/>
                <a:gd name="connsiteY9" fmla="*/ 162175 h 1082545"/>
                <a:gd name="connsiteX10" fmla="*/ 1395752 w 1395752"/>
                <a:gd name="connsiteY10" fmla="*/ 0 h 1082545"/>
                <a:gd name="connsiteX0" fmla="*/ 0 w 1395752"/>
                <a:gd name="connsiteY0" fmla="*/ 1082545 h 1082545"/>
                <a:gd name="connsiteX1" fmla="*/ 95497 w 1395752"/>
                <a:gd name="connsiteY1" fmla="*/ 911299 h 1082545"/>
                <a:gd name="connsiteX2" fmla="*/ 173318 w 1395752"/>
                <a:gd name="connsiteY2" fmla="*/ 758899 h 1082545"/>
                <a:gd name="connsiteX3" fmla="*/ 264109 w 1395752"/>
                <a:gd name="connsiteY3" fmla="*/ 603256 h 1082545"/>
                <a:gd name="connsiteX4" fmla="*/ 328961 w 1395752"/>
                <a:gd name="connsiteY4" fmla="*/ 479708 h 1082545"/>
                <a:gd name="connsiteX5" fmla="*/ 372349 w 1395752"/>
                <a:gd name="connsiteY5" fmla="*/ 453141 h 1082545"/>
                <a:gd name="connsiteX6" fmla="*/ 445692 w 1395752"/>
                <a:gd name="connsiteY6" fmla="*/ 441129 h 1082545"/>
                <a:gd name="connsiteX7" fmla="*/ 688884 w 1395752"/>
                <a:gd name="connsiteY7" fmla="*/ 434643 h 1082545"/>
                <a:gd name="connsiteX8" fmla="*/ 1214178 w 1395752"/>
                <a:gd name="connsiteY8" fmla="*/ 431401 h 1082545"/>
                <a:gd name="connsiteX9" fmla="*/ 1369818 w 1395752"/>
                <a:gd name="connsiteY9" fmla="*/ 162175 h 1082545"/>
                <a:gd name="connsiteX10" fmla="*/ 1395752 w 1395752"/>
                <a:gd name="connsiteY10" fmla="*/ 0 h 1082545"/>
                <a:gd name="connsiteX0" fmla="*/ 0 w 1405686"/>
                <a:gd name="connsiteY0" fmla="*/ 1082545 h 1082545"/>
                <a:gd name="connsiteX1" fmla="*/ 105431 w 1405686"/>
                <a:gd name="connsiteY1" fmla="*/ 911299 h 1082545"/>
                <a:gd name="connsiteX2" fmla="*/ 183252 w 1405686"/>
                <a:gd name="connsiteY2" fmla="*/ 758899 h 1082545"/>
                <a:gd name="connsiteX3" fmla="*/ 274043 w 1405686"/>
                <a:gd name="connsiteY3" fmla="*/ 603256 h 1082545"/>
                <a:gd name="connsiteX4" fmla="*/ 338895 w 1405686"/>
                <a:gd name="connsiteY4" fmla="*/ 479708 h 1082545"/>
                <a:gd name="connsiteX5" fmla="*/ 382283 w 1405686"/>
                <a:gd name="connsiteY5" fmla="*/ 453141 h 1082545"/>
                <a:gd name="connsiteX6" fmla="*/ 455626 w 1405686"/>
                <a:gd name="connsiteY6" fmla="*/ 441129 h 1082545"/>
                <a:gd name="connsiteX7" fmla="*/ 698818 w 1405686"/>
                <a:gd name="connsiteY7" fmla="*/ 434643 h 1082545"/>
                <a:gd name="connsiteX8" fmla="*/ 1224112 w 1405686"/>
                <a:gd name="connsiteY8" fmla="*/ 431401 h 1082545"/>
                <a:gd name="connsiteX9" fmla="*/ 1379752 w 1405686"/>
                <a:gd name="connsiteY9" fmla="*/ 162175 h 1082545"/>
                <a:gd name="connsiteX10" fmla="*/ 1405686 w 1405686"/>
                <a:gd name="connsiteY10" fmla="*/ 0 h 1082545"/>
                <a:gd name="connsiteX0" fmla="*/ 0 w 1461189"/>
                <a:gd name="connsiteY0" fmla="*/ 1578680 h 1578680"/>
                <a:gd name="connsiteX1" fmla="*/ 105431 w 1461189"/>
                <a:gd name="connsiteY1" fmla="*/ 1407434 h 1578680"/>
                <a:gd name="connsiteX2" fmla="*/ 183252 w 1461189"/>
                <a:gd name="connsiteY2" fmla="*/ 1255034 h 1578680"/>
                <a:gd name="connsiteX3" fmla="*/ 274043 w 1461189"/>
                <a:gd name="connsiteY3" fmla="*/ 1099391 h 1578680"/>
                <a:gd name="connsiteX4" fmla="*/ 338895 w 1461189"/>
                <a:gd name="connsiteY4" fmla="*/ 975843 h 1578680"/>
                <a:gd name="connsiteX5" fmla="*/ 382283 w 1461189"/>
                <a:gd name="connsiteY5" fmla="*/ 949276 h 1578680"/>
                <a:gd name="connsiteX6" fmla="*/ 455626 w 1461189"/>
                <a:gd name="connsiteY6" fmla="*/ 937264 h 1578680"/>
                <a:gd name="connsiteX7" fmla="*/ 698818 w 1461189"/>
                <a:gd name="connsiteY7" fmla="*/ 930778 h 1578680"/>
                <a:gd name="connsiteX8" fmla="*/ 1224112 w 1461189"/>
                <a:gd name="connsiteY8" fmla="*/ 927536 h 1578680"/>
                <a:gd name="connsiteX9" fmla="*/ 1379752 w 1461189"/>
                <a:gd name="connsiteY9" fmla="*/ 658310 h 1578680"/>
                <a:gd name="connsiteX10" fmla="*/ 1461189 w 1461189"/>
                <a:gd name="connsiteY10" fmla="*/ 0 h 1578680"/>
                <a:gd name="connsiteX0" fmla="*/ 0 w 1475991"/>
                <a:gd name="connsiteY0" fmla="*/ 1673530 h 1673530"/>
                <a:gd name="connsiteX1" fmla="*/ 105431 w 1475991"/>
                <a:gd name="connsiteY1" fmla="*/ 1502284 h 1673530"/>
                <a:gd name="connsiteX2" fmla="*/ 183252 w 1475991"/>
                <a:gd name="connsiteY2" fmla="*/ 1349884 h 1673530"/>
                <a:gd name="connsiteX3" fmla="*/ 274043 w 1475991"/>
                <a:gd name="connsiteY3" fmla="*/ 1194241 h 1673530"/>
                <a:gd name="connsiteX4" fmla="*/ 338895 w 1475991"/>
                <a:gd name="connsiteY4" fmla="*/ 1070693 h 1673530"/>
                <a:gd name="connsiteX5" fmla="*/ 382283 w 1475991"/>
                <a:gd name="connsiteY5" fmla="*/ 1044126 h 1673530"/>
                <a:gd name="connsiteX6" fmla="*/ 455626 w 1475991"/>
                <a:gd name="connsiteY6" fmla="*/ 1032114 h 1673530"/>
                <a:gd name="connsiteX7" fmla="*/ 698818 w 1475991"/>
                <a:gd name="connsiteY7" fmla="*/ 1025628 h 1673530"/>
                <a:gd name="connsiteX8" fmla="*/ 1224112 w 1475991"/>
                <a:gd name="connsiteY8" fmla="*/ 1022386 h 1673530"/>
                <a:gd name="connsiteX9" fmla="*/ 1379752 w 1475991"/>
                <a:gd name="connsiteY9" fmla="*/ 753160 h 1673530"/>
                <a:gd name="connsiteX10" fmla="*/ 1475991 w 1475991"/>
                <a:gd name="connsiteY10" fmla="*/ 0 h 1673530"/>
                <a:gd name="connsiteX0" fmla="*/ 0 w 1469838"/>
                <a:gd name="connsiteY0" fmla="*/ 1541335 h 1541335"/>
                <a:gd name="connsiteX1" fmla="*/ 105431 w 1469838"/>
                <a:gd name="connsiteY1" fmla="*/ 1370089 h 1541335"/>
                <a:gd name="connsiteX2" fmla="*/ 183252 w 1469838"/>
                <a:gd name="connsiteY2" fmla="*/ 1217689 h 1541335"/>
                <a:gd name="connsiteX3" fmla="*/ 274043 w 1469838"/>
                <a:gd name="connsiteY3" fmla="*/ 1062046 h 1541335"/>
                <a:gd name="connsiteX4" fmla="*/ 338895 w 1469838"/>
                <a:gd name="connsiteY4" fmla="*/ 938498 h 1541335"/>
                <a:gd name="connsiteX5" fmla="*/ 382283 w 1469838"/>
                <a:gd name="connsiteY5" fmla="*/ 911931 h 1541335"/>
                <a:gd name="connsiteX6" fmla="*/ 455626 w 1469838"/>
                <a:gd name="connsiteY6" fmla="*/ 899919 h 1541335"/>
                <a:gd name="connsiteX7" fmla="*/ 698818 w 1469838"/>
                <a:gd name="connsiteY7" fmla="*/ 893433 h 1541335"/>
                <a:gd name="connsiteX8" fmla="*/ 1224112 w 1469838"/>
                <a:gd name="connsiteY8" fmla="*/ 890191 h 1541335"/>
                <a:gd name="connsiteX9" fmla="*/ 1379752 w 1469838"/>
                <a:gd name="connsiteY9" fmla="*/ 620965 h 1541335"/>
                <a:gd name="connsiteX10" fmla="*/ 1469838 w 1469838"/>
                <a:gd name="connsiteY10" fmla="*/ 0 h 1541335"/>
                <a:gd name="connsiteX0" fmla="*/ 0 w 1537520"/>
                <a:gd name="connsiteY0" fmla="*/ 1546843 h 1546843"/>
                <a:gd name="connsiteX1" fmla="*/ 173113 w 1537520"/>
                <a:gd name="connsiteY1" fmla="*/ 1370089 h 1546843"/>
                <a:gd name="connsiteX2" fmla="*/ 250934 w 1537520"/>
                <a:gd name="connsiteY2" fmla="*/ 1217689 h 1546843"/>
                <a:gd name="connsiteX3" fmla="*/ 341725 w 1537520"/>
                <a:gd name="connsiteY3" fmla="*/ 1062046 h 1546843"/>
                <a:gd name="connsiteX4" fmla="*/ 406577 w 1537520"/>
                <a:gd name="connsiteY4" fmla="*/ 938498 h 1546843"/>
                <a:gd name="connsiteX5" fmla="*/ 449965 w 1537520"/>
                <a:gd name="connsiteY5" fmla="*/ 911931 h 1546843"/>
                <a:gd name="connsiteX6" fmla="*/ 523308 w 1537520"/>
                <a:gd name="connsiteY6" fmla="*/ 899919 h 1546843"/>
                <a:gd name="connsiteX7" fmla="*/ 766500 w 1537520"/>
                <a:gd name="connsiteY7" fmla="*/ 893433 h 1546843"/>
                <a:gd name="connsiteX8" fmla="*/ 1291794 w 1537520"/>
                <a:gd name="connsiteY8" fmla="*/ 890191 h 1546843"/>
                <a:gd name="connsiteX9" fmla="*/ 1447434 w 1537520"/>
                <a:gd name="connsiteY9" fmla="*/ 620965 h 1546843"/>
                <a:gd name="connsiteX10" fmla="*/ 1537520 w 1537520"/>
                <a:gd name="connsiteY10" fmla="*/ 0 h 1546843"/>
                <a:gd name="connsiteX0" fmla="*/ 0 w 1537520"/>
                <a:gd name="connsiteY0" fmla="*/ 1546843 h 1546843"/>
                <a:gd name="connsiteX1" fmla="*/ 173113 w 1537520"/>
                <a:gd name="connsiteY1" fmla="*/ 1370089 h 1546843"/>
                <a:gd name="connsiteX2" fmla="*/ 250934 w 1537520"/>
                <a:gd name="connsiteY2" fmla="*/ 1217689 h 1546843"/>
                <a:gd name="connsiteX3" fmla="*/ 341725 w 1537520"/>
                <a:gd name="connsiteY3" fmla="*/ 1062046 h 1546843"/>
                <a:gd name="connsiteX4" fmla="*/ 406577 w 1537520"/>
                <a:gd name="connsiteY4" fmla="*/ 938498 h 1546843"/>
                <a:gd name="connsiteX5" fmla="*/ 449965 w 1537520"/>
                <a:gd name="connsiteY5" fmla="*/ 911931 h 1546843"/>
                <a:gd name="connsiteX6" fmla="*/ 523308 w 1537520"/>
                <a:gd name="connsiteY6" fmla="*/ 899919 h 1546843"/>
                <a:gd name="connsiteX7" fmla="*/ 766500 w 1537520"/>
                <a:gd name="connsiteY7" fmla="*/ 893433 h 1546843"/>
                <a:gd name="connsiteX8" fmla="*/ 1291794 w 1537520"/>
                <a:gd name="connsiteY8" fmla="*/ 890191 h 1546843"/>
                <a:gd name="connsiteX9" fmla="*/ 1447434 w 1537520"/>
                <a:gd name="connsiteY9" fmla="*/ 620965 h 1546843"/>
                <a:gd name="connsiteX10" fmla="*/ 1537520 w 1537520"/>
                <a:gd name="connsiteY10" fmla="*/ 0 h 1546843"/>
                <a:gd name="connsiteX0" fmla="*/ 0 w 1666731"/>
                <a:gd name="connsiteY0" fmla="*/ 1623957 h 1623957"/>
                <a:gd name="connsiteX1" fmla="*/ 302324 w 1666731"/>
                <a:gd name="connsiteY1" fmla="*/ 1370089 h 1623957"/>
                <a:gd name="connsiteX2" fmla="*/ 380145 w 1666731"/>
                <a:gd name="connsiteY2" fmla="*/ 1217689 h 1623957"/>
                <a:gd name="connsiteX3" fmla="*/ 470936 w 1666731"/>
                <a:gd name="connsiteY3" fmla="*/ 1062046 h 1623957"/>
                <a:gd name="connsiteX4" fmla="*/ 535788 w 1666731"/>
                <a:gd name="connsiteY4" fmla="*/ 938498 h 1623957"/>
                <a:gd name="connsiteX5" fmla="*/ 579176 w 1666731"/>
                <a:gd name="connsiteY5" fmla="*/ 911931 h 1623957"/>
                <a:gd name="connsiteX6" fmla="*/ 652519 w 1666731"/>
                <a:gd name="connsiteY6" fmla="*/ 899919 h 1623957"/>
                <a:gd name="connsiteX7" fmla="*/ 895711 w 1666731"/>
                <a:gd name="connsiteY7" fmla="*/ 893433 h 1623957"/>
                <a:gd name="connsiteX8" fmla="*/ 1421005 w 1666731"/>
                <a:gd name="connsiteY8" fmla="*/ 890191 h 1623957"/>
                <a:gd name="connsiteX9" fmla="*/ 1576645 w 1666731"/>
                <a:gd name="connsiteY9" fmla="*/ 620965 h 1623957"/>
                <a:gd name="connsiteX10" fmla="*/ 1666731 w 1666731"/>
                <a:gd name="connsiteY10" fmla="*/ 0 h 1623957"/>
                <a:gd name="connsiteX0" fmla="*/ 0 w 1666731"/>
                <a:gd name="connsiteY0" fmla="*/ 1623957 h 1623957"/>
                <a:gd name="connsiteX1" fmla="*/ 302324 w 1666731"/>
                <a:gd name="connsiteY1" fmla="*/ 1370089 h 1623957"/>
                <a:gd name="connsiteX2" fmla="*/ 380145 w 1666731"/>
                <a:gd name="connsiteY2" fmla="*/ 1217689 h 1623957"/>
                <a:gd name="connsiteX3" fmla="*/ 470936 w 1666731"/>
                <a:gd name="connsiteY3" fmla="*/ 1062046 h 1623957"/>
                <a:gd name="connsiteX4" fmla="*/ 535788 w 1666731"/>
                <a:gd name="connsiteY4" fmla="*/ 938498 h 1623957"/>
                <a:gd name="connsiteX5" fmla="*/ 579176 w 1666731"/>
                <a:gd name="connsiteY5" fmla="*/ 911931 h 1623957"/>
                <a:gd name="connsiteX6" fmla="*/ 652519 w 1666731"/>
                <a:gd name="connsiteY6" fmla="*/ 899919 h 1623957"/>
                <a:gd name="connsiteX7" fmla="*/ 895711 w 1666731"/>
                <a:gd name="connsiteY7" fmla="*/ 893433 h 1623957"/>
                <a:gd name="connsiteX8" fmla="*/ 1421005 w 1666731"/>
                <a:gd name="connsiteY8" fmla="*/ 890191 h 1623957"/>
                <a:gd name="connsiteX9" fmla="*/ 1576645 w 1666731"/>
                <a:gd name="connsiteY9" fmla="*/ 620965 h 1623957"/>
                <a:gd name="connsiteX10" fmla="*/ 1666731 w 1666731"/>
                <a:gd name="connsiteY10" fmla="*/ 0 h 1623957"/>
                <a:gd name="connsiteX0" fmla="*/ 0 w 1666731"/>
                <a:gd name="connsiteY0" fmla="*/ 1623957 h 1623957"/>
                <a:gd name="connsiteX1" fmla="*/ 302324 w 1666731"/>
                <a:gd name="connsiteY1" fmla="*/ 1370089 h 1623957"/>
                <a:gd name="connsiteX2" fmla="*/ 380145 w 1666731"/>
                <a:gd name="connsiteY2" fmla="*/ 1217689 h 1623957"/>
                <a:gd name="connsiteX3" fmla="*/ 470936 w 1666731"/>
                <a:gd name="connsiteY3" fmla="*/ 1062046 h 1623957"/>
                <a:gd name="connsiteX4" fmla="*/ 535788 w 1666731"/>
                <a:gd name="connsiteY4" fmla="*/ 938498 h 1623957"/>
                <a:gd name="connsiteX5" fmla="*/ 579176 w 1666731"/>
                <a:gd name="connsiteY5" fmla="*/ 911931 h 1623957"/>
                <a:gd name="connsiteX6" fmla="*/ 652519 w 1666731"/>
                <a:gd name="connsiteY6" fmla="*/ 899919 h 1623957"/>
                <a:gd name="connsiteX7" fmla="*/ 895711 w 1666731"/>
                <a:gd name="connsiteY7" fmla="*/ 893433 h 1623957"/>
                <a:gd name="connsiteX8" fmla="*/ 1421005 w 1666731"/>
                <a:gd name="connsiteY8" fmla="*/ 890191 h 1623957"/>
                <a:gd name="connsiteX9" fmla="*/ 1576645 w 1666731"/>
                <a:gd name="connsiteY9" fmla="*/ 620965 h 1623957"/>
                <a:gd name="connsiteX10" fmla="*/ 1666731 w 1666731"/>
                <a:gd name="connsiteY10" fmla="*/ 0 h 1623957"/>
                <a:gd name="connsiteX0" fmla="*/ 0 w 1666731"/>
                <a:gd name="connsiteY0" fmla="*/ 1623957 h 1623957"/>
                <a:gd name="connsiteX1" fmla="*/ 290019 w 1666731"/>
                <a:gd name="connsiteY1" fmla="*/ 1370089 h 1623957"/>
                <a:gd name="connsiteX2" fmla="*/ 380145 w 1666731"/>
                <a:gd name="connsiteY2" fmla="*/ 1217689 h 1623957"/>
                <a:gd name="connsiteX3" fmla="*/ 470936 w 1666731"/>
                <a:gd name="connsiteY3" fmla="*/ 1062046 h 1623957"/>
                <a:gd name="connsiteX4" fmla="*/ 535788 w 1666731"/>
                <a:gd name="connsiteY4" fmla="*/ 938498 h 1623957"/>
                <a:gd name="connsiteX5" fmla="*/ 579176 w 1666731"/>
                <a:gd name="connsiteY5" fmla="*/ 911931 h 1623957"/>
                <a:gd name="connsiteX6" fmla="*/ 652519 w 1666731"/>
                <a:gd name="connsiteY6" fmla="*/ 899919 h 1623957"/>
                <a:gd name="connsiteX7" fmla="*/ 895711 w 1666731"/>
                <a:gd name="connsiteY7" fmla="*/ 893433 h 1623957"/>
                <a:gd name="connsiteX8" fmla="*/ 1421005 w 1666731"/>
                <a:gd name="connsiteY8" fmla="*/ 890191 h 1623957"/>
                <a:gd name="connsiteX9" fmla="*/ 1576645 w 1666731"/>
                <a:gd name="connsiteY9" fmla="*/ 620965 h 1623957"/>
                <a:gd name="connsiteX10" fmla="*/ 1666731 w 1666731"/>
                <a:gd name="connsiteY10" fmla="*/ 0 h 16239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1666731" h="1623957">
                  <a:moveTo>
                    <a:pt x="0" y="1623957"/>
                  </a:moveTo>
                  <a:cubicBezTo>
                    <a:pt x="212130" y="1509121"/>
                    <a:pt x="226662" y="1437800"/>
                    <a:pt x="290019" y="1370089"/>
                  </a:cubicBezTo>
                  <a:cubicBezTo>
                    <a:pt x="353376" y="1302378"/>
                    <a:pt x="349992" y="1269029"/>
                    <a:pt x="380145" y="1217689"/>
                  </a:cubicBezTo>
                  <a:cubicBezTo>
                    <a:pt x="410298" y="1166349"/>
                    <a:pt x="444996" y="1108578"/>
                    <a:pt x="470936" y="1062046"/>
                  </a:cubicBezTo>
                  <a:cubicBezTo>
                    <a:pt x="496877" y="1015514"/>
                    <a:pt x="517748" y="963517"/>
                    <a:pt x="535788" y="938498"/>
                  </a:cubicBezTo>
                  <a:cubicBezTo>
                    <a:pt x="553828" y="913479"/>
                    <a:pt x="567670" y="916402"/>
                    <a:pt x="579176" y="911931"/>
                  </a:cubicBezTo>
                  <a:cubicBezTo>
                    <a:pt x="590682" y="907460"/>
                    <a:pt x="599763" y="903002"/>
                    <a:pt x="652519" y="899919"/>
                  </a:cubicBezTo>
                  <a:cubicBezTo>
                    <a:pt x="705275" y="896836"/>
                    <a:pt x="895711" y="893433"/>
                    <a:pt x="895711" y="893433"/>
                  </a:cubicBezTo>
                  <a:cubicBezTo>
                    <a:pt x="1023792" y="891812"/>
                    <a:pt x="1307516" y="935602"/>
                    <a:pt x="1421005" y="890191"/>
                  </a:cubicBezTo>
                  <a:cubicBezTo>
                    <a:pt x="1534494" y="844780"/>
                    <a:pt x="1549624" y="694463"/>
                    <a:pt x="1576645" y="620965"/>
                  </a:cubicBezTo>
                  <a:cubicBezTo>
                    <a:pt x="1593942" y="547467"/>
                    <a:pt x="1654311" y="68303"/>
                    <a:pt x="1666731" y="0"/>
                  </a:cubicBezTo>
                </a:path>
              </a:pathLst>
            </a:cu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C85814AA-0E62-4BF1-A67B-88E53E71194F}"/>
                </a:ext>
              </a:extLst>
            </p:cNvPr>
            <p:cNvSpPr txBox="1"/>
            <p:nvPr/>
          </p:nvSpPr>
          <p:spPr>
            <a:xfrm>
              <a:off x="6165147" y="1358722"/>
              <a:ext cx="367242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.coli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acteria 10</a:t>
              </a:r>
              <a:r>
                <a:rPr lang="en-US" altLang="zh-CN" sz="16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CFU Intrabronchial to RML/RLL or LLL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直接箭头连接符 54">
              <a:extLst>
                <a:ext uri="{FF2B5EF4-FFF2-40B4-BE49-F238E27FC236}">
                  <a16:creationId xmlns:a16="http://schemas.microsoft.com/office/drawing/2014/main" id="{497FEC4A-E2F5-4B98-9199-D84A6E22E9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29998" y="1703131"/>
              <a:ext cx="469538" cy="154855"/>
            </a:xfrm>
            <a:prstGeom prst="straightConnector1">
              <a:avLst/>
            </a:prstGeom>
            <a:ln w="190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箭头: 右 59">
              <a:extLst>
                <a:ext uri="{FF2B5EF4-FFF2-40B4-BE49-F238E27FC236}">
                  <a16:creationId xmlns:a16="http://schemas.microsoft.com/office/drawing/2014/main" id="{C0A321E3-6BBE-4029-9C66-B0BF657CB4C1}"/>
                </a:ext>
              </a:extLst>
            </p:cNvPr>
            <p:cNvSpPr/>
            <p:nvPr/>
          </p:nvSpPr>
          <p:spPr>
            <a:xfrm>
              <a:off x="2830987" y="564052"/>
              <a:ext cx="6848456" cy="402555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箭头: 下 60">
              <a:extLst>
                <a:ext uri="{FF2B5EF4-FFF2-40B4-BE49-F238E27FC236}">
                  <a16:creationId xmlns:a16="http://schemas.microsoft.com/office/drawing/2014/main" id="{33E6AB98-0194-4B03-A72E-3249D39823D7}"/>
                </a:ext>
              </a:extLst>
            </p:cNvPr>
            <p:cNvSpPr/>
            <p:nvPr/>
          </p:nvSpPr>
          <p:spPr>
            <a:xfrm>
              <a:off x="4062103" y="460556"/>
              <a:ext cx="185057" cy="190695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EB6A4544-9AA1-4EED-B9EC-D32981BA5C91}"/>
                </a:ext>
              </a:extLst>
            </p:cNvPr>
            <p:cNvSpPr txBox="1"/>
            <p:nvPr/>
          </p:nvSpPr>
          <p:spPr>
            <a:xfrm>
              <a:off x="2520125" y="-417566"/>
              <a:ext cx="206249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100 ml whole blood to perfusate</a:t>
              </a: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altLang="zh-CN" sz="1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.coli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acteria IT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箭头: 下 63">
              <a:extLst>
                <a:ext uri="{FF2B5EF4-FFF2-40B4-BE49-F238E27FC236}">
                  <a16:creationId xmlns:a16="http://schemas.microsoft.com/office/drawing/2014/main" id="{20E6523C-7244-47F4-BD17-7C3C5EDFB3C5}"/>
                </a:ext>
              </a:extLst>
            </p:cNvPr>
            <p:cNvSpPr/>
            <p:nvPr/>
          </p:nvSpPr>
          <p:spPr>
            <a:xfrm>
              <a:off x="8318776" y="460556"/>
              <a:ext cx="185057" cy="190695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8C02614C-4ACD-4834-8A39-861E041CADEF}"/>
                </a:ext>
              </a:extLst>
            </p:cNvPr>
            <p:cNvSpPr txBox="1"/>
            <p:nvPr/>
          </p:nvSpPr>
          <p:spPr>
            <a:xfrm>
              <a:off x="7484783" y="-613723"/>
              <a:ext cx="2841889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 Measurement of AFC Rate in Injured Lung Lobe</a:t>
              </a: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 BALF &amp; Perfusate Sample Collection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81CCBBF7-78B7-4366-8DF5-B0C739AA05D6}"/>
                </a:ext>
              </a:extLst>
            </p:cNvPr>
            <p:cNvSpPr txBox="1"/>
            <p:nvPr/>
          </p:nvSpPr>
          <p:spPr>
            <a:xfrm>
              <a:off x="7392360" y="890760"/>
              <a:ext cx="20624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6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7AB70010-B067-4935-8035-85DC899103C7}"/>
                </a:ext>
              </a:extLst>
            </p:cNvPr>
            <p:cNvSpPr txBox="1"/>
            <p:nvPr/>
          </p:nvSpPr>
          <p:spPr>
            <a:xfrm>
              <a:off x="746167" y="368352"/>
              <a:ext cx="2062498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Lung Perfusion</a:t>
              </a: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lowly Up to </a:t>
              </a: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250 ml/h over 1 h</a:t>
              </a:r>
            </a:p>
          </p:txBody>
        </p:sp>
        <p:sp>
          <p:nvSpPr>
            <p:cNvPr id="68" name="流程图: 磁盘 67">
              <a:extLst>
                <a:ext uri="{FF2B5EF4-FFF2-40B4-BE49-F238E27FC236}">
                  <a16:creationId xmlns:a16="http://schemas.microsoft.com/office/drawing/2014/main" id="{756EE730-1C66-4E29-BB1C-A03106DFC7FF}"/>
                </a:ext>
              </a:extLst>
            </p:cNvPr>
            <p:cNvSpPr/>
            <p:nvPr/>
          </p:nvSpPr>
          <p:spPr>
            <a:xfrm>
              <a:off x="8191516" y="5123816"/>
              <a:ext cx="1711646" cy="369332"/>
            </a:xfrm>
            <a:prstGeom prst="flowChartMagneticDisk">
              <a:avLst/>
            </a:prstGeom>
            <a:solidFill>
              <a:srgbClr val="C00000">
                <a:alpha val="35000"/>
              </a:srgb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矩形: 圆顶角 74">
              <a:extLst>
                <a:ext uri="{FF2B5EF4-FFF2-40B4-BE49-F238E27FC236}">
                  <a16:creationId xmlns:a16="http://schemas.microsoft.com/office/drawing/2014/main" id="{00A576F8-51FD-40D1-8574-1EB63DE90F00}"/>
                </a:ext>
              </a:extLst>
            </p:cNvPr>
            <p:cNvSpPr/>
            <p:nvPr/>
          </p:nvSpPr>
          <p:spPr>
            <a:xfrm>
              <a:off x="8191516" y="4463836"/>
              <a:ext cx="1711646" cy="1029312"/>
            </a:xfrm>
            <a:prstGeom prst="round2SameRect">
              <a:avLst/>
            </a:prstGeom>
            <a:noFill/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矩形: 圆顶角 75">
              <a:extLst>
                <a:ext uri="{FF2B5EF4-FFF2-40B4-BE49-F238E27FC236}">
                  <a16:creationId xmlns:a16="http://schemas.microsoft.com/office/drawing/2014/main" id="{A61E8066-9C98-41D5-8CC0-C1F358ECE92B}"/>
                </a:ext>
              </a:extLst>
            </p:cNvPr>
            <p:cNvSpPr/>
            <p:nvPr/>
          </p:nvSpPr>
          <p:spPr>
            <a:xfrm>
              <a:off x="7993064" y="4463836"/>
              <a:ext cx="2062498" cy="1181712"/>
            </a:xfrm>
            <a:prstGeom prst="round2SameRect">
              <a:avLst/>
            </a:prstGeom>
            <a:noFill/>
            <a:ln w="381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直接连接符 77">
              <a:extLst>
                <a:ext uri="{FF2B5EF4-FFF2-40B4-BE49-F238E27FC236}">
                  <a16:creationId xmlns:a16="http://schemas.microsoft.com/office/drawing/2014/main" id="{E509CAD2-1F1C-44FD-8AEA-8323764C20B1}"/>
                </a:ext>
              </a:extLst>
            </p:cNvPr>
            <p:cNvCxnSpPr/>
            <p:nvPr/>
          </p:nvCxnSpPr>
          <p:spPr>
            <a:xfrm>
              <a:off x="6716535" y="4123284"/>
              <a:ext cx="2554904" cy="0"/>
            </a:xfrm>
            <a:prstGeom prst="line">
              <a:avLst/>
            </a:prstGeom>
            <a:ln w="571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连接符 78">
              <a:extLst>
                <a:ext uri="{FF2B5EF4-FFF2-40B4-BE49-F238E27FC236}">
                  <a16:creationId xmlns:a16="http://schemas.microsoft.com/office/drawing/2014/main" id="{C598834B-EB0A-42C3-AE6A-BF4386B59E7B}"/>
                </a:ext>
              </a:extLst>
            </p:cNvPr>
            <p:cNvCxnSpPr>
              <a:cxnSpLocks/>
            </p:cNvCxnSpPr>
            <p:nvPr/>
          </p:nvCxnSpPr>
          <p:spPr>
            <a:xfrm>
              <a:off x="6715612" y="4308052"/>
              <a:ext cx="2254152" cy="0"/>
            </a:xfrm>
            <a:prstGeom prst="line">
              <a:avLst/>
            </a:prstGeom>
            <a:ln w="571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>
              <a:extLst>
                <a:ext uri="{FF2B5EF4-FFF2-40B4-BE49-F238E27FC236}">
                  <a16:creationId xmlns:a16="http://schemas.microsoft.com/office/drawing/2014/main" id="{E9898D60-AE49-4628-94C8-FC9496333854}"/>
                </a:ext>
              </a:extLst>
            </p:cNvPr>
            <p:cNvCxnSpPr>
              <a:cxnSpLocks/>
            </p:cNvCxnSpPr>
            <p:nvPr/>
          </p:nvCxnSpPr>
          <p:spPr>
            <a:xfrm>
              <a:off x="8969764" y="4281599"/>
              <a:ext cx="0" cy="486509"/>
            </a:xfrm>
            <a:prstGeom prst="line">
              <a:avLst/>
            </a:prstGeom>
            <a:ln w="571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连接符 82">
              <a:extLst>
                <a:ext uri="{FF2B5EF4-FFF2-40B4-BE49-F238E27FC236}">
                  <a16:creationId xmlns:a16="http://schemas.microsoft.com/office/drawing/2014/main" id="{6061EB90-3D69-45AF-BEF8-7CA9231344CF}"/>
                </a:ext>
              </a:extLst>
            </p:cNvPr>
            <p:cNvCxnSpPr>
              <a:cxnSpLocks/>
            </p:cNvCxnSpPr>
            <p:nvPr/>
          </p:nvCxnSpPr>
          <p:spPr>
            <a:xfrm>
              <a:off x="9271439" y="4098260"/>
              <a:ext cx="0" cy="1354438"/>
            </a:xfrm>
            <a:prstGeom prst="line">
              <a:avLst/>
            </a:prstGeom>
            <a:ln w="57150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箭头连接符 88">
              <a:extLst>
                <a:ext uri="{FF2B5EF4-FFF2-40B4-BE49-F238E27FC236}">
                  <a16:creationId xmlns:a16="http://schemas.microsoft.com/office/drawing/2014/main" id="{C2B1393E-88DA-4984-8F7C-47FC580635DC}"/>
                </a:ext>
              </a:extLst>
            </p:cNvPr>
            <p:cNvCxnSpPr/>
            <p:nvPr/>
          </p:nvCxnSpPr>
          <p:spPr>
            <a:xfrm>
              <a:off x="7381014" y="4463836"/>
              <a:ext cx="379903" cy="0"/>
            </a:xfrm>
            <a:prstGeom prst="straightConnector1">
              <a:avLst/>
            </a:prstGeom>
            <a:ln w="190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箭头连接符 89">
              <a:extLst>
                <a:ext uri="{FF2B5EF4-FFF2-40B4-BE49-F238E27FC236}">
                  <a16:creationId xmlns:a16="http://schemas.microsoft.com/office/drawing/2014/main" id="{4CBA3DCC-CEAC-42DC-B85B-4544E41FC8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468265" y="3977438"/>
              <a:ext cx="392297" cy="0"/>
            </a:xfrm>
            <a:prstGeom prst="straightConnector1">
              <a:avLst/>
            </a:prstGeom>
            <a:ln w="19050">
              <a:solidFill>
                <a:srgbClr val="00206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8" name="组合 97">
              <a:extLst>
                <a:ext uri="{FF2B5EF4-FFF2-40B4-BE49-F238E27FC236}">
                  <a16:creationId xmlns:a16="http://schemas.microsoft.com/office/drawing/2014/main" id="{F696A654-2B96-44AD-A43A-6C24FAEE51CE}"/>
                </a:ext>
              </a:extLst>
            </p:cNvPr>
            <p:cNvGrpSpPr/>
            <p:nvPr/>
          </p:nvGrpSpPr>
          <p:grpSpPr>
            <a:xfrm>
              <a:off x="2460687" y="1684230"/>
              <a:ext cx="2696371" cy="4065342"/>
              <a:chOff x="1566773" y="2641681"/>
              <a:chExt cx="2756940" cy="3132240"/>
            </a:xfrm>
          </p:grpSpPr>
          <p:sp>
            <p:nvSpPr>
              <p:cNvPr id="97" name="矩形 96">
                <a:extLst>
                  <a:ext uri="{FF2B5EF4-FFF2-40B4-BE49-F238E27FC236}">
                    <a16:creationId xmlns:a16="http://schemas.microsoft.com/office/drawing/2014/main" id="{342CDE9E-D681-4731-A969-8531EFBA1C30}"/>
                  </a:ext>
                </a:extLst>
              </p:cNvPr>
              <p:cNvSpPr/>
              <p:nvPr/>
            </p:nvSpPr>
            <p:spPr>
              <a:xfrm>
                <a:off x="1576908" y="2855690"/>
                <a:ext cx="2746805" cy="2471731"/>
              </a:xfrm>
              <a:prstGeom prst="rect">
                <a:avLst/>
              </a:prstGeom>
              <a:solidFill>
                <a:schemeClr val="accent6">
                  <a:lumMod val="20000"/>
                  <a:lumOff val="80000"/>
                  <a:alpha val="24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流程图: 磁盘 90">
                <a:extLst>
                  <a:ext uri="{FF2B5EF4-FFF2-40B4-BE49-F238E27FC236}">
                    <a16:creationId xmlns:a16="http://schemas.microsoft.com/office/drawing/2014/main" id="{8B251D9D-D5C9-4066-B51A-44F496376AE9}"/>
                  </a:ext>
                </a:extLst>
              </p:cNvPr>
              <p:cNvSpPr/>
              <p:nvPr/>
            </p:nvSpPr>
            <p:spPr>
              <a:xfrm>
                <a:off x="1566773" y="5265479"/>
                <a:ext cx="2749964" cy="508442"/>
              </a:xfrm>
              <a:prstGeom prst="flowChartMagneticDisk">
                <a:avLst/>
              </a:prstGeom>
              <a:solidFill>
                <a:srgbClr val="C00000">
                  <a:alpha val="35000"/>
                </a:srgbClr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300A2A94-6900-4631-A3D7-1C6FE47615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66773" y="2870133"/>
                <a:ext cx="0" cy="2822535"/>
              </a:xfrm>
              <a:prstGeom prst="line">
                <a:avLst/>
              </a:prstGeom>
              <a:ln w="3810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直接连接符 94">
                <a:extLst>
                  <a:ext uri="{FF2B5EF4-FFF2-40B4-BE49-F238E27FC236}">
                    <a16:creationId xmlns:a16="http://schemas.microsoft.com/office/drawing/2014/main" id="{F4C2A41D-8A6F-4FE8-8C38-E6F1F4197E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16737" y="2870133"/>
                <a:ext cx="0" cy="2822535"/>
              </a:xfrm>
              <a:prstGeom prst="line">
                <a:avLst/>
              </a:prstGeom>
              <a:ln w="38100"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椭圆 95">
                <a:extLst>
                  <a:ext uri="{FF2B5EF4-FFF2-40B4-BE49-F238E27FC236}">
                    <a16:creationId xmlns:a16="http://schemas.microsoft.com/office/drawing/2014/main" id="{EFAAC83A-A9FF-49F4-92B7-A4150125CA99}"/>
                  </a:ext>
                </a:extLst>
              </p:cNvPr>
              <p:cNvSpPr/>
              <p:nvPr/>
            </p:nvSpPr>
            <p:spPr>
              <a:xfrm>
                <a:off x="1566773" y="2641681"/>
                <a:ext cx="2749962" cy="451624"/>
              </a:xfrm>
              <a:prstGeom prst="ellipse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accent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7" name="箭头: 下 106">
              <a:extLst>
                <a:ext uri="{FF2B5EF4-FFF2-40B4-BE49-F238E27FC236}">
                  <a16:creationId xmlns:a16="http://schemas.microsoft.com/office/drawing/2014/main" id="{B7F38031-3D93-432C-983F-64319C4ED0ED}"/>
                </a:ext>
              </a:extLst>
            </p:cNvPr>
            <p:cNvSpPr/>
            <p:nvPr/>
          </p:nvSpPr>
          <p:spPr>
            <a:xfrm>
              <a:off x="5157986" y="470756"/>
              <a:ext cx="185057" cy="190695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C13AAF93-0FDC-48EE-A869-F44CECF71B0E}"/>
                </a:ext>
              </a:extLst>
            </p:cNvPr>
            <p:cNvSpPr txBox="1"/>
            <p:nvPr/>
          </p:nvSpPr>
          <p:spPr>
            <a:xfrm>
              <a:off x="3927483" y="880687"/>
              <a:ext cx="4695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T0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箭头: 下 110">
              <a:extLst>
                <a:ext uri="{FF2B5EF4-FFF2-40B4-BE49-F238E27FC236}">
                  <a16:creationId xmlns:a16="http://schemas.microsoft.com/office/drawing/2014/main" id="{D304019C-AB8F-4E02-A425-EB7C70BD91E1}"/>
                </a:ext>
              </a:extLst>
            </p:cNvPr>
            <p:cNvSpPr/>
            <p:nvPr/>
          </p:nvSpPr>
          <p:spPr>
            <a:xfrm rot="10800000">
              <a:off x="3338109" y="877557"/>
              <a:ext cx="185057" cy="190695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18B2F95F-0D19-46F5-9329-9E6EB803660B}"/>
                </a:ext>
              </a:extLst>
            </p:cNvPr>
            <p:cNvSpPr txBox="1"/>
            <p:nvPr/>
          </p:nvSpPr>
          <p:spPr>
            <a:xfrm>
              <a:off x="2412240" y="1080841"/>
              <a:ext cx="2062498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tart Ventilation Temp ≥ 30</a:t>
              </a:r>
              <a:r>
                <a:rPr lang="zh-CN" altLang="en-US" sz="1600" b="1">
                  <a:latin typeface="Arial" panose="020B0604020202020204" pitchFamily="34" charset="0"/>
                  <a:cs typeface="Arial" panose="020B0604020202020204" pitchFamily="34" charset="0"/>
                </a:rPr>
                <a:t>℃</a:t>
              </a: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D2D55E7D-CE86-437B-9448-1770DC5AE926}"/>
                </a:ext>
              </a:extLst>
            </p:cNvPr>
            <p:cNvSpPr txBox="1"/>
            <p:nvPr/>
          </p:nvSpPr>
          <p:spPr>
            <a:xfrm>
              <a:off x="7310275" y="2611707"/>
              <a:ext cx="234868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300ml PEEP </a:t>
              </a: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5 cmH</a:t>
              </a:r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O,</a:t>
              </a:r>
            </a:p>
            <a:p>
              <a:pPr algn="ctr"/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RR 10/min</a:t>
              </a:r>
              <a:r>
                <a:rPr lang="zh-CN" altLang="en-US" sz="1600" b="1">
                  <a:latin typeface="Arial" panose="020B0604020202020204" pitchFamily="34" charset="0"/>
                  <a:cs typeface="Arial" panose="020B0604020202020204" pitchFamily="34" charset="0"/>
                </a:rPr>
                <a:t>， 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FiO</a:t>
              </a:r>
              <a:r>
                <a:rPr lang="en-US" altLang="zh-CN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21%</a:t>
              </a:r>
              <a:endParaRPr lang="zh-CN" altLang="en-US" sz="1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文本框 107">
            <a:extLst>
              <a:ext uri="{FF2B5EF4-FFF2-40B4-BE49-F238E27FC236}">
                <a16:creationId xmlns:a16="http://schemas.microsoft.com/office/drawing/2014/main" id="{5A91451C-97B4-A34E-A914-33EFAB0EBF85}"/>
              </a:ext>
            </a:extLst>
          </p:cNvPr>
          <p:cNvSpPr txBox="1"/>
          <p:nvPr/>
        </p:nvSpPr>
        <p:spPr>
          <a:xfrm>
            <a:off x="5518778" y="1567424"/>
            <a:ext cx="46953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1</a:t>
            </a:r>
            <a:endParaRPr lang="zh-CN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EC5FD1-4630-8E4D-9EF7-0CD9655D02B3}"/>
              </a:ext>
            </a:extLst>
          </p:cNvPr>
          <p:cNvSpPr txBox="1"/>
          <p:nvPr/>
        </p:nvSpPr>
        <p:spPr>
          <a:xfrm>
            <a:off x="5338648" y="800105"/>
            <a:ext cx="21695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Reversan 20 m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AEF016-9AE4-1141-A020-C0217569F57F}"/>
              </a:ext>
            </a:extLst>
          </p:cNvPr>
          <p:cNvSpPr txBox="1"/>
          <p:nvPr/>
        </p:nvSpPr>
        <p:spPr>
          <a:xfrm>
            <a:off x="5666029" y="4150757"/>
            <a:ext cx="116089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ulmonary 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rtery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E236271-6853-6B47-8A74-294A491ED673}"/>
              </a:ext>
            </a:extLst>
          </p:cNvPr>
          <p:cNvSpPr txBox="1"/>
          <p:nvPr/>
        </p:nvSpPr>
        <p:spPr>
          <a:xfrm>
            <a:off x="5655146" y="3225470"/>
            <a:ext cx="8608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rachea</a:t>
            </a:r>
          </a:p>
        </p:txBody>
      </p:sp>
      <p:sp>
        <p:nvSpPr>
          <p:cNvPr id="11" name="文本框 59">
            <a:extLst>
              <a:ext uri="{FF2B5EF4-FFF2-40B4-BE49-F238E27FC236}">
                <a16:creationId xmlns:a16="http://schemas.microsoft.com/office/drawing/2014/main" id="{8ABEF0B3-069C-3502-3C94-213FAA993178}"/>
              </a:ext>
            </a:extLst>
          </p:cNvPr>
          <p:cNvSpPr txBox="1"/>
          <p:nvPr/>
        </p:nvSpPr>
        <p:spPr>
          <a:xfrm>
            <a:off x="57151" y="76101"/>
            <a:ext cx="3014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11757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>
            <a:extLst>
              <a:ext uri="{FF2B5EF4-FFF2-40B4-BE49-F238E27FC236}">
                <a16:creationId xmlns:a16="http://schemas.microsoft.com/office/drawing/2014/main" id="{437E7334-49D8-B445-8410-AC8BDA54AD85}"/>
              </a:ext>
            </a:extLst>
          </p:cNvPr>
          <p:cNvGrpSpPr/>
          <p:nvPr/>
        </p:nvGrpSpPr>
        <p:grpSpPr>
          <a:xfrm>
            <a:off x="5872535" y="1659531"/>
            <a:ext cx="3496580" cy="3248681"/>
            <a:chOff x="8658600" y="3645505"/>
            <a:chExt cx="3496580" cy="3248681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B243F17-F4FB-7347-8F97-630B7F65BE2E}"/>
                </a:ext>
              </a:extLst>
            </p:cNvPr>
            <p:cNvSpPr txBox="1"/>
            <p:nvPr/>
          </p:nvSpPr>
          <p:spPr>
            <a:xfrm>
              <a:off x="8935928" y="3645506"/>
              <a:ext cx="955795" cy="25995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onocyte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F45619A-D635-854D-AD13-80B9BA4A5DAE}"/>
                </a:ext>
              </a:extLst>
            </p:cNvPr>
            <p:cNvSpPr txBox="1"/>
            <p:nvPr/>
          </p:nvSpPr>
          <p:spPr>
            <a:xfrm>
              <a:off x="10844035" y="3645505"/>
              <a:ext cx="975360" cy="25995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+ LP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F78BD6B-E1DF-9D48-88C7-464156733CED}"/>
                </a:ext>
              </a:extLst>
            </p:cNvPr>
            <p:cNvSpPr txBox="1"/>
            <p:nvPr/>
          </p:nvSpPr>
          <p:spPr>
            <a:xfrm>
              <a:off x="8891059" y="6155523"/>
              <a:ext cx="1205779" cy="52322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.coli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EV  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+ LPS (pre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3889415-2C32-404C-B2CA-26D025409156}"/>
                </a:ext>
              </a:extLst>
            </p:cNvPr>
            <p:cNvSpPr txBox="1"/>
            <p:nvPr/>
          </p:nvSpPr>
          <p:spPr>
            <a:xfrm>
              <a:off x="10620685" y="6155522"/>
              <a:ext cx="1503938" cy="7386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+ </a:t>
              </a:r>
              <a:r>
                <a:rPr lang="en-US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.coli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EV 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eversan (pre) </a:t>
              </a:r>
            </a:p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  + LPS (pre)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3A78A255-AF34-F94C-B7B2-6C725A4F58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662948" y="3886854"/>
              <a:ext cx="3486561" cy="111394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EE083C5B-ACD0-F64E-B710-657CBBA7C1C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658600" y="5047136"/>
              <a:ext cx="3496580" cy="1094398"/>
            </a:xfrm>
            <a:prstGeom prst="rect">
              <a:avLst/>
            </a:prstGeom>
          </p:spPr>
        </p:pic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96E7FD1E-876A-124C-992F-B7BAC546174B}"/>
                </a:ext>
              </a:extLst>
            </p:cNvPr>
            <p:cNvCxnSpPr>
              <a:cxnSpLocks/>
            </p:cNvCxnSpPr>
            <p:nvPr/>
          </p:nvCxnSpPr>
          <p:spPr>
            <a:xfrm>
              <a:off x="11815249" y="6044407"/>
              <a:ext cx="245366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38272BE7-2EE3-3F41-8CA7-763BF1126D78}"/>
                </a:ext>
              </a:extLst>
            </p:cNvPr>
            <p:cNvCxnSpPr>
              <a:cxnSpLocks/>
            </p:cNvCxnSpPr>
            <p:nvPr/>
          </p:nvCxnSpPr>
          <p:spPr>
            <a:xfrm>
              <a:off x="9912076" y="6054306"/>
              <a:ext cx="245366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C7C92C74-56AA-5042-A00C-6453AD92A873}"/>
                </a:ext>
              </a:extLst>
            </p:cNvPr>
            <p:cNvCxnSpPr>
              <a:cxnSpLocks/>
            </p:cNvCxnSpPr>
            <p:nvPr/>
          </p:nvCxnSpPr>
          <p:spPr>
            <a:xfrm>
              <a:off x="11820591" y="4925543"/>
              <a:ext cx="245366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C18F43DD-7CE3-864E-9F46-2557CF86B855}"/>
                </a:ext>
              </a:extLst>
            </p:cNvPr>
            <p:cNvCxnSpPr>
              <a:cxnSpLocks/>
            </p:cNvCxnSpPr>
            <p:nvPr/>
          </p:nvCxnSpPr>
          <p:spPr>
            <a:xfrm>
              <a:off x="9917419" y="4935442"/>
              <a:ext cx="245366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文本框 59">
            <a:extLst>
              <a:ext uri="{FF2B5EF4-FFF2-40B4-BE49-F238E27FC236}">
                <a16:creationId xmlns:a16="http://schemas.microsoft.com/office/drawing/2014/main" id="{6A366B05-A1CE-7149-8CD7-3BAEB252DA91}"/>
              </a:ext>
            </a:extLst>
          </p:cNvPr>
          <p:cNvSpPr txBox="1"/>
          <p:nvPr/>
        </p:nvSpPr>
        <p:spPr>
          <a:xfrm>
            <a:off x="57151" y="76101"/>
            <a:ext cx="3014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3379055-7D4B-69E3-F67E-DB08B8443E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0099" y="1607333"/>
            <a:ext cx="3695700" cy="490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52369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文本框 59">
            <a:extLst>
              <a:ext uri="{FF2B5EF4-FFF2-40B4-BE49-F238E27FC236}">
                <a16:creationId xmlns:a16="http://schemas.microsoft.com/office/drawing/2014/main" id="{A5902EC7-AD24-CA41-9338-EA2C50DE0BF4}"/>
              </a:ext>
            </a:extLst>
          </p:cNvPr>
          <p:cNvSpPr txBox="1"/>
          <p:nvPr/>
        </p:nvSpPr>
        <p:spPr>
          <a:xfrm>
            <a:off x="57151" y="76101"/>
            <a:ext cx="3014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</a:t>
            </a:r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: 圆角 2">
            <a:extLst>
              <a:ext uri="{FF2B5EF4-FFF2-40B4-BE49-F238E27FC236}">
                <a16:creationId xmlns:a16="http://schemas.microsoft.com/office/drawing/2014/main" id="{CA7D63E2-DE76-47EE-93A3-4A25B1AD3FEB}"/>
              </a:ext>
            </a:extLst>
          </p:cNvPr>
          <p:cNvSpPr/>
          <p:nvPr/>
        </p:nvSpPr>
        <p:spPr>
          <a:xfrm>
            <a:off x="2616892" y="810413"/>
            <a:ext cx="7098608" cy="5071910"/>
          </a:xfrm>
          <a:prstGeom prst="roundRect">
            <a:avLst/>
          </a:prstGeom>
          <a:gradFill flip="none" rotWithShape="1">
            <a:gsLst>
              <a:gs pos="0">
                <a:schemeClr val="accent6">
                  <a:lumMod val="5000"/>
                  <a:lumOff val="95000"/>
                </a:schemeClr>
              </a:gs>
              <a:gs pos="74000">
                <a:schemeClr val="accent6">
                  <a:lumMod val="45000"/>
                  <a:lumOff val="55000"/>
                </a:schemeClr>
              </a:gs>
              <a:gs pos="83000">
                <a:schemeClr val="accent6">
                  <a:lumMod val="45000"/>
                  <a:lumOff val="55000"/>
                </a:schemeClr>
              </a:gs>
              <a:gs pos="100000">
                <a:schemeClr val="accent6">
                  <a:lumMod val="30000"/>
                  <a:lumOff val="70000"/>
                </a:schemeClr>
              </a:gs>
            </a:gsLst>
            <a:lin ang="5400000" scaled="1"/>
            <a:tileRect/>
          </a:gradFill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94001D39-043E-4179-AE6D-74F09E60D6B7}"/>
              </a:ext>
            </a:extLst>
          </p:cNvPr>
          <p:cNvGrpSpPr/>
          <p:nvPr/>
        </p:nvGrpSpPr>
        <p:grpSpPr>
          <a:xfrm>
            <a:off x="5962311" y="1173971"/>
            <a:ext cx="3554221" cy="2311163"/>
            <a:chOff x="1527893" y="3094432"/>
            <a:chExt cx="4205435" cy="2968987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E88F835A-C762-4820-A167-8251CBB0F547}"/>
                </a:ext>
              </a:extLst>
            </p:cNvPr>
            <p:cNvGrpSpPr/>
            <p:nvPr/>
          </p:nvGrpSpPr>
          <p:grpSpPr>
            <a:xfrm>
              <a:off x="1527893" y="3094432"/>
              <a:ext cx="4205435" cy="2968987"/>
              <a:chOff x="2421973" y="1830420"/>
              <a:chExt cx="6732165" cy="4507315"/>
            </a:xfrm>
          </p:grpSpPr>
          <p:sp>
            <p:nvSpPr>
              <p:cNvPr id="17" name="椭圆 16">
                <a:extLst>
                  <a:ext uri="{FF2B5EF4-FFF2-40B4-BE49-F238E27FC236}">
                    <a16:creationId xmlns:a16="http://schemas.microsoft.com/office/drawing/2014/main" id="{0E707098-234B-4E06-8FD0-E839593E3583}"/>
                  </a:ext>
                </a:extLst>
              </p:cNvPr>
              <p:cNvSpPr/>
              <p:nvPr/>
            </p:nvSpPr>
            <p:spPr>
              <a:xfrm>
                <a:off x="2421973" y="2091556"/>
                <a:ext cx="4560702" cy="4246179"/>
              </a:xfrm>
              <a:prstGeom prst="ellipse">
                <a:avLst/>
              </a:prstGeom>
              <a:gradFill flip="none" rotWithShape="1">
                <a:gsLst>
                  <a:gs pos="28000">
                    <a:schemeClr val="accent5">
                      <a:lumMod val="5000"/>
                      <a:lumOff val="95000"/>
                    </a:schemeClr>
                  </a:gs>
                  <a:gs pos="99000">
                    <a:schemeClr val="accent5">
                      <a:lumMod val="45000"/>
                      <a:lumOff val="55000"/>
                    </a:schemeClr>
                  </a:gs>
                  <a:gs pos="78000">
                    <a:schemeClr val="accent5">
                      <a:lumMod val="45000"/>
                      <a:lumOff val="55000"/>
                    </a:schemeClr>
                  </a:gs>
                  <a:gs pos="100000">
                    <a:schemeClr val="accent5">
                      <a:lumMod val="30000"/>
                      <a:lumOff val="70000"/>
                    </a:schemeClr>
                  </a:gs>
                </a:gsLst>
                <a:lin ang="5400000" scaled="1"/>
                <a:tileRect/>
              </a:gradFill>
              <a:ln w="95250" cmpd="dbl"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六边形 17">
                <a:extLst>
                  <a:ext uri="{FF2B5EF4-FFF2-40B4-BE49-F238E27FC236}">
                    <a16:creationId xmlns:a16="http://schemas.microsoft.com/office/drawing/2014/main" id="{46051936-D03B-4A6A-8698-5507B414AAE8}"/>
                  </a:ext>
                </a:extLst>
              </p:cNvPr>
              <p:cNvSpPr/>
              <p:nvPr/>
            </p:nvSpPr>
            <p:spPr>
              <a:xfrm>
                <a:off x="4317861" y="2748921"/>
                <a:ext cx="325821" cy="231228"/>
              </a:xfrm>
              <a:prstGeom prst="hexagon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菱形 18">
                <a:extLst>
                  <a:ext uri="{FF2B5EF4-FFF2-40B4-BE49-F238E27FC236}">
                    <a16:creationId xmlns:a16="http://schemas.microsoft.com/office/drawing/2014/main" id="{74C974AC-0BA8-4603-8777-9748D21641D9}"/>
                  </a:ext>
                </a:extLst>
              </p:cNvPr>
              <p:cNvSpPr/>
              <p:nvPr/>
            </p:nvSpPr>
            <p:spPr>
              <a:xfrm>
                <a:off x="3526613" y="3983420"/>
                <a:ext cx="310055" cy="273268"/>
              </a:xfrm>
              <a:prstGeom prst="diamon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标题 1">
                <a:extLst>
                  <a:ext uri="{FF2B5EF4-FFF2-40B4-BE49-F238E27FC236}">
                    <a16:creationId xmlns:a16="http://schemas.microsoft.com/office/drawing/2014/main" id="{15E62117-3C15-4A2B-A91F-D7E361EBC90D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788980" y="4465780"/>
                <a:ext cx="1246210" cy="271682"/>
              </a:xfrm>
              <a:prstGeom prst="rect">
                <a:avLst/>
              </a:prstGeom>
            </p:spPr>
            <p:txBody>
              <a:bodyPr vert="horz" lIns="91440" tIns="45720" rIns="91440" bIns="45720" rtlCol="0" anchor="t">
                <a:noAutofit/>
              </a:bodyPr>
              <a:lstStyle>
                <a:lvl1pPr algn="l" defTabSz="457200" rtl="0" eaLnBrk="1" latinLnBrk="0" hangingPunct="1">
                  <a:spcBef>
                    <a:spcPct val="0"/>
                  </a:spcBef>
                  <a:buNone/>
                  <a:defRPr sz="3600" b="1" kern="120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Times New Roman" panose="02020603050405020304" pitchFamily="18" charset="0"/>
                    <a:ea typeface="+mj-ea"/>
                    <a:cs typeface="Times New Roman" panose="02020603050405020304" pitchFamily="18" charset="0"/>
                  </a:defRPr>
                </a:lvl1pPr>
                <a:lvl2pPr eaLnBrk="1" hangingPunct="1">
                  <a:defRPr>
                    <a:solidFill>
                      <a:schemeClr val="tx2"/>
                    </a:solidFill>
                  </a:defRPr>
                </a:lvl2pPr>
                <a:lvl3pPr eaLnBrk="1" hangingPunct="1">
                  <a:defRPr>
                    <a:solidFill>
                      <a:schemeClr val="tx2"/>
                    </a:solidFill>
                  </a:defRPr>
                </a:lvl3pPr>
                <a:lvl4pPr eaLnBrk="1" hangingPunct="1">
                  <a:defRPr>
                    <a:solidFill>
                      <a:schemeClr val="tx2"/>
                    </a:solidFill>
                  </a:defRPr>
                </a:lvl4pPr>
                <a:lvl5pPr eaLnBrk="1" hangingPunct="1">
                  <a:defRPr>
                    <a:solidFill>
                      <a:schemeClr val="tx2"/>
                    </a:solidFill>
                  </a:defRPr>
                </a:lvl5pPr>
                <a:lvl6pPr eaLnBrk="1" hangingPunct="1">
                  <a:defRPr>
                    <a:solidFill>
                      <a:schemeClr val="tx2"/>
                    </a:solidFill>
                  </a:defRPr>
                </a:lvl6pPr>
                <a:lvl7pPr eaLnBrk="1" hangingPunct="1">
                  <a:defRPr>
                    <a:solidFill>
                      <a:schemeClr val="tx2"/>
                    </a:solidFill>
                  </a:defRPr>
                </a:lvl7pPr>
                <a:lvl8pPr eaLnBrk="1" hangingPunct="1">
                  <a:defRPr>
                    <a:solidFill>
                      <a:schemeClr val="tx2"/>
                    </a:solidFill>
                  </a:defRPr>
                </a:lvl8pPr>
                <a:lvl9pPr eaLnBrk="1" hangingPunct="1">
                  <a:defRPr>
                    <a:solidFill>
                      <a:schemeClr val="tx2"/>
                    </a:solidFill>
                  </a:defRPr>
                </a:lvl9pPr>
              </a:lstStyle>
              <a:p>
                <a:r>
                  <a:rPr lang="en-US" altLang="zh-CN" sz="1400" dirty="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TB</a:t>
                </a:r>
                <a:r>
                  <a:rPr lang="en-US" altLang="zh-CN" sz="1400" baseline="-25000" dirty="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baseline="-2500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箭头: 五边形 20">
                <a:extLst>
                  <a:ext uri="{FF2B5EF4-FFF2-40B4-BE49-F238E27FC236}">
                    <a16:creationId xmlns:a16="http://schemas.microsoft.com/office/drawing/2014/main" id="{F6EDF812-B337-4668-AAAC-5BA16AFBE4DF}"/>
                  </a:ext>
                </a:extLst>
              </p:cNvPr>
              <p:cNvSpPr/>
              <p:nvPr/>
            </p:nvSpPr>
            <p:spPr>
              <a:xfrm rot="16200000">
                <a:off x="5610160" y="3981843"/>
                <a:ext cx="189185" cy="215461"/>
              </a:xfrm>
              <a:prstGeom prst="homePlate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accent1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标题 1">
                <a:extLst>
                  <a:ext uri="{FF2B5EF4-FFF2-40B4-BE49-F238E27FC236}">
                    <a16:creationId xmlns:a16="http://schemas.microsoft.com/office/drawing/2014/main" id="{B6CAFF7E-DDDE-46C5-B6FD-3EF56D0CA677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795204" y="4357178"/>
                <a:ext cx="1230061" cy="390982"/>
              </a:xfrm>
              <a:prstGeom prst="rect">
                <a:avLst/>
              </a:prstGeom>
            </p:spPr>
            <p:txBody>
              <a:bodyPr vert="horz" lIns="91440" tIns="45720" rIns="91440" bIns="45720" rtlCol="0" anchor="t">
                <a:noAutofit/>
              </a:bodyPr>
              <a:lstStyle>
                <a:lvl1pPr algn="l" defTabSz="457200" rtl="0" eaLnBrk="1" latinLnBrk="0" hangingPunct="1">
                  <a:spcBef>
                    <a:spcPct val="0"/>
                  </a:spcBef>
                  <a:buNone/>
                  <a:defRPr sz="3600" b="1" kern="120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Times New Roman" panose="02020603050405020304" pitchFamily="18" charset="0"/>
                    <a:ea typeface="+mj-ea"/>
                    <a:cs typeface="Times New Roman" panose="02020603050405020304" pitchFamily="18" charset="0"/>
                  </a:defRPr>
                </a:lvl1pPr>
                <a:lvl2pPr eaLnBrk="1" hangingPunct="1">
                  <a:defRPr>
                    <a:solidFill>
                      <a:schemeClr val="tx2"/>
                    </a:solidFill>
                  </a:defRPr>
                </a:lvl2pPr>
                <a:lvl3pPr eaLnBrk="1" hangingPunct="1">
                  <a:defRPr>
                    <a:solidFill>
                      <a:schemeClr val="tx2"/>
                    </a:solidFill>
                  </a:defRPr>
                </a:lvl3pPr>
                <a:lvl4pPr eaLnBrk="1" hangingPunct="1">
                  <a:defRPr>
                    <a:solidFill>
                      <a:schemeClr val="tx2"/>
                    </a:solidFill>
                  </a:defRPr>
                </a:lvl4pPr>
                <a:lvl5pPr eaLnBrk="1" hangingPunct="1">
                  <a:defRPr>
                    <a:solidFill>
                      <a:schemeClr val="tx2"/>
                    </a:solidFill>
                  </a:defRPr>
                </a:lvl5pPr>
                <a:lvl6pPr eaLnBrk="1" hangingPunct="1">
                  <a:defRPr>
                    <a:solidFill>
                      <a:schemeClr val="tx2"/>
                    </a:solidFill>
                  </a:defRPr>
                </a:lvl6pPr>
                <a:lvl7pPr eaLnBrk="1" hangingPunct="1">
                  <a:defRPr>
                    <a:solidFill>
                      <a:schemeClr val="tx2"/>
                    </a:solidFill>
                  </a:defRPr>
                </a:lvl7pPr>
                <a:lvl8pPr eaLnBrk="1" hangingPunct="1">
                  <a:defRPr>
                    <a:solidFill>
                      <a:schemeClr val="tx2"/>
                    </a:solidFill>
                  </a:defRPr>
                </a:lvl8pPr>
                <a:lvl9pPr eaLnBrk="1" hangingPunct="1">
                  <a:defRPr>
                    <a:solidFill>
                      <a:schemeClr val="tx2"/>
                    </a:solidFill>
                  </a:defRPr>
                </a:lvl9pPr>
              </a:lstStyle>
              <a:p>
                <a:r>
                  <a:rPr lang="en-US" altLang="zh-CN" sz="1400" dirty="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TC</a:t>
                </a:r>
                <a:r>
                  <a:rPr lang="en-US" altLang="zh-CN" sz="1400" baseline="-25000" dirty="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baseline="-2500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任意多边形: 形状 22">
                <a:extLst>
                  <a:ext uri="{FF2B5EF4-FFF2-40B4-BE49-F238E27FC236}">
                    <a16:creationId xmlns:a16="http://schemas.microsoft.com/office/drawing/2014/main" id="{E1E07569-5A38-42AE-93C5-A31A96E31CEB}"/>
                  </a:ext>
                </a:extLst>
              </p:cNvPr>
              <p:cNvSpPr/>
              <p:nvPr/>
            </p:nvSpPr>
            <p:spPr>
              <a:xfrm>
                <a:off x="3808057" y="2986761"/>
                <a:ext cx="813837" cy="1080096"/>
              </a:xfrm>
              <a:custGeom>
                <a:avLst/>
                <a:gdLst>
                  <a:gd name="connsiteX0" fmla="*/ 865304 w 868128"/>
                  <a:gd name="connsiteY0" fmla="*/ 0 h 1080096"/>
                  <a:gd name="connsiteX1" fmla="*/ 853031 w 868128"/>
                  <a:gd name="connsiteY1" fmla="*/ 227065 h 1080096"/>
                  <a:gd name="connsiteX2" fmla="*/ 748703 w 868128"/>
                  <a:gd name="connsiteY2" fmla="*/ 417310 h 1080096"/>
                  <a:gd name="connsiteX3" fmla="*/ 540048 w 868128"/>
                  <a:gd name="connsiteY3" fmla="*/ 644376 h 1080096"/>
                  <a:gd name="connsiteX4" fmla="*/ 319119 w 868128"/>
                  <a:gd name="connsiteY4" fmla="*/ 846894 h 1080096"/>
                  <a:gd name="connsiteX5" fmla="*/ 153422 w 868128"/>
                  <a:gd name="connsiteY5" fmla="*/ 981906 h 1080096"/>
                  <a:gd name="connsiteX6" fmla="*/ 0 w 868128"/>
                  <a:gd name="connsiteY6" fmla="*/ 1080096 h 1080096"/>
                  <a:gd name="connsiteX7" fmla="*/ 0 w 868128"/>
                  <a:gd name="connsiteY7" fmla="*/ 1080096 h 1080096"/>
                  <a:gd name="connsiteX0" fmla="*/ 865304 w 865527"/>
                  <a:gd name="connsiteY0" fmla="*/ 0 h 1080096"/>
                  <a:gd name="connsiteX1" fmla="*/ 809353 w 865527"/>
                  <a:gd name="connsiteY1" fmla="*/ 287295 h 1080096"/>
                  <a:gd name="connsiteX2" fmla="*/ 748703 w 865527"/>
                  <a:gd name="connsiteY2" fmla="*/ 417310 h 1080096"/>
                  <a:gd name="connsiteX3" fmla="*/ 540048 w 865527"/>
                  <a:gd name="connsiteY3" fmla="*/ 644376 h 1080096"/>
                  <a:gd name="connsiteX4" fmla="*/ 319119 w 865527"/>
                  <a:gd name="connsiteY4" fmla="*/ 846894 h 1080096"/>
                  <a:gd name="connsiteX5" fmla="*/ 153422 w 865527"/>
                  <a:gd name="connsiteY5" fmla="*/ 981906 h 1080096"/>
                  <a:gd name="connsiteX6" fmla="*/ 0 w 865527"/>
                  <a:gd name="connsiteY6" fmla="*/ 1080096 h 1080096"/>
                  <a:gd name="connsiteX7" fmla="*/ 0 w 865527"/>
                  <a:gd name="connsiteY7" fmla="*/ 1080096 h 1080096"/>
                  <a:gd name="connsiteX0" fmla="*/ 865304 w 865547"/>
                  <a:gd name="connsiteY0" fmla="*/ 0 h 1080096"/>
                  <a:gd name="connsiteX1" fmla="*/ 809353 w 865547"/>
                  <a:gd name="connsiteY1" fmla="*/ 287295 h 1080096"/>
                  <a:gd name="connsiteX2" fmla="*/ 728320 w 865547"/>
                  <a:gd name="connsiteY2" fmla="*/ 444688 h 1080096"/>
                  <a:gd name="connsiteX3" fmla="*/ 540048 w 865547"/>
                  <a:gd name="connsiteY3" fmla="*/ 644376 h 1080096"/>
                  <a:gd name="connsiteX4" fmla="*/ 319119 w 865547"/>
                  <a:gd name="connsiteY4" fmla="*/ 846894 h 1080096"/>
                  <a:gd name="connsiteX5" fmla="*/ 153422 w 865547"/>
                  <a:gd name="connsiteY5" fmla="*/ 981906 h 1080096"/>
                  <a:gd name="connsiteX6" fmla="*/ 0 w 865547"/>
                  <a:gd name="connsiteY6" fmla="*/ 1080096 h 1080096"/>
                  <a:gd name="connsiteX7" fmla="*/ 0 w 865547"/>
                  <a:gd name="connsiteY7" fmla="*/ 1080096 h 1080096"/>
                  <a:gd name="connsiteX0" fmla="*/ 865304 w 865604"/>
                  <a:gd name="connsiteY0" fmla="*/ 0 h 1080096"/>
                  <a:gd name="connsiteX1" fmla="*/ 809353 w 865604"/>
                  <a:gd name="connsiteY1" fmla="*/ 287295 h 1080096"/>
                  <a:gd name="connsiteX2" fmla="*/ 681730 w 865604"/>
                  <a:gd name="connsiteY2" fmla="*/ 485753 h 1080096"/>
                  <a:gd name="connsiteX3" fmla="*/ 540048 w 865604"/>
                  <a:gd name="connsiteY3" fmla="*/ 644376 h 1080096"/>
                  <a:gd name="connsiteX4" fmla="*/ 319119 w 865604"/>
                  <a:gd name="connsiteY4" fmla="*/ 846894 h 1080096"/>
                  <a:gd name="connsiteX5" fmla="*/ 153422 w 865604"/>
                  <a:gd name="connsiteY5" fmla="*/ 981906 h 1080096"/>
                  <a:gd name="connsiteX6" fmla="*/ 0 w 865604"/>
                  <a:gd name="connsiteY6" fmla="*/ 1080096 h 1080096"/>
                  <a:gd name="connsiteX7" fmla="*/ 0 w 865604"/>
                  <a:gd name="connsiteY7" fmla="*/ 1080096 h 1080096"/>
                  <a:gd name="connsiteX0" fmla="*/ 865304 w 865580"/>
                  <a:gd name="connsiteY0" fmla="*/ 0 h 1080096"/>
                  <a:gd name="connsiteX1" fmla="*/ 809353 w 865580"/>
                  <a:gd name="connsiteY1" fmla="*/ 287295 h 1080096"/>
                  <a:gd name="connsiteX2" fmla="*/ 699201 w 865580"/>
                  <a:gd name="connsiteY2" fmla="*/ 496703 h 1080096"/>
                  <a:gd name="connsiteX3" fmla="*/ 540048 w 865580"/>
                  <a:gd name="connsiteY3" fmla="*/ 644376 h 1080096"/>
                  <a:gd name="connsiteX4" fmla="*/ 319119 w 865580"/>
                  <a:gd name="connsiteY4" fmla="*/ 846894 h 1080096"/>
                  <a:gd name="connsiteX5" fmla="*/ 153422 w 865580"/>
                  <a:gd name="connsiteY5" fmla="*/ 981906 h 1080096"/>
                  <a:gd name="connsiteX6" fmla="*/ 0 w 865580"/>
                  <a:gd name="connsiteY6" fmla="*/ 1080096 h 1080096"/>
                  <a:gd name="connsiteX7" fmla="*/ 0 w 865580"/>
                  <a:gd name="connsiteY7" fmla="*/ 1080096 h 1080096"/>
                  <a:gd name="connsiteX0" fmla="*/ 865304 w 865580"/>
                  <a:gd name="connsiteY0" fmla="*/ 0 h 1080096"/>
                  <a:gd name="connsiteX1" fmla="*/ 809353 w 865580"/>
                  <a:gd name="connsiteY1" fmla="*/ 287295 h 1080096"/>
                  <a:gd name="connsiteX2" fmla="*/ 699201 w 865580"/>
                  <a:gd name="connsiteY2" fmla="*/ 496703 h 1080096"/>
                  <a:gd name="connsiteX3" fmla="*/ 551695 w 865580"/>
                  <a:gd name="connsiteY3" fmla="*/ 679966 h 1080096"/>
                  <a:gd name="connsiteX4" fmla="*/ 319119 w 865580"/>
                  <a:gd name="connsiteY4" fmla="*/ 846894 h 1080096"/>
                  <a:gd name="connsiteX5" fmla="*/ 153422 w 865580"/>
                  <a:gd name="connsiteY5" fmla="*/ 981906 h 1080096"/>
                  <a:gd name="connsiteX6" fmla="*/ 0 w 865580"/>
                  <a:gd name="connsiteY6" fmla="*/ 1080096 h 1080096"/>
                  <a:gd name="connsiteX7" fmla="*/ 0 w 865580"/>
                  <a:gd name="connsiteY7" fmla="*/ 1080096 h 1080096"/>
                  <a:gd name="connsiteX0" fmla="*/ 865304 w 865580"/>
                  <a:gd name="connsiteY0" fmla="*/ 0 h 1080096"/>
                  <a:gd name="connsiteX1" fmla="*/ 809353 w 865580"/>
                  <a:gd name="connsiteY1" fmla="*/ 287295 h 1080096"/>
                  <a:gd name="connsiteX2" fmla="*/ 699201 w 865580"/>
                  <a:gd name="connsiteY2" fmla="*/ 496703 h 1080096"/>
                  <a:gd name="connsiteX3" fmla="*/ 551695 w 865580"/>
                  <a:gd name="connsiteY3" fmla="*/ 679966 h 1080096"/>
                  <a:gd name="connsiteX4" fmla="*/ 333678 w 865580"/>
                  <a:gd name="connsiteY4" fmla="*/ 863321 h 1080096"/>
                  <a:gd name="connsiteX5" fmla="*/ 153422 w 865580"/>
                  <a:gd name="connsiteY5" fmla="*/ 981906 h 1080096"/>
                  <a:gd name="connsiteX6" fmla="*/ 0 w 865580"/>
                  <a:gd name="connsiteY6" fmla="*/ 1080096 h 1080096"/>
                  <a:gd name="connsiteX7" fmla="*/ 0 w 865580"/>
                  <a:gd name="connsiteY7" fmla="*/ 1080096 h 1080096"/>
                  <a:gd name="connsiteX0" fmla="*/ 865304 w 865604"/>
                  <a:gd name="connsiteY0" fmla="*/ 0 h 1080096"/>
                  <a:gd name="connsiteX1" fmla="*/ 809353 w 865604"/>
                  <a:gd name="connsiteY1" fmla="*/ 287295 h 1080096"/>
                  <a:gd name="connsiteX2" fmla="*/ 699201 w 865604"/>
                  <a:gd name="connsiteY2" fmla="*/ 496703 h 1080096"/>
                  <a:gd name="connsiteX3" fmla="*/ 551695 w 865604"/>
                  <a:gd name="connsiteY3" fmla="*/ 679966 h 1080096"/>
                  <a:gd name="connsiteX4" fmla="*/ 333678 w 865604"/>
                  <a:gd name="connsiteY4" fmla="*/ 863321 h 1080096"/>
                  <a:gd name="connsiteX5" fmla="*/ 153422 w 865604"/>
                  <a:gd name="connsiteY5" fmla="*/ 981906 h 1080096"/>
                  <a:gd name="connsiteX6" fmla="*/ 0 w 865604"/>
                  <a:gd name="connsiteY6" fmla="*/ 1080096 h 1080096"/>
                  <a:gd name="connsiteX7" fmla="*/ 0 w 865604"/>
                  <a:gd name="connsiteY7" fmla="*/ 1080096 h 1080096"/>
                  <a:gd name="connsiteX0" fmla="*/ 865304 w 865604"/>
                  <a:gd name="connsiteY0" fmla="*/ 0 h 1080096"/>
                  <a:gd name="connsiteX1" fmla="*/ 809353 w 865604"/>
                  <a:gd name="connsiteY1" fmla="*/ 287295 h 1080096"/>
                  <a:gd name="connsiteX2" fmla="*/ 699201 w 865604"/>
                  <a:gd name="connsiteY2" fmla="*/ 496703 h 1080096"/>
                  <a:gd name="connsiteX3" fmla="*/ 551695 w 865604"/>
                  <a:gd name="connsiteY3" fmla="*/ 679966 h 1080096"/>
                  <a:gd name="connsiteX4" fmla="*/ 333678 w 865604"/>
                  <a:gd name="connsiteY4" fmla="*/ 863321 h 1080096"/>
                  <a:gd name="connsiteX5" fmla="*/ 153422 w 865604"/>
                  <a:gd name="connsiteY5" fmla="*/ 987382 h 1080096"/>
                  <a:gd name="connsiteX6" fmla="*/ 0 w 865604"/>
                  <a:gd name="connsiteY6" fmla="*/ 1080096 h 1080096"/>
                  <a:gd name="connsiteX7" fmla="*/ 0 w 865604"/>
                  <a:gd name="connsiteY7" fmla="*/ 1080096 h 108009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865604" h="1080096">
                    <a:moveTo>
                      <a:pt x="865304" y="0"/>
                    </a:moveTo>
                    <a:cubicBezTo>
                      <a:pt x="868884" y="78756"/>
                      <a:pt x="839949" y="204511"/>
                      <a:pt x="809353" y="287295"/>
                    </a:cubicBezTo>
                    <a:cubicBezTo>
                      <a:pt x="778757" y="370079"/>
                      <a:pt x="742144" y="431258"/>
                      <a:pt x="699201" y="496703"/>
                    </a:cubicBezTo>
                    <a:cubicBezTo>
                      <a:pt x="656258" y="562148"/>
                      <a:pt x="612615" y="618863"/>
                      <a:pt x="551695" y="679966"/>
                    </a:cubicBezTo>
                    <a:cubicBezTo>
                      <a:pt x="490775" y="741069"/>
                      <a:pt x="400057" y="812085"/>
                      <a:pt x="333678" y="863321"/>
                    </a:cubicBezTo>
                    <a:cubicBezTo>
                      <a:pt x="267299" y="914557"/>
                      <a:pt x="209035" y="951253"/>
                      <a:pt x="153422" y="987382"/>
                    </a:cubicBezTo>
                    <a:lnTo>
                      <a:pt x="0" y="1080096"/>
                    </a:lnTo>
                    <a:lnTo>
                      <a:pt x="0" y="1080096"/>
                    </a:ln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任意多边形: 形状 23">
                <a:extLst>
                  <a:ext uri="{FF2B5EF4-FFF2-40B4-BE49-F238E27FC236}">
                    <a16:creationId xmlns:a16="http://schemas.microsoft.com/office/drawing/2014/main" id="{1D6C4C10-C3B3-467D-9094-5CA1550D32A3}"/>
                  </a:ext>
                </a:extLst>
              </p:cNvPr>
              <p:cNvSpPr/>
              <p:nvPr/>
            </p:nvSpPr>
            <p:spPr>
              <a:xfrm flipH="1">
                <a:off x="4756250" y="2986760"/>
                <a:ext cx="813836" cy="1080097"/>
              </a:xfrm>
              <a:custGeom>
                <a:avLst/>
                <a:gdLst>
                  <a:gd name="connsiteX0" fmla="*/ 865304 w 868128"/>
                  <a:gd name="connsiteY0" fmla="*/ 0 h 1080096"/>
                  <a:gd name="connsiteX1" fmla="*/ 853031 w 868128"/>
                  <a:gd name="connsiteY1" fmla="*/ 227065 h 1080096"/>
                  <a:gd name="connsiteX2" fmla="*/ 748703 w 868128"/>
                  <a:gd name="connsiteY2" fmla="*/ 417310 h 1080096"/>
                  <a:gd name="connsiteX3" fmla="*/ 540048 w 868128"/>
                  <a:gd name="connsiteY3" fmla="*/ 644376 h 1080096"/>
                  <a:gd name="connsiteX4" fmla="*/ 319119 w 868128"/>
                  <a:gd name="connsiteY4" fmla="*/ 846894 h 1080096"/>
                  <a:gd name="connsiteX5" fmla="*/ 153422 w 868128"/>
                  <a:gd name="connsiteY5" fmla="*/ 981906 h 1080096"/>
                  <a:gd name="connsiteX6" fmla="*/ 0 w 868128"/>
                  <a:gd name="connsiteY6" fmla="*/ 1080096 h 1080096"/>
                  <a:gd name="connsiteX7" fmla="*/ 0 w 868128"/>
                  <a:gd name="connsiteY7" fmla="*/ 1080096 h 1080096"/>
                  <a:gd name="connsiteX0" fmla="*/ 865304 w 865527"/>
                  <a:gd name="connsiteY0" fmla="*/ 0 h 1080096"/>
                  <a:gd name="connsiteX1" fmla="*/ 809353 w 865527"/>
                  <a:gd name="connsiteY1" fmla="*/ 287295 h 1080096"/>
                  <a:gd name="connsiteX2" fmla="*/ 748703 w 865527"/>
                  <a:gd name="connsiteY2" fmla="*/ 417310 h 1080096"/>
                  <a:gd name="connsiteX3" fmla="*/ 540048 w 865527"/>
                  <a:gd name="connsiteY3" fmla="*/ 644376 h 1080096"/>
                  <a:gd name="connsiteX4" fmla="*/ 319119 w 865527"/>
                  <a:gd name="connsiteY4" fmla="*/ 846894 h 1080096"/>
                  <a:gd name="connsiteX5" fmla="*/ 153422 w 865527"/>
                  <a:gd name="connsiteY5" fmla="*/ 981906 h 1080096"/>
                  <a:gd name="connsiteX6" fmla="*/ 0 w 865527"/>
                  <a:gd name="connsiteY6" fmla="*/ 1080096 h 1080096"/>
                  <a:gd name="connsiteX7" fmla="*/ 0 w 865527"/>
                  <a:gd name="connsiteY7" fmla="*/ 1080096 h 1080096"/>
                  <a:gd name="connsiteX0" fmla="*/ 865304 w 865547"/>
                  <a:gd name="connsiteY0" fmla="*/ 0 h 1080096"/>
                  <a:gd name="connsiteX1" fmla="*/ 809353 w 865547"/>
                  <a:gd name="connsiteY1" fmla="*/ 287295 h 1080096"/>
                  <a:gd name="connsiteX2" fmla="*/ 728320 w 865547"/>
                  <a:gd name="connsiteY2" fmla="*/ 444688 h 1080096"/>
                  <a:gd name="connsiteX3" fmla="*/ 540048 w 865547"/>
                  <a:gd name="connsiteY3" fmla="*/ 644376 h 1080096"/>
                  <a:gd name="connsiteX4" fmla="*/ 319119 w 865547"/>
                  <a:gd name="connsiteY4" fmla="*/ 846894 h 1080096"/>
                  <a:gd name="connsiteX5" fmla="*/ 153422 w 865547"/>
                  <a:gd name="connsiteY5" fmla="*/ 981906 h 1080096"/>
                  <a:gd name="connsiteX6" fmla="*/ 0 w 865547"/>
                  <a:gd name="connsiteY6" fmla="*/ 1080096 h 1080096"/>
                  <a:gd name="connsiteX7" fmla="*/ 0 w 865547"/>
                  <a:gd name="connsiteY7" fmla="*/ 1080096 h 1080096"/>
                  <a:gd name="connsiteX0" fmla="*/ 865304 w 865604"/>
                  <a:gd name="connsiteY0" fmla="*/ 0 h 1080096"/>
                  <a:gd name="connsiteX1" fmla="*/ 809353 w 865604"/>
                  <a:gd name="connsiteY1" fmla="*/ 287295 h 1080096"/>
                  <a:gd name="connsiteX2" fmla="*/ 681730 w 865604"/>
                  <a:gd name="connsiteY2" fmla="*/ 485753 h 1080096"/>
                  <a:gd name="connsiteX3" fmla="*/ 540048 w 865604"/>
                  <a:gd name="connsiteY3" fmla="*/ 644376 h 1080096"/>
                  <a:gd name="connsiteX4" fmla="*/ 319119 w 865604"/>
                  <a:gd name="connsiteY4" fmla="*/ 846894 h 1080096"/>
                  <a:gd name="connsiteX5" fmla="*/ 153422 w 865604"/>
                  <a:gd name="connsiteY5" fmla="*/ 981906 h 1080096"/>
                  <a:gd name="connsiteX6" fmla="*/ 0 w 865604"/>
                  <a:gd name="connsiteY6" fmla="*/ 1080096 h 1080096"/>
                  <a:gd name="connsiteX7" fmla="*/ 0 w 865604"/>
                  <a:gd name="connsiteY7" fmla="*/ 1080096 h 1080096"/>
                  <a:gd name="connsiteX0" fmla="*/ 865304 w 865580"/>
                  <a:gd name="connsiteY0" fmla="*/ 0 h 1080096"/>
                  <a:gd name="connsiteX1" fmla="*/ 809353 w 865580"/>
                  <a:gd name="connsiteY1" fmla="*/ 287295 h 1080096"/>
                  <a:gd name="connsiteX2" fmla="*/ 699201 w 865580"/>
                  <a:gd name="connsiteY2" fmla="*/ 496703 h 1080096"/>
                  <a:gd name="connsiteX3" fmla="*/ 540048 w 865580"/>
                  <a:gd name="connsiteY3" fmla="*/ 644376 h 1080096"/>
                  <a:gd name="connsiteX4" fmla="*/ 319119 w 865580"/>
                  <a:gd name="connsiteY4" fmla="*/ 846894 h 1080096"/>
                  <a:gd name="connsiteX5" fmla="*/ 153422 w 865580"/>
                  <a:gd name="connsiteY5" fmla="*/ 981906 h 1080096"/>
                  <a:gd name="connsiteX6" fmla="*/ 0 w 865580"/>
                  <a:gd name="connsiteY6" fmla="*/ 1080096 h 1080096"/>
                  <a:gd name="connsiteX7" fmla="*/ 0 w 865580"/>
                  <a:gd name="connsiteY7" fmla="*/ 1080096 h 1080096"/>
                  <a:gd name="connsiteX0" fmla="*/ 865304 w 865580"/>
                  <a:gd name="connsiteY0" fmla="*/ 0 h 1080096"/>
                  <a:gd name="connsiteX1" fmla="*/ 809353 w 865580"/>
                  <a:gd name="connsiteY1" fmla="*/ 287295 h 1080096"/>
                  <a:gd name="connsiteX2" fmla="*/ 699201 w 865580"/>
                  <a:gd name="connsiteY2" fmla="*/ 496703 h 1080096"/>
                  <a:gd name="connsiteX3" fmla="*/ 551695 w 865580"/>
                  <a:gd name="connsiteY3" fmla="*/ 679966 h 1080096"/>
                  <a:gd name="connsiteX4" fmla="*/ 319119 w 865580"/>
                  <a:gd name="connsiteY4" fmla="*/ 846894 h 1080096"/>
                  <a:gd name="connsiteX5" fmla="*/ 153422 w 865580"/>
                  <a:gd name="connsiteY5" fmla="*/ 981906 h 1080096"/>
                  <a:gd name="connsiteX6" fmla="*/ 0 w 865580"/>
                  <a:gd name="connsiteY6" fmla="*/ 1080096 h 1080096"/>
                  <a:gd name="connsiteX7" fmla="*/ 0 w 865580"/>
                  <a:gd name="connsiteY7" fmla="*/ 1080096 h 1080096"/>
                  <a:gd name="connsiteX0" fmla="*/ 865304 w 865580"/>
                  <a:gd name="connsiteY0" fmla="*/ 0 h 1080096"/>
                  <a:gd name="connsiteX1" fmla="*/ 809353 w 865580"/>
                  <a:gd name="connsiteY1" fmla="*/ 287295 h 1080096"/>
                  <a:gd name="connsiteX2" fmla="*/ 699201 w 865580"/>
                  <a:gd name="connsiteY2" fmla="*/ 496703 h 1080096"/>
                  <a:gd name="connsiteX3" fmla="*/ 551695 w 865580"/>
                  <a:gd name="connsiteY3" fmla="*/ 679966 h 1080096"/>
                  <a:gd name="connsiteX4" fmla="*/ 333678 w 865580"/>
                  <a:gd name="connsiteY4" fmla="*/ 863321 h 1080096"/>
                  <a:gd name="connsiteX5" fmla="*/ 153422 w 865580"/>
                  <a:gd name="connsiteY5" fmla="*/ 981906 h 1080096"/>
                  <a:gd name="connsiteX6" fmla="*/ 0 w 865580"/>
                  <a:gd name="connsiteY6" fmla="*/ 1080096 h 1080096"/>
                  <a:gd name="connsiteX7" fmla="*/ 0 w 865580"/>
                  <a:gd name="connsiteY7" fmla="*/ 1080096 h 1080096"/>
                  <a:gd name="connsiteX0" fmla="*/ 865304 w 865604"/>
                  <a:gd name="connsiteY0" fmla="*/ 0 h 1080096"/>
                  <a:gd name="connsiteX1" fmla="*/ 809353 w 865604"/>
                  <a:gd name="connsiteY1" fmla="*/ 287295 h 1080096"/>
                  <a:gd name="connsiteX2" fmla="*/ 699201 w 865604"/>
                  <a:gd name="connsiteY2" fmla="*/ 496703 h 1080096"/>
                  <a:gd name="connsiteX3" fmla="*/ 551695 w 865604"/>
                  <a:gd name="connsiteY3" fmla="*/ 679966 h 1080096"/>
                  <a:gd name="connsiteX4" fmla="*/ 333678 w 865604"/>
                  <a:gd name="connsiteY4" fmla="*/ 863321 h 1080096"/>
                  <a:gd name="connsiteX5" fmla="*/ 153422 w 865604"/>
                  <a:gd name="connsiteY5" fmla="*/ 981906 h 1080096"/>
                  <a:gd name="connsiteX6" fmla="*/ 0 w 865604"/>
                  <a:gd name="connsiteY6" fmla="*/ 1080096 h 1080096"/>
                  <a:gd name="connsiteX7" fmla="*/ 0 w 865604"/>
                  <a:gd name="connsiteY7" fmla="*/ 1080096 h 1080096"/>
                  <a:gd name="connsiteX0" fmla="*/ 865304 w 865604"/>
                  <a:gd name="connsiteY0" fmla="*/ 0 h 1080096"/>
                  <a:gd name="connsiteX1" fmla="*/ 809353 w 865604"/>
                  <a:gd name="connsiteY1" fmla="*/ 287295 h 1080096"/>
                  <a:gd name="connsiteX2" fmla="*/ 699201 w 865604"/>
                  <a:gd name="connsiteY2" fmla="*/ 496703 h 1080096"/>
                  <a:gd name="connsiteX3" fmla="*/ 551695 w 865604"/>
                  <a:gd name="connsiteY3" fmla="*/ 679966 h 1080096"/>
                  <a:gd name="connsiteX4" fmla="*/ 333678 w 865604"/>
                  <a:gd name="connsiteY4" fmla="*/ 863321 h 1080096"/>
                  <a:gd name="connsiteX5" fmla="*/ 153422 w 865604"/>
                  <a:gd name="connsiteY5" fmla="*/ 987382 h 1080096"/>
                  <a:gd name="connsiteX6" fmla="*/ 0 w 865604"/>
                  <a:gd name="connsiteY6" fmla="*/ 1080096 h 1080096"/>
                  <a:gd name="connsiteX7" fmla="*/ 0 w 865604"/>
                  <a:gd name="connsiteY7" fmla="*/ 1080096 h 108009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865604" h="1080096">
                    <a:moveTo>
                      <a:pt x="865304" y="0"/>
                    </a:moveTo>
                    <a:cubicBezTo>
                      <a:pt x="868884" y="78756"/>
                      <a:pt x="839949" y="204511"/>
                      <a:pt x="809353" y="287295"/>
                    </a:cubicBezTo>
                    <a:cubicBezTo>
                      <a:pt x="778757" y="370079"/>
                      <a:pt x="742144" y="431258"/>
                      <a:pt x="699201" y="496703"/>
                    </a:cubicBezTo>
                    <a:cubicBezTo>
                      <a:pt x="656258" y="562148"/>
                      <a:pt x="612615" y="618863"/>
                      <a:pt x="551695" y="679966"/>
                    </a:cubicBezTo>
                    <a:cubicBezTo>
                      <a:pt x="490775" y="741069"/>
                      <a:pt x="400057" y="812085"/>
                      <a:pt x="333678" y="863321"/>
                    </a:cubicBezTo>
                    <a:cubicBezTo>
                      <a:pt x="267299" y="914557"/>
                      <a:pt x="209035" y="951253"/>
                      <a:pt x="153422" y="987382"/>
                    </a:cubicBezTo>
                    <a:lnTo>
                      <a:pt x="0" y="1080096"/>
                    </a:lnTo>
                    <a:lnTo>
                      <a:pt x="0" y="1080096"/>
                    </a:ln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直接箭头连接符 24">
                <a:extLst>
                  <a:ext uri="{FF2B5EF4-FFF2-40B4-BE49-F238E27FC236}">
                    <a16:creationId xmlns:a16="http://schemas.microsoft.com/office/drawing/2014/main" id="{6C866392-340B-4A76-BE01-551843489115}"/>
                  </a:ext>
                </a:extLst>
              </p:cNvPr>
              <p:cNvCxnSpPr/>
              <p:nvPr/>
            </p:nvCxnSpPr>
            <p:spPr>
              <a:xfrm>
                <a:off x="6350195" y="4113019"/>
                <a:ext cx="1016000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664ECE75-0591-4FCD-A6F9-7A1EC0867D30}"/>
                  </a:ext>
                </a:extLst>
              </p:cNvPr>
              <p:cNvGrpSpPr/>
              <p:nvPr/>
            </p:nvGrpSpPr>
            <p:grpSpPr>
              <a:xfrm>
                <a:off x="6626248" y="3496613"/>
                <a:ext cx="2527890" cy="1833423"/>
                <a:chOff x="6626248" y="3496613"/>
                <a:chExt cx="2527890" cy="1833423"/>
              </a:xfrm>
            </p:grpSpPr>
            <p:sp>
              <p:nvSpPr>
                <p:cNvPr id="39" name="流程图: 直接访问存储器 38">
                  <a:extLst>
                    <a:ext uri="{FF2B5EF4-FFF2-40B4-BE49-F238E27FC236}">
                      <a16:creationId xmlns:a16="http://schemas.microsoft.com/office/drawing/2014/main" id="{37943AEE-4B74-4419-9811-ECAC0CB28E9F}"/>
                    </a:ext>
                  </a:extLst>
                </p:cNvPr>
                <p:cNvSpPr/>
                <p:nvPr/>
              </p:nvSpPr>
              <p:spPr>
                <a:xfrm>
                  <a:off x="6854465" y="4017287"/>
                  <a:ext cx="309135" cy="208398"/>
                </a:xfrm>
                <a:prstGeom prst="flowChartMagneticDrum">
                  <a:avLst/>
                </a:prstGeom>
                <a:solidFill>
                  <a:schemeClr val="accent2">
                    <a:lumMod val="60000"/>
                    <a:lumOff val="40000"/>
                  </a:schemeClr>
                </a:solidFill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标题 1">
                  <a:extLst>
                    <a:ext uri="{FF2B5EF4-FFF2-40B4-BE49-F238E27FC236}">
                      <a16:creationId xmlns:a16="http://schemas.microsoft.com/office/drawing/2014/main" id="{DF321CE8-8846-4F59-9568-483FAF3D3471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7255155" y="4863331"/>
                  <a:ext cx="1898983" cy="466705"/>
                </a:xfrm>
                <a:prstGeom prst="rect">
                  <a:avLst/>
                </a:prstGeom>
              </p:spPr>
              <p:txBody>
                <a:bodyPr vert="horz" lIns="91440" tIns="45720" rIns="91440" bIns="45720" rtlCol="0" anchor="t">
                  <a:noAutofit/>
                </a:bodyPr>
                <a:lstStyle>
                  <a:lvl1pPr algn="l" defTabSz="457200" rtl="0" eaLnBrk="1" latinLnBrk="0" hangingPunct="1">
                    <a:spcBef>
                      <a:spcPct val="0"/>
                    </a:spcBef>
                    <a:buNone/>
                    <a:defRPr sz="3600" b="1" kern="1200">
                      <a:solidFill>
                        <a:schemeClr val="tx1">
                          <a:lumMod val="85000"/>
                          <a:lumOff val="15000"/>
                        </a:schemeClr>
                      </a:solidFill>
                      <a:latin typeface="Times New Roman" panose="02020603050405020304" pitchFamily="18" charset="0"/>
                      <a:ea typeface="+mj-ea"/>
                      <a:cs typeface="Times New Roman" panose="02020603050405020304" pitchFamily="18" charset="0"/>
                    </a:defRPr>
                  </a:lvl1pPr>
                  <a:lvl2pPr eaLnBrk="1" hangingPunct="1">
                    <a:defRPr>
                      <a:solidFill>
                        <a:schemeClr val="tx2"/>
                      </a:solidFill>
                    </a:defRPr>
                  </a:lvl2pPr>
                  <a:lvl3pPr eaLnBrk="1" hangingPunct="1">
                    <a:defRPr>
                      <a:solidFill>
                        <a:schemeClr val="tx2"/>
                      </a:solidFill>
                    </a:defRPr>
                  </a:lvl3pPr>
                  <a:lvl4pPr eaLnBrk="1" hangingPunct="1">
                    <a:defRPr>
                      <a:solidFill>
                        <a:schemeClr val="tx2"/>
                      </a:solidFill>
                    </a:defRPr>
                  </a:lvl4pPr>
                  <a:lvl5pPr eaLnBrk="1" hangingPunct="1">
                    <a:defRPr>
                      <a:solidFill>
                        <a:schemeClr val="tx2"/>
                      </a:solidFill>
                    </a:defRPr>
                  </a:lvl5pPr>
                  <a:lvl6pPr eaLnBrk="1" hangingPunct="1">
                    <a:defRPr>
                      <a:solidFill>
                        <a:schemeClr val="tx2"/>
                      </a:solidFill>
                    </a:defRPr>
                  </a:lvl6pPr>
                  <a:lvl7pPr eaLnBrk="1" hangingPunct="1">
                    <a:defRPr>
                      <a:solidFill>
                        <a:schemeClr val="tx2"/>
                      </a:solidFill>
                    </a:defRPr>
                  </a:lvl7pPr>
                  <a:lvl8pPr eaLnBrk="1" hangingPunct="1">
                    <a:defRPr>
                      <a:solidFill>
                        <a:schemeClr val="tx2"/>
                      </a:solidFill>
                    </a:defRPr>
                  </a:lvl8pPr>
                  <a:lvl9pPr eaLnBrk="1" hangingPunct="1">
                    <a:defRPr>
                      <a:solidFill>
                        <a:schemeClr val="tx2"/>
                      </a:solidFill>
                    </a:defRPr>
                  </a:lvl9pPr>
                </a:lstStyle>
                <a:p>
                  <a:r>
                    <a:rPr lang="en-US" altLang="zh-CN" sz="1400" dirty="0">
                      <a:solidFill>
                        <a:schemeClr val="tx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TC</a:t>
                  </a:r>
                  <a:r>
                    <a:rPr lang="en-US" altLang="zh-CN" sz="1400" baseline="-25000" dirty="0">
                      <a:solidFill>
                        <a:schemeClr val="tx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zh-CN" sz="1400" dirty="0">
                      <a:solidFill>
                        <a:schemeClr val="tx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en-US" altLang="zh-CN" sz="1400" baseline="-25000" dirty="0">
                      <a:solidFill>
                        <a:schemeClr val="tx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r>
                    <a:rPr lang="en-US" altLang="zh-CN" sz="1400" dirty="0">
                      <a:solidFill>
                        <a:schemeClr val="tx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  <a:r>
                    <a:rPr lang="en-US" altLang="zh-CN" sz="1400" baseline="-25000" dirty="0">
                      <a:solidFill>
                        <a:schemeClr val="tx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lang="zh-CN" altLang="en-US" sz="1400" baseline="-2500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箭头: 五边形 40">
                  <a:extLst>
                    <a:ext uri="{FF2B5EF4-FFF2-40B4-BE49-F238E27FC236}">
                      <a16:creationId xmlns:a16="http://schemas.microsoft.com/office/drawing/2014/main" id="{11092ECF-B87E-4ADE-BC24-7142821FCA76}"/>
                    </a:ext>
                  </a:extLst>
                </p:cNvPr>
                <p:cNvSpPr/>
                <p:nvPr/>
              </p:nvSpPr>
              <p:spPr>
                <a:xfrm rot="16200000">
                  <a:off x="7586327" y="4060319"/>
                  <a:ext cx="189185" cy="215461"/>
                </a:xfrm>
                <a:prstGeom prst="homePlate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箭头: 五边形 41">
                  <a:extLst>
                    <a:ext uri="{FF2B5EF4-FFF2-40B4-BE49-F238E27FC236}">
                      <a16:creationId xmlns:a16="http://schemas.microsoft.com/office/drawing/2014/main" id="{6E527D69-EB1E-45E9-A106-9D843C9C574A}"/>
                    </a:ext>
                  </a:extLst>
                </p:cNvPr>
                <p:cNvSpPr/>
                <p:nvPr/>
              </p:nvSpPr>
              <p:spPr>
                <a:xfrm rot="16200000">
                  <a:off x="7344796" y="4415919"/>
                  <a:ext cx="189185" cy="215461"/>
                </a:xfrm>
                <a:prstGeom prst="homePlate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箭头: 五边形 42">
                  <a:extLst>
                    <a:ext uri="{FF2B5EF4-FFF2-40B4-BE49-F238E27FC236}">
                      <a16:creationId xmlns:a16="http://schemas.microsoft.com/office/drawing/2014/main" id="{EA249431-5562-4D19-9F19-5ADFA805A2F5}"/>
                    </a:ext>
                  </a:extLst>
                </p:cNvPr>
                <p:cNvSpPr/>
                <p:nvPr/>
              </p:nvSpPr>
              <p:spPr>
                <a:xfrm rot="16200000">
                  <a:off x="7901646" y="4415918"/>
                  <a:ext cx="189185" cy="215461"/>
                </a:xfrm>
                <a:prstGeom prst="homePlate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箭头: 五边形 43">
                  <a:extLst>
                    <a:ext uri="{FF2B5EF4-FFF2-40B4-BE49-F238E27FC236}">
                      <a16:creationId xmlns:a16="http://schemas.microsoft.com/office/drawing/2014/main" id="{D80F637F-17E0-44A2-85CD-54C5EAE738EA}"/>
                    </a:ext>
                  </a:extLst>
                </p:cNvPr>
                <p:cNvSpPr/>
                <p:nvPr/>
              </p:nvSpPr>
              <p:spPr>
                <a:xfrm rot="16200000">
                  <a:off x="7934273" y="3730586"/>
                  <a:ext cx="189185" cy="215461"/>
                </a:xfrm>
                <a:prstGeom prst="homePlate">
                  <a:avLst/>
                </a:prstGeom>
                <a:solidFill>
                  <a:schemeClr val="accent1">
                    <a:lumMod val="20000"/>
                    <a:lumOff val="80000"/>
                  </a:schemeClr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标题 1">
                  <a:extLst>
                    <a:ext uri="{FF2B5EF4-FFF2-40B4-BE49-F238E27FC236}">
                      <a16:creationId xmlns:a16="http://schemas.microsoft.com/office/drawing/2014/main" id="{3DDECA00-8717-42E0-9E30-24225D603FE8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6626248" y="3496613"/>
                  <a:ext cx="1330058" cy="411769"/>
                </a:xfrm>
                <a:prstGeom prst="rect">
                  <a:avLst/>
                </a:prstGeom>
              </p:spPr>
              <p:txBody>
                <a:bodyPr vert="horz" lIns="91440" tIns="45720" rIns="91440" bIns="45720" rtlCol="0" anchor="t">
                  <a:noAutofit/>
                </a:bodyPr>
                <a:lstStyle>
                  <a:lvl1pPr algn="l" defTabSz="457200" rtl="0" eaLnBrk="1" latinLnBrk="0" hangingPunct="1">
                    <a:spcBef>
                      <a:spcPct val="0"/>
                    </a:spcBef>
                    <a:buNone/>
                    <a:defRPr sz="3600" b="1" kern="1200">
                      <a:solidFill>
                        <a:schemeClr val="tx1">
                          <a:lumMod val="85000"/>
                          <a:lumOff val="15000"/>
                        </a:schemeClr>
                      </a:solidFill>
                      <a:latin typeface="Times New Roman" panose="02020603050405020304" pitchFamily="18" charset="0"/>
                      <a:ea typeface="+mj-ea"/>
                      <a:cs typeface="Times New Roman" panose="02020603050405020304" pitchFamily="18" charset="0"/>
                    </a:defRPr>
                  </a:lvl1pPr>
                  <a:lvl2pPr eaLnBrk="1" hangingPunct="1">
                    <a:defRPr>
                      <a:solidFill>
                        <a:schemeClr val="tx2"/>
                      </a:solidFill>
                    </a:defRPr>
                  </a:lvl2pPr>
                  <a:lvl3pPr eaLnBrk="1" hangingPunct="1">
                    <a:defRPr>
                      <a:solidFill>
                        <a:schemeClr val="tx2"/>
                      </a:solidFill>
                    </a:defRPr>
                  </a:lvl3pPr>
                  <a:lvl4pPr eaLnBrk="1" hangingPunct="1">
                    <a:defRPr>
                      <a:solidFill>
                        <a:schemeClr val="tx2"/>
                      </a:solidFill>
                    </a:defRPr>
                  </a:lvl4pPr>
                  <a:lvl5pPr eaLnBrk="1" hangingPunct="1">
                    <a:defRPr>
                      <a:solidFill>
                        <a:schemeClr val="tx2"/>
                      </a:solidFill>
                    </a:defRPr>
                  </a:lvl5pPr>
                  <a:lvl6pPr eaLnBrk="1" hangingPunct="1">
                    <a:defRPr>
                      <a:solidFill>
                        <a:schemeClr val="tx2"/>
                      </a:solidFill>
                    </a:defRPr>
                  </a:lvl6pPr>
                  <a:lvl7pPr eaLnBrk="1" hangingPunct="1">
                    <a:defRPr>
                      <a:solidFill>
                        <a:schemeClr val="tx2"/>
                      </a:solidFill>
                    </a:defRPr>
                  </a:lvl7pPr>
                  <a:lvl8pPr eaLnBrk="1" hangingPunct="1">
                    <a:defRPr>
                      <a:solidFill>
                        <a:schemeClr val="tx2"/>
                      </a:solidFill>
                    </a:defRPr>
                  </a:lvl8pPr>
                  <a:lvl9pPr eaLnBrk="1" hangingPunct="1">
                    <a:defRPr>
                      <a:solidFill>
                        <a:schemeClr val="tx2"/>
                      </a:solidFill>
                    </a:defRPr>
                  </a:lvl9pPr>
                </a:lstStyle>
                <a:p>
                  <a:r>
                    <a:rPr lang="en-US" altLang="zh-CN" sz="1400" dirty="0">
                      <a:solidFill>
                        <a:schemeClr val="tx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RP1</a:t>
                  </a:r>
                  <a:endParaRPr lang="zh-CN" altLang="en-US" sz="140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7" name="六边形 26">
                <a:extLst>
                  <a:ext uri="{FF2B5EF4-FFF2-40B4-BE49-F238E27FC236}">
                    <a16:creationId xmlns:a16="http://schemas.microsoft.com/office/drawing/2014/main" id="{ED641AD2-54B4-4B8B-A684-38B41CD8A158}"/>
                  </a:ext>
                </a:extLst>
              </p:cNvPr>
              <p:cNvSpPr/>
              <p:nvPr/>
            </p:nvSpPr>
            <p:spPr>
              <a:xfrm>
                <a:off x="4711785" y="2742309"/>
                <a:ext cx="325821" cy="231228"/>
              </a:xfrm>
              <a:prstGeom prst="hexagon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菱形 27">
                <a:extLst>
                  <a:ext uri="{FF2B5EF4-FFF2-40B4-BE49-F238E27FC236}">
                    <a16:creationId xmlns:a16="http://schemas.microsoft.com/office/drawing/2014/main" id="{A2930C6B-91D9-4808-A801-291415FD918C}"/>
                  </a:ext>
                </a:extLst>
              </p:cNvPr>
              <p:cNvSpPr/>
              <p:nvPr/>
            </p:nvSpPr>
            <p:spPr>
              <a:xfrm>
                <a:off x="3310804" y="4256688"/>
                <a:ext cx="310055" cy="273268"/>
              </a:xfrm>
              <a:prstGeom prst="diamon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菱形 28">
                <a:extLst>
                  <a:ext uri="{FF2B5EF4-FFF2-40B4-BE49-F238E27FC236}">
                    <a16:creationId xmlns:a16="http://schemas.microsoft.com/office/drawing/2014/main" id="{E8542F0B-3A03-404B-BFFE-B2A3C91C3711}"/>
                  </a:ext>
                </a:extLst>
              </p:cNvPr>
              <p:cNvSpPr/>
              <p:nvPr/>
            </p:nvSpPr>
            <p:spPr>
              <a:xfrm>
                <a:off x="3759778" y="4240044"/>
                <a:ext cx="310055" cy="273268"/>
              </a:xfrm>
              <a:prstGeom prst="diamon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箭头: 五边形 29">
                <a:extLst>
                  <a:ext uri="{FF2B5EF4-FFF2-40B4-BE49-F238E27FC236}">
                    <a16:creationId xmlns:a16="http://schemas.microsoft.com/office/drawing/2014/main" id="{79021D9D-EB85-4ADA-9F23-18FD7BC871DA}"/>
                  </a:ext>
                </a:extLst>
              </p:cNvPr>
              <p:cNvSpPr/>
              <p:nvPr/>
            </p:nvSpPr>
            <p:spPr>
              <a:xfrm rot="16200000">
                <a:off x="5850428" y="4226906"/>
                <a:ext cx="189185" cy="215461"/>
              </a:xfrm>
              <a:prstGeom prst="homePlate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accent1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箭头: 五边形 30">
                <a:extLst>
                  <a:ext uri="{FF2B5EF4-FFF2-40B4-BE49-F238E27FC236}">
                    <a16:creationId xmlns:a16="http://schemas.microsoft.com/office/drawing/2014/main" id="{B4F538D2-9DB4-425D-A355-A6BF6071260A}"/>
                  </a:ext>
                </a:extLst>
              </p:cNvPr>
              <p:cNvSpPr/>
              <p:nvPr/>
            </p:nvSpPr>
            <p:spPr>
              <a:xfrm rot="16200000">
                <a:off x="5439946" y="4226905"/>
                <a:ext cx="189185" cy="215461"/>
              </a:xfrm>
              <a:prstGeom prst="homePlate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>
                <a:solidFill>
                  <a:schemeClr val="accent1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六边形 31">
                <a:extLst>
                  <a:ext uri="{FF2B5EF4-FFF2-40B4-BE49-F238E27FC236}">
                    <a16:creationId xmlns:a16="http://schemas.microsoft.com/office/drawing/2014/main" id="{BDDE9373-9DA6-4D7D-BDFF-DC754AAB07EA}"/>
                  </a:ext>
                </a:extLst>
              </p:cNvPr>
              <p:cNvSpPr/>
              <p:nvPr/>
            </p:nvSpPr>
            <p:spPr>
              <a:xfrm>
                <a:off x="4509327" y="2423544"/>
                <a:ext cx="325821" cy="231228"/>
              </a:xfrm>
              <a:prstGeom prst="hexagon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5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2A886277-60FB-4EF6-8BFC-3ABEDB195F96}"/>
                  </a:ext>
                </a:extLst>
              </p:cNvPr>
              <p:cNvCxnSpPr/>
              <p:nvPr/>
            </p:nvCxnSpPr>
            <p:spPr>
              <a:xfrm>
                <a:off x="4689171" y="2986760"/>
                <a:ext cx="0" cy="1639948"/>
              </a:xfrm>
              <a:prstGeom prst="line">
                <a:avLst/>
              </a:prstGeom>
              <a:ln w="12700">
                <a:solidFill>
                  <a:schemeClr val="accent5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等腰三角形 33">
                <a:extLst>
                  <a:ext uri="{FF2B5EF4-FFF2-40B4-BE49-F238E27FC236}">
                    <a16:creationId xmlns:a16="http://schemas.microsoft.com/office/drawing/2014/main" id="{0DF66177-2703-4921-88A3-D48C89E3ABA8}"/>
                  </a:ext>
                </a:extLst>
              </p:cNvPr>
              <p:cNvSpPr/>
              <p:nvPr/>
            </p:nvSpPr>
            <p:spPr>
              <a:xfrm>
                <a:off x="4593438" y="4727468"/>
                <a:ext cx="191466" cy="231228"/>
              </a:xfrm>
              <a:prstGeom prst="triangle">
                <a:avLst/>
              </a:prstGeom>
              <a:solidFill>
                <a:srgbClr val="92D050"/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等腰三角形 34">
                <a:extLst>
                  <a:ext uri="{FF2B5EF4-FFF2-40B4-BE49-F238E27FC236}">
                    <a16:creationId xmlns:a16="http://schemas.microsoft.com/office/drawing/2014/main" id="{6A0F302A-8710-493F-A25C-2D91A81143B3}"/>
                  </a:ext>
                </a:extLst>
              </p:cNvPr>
              <p:cNvSpPr/>
              <p:nvPr/>
            </p:nvSpPr>
            <p:spPr>
              <a:xfrm>
                <a:off x="4835148" y="4930525"/>
                <a:ext cx="191466" cy="231228"/>
              </a:xfrm>
              <a:prstGeom prst="triangle">
                <a:avLst/>
              </a:prstGeom>
              <a:solidFill>
                <a:srgbClr val="92D050"/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等腰三角形 35">
                <a:extLst>
                  <a:ext uri="{FF2B5EF4-FFF2-40B4-BE49-F238E27FC236}">
                    <a16:creationId xmlns:a16="http://schemas.microsoft.com/office/drawing/2014/main" id="{8825AE34-4A55-4B56-B6B7-C0DA587B6A30}"/>
                  </a:ext>
                </a:extLst>
              </p:cNvPr>
              <p:cNvSpPr/>
              <p:nvPr/>
            </p:nvSpPr>
            <p:spPr>
              <a:xfrm>
                <a:off x="4372749" y="4930525"/>
                <a:ext cx="191466" cy="231228"/>
              </a:xfrm>
              <a:prstGeom prst="triangle">
                <a:avLst/>
              </a:prstGeom>
              <a:solidFill>
                <a:srgbClr val="92D050"/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标题 1">
                <a:extLst>
                  <a:ext uri="{FF2B5EF4-FFF2-40B4-BE49-F238E27FC236}">
                    <a16:creationId xmlns:a16="http://schemas.microsoft.com/office/drawing/2014/main" id="{0BF2F171-136F-43AC-A674-FE3877C0BA0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242243" y="5199296"/>
                <a:ext cx="1330130" cy="243362"/>
              </a:xfrm>
              <a:prstGeom prst="rect">
                <a:avLst/>
              </a:prstGeom>
            </p:spPr>
            <p:txBody>
              <a:bodyPr vert="horz" lIns="91440" tIns="45720" rIns="91440" bIns="45720" rtlCol="0" anchor="t">
                <a:noAutofit/>
              </a:bodyPr>
              <a:lstStyle>
                <a:lvl1pPr algn="l" defTabSz="457200" rtl="0" eaLnBrk="1" latinLnBrk="0" hangingPunct="1">
                  <a:spcBef>
                    <a:spcPct val="0"/>
                  </a:spcBef>
                  <a:buNone/>
                  <a:defRPr sz="3600" b="1" kern="120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Times New Roman" panose="02020603050405020304" pitchFamily="18" charset="0"/>
                    <a:ea typeface="+mj-ea"/>
                    <a:cs typeface="Times New Roman" panose="02020603050405020304" pitchFamily="18" charset="0"/>
                  </a:defRPr>
                </a:lvl1pPr>
                <a:lvl2pPr eaLnBrk="1" hangingPunct="1">
                  <a:defRPr>
                    <a:solidFill>
                      <a:schemeClr val="tx2"/>
                    </a:solidFill>
                  </a:defRPr>
                </a:lvl2pPr>
                <a:lvl3pPr eaLnBrk="1" hangingPunct="1">
                  <a:defRPr>
                    <a:solidFill>
                      <a:schemeClr val="tx2"/>
                    </a:solidFill>
                  </a:defRPr>
                </a:lvl3pPr>
                <a:lvl4pPr eaLnBrk="1" hangingPunct="1">
                  <a:defRPr>
                    <a:solidFill>
                      <a:schemeClr val="tx2"/>
                    </a:solidFill>
                  </a:defRPr>
                </a:lvl4pPr>
                <a:lvl5pPr eaLnBrk="1" hangingPunct="1">
                  <a:defRPr>
                    <a:solidFill>
                      <a:schemeClr val="tx2"/>
                    </a:solidFill>
                  </a:defRPr>
                </a:lvl5pPr>
                <a:lvl6pPr eaLnBrk="1" hangingPunct="1">
                  <a:defRPr>
                    <a:solidFill>
                      <a:schemeClr val="tx2"/>
                    </a:solidFill>
                  </a:defRPr>
                </a:lvl6pPr>
                <a:lvl7pPr eaLnBrk="1" hangingPunct="1">
                  <a:defRPr>
                    <a:solidFill>
                      <a:schemeClr val="tx2"/>
                    </a:solidFill>
                  </a:defRPr>
                </a:lvl7pPr>
                <a:lvl8pPr eaLnBrk="1" hangingPunct="1">
                  <a:defRPr>
                    <a:solidFill>
                      <a:schemeClr val="tx2"/>
                    </a:solidFill>
                  </a:defRPr>
                </a:lvl8pPr>
                <a:lvl9pPr eaLnBrk="1" hangingPunct="1">
                  <a:defRPr>
                    <a:solidFill>
                      <a:schemeClr val="tx2"/>
                    </a:solidFill>
                  </a:defRPr>
                </a:lvl9pPr>
              </a:lstStyle>
              <a:p>
                <a:r>
                  <a:rPr lang="en-US" altLang="zh-CN" sz="1400" dirty="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XA</a:t>
                </a:r>
                <a:r>
                  <a:rPr lang="en-US" altLang="zh-CN" sz="1400" baseline="-25000" dirty="0">
                    <a:solidFill>
                      <a:schemeClr val="tx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1400" baseline="-2500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3FEF087C-8931-40F6-A72B-7D2066A8E277}"/>
                  </a:ext>
                </a:extLst>
              </p:cNvPr>
              <p:cNvSpPr txBox="1"/>
              <p:nvPr/>
            </p:nvSpPr>
            <p:spPr>
              <a:xfrm>
                <a:off x="4196917" y="1830420"/>
                <a:ext cx="1229744" cy="6002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solidFill>
                      <a:schemeClr val="tx2"/>
                    </a:solidFill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LTA</a:t>
                </a:r>
                <a:r>
                  <a:rPr lang="en-US" altLang="zh-CN" sz="1400" b="1" baseline="-25000" dirty="0">
                    <a:solidFill>
                      <a:schemeClr val="tx2"/>
                    </a:solidFill>
                    <a:latin typeface="Arial" panose="020B0604020202020204" pitchFamily="34" charset="0"/>
                    <a:ea typeface="+mj-ea"/>
                    <a:cs typeface="Arial" panose="020B0604020202020204" pitchFamily="34" charset="0"/>
                  </a:rPr>
                  <a:t>4</a:t>
                </a:r>
                <a:endParaRPr lang="zh-CN" altLang="en-US" sz="1400" b="1" baseline="-25000">
                  <a:solidFill>
                    <a:schemeClr val="tx2"/>
                  </a:solidFill>
                  <a:latin typeface="Arial" panose="020B0604020202020204" pitchFamily="34" charset="0"/>
                  <a:ea typeface="+mj-ea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D8D1DF14-F54D-4838-AD78-4E7CCD1252E9}"/>
                </a:ext>
              </a:extLst>
            </p:cNvPr>
            <p:cNvGrpSpPr/>
            <p:nvPr/>
          </p:nvGrpSpPr>
          <p:grpSpPr>
            <a:xfrm>
              <a:off x="3158932" y="4026571"/>
              <a:ext cx="1217651" cy="273082"/>
              <a:chOff x="7746921" y="4079191"/>
              <a:chExt cx="1217651" cy="273082"/>
            </a:xfrm>
          </p:grpSpPr>
          <p:sp>
            <p:nvSpPr>
              <p:cNvPr id="12" name="标题 1">
                <a:extLst>
                  <a:ext uri="{FF2B5EF4-FFF2-40B4-BE49-F238E27FC236}">
                    <a16:creationId xmlns:a16="http://schemas.microsoft.com/office/drawing/2014/main" id="{38AACAE5-BD94-499C-8824-DD76DCA48A77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964377" y="4079191"/>
                <a:ext cx="1000195" cy="228464"/>
              </a:xfrm>
              <a:prstGeom prst="rect">
                <a:avLst/>
              </a:prstGeom>
            </p:spPr>
            <p:txBody>
              <a:bodyPr vert="horz" lIns="91440" tIns="45720" rIns="91440" bIns="45720" rtlCol="0" anchor="t">
                <a:noAutofit/>
              </a:bodyPr>
              <a:lstStyle>
                <a:lvl1pPr algn="l" defTabSz="457200" rtl="0" eaLnBrk="1" latinLnBrk="0" hangingPunct="1">
                  <a:spcBef>
                    <a:spcPct val="0"/>
                  </a:spcBef>
                  <a:buNone/>
                  <a:defRPr sz="3600" b="1" kern="120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Times New Roman" panose="02020603050405020304" pitchFamily="18" charset="0"/>
                    <a:ea typeface="+mj-ea"/>
                    <a:cs typeface="Times New Roman" panose="02020603050405020304" pitchFamily="18" charset="0"/>
                  </a:defRPr>
                </a:lvl1pPr>
                <a:lvl2pPr eaLnBrk="1" hangingPunct="1">
                  <a:defRPr>
                    <a:solidFill>
                      <a:schemeClr val="tx2"/>
                    </a:solidFill>
                  </a:defRPr>
                </a:lvl2pPr>
                <a:lvl3pPr eaLnBrk="1" hangingPunct="1">
                  <a:defRPr>
                    <a:solidFill>
                      <a:schemeClr val="tx2"/>
                    </a:solidFill>
                  </a:defRPr>
                </a:lvl3pPr>
                <a:lvl4pPr eaLnBrk="1" hangingPunct="1">
                  <a:defRPr>
                    <a:solidFill>
                      <a:schemeClr val="tx2"/>
                    </a:solidFill>
                  </a:defRPr>
                </a:lvl4pPr>
                <a:lvl5pPr eaLnBrk="1" hangingPunct="1">
                  <a:defRPr>
                    <a:solidFill>
                      <a:schemeClr val="tx2"/>
                    </a:solidFill>
                  </a:defRPr>
                </a:lvl5pPr>
                <a:lvl6pPr eaLnBrk="1" hangingPunct="1">
                  <a:defRPr>
                    <a:solidFill>
                      <a:schemeClr val="tx2"/>
                    </a:solidFill>
                  </a:defRPr>
                </a:lvl6pPr>
                <a:lvl7pPr eaLnBrk="1" hangingPunct="1">
                  <a:defRPr>
                    <a:solidFill>
                      <a:schemeClr val="tx2"/>
                    </a:solidFill>
                  </a:defRPr>
                </a:lvl7pPr>
                <a:lvl8pPr eaLnBrk="1" hangingPunct="1">
                  <a:defRPr>
                    <a:solidFill>
                      <a:schemeClr val="tx2"/>
                    </a:solidFill>
                  </a:defRPr>
                </a:lvl8pPr>
                <a:lvl9pPr eaLnBrk="1" hangingPunct="1">
                  <a:defRPr>
                    <a:solidFill>
                      <a:schemeClr val="tx2"/>
                    </a:solidFill>
                  </a:defRPr>
                </a:lvl9pPr>
              </a:lstStyle>
              <a:p>
                <a:r>
                  <a:rPr lang="en-US" altLang="zh-CN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TC</a:t>
                </a:r>
                <a:r>
                  <a:rPr lang="en-US" altLang="zh-CN" sz="1200" baseline="-25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altLang="zh-CN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endParaRPr lang="zh-CN" altLang="en-US" sz="120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id="{A5AEE34A-85CF-42AF-A505-F13E9C2F42E5}"/>
                  </a:ext>
                </a:extLst>
              </p:cNvPr>
              <p:cNvGrpSpPr/>
              <p:nvPr/>
            </p:nvGrpSpPr>
            <p:grpSpPr>
              <a:xfrm>
                <a:off x="7746921" y="4234839"/>
                <a:ext cx="204168" cy="117434"/>
                <a:chOff x="9522539" y="3142908"/>
                <a:chExt cx="204168" cy="117434"/>
              </a:xfrm>
            </p:grpSpPr>
            <p:sp>
              <p:nvSpPr>
                <p:cNvPr id="14" name="弦形 13">
                  <a:extLst>
                    <a:ext uri="{FF2B5EF4-FFF2-40B4-BE49-F238E27FC236}">
                      <a16:creationId xmlns:a16="http://schemas.microsoft.com/office/drawing/2014/main" id="{7F7E3025-A198-4341-84A6-B51BBD77ED6E}"/>
                    </a:ext>
                  </a:extLst>
                </p:cNvPr>
                <p:cNvSpPr/>
                <p:nvPr/>
              </p:nvSpPr>
              <p:spPr>
                <a:xfrm>
                  <a:off x="9522539" y="3142908"/>
                  <a:ext cx="87626" cy="45719"/>
                </a:xfrm>
                <a:prstGeom prst="chord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弦形 14">
                  <a:extLst>
                    <a:ext uri="{FF2B5EF4-FFF2-40B4-BE49-F238E27FC236}">
                      <a16:creationId xmlns:a16="http://schemas.microsoft.com/office/drawing/2014/main" id="{CB9FC6F0-ABAB-4F50-823C-5193DB3C0EE7}"/>
                    </a:ext>
                  </a:extLst>
                </p:cNvPr>
                <p:cNvSpPr/>
                <p:nvPr/>
              </p:nvSpPr>
              <p:spPr>
                <a:xfrm>
                  <a:off x="9567362" y="3214623"/>
                  <a:ext cx="87626" cy="45719"/>
                </a:xfrm>
                <a:prstGeom prst="chord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弦形 15">
                  <a:extLst>
                    <a:ext uri="{FF2B5EF4-FFF2-40B4-BE49-F238E27FC236}">
                      <a16:creationId xmlns:a16="http://schemas.microsoft.com/office/drawing/2014/main" id="{6DE892D7-BF42-43A3-9286-5473825A0F04}"/>
                    </a:ext>
                  </a:extLst>
                </p:cNvPr>
                <p:cNvSpPr/>
                <p:nvPr/>
              </p:nvSpPr>
              <p:spPr>
                <a:xfrm>
                  <a:off x="9639081" y="3160839"/>
                  <a:ext cx="87626" cy="45719"/>
                </a:xfrm>
                <a:prstGeom prst="chord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F1EBC562-F89E-48AC-B662-FD1B2F150250}"/>
                </a:ext>
              </a:extLst>
            </p:cNvPr>
            <p:cNvGrpSpPr/>
            <p:nvPr/>
          </p:nvGrpSpPr>
          <p:grpSpPr>
            <a:xfrm>
              <a:off x="1807978" y="4026563"/>
              <a:ext cx="891283" cy="278367"/>
              <a:chOff x="9005752" y="2330363"/>
              <a:chExt cx="891283" cy="278367"/>
            </a:xfrm>
          </p:grpSpPr>
          <p:sp>
            <p:nvSpPr>
              <p:cNvPr id="8" name="不完整圆 7">
                <a:extLst>
                  <a:ext uri="{FF2B5EF4-FFF2-40B4-BE49-F238E27FC236}">
                    <a16:creationId xmlns:a16="http://schemas.microsoft.com/office/drawing/2014/main" id="{2E0CAF3A-8D51-4711-A8CD-CD2C70E22389}"/>
                  </a:ext>
                </a:extLst>
              </p:cNvPr>
              <p:cNvSpPr/>
              <p:nvPr/>
            </p:nvSpPr>
            <p:spPr>
              <a:xfrm>
                <a:off x="9708777" y="2456330"/>
                <a:ext cx="71718" cy="71718"/>
              </a:xfrm>
              <a:prstGeom prst="pie">
                <a:avLst/>
              </a:prstGeom>
              <a:solidFill>
                <a:srgbClr val="9933FF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不完整圆 8">
                <a:extLst>
                  <a:ext uri="{FF2B5EF4-FFF2-40B4-BE49-F238E27FC236}">
                    <a16:creationId xmlns:a16="http://schemas.microsoft.com/office/drawing/2014/main" id="{632F7698-FA6B-4416-8F6B-81A01DF81D85}"/>
                  </a:ext>
                </a:extLst>
              </p:cNvPr>
              <p:cNvSpPr/>
              <p:nvPr/>
            </p:nvSpPr>
            <p:spPr>
              <a:xfrm>
                <a:off x="9825317" y="2474259"/>
                <a:ext cx="71718" cy="71718"/>
              </a:xfrm>
              <a:prstGeom prst="pie">
                <a:avLst/>
              </a:prstGeom>
              <a:solidFill>
                <a:srgbClr val="9933FF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不完整圆 9">
                <a:extLst>
                  <a:ext uri="{FF2B5EF4-FFF2-40B4-BE49-F238E27FC236}">
                    <a16:creationId xmlns:a16="http://schemas.microsoft.com/office/drawing/2014/main" id="{873E0DF2-1609-4D83-8390-34695DA662B1}"/>
                  </a:ext>
                </a:extLst>
              </p:cNvPr>
              <p:cNvSpPr/>
              <p:nvPr/>
            </p:nvSpPr>
            <p:spPr>
              <a:xfrm>
                <a:off x="9753602" y="2537012"/>
                <a:ext cx="71718" cy="71718"/>
              </a:xfrm>
              <a:prstGeom prst="pie">
                <a:avLst/>
              </a:prstGeom>
              <a:solidFill>
                <a:srgbClr val="9933FF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标题 1">
                <a:extLst>
                  <a:ext uri="{FF2B5EF4-FFF2-40B4-BE49-F238E27FC236}">
                    <a16:creationId xmlns:a16="http://schemas.microsoft.com/office/drawing/2014/main" id="{4BA27C35-D625-448E-9EB9-429624D96DE2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9005752" y="2330363"/>
                <a:ext cx="887936" cy="231884"/>
              </a:xfrm>
              <a:prstGeom prst="rect">
                <a:avLst/>
              </a:prstGeom>
            </p:spPr>
            <p:txBody>
              <a:bodyPr vert="horz" lIns="91440" tIns="45720" rIns="91440" bIns="45720" rtlCol="0" anchor="t">
                <a:noAutofit/>
              </a:bodyPr>
              <a:lstStyle>
                <a:lvl1pPr algn="l" defTabSz="457200" rtl="0" eaLnBrk="1" latinLnBrk="0" hangingPunct="1">
                  <a:spcBef>
                    <a:spcPct val="0"/>
                  </a:spcBef>
                  <a:buNone/>
                  <a:defRPr sz="3600" b="1" kern="1200">
                    <a:solidFill>
                      <a:schemeClr val="tx1">
                        <a:lumMod val="85000"/>
                        <a:lumOff val="15000"/>
                      </a:schemeClr>
                    </a:solidFill>
                    <a:latin typeface="Times New Roman" panose="02020603050405020304" pitchFamily="18" charset="0"/>
                    <a:ea typeface="+mj-ea"/>
                    <a:cs typeface="Times New Roman" panose="02020603050405020304" pitchFamily="18" charset="0"/>
                  </a:defRPr>
                </a:lvl1pPr>
                <a:lvl2pPr eaLnBrk="1" hangingPunct="1">
                  <a:defRPr>
                    <a:solidFill>
                      <a:schemeClr val="tx2"/>
                    </a:solidFill>
                  </a:defRPr>
                </a:lvl2pPr>
                <a:lvl3pPr eaLnBrk="1" hangingPunct="1">
                  <a:defRPr>
                    <a:solidFill>
                      <a:schemeClr val="tx2"/>
                    </a:solidFill>
                  </a:defRPr>
                </a:lvl3pPr>
                <a:lvl4pPr eaLnBrk="1" hangingPunct="1">
                  <a:defRPr>
                    <a:solidFill>
                      <a:schemeClr val="tx2"/>
                    </a:solidFill>
                  </a:defRPr>
                </a:lvl4pPr>
                <a:lvl5pPr eaLnBrk="1" hangingPunct="1">
                  <a:defRPr>
                    <a:solidFill>
                      <a:schemeClr val="tx2"/>
                    </a:solidFill>
                  </a:defRPr>
                </a:lvl5pPr>
                <a:lvl6pPr eaLnBrk="1" hangingPunct="1">
                  <a:defRPr>
                    <a:solidFill>
                      <a:schemeClr val="tx2"/>
                    </a:solidFill>
                  </a:defRPr>
                </a:lvl6pPr>
                <a:lvl7pPr eaLnBrk="1" hangingPunct="1">
                  <a:defRPr>
                    <a:solidFill>
                      <a:schemeClr val="tx2"/>
                    </a:solidFill>
                  </a:defRPr>
                </a:lvl7pPr>
                <a:lvl8pPr eaLnBrk="1" hangingPunct="1">
                  <a:defRPr>
                    <a:solidFill>
                      <a:schemeClr val="tx2"/>
                    </a:solidFill>
                  </a:defRPr>
                </a:lvl8pPr>
                <a:lvl9pPr eaLnBrk="1" hangingPunct="1">
                  <a:defRPr>
                    <a:solidFill>
                      <a:schemeClr val="tx2"/>
                    </a:solidFill>
                  </a:defRPr>
                </a:lvl9pPr>
              </a:lstStyle>
              <a:p>
                <a:r>
                  <a:rPr lang="en-US" altLang="zh-CN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TA</a:t>
                </a:r>
                <a:r>
                  <a:rPr lang="en-US" altLang="zh-CN" sz="1200" baseline="-25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lang="en-US" altLang="zh-CN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lang="zh-CN" altLang="en-US" sz="120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6" name="组合 105">
            <a:extLst>
              <a:ext uri="{FF2B5EF4-FFF2-40B4-BE49-F238E27FC236}">
                <a16:creationId xmlns:a16="http://schemas.microsoft.com/office/drawing/2014/main" id="{03E957D1-8F36-4D9D-9C52-E3EEBAA34412}"/>
              </a:ext>
            </a:extLst>
          </p:cNvPr>
          <p:cNvGrpSpPr/>
          <p:nvPr/>
        </p:nvGrpSpPr>
        <p:grpSpPr>
          <a:xfrm>
            <a:off x="6287934" y="4076693"/>
            <a:ext cx="1858595" cy="1391742"/>
            <a:chOff x="5308908" y="4834084"/>
            <a:chExt cx="2199130" cy="1787872"/>
          </a:xfrm>
        </p:grpSpPr>
        <p:sp>
          <p:nvSpPr>
            <p:cNvPr id="107" name="任意多边形: 形状 106">
              <a:extLst>
                <a:ext uri="{FF2B5EF4-FFF2-40B4-BE49-F238E27FC236}">
                  <a16:creationId xmlns:a16="http://schemas.microsoft.com/office/drawing/2014/main" id="{F1C6036C-E19E-40E4-ADA7-17A886B16510}"/>
                </a:ext>
              </a:extLst>
            </p:cNvPr>
            <p:cNvSpPr/>
            <p:nvPr/>
          </p:nvSpPr>
          <p:spPr>
            <a:xfrm>
              <a:off x="5308908" y="4834084"/>
              <a:ext cx="2199130" cy="1787872"/>
            </a:xfrm>
            <a:custGeom>
              <a:avLst/>
              <a:gdLst>
                <a:gd name="connsiteX0" fmla="*/ 259658 w 2214474"/>
                <a:gd name="connsiteY0" fmla="*/ 599947 h 1800675"/>
                <a:gd name="connsiteX1" fmla="*/ 516512 w 2214474"/>
                <a:gd name="connsiteY1" fmla="*/ 373915 h 1800675"/>
                <a:gd name="connsiteX2" fmla="*/ 598706 w 2214474"/>
                <a:gd name="connsiteY2" fmla="*/ 96513 h 1800675"/>
                <a:gd name="connsiteX3" fmla="*/ 948027 w 2214474"/>
                <a:gd name="connsiteY3" fmla="*/ 4045 h 1800675"/>
                <a:gd name="connsiteX4" fmla="*/ 1338445 w 2214474"/>
                <a:gd name="connsiteY4" fmla="*/ 209529 h 1800675"/>
                <a:gd name="connsiteX5" fmla="*/ 1687766 w 2214474"/>
                <a:gd name="connsiteY5" fmla="*/ 240351 h 1800675"/>
                <a:gd name="connsiteX6" fmla="*/ 2201474 w 2214474"/>
                <a:gd name="connsiteY6" fmla="*/ 404738 h 1800675"/>
                <a:gd name="connsiteX7" fmla="*/ 2067910 w 2214474"/>
                <a:gd name="connsiteY7" fmla="*/ 774607 h 1800675"/>
                <a:gd name="connsiteX8" fmla="*/ 2150103 w 2214474"/>
                <a:gd name="connsiteY8" fmla="*/ 1134203 h 1800675"/>
                <a:gd name="connsiteX9" fmla="*/ 2088458 w 2214474"/>
                <a:gd name="connsiteY9" fmla="*/ 1391057 h 1800675"/>
                <a:gd name="connsiteX10" fmla="*/ 1626121 w 2214474"/>
                <a:gd name="connsiteY10" fmla="*/ 1401331 h 1800675"/>
                <a:gd name="connsiteX11" fmla="*/ 1410364 w 2214474"/>
                <a:gd name="connsiteY11" fmla="*/ 1647911 h 1800675"/>
                <a:gd name="connsiteX12" fmla="*/ 927479 w 2214474"/>
                <a:gd name="connsiteY12" fmla="*/ 1791749 h 1800675"/>
                <a:gd name="connsiteX13" fmla="*/ 1019946 w 2214474"/>
                <a:gd name="connsiteY13" fmla="*/ 1391057 h 1800675"/>
                <a:gd name="connsiteX14" fmla="*/ 855560 w 2214474"/>
                <a:gd name="connsiteY14" fmla="*/ 1257493 h 1800675"/>
                <a:gd name="connsiteX15" fmla="*/ 95272 w 2214474"/>
                <a:gd name="connsiteY15" fmla="*/ 1288315 h 1800675"/>
                <a:gd name="connsiteX16" fmla="*/ 33627 w 2214474"/>
                <a:gd name="connsiteY16" fmla="*/ 990365 h 1800675"/>
                <a:gd name="connsiteX17" fmla="*/ 300755 w 2214474"/>
                <a:gd name="connsiteY17" fmla="*/ 754059 h 1800675"/>
                <a:gd name="connsiteX18" fmla="*/ 259658 w 2214474"/>
                <a:gd name="connsiteY18" fmla="*/ 599947 h 1800675"/>
                <a:gd name="connsiteX0" fmla="*/ 247777 w 2202593"/>
                <a:gd name="connsiteY0" fmla="*/ 599947 h 1800675"/>
                <a:gd name="connsiteX1" fmla="*/ 504631 w 2202593"/>
                <a:gd name="connsiteY1" fmla="*/ 373915 h 1800675"/>
                <a:gd name="connsiteX2" fmla="*/ 586825 w 2202593"/>
                <a:gd name="connsiteY2" fmla="*/ 96513 h 1800675"/>
                <a:gd name="connsiteX3" fmla="*/ 936146 w 2202593"/>
                <a:gd name="connsiteY3" fmla="*/ 4045 h 1800675"/>
                <a:gd name="connsiteX4" fmla="*/ 1326564 w 2202593"/>
                <a:gd name="connsiteY4" fmla="*/ 209529 h 1800675"/>
                <a:gd name="connsiteX5" fmla="*/ 1675885 w 2202593"/>
                <a:gd name="connsiteY5" fmla="*/ 240351 h 1800675"/>
                <a:gd name="connsiteX6" fmla="*/ 2189593 w 2202593"/>
                <a:gd name="connsiteY6" fmla="*/ 404738 h 1800675"/>
                <a:gd name="connsiteX7" fmla="*/ 2056029 w 2202593"/>
                <a:gd name="connsiteY7" fmla="*/ 774607 h 1800675"/>
                <a:gd name="connsiteX8" fmla="*/ 2138222 w 2202593"/>
                <a:gd name="connsiteY8" fmla="*/ 1134203 h 1800675"/>
                <a:gd name="connsiteX9" fmla="*/ 2076577 w 2202593"/>
                <a:gd name="connsiteY9" fmla="*/ 1391057 h 1800675"/>
                <a:gd name="connsiteX10" fmla="*/ 1614240 w 2202593"/>
                <a:gd name="connsiteY10" fmla="*/ 1401331 h 1800675"/>
                <a:gd name="connsiteX11" fmla="*/ 1398483 w 2202593"/>
                <a:gd name="connsiteY11" fmla="*/ 1647911 h 1800675"/>
                <a:gd name="connsiteX12" fmla="*/ 915598 w 2202593"/>
                <a:gd name="connsiteY12" fmla="*/ 1791749 h 1800675"/>
                <a:gd name="connsiteX13" fmla="*/ 1008065 w 2202593"/>
                <a:gd name="connsiteY13" fmla="*/ 1391057 h 1800675"/>
                <a:gd name="connsiteX14" fmla="*/ 617647 w 2202593"/>
                <a:gd name="connsiteY14" fmla="*/ 1391057 h 1800675"/>
                <a:gd name="connsiteX15" fmla="*/ 83391 w 2202593"/>
                <a:gd name="connsiteY15" fmla="*/ 1288315 h 1800675"/>
                <a:gd name="connsiteX16" fmla="*/ 21746 w 2202593"/>
                <a:gd name="connsiteY16" fmla="*/ 990365 h 1800675"/>
                <a:gd name="connsiteX17" fmla="*/ 288874 w 2202593"/>
                <a:gd name="connsiteY17" fmla="*/ 754059 h 1800675"/>
                <a:gd name="connsiteX18" fmla="*/ 247777 w 2202593"/>
                <a:gd name="connsiteY18" fmla="*/ 599947 h 1800675"/>
                <a:gd name="connsiteX0" fmla="*/ 247777 w 2202593"/>
                <a:gd name="connsiteY0" fmla="*/ 599947 h 1792824"/>
                <a:gd name="connsiteX1" fmla="*/ 504631 w 2202593"/>
                <a:gd name="connsiteY1" fmla="*/ 373915 h 1792824"/>
                <a:gd name="connsiteX2" fmla="*/ 586825 w 2202593"/>
                <a:gd name="connsiteY2" fmla="*/ 96513 h 1792824"/>
                <a:gd name="connsiteX3" fmla="*/ 936146 w 2202593"/>
                <a:gd name="connsiteY3" fmla="*/ 4045 h 1792824"/>
                <a:gd name="connsiteX4" fmla="*/ 1326564 w 2202593"/>
                <a:gd name="connsiteY4" fmla="*/ 209529 h 1792824"/>
                <a:gd name="connsiteX5" fmla="*/ 1675885 w 2202593"/>
                <a:gd name="connsiteY5" fmla="*/ 240351 h 1792824"/>
                <a:gd name="connsiteX6" fmla="*/ 2189593 w 2202593"/>
                <a:gd name="connsiteY6" fmla="*/ 404738 h 1792824"/>
                <a:gd name="connsiteX7" fmla="*/ 2056029 w 2202593"/>
                <a:gd name="connsiteY7" fmla="*/ 774607 h 1792824"/>
                <a:gd name="connsiteX8" fmla="*/ 2138222 w 2202593"/>
                <a:gd name="connsiteY8" fmla="*/ 1134203 h 1792824"/>
                <a:gd name="connsiteX9" fmla="*/ 2076577 w 2202593"/>
                <a:gd name="connsiteY9" fmla="*/ 1391057 h 1792824"/>
                <a:gd name="connsiteX10" fmla="*/ 1614240 w 2202593"/>
                <a:gd name="connsiteY10" fmla="*/ 1401331 h 1792824"/>
                <a:gd name="connsiteX11" fmla="*/ 1398483 w 2202593"/>
                <a:gd name="connsiteY11" fmla="*/ 1647911 h 1792824"/>
                <a:gd name="connsiteX12" fmla="*/ 915598 w 2202593"/>
                <a:gd name="connsiteY12" fmla="*/ 1791749 h 1792824"/>
                <a:gd name="connsiteX13" fmla="*/ 720388 w 2202593"/>
                <a:gd name="connsiteY13" fmla="*/ 1575992 h 1792824"/>
                <a:gd name="connsiteX14" fmla="*/ 617647 w 2202593"/>
                <a:gd name="connsiteY14" fmla="*/ 1391057 h 1792824"/>
                <a:gd name="connsiteX15" fmla="*/ 83391 w 2202593"/>
                <a:gd name="connsiteY15" fmla="*/ 1288315 h 1792824"/>
                <a:gd name="connsiteX16" fmla="*/ 21746 w 2202593"/>
                <a:gd name="connsiteY16" fmla="*/ 990365 h 1792824"/>
                <a:gd name="connsiteX17" fmla="*/ 288874 w 2202593"/>
                <a:gd name="connsiteY17" fmla="*/ 754059 h 1792824"/>
                <a:gd name="connsiteX18" fmla="*/ 247777 w 2202593"/>
                <a:gd name="connsiteY18" fmla="*/ 599947 h 1792824"/>
                <a:gd name="connsiteX0" fmla="*/ 242434 w 2197250"/>
                <a:gd name="connsiteY0" fmla="*/ 599947 h 1792824"/>
                <a:gd name="connsiteX1" fmla="*/ 499288 w 2197250"/>
                <a:gd name="connsiteY1" fmla="*/ 373915 h 1792824"/>
                <a:gd name="connsiteX2" fmla="*/ 581482 w 2197250"/>
                <a:gd name="connsiteY2" fmla="*/ 96513 h 1792824"/>
                <a:gd name="connsiteX3" fmla="*/ 930803 w 2197250"/>
                <a:gd name="connsiteY3" fmla="*/ 4045 h 1792824"/>
                <a:gd name="connsiteX4" fmla="*/ 1321221 w 2197250"/>
                <a:gd name="connsiteY4" fmla="*/ 209529 h 1792824"/>
                <a:gd name="connsiteX5" fmla="*/ 1670542 w 2197250"/>
                <a:gd name="connsiteY5" fmla="*/ 240351 h 1792824"/>
                <a:gd name="connsiteX6" fmla="*/ 2184250 w 2197250"/>
                <a:gd name="connsiteY6" fmla="*/ 404738 h 1792824"/>
                <a:gd name="connsiteX7" fmla="*/ 2050686 w 2197250"/>
                <a:gd name="connsiteY7" fmla="*/ 774607 h 1792824"/>
                <a:gd name="connsiteX8" fmla="*/ 2132879 w 2197250"/>
                <a:gd name="connsiteY8" fmla="*/ 1134203 h 1792824"/>
                <a:gd name="connsiteX9" fmla="*/ 2071234 w 2197250"/>
                <a:gd name="connsiteY9" fmla="*/ 1391057 h 1792824"/>
                <a:gd name="connsiteX10" fmla="*/ 1608897 w 2197250"/>
                <a:gd name="connsiteY10" fmla="*/ 1401331 h 1792824"/>
                <a:gd name="connsiteX11" fmla="*/ 1393140 w 2197250"/>
                <a:gd name="connsiteY11" fmla="*/ 1647911 h 1792824"/>
                <a:gd name="connsiteX12" fmla="*/ 910255 w 2197250"/>
                <a:gd name="connsiteY12" fmla="*/ 1791749 h 1792824"/>
                <a:gd name="connsiteX13" fmla="*/ 715045 w 2197250"/>
                <a:gd name="connsiteY13" fmla="*/ 1575992 h 1792824"/>
                <a:gd name="connsiteX14" fmla="*/ 478740 w 2197250"/>
                <a:gd name="connsiteY14" fmla="*/ 1462976 h 1792824"/>
                <a:gd name="connsiteX15" fmla="*/ 78048 w 2197250"/>
                <a:gd name="connsiteY15" fmla="*/ 1288315 h 1792824"/>
                <a:gd name="connsiteX16" fmla="*/ 16403 w 2197250"/>
                <a:gd name="connsiteY16" fmla="*/ 990365 h 1792824"/>
                <a:gd name="connsiteX17" fmla="*/ 283531 w 2197250"/>
                <a:gd name="connsiteY17" fmla="*/ 754059 h 1792824"/>
                <a:gd name="connsiteX18" fmla="*/ 242434 w 2197250"/>
                <a:gd name="connsiteY18" fmla="*/ 599947 h 1792824"/>
                <a:gd name="connsiteX0" fmla="*/ 242434 w 2197250"/>
                <a:gd name="connsiteY0" fmla="*/ 599947 h 1791852"/>
                <a:gd name="connsiteX1" fmla="*/ 499288 w 2197250"/>
                <a:gd name="connsiteY1" fmla="*/ 373915 h 1791852"/>
                <a:gd name="connsiteX2" fmla="*/ 581482 w 2197250"/>
                <a:gd name="connsiteY2" fmla="*/ 96513 h 1791852"/>
                <a:gd name="connsiteX3" fmla="*/ 930803 w 2197250"/>
                <a:gd name="connsiteY3" fmla="*/ 4045 h 1791852"/>
                <a:gd name="connsiteX4" fmla="*/ 1321221 w 2197250"/>
                <a:gd name="connsiteY4" fmla="*/ 209529 h 1791852"/>
                <a:gd name="connsiteX5" fmla="*/ 1670542 w 2197250"/>
                <a:gd name="connsiteY5" fmla="*/ 240351 h 1791852"/>
                <a:gd name="connsiteX6" fmla="*/ 2184250 w 2197250"/>
                <a:gd name="connsiteY6" fmla="*/ 404738 h 1791852"/>
                <a:gd name="connsiteX7" fmla="*/ 2050686 w 2197250"/>
                <a:gd name="connsiteY7" fmla="*/ 774607 h 1791852"/>
                <a:gd name="connsiteX8" fmla="*/ 2132879 w 2197250"/>
                <a:gd name="connsiteY8" fmla="*/ 1134203 h 1791852"/>
                <a:gd name="connsiteX9" fmla="*/ 2071234 w 2197250"/>
                <a:gd name="connsiteY9" fmla="*/ 1391057 h 1791852"/>
                <a:gd name="connsiteX10" fmla="*/ 1608897 w 2197250"/>
                <a:gd name="connsiteY10" fmla="*/ 1401331 h 1791852"/>
                <a:gd name="connsiteX11" fmla="*/ 1393140 w 2197250"/>
                <a:gd name="connsiteY11" fmla="*/ 1647911 h 1791852"/>
                <a:gd name="connsiteX12" fmla="*/ 910255 w 2197250"/>
                <a:gd name="connsiteY12" fmla="*/ 1791749 h 1791852"/>
                <a:gd name="connsiteX13" fmla="*/ 653400 w 2197250"/>
                <a:gd name="connsiteY13" fmla="*/ 1627363 h 1791852"/>
                <a:gd name="connsiteX14" fmla="*/ 478740 w 2197250"/>
                <a:gd name="connsiteY14" fmla="*/ 1462976 h 1791852"/>
                <a:gd name="connsiteX15" fmla="*/ 78048 w 2197250"/>
                <a:gd name="connsiteY15" fmla="*/ 1288315 h 1791852"/>
                <a:gd name="connsiteX16" fmla="*/ 16403 w 2197250"/>
                <a:gd name="connsiteY16" fmla="*/ 990365 h 1791852"/>
                <a:gd name="connsiteX17" fmla="*/ 283531 w 2197250"/>
                <a:gd name="connsiteY17" fmla="*/ 754059 h 1791852"/>
                <a:gd name="connsiteX18" fmla="*/ 242434 w 2197250"/>
                <a:gd name="connsiteY18" fmla="*/ 599947 h 1791852"/>
                <a:gd name="connsiteX0" fmla="*/ 250204 w 2205020"/>
                <a:gd name="connsiteY0" fmla="*/ 599947 h 1791852"/>
                <a:gd name="connsiteX1" fmla="*/ 507058 w 2205020"/>
                <a:gd name="connsiteY1" fmla="*/ 373915 h 1791852"/>
                <a:gd name="connsiteX2" fmla="*/ 589252 w 2205020"/>
                <a:gd name="connsiteY2" fmla="*/ 96513 h 1791852"/>
                <a:gd name="connsiteX3" fmla="*/ 938573 w 2205020"/>
                <a:gd name="connsiteY3" fmla="*/ 4045 h 1791852"/>
                <a:gd name="connsiteX4" fmla="*/ 1328991 w 2205020"/>
                <a:gd name="connsiteY4" fmla="*/ 209529 h 1791852"/>
                <a:gd name="connsiteX5" fmla="*/ 1678312 w 2205020"/>
                <a:gd name="connsiteY5" fmla="*/ 240351 h 1791852"/>
                <a:gd name="connsiteX6" fmla="*/ 2192020 w 2205020"/>
                <a:gd name="connsiteY6" fmla="*/ 404738 h 1791852"/>
                <a:gd name="connsiteX7" fmla="*/ 2058456 w 2205020"/>
                <a:gd name="connsiteY7" fmla="*/ 774607 h 1791852"/>
                <a:gd name="connsiteX8" fmla="*/ 2140649 w 2205020"/>
                <a:gd name="connsiteY8" fmla="*/ 1134203 h 1791852"/>
                <a:gd name="connsiteX9" fmla="*/ 2079004 w 2205020"/>
                <a:gd name="connsiteY9" fmla="*/ 1391057 h 1791852"/>
                <a:gd name="connsiteX10" fmla="*/ 1616667 w 2205020"/>
                <a:gd name="connsiteY10" fmla="*/ 1401331 h 1791852"/>
                <a:gd name="connsiteX11" fmla="*/ 1400910 w 2205020"/>
                <a:gd name="connsiteY11" fmla="*/ 1647911 h 1791852"/>
                <a:gd name="connsiteX12" fmla="*/ 918025 w 2205020"/>
                <a:gd name="connsiteY12" fmla="*/ 1791749 h 1791852"/>
                <a:gd name="connsiteX13" fmla="*/ 661170 w 2205020"/>
                <a:gd name="connsiteY13" fmla="*/ 1627363 h 1791852"/>
                <a:gd name="connsiteX14" fmla="*/ 671445 w 2205020"/>
                <a:gd name="connsiteY14" fmla="*/ 1380783 h 1791852"/>
                <a:gd name="connsiteX15" fmla="*/ 85818 w 2205020"/>
                <a:gd name="connsiteY15" fmla="*/ 1288315 h 1791852"/>
                <a:gd name="connsiteX16" fmla="*/ 24173 w 2205020"/>
                <a:gd name="connsiteY16" fmla="*/ 990365 h 1791852"/>
                <a:gd name="connsiteX17" fmla="*/ 291301 w 2205020"/>
                <a:gd name="connsiteY17" fmla="*/ 754059 h 1791852"/>
                <a:gd name="connsiteX18" fmla="*/ 250204 w 2205020"/>
                <a:gd name="connsiteY18" fmla="*/ 599947 h 1791852"/>
                <a:gd name="connsiteX0" fmla="*/ 244314 w 2199130"/>
                <a:gd name="connsiteY0" fmla="*/ 599947 h 1791852"/>
                <a:gd name="connsiteX1" fmla="*/ 501168 w 2199130"/>
                <a:gd name="connsiteY1" fmla="*/ 373915 h 1791852"/>
                <a:gd name="connsiteX2" fmla="*/ 583362 w 2199130"/>
                <a:gd name="connsiteY2" fmla="*/ 96513 h 1791852"/>
                <a:gd name="connsiteX3" fmla="*/ 932683 w 2199130"/>
                <a:gd name="connsiteY3" fmla="*/ 4045 h 1791852"/>
                <a:gd name="connsiteX4" fmla="*/ 1323101 w 2199130"/>
                <a:gd name="connsiteY4" fmla="*/ 209529 h 1791852"/>
                <a:gd name="connsiteX5" fmla="*/ 1672422 w 2199130"/>
                <a:gd name="connsiteY5" fmla="*/ 240351 h 1791852"/>
                <a:gd name="connsiteX6" fmla="*/ 2186130 w 2199130"/>
                <a:gd name="connsiteY6" fmla="*/ 404738 h 1791852"/>
                <a:gd name="connsiteX7" fmla="*/ 2052566 w 2199130"/>
                <a:gd name="connsiteY7" fmla="*/ 774607 h 1791852"/>
                <a:gd name="connsiteX8" fmla="*/ 2134759 w 2199130"/>
                <a:gd name="connsiteY8" fmla="*/ 1134203 h 1791852"/>
                <a:gd name="connsiteX9" fmla="*/ 2073114 w 2199130"/>
                <a:gd name="connsiteY9" fmla="*/ 1391057 h 1791852"/>
                <a:gd name="connsiteX10" fmla="*/ 1610777 w 2199130"/>
                <a:gd name="connsiteY10" fmla="*/ 1401331 h 1791852"/>
                <a:gd name="connsiteX11" fmla="*/ 1395020 w 2199130"/>
                <a:gd name="connsiteY11" fmla="*/ 1647911 h 1791852"/>
                <a:gd name="connsiteX12" fmla="*/ 912135 w 2199130"/>
                <a:gd name="connsiteY12" fmla="*/ 1791749 h 1791852"/>
                <a:gd name="connsiteX13" fmla="*/ 655280 w 2199130"/>
                <a:gd name="connsiteY13" fmla="*/ 1627363 h 1791852"/>
                <a:gd name="connsiteX14" fmla="*/ 531991 w 2199130"/>
                <a:gd name="connsiteY14" fmla="*/ 1391057 h 1791852"/>
                <a:gd name="connsiteX15" fmla="*/ 79928 w 2199130"/>
                <a:gd name="connsiteY15" fmla="*/ 1288315 h 1791852"/>
                <a:gd name="connsiteX16" fmla="*/ 18283 w 2199130"/>
                <a:gd name="connsiteY16" fmla="*/ 990365 h 1791852"/>
                <a:gd name="connsiteX17" fmla="*/ 285411 w 2199130"/>
                <a:gd name="connsiteY17" fmla="*/ 754059 h 1791852"/>
                <a:gd name="connsiteX18" fmla="*/ 244314 w 2199130"/>
                <a:gd name="connsiteY18" fmla="*/ 599947 h 1791852"/>
                <a:gd name="connsiteX0" fmla="*/ 244314 w 2199130"/>
                <a:gd name="connsiteY0" fmla="*/ 595967 h 1787872"/>
                <a:gd name="connsiteX1" fmla="*/ 501168 w 2199130"/>
                <a:gd name="connsiteY1" fmla="*/ 369935 h 1787872"/>
                <a:gd name="connsiteX2" fmla="*/ 583362 w 2199130"/>
                <a:gd name="connsiteY2" fmla="*/ 92533 h 1787872"/>
                <a:gd name="connsiteX3" fmla="*/ 932683 w 2199130"/>
                <a:gd name="connsiteY3" fmla="*/ 65 h 1787872"/>
                <a:gd name="connsiteX4" fmla="*/ 1364198 w 2199130"/>
                <a:gd name="connsiteY4" fmla="*/ 102808 h 1787872"/>
                <a:gd name="connsiteX5" fmla="*/ 1672422 w 2199130"/>
                <a:gd name="connsiteY5" fmla="*/ 236371 h 1787872"/>
                <a:gd name="connsiteX6" fmla="*/ 2186130 w 2199130"/>
                <a:gd name="connsiteY6" fmla="*/ 400758 h 1787872"/>
                <a:gd name="connsiteX7" fmla="*/ 2052566 w 2199130"/>
                <a:gd name="connsiteY7" fmla="*/ 770627 h 1787872"/>
                <a:gd name="connsiteX8" fmla="*/ 2134759 w 2199130"/>
                <a:gd name="connsiteY8" fmla="*/ 1130223 h 1787872"/>
                <a:gd name="connsiteX9" fmla="*/ 2073114 w 2199130"/>
                <a:gd name="connsiteY9" fmla="*/ 1387077 h 1787872"/>
                <a:gd name="connsiteX10" fmla="*/ 1610777 w 2199130"/>
                <a:gd name="connsiteY10" fmla="*/ 1397351 h 1787872"/>
                <a:gd name="connsiteX11" fmla="*/ 1395020 w 2199130"/>
                <a:gd name="connsiteY11" fmla="*/ 1643931 h 1787872"/>
                <a:gd name="connsiteX12" fmla="*/ 912135 w 2199130"/>
                <a:gd name="connsiteY12" fmla="*/ 1787769 h 1787872"/>
                <a:gd name="connsiteX13" fmla="*/ 655280 w 2199130"/>
                <a:gd name="connsiteY13" fmla="*/ 1623383 h 1787872"/>
                <a:gd name="connsiteX14" fmla="*/ 531991 w 2199130"/>
                <a:gd name="connsiteY14" fmla="*/ 1387077 h 1787872"/>
                <a:gd name="connsiteX15" fmla="*/ 79928 w 2199130"/>
                <a:gd name="connsiteY15" fmla="*/ 1284335 h 1787872"/>
                <a:gd name="connsiteX16" fmla="*/ 18283 w 2199130"/>
                <a:gd name="connsiteY16" fmla="*/ 986385 h 1787872"/>
                <a:gd name="connsiteX17" fmla="*/ 285411 w 2199130"/>
                <a:gd name="connsiteY17" fmla="*/ 750079 h 1787872"/>
                <a:gd name="connsiteX18" fmla="*/ 244314 w 2199130"/>
                <a:gd name="connsiteY18" fmla="*/ 595967 h 1787872"/>
                <a:gd name="connsiteX0" fmla="*/ 264863 w 2199130"/>
                <a:gd name="connsiteY0" fmla="*/ 544596 h 1787872"/>
                <a:gd name="connsiteX1" fmla="*/ 501168 w 2199130"/>
                <a:gd name="connsiteY1" fmla="*/ 369935 h 1787872"/>
                <a:gd name="connsiteX2" fmla="*/ 583362 w 2199130"/>
                <a:gd name="connsiteY2" fmla="*/ 92533 h 1787872"/>
                <a:gd name="connsiteX3" fmla="*/ 932683 w 2199130"/>
                <a:gd name="connsiteY3" fmla="*/ 65 h 1787872"/>
                <a:gd name="connsiteX4" fmla="*/ 1364198 w 2199130"/>
                <a:gd name="connsiteY4" fmla="*/ 102808 h 1787872"/>
                <a:gd name="connsiteX5" fmla="*/ 1672422 w 2199130"/>
                <a:gd name="connsiteY5" fmla="*/ 236371 h 1787872"/>
                <a:gd name="connsiteX6" fmla="*/ 2186130 w 2199130"/>
                <a:gd name="connsiteY6" fmla="*/ 400758 h 1787872"/>
                <a:gd name="connsiteX7" fmla="*/ 2052566 w 2199130"/>
                <a:gd name="connsiteY7" fmla="*/ 770627 h 1787872"/>
                <a:gd name="connsiteX8" fmla="*/ 2134759 w 2199130"/>
                <a:gd name="connsiteY8" fmla="*/ 1130223 h 1787872"/>
                <a:gd name="connsiteX9" fmla="*/ 2073114 w 2199130"/>
                <a:gd name="connsiteY9" fmla="*/ 1387077 h 1787872"/>
                <a:gd name="connsiteX10" fmla="*/ 1610777 w 2199130"/>
                <a:gd name="connsiteY10" fmla="*/ 1397351 h 1787872"/>
                <a:gd name="connsiteX11" fmla="*/ 1395020 w 2199130"/>
                <a:gd name="connsiteY11" fmla="*/ 1643931 h 1787872"/>
                <a:gd name="connsiteX12" fmla="*/ 912135 w 2199130"/>
                <a:gd name="connsiteY12" fmla="*/ 1787769 h 1787872"/>
                <a:gd name="connsiteX13" fmla="*/ 655280 w 2199130"/>
                <a:gd name="connsiteY13" fmla="*/ 1623383 h 1787872"/>
                <a:gd name="connsiteX14" fmla="*/ 531991 w 2199130"/>
                <a:gd name="connsiteY14" fmla="*/ 1387077 h 1787872"/>
                <a:gd name="connsiteX15" fmla="*/ 79928 w 2199130"/>
                <a:gd name="connsiteY15" fmla="*/ 1284335 h 1787872"/>
                <a:gd name="connsiteX16" fmla="*/ 18283 w 2199130"/>
                <a:gd name="connsiteY16" fmla="*/ 986385 h 1787872"/>
                <a:gd name="connsiteX17" fmla="*/ 285411 w 2199130"/>
                <a:gd name="connsiteY17" fmla="*/ 750079 h 1787872"/>
                <a:gd name="connsiteX18" fmla="*/ 264863 w 2199130"/>
                <a:gd name="connsiteY18" fmla="*/ 544596 h 1787872"/>
                <a:gd name="connsiteX0" fmla="*/ 264863 w 2199130"/>
                <a:gd name="connsiteY0" fmla="*/ 544596 h 1787872"/>
                <a:gd name="connsiteX1" fmla="*/ 501168 w 2199130"/>
                <a:gd name="connsiteY1" fmla="*/ 369935 h 1787872"/>
                <a:gd name="connsiteX2" fmla="*/ 583362 w 2199130"/>
                <a:gd name="connsiteY2" fmla="*/ 92533 h 1787872"/>
                <a:gd name="connsiteX3" fmla="*/ 932683 w 2199130"/>
                <a:gd name="connsiteY3" fmla="*/ 65 h 1787872"/>
                <a:gd name="connsiteX4" fmla="*/ 1364198 w 2199130"/>
                <a:gd name="connsiteY4" fmla="*/ 102808 h 1787872"/>
                <a:gd name="connsiteX5" fmla="*/ 1672422 w 2199130"/>
                <a:gd name="connsiteY5" fmla="*/ 236371 h 1787872"/>
                <a:gd name="connsiteX6" fmla="*/ 2186130 w 2199130"/>
                <a:gd name="connsiteY6" fmla="*/ 400758 h 1787872"/>
                <a:gd name="connsiteX7" fmla="*/ 2052566 w 2199130"/>
                <a:gd name="connsiteY7" fmla="*/ 770627 h 1787872"/>
                <a:gd name="connsiteX8" fmla="*/ 2134759 w 2199130"/>
                <a:gd name="connsiteY8" fmla="*/ 1130223 h 1787872"/>
                <a:gd name="connsiteX9" fmla="*/ 2073114 w 2199130"/>
                <a:gd name="connsiteY9" fmla="*/ 1387077 h 1787872"/>
                <a:gd name="connsiteX10" fmla="*/ 1610777 w 2199130"/>
                <a:gd name="connsiteY10" fmla="*/ 1397351 h 1787872"/>
                <a:gd name="connsiteX11" fmla="*/ 1395020 w 2199130"/>
                <a:gd name="connsiteY11" fmla="*/ 1643931 h 1787872"/>
                <a:gd name="connsiteX12" fmla="*/ 912135 w 2199130"/>
                <a:gd name="connsiteY12" fmla="*/ 1787769 h 1787872"/>
                <a:gd name="connsiteX13" fmla="*/ 655280 w 2199130"/>
                <a:gd name="connsiteY13" fmla="*/ 1623383 h 1787872"/>
                <a:gd name="connsiteX14" fmla="*/ 531991 w 2199130"/>
                <a:gd name="connsiteY14" fmla="*/ 1387077 h 1787872"/>
                <a:gd name="connsiteX15" fmla="*/ 79928 w 2199130"/>
                <a:gd name="connsiteY15" fmla="*/ 1284335 h 1787872"/>
                <a:gd name="connsiteX16" fmla="*/ 18283 w 2199130"/>
                <a:gd name="connsiteY16" fmla="*/ 986385 h 1787872"/>
                <a:gd name="connsiteX17" fmla="*/ 234040 w 2199130"/>
                <a:gd name="connsiteY17" fmla="*/ 791175 h 1787872"/>
                <a:gd name="connsiteX18" fmla="*/ 264863 w 2199130"/>
                <a:gd name="connsiteY18" fmla="*/ 544596 h 1787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2199130" h="1787872">
                  <a:moveTo>
                    <a:pt x="264863" y="544596"/>
                  </a:moveTo>
                  <a:cubicBezTo>
                    <a:pt x="309384" y="474389"/>
                    <a:pt x="448085" y="445279"/>
                    <a:pt x="501168" y="369935"/>
                  </a:cubicBezTo>
                  <a:cubicBezTo>
                    <a:pt x="554251" y="294591"/>
                    <a:pt x="511443" y="154178"/>
                    <a:pt x="583362" y="92533"/>
                  </a:cubicBezTo>
                  <a:cubicBezTo>
                    <a:pt x="655281" y="30888"/>
                    <a:pt x="802544" y="-1647"/>
                    <a:pt x="932683" y="65"/>
                  </a:cubicBezTo>
                  <a:cubicBezTo>
                    <a:pt x="1062822" y="1777"/>
                    <a:pt x="1240908" y="63424"/>
                    <a:pt x="1364198" y="102808"/>
                  </a:cubicBezTo>
                  <a:cubicBezTo>
                    <a:pt x="1487488" y="142192"/>
                    <a:pt x="1535433" y="186713"/>
                    <a:pt x="1672422" y="236371"/>
                  </a:cubicBezTo>
                  <a:cubicBezTo>
                    <a:pt x="1809411" y="286029"/>
                    <a:pt x="2122773" y="311715"/>
                    <a:pt x="2186130" y="400758"/>
                  </a:cubicBezTo>
                  <a:cubicBezTo>
                    <a:pt x="2249487" y="489801"/>
                    <a:pt x="2061128" y="649050"/>
                    <a:pt x="2052566" y="770627"/>
                  </a:cubicBezTo>
                  <a:cubicBezTo>
                    <a:pt x="2044004" y="892204"/>
                    <a:pt x="2131334" y="1027481"/>
                    <a:pt x="2134759" y="1130223"/>
                  </a:cubicBezTo>
                  <a:cubicBezTo>
                    <a:pt x="2138184" y="1232965"/>
                    <a:pt x="2160444" y="1342556"/>
                    <a:pt x="2073114" y="1387077"/>
                  </a:cubicBezTo>
                  <a:cubicBezTo>
                    <a:pt x="1985784" y="1431598"/>
                    <a:pt x="1723793" y="1354542"/>
                    <a:pt x="1610777" y="1397351"/>
                  </a:cubicBezTo>
                  <a:cubicBezTo>
                    <a:pt x="1497761" y="1440160"/>
                    <a:pt x="1511460" y="1578861"/>
                    <a:pt x="1395020" y="1643931"/>
                  </a:cubicBezTo>
                  <a:cubicBezTo>
                    <a:pt x="1278580" y="1709001"/>
                    <a:pt x="1035425" y="1791194"/>
                    <a:pt x="912135" y="1787769"/>
                  </a:cubicBezTo>
                  <a:cubicBezTo>
                    <a:pt x="788845" y="1784344"/>
                    <a:pt x="718637" y="1690165"/>
                    <a:pt x="655280" y="1623383"/>
                  </a:cubicBezTo>
                  <a:cubicBezTo>
                    <a:pt x="591923" y="1556601"/>
                    <a:pt x="627883" y="1443585"/>
                    <a:pt x="531991" y="1387077"/>
                  </a:cubicBezTo>
                  <a:cubicBezTo>
                    <a:pt x="436099" y="1330569"/>
                    <a:pt x="165546" y="1351117"/>
                    <a:pt x="79928" y="1284335"/>
                  </a:cubicBezTo>
                  <a:cubicBezTo>
                    <a:pt x="-5690" y="1217553"/>
                    <a:pt x="-15964" y="1075428"/>
                    <a:pt x="18283" y="986385"/>
                  </a:cubicBezTo>
                  <a:cubicBezTo>
                    <a:pt x="52530" y="897342"/>
                    <a:pt x="192943" y="864806"/>
                    <a:pt x="234040" y="791175"/>
                  </a:cubicBezTo>
                  <a:cubicBezTo>
                    <a:pt x="275137" y="717544"/>
                    <a:pt x="220342" y="614803"/>
                    <a:pt x="264863" y="544596"/>
                  </a:cubicBezTo>
                  <a:close/>
                </a:path>
              </a:pathLst>
            </a:custGeom>
            <a:gradFill>
              <a:gsLst>
                <a:gs pos="15000">
                  <a:srgbClr val="E9D4F8">
                    <a:shade val="30000"/>
                    <a:satMod val="115000"/>
                  </a:srgbClr>
                </a:gs>
                <a:gs pos="50000">
                  <a:srgbClr val="E9D4F8">
                    <a:shade val="67500"/>
                    <a:satMod val="115000"/>
                  </a:srgbClr>
                </a:gs>
                <a:gs pos="100000">
                  <a:srgbClr val="E9D4F8">
                    <a:shade val="100000"/>
                    <a:satMod val="115000"/>
                  </a:srgbClr>
                </a:gs>
              </a:gsLst>
              <a:path path="circle">
                <a:fillToRect l="100000" b="100000"/>
              </a:path>
            </a:gradFill>
            <a:ln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任意多边形: 形状 107">
              <a:extLst>
                <a:ext uri="{FF2B5EF4-FFF2-40B4-BE49-F238E27FC236}">
                  <a16:creationId xmlns:a16="http://schemas.microsoft.com/office/drawing/2014/main" id="{3EC09ABD-9E65-4A16-83BE-90C675D0BCD9}"/>
                </a:ext>
              </a:extLst>
            </p:cNvPr>
            <p:cNvSpPr/>
            <p:nvPr/>
          </p:nvSpPr>
          <p:spPr>
            <a:xfrm rot="11128731">
              <a:off x="6023043" y="5073089"/>
              <a:ext cx="1199689" cy="726607"/>
            </a:xfrm>
            <a:custGeom>
              <a:avLst/>
              <a:gdLst>
                <a:gd name="connsiteX0" fmla="*/ 4238 w 1552989"/>
                <a:gd name="connsiteY0" fmla="*/ 267706 h 1155866"/>
                <a:gd name="connsiteX1" fmla="*/ 35061 w 1552989"/>
                <a:gd name="connsiteY1" fmla="*/ 668398 h 1155866"/>
                <a:gd name="connsiteX2" fmla="*/ 230270 w 1552989"/>
                <a:gd name="connsiteY2" fmla="*/ 914978 h 1155866"/>
                <a:gd name="connsiteX3" fmla="*/ 517946 w 1552989"/>
                <a:gd name="connsiteY3" fmla="*/ 1079364 h 1155866"/>
                <a:gd name="connsiteX4" fmla="*/ 949461 w 1552989"/>
                <a:gd name="connsiteY4" fmla="*/ 1141009 h 1155866"/>
                <a:gd name="connsiteX5" fmla="*/ 1206315 w 1552989"/>
                <a:gd name="connsiteY5" fmla="*/ 1151283 h 1155866"/>
                <a:gd name="connsiteX6" fmla="*/ 1370701 w 1552989"/>
                <a:gd name="connsiteY6" fmla="*/ 1079364 h 1155866"/>
                <a:gd name="connsiteX7" fmla="*/ 1483717 w 1552989"/>
                <a:gd name="connsiteY7" fmla="*/ 966349 h 1155866"/>
                <a:gd name="connsiteX8" fmla="*/ 1524814 w 1552989"/>
                <a:gd name="connsiteY8" fmla="*/ 822510 h 1155866"/>
                <a:gd name="connsiteX9" fmla="*/ 1545362 w 1552989"/>
                <a:gd name="connsiteY9" fmla="*/ 699220 h 1155866"/>
                <a:gd name="connsiteX10" fmla="*/ 1391250 w 1552989"/>
                <a:gd name="connsiteY10" fmla="*/ 627301 h 1155866"/>
                <a:gd name="connsiteX11" fmla="*/ 1165218 w 1552989"/>
                <a:gd name="connsiteY11" fmla="*/ 586205 h 1155866"/>
                <a:gd name="connsiteX12" fmla="*/ 928913 w 1552989"/>
                <a:gd name="connsiteY12" fmla="*/ 524560 h 1155866"/>
                <a:gd name="connsiteX13" fmla="*/ 682333 w 1552989"/>
                <a:gd name="connsiteY13" fmla="*/ 432092 h 1155866"/>
                <a:gd name="connsiteX14" fmla="*/ 620688 w 1552989"/>
                <a:gd name="connsiteY14" fmla="*/ 319077 h 1155866"/>
                <a:gd name="connsiteX15" fmla="*/ 548769 w 1552989"/>
                <a:gd name="connsiteY15" fmla="*/ 134142 h 1155866"/>
                <a:gd name="connsiteX16" fmla="*/ 497398 w 1552989"/>
                <a:gd name="connsiteY16" fmla="*/ 10852 h 1155866"/>
                <a:gd name="connsiteX17" fmla="*/ 363834 w 1552989"/>
                <a:gd name="connsiteY17" fmla="*/ 10852 h 1155866"/>
                <a:gd name="connsiteX18" fmla="*/ 178899 w 1552989"/>
                <a:gd name="connsiteY18" fmla="*/ 51949 h 1155866"/>
                <a:gd name="connsiteX19" fmla="*/ 86432 w 1552989"/>
                <a:gd name="connsiteY19" fmla="*/ 123868 h 1155866"/>
                <a:gd name="connsiteX20" fmla="*/ 4238 w 1552989"/>
                <a:gd name="connsiteY20" fmla="*/ 267706 h 1155866"/>
                <a:gd name="connsiteX0" fmla="*/ 643 w 1641861"/>
                <a:gd name="connsiteY0" fmla="*/ 308802 h 1155866"/>
                <a:gd name="connsiteX1" fmla="*/ 123933 w 1641861"/>
                <a:gd name="connsiteY1" fmla="*/ 668398 h 1155866"/>
                <a:gd name="connsiteX2" fmla="*/ 319142 w 1641861"/>
                <a:gd name="connsiteY2" fmla="*/ 914978 h 1155866"/>
                <a:gd name="connsiteX3" fmla="*/ 606818 w 1641861"/>
                <a:gd name="connsiteY3" fmla="*/ 1079364 h 1155866"/>
                <a:gd name="connsiteX4" fmla="*/ 1038333 w 1641861"/>
                <a:gd name="connsiteY4" fmla="*/ 1141009 h 1155866"/>
                <a:gd name="connsiteX5" fmla="*/ 1295187 w 1641861"/>
                <a:gd name="connsiteY5" fmla="*/ 1151283 h 1155866"/>
                <a:gd name="connsiteX6" fmla="*/ 1459573 w 1641861"/>
                <a:gd name="connsiteY6" fmla="*/ 1079364 h 1155866"/>
                <a:gd name="connsiteX7" fmla="*/ 1572589 w 1641861"/>
                <a:gd name="connsiteY7" fmla="*/ 966349 h 1155866"/>
                <a:gd name="connsiteX8" fmla="*/ 1613686 w 1641861"/>
                <a:gd name="connsiteY8" fmla="*/ 822510 h 1155866"/>
                <a:gd name="connsiteX9" fmla="*/ 1634234 w 1641861"/>
                <a:gd name="connsiteY9" fmla="*/ 699220 h 1155866"/>
                <a:gd name="connsiteX10" fmla="*/ 1480122 w 1641861"/>
                <a:gd name="connsiteY10" fmla="*/ 627301 h 1155866"/>
                <a:gd name="connsiteX11" fmla="*/ 1254090 w 1641861"/>
                <a:gd name="connsiteY11" fmla="*/ 586205 h 1155866"/>
                <a:gd name="connsiteX12" fmla="*/ 1017785 w 1641861"/>
                <a:gd name="connsiteY12" fmla="*/ 524560 h 1155866"/>
                <a:gd name="connsiteX13" fmla="*/ 771205 w 1641861"/>
                <a:gd name="connsiteY13" fmla="*/ 432092 h 1155866"/>
                <a:gd name="connsiteX14" fmla="*/ 709560 w 1641861"/>
                <a:gd name="connsiteY14" fmla="*/ 319077 h 1155866"/>
                <a:gd name="connsiteX15" fmla="*/ 637641 w 1641861"/>
                <a:gd name="connsiteY15" fmla="*/ 134142 h 1155866"/>
                <a:gd name="connsiteX16" fmla="*/ 586270 w 1641861"/>
                <a:gd name="connsiteY16" fmla="*/ 10852 h 1155866"/>
                <a:gd name="connsiteX17" fmla="*/ 452706 w 1641861"/>
                <a:gd name="connsiteY17" fmla="*/ 10852 h 1155866"/>
                <a:gd name="connsiteX18" fmla="*/ 267771 w 1641861"/>
                <a:gd name="connsiteY18" fmla="*/ 51949 h 1155866"/>
                <a:gd name="connsiteX19" fmla="*/ 175304 w 1641861"/>
                <a:gd name="connsiteY19" fmla="*/ 123868 h 1155866"/>
                <a:gd name="connsiteX20" fmla="*/ 643 w 1641861"/>
                <a:gd name="connsiteY20" fmla="*/ 308802 h 1155866"/>
                <a:gd name="connsiteX0" fmla="*/ 0 w 1641218"/>
                <a:gd name="connsiteY0" fmla="*/ 308802 h 1155866"/>
                <a:gd name="connsiteX1" fmla="*/ 123290 w 1641218"/>
                <a:gd name="connsiteY1" fmla="*/ 668398 h 1155866"/>
                <a:gd name="connsiteX2" fmla="*/ 318499 w 1641218"/>
                <a:gd name="connsiteY2" fmla="*/ 914978 h 1155866"/>
                <a:gd name="connsiteX3" fmla="*/ 606175 w 1641218"/>
                <a:gd name="connsiteY3" fmla="*/ 1079364 h 1155866"/>
                <a:gd name="connsiteX4" fmla="*/ 1037690 w 1641218"/>
                <a:gd name="connsiteY4" fmla="*/ 1141009 h 1155866"/>
                <a:gd name="connsiteX5" fmla="*/ 1294544 w 1641218"/>
                <a:gd name="connsiteY5" fmla="*/ 1151283 h 1155866"/>
                <a:gd name="connsiteX6" fmla="*/ 1458930 w 1641218"/>
                <a:gd name="connsiteY6" fmla="*/ 1079364 h 1155866"/>
                <a:gd name="connsiteX7" fmla="*/ 1571946 w 1641218"/>
                <a:gd name="connsiteY7" fmla="*/ 966349 h 1155866"/>
                <a:gd name="connsiteX8" fmla="*/ 1613043 w 1641218"/>
                <a:gd name="connsiteY8" fmla="*/ 822510 h 1155866"/>
                <a:gd name="connsiteX9" fmla="*/ 1633591 w 1641218"/>
                <a:gd name="connsiteY9" fmla="*/ 699220 h 1155866"/>
                <a:gd name="connsiteX10" fmla="*/ 1479479 w 1641218"/>
                <a:gd name="connsiteY10" fmla="*/ 627301 h 1155866"/>
                <a:gd name="connsiteX11" fmla="*/ 1253447 w 1641218"/>
                <a:gd name="connsiteY11" fmla="*/ 586205 h 1155866"/>
                <a:gd name="connsiteX12" fmla="*/ 1017142 w 1641218"/>
                <a:gd name="connsiteY12" fmla="*/ 524560 h 1155866"/>
                <a:gd name="connsiteX13" fmla="*/ 770562 w 1641218"/>
                <a:gd name="connsiteY13" fmla="*/ 432092 h 1155866"/>
                <a:gd name="connsiteX14" fmla="*/ 708917 w 1641218"/>
                <a:gd name="connsiteY14" fmla="*/ 319077 h 1155866"/>
                <a:gd name="connsiteX15" fmla="*/ 636998 w 1641218"/>
                <a:gd name="connsiteY15" fmla="*/ 134142 h 1155866"/>
                <a:gd name="connsiteX16" fmla="*/ 585627 w 1641218"/>
                <a:gd name="connsiteY16" fmla="*/ 10852 h 1155866"/>
                <a:gd name="connsiteX17" fmla="*/ 452063 w 1641218"/>
                <a:gd name="connsiteY17" fmla="*/ 10852 h 1155866"/>
                <a:gd name="connsiteX18" fmla="*/ 267128 w 1641218"/>
                <a:gd name="connsiteY18" fmla="*/ 51949 h 1155866"/>
                <a:gd name="connsiteX19" fmla="*/ 123291 w 1641218"/>
                <a:gd name="connsiteY19" fmla="*/ 93046 h 1155866"/>
                <a:gd name="connsiteX20" fmla="*/ 0 w 1641218"/>
                <a:gd name="connsiteY20" fmla="*/ 308802 h 1155866"/>
                <a:gd name="connsiteX0" fmla="*/ 30 w 1641248"/>
                <a:gd name="connsiteY0" fmla="*/ 308802 h 1155866"/>
                <a:gd name="connsiteX1" fmla="*/ 123320 w 1641248"/>
                <a:gd name="connsiteY1" fmla="*/ 668398 h 1155866"/>
                <a:gd name="connsiteX2" fmla="*/ 318529 w 1641248"/>
                <a:gd name="connsiteY2" fmla="*/ 914978 h 1155866"/>
                <a:gd name="connsiteX3" fmla="*/ 606205 w 1641248"/>
                <a:gd name="connsiteY3" fmla="*/ 1079364 h 1155866"/>
                <a:gd name="connsiteX4" fmla="*/ 1037720 w 1641248"/>
                <a:gd name="connsiteY4" fmla="*/ 1141009 h 1155866"/>
                <a:gd name="connsiteX5" fmla="*/ 1294574 w 1641248"/>
                <a:gd name="connsiteY5" fmla="*/ 1151283 h 1155866"/>
                <a:gd name="connsiteX6" fmla="*/ 1458960 w 1641248"/>
                <a:gd name="connsiteY6" fmla="*/ 1079364 h 1155866"/>
                <a:gd name="connsiteX7" fmla="*/ 1571976 w 1641248"/>
                <a:gd name="connsiteY7" fmla="*/ 966349 h 1155866"/>
                <a:gd name="connsiteX8" fmla="*/ 1613073 w 1641248"/>
                <a:gd name="connsiteY8" fmla="*/ 822510 h 1155866"/>
                <a:gd name="connsiteX9" fmla="*/ 1633621 w 1641248"/>
                <a:gd name="connsiteY9" fmla="*/ 699220 h 1155866"/>
                <a:gd name="connsiteX10" fmla="*/ 1479509 w 1641248"/>
                <a:gd name="connsiteY10" fmla="*/ 627301 h 1155866"/>
                <a:gd name="connsiteX11" fmla="*/ 1253477 w 1641248"/>
                <a:gd name="connsiteY11" fmla="*/ 586205 h 1155866"/>
                <a:gd name="connsiteX12" fmla="*/ 1017172 w 1641248"/>
                <a:gd name="connsiteY12" fmla="*/ 524560 h 1155866"/>
                <a:gd name="connsiteX13" fmla="*/ 770592 w 1641248"/>
                <a:gd name="connsiteY13" fmla="*/ 432092 h 1155866"/>
                <a:gd name="connsiteX14" fmla="*/ 708947 w 1641248"/>
                <a:gd name="connsiteY14" fmla="*/ 319077 h 1155866"/>
                <a:gd name="connsiteX15" fmla="*/ 637028 w 1641248"/>
                <a:gd name="connsiteY15" fmla="*/ 134142 h 1155866"/>
                <a:gd name="connsiteX16" fmla="*/ 585657 w 1641248"/>
                <a:gd name="connsiteY16" fmla="*/ 10852 h 1155866"/>
                <a:gd name="connsiteX17" fmla="*/ 452093 w 1641248"/>
                <a:gd name="connsiteY17" fmla="*/ 10852 h 1155866"/>
                <a:gd name="connsiteX18" fmla="*/ 267158 w 1641248"/>
                <a:gd name="connsiteY18" fmla="*/ 51949 h 1155866"/>
                <a:gd name="connsiteX19" fmla="*/ 113046 w 1641248"/>
                <a:gd name="connsiteY19" fmla="*/ 51950 h 1155866"/>
                <a:gd name="connsiteX20" fmla="*/ 30 w 1641248"/>
                <a:gd name="connsiteY20" fmla="*/ 308802 h 1155866"/>
                <a:gd name="connsiteX0" fmla="*/ 30 w 1641248"/>
                <a:gd name="connsiteY0" fmla="*/ 333391 h 1180455"/>
                <a:gd name="connsiteX1" fmla="*/ 123320 w 1641248"/>
                <a:gd name="connsiteY1" fmla="*/ 692987 h 1180455"/>
                <a:gd name="connsiteX2" fmla="*/ 318529 w 1641248"/>
                <a:gd name="connsiteY2" fmla="*/ 939567 h 1180455"/>
                <a:gd name="connsiteX3" fmla="*/ 606205 w 1641248"/>
                <a:gd name="connsiteY3" fmla="*/ 1103953 h 1180455"/>
                <a:gd name="connsiteX4" fmla="*/ 1037720 w 1641248"/>
                <a:gd name="connsiteY4" fmla="*/ 1165598 h 1180455"/>
                <a:gd name="connsiteX5" fmla="*/ 1294574 w 1641248"/>
                <a:gd name="connsiteY5" fmla="*/ 1175872 h 1180455"/>
                <a:gd name="connsiteX6" fmla="*/ 1458960 w 1641248"/>
                <a:gd name="connsiteY6" fmla="*/ 1103953 h 1180455"/>
                <a:gd name="connsiteX7" fmla="*/ 1571976 w 1641248"/>
                <a:gd name="connsiteY7" fmla="*/ 990938 h 1180455"/>
                <a:gd name="connsiteX8" fmla="*/ 1613073 w 1641248"/>
                <a:gd name="connsiteY8" fmla="*/ 847099 h 1180455"/>
                <a:gd name="connsiteX9" fmla="*/ 1633621 w 1641248"/>
                <a:gd name="connsiteY9" fmla="*/ 723809 h 1180455"/>
                <a:gd name="connsiteX10" fmla="*/ 1479509 w 1641248"/>
                <a:gd name="connsiteY10" fmla="*/ 651890 h 1180455"/>
                <a:gd name="connsiteX11" fmla="*/ 1253477 w 1641248"/>
                <a:gd name="connsiteY11" fmla="*/ 610794 h 1180455"/>
                <a:gd name="connsiteX12" fmla="*/ 1017172 w 1641248"/>
                <a:gd name="connsiteY12" fmla="*/ 549149 h 1180455"/>
                <a:gd name="connsiteX13" fmla="*/ 770592 w 1641248"/>
                <a:gd name="connsiteY13" fmla="*/ 456681 h 1180455"/>
                <a:gd name="connsiteX14" fmla="*/ 708947 w 1641248"/>
                <a:gd name="connsiteY14" fmla="*/ 343666 h 1180455"/>
                <a:gd name="connsiteX15" fmla="*/ 637028 w 1641248"/>
                <a:gd name="connsiteY15" fmla="*/ 158731 h 1180455"/>
                <a:gd name="connsiteX16" fmla="*/ 585657 w 1641248"/>
                <a:gd name="connsiteY16" fmla="*/ 35441 h 1180455"/>
                <a:gd name="connsiteX17" fmla="*/ 452093 w 1641248"/>
                <a:gd name="connsiteY17" fmla="*/ 35441 h 1180455"/>
                <a:gd name="connsiteX18" fmla="*/ 256884 w 1641248"/>
                <a:gd name="connsiteY18" fmla="*/ 4619 h 1180455"/>
                <a:gd name="connsiteX19" fmla="*/ 113046 w 1641248"/>
                <a:gd name="connsiteY19" fmla="*/ 76539 h 1180455"/>
                <a:gd name="connsiteX20" fmla="*/ 30 w 1641248"/>
                <a:gd name="connsiteY20" fmla="*/ 333391 h 1180455"/>
                <a:gd name="connsiteX0" fmla="*/ 30 w 1641248"/>
                <a:gd name="connsiteY0" fmla="*/ 350972 h 1198036"/>
                <a:gd name="connsiteX1" fmla="*/ 123320 w 1641248"/>
                <a:gd name="connsiteY1" fmla="*/ 710568 h 1198036"/>
                <a:gd name="connsiteX2" fmla="*/ 318529 w 1641248"/>
                <a:gd name="connsiteY2" fmla="*/ 957148 h 1198036"/>
                <a:gd name="connsiteX3" fmla="*/ 606205 w 1641248"/>
                <a:gd name="connsiteY3" fmla="*/ 1121534 h 1198036"/>
                <a:gd name="connsiteX4" fmla="*/ 1037720 w 1641248"/>
                <a:gd name="connsiteY4" fmla="*/ 1183179 h 1198036"/>
                <a:gd name="connsiteX5" fmla="*/ 1294574 w 1641248"/>
                <a:gd name="connsiteY5" fmla="*/ 1193453 h 1198036"/>
                <a:gd name="connsiteX6" fmla="*/ 1458960 w 1641248"/>
                <a:gd name="connsiteY6" fmla="*/ 1121534 h 1198036"/>
                <a:gd name="connsiteX7" fmla="*/ 1571976 w 1641248"/>
                <a:gd name="connsiteY7" fmla="*/ 1008519 h 1198036"/>
                <a:gd name="connsiteX8" fmla="*/ 1613073 w 1641248"/>
                <a:gd name="connsiteY8" fmla="*/ 864680 h 1198036"/>
                <a:gd name="connsiteX9" fmla="*/ 1633621 w 1641248"/>
                <a:gd name="connsiteY9" fmla="*/ 741390 h 1198036"/>
                <a:gd name="connsiteX10" fmla="*/ 1479509 w 1641248"/>
                <a:gd name="connsiteY10" fmla="*/ 669471 h 1198036"/>
                <a:gd name="connsiteX11" fmla="*/ 1253477 w 1641248"/>
                <a:gd name="connsiteY11" fmla="*/ 628375 h 1198036"/>
                <a:gd name="connsiteX12" fmla="*/ 1017172 w 1641248"/>
                <a:gd name="connsiteY12" fmla="*/ 566730 h 1198036"/>
                <a:gd name="connsiteX13" fmla="*/ 770592 w 1641248"/>
                <a:gd name="connsiteY13" fmla="*/ 474262 h 1198036"/>
                <a:gd name="connsiteX14" fmla="*/ 708947 w 1641248"/>
                <a:gd name="connsiteY14" fmla="*/ 361247 h 1198036"/>
                <a:gd name="connsiteX15" fmla="*/ 637028 w 1641248"/>
                <a:gd name="connsiteY15" fmla="*/ 176312 h 1198036"/>
                <a:gd name="connsiteX16" fmla="*/ 585657 w 1641248"/>
                <a:gd name="connsiteY16" fmla="*/ 53022 h 1198036"/>
                <a:gd name="connsiteX17" fmla="*/ 452093 w 1641248"/>
                <a:gd name="connsiteY17" fmla="*/ 1651 h 1198036"/>
                <a:gd name="connsiteX18" fmla="*/ 256884 w 1641248"/>
                <a:gd name="connsiteY18" fmla="*/ 22200 h 1198036"/>
                <a:gd name="connsiteX19" fmla="*/ 113046 w 1641248"/>
                <a:gd name="connsiteY19" fmla="*/ 94120 h 1198036"/>
                <a:gd name="connsiteX20" fmla="*/ 30 w 1641248"/>
                <a:gd name="connsiteY20" fmla="*/ 350972 h 1198036"/>
                <a:gd name="connsiteX0" fmla="*/ 30 w 1641248"/>
                <a:gd name="connsiteY0" fmla="*/ 363054 h 1210118"/>
                <a:gd name="connsiteX1" fmla="*/ 123320 w 1641248"/>
                <a:gd name="connsiteY1" fmla="*/ 722650 h 1210118"/>
                <a:gd name="connsiteX2" fmla="*/ 318529 w 1641248"/>
                <a:gd name="connsiteY2" fmla="*/ 969230 h 1210118"/>
                <a:gd name="connsiteX3" fmla="*/ 606205 w 1641248"/>
                <a:gd name="connsiteY3" fmla="*/ 1133616 h 1210118"/>
                <a:gd name="connsiteX4" fmla="*/ 1037720 w 1641248"/>
                <a:gd name="connsiteY4" fmla="*/ 1195261 h 1210118"/>
                <a:gd name="connsiteX5" fmla="*/ 1294574 w 1641248"/>
                <a:gd name="connsiteY5" fmla="*/ 1205535 h 1210118"/>
                <a:gd name="connsiteX6" fmla="*/ 1458960 w 1641248"/>
                <a:gd name="connsiteY6" fmla="*/ 1133616 h 1210118"/>
                <a:gd name="connsiteX7" fmla="*/ 1571976 w 1641248"/>
                <a:gd name="connsiteY7" fmla="*/ 1020601 h 1210118"/>
                <a:gd name="connsiteX8" fmla="*/ 1613073 w 1641248"/>
                <a:gd name="connsiteY8" fmla="*/ 876762 h 1210118"/>
                <a:gd name="connsiteX9" fmla="*/ 1633621 w 1641248"/>
                <a:gd name="connsiteY9" fmla="*/ 753472 h 1210118"/>
                <a:gd name="connsiteX10" fmla="*/ 1479509 w 1641248"/>
                <a:gd name="connsiteY10" fmla="*/ 681553 h 1210118"/>
                <a:gd name="connsiteX11" fmla="*/ 1253477 w 1641248"/>
                <a:gd name="connsiteY11" fmla="*/ 640457 h 1210118"/>
                <a:gd name="connsiteX12" fmla="*/ 1017172 w 1641248"/>
                <a:gd name="connsiteY12" fmla="*/ 578812 h 1210118"/>
                <a:gd name="connsiteX13" fmla="*/ 770592 w 1641248"/>
                <a:gd name="connsiteY13" fmla="*/ 486344 h 1210118"/>
                <a:gd name="connsiteX14" fmla="*/ 708947 w 1641248"/>
                <a:gd name="connsiteY14" fmla="*/ 373329 h 1210118"/>
                <a:gd name="connsiteX15" fmla="*/ 637028 w 1641248"/>
                <a:gd name="connsiteY15" fmla="*/ 188394 h 1210118"/>
                <a:gd name="connsiteX16" fmla="*/ 585657 w 1641248"/>
                <a:gd name="connsiteY16" fmla="*/ 13733 h 1210118"/>
                <a:gd name="connsiteX17" fmla="*/ 452093 w 1641248"/>
                <a:gd name="connsiteY17" fmla="*/ 13733 h 1210118"/>
                <a:gd name="connsiteX18" fmla="*/ 256884 w 1641248"/>
                <a:gd name="connsiteY18" fmla="*/ 34282 h 1210118"/>
                <a:gd name="connsiteX19" fmla="*/ 113046 w 1641248"/>
                <a:gd name="connsiteY19" fmla="*/ 106202 h 1210118"/>
                <a:gd name="connsiteX20" fmla="*/ 30 w 1641248"/>
                <a:gd name="connsiteY20" fmla="*/ 363054 h 1210118"/>
                <a:gd name="connsiteX0" fmla="*/ 30 w 1641248"/>
                <a:gd name="connsiteY0" fmla="*/ 363054 h 1210118"/>
                <a:gd name="connsiteX1" fmla="*/ 123320 w 1641248"/>
                <a:gd name="connsiteY1" fmla="*/ 722650 h 1210118"/>
                <a:gd name="connsiteX2" fmla="*/ 318529 w 1641248"/>
                <a:gd name="connsiteY2" fmla="*/ 969230 h 1210118"/>
                <a:gd name="connsiteX3" fmla="*/ 606205 w 1641248"/>
                <a:gd name="connsiteY3" fmla="*/ 1133616 h 1210118"/>
                <a:gd name="connsiteX4" fmla="*/ 1037720 w 1641248"/>
                <a:gd name="connsiteY4" fmla="*/ 1195261 h 1210118"/>
                <a:gd name="connsiteX5" fmla="*/ 1294574 w 1641248"/>
                <a:gd name="connsiteY5" fmla="*/ 1205535 h 1210118"/>
                <a:gd name="connsiteX6" fmla="*/ 1458960 w 1641248"/>
                <a:gd name="connsiteY6" fmla="*/ 1133616 h 1210118"/>
                <a:gd name="connsiteX7" fmla="*/ 1571976 w 1641248"/>
                <a:gd name="connsiteY7" fmla="*/ 1020601 h 1210118"/>
                <a:gd name="connsiteX8" fmla="*/ 1613073 w 1641248"/>
                <a:gd name="connsiteY8" fmla="*/ 876762 h 1210118"/>
                <a:gd name="connsiteX9" fmla="*/ 1633621 w 1641248"/>
                <a:gd name="connsiteY9" fmla="*/ 753472 h 1210118"/>
                <a:gd name="connsiteX10" fmla="*/ 1479509 w 1641248"/>
                <a:gd name="connsiteY10" fmla="*/ 681553 h 1210118"/>
                <a:gd name="connsiteX11" fmla="*/ 1253477 w 1641248"/>
                <a:gd name="connsiteY11" fmla="*/ 640457 h 1210118"/>
                <a:gd name="connsiteX12" fmla="*/ 1017172 w 1641248"/>
                <a:gd name="connsiteY12" fmla="*/ 578812 h 1210118"/>
                <a:gd name="connsiteX13" fmla="*/ 770592 w 1641248"/>
                <a:gd name="connsiteY13" fmla="*/ 486344 h 1210118"/>
                <a:gd name="connsiteX14" fmla="*/ 708947 w 1641248"/>
                <a:gd name="connsiteY14" fmla="*/ 373329 h 1210118"/>
                <a:gd name="connsiteX15" fmla="*/ 688399 w 1641248"/>
                <a:gd name="connsiteY15" fmla="*/ 188394 h 1210118"/>
                <a:gd name="connsiteX16" fmla="*/ 585657 w 1641248"/>
                <a:gd name="connsiteY16" fmla="*/ 13733 h 1210118"/>
                <a:gd name="connsiteX17" fmla="*/ 452093 w 1641248"/>
                <a:gd name="connsiteY17" fmla="*/ 13733 h 1210118"/>
                <a:gd name="connsiteX18" fmla="*/ 256884 w 1641248"/>
                <a:gd name="connsiteY18" fmla="*/ 34282 h 1210118"/>
                <a:gd name="connsiteX19" fmla="*/ 113046 w 1641248"/>
                <a:gd name="connsiteY19" fmla="*/ 106202 h 1210118"/>
                <a:gd name="connsiteX20" fmla="*/ 30 w 1641248"/>
                <a:gd name="connsiteY20" fmla="*/ 363054 h 1210118"/>
                <a:gd name="connsiteX0" fmla="*/ 30 w 1641248"/>
                <a:gd name="connsiteY0" fmla="*/ 363054 h 1210118"/>
                <a:gd name="connsiteX1" fmla="*/ 123320 w 1641248"/>
                <a:gd name="connsiteY1" fmla="*/ 722650 h 1210118"/>
                <a:gd name="connsiteX2" fmla="*/ 318529 w 1641248"/>
                <a:gd name="connsiteY2" fmla="*/ 969230 h 1210118"/>
                <a:gd name="connsiteX3" fmla="*/ 606205 w 1641248"/>
                <a:gd name="connsiteY3" fmla="*/ 1133616 h 1210118"/>
                <a:gd name="connsiteX4" fmla="*/ 1037720 w 1641248"/>
                <a:gd name="connsiteY4" fmla="*/ 1195261 h 1210118"/>
                <a:gd name="connsiteX5" fmla="*/ 1294574 w 1641248"/>
                <a:gd name="connsiteY5" fmla="*/ 1205535 h 1210118"/>
                <a:gd name="connsiteX6" fmla="*/ 1458960 w 1641248"/>
                <a:gd name="connsiteY6" fmla="*/ 1133616 h 1210118"/>
                <a:gd name="connsiteX7" fmla="*/ 1571976 w 1641248"/>
                <a:gd name="connsiteY7" fmla="*/ 1020601 h 1210118"/>
                <a:gd name="connsiteX8" fmla="*/ 1613073 w 1641248"/>
                <a:gd name="connsiteY8" fmla="*/ 876762 h 1210118"/>
                <a:gd name="connsiteX9" fmla="*/ 1633621 w 1641248"/>
                <a:gd name="connsiteY9" fmla="*/ 753472 h 1210118"/>
                <a:gd name="connsiteX10" fmla="*/ 1479509 w 1641248"/>
                <a:gd name="connsiteY10" fmla="*/ 681553 h 1210118"/>
                <a:gd name="connsiteX11" fmla="*/ 1253477 w 1641248"/>
                <a:gd name="connsiteY11" fmla="*/ 640457 h 1210118"/>
                <a:gd name="connsiteX12" fmla="*/ 1017172 w 1641248"/>
                <a:gd name="connsiteY12" fmla="*/ 578812 h 1210118"/>
                <a:gd name="connsiteX13" fmla="*/ 770592 w 1641248"/>
                <a:gd name="connsiteY13" fmla="*/ 486344 h 1210118"/>
                <a:gd name="connsiteX14" fmla="*/ 801415 w 1641248"/>
                <a:gd name="connsiteY14" fmla="*/ 373329 h 1210118"/>
                <a:gd name="connsiteX15" fmla="*/ 688399 w 1641248"/>
                <a:gd name="connsiteY15" fmla="*/ 188394 h 1210118"/>
                <a:gd name="connsiteX16" fmla="*/ 585657 w 1641248"/>
                <a:gd name="connsiteY16" fmla="*/ 13733 h 1210118"/>
                <a:gd name="connsiteX17" fmla="*/ 452093 w 1641248"/>
                <a:gd name="connsiteY17" fmla="*/ 13733 h 1210118"/>
                <a:gd name="connsiteX18" fmla="*/ 256884 w 1641248"/>
                <a:gd name="connsiteY18" fmla="*/ 34282 h 1210118"/>
                <a:gd name="connsiteX19" fmla="*/ 113046 w 1641248"/>
                <a:gd name="connsiteY19" fmla="*/ 106202 h 1210118"/>
                <a:gd name="connsiteX20" fmla="*/ 30 w 1641248"/>
                <a:gd name="connsiteY20" fmla="*/ 363054 h 1210118"/>
                <a:gd name="connsiteX0" fmla="*/ 30 w 1641248"/>
                <a:gd name="connsiteY0" fmla="*/ 363054 h 1210118"/>
                <a:gd name="connsiteX1" fmla="*/ 123320 w 1641248"/>
                <a:gd name="connsiteY1" fmla="*/ 722650 h 1210118"/>
                <a:gd name="connsiteX2" fmla="*/ 318529 w 1641248"/>
                <a:gd name="connsiteY2" fmla="*/ 969230 h 1210118"/>
                <a:gd name="connsiteX3" fmla="*/ 606205 w 1641248"/>
                <a:gd name="connsiteY3" fmla="*/ 1133616 h 1210118"/>
                <a:gd name="connsiteX4" fmla="*/ 1037720 w 1641248"/>
                <a:gd name="connsiteY4" fmla="*/ 1195261 h 1210118"/>
                <a:gd name="connsiteX5" fmla="*/ 1294574 w 1641248"/>
                <a:gd name="connsiteY5" fmla="*/ 1205535 h 1210118"/>
                <a:gd name="connsiteX6" fmla="*/ 1458960 w 1641248"/>
                <a:gd name="connsiteY6" fmla="*/ 1133616 h 1210118"/>
                <a:gd name="connsiteX7" fmla="*/ 1571976 w 1641248"/>
                <a:gd name="connsiteY7" fmla="*/ 1020601 h 1210118"/>
                <a:gd name="connsiteX8" fmla="*/ 1613073 w 1641248"/>
                <a:gd name="connsiteY8" fmla="*/ 876762 h 1210118"/>
                <a:gd name="connsiteX9" fmla="*/ 1633621 w 1641248"/>
                <a:gd name="connsiteY9" fmla="*/ 753472 h 1210118"/>
                <a:gd name="connsiteX10" fmla="*/ 1479509 w 1641248"/>
                <a:gd name="connsiteY10" fmla="*/ 681553 h 1210118"/>
                <a:gd name="connsiteX11" fmla="*/ 1253477 w 1641248"/>
                <a:gd name="connsiteY11" fmla="*/ 640457 h 1210118"/>
                <a:gd name="connsiteX12" fmla="*/ 1017172 w 1641248"/>
                <a:gd name="connsiteY12" fmla="*/ 578812 h 1210118"/>
                <a:gd name="connsiteX13" fmla="*/ 893882 w 1641248"/>
                <a:gd name="connsiteY13" fmla="*/ 445247 h 1210118"/>
                <a:gd name="connsiteX14" fmla="*/ 801415 w 1641248"/>
                <a:gd name="connsiteY14" fmla="*/ 373329 h 1210118"/>
                <a:gd name="connsiteX15" fmla="*/ 688399 w 1641248"/>
                <a:gd name="connsiteY15" fmla="*/ 188394 h 1210118"/>
                <a:gd name="connsiteX16" fmla="*/ 585657 w 1641248"/>
                <a:gd name="connsiteY16" fmla="*/ 13733 h 1210118"/>
                <a:gd name="connsiteX17" fmla="*/ 452093 w 1641248"/>
                <a:gd name="connsiteY17" fmla="*/ 13733 h 1210118"/>
                <a:gd name="connsiteX18" fmla="*/ 256884 w 1641248"/>
                <a:gd name="connsiteY18" fmla="*/ 34282 h 1210118"/>
                <a:gd name="connsiteX19" fmla="*/ 113046 w 1641248"/>
                <a:gd name="connsiteY19" fmla="*/ 106202 h 1210118"/>
                <a:gd name="connsiteX20" fmla="*/ 30 w 1641248"/>
                <a:gd name="connsiteY20" fmla="*/ 363054 h 1210118"/>
                <a:gd name="connsiteX0" fmla="*/ 30 w 1641248"/>
                <a:gd name="connsiteY0" fmla="*/ 363054 h 1210118"/>
                <a:gd name="connsiteX1" fmla="*/ 123320 w 1641248"/>
                <a:gd name="connsiteY1" fmla="*/ 722650 h 1210118"/>
                <a:gd name="connsiteX2" fmla="*/ 318529 w 1641248"/>
                <a:gd name="connsiteY2" fmla="*/ 969230 h 1210118"/>
                <a:gd name="connsiteX3" fmla="*/ 606205 w 1641248"/>
                <a:gd name="connsiteY3" fmla="*/ 1133616 h 1210118"/>
                <a:gd name="connsiteX4" fmla="*/ 1037720 w 1641248"/>
                <a:gd name="connsiteY4" fmla="*/ 1195261 h 1210118"/>
                <a:gd name="connsiteX5" fmla="*/ 1294574 w 1641248"/>
                <a:gd name="connsiteY5" fmla="*/ 1205535 h 1210118"/>
                <a:gd name="connsiteX6" fmla="*/ 1458960 w 1641248"/>
                <a:gd name="connsiteY6" fmla="*/ 1133616 h 1210118"/>
                <a:gd name="connsiteX7" fmla="*/ 1571976 w 1641248"/>
                <a:gd name="connsiteY7" fmla="*/ 1020601 h 1210118"/>
                <a:gd name="connsiteX8" fmla="*/ 1613073 w 1641248"/>
                <a:gd name="connsiteY8" fmla="*/ 876762 h 1210118"/>
                <a:gd name="connsiteX9" fmla="*/ 1633621 w 1641248"/>
                <a:gd name="connsiteY9" fmla="*/ 753472 h 1210118"/>
                <a:gd name="connsiteX10" fmla="*/ 1479509 w 1641248"/>
                <a:gd name="connsiteY10" fmla="*/ 681553 h 1210118"/>
                <a:gd name="connsiteX11" fmla="*/ 1253477 w 1641248"/>
                <a:gd name="connsiteY11" fmla="*/ 640457 h 1210118"/>
                <a:gd name="connsiteX12" fmla="*/ 1058269 w 1641248"/>
                <a:gd name="connsiteY12" fmla="*/ 558264 h 1210118"/>
                <a:gd name="connsiteX13" fmla="*/ 893882 w 1641248"/>
                <a:gd name="connsiteY13" fmla="*/ 445247 h 1210118"/>
                <a:gd name="connsiteX14" fmla="*/ 801415 w 1641248"/>
                <a:gd name="connsiteY14" fmla="*/ 373329 h 1210118"/>
                <a:gd name="connsiteX15" fmla="*/ 688399 w 1641248"/>
                <a:gd name="connsiteY15" fmla="*/ 188394 h 1210118"/>
                <a:gd name="connsiteX16" fmla="*/ 585657 w 1641248"/>
                <a:gd name="connsiteY16" fmla="*/ 13733 h 1210118"/>
                <a:gd name="connsiteX17" fmla="*/ 452093 w 1641248"/>
                <a:gd name="connsiteY17" fmla="*/ 13733 h 1210118"/>
                <a:gd name="connsiteX18" fmla="*/ 256884 w 1641248"/>
                <a:gd name="connsiteY18" fmla="*/ 34282 h 1210118"/>
                <a:gd name="connsiteX19" fmla="*/ 113046 w 1641248"/>
                <a:gd name="connsiteY19" fmla="*/ 106202 h 1210118"/>
                <a:gd name="connsiteX20" fmla="*/ 30 w 1641248"/>
                <a:gd name="connsiteY20" fmla="*/ 363054 h 1210118"/>
                <a:gd name="connsiteX0" fmla="*/ 30 w 1641248"/>
                <a:gd name="connsiteY0" fmla="*/ 363054 h 1210118"/>
                <a:gd name="connsiteX1" fmla="*/ 123320 w 1641248"/>
                <a:gd name="connsiteY1" fmla="*/ 722650 h 1210118"/>
                <a:gd name="connsiteX2" fmla="*/ 318529 w 1641248"/>
                <a:gd name="connsiteY2" fmla="*/ 969230 h 1210118"/>
                <a:gd name="connsiteX3" fmla="*/ 606205 w 1641248"/>
                <a:gd name="connsiteY3" fmla="*/ 1133616 h 1210118"/>
                <a:gd name="connsiteX4" fmla="*/ 1037720 w 1641248"/>
                <a:gd name="connsiteY4" fmla="*/ 1195261 h 1210118"/>
                <a:gd name="connsiteX5" fmla="*/ 1294574 w 1641248"/>
                <a:gd name="connsiteY5" fmla="*/ 1205535 h 1210118"/>
                <a:gd name="connsiteX6" fmla="*/ 1458960 w 1641248"/>
                <a:gd name="connsiteY6" fmla="*/ 1133616 h 1210118"/>
                <a:gd name="connsiteX7" fmla="*/ 1571976 w 1641248"/>
                <a:gd name="connsiteY7" fmla="*/ 1020601 h 1210118"/>
                <a:gd name="connsiteX8" fmla="*/ 1613073 w 1641248"/>
                <a:gd name="connsiteY8" fmla="*/ 876762 h 1210118"/>
                <a:gd name="connsiteX9" fmla="*/ 1633621 w 1641248"/>
                <a:gd name="connsiteY9" fmla="*/ 753472 h 1210118"/>
                <a:gd name="connsiteX10" fmla="*/ 1479509 w 1641248"/>
                <a:gd name="connsiteY10" fmla="*/ 681553 h 1210118"/>
                <a:gd name="connsiteX11" fmla="*/ 1274025 w 1641248"/>
                <a:gd name="connsiteY11" fmla="*/ 609635 h 1210118"/>
                <a:gd name="connsiteX12" fmla="*/ 1058269 w 1641248"/>
                <a:gd name="connsiteY12" fmla="*/ 558264 h 1210118"/>
                <a:gd name="connsiteX13" fmla="*/ 893882 w 1641248"/>
                <a:gd name="connsiteY13" fmla="*/ 445247 h 1210118"/>
                <a:gd name="connsiteX14" fmla="*/ 801415 w 1641248"/>
                <a:gd name="connsiteY14" fmla="*/ 373329 h 1210118"/>
                <a:gd name="connsiteX15" fmla="*/ 688399 w 1641248"/>
                <a:gd name="connsiteY15" fmla="*/ 188394 h 1210118"/>
                <a:gd name="connsiteX16" fmla="*/ 585657 w 1641248"/>
                <a:gd name="connsiteY16" fmla="*/ 13733 h 1210118"/>
                <a:gd name="connsiteX17" fmla="*/ 452093 w 1641248"/>
                <a:gd name="connsiteY17" fmla="*/ 13733 h 1210118"/>
                <a:gd name="connsiteX18" fmla="*/ 256884 w 1641248"/>
                <a:gd name="connsiteY18" fmla="*/ 34282 h 1210118"/>
                <a:gd name="connsiteX19" fmla="*/ 113046 w 1641248"/>
                <a:gd name="connsiteY19" fmla="*/ 106202 h 1210118"/>
                <a:gd name="connsiteX20" fmla="*/ 30 w 1641248"/>
                <a:gd name="connsiteY20" fmla="*/ 363054 h 1210118"/>
                <a:gd name="connsiteX0" fmla="*/ 30 w 1640533"/>
                <a:gd name="connsiteY0" fmla="*/ 363054 h 1210118"/>
                <a:gd name="connsiteX1" fmla="*/ 123320 w 1640533"/>
                <a:gd name="connsiteY1" fmla="*/ 722650 h 1210118"/>
                <a:gd name="connsiteX2" fmla="*/ 318529 w 1640533"/>
                <a:gd name="connsiteY2" fmla="*/ 969230 h 1210118"/>
                <a:gd name="connsiteX3" fmla="*/ 606205 w 1640533"/>
                <a:gd name="connsiteY3" fmla="*/ 1133616 h 1210118"/>
                <a:gd name="connsiteX4" fmla="*/ 1037720 w 1640533"/>
                <a:gd name="connsiteY4" fmla="*/ 1195261 h 1210118"/>
                <a:gd name="connsiteX5" fmla="*/ 1294574 w 1640533"/>
                <a:gd name="connsiteY5" fmla="*/ 1205535 h 1210118"/>
                <a:gd name="connsiteX6" fmla="*/ 1458960 w 1640533"/>
                <a:gd name="connsiteY6" fmla="*/ 1133616 h 1210118"/>
                <a:gd name="connsiteX7" fmla="*/ 1571976 w 1640533"/>
                <a:gd name="connsiteY7" fmla="*/ 1020601 h 1210118"/>
                <a:gd name="connsiteX8" fmla="*/ 1613073 w 1640533"/>
                <a:gd name="connsiteY8" fmla="*/ 876762 h 1210118"/>
                <a:gd name="connsiteX9" fmla="*/ 1633621 w 1640533"/>
                <a:gd name="connsiteY9" fmla="*/ 753472 h 1210118"/>
                <a:gd name="connsiteX10" fmla="*/ 1489783 w 1640533"/>
                <a:gd name="connsiteY10" fmla="*/ 661005 h 1210118"/>
                <a:gd name="connsiteX11" fmla="*/ 1274025 w 1640533"/>
                <a:gd name="connsiteY11" fmla="*/ 609635 h 1210118"/>
                <a:gd name="connsiteX12" fmla="*/ 1058269 w 1640533"/>
                <a:gd name="connsiteY12" fmla="*/ 558264 h 1210118"/>
                <a:gd name="connsiteX13" fmla="*/ 893882 w 1640533"/>
                <a:gd name="connsiteY13" fmla="*/ 445247 h 1210118"/>
                <a:gd name="connsiteX14" fmla="*/ 801415 w 1640533"/>
                <a:gd name="connsiteY14" fmla="*/ 373329 h 1210118"/>
                <a:gd name="connsiteX15" fmla="*/ 688399 w 1640533"/>
                <a:gd name="connsiteY15" fmla="*/ 188394 h 1210118"/>
                <a:gd name="connsiteX16" fmla="*/ 585657 w 1640533"/>
                <a:gd name="connsiteY16" fmla="*/ 13733 h 1210118"/>
                <a:gd name="connsiteX17" fmla="*/ 452093 w 1640533"/>
                <a:gd name="connsiteY17" fmla="*/ 13733 h 1210118"/>
                <a:gd name="connsiteX18" fmla="*/ 256884 w 1640533"/>
                <a:gd name="connsiteY18" fmla="*/ 34282 h 1210118"/>
                <a:gd name="connsiteX19" fmla="*/ 113046 w 1640533"/>
                <a:gd name="connsiteY19" fmla="*/ 106202 h 1210118"/>
                <a:gd name="connsiteX20" fmla="*/ 30 w 1640533"/>
                <a:gd name="connsiteY20" fmla="*/ 363054 h 1210118"/>
                <a:gd name="connsiteX0" fmla="*/ 30 w 1640533"/>
                <a:gd name="connsiteY0" fmla="*/ 362158 h 1209222"/>
                <a:gd name="connsiteX1" fmla="*/ 123320 w 1640533"/>
                <a:gd name="connsiteY1" fmla="*/ 721754 h 1209222"/>
                <a:gd name="connsiteX2" fmla="*/ 318529 w 1640533"/>
                <a:gd name="connsiteY2" fmla="*/ 968334 h 1209222"/>
                <a:gd name="connsiteX3" fmla="*/ 606205 w 1640533"/>
                <a:gd name="connsiteY3" fmla="*/ 1132720 h 1209222"/>
                <a:gd name="connsiteX4" fmla="*/ 1037720 w 1640533"/>
                <a:gd name="connsiteY4" fmla="*/ 1194365 h 1209222"/>
                <a:gd name="connsiteX5" fmla="*/ 1294574 w 1640533"/>
                <a:gd name="connsiteY5" fmla="*/ 1204639 h 1209222"/>
                <a:gd name="connsiteX6" fmla="*/ 1458960 w 1640533"/>
                <a:gd name="connsiteY6" fmla="*/ 1132720 h 1209222"/>
                <a:gd name="connsiteX7" fmla="*/ 1571976 w 1640533"/>
                <a:gd name="connsiteY7" fmla="*/ 1019705 h 1209222"/>
                <a:gd name="connsiteX8" fmla="*/ 1613073 w 1640533"/>
                <a:gd name="connsiteY8" fmla="*/ 875866 h 1209222"/>
                <a:gd name="connsiteX9" fmla="*/ 1633621 w 1640533"/>
                <a:gd name="connsiteY9" fmla="*/ 752576 h 1209222"/>
                <a:gd name="connsiteX10" fmla="*/ 1489783 w 1640533"/>
                <a:gd name="connsiteY10" fmla="*/ 660109 h 1209222"/>
                <a:gd name="connsiteX11" fmla="*/ 1274025 w 1640533"/>
                <a:gd name="connsiteY11" fmla="*/ 608739 h 1209222"/>
                <a:gd name="connsiteX12" fmla="*/ 1058269 w 1640533"/>
                <a:gd name="connsiteY12" fmla="*/ 557368 h 1209222"/>
                <a:gd name="connsiteX13" fmla="*/ 893882 w 1640533"/>
                <a:gd name="connsiteY13" fmla="*/ 444351 h 1209222"/>
                <a:gd name="connsiteX14" fmla="*/ 801415 w 1640533"/>
                <a:gd name="connsiteY14" fmla="*/ 372433 h 1209222"/>
                <a:gd name="connsiteX15" fmla="*/ 688399 w 1640533"/>
                <a:gd name="connsiteY15" fmla="*/ 187498 h 1209222"/>
                <a:gd name="connsiteX16" fmla="*/ 585657 w 1640533"/>
                <a:gd name="connsiteY16" fmla="*/ 12837 h 1209222"/>
                <a:gd name="connsiteX17" fmla="*/ 372542 w 1640533"/>
                <a:gd name="connsiteY17" fmla="*/ 15423 h 1209222"/>
                <a:gd name="connsiteX18" fmla="*/ 256884 w 1640533"/>
                <a:gd name="connsiteY18" fmla="*/ 33386 h 1209222"/>
                <a:gd name="connsiteX19" fmla="*/ 113046 w 1640533"/>
                <a:gd name="connsiteY19" fmla="*/ 105306 h 1209222"/>
                <a:gd name="connsiteX20" fmla="*/ 30 w 1640533"/>
                <a:gd name="connsiteY20" fmla="*/ 362158 h 1209222"/>
                <a:gd name="connsiteX0" fmla="*/ 30 w 1640533"/>
                <a:gd name="connsiteY0" fmla="*/ 350469 h 1197533"/>
                <a:gd name="connsiteX1" fmla="*/ 123320 w 1640533"/>
                <a:gd name="connsiteY1" fmla="*/ 710065 h 1197533"/>
                <a:gd name="connsiteX2" fmla="*/ 318529 w 1640533"/>
                <a:gd name="connsiteY2" fmla="*/ 956645 h 1197533"/>
                <a:gd name="connsiteX3" fmla="*/ 606205 w 1640533"/>
                <a:gd name="connsiteY3" fmla="*/ 1121031 h 1197533"/>
                <a:gd name="connsiteX4" fmla="*/ 1037720 w 1640533"/>
                <a:gd name="connsiteY4" fmla="*/ 1182676 h 1197533"/>
                <a:gd name="connsiteX5" fmla="*/ 1294574 w 1640533"/>
                <a:gd name="connsiteY5" fmla="*/ 1192950 h 1197533"/>
                <a:gd name="connsiteX6" fmla="*/ 1458960 w 1640533"/>
                <a:gd name="connsiteY6" fmla="*/ 1121031 h 1197533"/>
                <a:gd name="connsiteX7" fmla="*/ 1571976 w 1640533"/>
                <a:gd name="connsiteY7" fmla="*/ 1008016 h 1197533"/>
                <a:gd name="connsiteX8" fmla="*/ 1613073 w 1640533"/>
                <a:gd name="connsiteY8" fmla="*/ 864177 h 1197533"/>
                <a:gd name="connsiteX9" fmla="*/ 1633621 w 1640533"/>
                <a:gd name="connsiteY9" fmla="*/ 740887 h 1197533"/>
                <a:gd name="connsiteX10" fmla="*/ 1489783 w 1640533"/>
                <a:gd name="connsiteY10" fmla="*/ 648420 h 1197533"/>
                <a:gd name="connsiteX11" fmla="*/ 1274025 w 1640533"/>
                <a:gd name="connsiteY11" fmla="*/ 597050 h 1197533"/>
                <a:gd name="connsiteX12" fmla="*/ 1058269 w 1640533"/>
                <a:gd name="connsiteY12" fmla="*/ 545679 h 1197533"/>
                <a:gd name="connsiteX13" fmla="*/ 893882 w 1640533"/>
                <a:gd name="connsiteY13" fmla="*/ 432662 h 1197533"/>
                <a:gd name="connsiteX14" fmla="*/ 801415 w 1640533"/>
                <a:gd name="connsiteY14" fmla="*/ 360744 h 1197533"/>
                <a:gd name="connsiteX15" fmla="*/ 688399 w 1640533"/>
                <a:gd name="connsiteY15" fmla="*/ 175809 h 1197533"/>
                <a:gd name="connsiteX16" fmla="*/ 503574 w 1640533"/>
                <a:gd name="connsiteY16" fmla="*/ 18217 h 1197533"/>
                <a:gd name="connsiteX17" fmla="*/ 372542 w 1640533"/>
                <a:gd name="connsiteY17" fmla="*/ 3734 h 1197533"/>
                <a:gd name="connsiteX18" fmla="*/ 256884 w 1640533"/>
                <a:gd name="connsiteY18" fmla="*/ 21697 h 1197533"/>
                <a:gd name="connsiteX19" fmla="*/ 113046 w 1640533"/>
                <a:gd name="connsiteY19" fmla="*/ 93617 h 1197533"/>
                <a:gd name="connsiteX20" fmla="*/ 30 w 1640533"/>
                <a:gd name="connsiteY20" fmla="*/ 350469 h 1197533"/>
                <a:gd name="connsiteX0" fmla="*/ 30 w 1640533"/>
                <a:gd name="connsiteY0" fmla="*/ 350469 h 1197533"/>
                <a:gd name="connsiteX1" fmla="*/ 123320 w 1640533"/>
                <a:gd name="connsiteY1" fmla="*/ 710065 h 1197533"/>
                <a:gd name="connsiteX2" fmla="*/ 318529 w 1640533"/>
                <a:gd name="connsiteY2" fmla="*/ 956645 h 1197533"/>
                <a:gd name="connsiteX3" fmla="*/ 606205 w 1640533"/>
                <a:gd name="connsiteY3" fmla="*/ 1121031 h 1197533"/>
                <a:gd name="connsiteX4" fmla="*/ 1037720 w 1640533"/>
                <a:gd name="connsiteY4" fmla="*/ 1182676 h 1197533"/>
                <a:gd name="connsiteX5" fmla="*/ 1294574 w 1640533"/>
                <a:gd name="connsiteY5" fmla="*/ 1192950 h 1197533"/>
                <a:gd name="connsiteX6" fmla="*/ 1458960 w 1640533"/>
                <a:gd name="connsiteY6" fmla="*/ 1121031 h 1197533"/>
                <a:gd name="connsiteX7" fmla="*/ 1571976 w 1640533"/>
                <a:gd name="connsiteY7" fmla="*/ 1008016 h 1197533"/>
                <a:gd name="connsiteX8" fmla="*/ 1613073 w 1640533"/>
                <a:gd name="connsiteY8" fmla="*/ 864177 h 1197533"/>
                <a:gd name="connsiteX9" fmla="*/ 1633621 w 1640533"/>
                <a:gd name="connsiteY9" fmla="*/ 740887 h 1197533"/>
                <a:gd name="connsiteX10" fmla="*/ 1489783 w 1640533"/>
                <a:gd name="connsiteY10" fmla="*/ 648420 h 1197533"/>
                <a:gd name="connsiteX11" fmla="*/ 1288058 w 1640533"/>
                <a:gd name="connsiteY11" fmla="*/ 533835 h 1197533"/>
                <a:gd name="connsiteX12" fmla="*/ 1058269 w 1640533"/>
                <a:gd name="connsiteY12" fmla="*/ 545679 h 1197533"/>
                <a:gd name="connsiteX13" fmla="*/ 893882 w 1640533"/>
                <a:gd name="connsiteY13" fmla="*/ 432662 h 1197533"/>
                <a:gd name="connsiteX14" fmla="*/ 801415 w 1640533"/>
                <a:gd name="connsiteY14" fmla="*/ 360744 h 1197533"/>
                <a:gd name="connsiteX15" fmla="*/ 688399 w 1640533"/>
                <a:gd name="connsiteY15" fmla="*/ 175809 h 1197533"/>
                <a:gd name="connsiteX16" fmla="*/ 503574 w 1640533"/>
                <a:gd name="connsiteY16" fmla="*/ 18217 h 1197533"/>
                <a:gd name="connsiteX17" fmla="*/ 372542 w 1640533"/>
                <a:gd name="connsiteY17" fmla="*/ 3734 h 1197533"/>
                <a:gd name="connsiteX18" fmla="*/ 256884 w 1640533"/>
                <a:gd name="connsiteY18" fmla="*/ 21697 h 1197533"/>
                <a:gd name="connsiteX19" fmla="*/ 113046 w 1640533"/>
                <a:gd name="connsiteY19" fmla="*/ 93617 h 1197533"/>
                <a:gd name="connsiteX20" fmla="*/ 30 w 1640533"/>
                <a:gd name="connsiteY20" fmla="*/ 350469 h 1197533"/>
                <a:gd name="connsiteX0" fmla="*/ 30 w 1640533"/>
                <a:gd name="connsiteY0" fmla="*/ 350469 h 1197533"/>
                <a:gd name="connsiteX1" fmla="*/ 123320 w 1640533"/>
                <a:gd name="connsiteY1" fmla="*/ 710065 h 1197533"/>
                <a:gd name="connsiteX2" fmla="*/ 318529 w 1640533"/>
                <a:gd name="connsiteY2" fmla="*/ 956645 h 1197533"/>
                <a:gd name="connsiteX3" fmla="*/ 606205 w 1640533"/>
                <a:gd name="connsiteY3" fmla="*/ 1121031 h 1197533"/>
                <a:gd name="connsiteX4" fmla="*/ 1037720 w 1640533"/>
                <a:gd name="connsiteY4" fmla="*/ 1182676 h 1197533"/>
                <a:gd name="connsiteX5" fmla="*/ 1294574 w 1640533"/>
                <a:gd name="connsiteY5" fmla="*/ 1192950 h 1197533"/>
                <a:gd name="connsiteX6" fmla="*/ 1458960 w 1640533"/>
                <a:gd name="connsiteY6" fmla="*/ 1121031 h 1197533"/>
                <a:gd name="connsiteX7" fmla="*/ 1571976 w 1640533"/>
                <a:gd name="connsiteY7" fmla="*/ 1008016 h 1197533"/>
                <a:gd name="connsiteX8" fmla="*/ 1613073 w 1640533"/>
                <a:gd name="connsiteY8" fmla="*/ 864177 h 1197533"/>
                <a:gd name="connsiteX9" fmla="*/ 1633621 w 1640533"/>
                <a:gd name="connsiteY9" fmla="*/ 740887 h 1197533"/>
                <a:gd name="connsiteX10" fmla="*/ 1489783 w 1640533"/>
                <a:gd name="connsiteY10" fmla="*/ 648420 h 1197533"/>
                <a:gd name="connsiteX11" fmla="*/ 1288058 w 1640533"/>
                <a:gd name="connsiteY11" fmla="*/ 533835 h 1197533"/>
                <a:gd name="connsiteX12" fmla="*/ 1086335 w 1640533"/>
                <a:gd name="connsiteY12" fmla="*/ 406605 h 1197533"/>
                <a:gd name="connsiteX13" fmla="*/ 893882 w 1640533"/>
                <a:gd name="connsiteY13" fmla="*/ 432662 h 1197533"/>
                <a:gd name="connsiteX14" fmla="*/ 801415 w 1640533"/>
                <a:gd name="connsiteY14" fmla="*/ 360744 h 1197533"/>
                <a:gd name="connsiteX15" fmla="*/ 688399 w 1640533"/>
                <a:gd name="connsiteY15" fmla="*/ 175809 h 1197533"/>
                <a:gd name="connsiteX16" fmla="*/ 503574 w 1640533"/>
                <a:gd name="connsiteY16" fmla="*/ 18217 h 1197533"/>
                <a:gd name="connsiteX17" fmla="*/ 372542 w 1640533"/>
                <a:gd name="connsiteY17" fmla="*/ 3734 h 1197533"/>
                <a:gd name="connsiteX18" fmla="*/ 256884 w 1640533"/>
                <a:gd name="connsiteY18" fmla="*/ 21697 h 1197533"/>
                <a:gd name="connsiteX19" fmla="*/ 113046 w 1640533"/>
                <a:gd name="connsiteY19" fmla="*/ 93617 h 1197533"/>
                <a:gd name="connsiteX20" fmla="*/ 30 w 1640533"/>
                <a:gd name="connsiteY20" fmla="*/ 350469 h 1197533"/>
                <a:gd name="connsiteX0" fmla="*/ 30 w 1640533"/>
                <a:gd name="connsiteY0" fmla="*/ 350469 h 1197533"/>
                <a:gd name="connsiteX1" fmla="*/ 123320 w 1640533"/>
                <a:gd name="connsiteY1" fmla="*/ 710065 h 1197533"/>
                <a:gd name="connsiteX2" fmla="*/ 318529 w 1640533"/>
                <a:gd name="connsiteY2" fmla="*/ 956645 h 1197533"/>
                <a:gd name="connsiteX3" fmla="*/ 606205 w 1640533"/>
                <a:gd name="connsiteY3" fmla="*/ 1121031 h 1197533"/>
                <a:gd name="connsiteX4" fmla="*/ 1037720 w 1640533"/>
                <a:gd name="connsiteY4" fmla="*/ 1182676 h 1197533"/>
                <a:gd name="connsiteX5" fmla="*/ 1294574 w 1640533"/>
                <a:gd name="connsiteY5" fmla="*/ 1192950 h 1197533"/>
                <a:gd name="connsiteX6" fmla="*/ 1458960 w 1640533"/>
                <a:gd name="connsiteY6" fmla="*/ 1121031 h 1197533"/>
                <a:gd name="connsiteX7" fmla="*/ 1571976 w 1640533"/>
                <a:gd name="connsiteY7" fmla="*/ 1008016 h 1197533"/>
                <a:gd name="connsiteX8" fmla="*/ 1613073 w 1640533"/>
                <a:gd name="connsiteY8" fmla="*/ 864177 h 1197533"/>
                <a:gd name="connsiteX9" fmla="*/ 1633621 w 1640533"/>
                <a:gd name="connsiteY9" fmla="*/ 740887 h 1197533"/>
                <a:gd name="connsiteX10" fmla="*/ 1489783 w 1640533"/>
                <a:gd name="connsiteY10" fmla="*/ 648420 h 1197533"/>
                <a:gd name="connsiteX11" fmla="*/ 1288058 w 1640533"/>
                <a:gd name="connsiteY11" fmla="*/ 533835 h 1197533"/>
                <a:gd name="connsiteX12" fmla="*/ 1086335 w 1640533"/>
                <a:gd name="connsiteY12" fmla="*/ 406605 h 1197533"/>
                <a:gd name="connsiteX13" fmla="*/ 978081 w 1640533"/>
                <a:gd name="connsiteY13" fmla="*/ 344162 h 1197533"/>
                <a:gd name="connsiteX14" fmla="*/ 801415 w 1640533"/>
                <a:gd name="connsiteY14" fmla="*/ 360744 h 1197533"/>
                <a:gd name="connsiteX15" fmla="*/ 688399 w 1640533"/>
                <a:gd name="connsiteY15" fmla="*/ 175809 h 1197533"/>
                <a:gd name="connsiteX16" fmla="*/ 503574 w 1640533"/>
                <a:gd name="connsiteY16" fmla="*/ 18217 h 1197533"/>
                <a:gd name="connsiteX17" fmla="*/ 372542 w 1640533"/>
                <a:gd name="connsiteY17" fmla="*/ 3734 h 1197533"/>
                <a:gd name="connsiteX18" fmla="*/ 256884 w 1640533"/>
                <a:gd name="connsiteY18" fmla="*/ 21697 h 1197533"/>
                <a:gd name="connsiteX19" fmla="*/ 113046 w 1640533"/>
                <a:gd name="connsiteY19" fmla="*/ 93617 h 1197533"/>
                <a:gd name="connsiteX20" fmla="*/ 30 w 1640533"/>
                <a:gd name="connsiteY20" fmla="*/ 350469 h 1197533"/>
                <a:gd name="connsiteX0" fmla="*/ 30 w 1640533"/>
                <a:gd name="connsiteY0" fmla="*/ 350469 h 1197533"/>
                <a:gd name="connsiteX1" fmla="*/ 123320 w 1640533"/>
                <a:gd name="connsiteY1" fmla="*/ 710065 h 1197533"/>
                <a:gd name="connsiteX2" fmla="*/ 318529 w 1640533"/>
                <a:gd name="connsiteY2" fmla="*/ 956645 h 1197533"/>
                <a:gd name="connsiteX3" fmla="*/ 606205 w 1640533"/>
                <a:gd name="connsiteY3" fmla="*/ 1121031 h 1197533"/>
                <a:gd name="connsiteX4" fmla="*/ 1037720 w 1640533"/>
                <a:gd name="connsiteY4" fmla="*/ 1182676 h 1197533"/>
                <a:gd name="connsiteX5" fmla="*/ 1294574 w 1640533"/>
                <a:gd name="connsiteY5" fmla="*/ 1192950 h 1197533"/>
                <a:gd name="connsiteX6" fmla="*/ 1458960 w 1640533"/>
                <a:gd name="connsiteY6" fmla="*/ 1121031 h 1197533"/>
                <a:gd name="connsiteX7" fmla="*/ 1571976 w 1640533"/>
                <a:gd name="connsiteY7" fmla="*/ 1008016 h 1197533"/>
                <a:gd name="connsiteX8" fmla="*/ 1613073 w 1640533"/>
                <a:gd name="connsiteY8" fmla="*/ 864177 h 1197533"/>
                <a:gd name="connsiteX9" fmla="*/ 1633621 w 1640533"/>
                <a:gd name="connsiteY9" fmla="*/ 740887 h 1197533"/>
                <a:gd name="connsiteX10" fmla="*/ 1489783 w 1640533"/>
                <a:gd name="connsiteY10" fmla="*/ 648420 h 1197533"/>
                <a:gd name="connsiteX11" fmla="*/ 1288058 w 1640533"/>
                <a:gd name="connsiteY11" fmla="*/ 533835 h 1197533"/>
                <a:gd name="connsiteX12" fmla="*/ 1086335 w 1640533"/>
                <a:gd name="connsiteY12" fmla="*/ 406605 h 1197533"/>
                <a:gd name="connsiteX13" fmla="*/ 978081 w 1640533"/>
                <a:gd name="connsiteY13" fmla="*/ 344162 h 1197533"/>
                <a:gd name="connsiteX14" fmla="*/ 829481 w 1640533"/>
                <a:gd name="connsiteY14" fmla="*/ 272243 h 1197533"/>
                <a:gd name="connsiteX15" fmla="*/ 688399 w 1640533"/>
                <a:gd name="connsiteY15" fmla="*/ 175809 h 1197533"/>
                <a:gd name="connsiteX16" fmla="*/ 503574 w 1640533"/>
                <a:gd name="connsiteY16" fmla="*/ 18217 h 1197533"/>
                <a:gd name="connsiteX17" fmla="*/ 372542 w 1640533"/>
                <a:gd name="connsiteY17" fmla="*/ 3734 h 1197533"/>
                <a:gd name="connsiteX18" fmla="*/ 256884 w 1640533"/>
                <a:gd name="connsiteY18" fmla="*/ 21697 h 1197533"/>
                <a:gd name="connsiteX19" fmla="*/ 113046 w 1640533"/>
                <a:gd name="connsiteY19" fmla="*/ 93617 h 1197533"/>
                <a:gd name="connsiteX20" fmla="*/ 30 w 1640533"/>
                <a:gd name="connsiteY20" fmla="*/ 350469 h 1197533"/>
                <a:gd name="connsiteX0" fmla="*/ 30 w 1640533"/>
                <a:gd name="connsiteY0" fmla="*/ 346767 h 1193831"/>
                <a:gd name="connsiteX1" fmla="*/ 123320 w 1640533"/>
                <a:gd name="connsiteY1" fmla="*/ 706363 h 1193831"/>
                <a:gd name="connsiteX2" fmla="*/ 318529 w 1640533"/>
                <a:gd name="connsiteY2" fmla="*/ 952943 h 1193831"/>
                <a:gd name="connsiteX3" fmla="*/ 606205 w 1640533"/>
                <a:gd name="connsiteY3" fmla="*/ 1117329 h 1193831"/>
                <a:gd name="connsiteX4" fmla="*/ 1037720 w 1640533"/>
                <a:gd name="connsiteY4" fmla="*/ 1178974 h 1193831"/>
                <a:gd name="connsiteX5" fmla="*/ 1294574 w 1640533"/>
                <a:gd name="connsiteY5" fmla="*/ 1189248 h 1193831"/>
                <a:gd name="connsiteX6" fmla="*/ 1458960 w 1640533"/>
                <a:gd name="connsiteY6" fmla="*/ 1117329 h 1193831"/>
                <a:gd name="connsiteX7" fmla="*/ 1571976 w 1640533"/>
                <a:gd name="connsiteY7" fmla="*/ 1004314 h 1193831"/>
                <a:gd name="connsiteX8" fmla="*/ 1613073 w 1640533"/>
                <a:gd name="connsiteY8" fmla="*/ 860475 h 1193831"/>
                <a:gd name="connsiteX9" fmla="*/ 1633621 w 1640533"/>
                <a:gd name="connsiteY9" fmla="*/ 737185 h 1193831"/>
                <a:gd name="connsiteX10" fmla="*/ 1489783 w 1640533"/>
                <a:gd name="connsiteY10" fmla="*/ 644718 h 1193831"/>
                <a:gd name="connsiteX11" fmla="*/ 1288058 w 1640533"/>
                <a:gd name="connsiteY11" fmla="*/ 530133 h 1193831"/>
                <a:gd name="connsiteX12" fmla="*/ 1086335 w 1640533"/>
                <a:gd name="connsiteY12" fmla="*/ 402903 h 1193831"/>
                <a:gd name="connsiteX13" fmla="*/ 978081 w 1640533"/>
                <a:gd name="connsiteY13" fmla="*/ 340460 h 1193831"/>
                <a:gd name="connsiteX14" fmla="*/ 829481 w 1640533"/>
                <a:gd name="connsiteY14" fmla="*/ 268541 h 1193831"/>
                <a:gd name="connsiteX15" fmla="*/ 800664 w 1640533"/>
                <a:gd name="connsiteY15" fmla="*/ 45677 h 1193831"/>
                <a:gd name="connsiteX16" fmla="*/ 503574 w 1640533"/>
                <a:gd name="connsiteY16" fmla="*/ 14515 h 1193831"/>
                <a:gd name="connsiteX17" fmla="*/ 372542 w 1640533"/>
                <a:gd name="connsiteY17" fmla="*/ 32 h 1193831"/>
                <a:gd name="connsiteX18" fmla="*/ 256884 w 1640533"/>
                <a:gd name="connsiteY18" fmla="*/ 17995 h 1193831"/>
                <a:gd name="connsiteX19" fmla="*/ 113046 w 1640533"/>
                <a:gd name="connsiteY19" fmla="*/ 89915 h 1193831"/>
                <a:gd name="connsiteX20" fmla="*/ 30 w 1640533"/>
                <a:gd name="connsiteY20" fmla="*/ 346767 h 1193831"/>
                <a:gd name="connsiteX0" fmla="*/ 30 w 1640533"/>
                <a:gd name="connsiteY0" fmla="*/ 346767 h 1193831"/>
                <a:gd name="connsiteX1" fmla="*/ 123320 w 1640533"/>
                <a:gd name="connsiteY1" fmla="*/ 706363 h 1193831"/>
                <a:gd name="connsiteX2" fmla="*/ 318529 w 1640533"/>
                <a:gd name="connsiteY2" fmla="*/ 952943 h 1193831"/>
                <a:gd name="connsiteX3" fmla="*/ 606205 w 1640533"/>
                <a:gd name="connsiteY3" fmla="*/ 1117329 h 1193831"/>
                <a:gd name="connsiteX4" fmla="*/ 1037720 w 1640533"/>
                <a:gd name="connsiteY4" fmla="*/ 1178974 h 1193831"/>
                <a:gd name="connsiteX5" fmla="*/ 1294574 w 1640533"/>
                <a:gd name="connsiteY5" fmla="*/ 1189248 h 1193831"/>
                <a:gd name="connsiteX6" fmla="*/ 1458960 w 1640533"/>
                <a:gd name="connsiteY6" fmla="*/ 1117329 h 1193831"/>
                <a:gd name="connsiteX7" fmla="*/ 1571976 w 1640533"/>
                <a:gd name="connsiteY7" fmla="*/ 1004314 h 1193831"/>
                <a:gd name="connsiteX8" fmla="*/ 1613073 w 1640533"/>
                <a:gd name="connsiteY8" fmla="*/ 860475 h 1193831"/>
                <a:gd name="connsiteX9" fmla="*/ 1633621 w 1640533"/>
                <a:gd name="connsiteY9" fmla="*/ 737185 h 1193831"/>
                <a:gd name="connsiteX10" fmla="*/ 1489783 w 1640533"/>
                <a:gd name="connsiteY10" fmla="*/ 644718 h 1193831"/>
                <a:gd name="connsiteX11" fmla="*/ 1288058 w 1640533"/>
                <a:gd name="connsiteY11" fmla="*/ 530133 h 1193831"/>
                <a:gd name="connsiteX12" fmla="*/ 1086335 w 1640533"/>
                <a:gd name="connsiteY12" fmla="*/ 402903 h 1193831"/>
                <a:gd name="connsiteX13" fmla="*/ 978081 w 1640533"/>
                <a:gd name="connsiteY13" fmla="*/ 340460 h 1193831"/>
                <a:gd name="connsiteX14" fmla="*/ 1039977 w 1640533"/>
                <a:gd name="connsiteY14" fmla="*/ 167397 h 1193831"/>
                <a:gd name="connsiteX15" fmla="*/ 800664 w 1640533"/>
                <a:gd name="connsiteY15" fmla="*/ 45677 h 1193831"/>
                <a:gd name="connsiteX16" fmla="*/ 503574 w 1640533"/>
                <a:gd name="connsiteY16" fmla="*/ 14515 h 1193831"/>
                <a:gd name="connsiteX17" fmla="*/ 372542 w 1640533"/>
                <a:gd name="connsiteY17" fmla="*/ 32 h 1193831"/>
                <a:gd name="connsiteX18" fmla="*/ 256884 w 1640533"/>
                <a:gd name="connsiteY18" fmla="*/ 17995 h 1193831"/>
                <a:gd name="connsiteX19" fmla="*/ 113046 w 1640533"/>
                <a:gd name="connsiteY19" fmla="*/ 89915 h 1193831"/>
                <a:gd name="connsiteX20" fmla="*/ 30 w 1640533"/>
                <a:gd name="connsiteY20" fmla="*/ 346767 h 1193831"/>
                <a:gd name="connsiteX0" fmla="*/ 30 w 1640533"/>
                <a:gd name="connsiteY0" fmla="*/ 346767 h 1193831"/>
                <a:gd name="connsiteX1" fmla="*/ 123320 w 1640533"/>
                <a:gd name="connsiteY1" fmla="*/ 706363 h 1193831"/>
                <a:gd name="connsiteX2" fmla="*/ 318529 w 1640533"/>
                <a:gd name="connsiteY2" fmla="*/ 952943 h 1193831"/>
                <a:gd name="connsiteX3" fmla="*/ 606205 w 1640533"/>
                <a:gd name="connsiteY3" fmla="*/ 1117329 h 1193831"/>
                <a:gd name="connsiteX4" fmla="*/ 1037720 w 1640533"/>
                <a:gd name="connsiteY4" fmla="*/ 1178974 h 1193831"/>
                <a:gd name="connsiteX5" fmla="*/ 1294574 w 1640533"/>
                <a:gd name="connsiteY5" fmla="*/ 1189248 h 1193831"/>
                <a:gd name="connsiteX6" fmla="*/ 1458960 w 1640533"/>
                <a:gd name="connsiteY6" fmla="*/ 1117329 h 1193831"/>
                <a:gd name="connsiteX7" fmla="*/ 1571976 w 1640533"/>
                <a:gd name="connsiteY7" fmla="*/ 1004314 h 1193831"/>
                <a:gd name="connsiteX8" fmla="*/ 1613073 w 1640533"/>
                <a:gd name="connsiteY8" fmla="*/ 860475 h 1193831"/>
                <a:gd name="connsiteX9" fmla="*/ 1633621 w 1640533"/>
                <a:gd name="connsiteY9" fmla="*/ 737185 h 1193831"/>
                <a:gd name="connsiteX10" fmla="*/ 1489783 w 1640533"/>
                <a:gd name="connsiteY10" fmla="*/ 644718 h 1193831"/>
                <a:gd name="connsiteX11" fmla="*/ 1288058 w 1640533"/>
                <a:gd name="connsiteY11" fmla="*/ 530133 h 1193831"/>
                <a:gd name="connsiteX12" fmla="*/ 1086335 w 1640533"/>
                <a:gd name="connsiteY12" fmla="*/ 402903 h 1193831"/>
                <a:gd name="connsiteX13" fmla="*/ 1146478 w 1640533"/>
                <a:gd name="connsiteY13" fmla="*/ 302530 h 1193831"/>
                <a:gd name="connsiteX14" fmla="*/ 1039977 w 1640533"/>
                <a:gd name="connsiteY14" fmla="*/ 167397 h 1193831"/>
                <a:gd name="connsiteX15" fmla="*/ 800664 w 1640533"/>
                <a:gd name="connsiteY15" fmla="*/ 45677 h 1193831"/>
                <a:gd name="connsiteX16" fmla="*/ 503574 w 1640533"/>
                <a:gd name="connsiteY16" fmla="*/ 14515 h 1193831"/>
                <a:gd name="connsiteX17" fmla="*/ 372542 w 1640533"/>
                <a:gd name="connsiteY17" fmla="*/ 32 h 1193831"/>
                <a:gd name="connsiteX18" fmla="*/ 256884 w 1640533"/>
                <a:gd name="connsiteY18" fmla="*/ 17995 h 1193831"/>
                <a:gd name="connsiteX19" fmla="*/ 113046 w 1640533"/>
                <a:gd name="connsiteY19" fmla="*/ 89915 h 1193831"/>
                <a:gd name="connsiteX20" fmla="*/ 30 w 1640533"/>
                <a:gd name="connsiteY20" fmla="*/ 346767 h 1193831"/>
                <a:gd name="connsiteX0" fmla="*/ 30 w 1640533"/>
                <a:gd name="connsiteY0" fmla="*/ 346767 h 1193831"/>
                <a:gd name="connsiteX1" fmla="*/ 123320 w 1640533"/>
                <a:gd name="connsiteY1" fmla="*/ 706363 h 1193831"/>
                <a:gd name="connsiteX2" fmla="*/ 318529 w 1640533"/>
                <a:gd name="connsiteY2" fmla="*/ 952943 h 1193831"/>
                <a:gd name="connsiteX3" fmla="*/ 606205 w 1640533"/>
                <a:gd name="connsiteY3" fmla="*/ 1117329 h 1193831"/>
                <a:gd name="connsiteX4" fmla="*/ 1037720 w 1640533"/>
                <a:gd name="connsiteY4" fmla="*/ 1178974 h 1193831"/>
                <a:gd name="connsiteX5" fmla="*/ 1294574 w 1640533"/>
                <a:gd name="connsiteY5" fmla="*/ 1189248 h 1193831"/>
                <a:gd name="connsiteX6" fmla="*/ 1458960 w 1640533"/>
                <a:gd name="connsiteY6" fmla="*/ 1117329 h 1193831"/>
                <a:gd name="connsiteX7" fmla="*/ 1571976 w 1640533"/>
                <a:gd name="connsiteY7" fmla="*/ 1004314 h 1193831"/>
                <a:gd name="connsiteX8" fmla="*/ 1613073 w 1640533"/>
                <a:gd name="connsiteY8" fmla="*/ 860475 h 1193831"/>
                <a:gd name="connsiteX9" fmla="*/ 1633621 w 1640533"/>
                <a:gd name="connsiteY9" fmla="*/ 737185 h 1193831"/>
                <a:gd name="connsiteX10" fmla="*/ 1489783 w 1640533"/>
                <a:gd name="connsiteY10" fmla="*/ 644718 h 1193831"/>
                <a:gd name="connsiteX11" fmla="*/ 1330158 w 1640533"/>
                <a:gd name="connsiteY11" fmla="*/ 504847 h 1193831"/>
                <a:gd name="connsiteX12" fmla="*/ 1086335 w 1640533"/>
                <a:gd name="connsiteY12" fmla="*/ 402903 h 1193831"/>
                <a:gd name="connsiteX13" fmla="*/ 1146478 w 1640533"/>
                <a:gd name="connsiteY13" fmla="*/ 302530 h 1193831"/>
                <a:gd name="connsiteX14" fmla="*/ 1039977 w 1640533"/>
                <a:gd name="connsiteY14" fmla="*/ 167397 h 1193831"/>
                <a:gd name="connsiteX15" fmla="*/ 800664 w 1640533"/>
                <a:gd name="connsiteY15" fmla="*/ 45677 h 1193831"/>
                <a:gd name="connsiteX16" fmla="*/ 503574 w 1640533"/>
                <a:gd name="connsiteY16" fmla="*/ 14515 h 1193831"/>
                <a:gd name="connsiteX17" fmla="*/ 372542 w 1640533"/>
                <a:gd name="connsiteY17" fmla="*/ 32 h 1193831"/>
                <a:gd name="connsiteX18" fmla="*/ 256884 w 1640533"/>
                <a:gd name="connsiteY18" fmla="*/ 17995 h 1193831"/>
                <a:gd name="connsiteX19" fmla="*/ 113046 w 1640533"/>
                <a:gd name="connsiteY19" fmla="*/ 89915 h 1193831"/>
                <a:gd name="connsiteX20" fmla="*/ 30 w 1640533"/>
                <a:gd name="connsiteY20" fmla="*/ 346767 h 1193831"/>
                <a:gd name="connsiteX0" fmla="*/ 30 w 1638613"/>
                <a:gd name="connsiteY0" fmla="*/ 346767 h 1193831"/>
                <a:gd name="connsiteX1" fmla="*/ 123320 w 1638613"/>
                <a:gd name="connsiteY1" fmla="*/ 706363 h 1193831"/>
                <a:gd name="connsiteX2" fmla="*/ 318529 w 1638613"/>
                <a:gd name="connsiteY2" fmla="*/ 952943 h 1193831"/>
                <a:gd name="connsiteX3" fmla="*/ 606205 w 1638613"/>
                <a:gd name="connsiteY3" fmla="*/ 1117329 h 1193831"/>
                <a:gd name="connsiteX4" fmla="*/ 1037720 w 1638613"/>
                <a:gd name="connsiteY4" fmla="*/ 1178974 h 1193831"/>
                <a:gd name="connsiteX5" fmla="*/ 1294574 w 1638613"/>
                <a:gd name="connsiteY5" fmla="*/ 1189248 h 1193831"/>
                <a:gd name="connsiteX6" fmla="*/ 1458960 w 1638613"/>
                <a:gd name="connsiteY6" fmla="*/ 1117329 h 1193831"/>
                <a:gd name="connsiteX7" fmla="*/ 1571976 w 1638613"/>
                <a:gd name="connsiteY7" fmla="*/ 1004314 h 1193831"/>
                <a:gd name="connsiteX8" fmla="*/ 1613073 w 1638613"/>
                <a:gd name="connsiteY8" fmla="*/ 860475 h 1193831"/>
                <a:gd name="connsiteX9" fmla="*/ 1633621 w 1638613"/>
                <a:gd name="connsiteY9" fmla="*/ 737185 h 1193831"/>
                <a:gd name="connsiteX10" fmla="*/ 1517850 w 1638613"/>
                <a:gd name="connsiteY10" fmla="*/ 594146 h 1193831"/>
                <a:gd name="connsiteX11" fmla="*/ 1330158 w 1638613"/>
                <a:gd name="connsiteY11" fmla="*/ 504847 h 1193831"/>
                <a:gd name="connsiteX12" fmla="*/ 1086335 w 1638613"/>
                <a:gd name="connsiteY12" fmla="*/ 402903 h 1193831"/>
                <a:gd name="connsiteX13" fmla="*/ 1146478 w 1638613"/>
                <a:gd name="connsiteY13" fmla="*/ 302530 h 1193831"/>
                <a:gd name="connsiteX14" fmla="*/ 1039977 w 1638613"/>
                <a:gd name="connsiteY14" fmla="*/ 167397 h 1193831"/>
                <a:gd name="connsiteX15" fmla="*/ 800664 w 1638613"/>
                <a:gd name="connsiteY15" fmla="*/ 45677 h 1193831"/>
                <a:gd name="connsiteX16" fmla="*/ 503574 w 1638613"/>
                <a:gd name="connsiteY16" fmla="*/ 14515 h 1193831"/>
                <a:gd name="connsiteX17" fmla="*/ 372542 w 1638613"/>
                <a:gd name="connsiteY17" fmla="*/ 32 h 1193831"/>
                <a:gd name="connsiteX18" fmla="*/ 256884 w 1638613"/>
                <a:gd name="connsiteY18" fmla="*/ 17995 h 1193831"/>
                <a:gd name="connsiteX19" fmla="*/ 113046 w 1638613"/>
                <a:gd name="connsiteY19" fmla="*/ 89915 h 1193831"/>
                <a:gd name="connsiteX20" fmla="*/ 30 w 1638613"/>
                <a:gd name="connsiteY20" fmla="*/ 346767 h 1193831"/>
                <a:gd name="connsiteX0" fmla="*/ 30 w 1638612"/>
                <a:gd name="connsiteY0" fmla="*/ 346767 h 1193831"/>
                <a:gd name="connsiteX1" fmla="*/ 123320 w 1638612"/>
                <a:gd name="connsiteY1" fmla="*/ 706363 h 1193831"/>
                <a:gd name="connsiteX2" fmla="*/ 318529 w 1638612"/>
                <a:gd name="connsiteY2" fmla="*/ 952943 h 1193831"/>
                <a:gd name="connsiteX3" fmla="*/ 606205 w 1638612"/>
                <a:gd name="connsiteY3" fmla="*/ 1117329 h 1193831"/>
                <a:gd name="connsiteX4" fmla="*/ 1037720 w 1638612"/>
                <a:gd name="connsiteY4" fmla="*/ 1178974 h 1193831"/>
                <a:gd name="connsiteX5" fmla="*/ 1294574 w 1638612"/>
                <a:gd name="connsiteY5" fmla="*/ 1189248 h 1193831"/>
                <a:gd name="connsiteX6" fmla="*/ 1458960 w 1638612"/>
                <a:gd name="connsiteY6" fmla="*/ 1117329 h 1193831"/>
                <a:gd name="connsiteX7" fmla="*/ 1571976 w 1638612"/>
                <a:gd name="connsiteY7" fmla="*/ 1004314 h 1193831"/>
                <a:gd name="connsiteX8" fmla="*/ 1613073 w 1638612"/>
                <a:gd name="connsiteY8" fmla="*/ 860475 h 1193831"/>
                <a:gd name="connsiteX9" fmla="*/ 1633621 w 1638612"/>
                <a:gd name="connsiteY9" fmla="*/ 737185 h 1193831"/>
                <a:gd name="connsiteX10" fmla="*/ 1517850 w 1638612"/>
                <a:gd name="connsiteY10" fmla="*/ 594146 h 1193831"/>
                <a:gd name="connsiteX11" fmla="*/ 1330158 w 1638612"/>
                <a:gd name="connsiteY11" fmla="*/ 504847 h 1193831"/>
                <a:gd name="connsiteX12" fmla="*/ 1212634 w 1638612"/>
                <a:gd name="connsiteY12" fmla="*/ 390260 h 1193831"/>
                <a:gd name="connsiteX13" fmla="*/ 1146478 w 1638612"/>
                <a:gd name="connsiteY13" fmla="*/ 302530 h 1193831"/>
                <a:gd name="connsiteX14" fmla="*/ 1039977 w 1638612"/>
                <a:gd name="connsiteY14" fmla="*/ 167397 h 1193831"/>
                <a:gd name="connsiteX15" fmla="*/ 800664 w 1638612"/>
                <a:gd name="connsiteY15" fmla="*/ 45677 h 1193831"/>
                <a:gd name="connsiteX16" fmla="*/ 503574 w 1638612"/>
                <a:gd name="connsiteY16" fmla="*/ 14515 h 1193831"/>
                <a:gd name="connsiteX17" fmla="*/ 372542 w 1638612"/>
                <a:gd name="connsiteY17" fmla="*/ 32 h 1193831"/>
                <a:gd name="connsiteX18" fmla="*/ 256884 w 1638612"/>
                <a:gd name="connsiteY18" fmla="*/ 17995 h 1193831"/>
                <a:gd name="connsiteX19" fmla="*/ 113046 w 1638612"/>
                <a:gd name="connsiteY19" fmla="*/ 89915 h 1193831"/>
                <a:gd name="connsiteX20" fmla="*/ 30 w 1638612"/>
                <a:gd name="connsiteY20" fmla="*/ 346767 h 119383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1638612" h="1193831">
                  <a:moveTo>
                    <a:pt x="30" y="346767"/>
                  </a:moveTo>
                  <a:cubicBezTo>
                    <a:pt x="1742" y="449508"/>
                    <a:pt x="70237" y="605334"/>
                    <a:pt x="123320" y="706363"/>
                  </a:cubicBezTo>
                  <a:cubicBezTo>
                    <a:pt x="176403" y="807392"/>
                    <a:pt x="238048" y="884449"/>
                    <a:pt x="318529" y="952943"/>
                  </a:cubicBezTo>
                  <a:cubicBezTo>
                    <a:pt x="399010" y="1021437"/>
                    <a:pt x="486340" y="1079657"/>
                    <a:pt x="606205" y="1117329"/>
                  </a:cubicBezTo>
                  <a:cubicBezTo>
                    <a:pt x="726070" y="1155001"/>
                    <a:pt x="922992" y="1166988"/>
                    <a:pt x="1037720" y="1178974"/>
                  </a:cubicBezTo>
                  <a:cubicBezTo>
                    <a:pt x="1152448" y="1190960"/>
                    <a:pt x="1224367" y="1199522"/>
                    <a:pt x="1294574" y="1189248"/>
                  </a:cubicBezTo>
                  <a:cubicBezTo>
                    <a:pt x="1364781" y="1178974"/>
                    <a:pt x="1412726" y="1148151"/>
                    <a:pt x="1458960" y="1117329"/>
                  </a:cubicBezTo>
                  <a:cubicBezTo>
                    <a:pt x="1505194" y="1086507"/>
                    <a:pt x="1546291" y="1047123"/>
                    <a:pt x="1571976" y="1004314"/>
                  </a:cubicBezTo>
                  <a:cubicBezTo>
                    <a:pt x="1597661" y="961505"/>
                    <a:pt x="1602799" y="904996"/>
                    <a:pt x="1613073" y="860475"/>
                  </a:cubicBezTo>
                  <a:cubicBezTo>
                    <a:pt x="1623347" y="815954"/>
                    <a:pt x="1649492" y="781573"/>
                    <a:pt x="1633621" y="737185"/>
                  </a:cubicBezTo>
                  <a:cubicBezTo>
                    <a:pt x="1617751" y="692797"/>
                    <a:pt x="1568427" y="632869"/>
                    <a:pt x="1517850" y="594146"/>
                  </a:cubicBezTo>
                  <a:cubicBezTo>
                    <a:pt x="1467273" y="555423"/>
                    <a:pt x="1381027" y="538828"/>
                    <a:pt x="1330158" y="504847"/>
                  </a:cubicBezTo>
                  <a:cubicBezTo>
                    <a:pt x="1279289" y="470866"/>
                    <a:pt x="1243247" y="423980"/>
                    <a:pt x="1212634" y="390260"/>
                  </a:cubicBezTo>
                  <a:cubicBezTo>
                    <a:pt x="1182021" y="356540"/>
                    <a:pt x="1175254" y="339674"/>
                    <a:pt x="1146478" y="302530"/>
                  </a:cubicBezTo>
                  <a:cubicBezTo>
                    <a:pt x="1117702" y="265386"/>
                    <a:pt x="1097613" y="210206"/>
                    <a:pt x="1039977" y="167397"/>
                  </a:cubicBezTo>
                  <a:cubicBezTo>
                    <a:pt x="982341" y="124588"/>
                    <a:pt x="890065" y="71157"/>
                    <a:pt x="800664" y="45677"/>
                  </a:cubicBezTo>
                  <a:cubicBezTo>
                    <a:pt x="711264" y="20197"/>
                    <a:pt x="574928" y="22122"/>
                    <a:pt x="503574" y="14515"/>
                  </a:cubicBezTo>
                  <a:cubicBezTo>
                    <a:pt x="432220" y="6908"/>
                    <a:pt x="413657" y="-548"/>
                    <a:pt x="372542" y="32"/>
                  </a:cubicBezTo>
                  <a:cubicBezTo>
                    <a:pt x="331427" y="612"/>
                    <a:pt x="303118" y="-841"/>
                    <a:pt x="256884" y="17995"/>
                  </a:cubicBezTo>
                  <a:cubicBezTo>
                    <a:pt x="210650" y="36831"/>
                    <a:pt x="155855" y="35120"/>
                    <a:pt x="113046" y="89915"/>
                  </a:cubicBezTo>
                  <a:cubicBezTo>
                    <a:pt x="70237" y="144710"/>
                    <a:pt x="-1682" y="244026"/>
                    <a:pt x="30" y="346767"/>
                  </a:cubicBezTo>
                  <a:close/>
                </a:path>
              </a:pathLst>
            </a:cu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5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9" name="组合 108">
            <a:extLst>
              <a:ext uri="{FF2B5EF4-FFF2-40B4-BE49-F238E27FC236}">
                <a16:creationId xmlns:a16="http://schemas.microsoft.com/office/drawing/2014/main" id="{1E73B829-A501-4447-BB05-924C8779BBAC}"/>
              </a:ext>
            </a:extLst>
          </p:cNvPr>
          <p:cNvGrpSpPr/>
          <p:nvPr/>
        </p:nvGrpSpPr>
        <p:grpSpPr>
          <a:xfrm rot="19673149">
            <a:off x="6568776" y="5560825"/>
            <a:ext cx="420301" cy="137367"/>
            <a:chOff x="1860884" y="4523874"/>
            <a:chExt cx="497309" cy="176466"/>
          </a:xfrm>
          <a:solidFill>
            <a:schemeClr val="accent6"/>
          </a:solidFill>
        </p:grpSpPr>
        <p:sp>
          <p:nvSpPr>
            <p:cNvPr id="110" name="流程图: 终止 109">
              <a:extLst>
                <a:ext uri="{FF2B5EF4-FFF2-40B4-BE49-F238E27FC236}">
                  <a16:creationId xmlns:a16="http://schemas.microsoft.com/office/drawing/2014/main" id="{078C1E9B-BEB9-49D9-91BD-86EE961E57E6}"/>
                </a:ext>
              </a:extLst>
            </p:cNvPr>
            <p:cNvSpPr/>
            <p:nvPr/>
          </p:nvSpPr>
          <p:spPr>
            <a:xfrm>
              <a:off x="1860884" y="4523874"/>
              <a:ext cx="304800" cy="80210"/>
            </a:xfrm>
            <a:prstGeom prst="flowChartTerminator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" name="连接符: 曲线 110">
              <a:extLst>
                <a:ext uri="{FF2B5EF4-FFF2-40B4-BE49-F238E27FC236}">
                  <a16:creationId xmlns:a16="http://schemas.microsoft.com/office/drawing/2014/main" id="{98E73A11-D9DF-4A6B-A659-831CD177F4C0}"/>
                </a:ext>
              </a:extLst>
            </p:cNvPr>
            <p:cNvCxnSpPr>
              <a:cxnSpLocks/>
            </p:cNvCxnSpPr>
            <p:nvPr/>
          </p:nvCxnSpPr>
          <p:spPr>
            <a:xfrm>
              <a:off x="2181725" y="4572000"/>
              <a:ext cx="176468" cy="128340"/>
            </a:xfrm>
            <a:prstGeom prst="curvedConnector3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组合 111">
            <a:extLst>
              <a:ext uri="{FF2B5EF4-FFF2-40B4-BE49-F238E27FC236}">
                <a16:creationId xmlns:a16="http://schemas.microsoft.com/office/drawing/2014/main" id="{52A5935B-1D41-43D2-BC5D-B7DD8452ABA5}"/>
              </a:ext>
            </a:extLst>
          </p:cNvPr>
          <p:cNvGrpSpPr/>
          <p:nvPr/>
        </p:nvGrpSpPr>
        <p:grpSpPr>
          <a:xfrm rot="4502470">
            <a:off x="5916774" y="4603488"/>
            <a:ext cx="387123" cy="149140"/>
            <a:chOff x="1860884" y="4523874"/>
            <a:chExt cx="497309" cy="176466"/>
          </a:xfrm>
          <a:solidFill>
            <a:schemeClr val="accent6"/>
          </a:solidFill>
        </p:grpSpPr>
        <p:sp>
          <p:nvSpPr>
            <p:cNvPr id="113" name="流程图: 终止 112">
              <a:extLst>
                <a:ext uri="{FF2B5EF4-FFF2-40B4-BE49-F238E27FC236}">
                  <a16:creationId xmlns:a16="http://schemas.microsoft.com/office/drawing/2014/main" id="{6EF2E76D-E626-4E34-BCAA-2D9266A83D7B}"/>
                </a:ext>
              </a:extLst>
            </p:cNvPr>
            <p:cNvSpPr/>
            <p:nvPr/>
          </p:nvSpPr>
          <p:spPr>
            <a:xfrm>
              <a:off x="1860884" y="4523874"/>
              <a:ext cx="304800" cy="80210"/>
            </a:xfrm>
            <a:prstGeom prst="flowChartTerminator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连接符: 曲线 113">
              <a:extLst>
                <a:ext uri="{FF2B5EF4-FFF2-40B4-BE49-F238E27FC236}">
                  <a16:creationId xmlns:a16="http://schemas.microsoft.com/office/drawing/2014/main" id="{D8D2DEF9-817F-4A02-9EBF-14E046E8E67C}"/>
                </a:ext>
              </a:extLst>
            </p:cNvPr>
            <p:cNvCxnSpPr>
              <a:cxnSpLocks/>
            </p:cNvCxnSpPr>
            <p:nvPr/>
          </p:nvCxnSpPr>
          <p:spPr>
            <a:xfrm>
              <a:off x="2181725" y="4572000"/>
              <a:ext cx="176468" cy="128340"/>
            </a:xfrm>
            <a:prstGeom prst="curvedConnector3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5" name="组合 114">
            <a:extLst>
              <a:ext uri="{FF2B5EF4-FFF2-40B4-BE49-F238E27FC236}">
                <a16:creationId xmlns:a16="http://schemas.microsoft.com/office/drawing/2014/main" id="{517B6F8D-16D4-47C3-9D85-82A4E0113EBE}"/>
              </a:ext>
            </a:extLst>
          </p:cNvPr>
          <p:cNvGrpSpPr/>
          <p:nvPr/>
        </p:nvGrpSpPr>
        <p:grpSpPr>
          <a:xfrm>
            <a:off x="5945338" y="5147959"/>
            <a:ext cx="420301" cy="137367"/>
            <a:chOff x="1860884" y="4523874"/>
            <a:chExt cx="497309" cy="176466"/>
          </a:xfrm>
          <a:solidFill>
            <a:schemeClr val="accent6"/>
          </a:solidFill>
        </p:grpSpPr>
        <p:sp>
          <p:nvSpPr>
            <p:cNvPr id="116" name="流程图: 终止 115">
              <a:extLst>
                <a:ext uri="{FF2B5EF4-FFF2-40B4-BE49-F238E27FC236}">
                  <a16:creationId xmlns:a16="http://schemas.microsoft.com/office/drawing/2014/main" id="{76AB3C42-3663-4DE7-BB7F-2C2169B97337}"/>
                </a:ext>
              </a:extLst>
            </p:cNvPr>
            <p:cNvSpPr/>
            <p:nvPr/>
          </p:nvSpPr>
          <p:spPr>
            <a:xfrm>
              <a:off x="1860884" y="4523874"/>
              <a:ext cx="304800" cy="80210"/>
            </a:xfrm>
            <a:prstGeom prst="flowChartTerminator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连接符: 曲线 116">
              <a:extLst>
                <a:ext uri="{FF2B5EF4-FFF2-40B4-BE49-F238E27FC236}">
                  <a16:creationId xmlns:a16="http://schemas.microsoft.com/office/drawing/2014/main" id="{330196B9-4B52-4B93-B5AA-2B0F0E1532A1}"/>
                </a:ext>
              </a:extLst>
            </p:cNvPr>
            <p:cNvCxnSpPr>
              <a:cxnSpLocks/>
            </p:cNvCxnSpPr>
            <p:nvPr/>
          </p:nvCxnSpPr>
          <p:spPr>
            <a:xfrm>
              <a:off x="2181725" y="4572000"/>
              <a:ext cx="176468" cy="128340"/>
            </a:xfrm>
            <a:prstGeom prst="curvedConnector3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8" name="组合 117">
            <a:extLst>
              <a:ext uri="{FF2B5EF4-FFF2-40B4-BE49-F238E27FC236}">
                <a16:creationId xmlns:a16="http://schemas.microsoft.com/office/drawing/2014/main" id="{BB249164-1BB9-4043-BDC6-C96F65331ACF}"/>
              </a:ext>
            </a:extLst>
          </p:cNvPr>
          <p:cNvGrpSpPr/>
          <p:nvPr/>
        </p:nvGrpSpPr>
        <p:grpSpPr>
          <a:xfrm rot="6429321">
            <a:off x="6227612" y="5393865"/>
            <a:ext cx="387123" cy="149140"/>
            <a:chOff x="1860884" y="4523874"/>
            <a:chExt cx="497309" cy="176466"/>
          </a:xfrm>
          <a:solidFill>
            <a:schemeClr val="accent6"/>
          </a:solidFill>
        </p:grpSpPr>
        <p:sp>
          <p:nvSpPr>
            <p:cNvPr id="119" name="流程图: 终止 118">
              <a:extLst>
                <a:ext uri="{FF2B5EF4-FFF2-40B4-BE49-F238E27FC236}">
                  <a16:creationId xmlns:a16="http://schemas.microsoft.com/office/drawing/2014/main" id="{B03F4A80-ADBA-4E36-B4D0-A23798468EAD}"/>
                </a:ext>
              </a:extLst>
            </p:cNvPr>
            <p:cNvSpPr/>
            <p:nvPr/>
          </p:nvSpPr>
          <p:spPr>
            <a:xfrm>
              <a:off x="1860884" y="4523874"/>
              <a:ext cx="304800" cy="80210"/>
            </a:xfrm>
            <a:prstGeom prst="flowChartTerminator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连接符: 曲线 119">
              <a:extLst>
                <a:ext uri="{FF2B5EF4-FFF2-40B4-BE49-F238E27FC236}">
                  <a16:creationId xmlns:a16="http://schemas.microsoft.com/office/drawing/2014/main" id="{BB15BCD5-1210-4D4C-A892-CCA2338372B0}"/>
                </a:ext>
              </a:extLst>
            </p:cNvPr>
            <p:cNvCxnSpPr>
              <a:cxnSpLocks/>
            </p:cNvCxnSpPr>
            <p:nvPr/>
          </p:nvCxnSpPr>
          <p:spPr>
            <a:xfrm>
              <a:off x="2181725" y="4572000"/>
              <a:ext cx="176468" cy="128340"/>
            </a:xfrm>
            <a:prstGeom prst="curvedConnector3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组合 120">
            <a:extLst>
              <a:ext uri="{FF2B5EF4-FFF2-40B4-BE49-F238E27FC236}">
                <a16:creationId xmlns:a16="http://schemas.microsoft.com/office/drawing/2014/main" id="{117B5F0B-574B-4D1D-AEC6-1129073CB658}"/>
              </a:ext>
            </a:extLst>
          </p:cNvPr>
          <p:cNvGrpSpPr/>
          <p:nvPr/>
        </p:nvGrpSpPr>
        <p:grpSpPr>
          <a:xfrm rot="21207973">
            <a:off x="6897007" y="5006215"/>
            <a:ext cx="420301" cy="137367"/>
            <a:chOff x="1860884" y="4523874"/>
            <a:chExt cx="497309" cy="176466"/>
          </a:xfrm>
          <a:solidFill>
            <a:schemeClr val="accent6"/>
          </a:solidFill>
        </p:grpSpPr>
        <p:sp>
          <p:nvSpPr>
            <p:cNvPr id="122" name="流程图: 终止 121">
              <a:extLst>
                <a:ext uri="{FF2B5EF4-FFF2-40B4-BE49-F238E27FC236}">
                  <a16:creationId xmlns:a16="http://schemas.microsoft.com/office/drawing/2014/main" id="{6CDBBD4A-F92D-4770-9725-1D4B8314A72B}"/>
                </a:ext>
              </a:extLst>
            </p:cNvPr>
            <p:cNvSpPr/>
            <p:nvPr/>
          </p:nvSpPr>
          <p:spPr>
            <a:xfrm>
              <a:off x="1860884" y="4523874"/>
              <a:ext cx="304800" cy="80210"/>
            </a:xfrm>
            <a:prstGeom prst="flowChartTerminator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3" name="连接符: 曲线 122">
              <a:extLst>
                <a:ext uri="{FF2B5EF4-FFF2-40B4-BE49-F238E27FC236}">
                  <a16:creationId xmlns:a16="http://schemas.microsoft.com/office/drawing/2014/main" id="{9A5A6FE3-9F13-4DEF-AAED-2AAACAD4780A}"/>
                </a:ext>
              </a:extLst>
            </p:cNvPr>
            <p:cNvCxnSpPr>
              <a:cxnSpLocks/>
            </p:cNvCxnSpPr>
            <p:nvPr/>
          </p:nvCxnSpPr>
          <p:spPr>
            <a:xfrm>
              <a:off x="2181725" y="4572000"/>
              <a:ext cx="176468" cy="128340"/>
            </a:xfrm>
            <a:prstGeom prst="curvedConnector3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18FF1B98-467F-40F5-BBA6-8A416B784A92}"/>
              </a:ext>
            </a:extLst>
          </p:cNvPr>
          <p:cNvGrpSpPr/>
          <p:nvPr/>
        </p:nvGrpSpPr>
        <p:grpSpPr>
          <a:xfrm rot="7388039">
            <a:off x="7636253" y="5324348"/>
            <a:ext cx="387123" cy="149140"/>
            <a:chOff x="1860884" y="4523874"/>
            <a:chExt cx="497309" cy="176466"/>
          </a:xfrm>
          <a:solidFill>
            <a:schemeClr val="accent6"/>
          </a:solidFill>
        </p:grpSpPr>
        <p:sp>
          <p:nvSpPr>
            <p:cNvPr id="125" name="流程图: 终止 124">
              <a:extLst>
                <a:ext uri="{FF2B5EF4-FFF2-40B4-BE49-F238E27FC236}">
                  <a16:creationId xmlns:a16="http://schemas.microsoft.com/office/drawing/2014/main" id="{1120C06A-99C5-4ABB-BEDE-936A502A1F6F}"/>
                </a:ext>
              </a:extLst>
            </p:cNvPr>
            <p:cNvSpPr/>
            <p:nvPr/>
          </p:nvSpPr>
          <p:spPr>
            <a:xfrm>
              <a:off x="1860884" y="4523874"/>
              <a:ext cx="304800" cy="80210"/>
            </a:xfrm>
            <a:prstGeom prst="flowChartTerminator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连接符: 曲线 125">
              <a:extLst>
                <a:ext uri="{FF2B5EF4-FFF2-40B4-BE49-F238E27FC236}">
                  <a16:creationId xmlns:a16="http://schemas.microsoft.com/office/drawing/2014/main" id="{22A25931-2E96-48F3-B24C-8095E267601B}"/>
                </a:ext>
              </a:extLst>
            </p:cNvPr>
            <p:cNvCxnSpPr>
              <a:cxnSpLocks/>
            </p:cNvCxnSpPr>
            <p:nvPr/>
          </p:nvCxnSpPr>
          <p:spPr>
            <a:xfrm>
              <a:off x="2181725" y="4572000"/>
              <a:ext cx="176468" cy="128340"/>
            </a:xfrm>
            <a:prstGeom prst="curvedConnector3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组合 126">
            <a:extLst>
              <a:ext uri="{FF2B5EF4-FFF2-40B4-BE49-F238E27FC236}">
                <a16:creationId xmlns:a16="http://schemas.microsoft.com/office/drawing/2014/main" id="{F0EF77F9-4569-454D-B236-A35C3D4BE9BE}"/>
              </a:ext>
            </a:extLst>
          </p:cNvPr>
          <p:cNvGrpSpPr/>
          <p:nvPr/>
        </p:nvGrpSpPr>
        <p:grpSpPr>
          <a:xfrm>
            <a:off x="7187340" y="5599458"/>
            <a:ext cx="420301" cy="137367"/>
            <a:chOff x="1860884" y="4523874"/>
            <a:chExt cx="497309" cy="176466"/>
          </a:xfrm>
          <a:solidFill>
            <a:schemeClr val="accent6"/>
          </a:solidFill>
        </p:grpSpPr>
        <p:sp>
          <p:nvSpPr>
            <p:cNvPr id="128" name="流程图: 终止 127">
              <a:extLst>
                <a:ext uri="{FF2B5EF4-FFF2-40B4-BE49-F238E27FC236}">
                  <a16:creationId xmlns:a16="http://schemas.microsoft.com/office/drawing/2014/main" id="{41655A91-BAE9-4CDA-8D1E-E89C8C2AF910}"/>
                </a:ext>
              </a:extLst>
            </p:cNvPr>
            <p:cNvSpPr/>
            <p:nvPr/>
          </p:nvSpPr>
          <p:spPr>
            <a:xfrm>
              <a:off x="1860884" y="4523874"/>
              <a:ext cx="304800" cy="80210"/>
            </a:xfrm>
            <a:prstGeom prst="flowChartTerminator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连接符: 曲线 128">
              <a:extLst>
                <a:ext uri="{FF2B5EF4-FFF2-40B4-BE49-F238E27FC236}">
                  <a16:creationId xmlns:a16="http://schemas.microsoft.com/office/drawing/2014/main" id="{BC58E9C3-00FE-4954-A535-CA36EEA46CB9}"/>
                </a:ext>
              </a:extLst>
            </p:cNvPr>
            <p:cNvCxnSpPr>
              <a:cxnSpLocks/>
            </p:cNvCxnSpPr>
            <p:nvPr/>
          </p:nvCxnSpPr>
          <p:spPr>
            <a:xfrm>
              <a:off x="2181725" y="4572000"/>
              <a:ext cx="176468" cy="128340"/>
            </a:xfrm>
            <a:prstGeom prst="curvedConnector3">
              <a:avLst/>
            </a:prstGeom>
            <a:grpFill/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1" name="组合 130">
            <a:extLst>
              <a:ext uri="{FF2B5EF4-FFF2-40B4-BE49-F238E27FC236}">
                <a16:creationId xmlns:a16="http://schemas.microsoft.com/office/drawing/2014/main" id="{F87D4FDA-9AD1-4E5D-AAAD-E1778C78899B}"/>
              </a:ext>
            </a:extLst>
          </p:cNvPr>
          <p:cNvGrpSpPr/>
          <p:nvPr/>
        </p:nvGrpSpPr>
        <p:grpSpPr>
          <a:xfrm>
            <a:off x="4751790" y="3678728"/>
            <a:ext cx="3622139" cy="1272661"/>
            <a:chOff x="1085056" y="6800877"/>
            <a:chExt cx="4285791" cy="1634897"/>
          </a:xfrm>
        </p:grpSpPr>
        <p:sp>
          <p:nvSpPr>
            <p:cNvPr id="132" name="椭圆 131">
              <a:extLst>
                <a:ext uri="{FF2B5EF4-FFF2-40B4-BE49-F238E27FC236}">
                  <a16:creationId xmlns:a16="http://schemas.microsoft.com/office/drawing/2014/main" id="{B2BBF2E3-3EDD-4D85-8E75-B153DC06336C}"/>
                </a:ext>
              </a:extLst>
            </p:cNvPr>
            <p:cNvSpPr/>
            <p:nvPr/>
          </p:nvSpPr>
          <p:spPr>
            <a:xfrm>
              <a:off x="3220325" y="7502723"/>
              <a:ext cx="156171" cy="145185"/>
            </a:xfrm>
            <a:prstGeom prst="ellipse">
              <a:avLst/>
            </a:prstGeom>
            <a:gradFill flip="none" rotWithShape="1">
              <a:gsLst>
                <a:gs pos="28000">
                  <a:schemeClr val="accent5">
                    <a:lumMod val="5000"/>
                    <a:lumOff val="95000"/>
                  </a:schemeClr>
                </a:gs>
                <a:gs pos="99000">
                  <a:schemeClr val="accent5">
                    <a:lumMod val="45000"/>
                    <a:lumOff val="55000"/>
                  </a:schemeClr>
                </a:gs>
                <a:gs pos="78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95250" cmpd="dbl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椭圆 132">
              <a:extLst>
                <a:ext uri="{FF2B5EF4-FFF2-40B4-BE49-F238E27FC236}">
                  <a16:creationId xmlns:a16="http://schemas.microsoft.com/office/drawing/2014/main" id="{E58749CF-9F66-40E2-83EE-A4AC736361BF}"/>
                </a:ext>
              </a:extLst>
            </p:cNvPr>
            <p:cNvSpPr/>
            <p:nvPr/>
          </p:nvSpPr>
          <p:spPr>
            <a:xfrm>
              <a:off x="3399427" y="7768918"/>
              <a:ext cx="156171" cy="145185"/>
            </a:xfrm>
            <a:prstGeom prst="ellipse">
              <a:avLst/>
            </a:prstGeom>
            <a:gradFill flip="none" rotWithShape="1">
              <a:gsLst>
                <a:gs pos="28000">
                  <a:schemeClr val="accent5">
                    <a:lumMod val="5000"/>
                    <a:lumOff val="95000"/>
                  </a:schemeClr>
                </a:gs>
                <a:gs pos="99000">
                  <a:schemeClr val="accent5">
                    <a:lumMod val="45000"/>
                    <a:lumOff val="55000"/>
                  </a:schemeClr>
                </a:gs>
                <a:gs pos="78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95250" cmpd="dbl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椭圆 133">
              <a:extLst>
                <a:ext uri="{FF2B5EF4-FFF2-40B4-BE49-F238E27FC236}">
                  <a16:creationId xmlns:a16="http://schemas.microsoft.com/office/drawing/2014/main" id="{1969E493-2358-4AAD-B8E0-EDE0EE7B3217}"/>
                </a:ext>
              </a:extLst>
            </p:cNvPr>
            <p:cNvSpPr/>
            <p:nvPr/>
          </p:nvSpPr>
          <p:spPr>
            <a:xfrm rot="5400000">
              <a:off x="3681601" y="7014900"/>
              <a:ext cx="156171" cy="145185"/>
            </a:xfrm>
            <a:prstGeom prst="ellipse">
              <a:avLst/>
            </a:prstGeom>
            <a:gradFill flip="none" rotWithShape="1">
              <a:gsLst>
                <a:gs pos="28000">
                  <a:schemeClr val="accent5">
                    <a:lumMod val="5000"/>
                    <a:lumOff val="95000"/>
                  </a:schemeClr>
                </a:gs>
                <a:gs pos="99000">
                  <a:schemeClr val="accent5">
                    <a:lumMod val="45000"/>
                    <a:lumOff val="55000"/>
                  </a:schemeClr>
                </a:gs>
                <a:gs pos="78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95250" cmpd="dbl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椭圆 134">
              <a:extLst>
                <a:ext uri="{FF2B5EF4-FFF2-40B4-BE49-F238E27FC236}">
                  <a16:creationId xmlns:a16="http://schemas.microsoft.com/office/drawing/2014/main" id="{83C2E69F-0E07-4EEA-8F91-A40FE838E356}"/>
                </a:ext>
              </a:extLst>
            </p:cNvPr>
            <p:cNvSpPr/>
            <p:nvPr/>
          </p:nvSpPr>
          <p:spPr>
            <a:xfrm rot="5400000">
              <a:off x="2842758" y="6978806"/>
              <a:ext cx="156171" cy="145185"/>
            </a:xfrm>
            <a:prstGeom prst="ellipse">
              <a:avLst/>
            </a:prstGeom>
            <a:gradFill flip="none" rotWithShape="1">
              <a:gsLst>
                <a:gs pos="28000">
                  <a:schemeClr val="accent5">
                    <a:lumMod val="5000"/>
                    <a:lumOff val="95000"/>
                  </a:schemeClr>
                </a:gs>
                <a:gs pos="99000">
                  <a:schemeClr val="accent5">
                    <a:lumMod val="45000"/>
                    <a:lumOff val="55000"/>
                  </a:schemeClr>
                </a:gs>
                <a:gs pos="78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95250" cmpd="dbl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椭圆 135">
              <a:extLst>
                <a:ext uri="{FF2B5EF4-FFF2-40B4-BE49-F238E27FC236}">
                  <a16:creationId xmlns:a16="http://schemas.microsoft.com/office/drawing/2014/main" id="{857327DD-C1DD-4835-9980-3EB7A382EDB4}"/>
                </a:ext>
              </a:extLst>
            </p:cNvPr>
            <p:cNvSpPr/>
            <p:nvPr/>
          </p:nvSpPr>
          <p:spPr>
            <a:xfrm rot="5400000">
              <a:off x="3627175" y="7993355"/>
              <a:ext cx="156171" cy="145185"/>
            </a:xfrm>
            <a:prstGeom prst="ellipse">
              <a:avLst/>
            </a:prstGeom>
            <a:gradFill flip="none" rotWithShape="1">
              <a:gsLst>
                <a:gs pos="28000">
                  <a:schemeClr val="accent5">
                    <a:lumMod val="5000"/>
                    <a:lumOff val="95000"/>
                  </a:schemeClr>
                </a:gs>
                <a:gs pos="99000">
                  <a:schemeClr val="accent5">
                    <a:lumMod val="45000"/>
                    <a:lumOff val="55000"/>
                  </a:schemeClr>
                </a:gs>
                <a:gs pos="78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95250" cmpd="dbl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任意多边形: 形状 136">
              <a:extLst>
                <a:ext uri="{FF2B5EF4-FFF2-40B4-BE49-F238E27FC236}">
                  <a16:creationId xmlns:a16="http://schemas.microsoft.com/office/drawing/2014/main" id="{129D2CA4-6ED4-4F5B-8E61-8DE941DFA0FD}"/>
                </a:ext>
              </a:extLst>
            </p:cNvPr>
            <p:cNvSpPr/>
            <p:nvPr/>
          </p:nvSpPr>
          <p:spPr>
            <a:xfrm>
              <a:off x="3659878" y="7217045"/>
              <a:ext cx="205226" cy="149379"/>
            </a:xfrm>
            <a:custGeom>
              <a:avLst/>
              <a:gdLst>
                <a:gd name="connsiteX0" fmla="*/ 0 w 416560"/>
                <a:gd name="connsiteY0" fmla="*/ 10160 h 762000"/>
                <a:gd name="connsiteX1" fmla="*/ 0 w 416560"/>
                <a:gd name="connsiteY1" fmla="*/ 223520 h 762000"/>
                <a:gd name="connsiteX2" fmla="*/ 152400 w 416560"/>
                <a:gd name="connsiteY2" fmla="*/ 223520 h 762000"/>
                <a:gd name="connsiteX3" fmla="*/ 152400 w 416560"/>
                <a:gd name="connsiteY3" fmla="*/ 762000 h 762000"/>
                <a:gd name="connsiteX4" fmla="*/ 264160 w 416560"/>
                <a:gd name="connsiteY4" fmla="*/ 751840 h 762000"/>
                <a:gd name="connsiteX5" fmla="*/ 264160 w 416560"/>
                <a:gd name="connsiteY5" fmla="*/ 223520 h 762000"/>
                <a:gd name="connsiteX6" fmla="*/ 416560 w 416560"/>
                <a:gd name="connsiteY6" fmla="*/ 223520 h 762000"/>
                <a:gd name="connsiteX7" fmla="*/ 416560 w 416560"/>
                <a:gd name="connsiteY7" fmla="*/ 0 h 762000"/>
                <a:gd name="connsiteX8" fmla="*/ 386080 w 416560"/>
                <a:gd name="connsiteY8" fmla="*/ 30480 h 762000"/>
                <a:gd name="connsiteX9" fmla="*/ 375920 w 416560"/>
                <a:gd name="connsiteY9" fmla="*/ 40640 h 762000"/>
                <a:gd name="connsiteX10" fmla="*/ 325120 w 416560"/>
                <a:gd name="connsiteY10" fmla="*/ 60960 h 762000"/>
                <a:gd name="connsiteX11" fmla="*/ 274320 w 416560"/>
                <a:gd name="connsiteY11" fmla="*/ 91440 h 762000"/>
                <a:gd name="connsiteX12" fmla="*/ 213360 w 416560"/>
                <a:gd name="connsiteY12" fmla="*/ 101600 h 762000"/>
                <a:gd name="connsiteX13" fmla="*/ 172720 w 416560"/>
                <a:gd name="connsiteY13" fmla="*/ 101600 h 762000"/>
                <a:gd name="connsiteX14" fmla="*/ 111760 w 416560"/>
                <a:gd name="connsiteY14" fmla="*/ 81280 h 762000"/>
                <a:gd name="connsiteX15" fmla="*/ 111760 w 416560"/>
                <a:gd name="connsiteY15" fmla="*/ 81280 h 762000"/>
                <a:gd name="connsiteX16" fmla="*/ 0 w 416560"/>
                <a:gd name="connsiteY16" fmla="*/ 10160 h 762000"/>
                <a:gd name="connsiteX0" fmla="*/ 0 w 416560"/>
                <a:gd name="connsiteY0" fmla="*/ 10160 h 772160"/>
                <a:gd name="connsiteX1" fmla="*/ 0 w 416560"/>
                <a:gd name="connsiteY1" fmla="*/ 223520 h 772160"/>
                <a:gd name="connsiteX2" fmla="*/ 152400 w 416560"/>
                <a:gd name="connsiteY2" fmla="*/ 223520 h 772160"/>
                <a:gd name="connsiteX3" fmla="*/ 152400 w 416560"/>
                <a:gd name="connsiteY3" fmla="*/ 762000 h 772160"/>
                <a:gd name="connsiteX4" fmla="*/ 264160 w 416560"/>
                <a:gd name="connsiteY4" fmla="*/ 772160 h 772160"/>
                <a:gd name="connsiteX5" fmla="*/ 264160 w 416560"/>
                <a:gd name="connsiteY5" fmla="*/ 223520 h 772160"/>
                <a:gd name="connsiteX6" fmla="*/ 416560 w 416560"/>
                <a:gd name="connsiteY6" fmla="*/ 223520 h 772160"/>
                <a:gd name="connsiteX7" fmla="*/ 416560 w 416560"/>
                <a:gd name="connsiteY7" fmla="*/ 0 h 772160"/>
                <a:gd name="connsiteX8" fmla="*/ 386080 w 416560"/>
                <a:gd name="connsiteY8" fmla="*/ 30480 h 772160"/>
                <a:gd name="connsiteX9" fmla="*/ 375920 w 416560"/>
                <a:gd name="connsiteY9" fmla="*/ 40640 h 772160"/>
                <a:gd name="connsiteX10" fmla="*/ 325120 w 416560"/>
                <a:gd name="connsiteY10" fmla="*/ 60960 h 772160"/>
                <a:gd name="connsiteX11" fmla="*/ 274320 w 416560"/>
                <a:gd name="connsiteY11" fmla="*/ 91440 h 772160"/>
                <a:gd name="connsiteX12" fmla="*/ 213360 w 416560"/>
                <a:gd name="connsiteY12" fmla="*/ 101600 h 772160"/>
                <a:gd name="connsiteX13" fmla="*/ 172720 w 416560"/>
                <a:gd name="connsiteY13" fmla="*/ 101600 h 772160"/>
                <a:gd name="connsiteX14" fmla="*/ 111760 w 416560"/>
                <a:gd name="connsiteY14" fmla="*/ 81280 h 772160"/>
                <a:gd name="connsiteX15" fmla="*/ 111760 w 416560"/>
                <a:gd name="connsiteY15" fmla="*/ 81280 h 772160"/>
                <a:gd name="connsiteX16" fmla="*/ 0 w 416560"/>
                <a:gd name="connsiteY16" fmla="*/ 10160 h 772160"/>
                <a:gd name="connsiteX0" fmla="*/ 0 w 416560"/>
                <a:gd name="connsiteY0" fmla="*/ 10160 h 813880"/>
                <a:gd name="connsiteX1" fmla="*/ 0 w 416560"/>
                <a:gd name="connsiteY1" fmla="*/ 223520 h 813880"/>
                <a:gd name="connsiteX2" fmla="*/ 152400 w 416560"/>
                <a:gd name="connsiteY2" fmla="*/ 223520 h 813880"/>
                <a:gd name="connsiteX3" fmla="*/ 152400 w 416560"/>
                <a:gd name="connsiteY3" fmla="*/ 813880 h 813880"/>
                <a:gd name="connsiteX4" fmla="*/ 264160 w 416560"/>
                <a:gd name="connsiteY4" fmla="*/ 772160 h 813880"/>
                <a:gd name="connsiteX5" fmla="*/ 264160 w 416560"/>
                <a:gd name="connsiteY5" fmla="*/ 223520 h 813880"/>
                <a:gd name="connsiteX6" fmla="*/ 416560 w 416560"/>
                <a:gd name="connsiteY6" fmla="*/ 223520 h 813880"/>
                <a:gd name="connsiteX7" fmla="*/ 416560 w 416560"/>
                <a:gd name="connsiteY7" fmla="*/ 0 h 813880"/>
                <a:gd name="connsiteX8" fmla="*/ 386080 w 416560"/>
                <a:gd name="connsiteY8" fmla="*/ 30480 h 813880"/>
                <a:gd name="connsiteX9" fmla="*/ 375920 w 416560"/>
                <a:gd name="connsiteY9" fmla="*/ 40640 h 813880"/>
                <a:gd name="connsiteX10" fmla="*/ 325120 w 416560"/>
                <a:gd name="connsiteY10" fmla="*/ 60960 h 813880"/>
                <a:gd name="connsiteX11" fmla="*/ 274320 w 416560"/>
                <a:gd name="connsiteY11" fmla="*/ 91440 h 813880"/>
                <a:gd name="connsiteX12" fmla="*/ 213360 w 416560"/>
                <a:gd name="connsiteY12" fmla="*/ 101600 h 813880"/>
                <a:gd name="connsiteX13" fmla="*/ 172720 w 416560"/>
                <a:gd name="connsiteY13" fmla="*/ 101600 h 813880"/>
                <a:gd name="connsiteX14" fmla="*/ 111760 w 416560"/>
                <a:gd name="connsiteY14" fmla="*/ 81280 h 813880"/>
                <a:gd name="connsiteX15" fmla="*/ 111760 w 416560"/>
                <a:gd name="connsiteY15" fmla="*/ 81280 h 813880"/>
                <a:gd name="connsiteX16" fmla="*/ 0 w 416560"/>
                <a:gd name="connsiteY16" fmla="*/ 10160 h 813880"/>
                <a:gd name="connsiteX0" fmla="*/ 0 w 416560"/>
                <a:gd name="connsiteY0" fmla="*/ 10160 h 800910"/>
                <a:gd name="connsiteX1" fmla="*/ 0 w 416560"/>
                <a:gd name="connsiteY1" fmla="*/ 223520 h 800910"/>
                <a:gd name="connsiteX2" fmla="*/ 152400 w 416560"/>
                <a:gd name="connsiteY2" fmla="*/ 223520 h 800910"/>
                <a:gd name="connsiteX3" fmla="*/ 152400 w 416560"/>
                <a:gd name="connsiteY3" fmla="*/ 800910 h 800910"/>
                <a:gd name="connsiteX4" fmla="*/ 264160 w 416560"/>
                <a:gd name="connsiteY4" fmla="*/ 772160 h 800910"/>
                <a:gd name="connsiteX5" fmla="*/ 264160 w 416560"/>
                <a:gd name="connsiteY5" fmla="*/ 223520 h 800910"/>
                <a:gd name="connsiteX6" fmla="*/ 416560 w 416560"/>
                <a:gd name="connsiteY6" fmla="*/ 223520 h 800910"/>
                <a:gd name="connsiteX7" fmla="*/ 416560 w 416560"/>
                <a:gd name="connsiteY7" fmla="*/ 0 h 800910"/>
                <a:gd name="connsiteX8" fmla="*/ 386080 w 416560"/>
                <a:gd name="connsiteY8" fmla="*/ 30480 h 800910"/>
                <a:gd name="connsiteX9" fmla="*/ 375920 w 416560"/>
                <a:gd name="connsiteY9" fmla="*/ 40640 h 800910"/>
                <a:gd name="connsiteX10" fmla="*/ 325120 w 416560"/>
                <a:gd name="connsiteY10" fmla="*/ 60960 h 800910"/>
                <a:gd name="connsiteX11" fmla="*/ 274320 w 416560"/>
                <a:gd name="connsiteY11" fmla="*/ 91440 h 800910"/>
                <a:gd name="connsiteX12" fmla="*/ 213360 w 416560"/>
                <a:gd name="connsiteY12" fmla="*/ 101600 h 800910"/>
                <a:gd name="connsiteX13" fmla="*/ 172720 w 416560"/>
                <a:gd name="connsiteY13" fmla="*/ 101600 h 800910"/>
                <a:gd name="connsiteX14" fmla="*/ 111760 w 416560"/>
                <a:gd name="connsiteY14" fmla="*/ 81280 h 800910"/>
                <a:gd name="connsiteX15" fmla="*/ 111760 w 416560"/>
                <a:gd name="connsiteY15" fmla="*/ 81280 h 800910"/>
                <a:gd name="connsiteX16" fmla="*/ 0 w 416560"/>
                <a:gd name="connsiteY16" fmla="*/ 10160 h 800910"/>
                <a:gd name="connsiteX0" fmla="*/ 0 w 416560"/>
                <a:gd name="connsiteY0" fmla="*/ 10160 h 781454"/>
                <a:gd name="connsiteX1" fmla="*/ 0 w 416560"/>
                <a:gd name="connsiteY1" fmla="*/ 223520 h 781454"/>
                <a:gd name="connsiteX2" fmla="*/ 152400 w 416560"/>
                <a:gd name="connsiteY2" fmla="*/ 223520 h 781454"/>
                <a:gd name="connsiteX3" fmla="*/ 145915 w 416560"/>
                <a:gd name="connsiteY3" fmla="*/ 781454 h 781454"/>
                <a:gd name="connsiteX4" fmla="*/ 264160 w 416560"/>
                <a:gd name="connsiteY4" fmla="*/ 772160 h 781454"/>
                <a:gd name="connsiteX5" fmla="*/ 264160 w 416560"/>
                <a:gd name="connsiteY5" fmla="*/ 223520 h 781454"/>
                <a:gd name="connsiteX6" fmla="*/ 416560 w 416560"/>
                <a:gd name="connsiteY6" fmla="*/ 223520 h 781454"/>
                <a:gd name="connsiteX7" fmla="*/ 416560 w 416560"/>
                <a:gd name="connsiteY7" fmla="*/ 0 h 781454"/>
                <a:gd name="connsiteX8" fmla="*/ 386080 w 416560"/>
                <a:gd name="connsiteY8" fmla="*/ 30480 h 781454"/>
                <a:gd name="connsiteX9" fmla="*/ 375920 w 416560"/>
                <a:gd name="connsiteY9" fmla="*/ 40640 h 781454"/>
                <a:gd name="connsiteX10" fmla="*/ 325120 w 416560"/>
                <a:gd name="connsiteY10" fmla="*/ 60960 h 781454"/>
                <a:gd name="connsiteX11" fmla="*/ 274320 w 416560"/>
                <a:gd name="connsiteY11" fmla="*/ 91440 h 781454"/>
                <a:gd name="connsiteX12" fmla="*/ 213360 w 416560"/>
                <a:gd name="connsiteY12" fmla="*/ 101600 h 781454"/>
                <a:gd name="connsiteX13" fmla="*/ 172720 w 416560"/>
                <a:gd name="connsiteY13" fmla="*/ 101600 h 781454"/>
                <a:gd name="connsiteX14" fmla="*/ 111760 w 416560"/>
                <a:gd name="connsiteY14" fmla="*/ 81280 h 781454"/>
                <a:gd name="connsiteX15" fmla="*/ 111760 w 416560"/>
                <a:gd name="connsiteY15" fmla="*/ 81280 h 781454"/>
                <a:gd name="connsiteX16" fmla="*/ 0 w 416560"/>
                <a:gd name="connsiteY16" fmla="*/ 10160 h 781454"/>
                <a:gd name="connsiteX0" fmla="*/ 0 w 416560"/>
                <a:gd name="connsiteY0" fmla="*/ 10160 h 772160"/>
                <a:gd name="connsiteX1" fmla="*/ 0 w 416560"/>
                <a:gd name="connsiteY1" fmla="*/ 223520 h 772160"/>
                <a:gd name="connsiteX2" fmla="*/ 152400 w 416560"/>
                <a:gd name="connsiteY2" fmla="*/ 223520 h 772160"/>
                <a:gd name="connsiteX3" fmla="*/ 145915 w 416560"/>
                <a:gd name="connsiteY3" fmla="*/ 768484 h 772160"/>
                <a:gd name="connsiteX4" fmla="*/ 264160 w 416560"/>
                <a:gd name="connsiteY4" fmla="*/ 772160 h 772160"/>
                <a:gd name="connsiteX5" fmla="*/ 264160 w 416560"/>
                <a:gd name="connsiteY5" fmla="*/ 223520 h 772160"/>
                <a:gd name="connsiteX6" fmla="*/ 416560 w 416560"/>
                <a:gd name="connsiteY6" fmla="*/ 223520 h 772160"/>
                <a:gd name="connsiteX7" fmla="*/ 416560 w 416560"/>
                <a:gd name="connsiteY7" fmla="*/ 0 h 772160"/>
                <a:gd name="connsiteX8" fmla="*/ 386080 w 416560"/>
                <a:gd name="connsiteY8" fmla="*/ 30480 h 772160"/>
                <a:gd name="connsiteX9" fmla="*/ 375920 w 416560"/>
                <a:gd name="connsiteY9" fmla="*/ 40640 h 772160"/>
                <a:gd name="connsiteX10" fmla="*/ 325120 w 416560"/>
                <a:gd name="connsiteY10" fmla="*/ 60960 h 772160"/>
                <a:gd name="connsiteX11" fmla="*/ 274320 w 416560"/>
                <a:gd name="connsiteY11" fmla="*/ 91440 h 772160"/>
                <a:gd name="connsiteX12" fmla="*/ 213360 w 416560"/>
                <a:gd name="connsiteY12" fmla="*/ 101600 h 772160"/>
                <a:gd name="connsiteX13" fmla="*/ 172720 w 416560"/>
                <a:gd name="connsiteY13" fmla="*/ 101600 h 772160"/>
                <a:gd name="connsiteX14" fmla="*/ 111760 w 416560"/>
                <a:gd name="connsiteY14" fmla="*/ 81280 h 772160"/>
                <a:gd name="connsiteX15" fmla="*/ 111760 w 416560"/>
                <a:gd name="connsiteY15" fmla="*/ 81280 h 772160"/>
                <a:gd name="connsiteX16" fmla="*/ 0 w 416560"/>
                <a:gd name="connsiteY16" fmla="*/ 10160 h 772160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25120 w 416560"/>
                <a:gd name="connsiteY10" fmla="*/ 60960 h 768484"/>
                <a:gd name="connsiteX11" fmla="*/ 274320 w 416560"/>
                <a:gd name="connsiteY11" fmla="*/ 91440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25120 w 416560"/>
                <a:gd name="connsiteY10" fmla="*/ 6096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31605 w 416560"/>
                <a:gd name="connsiteY10" fmla="*/ 6096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4576 w 416560"/>
                <a:gd name="connsiteY10" fmla="*/ 80416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0926 w 416560"/>
                <a:gd name="connsiteY10" fmla="*/ 76765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0926 w 416560"/>
                <a:gd name="connsiteY10" fmla="*/ 7494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0926 w 416560"/>
                <a:gd name="connsiteY10" fmla="*/ 7494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416560" h="768484">
                  <a:moveTo>
                    <a:pt x="0" y="10160"/>
                  </a:moveTo>
                  <a:lnTo>
                    <a:pt x="0" y="223520"/>
                  </a:lnTo>
                  <a:lnTo>
                    <a:pt x="152400" y="223520"/>
                  </a:lnTo>
                  <a:cubicBezTo>
                    <a:pt x="150238" y="409498"/>
                    <a:pt x="148077" y="582506"/>
                    <a:pt x="145915" y="768484"/>
                  </a:cubicBezTo>
                  <a:lnTo>
                    <a:pt x="264160" y="765675"/>
                  </a:lnTo>
                  <a:lnTo>
                    <a:pt x="264160" y="223520"/>
                  </a:lnTo>
                  <a:lnTo>
                    <a:pt x="416560" y="223520"/>
                  </a:lnTo>
                  <a:lnTo>
                    <a:pt x="416560" y="0"/>
                  </a:lnTo>
                  <a:lnTo>
                    <a:pt x="386080" y="30480"/>
                  </a:lnTo>
                  <a:lnTo>
                    <a:pt x="375920" y="40640"/>
                  </a:lnTo>
                  <a:lnTo>
                    <a:pt x="340926" y="74940"/>
                  </a:lnTo>
                  <a:cubicBezTo>
                    <a:pt x="320886" y="84427"/>
                    <a:pt x="300845" y="90264"/>
                    <a:pt x="280805" y="97926"/>
                  </a:cubicBezTo>
                  <a:lnTo>
                    <a:pt x="213360" y="101600"/>
                  </a:lnTo>
                  <a:lnTo>
                    <a:pt x="172720" y="101600"/>
                  </a:lnTo>
                  <a:lnTo>
                    <a:pt x="111760" y="81280"/>
                  </a:lnTo>
                  <a:lnTo>
                    <a:pt x="111760" y="81280"/>
                  </a:lnTo>
                  <a:lnTo>
                    <a:pt x="0" y="10160"/>
                  </a:lnTo>
                  <a:close/>
                </a:path>
              </a:pathLst>
            </a:custGeom>
            <a:solidFill>
              <a:schemeClr val="accent5"/>
            </a:solidFill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标题 1">
              <a:extLst>
                <a:ext uri="{FF2B5EF4-FFF2-40B4-BE49-F238E27FC236}">
                  <a16:creationId xmlns:a16="http://schemas.microsoft.com/office/drawing/2014/main" id="{64C90864-8C5A-4E8C-A896-A6F7439AD10D}"/>
                </a:ext>
              </a:extLst>
            </p:cNvPr>
            <p:cNvSpPr txBox="1">
              <a:spLocks/>
            </p:cNvSpPr>
            <p:nvPr/>
          </p:nvSpPr>
          <p:spPr>
            <a:xfrm>
              <a:off x="1085056" y="8171370"/>
              <a:ext cx="1822708" cy="264404"/>
            </a:xfrm>
            <a:prstGeom prst="rect">
              <a:avLst/>
            </a:prstGeom>
          </p:spPr>
          <p:txBody>
            <a:bodyPr vert="horz" lIns="91440" tIns="45720" rIns="91440" bIns="45720" rtlCol="0" anchor="t">
              <a:noAutofit/>
            </a:bodyPr>
            <a:lstStyle>
              <a:lvl1pPr algn="l" defTabSz="457200" rtl="0" eaLnBrk="1" latinLnBrk="0" hangingPunct="1">
                <a:spcBef>
                  <a:spcPct val="0"/>
                </a:spcBef>
                <a:buNone/>
                <a:defRPr sz="3600" b="1" kern="1200">
                  <a:solidFill>
                    <a:schemeClr val="tx1">
                      <a:lumMod val="85000"/>
                      <a:lumOff val="15000"/>
                    </a:schemeClr>
                  </a:solidFill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defRPr>
              </a:lvl1pPr>
              <a:lvl2pPr eaLnBrk="1" hangingPunct="1">
                <a:defRPr>
                  <a:solidFill>
                    <a:schemeClr val="tx2"/>
                  </a:solidFill>
                </a:defRPr>
              </a:lvl2pPr>
              <a:lvl3pPr eaLnBrk="1" hangingPunct="1">
                <a:defRPr>
                  <a:solidFill>
                    <a:schemeClr val="tx2"/>
                  </a:solidFill>
                </a:defRPr>
              </a:lvl3pPr>
              <a:lvl4pPr eaLnBrk="1" hangingPunct="1">
                <a:defRPr>
                  <a:solidFill>
                    <a:schemeClr val="tx2"/>
                  </a:solidFill>
                </a:defRPr>
              </a:lvl4pPr>
              <a:lvl5pPr eaLnBrk="1" hangingPunct="1">
                <a:defRPr>
                  <a:solidFill>
                    <a:schemeClr val="tx2"/>
                  </a:solidFill>
                </a:defRPr>
              </a:lvl5pPr>
              <a:lvl6pPr eaLnBrk="1" hangingPunct="1">
                <a:defRPr>
                  <a:solidFill>
                    <a:schemeClr val="tx2"/>
                  </a:solidFill>
                </a:defRPr>
              </a:lvl6pPr>
              <a:lvl7pPr eaLnBrk="1" hangingPunct="1">
                <a:defRPr>
                  <a:solidFill>
                    <a:schemeClr val="tx2"/>
                  </a:solidFill>
                </a:defRPr>
              </a:lvl7pPr>
              <a:lvl8pPr eaLnBrk="1" hangingPunct="1">
                <a:defRPr>
                  <a:solidFill>
                    <a:schemeClr val="tx2"/>
                  </a:solidFill>
                </a:defRPr>
              </a:lvl8pPr>
              <a:lvl9pPr eaLnBrk="1" hangingPunct="1">
                <a:defRPr>
                  <a:solidFill>
                    <a:schemeClr val="tx2"/>
                  </a:solidFill>
                </a:defRPr>
              </a:lvl9pPr>
            </a:lstStyle>
            <a:p>
              <a:r>
                <a:rPr lang="en-US" altLang="zh-CN" sz="14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hagocytosis</a:t>
              </a:r>
              <a:endParaRPr lang="zh-CN" altLang="en-US" sz="140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标题 1">
              <a:extLst>
                <a:ext uri="{FF2B5EF4-FFF2-40B4-BE49-F238E27FC236}">
                  <a16:creationId xmlns:a16="http://schemas.microsoft.com/office/drawing/2014/main" id="{383D5CA6-3EA1-4524-A7BA-867922638541}"/>
                </a:ext>
              </a:extLst>
            </p:cNvPr>
            <p:cNvSpPr txBox="1">
              <a:spLocks/>
            </p:cNvSpPr>
            <p:nvPr/>
          </p:nvSpPr>
          <p:spPr>
            <a:xfrm>
              <a:off x="3991582" y="6800877"/>
              <a:ext cx="1379265" cy="253782"/>
            </a:xfrm>
            <a:prstGeom prst="rect">
              <a:avLst/>
            </a:prstGeom>
          </p:spPr>
          <p:txBody>
            <a:bodyPr vert="horz" lIns="91440" tIns="45720" rIns="91440" bIns="45720" rtlCol="0" anchor="t">
              <a:noAutofit/>
            </a:bodyPr>
            <a:lstStyle>
              <a:lvl1pPr algn="l" defTabSz="457200" rtl="0" eaLnBrk="1" latinLnBrk="0" hangingPunct="1">
                <a:spcBef>
                  <a:spcPct val="0"/>
                </a:spcBef>
                <a:buNone/>
                <a:defRPr sz="3600" b="1" kern="1200">
                  <a:solidFill>
                    <a:schemeClr val="tx1">
                      <a:lumMod val="85000"/>
                      <a:lumOff val="15000"/>
                    </a:schemeClr>
                  </a:solidFill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defRPr>
              </a:lvl1pPr>
              <a:lvl2pPr eaLnBrk="1" hangingPunct="1">
                <a:defRPr>
                  <a:solidFill>
                    <a:schemeClr val="tx2"/>
                  </a:solidFill>
                </a:defRPr>
              </a:lvl2pPr>
              <a:lvl3pPr eaLnBrk="1" hangingPunct="1">
                <a:defRPr>
                  <a:solidFill>
                    <a:schemeClr val="tx2"/>
                  </a:solidFill>
                </a:defRPr>
              </a:lvl3pPr>
              <a:lvl4pPr eaLnBrk="1" hangingPunct="1">
                <a:defRPr>
                  <a:solidFill>
                    <a:schemeClr val="tx2"/>
                  </a:solidFill>
                </a:defRPr>
              </a:lvl4pPr>
              <a:lvl5pPr eaLnBrk="1" hangingPunct="1">
                <a:defRPr>
                  <a:solidFill>
                    <a:schemeClr val="tx2"/>
                  </a:solidFill>
                </a:defRPr>
              </a:lvl5pPr>
              <a:lvl6pPr eaLnBrk="1" hangingPunct="1">
                <a:defRPr>
                  <a:solidFill>
                    <a:schemeClr val="tx2"/>
                  </a:solidFill>
                </a:defRPr>
              </a:lvl6pPr>
              <a:lvl7pPr eaLnBrk="1" hangingPunct="1">
                <a:defRPr>
                  <a:solidFill>
                    <a:schemeClr val="tx2"/>
                  </a:solidFill>
                </a:defRPr>
              </a:lvl7pPr>
              <a:lvl8pPr eaLnBrk="1" hangingPunct="1">
                <a:defRPr>
                  <a:solidFill>
                    <a:schemeClr val="tx2"/>
                  </a:solidFill>
                </a:defRPr>
              </a:lvl8pPr>
              <a:lvl9pPr eaLnBrk="1" hangingPunct="1">
                <a:defRPr>
                  <a:solidFill>
                    <a:schemeClr val="tx2"/>
                  </a:solidFill>
                </a:defRPr>
              </a:lvl9pPr>
            </a:lstStyle>
            <a:p>
              <a:r>
                <a:rPr lang="en-US" altLang="zh-CN" sz="12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eptor-Ligand</a:t>
              </a:r>
              <a:endParaRPr lang="zh-CN" altLang="en-US" sz="120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椭圆 139">
              <a:extLst>
                <a:ext uri="{FF2B5EF4-FFF2-40B4-BE49-F238E27FC236}">
                  <a16:creationId xmlns:a16="http://schemas.microsoft.com/office/drawing/2014/main" id="{2DAF632D-3BE7-4B28-9430-56238BB93359}"/>
                </a:ext>
              </a:extLst>
            </p:cNvPr>
            <p:cNvSpPr/>
            <p:nvPr/>
          </p:nvSpPr>
          <p:spPr>
            <a:xfrm rot="5400000">
              <a:off x="4951242" y="7459515"/>
              <a:ext cx="156171" cy="145185"/>
            </a:xfrm>
            <a:prstGeom prst="ellipse">
              <a:avLst/>
            </a:prstGeom>
            <a:gradFill flip="none" rotWithShape="1">
              <a:gsLst>
                <a:gs pos="28000">
                  <a:schemeClr val="accent5">
                    <a:lumMod val="5000"/>
                    <a:lumOff val="95000"/>
                  </a:schemeClr>
                </a:gs>
                <a:gs pos="99000">
                  <a:schemeClr val="accent5">
                    <a:lumMod val="45000"/>
                    <a:lumOff val="55000"/>
                  </a:schemeClr>
                </a:gs>
                <a:gs pos="78000">
                  <a:schemeClr val="accent5">
                    <a:lumMod val="45000"/>
                    <a:lumOff val="55000"/>
                  </a:schemeClr>
                </a:gs>
                <a:gs pos="100000">
                  <a:schemeClr val="accent5">
                    <a:lumMod val="30000"/>
                    <a:lumOff val="70000"/>
                  </a:schemeClr>
                </a:gs>
              </a:gsLst>
              <a:lin ang="5400000" scaled="1"/>
              <a:tileRect/>
            </a:gradFill>
            <a:ln w="95250" cmpd="dbl">
              <a:solidFill>
                <a:schemeClr val="accent5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1" name="标题 1">
            <a:extLst>
              <a:ext uri="{FF2B5EF4-FFF2-40B4-BE49-F238E27FC236}">
                <a16:creationId xmlns:a16="http://schemas.microsoft.com/office/drawing/2014/main" id="{5F41ECC0-81A7-49C8-8049-12A26D47BF43}"/>
              </a:ext>
            </a:extLst>
          </p:cNvPr>
          <p:cNvSpPr txBox="1">
            <a:spLocks/>
          </p:cNvSpPr>
          <p:nvPr/>
        </p:nvSpPr>
        <p:spPr>
          <a:xfrm>
            <a:off x="8154530" y="4159243"/>
            <a:ext cx="876549" cy="17182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sion</a:t>
            </a:r>
            <a:endParaRPr lang="zh-CN" altLang="en-US" sz="120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直接连接符 141">
            <a:extLst>
              <a:ext uri="{FF2B5EF4-FFF2-40B4-BE49-F238E27FC236}">
                <a16:creationId xmlns:a16="http://schemas.microsoft.com/office/drawing/2014/main" id="{6136DD3E-185A-4BC0-B4DC-33BD0EB11C24}"/>
              </a:ext>
            </a:extLst>
          </p:cNvPr>
          <p:cNvCxnSpPr>
            <a:cxnSpLocks/>
          </p:cNvCxnSpPr>
          <p:nvPr/>
        </p:nvCxnSpPr>
        <p:spPr>
          <a:xfrm>
            <a:off x="6413655" y="3294681"/>
            <a:ext cx="503573" cy="54421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接连接符 142">
            <a:extLst>
              <a:ext uri="{FF2B5EF4-FFF2-40B4-BE49-F238E27FC236}">
                <a16:creationId xmlns:a16="http://schemas.microsoft.com/office/drawing/2014/main" id="{97EE28DB-4C30-4EC6-A5EA-3C145A537534}"/>
              </a:ext>
            </a:extLst>
          </p:cNvPr>
          <p:cNvCxnSpPr>
            <a:cxnSpLocks/>
          </p:cNvCxnSpPr>
          <p:nvPr/>
        </p:nvCxnSpPr>
        <p:spPr>
          <a:xfrm flipH="1">
            <a:off x="7109764" y="3355689"/>
            <a:ext cx="675208" cy="495168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菱形 180">
            <a:extLst>
              <a:ext uri="{FF2B5EF4-FFF2-40B4-BE49-F238E27FC236}">
                <a16:creationId xmlns:a16="http://schemas.microsoft.com/office/drawing/2014/main" id="{7BD4B34F-43D3-4C8E-B04F-5330E93E3544}"/>
              </a:ext>
            </a:extLst>
          </p:cNvPr>
          <p:cNvSpPr/>
          <p:nvPr/>
        </p:nvSpPr>
        <p:spPr>
          <a:xfrm>
            <a:off x="7534898" y="4971380"/>
            <a:ext cx="68567" cy="88168"/>
          </a:xfrm>
          <a:prstGeom prst="diamond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等腰三角形 181">
            <a:extLst>
              <a:ext uri="{FF2B5EF4-FFF2-40B4-BE49-F238E27FC236}">
                <a16:creationId xmlns:a16="http://schemas.microsoft.com/office/drawing/2014/main" id="{8545AF5C-DB68-4C3A-8171-F6393AF243C1}"/>
              </a:ext>
            </a:extLst>
          </p:cNvPr>
          <p:cNvSpPr/>
          <p:nvPr/>
        </p:nvSpPr>
        <p:spPr>
          <a:xfrm>
            <a:off x="7885656" y="4917265"/>
            <a:ext cx="42342" cy="74604"/>
          </a:xfrm>
          <a:prstGeom prst="triangle">
            <a:avLst/>
          </a:prstGeom>
          <a:solidFill>
            <a:srgbClr val="92D050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2" name="组合 191">
            <a:extLst>
              <a:ext uri="{FF2B5EF4-FFF2-40B4-BE49-F238E27FC236}">
                <a16:creationId xmlns:a16="http://schemas.microsoft.com/office/drawing/2014/main" id="{C9C5AB9A-7BED-4E80-A544-5249AB910FB9}"/>
              </a:ext>
            </a:extLst>
          </p:cNvPr>
          <p:cNvGrpSpPr/>
          <p:nvPr/>
        </p:nvGrpSpPr>
        <p:grpSpPr>
          <a:xfrm>
            <a:off x="7004250" y="2323018"/>
            <a:ext cx="931947" cy="233620"/>
            <a:chOff x="5969501" y="4126288"/>
            <a:chExt cx="1102699" cy="300116"/>
          </a:xfrm>
        </p:grpSpPr>
        <p:sp>
          <p:nvSpPr>
            <p:cNvPr id="193" name="标题 1">
              <a:extLst>
                <a:ext uri="{FF2B5EF4-FFF2-40B4-BE49-F238E27FC236}">
                  <a16:creationId xmlns:a16="http://schemas.microsoft.com/office/drawing/2014/main" id="{D4D32B80-4491-4963-B71A-3AC9E7034DD0}"/>
                </a:ext>
              </a:extLst>
            </p:cNvPr>
            <p:cNvSpPr txBox="1">
              <a:spLocks/>
            </p:cNvSpPr>
            <p:nvPr/>
          </p:nvSpPr>
          <p:spPr>
            <a:xfrm>
              <a:off x="6087334" y="4154459"/>
              <a:ext cx="984866" cy="271945"/>
            </a:xfrm>
            <a:prstGeom prst="rect">
              <a:avLst/>
            </a:prstGeom>
          </p:spPr>
          <p:txBody>
            <a:bodyPr vert="horz" lIns="91440" tIns="45720" rIns="91440" bIns="45720" rtlCol="0" anchor="t">
              <a:noAutofit/>
            </a:bodyPr>
            <a:lstStyle>
              <a:lvl1pPr algn="l" defTabSz="457200" rtl="0" eaLnBrk="1" latinLnBrk="0" hangingPunct="1">
                <a:spcBef>
                  <a:spcPct val="0"/>
                </a:spcBef>
                <a:buNone/>
                <a:defRPr sz="3600" b="1" kern="1200">
                  <a:solidFill>
                    <a:schemeClr val="tx1">
                      <a:lumMod val="85000"/>
                      <a:lumOff val="15000"/>
                    </a:schemeClr>
                  </a:solidFill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defRPr>
              </a:lvl1pPr>
              <a:lvl2pPr eaLnBrk="1" hangingPunct="1">
                <a:defRPr>
                  <a:solidFill>
                    <a:schemeClr val="tx2"/>
                  </a:solidFill>
                </a:defRPr>
              </a:lvl2pPr>
              <a:lvl3pPr eaLnBrk="1" hangingPunct="1">
                <a:defRPr>
                  <a:solidFill>
                    <a:schemeClr val="tx2"/>
                  </a:solidFill>
                </a:defRPr>
              </a:lvl3pPr>
              <a:lvl4pPr eaLnBrk="1" hangingPunct="1">
                <a:defRPr>
                  <a:solidFill>
                    <a:schemeClr val="tx2"/>
                  </a:solidFill>
                </a:defRPr>
              </a:lvl4pPr>
              <a:lvl5pPr eaLnBrk="1" hangingPunct="1">
                <a:defRPr>
                  <a:solidFill>
                    <a:schemeClr val="tx2"/>
                  </a:solidFill>
                </a:defRPr>
              </a:lvl5pPr>
              <a:lvl6pPr eaLnBrk="1" hangingPunct="1">
                <a:defRPr>
                  <a:solidFill>
                    <a:schemeClr val="tx2"/>
                  </a:solidFill>
                </a:defRPr>
              </a:lvl6pPr>
              <a:lvl7pPr eaLnBrk="1" hangingPunct="1">
                <a:defRPr>
                  <a:solidFill>
                    <a:schemeClr val="tx2"/>
                  </a:solidFill>
                </a:defRPr>
              </a:lvl7pPr>
              <a:lvl8pPr eaLnBrk="1" hangingPunct="1">
                <a:defRPr>
                  <a:solidFill>
                    <a:schemeClr val="tx2"/>
                  </a:solidFill>
                </a:defRPr>
              </a:lvl8pPr>
              <a:lvl9pPr eaLnBrk="1" hangingPunct="1">
                <a:defRPr>
                  <a:solidFill>
                    <a:schemeClr val="tx2"/>
                  </a:solidFill>
                </a:defRPr>
              </a:lvl9pPr>
            </a:lstStyle>
            <a:p>
              <a:r>
                <a:rPr lang="en-US" altLang="zh-CN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-LO</a:t>
              </a:r>
              <a:endParaRPr lang="zh-CN" altLang="en-US" sz="12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椭圆 193">
              <a:extLst>
                <a:ext uri="{FF2B5EF4-FFF2-40B4-BE49-F238E27FC236}">
                  <a16:creationId xmlns:a16="http://schemas.microsoft.com/office/drawing/2014/main" id="{22D5E8E6-4699-481D-B852-0100152BD0AB}"/>
                </a:ext>
              </a:extLst>
            </p:cNvPr>
            <p:cNvSpPr/>
            <p:nvPr/>
          </p:nvSpPr>
          <p:spPr>
            <a:xfrm>
              <a:off x="6028773" y="4126288"/>
              <a:ext cx="45894" cy="45719"/>
            </a:xfrm>
            <a:prstGeom prst="ellipse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椭圆 194">
              <a:extLst>
                <a:ext uri="{FF2B5EF4-FFF2-40B4-BE49-F238E27FC236}">
                  <a16:creationId xmlns:a16="http://schemas.microsoft.com/office/drawing/2014/main" id="{B77214D9-A9A6-48F4-A864-1C9D9EC1EB44}"/>
                </a:ext>
              </a:extLst>
            </p:cNvPr>
            <p:cNvSpPr/>
            <p:nvPr/>
          </p:nvSpPr>
          <p:spPr>
            <a:xfrm>
              <a:off x="6062637" y="4202485"/>
              <a:ext cx="45894" cy="45719"/>
            </a:xfrm>
            <a:prstGeom prst="ellipse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椭圆 195">
              <a:extLst>
                <a:ext uri="{FF2B5EF4-FFF2-40B4-BE49-F238E27FC236}">
                  <a16:creationId xmlns:a16="http://schemas.microsoft.com/office/drawing/2014/main" id="{CF1BF67B-4150-42A5-A0EB-EE3015CEA235}"/>
                </a:ext>
              </a:extLst>
            </p:cNvPr>
            <p:cNvSpPr/>
            <p:nvPr/>
          </p:nvSpPr>
          <p:spPr>
            <a:xfrm>
              <a:off x="5969501" y="4194017"/>
              <a:ext cx="45894" cy="45719"/>
            </a:xfrm>
            <a:prstGeom prst="ellipse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7" name="文本框 196">
            <a:extLst>
              <a:ext uri="{FF2B5EF4-FFF2-40B4-BE49-F238E27FC236}">
                <a16:creationId xmlns:a16="http://schemas.microsoft.com/office/drawing/2014/main" id="{A374AA3B-E91E-4645-AADD-01BEE3F227AE}"/>
              </a:ext>
            </a:extLst>
          </p:cNvPr>
          <p:cNvSpPr txBox="1"/>
          <p:nvPr/>
        </p:nvSpPr>
        <p:spPr>
          <a:xfrm>
            <a:off x="5956610" y="849280"/>
            <a:ext cx="26081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E.coli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xtracellular Vesicles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椭圆 305">
            <a:extLst>
              <a:ext uri="{FF2B5EF4-FFF2-40B4-BE49-F238E27FC236}">
                <a16:creationId xmlns:a16="http://schemas.microsoft.com/office/drawing/2014/main" id="{3C1B4D46-D610-4911-995C-D506B0313D46}"/>
              </a:ext>
            </a:extLst>
          </p:cNvPr>
          <p:cNvSpPr/>
          <p:nvPr/>
        </p:nvSpPr>
        <p:spPr>
          <a:xfrm>
            <a:off x="8219418" y="4772564"/>
            <a:ext cx="102829" cy="99403"/>
          </a:xfrm>
          <a:prstGeom prst="ellipse">
            <a:avLst/>
          </a:prstGeom>
          <a:solidFill>
            <a:schemeClr val="bg2">
              <a:lumMod val="9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9" name="组合 308">
            <a:extLst>
              <a:ext uri="{FF2B5EF4-FFF2-40B4-BE49-F238E27FC236}">
                <a16:creationId xmlns:a16="http://schemas.microsoft.com/office/drawing/2014/main" id="{48C9CDC0-0E57-4944-A64C-078760BCFE4F}"/>
              </a:ext>
            </a:extLst>
          </p:cNvPr>
          <p:cNvGrpSpPr/>
          <p:nvPr/>
        </p:nvGrpSpPr>
        <p:grpSpPr>
          <a:xfrm>
            <a:off x="8357352" y="4701294"/>
            <a:ext cx="190810" cy="233303"/>
            <a:chOff x="6845882" y="7064319"/>
            <a:chExt cx="225771" cy="299708"/>
          </a:xfrm>
        </p:grpSpPr>
        <p:sp>
          <p:nvSpPr>
            <p:cNvPr id="307" name="椭圆 306">
              <a:extLst>
                <a:ext uri="{FF2B5EF4-FFF2-40B4-BE49-F238E27FC236}">
                  <a16:creationId xmlns:a16="http://schemas.microsoft.com/office/drawing/2014/main" id="{ED67DF45-B57C-4A79-9374-C8FCDEC5AB2C}"/>
                </a:ext>
              </a:extLst>
            </p:cNvPr>
            <p:cNvSpPr/>
            <p:nvPr/>
          </p:nvSpPr>
          <p:spPr>
            <a:xfrm>
              <a:off x="6845882" y="7064319"/>
              <a:ext cx="121670" cy="127696"/>
            </a:xfrm>
            <a:prstGeom prst="ellipse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椭圆 307">
              <a:extLst>
                <a:ext uri="{FF2B5EF4-FFF2-40B4-BE49-F238E27FC236}">
                  <a16:creationId xmlns:a16="http://schemas.microsoft.com/office/drawing/2014/main" id="{D27E0AB5-BBC5-4410-816E-3E0D6D0392D6}"/>
                </a:ext>
              </a:extLst>
            </p:cNvPr>
            <p:cNvSpPr/>
            <p:nvPr/>
          </p:nvSpPr>
          <p:spPr>
            <a:xfrm>
              <a:off x="6949983" y="7236331"/>
              <a:ext cx="121670" cy="127696"/>
            </a:xfrm>
            <a:prstGeom prst="ellipse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0" name="标题 1">
            <a:extLst>
              <a:ext uri="{FF2B5EF4-FFF2-40B4-BE49-F238E27FC236}">
                <a16:creationId xmlns:a16="http://schemas.microsoft.com/office/drawing/2014/main" id="{977ECCF2-12A0-4CA1-ABCA-FA47D243B23D}"/>
              </a:ext>
            </a:extLst>
          </p:cNvPr>
          <p:cNvSpPr txBox="1">
            <a:spLocks/>
          </p:cNvSpPr>
          <p:nvPr/>
        </p:nvSpPr>
        <p:spPr>
          <a:xfrm>
            <a:off x="8224121" y="4919264"/>
            <a:ext cx="876549" cy="17182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en-US" altLang="zh-CN" sz="14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altLang="zh-CN" sz="14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40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8" name="直接箭头连接符 317">
            <a:extLst>
              <a:ext uri="{FF2B5EF4-FFF2-40B4-BE49-F238E27FC236}">
                <a16:creationId xmlns:a16="http://schemas.microsoft.com/office/drawing/2014/main" id="{CD38FA59-7662-417E-A6A9-D98B03629F29}"/>
              </a:ext>
            </a:extLst>
          </p:cNvPr>
          <p:cNvCxnSpPr>
            <a:cxnSpLocks/>
          </p:cNvCxnSpPr>
          <p:nvPr/>
        </p:nvCxnSpPr>
        <p:spPr>
          <a:xfrm flipH="1">
            <a:off x="7376472" y="1700696"/>
            <a:ext cx="352056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9" name="文本框 318">
            <a:extLst>
              <a:ext uri="{FF2B5EF4-FFF2-40B4-BE49-F238E27FC236}">
                <a16:creationId xmlns:a16="http://schemas.microsoft.com/office/drawing/2014/main" id="{582CCFB8-F164-45B7-A433-5C80C6D6B553}"/>
              </a:ext>
            </a:extLst>
          </p:cNvPr>
          <p:cNvSpPr txBox="1"/>
          <p:nvPr/>
        </p:nvSpPr>
        <p:spPr>
          <a:xfrm>
            <a:off x="7717331" y="1615192"/>
            <a:ext cx="533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tx2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AA</a:t>
            </a:r>
            <a:endParaRPr lang="zh-CN" altLang="en-US" sz="1400" b="1">
              <a:solidFill>
                <a:schemeClr val="tx2"/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20" name="文本框 319">
            <a:extLst>
              <a:ext uri="{FF2B5EF4-FFF2-40B4-BE49-F238E27FC236}">
                <a16:creationId xmlns:a16="http://schemas.microsoft.com/office/drawing/2014/main" id="{C660897B-93F3-4391-9E6D-79965F7264D1}"/>
              </a:ext>
            </a:extLst>
          </p:cNvPr>
          <p:cNvSpPr txBox="1"/>
          <p:nvPr/>
        </p:nvSpPr>
        <p:spPr>
          <a:xfrm>
            <a:off x="7438178" y="1416279"/>
            <a:ext cx="7602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5-LO</a:t>
            </a:r>
            <a:endParaRPr lang="zh-CN" altLang="en-US" sz="1200" b="1">
              <a:solidFill>
                <a:srgbClr val="FF0000"/>
              </a:solidFill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7C7A185C-38BC-6040-A961-746D5E9AB70D}"/>
              </a:ext>
            </a:extLst>
          </p:cNvPr>
          <p:cNvSpPr txBox="1"/>
          <p:nvPr/>
        </p:nvSpPr>
        <p:spPr>
          <a:xfrm>
            <a:off x="2696181" y="1949577"/>
            <a:ext cx="3021982" cy="15286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etreatment of EV with LPS and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RP1 inhibitor will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⇑ Bacterial Phagocytosis</a:t>
            </a:r>
            <a:endParaRPr lang="en-US" sz="1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⇓ Decrease Inflammation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n target cell such 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s alveolar macrophages.</a:t>
            </a:r>
          </a:p>
          <a:p>
            <a:pPr algn="ctr"/>
            <a:endParaRPr lang="en-US" sz="14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7" name="直接箭头连接符 304">
            <a:extLst>
              <a:ext uri="{FF2B5EF4-FFF2-40B4-BE49-F238E27FC236}">
                <a16:creationId xmlns:a16="http://schemas.microsoft.com/office/drawing/2014/main" id="{5540444F-985D-2A4C-926A-472FCFA96B14}"/>
              </a:ext>
            </a:extLst>
          </p:cNvPr>
          <p:cNvCxnSpPr>
            <a:cxnSpLocks/>
          </p:cNvCxnSpPr>
          <p:nvPr/>
        </p:nvCxnSpPr>
        <p:spPr>
          <a:xfrm>
            <a:off x="8863908" y="4996965"/>
            <a:ext cx="0" cy="426864"/>
          </a:xfrm>
          <a:prstGeom prst="straightConnector1">
            <a:avLst/>
          </a:prstGeom>
          <a:ln w="635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8" name="直接箭头连接符 304">
            <a:extLst>
              <a:ext uri="{FF2B5EF4-FFF2-40B4-BE49-F238E27FC236}">
                <a16:creationId xmlns:a16="http://schemas.microsoft.com/office/drawing/2014/main" id="{A7DD8AAB-DBF3-E048-9450-187B2BB2E51F}"/>
              </a:ext>
            </a:extLst>
          </p:cNvPr>
          <p:cNvCxnSpPr>
            <a:cxnSpLocks/>
          </p:cNvCxnSpPr>
          <p:nvPr/>
        </p:nvCxnSpPr>
        <p:spPr>
          <a:xfrm flipV="1">
            <a:off x="4710091" y="4571195"/>
            <a:ext cx="0" cy="440143"/>
          </a:xfrm>
          <a:prstGeom prst="straightConnector1">
            <a:avLst/>
          </a:prstGeom>
          <a:ln w="635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4" name="组合 47">
            <a:extLst>
              <a:ext uri="{FF2B5EF4-FFF2-40B4-BE49-F238E27FC236}">
                <a16:creationId xmlns:a16="http://schemas.microsoft.com/office/drawing/2014/main" id="{68B4F3B2-F2CA-F845-B700-7BD7C1B4DE9F}"/>
              </a:ext>
            </a:extLst>
          </p:cNvPr>
          <p:cNvGrpSpPr/>
          <p:nvPr/>
        </p:nvGrpSpPr>
        <p:grpSpPr>
          <a:xfrm rot="2084863">
            <a:off x="8525657" y="1700886"/>
            <a:ext cx="192092" cy="325727"/>
            <a:chOff x="8557966" y="1422400"/>
            <a:chExt cx="216787" cy="650240"/>
          </a:xfrm>
        </p:grpSpPr>
        <p:cxnSp>
          <p:nvCxnSpPr>
            <p:cNvPr id="145" name="直接连接符 77">
              <a:extLst>
                <a:ext uri="{FF2B5EF4-FFF2-40B4-BE49-F238E27FC236}">
                  <a16:creationId xmlns:a16="http://schemas.microsoft.com/office/drawing/2014/main" id="{F9908EA6-9759-7447-B670-1C0385C5A8C8}"/>
                </a:ext>
              </a:extLst>
            </p:cNvPr>
            <p:cNvCxnSpPr/>
            <p:nvPr/>
          </p:nvCxnSpPr>
          <p:spPr>
            <a:xfrm>
              <a:off x="8657101" y="1422400"/>
              <a:ext cx="0" cy="64008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直接连接符 78">
              <a:extLst>
                <a:ext uri="{FF2B5EF4-FFF2-40B4-BE49-F238E27FC236}">
                  <a16:creationId xmlns:a16="http://schemas.microsoft.com/office/drawing/2014/main" id="{6B5E41F7-A1C3-D94A-9BEF-B56CEBB5F0AB}"/>
                </a:ext>
              </a:extLst>
            </p:cNvPr>
            <p:cNvCxnSpPr/>
            <p:nvPr/>
          </p:nvCxnSpPr>
          <p:spPr>
            <a:xfrm>
              <a:off x="8557966" y="2072640"/>
              <a:ext cx="216787" cy="0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7" name="标题 1">
            <a:extLst>
              <a:ext uri="{FF2B5EF4-FFF2-40B4-BE49-F238E27FC236}">
                <a16:creationId xmlns:a16="http://schemas.microsoft.com/office/drawing/2014/main" id="{ED57F10A-4F72-3546-A9D1-CE098403F4B5}"/>
              </a:ext>
            </a:extLst>
          </p:cNvPr>
          <p:cNvSpPr txBox="1">
            <a:spLocks/>
          </p:cNvSpPr>
          <p:nvPr/>
        </p:nvSpPr>
        <p:spPr>
          <a:xfrm>
            <a:off x="8558747" y="1406101"/>
            <a:ext cx="1003311" cy="22162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pPr algn="ctr"/>
            <a:r>
              <a:rPr lang="en-US" altLang="zh-CN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versan</a:t>
            </a:r>
          </a:p>
          <a:p>
            <a:pPr algn="ctr"/>
            <a:endParaRPr lang="zh-CN" altLang="en-US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2E20374-108C-164D-BC67-B406BFFBD502}"/>
              </a:ext>
            </a:extLst>
          </p:cNvPr>
          <p:cNvGrpSpPr/>
          <p:nvPr/>
        </p:nvGrpSpPr>
        <p:grpSpPr>
          <a:xfrm>
            <a:off x="5363643" y="1448998"/>
            <a:ext cx="1430521" cy="482576"/>
            <a:chOff x="10015161" y="1833314"/>
            <a:chExt cx="1430521" cy="482576"/>
          </a:xfrm>
        </p:grpSpPr>
        <p:sp>
          <p:nvSpPr>
            <p:cNvPr id="148" name="任意多边形: 形状 61">
              <a:extLst>
                <a:ext uri="{FF2B5EF4-FFF2-40B4-BE49-F238E27FC236}">
                  <a16:creationId xmlns:a16="http://schemas.microsoft.com/office/drawing/2014/main" id="{9F899F20-30EE-D54B-8881-820B1C1CE10C}"/>
                </a:ext>
              </a:extLst>
            </p:cNvPr>
            <p:cNvSpPr/>
            <p:nvPr/>
          </p:nvSpPr>
          <p:spPr>
            <a:xfrm rot="18267497">
              <a:off x="10680096" y="2163254"/>
              <a:ext cx="96855" cy="208418"/>
            </a:xfrm>
            <a:custGeom>
              <a:avLst/>
              <a:gdLst>
                <a:gd name="connsiteX0" fmla="*/ 0 w 416560"/>
                <a:gd name="connsiteY0" fmla="*/ 10160 h 762000"/>
                <a:gd name="connsiteX1" fmla="*/ 0 w 416560"/>
                <a:gd name="connsiteY1" fmla="*/ 223520 h 762000"/>
                <a:gd name="connsiteX2" fmla="*/ 152400 w 416560"/>
                <a:gd name="connsiteY2" fmla="*/ 223520 h 762000"/>
                <a:gd name="connsiteX3" fmla="*/ 152400 w 416560"/>
                <a:gd name="connsiteY3" fmla="*/ 762000 h 762000"/>
                <a:gd name="connsiteX4" fmla="*/ 264160 w 416560"/>
                <a:gd name="connsiteY4" fmla="*/ 751840 h 762000"/>
                <a:gd name="connsiteX5" fmla="*/ 264160 w 416560"/>
                <a:gd name="connsiteY5" fmla="*/ 223520 h 762000"/>
                <a:gd name="connsiteX6" fmla="*/ 416560 w 416560"/>
                <a:gd name="connsiteY6" fmla="*/ 223520 h 762000"/>
                <a:gd name="connsiteX7" fmla="*/ 416560 w 416560"/>
                <a:gd name="connsiteY7" fmla="*/ 0 h 762000"/>
                <a:gd name="connsiteX8" fmla="*/ 386080 w 416560"/>
                <a:gd name="connsiteY8" fmla="*/ 30480 h 762000"/>
                <a:gd name="connsiteX9" fmla="*/ 375920 w 416560"/>
                <a:gd name="connsiteY9" fmla="*/ 40640 h 762000"/>
                <a:gd name="connsiteX10" fmla="*/ 325120 w 416560"/>
                <a:gd name="connsiteY10" fmla="*/ 60960 h 762000"/>
                <a:gd name="connsiteX11" fmla="*/ 274320 w 416560"/>
                <a:gd name="connsiteY11" fmla="*/ 91440 h 762000"/>
                <a:gd name="connsiteX12" fmla="*/ 213360 w 416560"/>
                <a:gd name="connsiteY12" fmla="*/ 101600 h 762000"/>
                <a:gd name="connsiteX13" fmla="*/ 172720 w 416560"/>
                <a:gd name="connsiteY13" fmla="*/ 101600 h 762000"/>
                <a:gd name="connsiteX14" fmla="*/ 111760 w 416560"/>
                <a:gd name="connsiteY14" fmla="*/ 81280 h 762000"/>
                <a:gd name="connsiteX15" fmla="*/ 111760 w 416560"/>
                <a:gd name="connsiteY15" fmla="*/ 81280 h 762000"/>
                <a:gd name="connsiteX16" fmla="*/ 0 w 416560"/>
                <a:gd name="connsiteY16" fmla="*/ 10160 h 762000"/>
                <a:gd name="connsiteX0" fmla="*/ 0 w 416560"/>
                <a:gd name="connsiteY0" fmla="*/ 10160 h 772160"/>
                <a:gd name="connsiteX1" fmla="*/ 0 w 416560"/>
                <a:gd name="connsiteY1" fmla="*/ 223520 h 772160"/>
                <a:gd name="connsiteX2" fmla="*/ 152400 w 416560"/>
                <a:gd name="connsiteY2" fmla="*/ 223520 h 772160"/>
                <a:gd name="connsiteX3" fmla="*/ 152400 w 416560"/>
                <a:gd name="connsiteY3" fmla="*/ 762000 h 772160"/>
                <a:gd name="connsiteX4" fmla="*/ 264160 w 416560"/>
                <a:gd name="connsiteY4" fmla="*/ 772160 h 772160"/>
                <a:gd name="connsiteX5" fmla="*/ 264160 w 416560"/>
                <a:gd name="connsiteY5" fmla="*/ 223520 h 772160"/>
                <a:gd name="connsiteX6" fmla="*/ 416560 w 416560"/>
                <a:gd name="connsiteY6" fmla="*/ 223520 h 772160"/>
                <a:gd name="connsiteX7" fmla="*/ 416560 w 416560"/>
                <a:gd name="connsiteY7" fmla="*/ 0 h 772160"/>
                <a:gd name="connsiteX8" fmla="*/ 386080 w 416560"/>
                <a:gd name="connsiteY8" fmla="*/ 30480 h 772160"/>
                <a:gd name="connsiteX9" fmla="*/ 375920 w 416560"/>
                <a:gd name="connsiteY9" fmla="*/ 40640 h 772160"/>
                <a:gd name="connsiteX10" fmla="*/ 325120 w 416560"/>
                <a:gd name="connsiteY10" fmla="*/ 60960 h 772160"/>
                <a:gd name="connsiteX11" fmla="*/ 274320 w 416560"/>
                <a:gd name="connsiteY11" fmla="*/ 91440 h 772160"/>
                <a:gd name="connsiteX12" fmla="*/ 213360 w 416560"/>
                <a:gd name="connsiteY12" fmla="*/ 101600 h 772160"/>
                <a:gd name="connsiteX13" fmla="*/ 172720 w 416560"/>
                <a:gd name="connsiteY13" fmla="*/ 101600 h 772160"/>
                <a:gd name="connsiteX14" fmla="*/ 111760 w 416560"/>
                <a:gd name="connsiteY14" fmla="*/ 81280 h 772160"/>
                <a:gd name="connsiteX15" fmla="*/ 111760 w 416560"/>
                <a:gd name="connsiteY15" fmla="*/ 81280 h 772160"/>
                <a:gd name="connsiteX16" fmla="*/ 0 w 416560"/>
                <a:gd name="connsiteY16" fmla="*/ 10160 h 772160"/>
                <a:gd name="connsiteX0" fmla="*/ 0 w 416560"/>
                <a:gd name="connsiteY0" fmla="*/ 10160 h 813880"/>
                <a:gd name="connsiteX1" fmla="*/ 0 w 416560"/>
                <a:gd name="connsiteY1" fmla="*/ 223520 h 813880"/>
                <a:gd name="connsiteX2" fmla="*/ 152400 w 416560"/>
                <a:gd name="connsiteY2" fmla="*/ 223520 h 813880"/>
                <a:gd name="connsiteX3" fmla="*/ 152400 w 416560"/>
                <a:gd name="connsiteY3" fmla="*/ 813880 h 813880"/>
                <a:gd name="connsiteX4" fmla="*/ 264160 w 416560"/>
                <a:gd name="connsiteY4" fmla="*/ 772160 h 813880"/>
                <a:gd name="connsiteX5" fmla="*/ 264160 w 416560"/>
                <a:gd name="connsiteY5" fmla="*/ 223520 h 813880"/>
                <a:gd name="connsiteX6" fmla="*/ 416560 w 416560"/>
                <a:gd name="connsiteY6" fmla="*/ 223520 h 813880"/>
                <a:gd name="connsiteX7" fmla="*/ 416560 w 416560"/>
                <a:gd name="connsiteY7" fmla="*/ 0 h 813880"/>
                <a:gd name="connsiteX8" fmla="*/ 386080 w 416560"/>
                <a:gd name="connsiteY8" fmla="*/ 30480 h 813880"/>
                <a:gd name="connsiteX9" fmla="*/ 375920 w 416560"/>
                <a:gd name="connsiteY9" fmla="*/ 40640 h 813880"/>
                <a:gd name="connsiteX10" fmla="*/ 325120 w 416560"/>
                <a:gd name="connsiteY10" fmla="*/ 60960 h 813880"/>
                <a:gd name="connsiteX11" fmla="*/ 274320 w 416560"/>
                <a:gd name="connsiteY11" fmla="*/ 91440 h 813880"/>
                <a:gd name="connsiteX12" fmla="*/ 213360 w 416560"/>
                <a:gd name="connsiteY12" fmla="*/ 101600 h 813880"/>
                <a:gd name="connsiteX13" fmla="*/ 172720 w 416560"/>
                <a:gd name="connsiteY13" fmla="*/ 101600 h 813880"/>
                <a:gd name="connsiteX14" fmla="*/ 111760 w 416560"/>
                <a:gd name="connsiteY14" fmla="*/ 81280 h 813880"/>
                <a:gd name="connsiteX15" fmla="*/ 111760 w 416560"/>
                <a:gd name="connsiteY15" fmla="*/ 81280 h 813880"/>
                <a:gd name="connsiteX16" fmla="*/ 0 w 416560"/>
                <a:gd name="connsiteY16" fmla="*/ 10160 h 813880"/>
                <a:gd name="connsiteX0" fmla="*/ 0 w 416560"/>
                <a:gd name="connsiteY0" fmla="*/ 10160 h 800910"/>
                <a:gd name="connsiteX1" fmla="*/ 0 w 416560"/>
                <a:gd name="connsiteY1" fmla="*/ 223520 h 800910"/>
                <a:gd name="connsiteX2" fmla="*/ 152400 w 416560"/>
                <a:gd name="connsiteY2" fmla="*/ 223520 h 800910"/>
                <a:gd name="connsiteX3" fmla="*/ 152400 w 416560"/>
                <a:gd name="connsiteY3" fmla="*/ 800910 h 800910"/>
                <a:gd name="connsiteX4" fmla="*/ 264160 w 416560"/>
                <a:gd name="connsiteY4" fmla="*/ 772160 h 800910"/>
                <a:gd name="connsiteX5" fmla="*/ 264160 w 416560"/>
                <a:gd name="connsiteY5" fmla="*/ 223520 h 800910"/>
                <a:gd name="connsiteX6" fmla="*/ 416560 w 416560"/>
                <a:gd name="connsiteY6" fmla="*/ 223520 h 800910"/>
                <a:gd name="connsiteX7" fmla="*/ 416560 w 416560"/>
                <a:gd name="connsiteY7" fmla="*/ 0 h 800910"/>
                <a:gd name="connsiteX8" fmla="*/ 386080 w 416560"/>
                <a:gd name="connsiteY8" fmla="*/ 30480 h 800910"/>
                <a:gd name="connsiteX9" fmla="*/ 375920 w 416560"/>
                <a:gd name="connsiteY9" fmla="*/ 40640 h 800910"/>
                <a:gd name="connsiteX10" fmla="*/ 325120 w 416560"/>
                <a:gd name="connsiteY10" fmla="*/ 60960 h 800910"/>
                <a:gd name="connsiteX11" fmla="*/ 274320 w 416560"/>
                <a:gd name="connsiteY11" fmla="*/ 91440 h 800910"/>
                <a:gd name="connsiteX12" fmla="*/ 213360 w 416560"/>
                <a:gd name="connsiteY12" fmla="*/ 101600 h 800910"/>
                <a:gd name="connsiteX13" fmla="*/ 172720 w 416560"/>
                <a:gd name="connsiteY13" fmla="*/ 101600 h 800910"/>
                <a:gd name="connsiteX14" fmla="*/ 111760 w 416560"/>
                <a:gd name="connsiteY14" fmla="*/ 81280 h 800910"/>
                <a:gd name="connsiteX15" fmla="*/ 111760 w 416560"/>
                <a:gd name="connsiteY15" fmla="*/ 81280 h 800910"/>
                <a:gd name="connsiteX16" fmla="*/ 0 w 416560"/>
                <a:gd name="connsiteY16" fmla="*/ 10160 h 800910"/>
                <a:gd name="connsiteX0" fmla="*/ 0 w 416560"/>
                <a:gd name="connsiteY0" fmla="*/ 10160 h 781454"/>
                <a:gd name="connsiteX1" fmla="*/ 0 w 416560"/>
                <a:gd name="connsiteY1" fmla="*/ 223520 h 781454"/>
                <a:gd name="connsiteX2" fmla="*/ 152400 w 416560"/>
                <a:gd name="connsiteY2" fmla="*/ 223520 h 781454"/>
                <a:gd name="connsiteX3" fmla="*/ 145915 w 416560"/>
                <a:gd name="connsiteY3" fmla="*/ 781454 h 781454"/>
                <a:gd name="connsiteX4" fmla="*/ 264160 w 416560"/>
                <a:gd name="connsiteY4" fmla="*/ 772160 h 781454"/>
                <a:gd name="connsiteX5" fmla="*/ 264160 w 416560"/>
                <a:gd name="connsiteY5" fmla="*/ 223520 h 781454"/>
                <a:gd name="connsiteX6" fmla="*/ 416560 w 416560"/>
                <a:gd name="connsiteY6" fmla="*/ 223520 h 781454"/>
                <a:gd name="connsiteX7" fmla="*/ 416560 w 416560"/>
                <a:gd name="connsiteY7" fmla="*/ 0 h 781454"/>
                <a:gd name="connsiteX8" fmla="*/ 386080 w 416560"/>
                <a:gd name="connsiteY8" fmla="*/ 30480 h 781454"/>
                <a:gd name="connsiteX9" fmla="*/ 375920 w 416560"/>
                <a:gd name="connsiteY9" fmla="*/ 40640 h 781454"/>
                <a:gd name="connsiteX10" fmla="*/ 325120 w 416560"/>
                <a:gd name="connsiteY10" fmla="*/ 60960 h 781454"/>
                <a:gd name="connsiteX11" fmla="*/ 274320 w 416560"/>
                <a:gd name="connsiteY11" fmla="*/ 91440 h 781454"/>
                <a:gd name="connsiteX12" fmla="*/ 213360 w 416560"/>
                <a:gd name="connsiteY12" fmla="*/ 101600 h 781454"/>
                <a:gd name="connsiteX13" fmla="*/ 172720 w 416560"/>
                <a:gd name="connsiteY13" fmla="*/ 101600 h 781454"/>
                <a:gd name="connsiteX14" fmla="*/ 111760 w 416560"/>
                <a:gd name="connsiteY14" fmla="*/ 81280 h 781454"/>
                <a:gd name="connsiteX15" fmla="*/ 111760 w 416560"/>
                <a:gd name="connsiteY15" fmla="*/ 81280 h 781454"/>
                <a:gd name="connsiteX16" fmla="*/ 0 w 416560"/>
                <a:gd name="connsiteY16" fmla="*/ 10160 h 781454"/>
                <a:gd name="connsiteX0" fmla="*/ 0 w 416560"/>
                <a:gd name="connsiteY0" fmla="*/ 10160 h 772160"/>
                <a:gd name="connsiteX1" fmla="*/ 0 w 416560"/>
                <a:gd name="connsiteY1" fmla="*/ 223520 h 772160"/>
                <a:gd name="connsiteX2" fmla="*/ 152400 w 416560"/>
                <a:gd name="connsiteY2" fmla="*/ 223520 h 772160"/>
                <a:gd name="connsiteX3" fmla="*/ 145915 w 416560"/>
                <a:gd name="connsiteY3" fmla="*/ 768484 h 772160"/>
                <a:gd name="connsiteX4" fmla="*/ 264160 w 416560"/>
                <a:gd name="connsiteY4" fmla="*/ 772160 h 772160"/>
                <a:gd name="connsiteX5" fmla="*/ 264160 w 416560"/>
                <a:gd name="connsiteY5" fmla="*/ 223520 h 772160"/>
                <a:gd name="connsiteX6" fmla="*/ 416560 w 416560"/>
                <a:gd name="connsiteY6" fmla="*/ 223520 h 772160"/>
                <a:gd name="connsiteX7" fmla="*/ 416560 w 416560"/>
                <a:gd name="connsiteY7" fmla="*/ 0 h 772160"/>
                <a:gd name="connsiteX8" fmla="*/ 386080 w 416560"/>
                <a:gd name="connsiteY8" fmla="*/ 30480 h 772160"/>
                <a:gd name="connsiteX9" fmla="*/ 375920 w 416560"/>
                <a:gd name="connsiteY9" fmla="*/ 40640 h 772160"/>
                <a:gd name="connsiteX10" fmla="*/ 325120 w 416560"/>
                <a:gd name="connsiteY10" fmla="*/ 60960 h 772160"/>
                <a:gd name="connsiteX11" fmla="*/ 274320 w 416560"/>
                <a:gd name="connsiteY11" fmla="*/ 91440 h 772160"/>
                <a:gd name="connsiteX12" fmla="*/ 213360 w 416560"/>
                <a:gd name="connsiteY12" fmla="*/ 101600 h 772160"/>
                <a:gd name="connsiteX13" fmla="*/ 172720 w 416560"/>
                <a:gd name="connsiteY13" fmla="*/ 101600 h 772160"/>
                <a:gd name="connsiteX14" fmla="*/ 111760 w 416560"/>
                <a:gd name="connsiteY14" fmla="*/ 81280 h 772160"/>
                <a:gd name="connsiteX15" fmla="*/ 111760 w 416560"/>
                <a:gd name="connsiteY15" fmla="*/ 81280 h 772160"/>
                <a:gd name="connsiteX16" fmla="*/ 0 w 416560"/>
                <a:gd name="connsiteY16" fmla="*/ 10160 h 772160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25120 w 416560"/>
                <a:gd name="connsiteY10" fmla="*/ 60960 h 768484"/>
                <a:gd name="connsiteX11" fmla="*/ 274320 w 416560"/>
                <a:gd name="connsiteY11" fmla="*/ 91440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25120 w 416560"/>
                <a:gd name="connsiteY10" fmla="*/ 6096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31605 w 416560"/>
                <a:gd name="connsiteY10" fmla="*/ 6096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4576 w 416560"/>
                <a:gd name="connsiteY10" fmla="*/ 80416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0926 w 416560"/>
                <a:gd name="connsiteY10" fmla="*/ 76765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0926 w 416560"/>
                <a:gd name="connsiteY10" fmla="*/ 7494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  <a:gd name="connsiteX0" fmla="*/ 0 w 416560"/>
                <a:gd name="connsiteY0" fmla="*/ 10160 h 768484"/>
                <a:gd name="connsiteX1" fmla="*/ 0 w 416560"/>
                <a:gd name="connsiteY1" fmla="*/ 223520 h 768484"/>
                <a:gd name="connsiteX2" fmla="*/ 152400 w 416560"/>
                <a:gd name="connsiteY2" fmla="*/ 223520 h 768484"/>
                <a:gd name="connsiteX3" fmla="*/ 145915 w 416560"/>
                <a:gd name="connsiteY3" fmla="*/ 768484 h 768484"/>
                <a:gd name="connsiteX4" fmla="*/ 264160 w 416560"/>
                <a:gd name="connsiteY4" fmla="*/ 765675 h 768484"/>
                <a:gd name="connsiteX5" fmla="*/ 264160 w 416560"/>
                <a:gd name="connsiteY5" fmla="*/ 223520 h 768484"/>
                <a:gd name="connsiteX6" fmla="*/ 416560 w 416560"/>
                <a:gd name="connsiteY6" fmla="*/ 223520 h 768484"/>
                <a:gd name="connsiteX7" fmla="*/ 416560 w 416560"/>
                <a:gd name="connsiteY7" fmla="*/ 0 h 768484"/>
                <a:gd name="connsiteX8" fmla="*/ 386080 w 416560"/>
                <a:gd name="connsiteY8" fmla="*/ 30480 h 768484"/>
                <a:gd name="connsiteX9" fmla="*/ 375920 w 416560"/>
                <a:gd name="connsiteY9" fmla="*/ 40640 h 768484"/>
                <a:gd name="connsiteX10" fmla="*/ 340926 w 416560"/>
                <a:gd name="connsiteY10" fmla="*/ 74940 h 768484"/>
                <a:gd name="connsiteX11" fmla="*/ 280805 w 416560"/>
                <a:gd name="connsiteY11" fmla="*/ 97926 h 768484"/>
                <a:gd name="connsiteX12" fmla="*/ 213360 w 416560"/>
                <a:gd name="connsiteY12" fmla="*/ 101600 h 768484"/>
                <a:gd name="connsiteX13" fmla="*/ 172720 w 416560"/>
                <a:gd name="connsiteY13" fmla="*/ 101600 h 768484"/>
                <a:gd name="connsiteX14" fmla="*/ 111760 w 416560"/>
                <a:gd name="connsiteY14" fmla="*/ 81280 h 768484"/>
                <a:gd name="connsiteX15" fmla="*/ 111760 w 416560"/>
                <a:gd name="connsiteY15" fmla="*/ 81280 h 768484"/>
                <a:gd name="connsiteX16" fmla="*/ 0 w 416560"/>
                <a:gd name="connsiteY16" fmla="*/ 10160 h 76848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</a:cxnLst>
              <a:rect l="l" t="t" r="r" b="b"/>
              <a:pathLst>
                <a:path w="416560" h="768484">
                  <a:moveTo>
                    <a:pt x="0" y="10160"/>
                  </a:moveTo>
                  <a:lnTo>
                    <a:pt x="0" y="223520"/>
                  </a:lnTo>
                  <a:lnTo>
                    <a:pt x="152400" y="223520"/>
                  </a:lnTo>
                  <a:cubicBezTo>
                    <a:pt x="150238" y="409498"/>
                    <a:pt x="148077" y="582506"/>
                    <a:pt x="145915" y="768484"/>
                  </a:cubicBezTo>
                  <a:lnTo>
                    <a:pt x="264160" y="765675"/>
                  </a:lnTo>
                  <a:lnTo>
                    <a:pt x="264160" y="223520"/>
                  </a:lnTo>
                  <a:lnTo>
                    <a:pt x="416560" y="223520"/>
                  </a:lnTo>
                  <a:lnTo>
                    <a:pt x="416560" y="0"/>
                  </a:lnTo>
                  <a:lnTo>
                    <a:pt x="386080" y="30480"/>
                  </a:lnTo>
                  <a:lnTo>
                    <a:pt x="375920" y="40640"/>
                  </a:lnTo>
                  <a:lnTo>
                    <a:pt x="340926" y="74940"/>
                  </a:lnTo>
                  <a:cubicBezTo>
                    <a:pt x="320886" y="84427"/>
                    <a:pt x="300845" y="90264"/>
                    <a:pt x="280805" y="97926"/>
                  </a:cubicBezTo>
                  <a:lnTo>
                    <a:pt x="213360" y="101600"/>
                  </a:lnTo>
                  <a:lnTo>
                    <a:pt x="172720" y="101600"/>
                  </a:lnTo>
                  <a:lnTo>
                    <a:pt x="111760" y="81280"/>
                  </a:lnTo>
                  <a:lnTo>
                    <a:pt x="111760" y="81280"/>
                  </a:lnTo>
                  <a:lnTo>
                    <a:pt x="0" y="10160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椭圆 62">
              <a:extLst>
                <a:ext uri="{FF2B5EF4-FFF2-40B4-BE49-F238E27FC236}">
                  <a16:creationId xmlns:a16="http://schemas.microsoft.com/office/drawing/2014/main" id="{C3C0E13F-2782-2B4B-A3F2-CB78633187B2}"/>
                </a:ext>
              </a:extLst>
            </p:cNvPr>
            <p:cNvSpPr/>
            <p:nvPr/>
          </p:nvSpPr>
          <p:spPr>
            <a:xfrm rot="12631023">
              <a:off x="10556396" y="2143149"/>
              <a:ext cx="96456" cy="93628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标题 1">
              <a:extLst>
                <a:ext uri="{FF2B5EF4-FFF2-40B4-BE49-F238E27FC236}">
                  <a16:creationId xmlns:a16="http://schemas.microsoft.com/office/drawing/2014/main" id="{5E6BA36F-9278-BF44-8636-9D1FD8BA40B3}"/>
                </a:ext>
              </a:extLst>
            </p:cNvPr>
            <p:cNvSpPr txBox="1">
              <a:spLocks/>
            </p:cNvSpPr>
            <p:nvPr/>
          </p:nvSpPr>
          <p:spPr>
            <a:xfrm>
              <a:off x="10015161" y="1833314"/>
              <a:ext cx="763336" cy="392366"/>
            </a:xfrm>
            <a:prstGeom prst="rect">
              <a:avLst/>
            </a:prstGeom>
          </p:spPr>
          <p:txBody>
            <a:bodyPr vert="horz" lIns="91440" tIns="45720" rIns="91440" bIns="45720" rtlCol="0" anchor="t">
              <a:noAutofit/>
            </a:bodyPr>
            <a:lstStyle>
              <a:lvl1pPr algn="l" defTabSz="457200" rtl="0" eaLnBrk="1" latinLnBrk="0" hangingPunct="1">
                <a:spcBef>
                  <a:spcPct val="0"/>
                </a:spcBef>
                <a:buNone/>
                <a:defRPr sz="3600" b="1" kern="1200">
                  <a:solidFill>
                    <a:schemeClr val="tx1">
                      <a:lumMod val="85000"/>
                      <a:lumOff val="15000"/>
                    </a:schemeClr>
                  </a:solidFill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defRPr>
              </a:lvl1pPr>
              <a:lvl2pPr eaLnBrk="1" hangingPunct="1">
                <a:defRPr>
                  <a:solidFill>
                    <a:schemeClr val="tx2"/>
                  </a:solidFill>
                </a:defRPr>
              </a:lvl2pPr>
              <a:lvl3pPr eaLnBrk="1" hangingPunct="1">
                <a:defRPr>
                  <a:solidFill>
                    <a:schemeClr val="tx2"/>
                  </a:solidFill>
                </a:defRPr>
              </a:lvl3pPr>
              <a:lvl4pPr eaLnBrk="1" hangingPunct="1">
                <a:defRPr>
                  <a:solidFill>
                    <a:schemeClr val="tx2"/>
                  </a:solidFill>
                </a:defRPr>
              </a:lvl4pPr>
              <a:lvl5pPr eaLnBrk="1" hangingPunct="1">
                <a:defRPr>
                  <a:solidFill>
                    <a:schemeClr val="tx2"/>
                  </a:solidFill>
                </a:defRPr>
              </a:lvl5pPr>
              <a:lvl6pPr eaLnBrk="1" hangingPunct="1">
                <a:defRPr>
                  <a:solidFill>
                    <a:schemeClr val="tx2"/>
                  </a:solidFill>
                </a:defRPr>
              </a:lvl6pPr>
              <a:lvl7pPr eaLnBrk="1" hangingPunct="1">
                <a:defRPr>
                  <a:solidFill>
                    <a:schemeClr val="tx2"/>
                  </a:solidFill>
                </a:defRPr>
              </a:lvl7pPr>
              <a:lvl8pPr eaLnBrk="1" hangingPunct="1">
                <a:defRPr>
                  <a:solidFill>
                    <a:schemeClr val="tx2"/>
                  </a:solidFill>
                </a:defRPr>
              </a:lvl8pPr>
              <a:lvl9pPr eaLnBrk="1" hangingPunct="1">
                <a:defRPr>
                  <a:solidFill>
                    <a:schemeClr val="tx2"/>
                  </a:solidFill>
                </a:defRPr>
              </a:lvl9pPr>
            </a:lstStyle>
            <a:p>
              <a:pPr algn="ctr"/>
              <a:r>
                <a:rPr lang="en-US" altLang="zh-CN" sz="14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PS</a:t>
              </a:r>
              <a:endParaRPr lang="zh-CN" altLang="en-US" sz="140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标题 1">
              <a:extLst>
                <a:ext uri="{FF2B5EF4-FFF2-40B4-BE49-F238E27FC236}">
                  <a16:creationId xmlns:a16="http://schemas.microsoft.com/office/drawing/2014/main" id="{DC26ECDA-9754-9F48-B010-B64FCDCE49EE}"/>
                </a:ext>
              </a:extLst>
            </p:cNvPr>
            <p:cNvSpPr txBox="1">
              <a:spLocks/>
            </p:cNvSpPr>
            <p:nvPr/>
          </p:nvSpPr>
          <p:spPr>
            <a:xfrm>
              <a:off x="10618782" y="2018008"/>
              <a:ext cx="826900" cy="207671"/>
            </a:xfrm>
            <a:prstGeom prst="rect">
              <a:avLst/>
            </a:prstGeom>
          </p:spPr>
          <p:txBody>
            <a:bodyPr vert="horz" lIns="91440" tIns="45720" rIns="91440" bIns="45720" rtlCol="0" anchor="t">
              <a:noAutofit/>
            </a:bodyPr>
            <a:lstStyle>
              <a:lvl1pPr algn="l" defTabSz="457200" rtl="0" eaLnBrk="1" latinLnBrk="0" hangingPunct="1">
                <a:spcBef>
                  <a:spcPct val="0"/>
                </a:spcBef>
                <a:buNone/>
                <a:defRPr sz="3600" b="1" kern="1200">
                  <a:solidFill>
                    <a:schemeClr val="tx1">
                      <a:lumMod val="85000"/>
                      <a:lumOff val="15000"/>
                    </a:schemeClr>
                  </a:solidFill>
                  <a:latin typeface="Times New Roman" panose="02020603050405020304" pitchFamily="18" charset="0"/>
                  <a:ea typeface="+mj-ea"/>
                  <a:cs typeface="Times New Roman" panose="02020603050405020304" pitchFamily="18" charset="0"/>
                </a:defRPr>
              </a:lvl1pPr>
              <a:lvl2pPr eaLnBrk="1" hangingPunct="1">
                <a:defRPr>
                  <a:solidFill>
                    <a:schemeClr val="tx2"/>
                  </a:solidFill>
                </a:defRPr>
              </a:lvl2pPr>
              <a:lvl3pPr eaLnBrk="1" hangingPunct="1">
                <a:defRPr>
                  <a:solidFill>
                    <a:schemeClr val="tx2"/>
                  </a:solidFill>
                </a:defRPr>
              </a:lvl3pPr>
              <a:lvl4pPr eaLnBrk="1" hangingPunct="1">
                <a:defRPr>
                  <a:solidFill>
                    <a:schemeClr val="tx2"/>
                  </a:solidFill>
                </a:defRPr>
              </a:lvl4pPr>
              <a:lvl5pPr eaLnBrk="1" hangingPunct="1">
                <a:defRPr>
                  <a:solidFill>
                    <a:schemeClr val="tx2"/>
                  </a:solidFill>
                </a:defRPr>
              </a:lvl5pPr>
              <a:lvl6pPr eaLnBrk="1" hangingPunct="1">
                <a:defRPr>
                  <a:solidFill>
                    <a:schemeClr val="tx2"/>
                  </a:solidFill>
                </a:defRPr>
              </a:lvl6pPr>
              <a:lvl7pPr eaLnBrk="1" hangingPunct="1">
                <a:defRPr>
                  <a:solidFill>
                    <a:schemeClr val="tx2"/>
                  </a:solidFill>
                </a:defRPr>
              </a:lvl7pPr>
              <a:lvl8pPr eaLnBrk="1" hangingPunct="1">
                <a:defRPr>
                  <a:solidFill>
                    <a:schemeClr val="tx2"/>
                  </a:solidFill>
                </a:defRPr>
              </a:lvl8pPr>
              <a:lvl9pPr eaLnBrk="1" hangingPunct="1">
                <a:defRPr>
                  <a:solidFill>
                    <a:schemeClr val="tx2"/>
                  </a:solidFill>
                </a:defRPr>
              </a:lvl9pPr>
            </a:lstStyle>
            <a:p>
              <a:pPr algn="ctr"/>
              <a:r>
                <a:rPr lang="en-US" altLang="zh-CN" sz="1400" dirty="0">
                  <a:solidFill>
                    <a:schemeClr val="tx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LR4</a:t>
              </a:r>
              <a:endParaRPr lang="zh-CN" altLang="en-US" sz="140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54" name="直接箭头连接符 304">
            <a:extLst>
              <a:ext uri="{FF2B5EF4-FFF2-40B4-BE49-F238E27FC236}">
                <a16:creationId xmlns:a16="http://schemas.microsoft.com/office/drawing/2014/main" id="{935E391E-1FE8-BB48-BCDC-B264F9BE708E}"/>
              </a:ext>
            </a:extLst>
          </p:cNvPr>
          <p:cNvCxnSpPr>
            <a:cxnSpLocks/>
          </p:cNvCxnSpPr>
          <p:nvPr/>
        </p:nvCxnSpPr>
        <p:spPr>
          <a:xfrm flipV="1">
            <a:off x="6121447" y="2550240"/>
            <a:ext cx="0" cy="21263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接箭头连接符 304">
            <a:extLst>
              <a:ext uri="{FF2B5EF4-FFF2-40B4-BE49-F238E27FC236}">
                <a16:creationId xmlns:a16="http://schemas.microsoft.com/office/drawing/2014/main" id="{33F47FDE-2D63-6A46-9F2D-3D1DDFF3B125}"/>
              </a:ext>
            </a:extLst>
          </p:cNvPr>
          <p:cNvCxnSpPr>
            <a:cxnSpLocks/>
          </p:cNvCxnSpPr>
          <p:nvPr/>
        </p:nvCxnSpPr>
        <p:spPr>
          <a:xfrm flipV="1">
            <a:off x="6909953" y="2914675"/>
            <a:ext cx="0" cy="212631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接箭头连接符 304">
            <a:extLst>
              <a:ext uri="{FF2B5EF4-FFF2-40B4-BE49-F238E27FC236}">
                <a16:creationId xmlns:a16="http://schemas.microsoft.com/office/drawing/2014/main" id="{AA074879-3222-6941-BC68-AECA4A9D239A}"/>
              </a:ext>
            </a:extLst>
          </p:cNvPr>
          <p:cNvCxnSpPr>
            <a:cxnSpLocks/>
          </p:cNvCxnSpPr>
          <p:nvPr/>
        </p:nvCxnSpPr>
        <p:spPr>
          <a:xfrm>
            <a:off x="9474246" y="2789374"/>
            <a:ext cx="0" cy="24226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标题 1">
            <a:extLst>
              <a:ext uri="{FF2B5EF4-FFF2-40B4-BE49-F238E27FC236}">
                <a16:creationId xmlns:a16="http://schemas.microsoft.com/office/drawing/2014/main" id="{929B25D7-AE2B-594C-81CD-6C74B8BAF5BB}"/>
              </a:ext>
            </a:extLst>
          </p:cNvPr>
          <p:cNvSpPr txBox="1">
            <a:spLocks/>
          </p:cNvSpPr>
          <p:nvPr/>
        </p:nvSpPr>
        <p:spPr>
          <a:xfrm>
            <a:off x="5563724" y="3940584"/>
            <a:ext cx="1208130" cy="160164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3600" b="1" kern="120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en-US" altLang="zh-CN" sz="1200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ocytosis</a:t>
            </a:r>
            <a:endParaRPr lang="zh-CN" altLang="en-US" sz="120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9629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202</Words>
  <Application>Microsoft Macintosh PowerPoint</Application>
  <PresentationFormat>Widescreen</PresentationFormat>
  <Paragraphs>6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Sandip Mukherjee</dc:creator>
  <cp:lastModifiedBy>Lee, Jae Woo</cp:lastModifiedBy>
  <cp:revision>11</cp:revision>
  <dcterms:created xsi:type="dcterms:W3CDTF">2025-04-07T22:39:00Z</dcterms:created>
  <dcterms:modified xsi:type="dcterms:W3CDTF">2026-03-31T19:27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7BBAB34C57A4480860CA092C6F864D5_12</vt:lpwstr>
  </property>
  <property fmtid="{D5CDD505-2E9C-101B-9397-08002B2CF9AE}" pid="3" name="KSOProductBuildVer">
    <vt:lpwstr>1033-12.2.0.20326</vt:lpwstr>
  </property>
</Properties>
</file>